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6D9F1"/>
    <a:srgbClr val="BFBFBF"/>
    <a:srgbClr val="BCA1A1"/>
    <a:srgbClr val="DDD9C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4225" autoAdjust="0"/>
    <p:restoredTop sz="94660"/>
  </p:normalViewPr>
  <p:slideViewPr>
    <p:cSldViewPr snapToGrid="0" showGuides="1">
      <p:cViewPr varScale="1">
        <p:scale>
          <a:sx n="102" d="100"/>
          <a:sy n="102" d="100"/>
        </p:scale>
        <p:origin x="1552" y="12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28FA49-21C9-40A9-B8EE-963CC3B8DC2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0AAB391-8499-4C3C-BD42-C6B61884912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C41C5D-434E-4E7D-8C6D-1F6ED76C27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15E52-2641-4815-AD13-DED3B178AFCA}" type="datetimeFigureOut">
              <a:rPr lang="en-US" smtClean="0"/>
              <a:t>6/2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08C771-A82F-49A2-A483-0700DDC7CA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108510-02CB-4621-AD7A-26BA2BE858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CEC37-1D44-4646-9269-74A338EBD2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63681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EE5229-2578-432C-BA6F-4B3135103A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3FB7C80-E313-4619-9C0E-20FEBD4823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CB3AF2-B648-4DEF-8E38-CFB2979BC5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15E52-2641-4815-AD13-DED3B178AFCA}" type="datetimeFigureOut">
              <a:rPr lang="en-US" smtClean="0"/>
              <a:t>6/2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7028F9-7AB9-4742-B35D-1D5D1A3876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D72937-AE6C-4F1A-8567-14AE27FB8B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CEC37-1D44-4646-9269-74A338EBD2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9144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E788ACC-CCCB-4BF8-A8C2-855671FD0E5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C0416F4-4C8A-489A-8F0E-88E7D5137F5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9D72D5-FA1C-45C9-9F64-3BC5566B41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15E52-2641-4815-AD13-DED3B178AFCA}" type="datetimeFigureOut">
              <a:rPr lang="en-US" smtClean="0"/>
              <a:t>6/2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360201-3C80-418D-828F-541AAAE88C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EE741A-A060-4AA9-B093-F10211FABC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CEC37-1D44-4646-9269-74A338EBD2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89467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D98512-7125-4CFB-B753-CAACA69224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CC85DFD-895E-46F5-9B18-4887BF6FED4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21B0BC-B1ED-4110-9FFC-FA6DC699B2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15E52-2641-4815-AD13-DED3B178AFCA}" type="datetimeFigureOut">
              <a:rPr lang="en-US" smtClean="0"/>
              <a:t>6/2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FD0639-2A5A-4B80-A4A5-5041D09B56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8FAFD9-269B-47C9-92D1-80F54371C2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CEC37-1D44-4646-9269-74A338EBD2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3505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0B6680-1EC4-4FC0-AF3C-83D0516679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AA779C6-34AE-48D8-836E-448690F1CC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6C4EA8-1559-47C7-AA67-F5AE6EE3D2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15E52-2641-4815-AD13-DED3B178AFCA}" type="datetimeFigureOut">
              <a:rPr lang="en-US" smtClean="0"/>
              <a:t>6/2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0EBD07-0509-42B0-8DBB-701DE63ED4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B8183A-5D88-457D-989C-DD558DD2FE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CEC37-1D44-4646-9269-74A338EBD2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32412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F602B8-8289-4859-AE86-93E8AA066B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D553832-BB37-44E4-94C7-35605B1AD6B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ABF1B19-BEC0-4432-9431-6152FC83FFB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4BED38B-102E-4F5A-B9FE-6F72A8591B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15E52-2641-4815-AD13-DED3B178AFCA}" type="datetimeFigureOut">
              <a:rPr lang="en-US" smtClean="0"/>
              <a:t>6/27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D02998D-B296-442C-9CDD-B8BB4A6DF1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B9D145-1A1F-455D-86D2-4D6072E8EB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CEC37-1D44-4646-9269-74A338EBD2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38343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C1DC34-0559-410F-AA22-AE1FF8C05D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5816C5B-D5C5-4763-A5B3-888E3A0D5F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3674825-51F7-4C21-943F-F21B68C5899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5162406-F33A-4DD4-81B2-99718405F0F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C2CC654-73C2-4B5C-9329-A5FF014655B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35BEC3A-B2EE-40BC-ABD9-EBC9ADD8FD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15E52-2641-4815-AD13-DED3B178AFCA}" type="datetimeFigureOut">
              <a:rPr lang="en-US" smtClean="0"/>
              <a:t>6/27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8795EBE-059F-4924-95FF-F51F6D18C4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4F9055E-337D-4693-9B52-2693EC72A8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CEC37-1D44-4646-9269-74A338EBD2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79863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CF2A72-A261-4D55-AF98-755B49080F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E781FD9-A340-4E3E-9767-6DE9A07FE4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15E52-2641-4815-AD13-DED3B178AFCA}" type="datetimeFigureOut">
              <a:rPr lang="en-US" smtClean="0"/>
              <a:t>6/27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B581D91-B817-40B3-86B0-9EAB22C378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29D5A03-551C-4AB7-8C28-C57A0DDB2E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CEC37-1D44-4646-9269-74A338EBD2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56714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F3F3589-4E7C-43D8-8984-1D624FBCCC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15E52-2641-4815-AD13-DED3B178AFCA}" type="datetimeFigureOut">
              <a:rPr lang="en-US" smtClean="0"/>
              <a:t>6/27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2FB6447-68CF-4856-9026-6D795C3C01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6399495-91D0-415A-BC8A-EA9918B324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CEC37-1D44-4646-9269-74A338EBD2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97823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2EEE53-7C70-4103-AAC6-9A3F454658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59730E-9742-42EF-9B84-AC56E97F816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A2DF9CF-2C1B-450B-BFEB-DBD9BE0FBB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6482B59-6069-4F4D-9250-BA66B88591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15E52-2641-4815-AD13-DED3B178AFCA}" type="datetimeFigureOut">
              <a:rPr lang="en-US" smtClean="0"/>
              <a:t>6/27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2F231E2-5901-4A5B-985A-764F232914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7FF7CF3-D02D-4E39-B1C2-831CB03A13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CEC37-1D44-4646-9269-74A338EBD2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00941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FA3C80-F3D3-429B-A3FE-ADF0DCD9A3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E369329-9D75-4867-841B-E49AA3DF5F6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7AEFBF5-D1F4-42EE-BE61-49540962242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2E4920D-592F-4DE0-83C3-F1FDE2BE94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15E52-2641-4815-AD13-DED3B178AFCA}" type="datetimeFigureOut">
              <a:rPr lang="en-US" smtClean="0"/>
              <a:t>6/27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3B77D15-93EC-45BB-B940-2CA4EE0C2F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5CC5B5E-3502-4A2C-8DE6-0D7782CA72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CEC37-1D44-4646-9269-74A338EBD2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3761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80F9112-EA2D-465C-BD90-AE484A8C2E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F86A1BF-7F73-4897-8BA0-7EF25B0D06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183C7D-DFE0-43F6-AC77-DFF8F020E89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B15E52-2641-4815-AD13-DED3B178AFCA}" type="datetimeFigureOut">
              <a:rPr lang="en-US" smtClean="0"/>
              <a:t>6/2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4231C7-B820-4959-BDF9-8BD4320E8DF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3A8C83-661B-4AA6-8832-8E31F62F023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4CEC37-1D44-4646-9269-74A338EBD2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27971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BA31069-E11A-9343-A022-980038CA2B01}"/>
              </a:ext>
            </a:extLst>
          </p:cNvPr>
          <p:cNvSpPr txBox="1"/>
          <p:nvPr/>
        </p:nvSpPr>
        <p:spPr>
          <a:xfrm>
            <a:off x="2248398" y="5808"/>
            <a:ext cx="13651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LEGS system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1E36E23-06F9-8542-A2BA-0CA84E033A85}"/>
              </a:ext>
            </a:extLst>
          </p:cNvPr>
          <p:cNvSpPr txBox="1"/>
          <p:nvPr/>
        </p:nvSpPr>
        <p:spPr>
          <a:xfrm>
            <a:off x="8431275" y="4568305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ucu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E19E1DC-59EB-F848-894F-73D0D1EAED47}"/>
              </a:ext>
            </a:extLst>
          </p:cNvPr>
          <p:cNvSpPr txBox="1"/>
          <p:nvPr/>
        </p:nvSpPr>
        <p:spPr>
          <a:xfrm>
            <a:off x="6506122" y="3915820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ea typeface="Arial" charset="0"/>
                <a:cs typeface="Arial" charset="0"/>
              </a:rPr>
              <a:t>Caco-2</a:t>
            </a:r>
          </a:p>
        </p:txBody>
      </p:sp>
      <p:sp>
        <p:nvSpPr>
          <p:cNvPr id="12" name="Freeform 11">
            <a:extLst>
              <a:ext uri="{FF2B5EF4-FFF2-40B4-BE49-F238E27FC236}">
                <a16:creationId xmlns:a16="http://schemas.microsoft.com/office/drawing/2014/main" id="{E9AE628B-9BC9-4E4F-99EE-39F22BF6A077}"/>
              </a:ext>
            </a:extLst>
          </p:cNvPr>
          <p:cNvSpPr/>
          <p:nvPr/>
        </p:nvSpPr>
        <p:spPr>
          <a:xfrm>
            <a:off x="6314420" y="3785376"/>
            <a:ext cx="221166" cy="457420"/>
          </a:xfrm>
          <a:custGeom>
            <a:avLst/>
            <a:gdLst>
              <a:gd name="connsiteX0" fmla="*/ 157497 w 1289611"/>
              <a:gd name="connsiteY0" fmla="*/ 174171 h 1859149"/>
              <a:gd name="connsiteX1" fmla="*/ 44285 w 1289611"/>
              <a:gd name="connsiteY1" fmla="*/ 156754 h 1859149"/>
              <a:gd name="connsiteX2" fmla="*/ 18160 w 1289611"/>
              <a:gd name="connsiteY2" fmla="*/ 182880 h 1859149"/>
              <a:gd name="connsiteX3" fmla="*/ 18160 w 1289611"/>
              <a:gd name="connsiteY3" fmla="*/ 444137 h 1859149"/>
              <a:gd name="connsiteX4" fmla="*/ 26868 w 1289611"/>
              <a:gd name="connsiteY4" fmla="*/ 505097 h 1859149"/>
              <a:gd name="connsiteX5" fmla="*/ 35577 w 1289611"/>
              <a:gd name="connsiteY5" fmla="*/ 618309 h 1859149"/>
              <a:gd name="connsiteX6" fmla="*/ 44285 w 1289611"/>
              <a:gd name="connsiteY6" fmla="*/ 679269 h 1859149"/>
              <a:gd name="connsiteX7" fmla="*/ 52994 w 1289611"/>
              <a:gd name="connsiteY7" fmla="*/ 757646 h 1859149"/>
              <a:gd name="connsiteX8" fmla="*/ 44285 w 1289611"/>
              <a:gd name="connsiteY8" fmla="*/ 914400 h 1859149"/>
              <a:gd name="connsiteX9" fmla="*/ 35577 w 1289611"/>
              <a:gd name="connsiteY9" fmla="*/ 966651 h 1859149"/>
              <a:gd name="connsiteX10" fmla="*/ 18160 w 1289611"/>
              <a:gd name="connsiteY10" fmla="*/ 1236617 h 1859149"/>
              <a:gd name="connsiteX11" fmla="*/ 9451 w 1289611"/>
              <a:gd name="connsiteY11" fmla="*/ 1323703 h 1859149"/>
              <a:gd name="connsiteX12" fmla="*/ 18160 w 1289611"/>
              <a:gd name="connsiteY12" fmla="*/ 1541417 h 1859149"/>
              <a:gd name="connsiteX13" fmla="*/ 26868 w 1289611"/>
              <a:gd name="connsiteY13" fmla="*/ 1576251 h 1859149"/>
              <a:gd name="connsiteX14" fmla="*/ 35577 w 1289611"/>
              <a:gd name="connsiteY14" fmla="*/ 1619794 h 1859149"/>
              <a:gd name="connsiteX15" fmla="*/ 61703 w 1289611"/>
              <a:gd name="connsiteY15" fmla="*/ 1698171 h 1859149"/>
              <a:gd name="connsiteX16" fmla="*/ 105245 w 1289611"/>
              <a:gd name="connsiteY16" fmla="*/ 1776549 h 1859149"/>
              <a:gd name="connsiteX17" fmla="*/ 122663 w 1289611"/>
              <a:gd name="connsiteY17" fmla="*/ 1793966 h 1859149"/>
              <a:gd name="connsiteX18" fmla="*/ 174914 w 1289611"/>
              <a:gd name="connsiteY18" fmla="*/ 1811383 h 1859149"/>
              <a:gd name="connsiteX19" fmla="*/ 201040 w 1289611"/>
              <a:gd name="connsiteY19" fmla="*/ 1820091 h 1859149"/>
              <a:gd name="connsiteX20" fmla="*/ 349085 w 1289611"/>
              <a:gd name="connsiteY20" fmla="*/ 1837509 h 1859149"/>
              <a:gd name="connsiteX21" fmla="*/ 976103 w 1289611"/>
              <a:gd name="connsiteY21" fmla="*/ 1837509 h 1859149"/>
              <a:gd name="connsiteX22" fmla="*/ 1010937 w 1289611"/>
              <a:gd name="connsiteY22" fmla="*/ 1828800 h 1859149"/>
              <a:gd name="connsiteX23" fmla="*/ 1063188 w 1289611"/>
              <a:gd name="connsiteY23" fmla="*/ 1820091 h 1859149"/>
              <a:gd name="connsiteX24" fmla="*/ 1089314 w 1289611"/>
              <a:gd name="connsiteY24" fmla="*/ 1811383 h 1859149"/>
              <a:gd name="connsiteX25" fmla="*/ 1150274 w 1289611"/>
              <a:gd name="connsiteY25" fmla="*/ 1793966 h 1859149"/>
              <a:gd name="connsiteX26" fmla="*/ 1176400 w 1289611"/>
              <a:gd name="connsiteY26" fmla="*/ 1776549 h 1859149"/>
              <a:gd name="connsiteX27" fmla="*/ 1202525 w 1289611"/>
              <a:gd name="connsiteY27" fmla="*/ 1767840 h 1859149"/>
              <a:gd name="connsiteX28" fmla="*/ 1237360 w 1289611"/>
              <a:gd name="connsiteY28" fmla="*/ 1715589 h 1859149"/>
              <a:gd name="connsiteX29" fmla="*/ 1254777 w 1289611"/>
              <a:gd name="connsiteY29" fmla="*/ 1698171 h 1859149"/>
              <a:gd name="connsiteX30" fmla="*/ 1280903 w 1289611"/>
              <a:gd name="connsiteY30" fmla="*/ 1576251 h 1859149"/>
              <a:gd name="connsiteX31" fmla="*/ 1289611 w 1289611"/>
              <a:gd name="connsiteY31" fmla="*/ 1349829 h 1859149"/>
              <a:gd name="connsiteX32" fmla="*/ 1280903 w 1289611"/>
              <a:gd name="connsiteY32" fmla="*/ 949234 h 1859149"/>
              <a:gd name="connsiteX33" fmla="*/ 1263485 w 1289611"/>
              <a:gd name="connsiteY33" fmla="*/ 539931 h 1859149"/>
              <a:gd name="connsiteX34" fmla="*/ 1246068 w 1289611"/>
              <a:gd name="connsiteY34" fmla="*/ 139337 h 1859149"/>
              <a:gd name="connsiteX35" fmla="*/ 1219943 w 1289611"/>
              <a:gd name="connsiteY35" fmla="*/ 43543 h 1859149"/>
              <a:gd name="connsiteX36" fmla="*/ 1211234 w 1289611"/>
              <a:gd name="connsiteY36" fmla="*/ 17417 h 1859149"/>
              <a:gd name="connsiteX37" fmla="*/ 1158983 w 1289611"/>
              <a:gd name="connsiteY37" fmla="*/ 0 h 1859149"/>
              <a:gd name="connsiteX38" fmla="*/ 1141565 w 1289611"/>
              <a:gd name="connsiteY38" fmla="*/ 26126 h 1859149"/>
              <a:gd name="connsiteX39" fmla="*/ 1124148 w 1289611"/>
              <a:gd name="connsiteY39" fmla="*/ 87086 h 1859149"/>
              <a:gd name="connsiteX40" fmla="*/ 1115440 w 1289611"/>
              <a:gd name="connsiteY40" fmla="*/ 113211 h 1859149"/>
              <a:gd name="connsiteX41" fmla="*/ 1124148 w 1289611"/>
              <a:gd name="connsiteY41" fmla="*/ 191589 h 1859149"/>
              <a:gd name="connsiteX42" fmla="*/ 1132857 w 1289611"/>
              <a:gd name="connsiteY42" fmla="*/ 243840 h 1859149"/>
              <a:gd name="connsiteX43" fmla="*/ 1141565 w 1289611"/>
              <a:gd name="connsiteY43" fmla="*/ 322217 h 1859149"/>
              <a:gd name="connsiteX44" fmla="*/ 1132857 w 1289611"/>
              <a:gd name="connsiteY44" fmla="*/ 444137 h 1859149"/>
              <a:gd name="connsiteX45" fmla="*/ 1089314 w 1289611"/>
              <a:gd name="connsiteY45" fmla="*/ 435429 h 1859149"/>
              <a:gd name="connsiteX46" fmla="*/ 1080605 w 1289611"/>
              <a:gd name="connsiteY46" fmla="*/ 409303 h 1859149"/>
              <a:gd name="connsiteX47" fmla="*/ 1063188 w 1289611"/>
              <a:gd name="connsiteY47" fmla="*/ 374469 h 1859149"/>
              <a:gd name="connsiteX48" fmla="*/ 1045771 w 1289611"/>
              <a:gd name="connsiteY48" fmla="*/ 322217 h 1859149"/>
              <a:gd name="connsiteX49" fmla="*/ 1037063 w 1289611"/>
              <a:gd name="connsiteY49" fmla="*/ 252549 h 1859149"/>
              <a:gd name="connsiteX50" fmla="*/ 1028354 w 1289611"/>
              <a:gd name="connsiteY50" fmla="*/ 156754 h 1859149"/>
              <a:gd name="connsiteX51" fmla="*/ 1019645 w 1289611"/>
              <a:gd name="connsiteY51" fmla="*/ 130629 h 1859149"/>
              <a:gd name="connsiteX52" fmla="*/ 967394 w 1289611"/>
              <a:gd name="connsiteY52" fmla="*/ 113211 h 1859149"/>
              <a:gd name="connsiteX53" fmla="*/ 949977 w 1289611"/>
              <a:gd name="connsiteY53" fmla="*/ 165463 h 1859149"/>
              <a:gd name="connsiteX54" fmla="*/ 941268 w 1289611"/>
              <a:gd name="connsiteY54" fmla="*/ 191589 h 1859149"/>
              <a:gd name="connsiteX55" fmla="*/ 949977 w 1289611"/>
              <a:gd name="connsiteY55" fmla="*/ 313509 h 1859149"/>
              <a:gd name="connsiteX56" fmla="*/ 958685 w 1289611"/>
              <a:gd name="connsiteY56" fmla="*/ 339634 h 1859149"/>
              <a:gd name="connsiteX57" fmla="*/ 967394 w 1289611"/>
              <a:gd name="connsiteY57" fmla="*/ 374469 h 1859149"/>
              <a:gd name="connsiteX58" fmla="*/ 958685 w 1289611"/>
              <a:gd name="connsiteY58" fmla="*/ 461554 h 1859149"/>
              <a:gd name="connsiteX59" fmla="*/ 932560 w 1289611"/>
              <a:gd name="connsiteY59" fmla="*/ 452846 h 1859149"/>
              <a:gd name="connsiteX60" fmla="*/ 915143 w 1289611"/>
              <a:gd name="connsiteY60" fmla="*/ 426720 h 1859149"/>
              <a:gd name="connsiteX61" fmla="*/ 906434 w 1289611"/>
              <a:gd name="connsiteY61" fmla="*/ 383177 h 1859149"/>
              <a:gd name="connsiteX62" fmla="*/ 889017 w 1289611"/>
              <a:gd name="connsiteY62" fmla="*/ 313509 h 1859149"/>
              <a:gd name="connsiteX63" fmla="*/ 871600 w 1289611"/>
              <a:gd name="connsiteY63" fmla="*/ 191589 h 1859149"/>
              <a:gd name="connsiteX64" fmla="*/ 862891 w 1289611"/>
              <a:gd name="connsiteY64" fmla="*/ 156754 h 1859149"/>
              <a:gd name="connsiteX65" fmla="*/ 810640 w 1289611"/>
              <a:gd name="connsiteY65" fmla="*/ 121920 h 1859149"/>
              <a:gd name="connsiteX66" fmla="*/ 784514 w 1289611"/>
              <a:gd name="connsiteY66" fmla="*/ 104503 h 1859149"/>
              <a:gd name="connsiteX67" fmla="*/ 767097 w 1289611"/>
              <a:gd name="connsiteY67" fmla="*/ 156754 h 1859149"/>
              <a:gd name="connsiteX68" fmla="*/ 784514 w 1289611"/>
              <a:gd name="connsiteY68" fmla="*/ 330926 h 1859149"/>
              <a:gd name="connsiteX69" fmla="*/ 749680 w 1289611"/>
              <a:gd name="connsiteY69" fmla="*/ 452846 h 1859149"/>
              <a:gd name="connsiteX70" fmla="*/ 723554 w 1289611"/>
              <a:gd name="connsiteY70" fmla="*/ 444137 h 1859149"/>
              <a:gd name="connsiteX71" fmla="*/ 697428 w 1289611"/>
              <a:gd name="connsiteY71" fmla="*/ 365760 h 1859149"/>
              <a:gd name="connsiteX72" fmla="*/ 688720 w 1289611"/>
              <a:gd name="connsiteY72" fmla="*/ 339634 h 1859149"/>
              <a:gd name="connsiteX73" fmla="*/ 688720 w 1289611"/>
              <a:gd name="connsiteY73" fmla="*/ 104503 h 1859149"/>
              <a:gd name="connsiteX74" fmla="*/ 662594 w 1289611"/>
              <a:gd name="connsiteY74" fmla="*/ 87086 h 1859149"/>
              <a:gd name="connsiteX75" fmla="*/ 601634 w 1289611"/>
              <a:gd name="connsiteY75" fmla="*/ 156754 h 1859149"/>
              <a:gd name="connsiteX76" fmla="*/ 584217 w 1289611"/>
              <a:gd name="connsiteY76" fmla="*/ 209006 h 1859149"/>
              <a:gd name="connsiteX77" fmla="*/ 592925 w 1289611"/>
              <a:gd name="connsiteY77" fmla="*/ 365760 h 1859149"/>
              <a:gd name="connsiteX78" fmla="*/ 584217 w 1289611"/>
              <a:gd name="connsiteY78" fmla="*/ 452846 h 1859149"/>
              <a:gd name="connsiteX79" fmla="*/ 566800 w 1289611"/>
              <a:gd name="connsiteY79" fmla="*/ 400594 h 1859149"/>
              <a:gd name="connsiteX80" fmla="*/ 549383 w 1289611"/>
              <a:gd name="connsiteY80" fmla="*/ 348343 h 1859149"/>
              <a:gd name="connsiteX81" fmla="*/ 540674 w 1289611"/>
              <a:gd name="connsiteY81" fmla="*/ 322217 h 1859149"/>
              <a:gd name="connsiteX82" fmla="*/ 505840 w 1289611"/>
              <a:gd name="connsiteY82" fmla="*/ 269966 h 1859149"/>
              <a:gd name="connsiteX83" fmla="*/ 505840 w 1289611"/>
              <a:gd name="connsiteY83" fmla="*/ 8709 h 1859149"/>
              <a:gd name="connsiteX84" fmla="*/ 479714 w 1289611"/>
              <a:gd name="connsiteY84" fmla="*/ 0 h 1859149"/>
              <a:gd name="connsiteX85" fmla="*/ 453588 w 1289611"/>
              <a:gd name="connsiteY85" fmla="*/ 8709 h 1859149"/>
              <a:gd name="connsiteX86" fmla="*/ 444880 w 1289611"/>
              <a:gd name="connsiteY86" fmla="*/ 34834 h 1859149"/>
              <a:gd name="connsiteX87" fmla="*/ 410045 w 1289611"/>
              <a:gd name="connsiteY87" fmla="*/ 78377 h 1859149"/>
              <a:gd name="connsiteX88" fmla="*/ 410045 w 1289611"/>
              <a:gd name="connsiteY88" fmla="*/ 243840 h 1859149"/>
              <a:gd name="connsiteX89" fmla="*/ 418754 w 1289611"/>
              <a:gd name="connsiteY89" fmla="*/ 296091 h 1859149"/>
              <a:gd name="connsiteX90" fmla="*/ 427463 w 1289611"/>
              <a:gd name="connsiteY90" fmla="*/ 374469 h 1859149"/>
              <a:gd name="connsiteX91" fmla="*/ 418754 w 1289611"/>
              <a:gd name="connsiteY91" fmla="*/ 461554 h 1859149"/>
              <a:gd name="connsiteX92" fmla="*/ 349085 w 1289611"/>
              <a:gd name="connsiteY92" fmla="*/ 426720 h 1859149"/>
              <a:gd name="connsiteX93" fmla="*/ 331668 w 1289611"/>
              <a:gd name="connsiteY93" fmla="*/ 374469 h 1859149"/>
              <a:gd name="connsiteX94" fmla="*/ 322960 w 1289611"/>
              <a:gd name="connsiteY94" fmla="*/ 165463 h 1859149"/>
              <a:gd name="connsiteX95" fmla="*/ 314251 w 1289611"/>
              <a:gd name="connsiteY95" fmla="*/ 139337 h 1859149"/>
              <a:gd name="connsiteX96" fmla="*/ 296834 w 1289611"/>
              <a:gd name="connsiteY96" fmla="*/ 113211 h 1859149"/>
              <a:gd name="connsiteX97" fmla="*/ 270708 w 1289611"/>
              <a:gd name="connsiteY97" fmla="*/ 95794 h 1859149"/>
              <a:gd name="connsiteX98" fmla="*/ 235874 w 1289611"/>
              <a:gd name="connsiteY98" fmla="*/ 104503 h 1859149"/>
              <a:gd name="connsiteX99" fmla="*/ 209748 w 1289611"/>
              <a:gd name="connsiteY99" fmla="*/ 156754 h 1859149"/>
              <a:gd name="connsiteX100" fmla="*/ 218457 w 1289611"/>
              <a:gd name="connsiteY100" fmla="*/ 278674 h 1859149"/>
              <a:gd name="connsiteX101" fmla="*/ 227165 w 1289611"/>
              <a:gd name="connsiteY101" fmla="*/ 313509 h 1859149"/>
              <a:gd name="connsiteX102" fmla="*/ 235874 w 1289611"/>
              <a:gd name="connsiteY102" fmla="*/ 357051 h 1859149"/>
              <a:gd name="connsiteX103" fmla="*/ 201040 w 1289611"/>
              <a:gd name="connsiteY103" fmla="*/ 487680 h 1859149"/>
              <a:gd name="connsiteX104" fmla="*/ 174914 w 1289611"/>
              <a:gd name="connsiteY104" fmla="*/ 478971 h 1859149"/>
              <a:gd name="connsiteX105" fmla="*/ 157497 w 1289611"/>
              <a:gd name="connsiteY105" fmla="*/ 452846 h 1859149"/>
              <a:gd name="connsiteX106" fmla="*/ 140080 w 1289611"/>
              <a:gd name="connsiteY106" fmla="*/ 400594 h 1859149"/>
              <a:gd name="connsiteX107" fmla="*/ 131371 w 1289611"/>
              <a:gd name="connsiteY107" fmla="*/ 200297 h 1859149"/>
              <a:gd name="connsiteX108" fmla="*/ 157497 w 1289611"/>
              <a:gd name="connsiteY108" fmla="*/ 174171 h 185914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</a:cxnLst>
            <a:rect l="l" t="t" r="r" b="b"/>
            <a:pathLst>
              <a:path w="1289611" h="1859149">
                <a:moveTo>
                  <a:pt x="157497" y="174171"/>
                </a:moveTo>
                <a:cubicBezTo>
                  <a:pt x="142983" y="166914"/>
                  <a:pt x="109336" y="133099"/>
                  <a:pt x="44285" y="156754"/>
                </a:cubicBezTo>
                <a:cubicBezTo>
                  <a:pt x="32711" y="160963"/>
                  <a:pt x="26868" y="174171"/>
                  <a:pt x="18160" y="182880"/>
                </a:cubicBezTo>
                <a:cubicBezTo>
                  <a:pt x="-14822" y="281823"/>
                  <a:pt x="4588" y="213403"/>
                  <a:pt x="18160" y="444137"/>
                </a:cubicBezTo>
                <a:cubicBezTo>
                  <a:pt x="19365" y="464628"/>
                  <a:pt x="24826" y="484673"/>
                  <a:pt x="26868" y="505097"/>
                </a:cubicBezTo>
                <a:cubicBezTo>
                  <a:pt x="30634" y="542758"/>
                  <a:pt x="31811" y="580648"/>
                  <a:pt x="35577" y="618309"/>
                </a:cubicBezTo>
                <a:cubicBezTo>
                  <a:pt x="37619" y="638733"/>
                  <a:pt x="41739" y="658901"/>
                  <a:pt x="44285" y="679269"/>
                </a:cubicBezTo>
                <a:cubicBezTo>
                  <a:pt x="47545" y="705352"/>
                  <a:pt x="50091" y="731520"/>
                  <a:pt x="52994" y="757646"/>
                </a:cubicBezTo>
                <a:cubicBezTo>
                  <a:pt x="50091" y="809897"/>
                  <a:pt x="48631" y="862249"/>
                  <a:pt x="44285" y="914400"/>
                </a:cubicBezTo>
                <a:cubicBezTo>
                  <a:pt x="42819" y="931996"/>
                  <a:pt x="37334" y="949081"/>
                  <a:pt x="35577" y="966651"/>
                </a:cubicBezTo>
                <a:cubicBezTo>
                  <a:pt x="28170" y="1040721"/>
                  <a:pt x="23407" y="1165779"/>
                  <a:pt x="18160" y="1236617"/>
                </a:cubicBezTo>
                <a:cubicBezTo>
                  <a:pt x="16005" y="1265711"/>
                  <a:pt x="12354" y="1294674"/>
                  <a:pt x="9451" y="1323703"/>
                </a:cubicBezTo>
                <a:cubicBezTo>
                  <a:pt x="12354" y="1396274"/>
                  <a:pt x="13163" y="1468960"/>
                  <a:pt x="18160" y="1541417"/>
                </a:cubicBezTo>
                <a:cubicBezTo>
                  <a:pt x="18983" y="1553357"/>
                  <a:pt x="24272" y="1564567"/>
                  <a:pt x="26868" y="1576251"/>
                </a:cubicBezTo>
                <a:cubicBezTo>
                  <a:pt x="30079" y="1590700"/>
                  <a:pt x="31682" y="1605514"/>
                  <a:pt x="35577" y="1619794"/>
                </a:cubicBezTo>
                <a:cubicBezTo>
                  <a:pt x="35589" y="1619837"/>
                  <a:pt x="57342" y="1685087"/>
                  <a:pt x="61703" y="1698171"/>
                </a:cubicBezTo>
                <a:cubicBezTo>
                  <a:pt x="72654" y="1731024"/>
                  <a:pt x="75298" y="1746604"/>
                  <a:pt x="105245" y="1776549"/>
                </a:cubicBezTo>
                <a:cubicBezTo>
                  <a:pt x="111051" y="1782355"/>
                  <a:pt x="115319" y="1790294"/>
                  <a:pt x="122663" y="1793966"/>
                </a:cubicBezTo>
                <a:cubicBezTo>
                  <a:pt x="139084" y="1802176"/>
                  <a:pt x="157497" y="1805577"/>
                  <a:pt x="174914" y="1811383"/>
                </a:cubicBezTo>
                <a:lnTo>
                  <a:pt x="201040" y="1820091"/>
                </a:lnTo>
                <a:cubicBezTo>
                  <a:pt x="265824" y="1841686"/>
                  <a:pt x="217981" y="1828144"/>
                  <a:pt x="349085" y="1837509"/>
                </a:cubicBezTo>
                <a:cubicBezTo>
                  <a:pt x="586588" y="1877090"/>
                  <a:pt x="424407" y="1853272"/>
                  <a:pt x="976103" y="1837509"/>
                </a:cubicBezTo>
                <a:cubicBezTo>
                  <a:pt x="988067" y="1837167"/>
                  <a:pt x="999201" y="1831147"/>
                  <a:pt x="1010937" y="1828800"/>
                </a:cubicBezTo>
                <a:cubicBezTo>
                  <a:pt x="1028251" y="1825337"/>
                  <a:pt x="1045951" y="1823921"/>
                  <a:pt x="1063188" y="1820091"/>
                </a:cubicBezTo>
                <a:cubicBezTo>
                  <a:pt x="1072149" y="1818100"/>
                  <a:pt x="1080488" y="1813905"/>
                  <a:pt x="1089314" y="1811383"/>
                </a:cubicBezTo>
                <a:cubicBezTo>
                  <a:pt x="1165859" y="1789513"/>
                  <a:pt x="1087633" y="1814845"/>
                  <a:pt x="1150274" y="1793966"/>
                </a:cubicBezTo>
                <a:cubicBezTo>
                  <a:pt x="1158983" y="1788160"/>
                  <a:pt x="1167039" y="1781230"/>
                  <a:pt x="1176400" y="1776549"/>
                </a:cubicBezTo>
                <a:cubicBezTo>
                  <a:pt x="1184610" y="1772444"/>
                  <a:pt x="1196034" y="1774331"/>
                  <a:pt x="1202525" y="1767840"/>
                </a:cubicBezTo>
                <a:cubicBezTo>
                  <a:pt x="1217327" y="1753038"/>
                  <a:pt x="1222559" y="1730391"/>
                  <a:pt x="1237360" y="1715589"/>
                </a:cubicBezTo>
                <a:lnTo>
                  <a:pt x="1254777" y="1698171"/>
                </a:lnTo>
                <a:cubicBezTo>
                  <a:pt x="1279595" y="1623717"/>
                  <a:pt x="1269917" y="1664137"/>
                  <a:pt x="1280903" y="1576251"/>
                </a:cubicBezTo>
                <a:cubicBezTo>
                  <a:pt x="1283806" y="1500777"/>
                  <a:pt x="1289611" y="1425359"/>
                  <a:pt x="1289611" y="1349829"/>
                </a:cubicBezTo>
                <a:cubicBezTo>
                  <a:pt x="1289611" y="1216266"/>
                  <a:pt x="1284371" y="1082752"/>
                  <a:pt x="1280903" y="949234"/>
                </a:cubicBezTo>
                <a:cubicBezTo>
                  <a:pt x="1274097" y="687216"/>
                  <a:pt x="1276051" y="740980"/>
                  <a:pt x="1263485" y="539931"/>
                </a:cubicBezTo>
                <a:cubicBezTo>
                  <a:pt x="1259188" y="376634"/>
                  <a:pt x="1267398" y="277986"/>
                  <a:pt x="1246068" y="139337"/>
                </a:cubicBezTo>
                <a:cubicBezTo>
                  <a:pt x="1239034" y="93614"/>
                  <a:pt x="1235499" y="90211"/>
                  <a:pt x="1219943" y="43543"/>
                </a:cubicBezTo>
                <a:cubicBezTo>
                  <a:pt x="1217040" y="34834"/>
                  <a:pt x="1219943" y="20320"/>
                  <a:pt x="1211234" y="17417"/>
                </a:cubicBezTo>
                <a:lnTo>
                  <a:pt x="1158983" y="0"/>
                </a:lnTo>
                <a:cubicBezTo>
                  <a:pt x="1153177" y="8709"/>
                  <a:pt x="1146246" y="16764"/>
                  <a:pt x="1141565" y="26126"/>
                </a:cubicBezTo>
                <a:cubicBezTo>
                  <a:pt x="1134607" y="40042"/>
                  <a:pt x="1127866" y="74071"/>
                  <a:pt x="1124148" y="87086"/>
                </a:cubicBezTo>
                <a:cubicBezTo>
                  <a:pt x="1121626" y="95912"/>
                  <a:pt x="1118343" y="104503"/>
                  <a:pt x="1115440" y="113211"/>
                </a:cubicBezTo>
                <a:cubicBezTo>
                  <a:pt x="1118343" y="139337"/>
                  <a:pt x="1120674" y="165533"/>
                  <a:pt x="1124148" y="191589"/>
                </a:cubicBezTo>
                <a:cubicBezTo>
                  <a:pt x="1126482" y="209091"/>
                  <a:pt x="1130523" y="226338"/>
                  <a:pt x="1132857" y="243840"/>
                </a:cubicBezTo>
                <a:cubicBezTo>
                  <a:pt x="1136331" y="269896"/>
                  <a:pt x="1138662" y="296091"/>
                  <a:pt x="1141565" y="322217"/>
                </a:cubicBezTo>
                <a:cubicBezTo>
                  <a:pt x="1138662" y="362857"/>
                  <a:pt x="1149931" y="407143"/>
                  <a:pt x="1132857" y="444137"/>
                </a:cubicBezTo>
                <a:cubicBezTo>
                  <a:pt x="1126654" y="457576"/>
                  <a:pt x="1101630" y="443639"/>
                  <a:pt x="1089314" y="435429"/>
                </a:cubicBezTo>
                <a:cubicBezTo>
                  <a:pt x="1081676" y="430337"/>
                  <a:pt x="1084221" y="417741"/>
                  <a:pt x="1080605" y="409303"/>
                </a:cubicBezTo>
                <a:cubicBezTo>
                  <a:pt x="1075491" y="397371"/>
                  <a:pt x="1068009" y="386522"/>
                  <a:pt x="1063188" y="374469"/>
                </a:cubicBezTo>
                <a:cubicBezTo>
                  <a:pt x="1056370" y="357423"/>
                  <a:pt x="1045771" y="322217"/>
                  <a:pt x="1045771" y="322217"/>
                </a:cubicBezTo>
                <a:cubicBezTo>
                  <a:pt x="1042868" y="298994"/>
                  <a:pt x="1039513" y="275824"/>
                  <a:pt x="1037063" y="252549"/>
                </a:cubicBezTo>
                <a:cubicBezTo>
                  <a:pt x="1033706" y="220662"/>
                  <a:pt x="1032889" y="188495"/>
                  <a:pt x="1028354" y="156754"/>
                </a:cubicBezTo>
                <a:cubicBezTo>
                  <a:pt x="1027056" y="147667"/>
                  <a:pt x="1027115" y="135964"/>
                  <a:pt x="1019645" y="130629"/>
                </a:cubicBezTo>
                <a:cubicBezTo>
                  <a:pt x="1004705" y="119958"/>
                  <a:pt x="967394" y="113211"/>
                  <a:pt x="967394" y="113211"/>
                </a:cubicBezTo>
                <a:lnTo>
                  <a:pt x="949977" y="165463"/>
                </a:lnTo>
                <a:lnTo>
                  <a:pt x="941268" y="191589"/>
                </a:lnTo>
                <a:cubicBezTo>
                  <a:pt x="944171" y="232229"/>
                  <a:pt x="945216" y="273045"/>
                  <a:pt x="949977" y="313509"/>
                </a:cubicBezTo>
                <a:cubicBezTo>
                  <a:pt x="951050" y="322625"/>
                  <a:pt x="956163" y="330808"/>
                  <a:pt x="958685" y="339634"/>
                </a:cubicBezTo>
                <a:cubicBezTo>
                  <a:pt x="961973" y="351143"/>
                  <a:pt x="964491" y="362857"/>
                  <a:pt x="967394" y="374469"/>
                </a:cubicBezTo>
                <a:cubicBezTo>
                  <a:pt x="964491" y="403497"/>
                  <a:pt x="970533" y="434895"/>
                  <a:pt x="958685" y="461554"/>
                </a:cubicBezTo>
                <a:cubicBezTo>
                  <a:pt x="954957" y="469942"/>
                  <a:pt x="939728" y="458580"/>
                  <a:pt x="932560" y="452846"/>
                </a:cubicBezTo>
                <a:cubicBezTo>
                  <a:pt x="924387" y="446308"/>
                  <a:pt x="920949" y="435429"/>
                  <a:pt x="915143" y="426720"/>
                </a:cubicBezTo>
                <a:cubicBezTo>
                  <a:pt x="912240" y="412206"/>
                  <a:pt x="909762" y="397600"/>
                  <a:pt x="906434" y="383177"/>
                </a:cubicBezTo>
                <a:cubicBezTo>
                  <a:pt x="901051" y="359853"/>
                  <a:pt x="889017" y="313509"/>
                  <a:pt x="889017" y="313509"/>
                </a:cubicBezTo>
                <a:cubicBezTo>
                  <a:pt x="881410" y="245051"/>
                  <a:pt x="883922" y="247038"/>
                  <a:pt x="871600" y="191589"/>
                </a:cubicBezTo>
                <a:cubicBezTo>
                  <a:pt x="869004" y="179905"/>
                  <a:pt x="870773" y="165762"/>
                  <a:pt x="862891" y="156754"/>
                </a:cubicBezTo>
                <a:cubicBezTo>
                  <a:pt x="849107" y="141001"/>
                  <a:pt x="828057" y="133531"/>
                  <a:pt x="810640" y="121920"/>
                </a:cubicBezTo>
                <a:lnTo>
                  <a:pt x="784514" y="104503"/>
                </a:lnTo>
                <a:cubicBezTo>
                  <a:pt x="778708" y="121920"/>
                  <a:pt x="765952" y="138431"/>
                  <a:pt x="767097" y="156754"/>
                </a:cubicBezTo>
                <a:cubicBezTo>
                  <a:pt x="776552" y="308037"/>
                  <a:pt x="764518" y="250944"/>
                  <a:pt x="784514" y="330926"/>
                </a:cubicBezTo>
                <a:cubicBezTo>
                  <a:pt x="782728" y="352362"/>
                  <a:pt x="802556" y="444034"/>
                  <a:pt x="749680" y="452846"/>
                </a:cubicBezTo>
                <a:cubicBezTo>
                  <a:pt x="740625" y="454355"/>
                  <a:pt x="732263" y="447040"/>
                  <a:pt x="723554" y="444137"/>
                </a:cubicBezTo>
                <a:lnTo>
                  <a:pt x="697428" y="365760"/>
                </a:lnTo>
                <a:lnTo>
                  <a:pt x="688720" y="339634"/>
                </a:lnTo>
                <a:cubicBezTo>
                  <a:pt x="691878" y="289110"/>
                  <a:pt x="706843" y="163403"/>
                  <a:pt x="688720" y="104503"/>
                </a:cubicBezTo>
                <a:cubicBezTo>
                  <a:pt x="685642" y="94499"/>
                  <a:pt x="671303" y="92892"/>
                  <a:pt x="662594" y="87086"/>
                </a:cubicBezTo>
                <a:cubicBezTo>
                  <a:pt x="632114" y="107406"/>
                  <a:pt x="616148" y="113211"/>
                  <a:pt x="601634" y="156754"/>
                </a:cubicBezTo>
                <a:lnTo>
                  <a:pt x="584217" y="209006"/>
                </a:lnTo>
                <a:cubicBezTo>
                  <a:pt x="587120" y="261257"/>
                  <a:pt x="592925" y="313428"/>
                  <a:pt x="592925" y="365760"/>
                </a:cubicBezTo>
                <a:cubicBezTo>
                  <a:pt x="592925" y="394933"/>
                  <a:pt x="601721" y="429507"/>
                  <a:pt x="584217" y="452846"/>
                </a:cubicBezTo>
                <a:cubicBezTo>
                  <a:pt x="573201" y="467534"/>
                  <a:pt x="572606" y="418011"/>
                  <a:pt x="566800" y="400594"/>
                </a:cubicBezTo>
                <a:lnTo>
                  <a:pt x="549383" y="348343"/>
                </a:lnTo>
                <a:cubicBezTo>
                  <a:pt x="546480" y="339634"/>
                  <a:pt x="545766" y="329855"/>
                  <a:pt x="540674" y="322217"/>
                </a:cubicBezTo>
                <a:lnTo>
                  <a:pt x="505840" y="269966"/>
                </a:lnTo>
                <a:cubicBezTo>
                  <a:pt x="506802" y="250719"/>
                  <a:pt x="524950" y="61262"/>
                  <a:pt x="505840" y="8709"/>
                </a:cubicBezTo>
                <a:cubicBezTo>
                  <a:pt x="502703" y="82"/>
                  <a:pt x="488423" y="2903"/>
                  <a:pt x="479714" y="0"/>
                </a:cubicBezTo>
                <a:cubicBezTo>
                  <a:pt x="471005" y="2903"/>
                  <a:pt x="460079" y="2218"/>
                  <a:pt x="453588" y="8709"/>
                </a:cubicBezTo>
                <a:cubicBezTo>
                  <a:pt x="447097" y="15200"/>
                  <a:pt x="448985" y="26624"/>
                  <a:pt x="444880" y="34834"/>
                </a:cubicBezTo>
                <a:cubicBezTo>
                  <a:pt x="433893" y="56808"/>
                  <a:pt x="426247" y="62176"/>
                  <a:pt x="410045" y="78377"/>
                </a:cubicBezTo>
                <a:cubicBezTo>
                  <a:pt x="387276" y="146690"/>
                  <a:pt x="397449" y="105287"/>
                  <a:pt x="410045" y="243840"/>
                </a:cubicBezTo>
                <a:cubicBezTo>
                  <a:pt x="411644" y="261425"/>
                  <a:pt x="416420" y="278589"/>
                  <a:pt x="418754" y="296091"/>
                </a:cubicBezTo>
                <a:cubicBezTo>
                  <a:pt x="422228" y="322147"/>
                  <a:pt x="424560" y="348343"/>
                  <a:pt x="427463" y="374469"/>
                </a:cubicBezTo>
                <a:cubicBezTo>
                  <a:pt x="424560" y="403497"/>
                  <a:pt x="436665" y="438526"/>
                  <a:pt x="418754" y="461554"/>
                </a:cubicBezTo>
                <a:cubicBezTo>
                  <a:pt x="388804" y="500061"/>
                  <a:pt x="356959" y="438530"/>
                  <a:pt x="349085" y="426720"/>
                </a:cubicBezTo>
                <a:cubicBezTo>
                  <a:pt x="343279" y="409303"/>
                  <a:pt x="332432" y="392812"/>
                  <a:pt x="331668" y="374469"/>
                </a:cubicBezTo>
                <a:cubicBezTo>
                  <a:pt x="328765" y="304800"/>
                  <a:pt x="328111" y="235002"/>
                  <a:pt x="322960" y="165463"/>
                </a:cubicBezTo>
                <a:cubicBezTo>
                  <a:pt x="322282" y="156308"/>
                  <a:pt x="318356" y="147548"/>
                  <a:pt x="314251" y="139337"/>
                </a:cubicBezTo>
                <a:cubicBezTo>
                  <a:pt x="309570" y="129976"/>
                  <a:pt x="304235" y="120612"/>
                  <a:pt x="296834" y="113211"/>
                </a:cubicBezTo>
                <a:cubicBezTo>
                  <a:pt x="289433" y="105810"/>
                  <a:pt x="279417" y="101600"/>
                  <a:pt x="270708" y="95794"/>
                </a:cubicBezTo>
                <a:cubicBezTo>
                  <a:pt x="259097" y="98697"/>
                  <a:pt x="245832" y="97864"/>
                  <a:pt x="235874" y="104503"/>
                </a:cubicBezTo>
                <a:cubicBezTo>
                  <a:pt x="221405" y="114149"/>
                  <a:pt x="214716" y="141852"/>
                  <a:pt x="209748" y="156754"/>
                </a:cubicBezTo>
                <a:cubicBezTo>
                  <a:pt x="212651" y="197394"/>
                  <a:pt x="213958" y="238180"/>
                  <a:pt x="218457" y="278674"/>
                </a:cubicBezTo>
                <a:cubicBezTo>
                  <a:pt x="219779" y="290570"/>
                  <a:pt x="224569" y="301825"/>
                  <a:pt x="227165" y="313509"/>
                </a:cubicBezTo>
                <a:cubicBezTo>
                  <a:pt x="230376" y="327958"/>
                  <a:pt x="232971" y="342537"/>
                  <a:pt x="235874" y="357051"/>
                </a:cubicBezTo>
                <a:cubicBezTo>
                  <a:pt x="233357" y="392280"/>
                  <a:pt x="264275" y="487680"/>
                  <a:pt x="201040" y="487680"/>
                </a:cubicBezTo>
                <a:cubicBezTo>
                  <a:pt x="191860" y="487680"/>
                  <a:pt x="183623" y="481874"/>
                  <a:pt x="174914" y="478971"/>
                </a:cubicBezTo>
                <a:cubicBezTo>
                  <a:pt x="169108" y="470263"/>
                  <a:pt x="161748" y="462410"/>
                  <a:pt x="157497" y="452846"/>
                </a:cubicBezTo>
                <a:cubicBezTo>
                  <a:pt x="150041" y="436069"/>
                  <a:pt x="140080" y="400594"/>
                  <a:pt x="140080" y="400594"/>
                </a:cubicBezTo>
                <a:cubicBezTo>
                  <a:pt x="137177" y="333828"/>
                  <a:pt x="139031" y="266685"/>
                  <a:pt x="131371" y="200297"/>
                </a:cubicBezTo>
                <a:cubicBezTo>
                  <a:pt x="130171" y="189900"/>
                  <a:pt x="172011" y="181428"/>
                  <a:pt x="157497" y="174171"/>
                </a:cubicBezTo>
                <a:close/>
              </a:path>
            </a:pathLst>
          </a:custGeom>
          <a:solidFill>
            <a:srgbClr val="B3C7E7"/>
          </a:solidFill>
          <a:ln>
            <a:solidFill>
              <a:srgbClr val="2F5597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" name="Oval 12">
            <a:extLst>
              <a:ext uri="{FF2B5EF4-FFF2-40B4-BE49-F238E27FC236}">
                <a16:creationId xmlns:a16="http://schemas.microsoft.com/office/drawing/2014/main" id="{A62D2D59-6817-9C4E-8434-6C53B285CD53}"/>
              </a:ext>
            </a:extLst>
          </p:cNvPr>
          <p:cNvSpPr/>
          <p:nvPr/>
        </p:nvSpPr>
        <p:spPr>
          <a:xfrm>
            <a:off x="6368015" y="4081792"/>
            <a:ext cx="118746" cy="87972"/>
          </a:xfrm>
          <a:prstGeom prst="ellipse">
            <a:avLst/>
          </a:prstGeom>
          <a:solidFill>
            <a:srgbClr val="2F5597"/>
          </a:solidFill>
          <a:ln>
            <a:solidFill>
              <a:srgbClr val="2F5597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4" name="Rounded Rectangle 13">
            <a:extLst>
              <a:ext uri="{FF2B5EF4-FFF2-40B4-BE49-F238E27FC236}">
                <a16:creationId xmlns:a16="http://schemas.microsoft.com/office/drawing/2014/main" id="{AB7F2AA8-53CC-9B4E-AE31-81AB4BDF5735}"/>
              </a:ext>
            </a:extLst>
          </p:cNvPr>
          <p:cNvSpPr/>
          <p:nvPr/>
        </p:nvSpPr>
        <p:spPr>
          <a:xfrm>
            <a:off x="8056889" y="3838525"/>
            <a:ext cx="198317" cy="374686"/>
          </a:xfrm>
          <a:prstGeom prst="roundRect">
            <a:avLst/>
          </a:prstGeom>
          <a:solidFill>
            <a:srgbClr val="A9D28E"/>
          </a:solidFill>
          <a:ln>
            <a:solidFill>
              <a:srgbClr val="54823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5" name="Oval 14">
            <a:extLst>
              <a:ext uri="{FF2B5EF4-FFF2-40B4-BE49-F238E27FC236}">
                <a16:creationId xmlns:a16="http://schemas.microsoft.com/office/drawing/2014/main" id="{F3BD4A38-03FD-2349-94F2-526B3C9391B3}"/>
              </a:ext>
            </a:extLst>
          </p:cNvPr>
          <p:cNvSpPr/>
          <p:nvPr/>
        </p:nvSpPr>
        <p:spPr>
          <a:xfrm>
            <a:off x="8102063" y="4053681"/>
            <a:ext cx="118746" cy="87972"/>
          </a:xfrm>
          <a:prstGeom prst="ellipse">
            <a:avLst/>
          </a:prstGeom>
          <a:solidFill>
            <a:srgbClr val="548234"/>
          </a:solidFill>
          <a:ln>
            <a:solidFill>
              <a:srgbClr val="54823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220E98A-B0E7-1646-B253-DA565512B08D}"/>
              </a:ext>
            </a:extLst>
          </p:cNvPr>
          <p:cNvSpPr txBox="1"/>
          <p:nvPr/>
        </p:nvSpPr>
        <p:spPr>
          <a:xfrm>
            <a:off x="8239057" y="3928659"/>
            <a:ext cx="13131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ea typeface="Arial" charset="0"/>
                <a:cs typeface="Arial" charset="0"/>
              </a:rPr>
              <a:t>HT29-MTX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440D058-1E58-B042-B580-6DE88EB07645}"/>
              </a:ext>
            </a:extLst>
          </p:cNvPr>
          <p:cNvSpPr txBox="1"/>
          <p:nvPr/>
        </p:nvSpPr>
        <p:spPr>
          <a:xfrm>
            <a:off x="6515153" y="4535901"/>
            <a:ext cx="15568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ea typeface="Arial" charset="0"/>
                <a:cs typeface="Arial" charset="0"/>
              </a:rPr>
              <a:t>Dendritic Cell</a:t>
            </a:r>
          </a:p>
        </p:txBody>
      </p:sp>
      <p:sp>
        <p:nvSpPr>
          <p:cNvPr id="18" name="Freeform 17">
            <a:extLst>
              <a:ext uri="{FF2B5EF4-FFF2-40B4-BE49-F238E27FC236}">
                <a16:creationId xmlns:a16="http://schemas.microsoft.com/office/drawing/2014/main" id="{504FF8B7-0A9E-944C-B754-4898FAE64ABD}"/>
              </a:ext>
            </a:extLst>
          </p:cNvPr>
          <p:cNvSpPr/>
          <p:nvPr/>
        </p:nvSpPr>
        <p:spPr>
          <a:xfrm>
            <a:off x="6216670" y="4445767"/>
            <a:ext cx="277739" cy="542912"/>
          </a:xfrm>
          <a:custGeom>
            <a:avLst/>
            <a:gdLst>
              <a:gd name="connsiteX0" fmla="*/ 76200 w 368300"/>
              <a:gd name="connsiteY0" fmla="*/ 0 h 1028700"/>
              <a:gd name="connsiteX1" fmla="*/ 69850 w 368300"/>
              <a:gd name="connsiteY1" fmla="*/ 41275 h 1028700"/>
              <a:gd name="connsiteX2" fmla="*/ 85725 w 368300"/>
              <a:gd name="connsiteY2" fmla="*/ 66675 h 1028700"/>
              <a:gd name="connsiteX3" fmla="*/ 114300 w 368300"/>
              <a:gd name="connsiteY3" fmla="*/ 95250 h 1028700"/>
              <a:gd name="connsiteX4" fmla="*/ 149225 w 368300"/>
              <a:gd name="connsiteY4" fmla="*/ 127000 h 1028700"/>
              <a:gd name="connsiteX5" fmla="*/ 168275 w 368300"/>
              <a:gd name="connsiteY5" fmla="*/ 158750 h 1028700"/>
              <a:gd name="connsiteX6" fmla="*/ 174625 w 368300"/>
              <a:gd name="connsiteY6" fmla="*/ 215900 h 1028700"/>
              <a:gd name="connsiteX7" fmla="*/ 168275 w 368300"/>
              <a:gd name="connsiteY7" fmla="*/ 266700 h 1028700"/>
              <a:gd name="connsiteX8" fmla="*/ 168275 w 368300"/>
              <a:gd name="connsiteY8" fmla="*/ 320675 h 1028700"/>
              <a:gd name="connsiteX9" fmla="*/ 184150 w 368300"/>
              <a:gd name="connsiteY9" fmla="*/ 400050 h 1028700"/>
              <a:gd name="connsiteX10" fmla="*/ 190500 w 368300"/>
              <a:gd name="connsiteY10" fmla="*/ 450850 h 1028700"/>
              <a:gd name="connsiteX11" fmla="*/ 190500 w 368300"/>
              <a:gd name="connsiteY11" fmla="*/ 450850 h 1028700"/>
              <a:gd name="connsiteX12" fmla="*/ 193675 w 368300"/>
              <a:gd name="connsiteY12" fmla="*/ 508000 h 1028700"/>
              <a:gd name="connsiteX13" fmla="*/ 187325 w 368300"/>
              <a:gd name="connsiteY13" fmla="*/ 533400 h 1028700"/>
              <a:gd name="connsiteX14" fmla="*/ 187325 w 368300"/>
              <a:gd name="connsiteY14" fmla="*/ 581025 h 1028700"/>
              <a:gd name="connsiteX15" fmla="*/ 196850 w 368300"/>
              <a:gd name="connsiteY15" fmla="*/ 612775 h 1028700"/>
              <a:gd name="connsiteX16" fmla="*/ 184150 w 368300"/>
              <a:gd name="connsiteY16" fmla="*/ 644525 h 1028700"/>
              <a:gd name="connsiteX17" fmla="*/ 193675 w 368300"/>
              <a:gd name="connsiteY17" fmla="*/ 692150 h 1028700"/>
              <a:gd name="connsiteX18" fmla="*/ 193675 w 368300"/>
              <a:gd name="connsiteY18" fmla="*/ 727075 h 1028700"/>
              <a:gd name="connsiteX19" fmla="*/ 180975 w 368300"/>
              <a:gd name="connsiteY19" fmla="*/ 752475 h 1028700"/>
              <a:gd name="connsiteX20" fmla="*/ 180975 w 368300"/>
              <a:gd name="connsiteY20" fmla="*/ 796925 h 1028700"/>
              <a:gd name="connsiteX21" fmla="*/ 155575 w 368300"/>
              <a:gd name="connsiteY21" fmla="*/ 828675 h 1028700"/>
              <a:gd name="connsiteX22" fmla="*/ 0 w 368300"/>
              <a:gd name="connsiteY22" fmla="*/ 914400 h 1028700"/>
              <a:gd name="connsiteX23" fmla="*/ 44450 w 368300"/>
              <a:gd name="connsiteY23" fmla="*/ 930275 h 1028700"/>
              <a:gd name="connsiteX24" fmla="*/ 79375 w 368300"/>
              <a:gd name="connsiteY24" fmla="*/ 920750 h 1028700"/>
              <a:gd name="connsiteX25" fmla="*/ 130175 w 368300"/>
              <a:gd name="connsiteY25" fmla="*/ 914400 h 1028700"/>
              <a:gd name="connsiteX26" fmla="*/ 139700 w 368300"/>
              <a:gd name="connsiteY26" fmla="*/ 936625 h 1028700"/>
              <a:gd name="connsiteX27" fmla="*/ 133350 w 368300"/>
              <a:gd name="connsiteY27" fmla="*/ 971550 h 1028700"/>
              <a:gd name="connsiteX28" fmla="*/ 123825 w 368300"/>
              <a:gd name="connsiteY28" fmla="*/ 1003300 h 1028700"/>
              <a:gd name="connsiteX29" fmla="*/ 136525 w 368300"/>
              <a:gd name="connsiteY29" fmla="*/ 1022350 h 1028700"/>
              <a:gd name="connsiteX30" fmla="*/ 152400 w 368300"/>
              <a:gd name="connsiteY30" fmla="*/ 1028700 h 1028700"/>
              <a:gd name="connsiteX31" fmla="*/ 152400 w 368300"/>
              <a:gd name="connsiteY31" fmla="*/ 1028700 h 1028700"/>
              <a:gd name="connsiteX32" fmla="*/ 155575 w 368300"/>
              <a:gd name="connsiteY32" fmla="*/ 996950 h 1028700"/>
              <a:gd name="connsiteX33" fmla="*/ 184150 w 368300"/>
              <a:gd name="connsiteY33" fmla="*/ 981075 h 1028700"/>
              <a:gd name="connsiteX34" fmla="*/ 212725 w 368300"/>
              <a:gd name="connsiteY34" fmla="*/ 962025 h 1028700"/>
              <a:gd name="connsiteX35" fmla="*/ 222250 w 368300"/>
              <a:gd name="connsiteY35" fmla="*/ 923925 h 1028700"/>
              <a:gd name="connsiteX36" fmla="*/ 254000 w 368300"/>
              <a:gd name="connsiteY36" fmla="*/ 933450 h 1028700"/>
              <a:gd name="connsiteX37" fmla="*/ 292100 w 368300"/>
              <a:gd name="connsiteY37" fmla="*/ 965200 h 1028700"/>
              <a:gd name="connsiteX38" fmla="*/ 327025 w 368300"/>
              <a:gd name="connsiteY38" fmla="*/ 990600 h 1028700"/>
              <a:gd name="connsiteX39" fmla="*/ 355600 w 368300"/>
              <a:gd name="connsiteY39" fmla="*/ 1009650 h 1028700"/>
              <a:gd name="connsiteX40" fmla="*/ 342900 w 368300"/>
              <a:gd name="connsiteY40" fmla="*/ 971550 h 1028700"/>
              <a:gd name="connsiteX41" fmla="*/ 330200 w 368300"/>
              <a:gd name="connsiteY41" fmla="*/ 936625 h 1028700"/>
              <a:gd name="connsiteX42" fmla="*/ 330200 w 368300"/>
              <a:gd name="connsiteY42" fmla="*/ 936625 h 1028700"/>
              <a:gd name="connsiteX43" fmla="*/ 368300 w 368300"/>
              <a:gd name="connsiteY43" fmla="*/ 908050 h 1028700"/>
              <a:gd name="connsiteX44" fmla="*/ 368300 w 368300"/>
              <a:gd name="connsiteY44" fmla="*/ 908050 h 1028700"/>
              <a:gd name="connsiteX0" fmla="*/ 76200 w 593725"/>
              <a:gd name="connsiteY0" fmla="*/ 0 h 1028700"/>
              <a:gd name="connsiteX1" fmla="*/ 69850 w 593725"/>
              <a:gd name="connsiteY1" fmla="*/ 41275 h 1028700"/>
              <a:gd name="connsiteX2" fmla="*/ 85725 w 593725"/>
              <a:gd name="connsiteY2" fmla="*/ 66675 h 1028700"/>
              <a:gd name="connsiteX3" fmla="*/ 114300 w 593725"/>
              <a:gd name="connsiteY3" fmla="*/ 95250 h 1028700"/>
              <a:gd name="connsiteX4" fmla="*/ 149225 w 593725"/>
              <a:gd name="connsiteY4" fmla="*/ 127000 h 1028700"/>
              <a:gd name="connsiteX5" fmla="*/ 168275 w 593725"/>
              <a:gd name="connsiteY5" fmla="*/ 158750 h 1028700"/>
              <a:gd name="connsiteX6" fmla="*/ 174625 w 593725"/>
              <a:gd name="connsiteY6" fmla="*/ 215900 h 1028700"/>
              <a:gd name="connsiteX7" fmla="*/ 168275 w 593725"/>
              <a:gd name="connsiteY7" fmla="*/ 266700 h 1028700"/>
              <a:gd name="connsiteX8" fmla="*/ 168275 w 593725"/>
              <a:gd name="connsiteY8" fmla="*/ 320675 h 1028700"/>
              <a:gd name="connsiteX9" fmla="*/ 184150 w 593725"/>
              <a:gd name="connsiteY9" fmla="*/ 400050 h 1028700"/>
              <a:gd name="connsiteX10" fmla="*/ 190500 w 593725"/>
              <a:gd name="connsiteY10" fmla="*/ 450850 h 1028700"/>
              <a:gd name="connsiteX11" fmla="*/ 190500 w 593725"/>
              <a:gd name="connsiteY11" fmla="*/ 450850 h 1028700"/>
              <a:gd name="connsiteX12" fmla="*/ 193675 w 593725"/>
              <a:gd name="connsiteY12" fmla="*/ 508000 h 1028700"/>
              <a:gd name="connsiteX13" fmla="*/ 187325 w 593725"/>
              <a:gd name="connsiteY13" fmla="*/ 533400 h 1028700"/>
              <a:gd name="connsiteX14" fmla="*/ 187325 w 593725"/>
              <a:gd name="connsiteY14" fmla="*/ 581025 h 1028700"/>
              <a:gd name="connsiteX15" fmla="*/ 196850 w 593725"/>
              <a:gd name="connsiteY15" fmla="*/ 612775 h 1028700"/>
              <a:gd name="connsiteX16" fmla="*/ 184150 w 593725"/>
              <a:gd name="connsiteY16" fmla="*/ 644525 h 1028700"/>
              <a:gd name="connsiteX17" fmla="*/ 193675 w 593725"/>
              <a:gd name="connsiteY17" fmla="*/ 692150 h 1028700"/>
              <a:gd name="connsiteX18" fmla="*/ 193675 w 593725"/>
              <a:gd name="connsiteY18" fmla="*/ 727075 h 1028700"/>
              <a:gd name="connsiteX19" fmla="*/ 180975 w 593725"/>
              <a:gd name="connsiteY19" fmla="*/ 752475 h 1028700"/>
              <a:gd name="connsiteX20" fmla="*/ 180975 w 593725"/>
              <a:gd name="connsiteY20" fmla="*/ 796925 h 1028700"/>
              <a:gd name="connsiteX21" fmla="*/ 155575 w 593725"/>
              <a:gd name="connsiteY21" fmla="*/ 828675 h 1028700"/>
              <a:gd name="connsiteX22" fmla="*/ 0 w 593725"/>
              <a:gd name="connsiteY22" fmla="*/ 914400 h 1028700"/>
              <a:gd name="connsiteX23" fmla="*/ 44450 w 593725"/>
              <a:gd name="connsiteY23" fmla="*/ 930275 h 1028700"/>
              <a:gd name="connsiteX24" fmla="*/ 79375 w 593725"/>
              <a:gd name="connsiteY24" fmla="*/ 920750 h 1028700"/>
              <a:gd name="connsiteX25" fmla="*/ 130175 w 593725"/>
              <a:gd name="connsiteY25" fmla="*/ 914400 h 1028700"/>
              <a:gd name="connsiteX26" fmla="*/ 139700 w 593725"/>
              <a:gd name="connsiteY26" fmla="*/ 936625 h 1028700"/>
              <a:gd name="connsiteX27" fmla="*/ 133350 w 593725"/>
              <a:gd name="connsiteY27" fmla="*/ 971550 h 1028700"/>
              <a:gd name="connsiteX28" fmla="*/ 123825 w 593725"/>
              <a:gd name="connsiteY28" fmla="*/ 1003300 h 1028700"/>
              <a:gd name="connsiteX29" fmla="*/ 136525 w 593725"/>
              <a:gd name="connsiteY29" fmla="*/ 1022350 h 1028700"/>
              <a:gd name="connsiteX30" fmla="*/ 152400 w 593725"/>
              <a:gd name="connsiteY30" fmla="*/ 1028700 h 1028700"/>
              <a:gd name="connsiteX31" fmla="*/ 152400 w 593725"/>
              <a:gd name="connsiteY31" fmla="*/ 1028700 h 1028700"/>
              <a:gd name="connsiteX32" fmla="*/ 155575 w 593725"/>
              <a:gd name="connsiteY32" fmla="*/ 996950 h 1028700"/>
              <a:gd name="connsiteX33" fmla="*/ 184150 w 593725"/>
              <a:gd name="connsiteY33" fmla="*/ 981075 h 1028700"/>
              <a:gd name="connsiteX34" fmla="*/ 212725 w 593725"/>
              <a:gd name="connsiteY34" fmla="*/ 962025 h 1028700"/>
              <a:gd name="connsiteX35" fmla="*/ 222250 w 593725"/>
              <a:gd name="connsiteY35" fmla="*/ 923925 h 1028700"/>
              <a:gd name="connsiteX36" fmla="*/ 254000 w 593725"/>
              <a:gd name="connsiteY36" fmla="*/ 933450 h 1028700"/>
              <a:gd name="connsiteX37" fmla="*/ 292100 w 593725"/>
              <a:gd name="connsiteY37" fmla="*/ 965200 h 1028700"/>
              <a:gd name="connsiteX38" fmla="*/ 327025 w 593725"/>
              <a:gd name="connsiteY38" fmla="*/ 990600 h 1028700"/>
              <a:gd name="connsiteX39" fmla="*/ 355600 w 593725"/>
              <a:gd name="connsiteY39" fmla="*/ 1009650 h 1028700"/>
              <a:gd name="connsiteX40" fmla="*/ 342900 w 593725"/>
              <a:gd name="connsiteY40" fmla="*/ 971550 h 1028700"/>
              <a:gd name="connsiteX41" fmla="*/ 330200 w 593725"/>
              <a:gd name="connsiteY41" fmla="*/ 936625 h 1028700"/>
              <a:gd name="connsiteX42" fmla="*/ 330200 w 593725"/>
              <a:gd name="connsiteY42" fmla="*/ 936625 h 1028700"/>
              <a:gd name="connsiteX43" fmla="*/ 368300 w 593725"/>
              <a:gd name="connsiteY43" fmla="*/ 908050 h 1028700"/>
              <a:gd name="connsiteX44" fmla="*/ 593725 w 593725"/>
              <a:gd name="connsiteY44" fmla="*/ 457200 h 1028700"/>
              <a:gd name="connsiteX0" fmla="*/ 76200 w 381618"/>
              <a:gd name="connsiteY0" fmla="*/ 3175 h 1031875"/>
              <a:gd name="connsiteX1" fmla="*/ 69850 w 381618"/>
              <a:gd name="connsiteY1" fmla="*/ 44450 h 1031875"/>
              <a:gd name="connsiteX2" fmla="*/ 85725 w 381618"/>
              <a:gd name="connsiteY2" fmla="*/ 69850 h 1031875"/>
              <a:gd name="connsiteX3" fmla="*/ 114300 w 381618"/>
              <a:gd name="connsiteY3" fmla="*/ 98425 h 1031875"/>
              <a:gd name="connsiteX4" fmla="*/ 149225 w 381618"/>
              <a:gd name="connsiteY4" fmla="*/ 130175 h 1031875"/>
              <a:gd name="connsiteX5" fmla="*/ 168275 w 381618"/>
              <a:gd name="connsiteY5" fmla="*/ 161925 h 1031875"/>
              <a:gd name="connsiteX6" fmla="*/ 174625 w 381618"/>
              <a:gd name="connsiteY6" fmla="*/ 219075 h 1031875"/>
              <a:gd name="connsiteX7" fmla="*/ 168275 w 381618"/>
              <a:gd name="connsiteY7" fmla="*/ 269875 h 1031875"/>
              <a:gd name="connsiteX8" fmla="*/ 168275 w 381618"/>
              <a:gd name="connsiteY8" fmla="*/ 323850 h 1031875"/>
              <a:gd name="connsiteX9" fmla="*/ 184150 w 381618"/>
              <a:gd name="connsiteY9" fmla="*/ 403225 h 1031875"/>
              <a:gd name="connsiteX10" fmla="*/ 190500 w 381618"/>
              <a:gd name="connsiteY10" fmla="*/ 454025 h 1031875"/>
              <a:gd name="connsiteX11" fmla="*/ 190500 w 381618"/>
              <a:gd name="connsiteY11" fmla="*/ 454025 h 1031875"/>
              <a:gd name="connsiteX12" fmla="*/ 193675 w 381618"/>
              <a:gd name="connsiteY12" fmla="*/ 511175 h 1031875"/>
              <a:gd name="connsiteX13" fmla="*/ 187325 w 381618"/>
              <a:gd name="connsiteY13" fmla="*/ 536575 h 1031875"/>
              <a:gd name="connsiteX14" fmla="*/ 187325 w 381618"/>
              <a:gd name="connsiteY14" fmla="*/ 584200 h 1031875"/>
              <a:gd name="connsiteX15" fmla="*/ 196850 w 381618"/>
              <a:gd name="connsiteY15" fmla="*/ 615950 h 1031875"/>
              <a:gd name="connsiteX16" fmla="*/ 184150 w 381618"/>
              <a:gd name="connsiteY16" fmla="*/ 647700 h 1031875"/>
              <a:gd name="connsiteX17" fmla="*/ 193675 w 381618"/>
              <a:gd name="connsiteY17" fmla="*/ 695325 h 1031875"/>
              <a:gd name="connsiteX18" fmla="*/ 193675 w 381618"/>
              <a:gd name="connsiteY18" fmla="*/ 730250 h 1031875"/>
              <a:gd name="connsiteX19" fmla="*/ 180975 w 381618"/>
              <a:gd name="connsiteY19" fmla="*/ 755650 h 1031875"/>
              <a:gd name="connsiteX20" fmla="*/ 180975 w 381618"/>
              <a:gd name="connsiteY20" fmla="*/ 800100 h 1031875"/>
              <a:gd name="connsiteX21" fmla="*/ 155575 w 381618"/>
              <a:gd name="connsiteY21" fmla="*/ 831850 h 1031875"/>
              <a:gd name="connsiteX22" fmla="*/ 0 w 381618"/>
              <a:gd name="connsiteY22" fmla="*/ 917575 h 1031875"/>
              <a:gd name="connsiteX23" fmla="*/ 44450 w 381618"/>
              <a:gd name="connsiteY23" fmla="*/ 933450 h 1031875"/>
              <a:gd name="connsiteX24" fmla="*/ 79375 w 381618"/>
              <a:gd name="connsiteY24" fmla="*/ 923925 h 1031875"/>
              <a:gd name="connsiteX25" fmla="*/ 130175 w 381618"/>
              <a:gd name="connsiteY25" fmla="*/ 917575 h 1031875"/>
              <a:gd name="connsiteX26" fmla="*/ 139700 w 381618"/>
              <a:gd name="connsiteY26" fmla="*/ 939800 h 1031875"/>
              <a:gd name="connsiteX27" fmla="*/ 133350 w 381618"/>
              <a:gd name="connsiteY27" fmla="*/ 974725 h 1031875"/>
              <a:gd name="connsiteX28" fmla="*/ 123825 w 381618"/>
              <a:gd name="connsiteY28" fmla="*/ 1006475 h 1031875"/>
              <a:gd name="connsiteX29" fmla="*/ 136525 w 381618"/>
              <a:gd name="connsiteY29" fmla="*/ 1025525 h 1031875"/>
              <a:gd name="connsiteX30" fmla="*/ 152400 w 381618"/>
              <a:gd name="connsiteY30" fmla="*/ 1031875 h 1031875"/>
              <a:gd name="connsiteX31" fmla="*/ 152400 w 381618"/>
              <a:gd name="connsiteY31" fmla="*/ 1031875 h 1031875"/>
              <a:gd name="connsiteX32" fmla="*/ 155575 w 381618"/>
              <a:gd name="connsiteY32" fmla="*/ 1000125 h 1031875"/>
              <a:gd name="connsiteX33" fmla="*/ 184150 w 381618"/>
              <a:gd name="connsiteY33" fmla="*/ 984250 h 1031875"/>
              <a:gd name="connsiteX34" fmla="*/ 212725 w 381618"/>
              <a:gd name="connsiteY34" fmla="*/ 965200 h 1031875"/>
              <a:gd name="connsiteX35" fmla="*/ 222250 w 381618"/>
              <a:gd name="connsiteY35" fmla="*/ 927100 h 1031875"/>
              <a:gd name="connsiteX36" fmla="*/ 254000 w 381618"/>
              <a:gd name="connsiteY36" fmla="*/ 936625 h 1031875"/>
              <a:gd name="connsiteX37" fmla="*/ 292100 w 381618"/>
              <a:gd name="connsiteY37" fmla="*/ 968375 h 1031875"/>
              <a:gd name="connsiteX38" fmla="*/ 327025 w 381618"/>
              <a:gd name="connsiteY38" fmla="*/ 993775 h 1031875"/>
              <a:gd name="connsiteX39" fmla="*/ 355600 w 381618"/>
              <a:gd name="connsiteY39" fmla="*/ 1012825 h 1031875"/>
              <a:gd name="connsiteX40" fmla="*/ 342900 w 381618"/>
              <a:gd name="connsiteY40" fmla="*/ 974725 h 1031875"/>
              <a:gd name="connsiteX41" fmla="*/ 330200 w 381618"/>
              <a:gd name="connsiteY41" fmla="*/ 939800 h 1031875"/>
              <a:gd name="connsiteX42" fmla="*/ 330200 w 381618"/>
              <a:gd name="connsiteY42" fmla="*/ 939800 h 1031875"/>
              <a:gd name="connsiteX43" fmla="*/ 368300 w 381618"/>
              <a:gd name="connsiteY43" fmla="*/ 911225 h 1031875"/>
              <a:gd name="connsiteX44" fmla="*/ 82550 w 381618"/>
              <a:gd name="connsiteY44" fmla="*/ 0 h 1031875"/>
              <a:gd name="connsiteX0" fmla="*/ 76200 w 373739"/>
              <a:gd name="connsiteY0" fmla="*/ 3175 h 1031875"/>
              <a:gd name="connsiteX1" fmla="*/ 69850 w 373739"/>
              <a:gd name="connsiteY1" fmla="*/ 44450 h 1031875"/>
              <a:gd name="connsiteX2" fmla="*/ 85725 w 373739"/>
              <a:gd name="connsiteY2" fmla="*/ 69850 h 1031875"/>
              <a:gd name="connsiteX3" fmla="*/ 114300 w 373739"/>
              <a:gd name="connsiteY3" fmla="*/ 98425 h 1031875"/>
              <a:gd name="connsiteX4" fmla="*/ 149225 w 373739"/>
              <a:gd name="connsiteY4" fmla="*/ 130175 h 1031875"/>
              <a:gd name="connsiteX5" fmla="*/ 168275 w 373739"/>
              <a:gd name="connsiteY5" fmla="*/ 161925 h 1031875"/>
              <a:gd name="connsiteX6" fmla="*/ 174625 w 373739"/>
              <a:gd name="connsiteY6" fmla="*/ 219075 h 1031875"/>
              <a:gd name="connsiteX7" fmla="*/ 168275 w 373739"/>
              <a:gd name="connsiteY7" fmla="*/ 269875 h 1031875"/>
              <a:gd name="connsiteX8" fmla="*/ 168275 w 373739"/>
              <a:gd name="connsiteY8" fmla="*/ 323850 h 1031875"/>
              <a:gd name="connsiteX9" fmla="*/ 184150 w 373739"/>
              <a:gd name="connsiteY9" fmla="*/ 403225 h 1031875"/>
              <a:gd name="connsiteX10" fmla="*/ 190500 w 373739"/>
              <a:gd name="connsiteY10" fmla="*/ 454025 h 1031875"/>
              <a:gd name="connsiteX11" fmla="*/ 190500 w 373739"/>
              <a:gd name="connsiteY11" fmla="*/ 454025 h 1031875"/>
              <a:gd name="connsiteX12" fmla="*/ 193675 w 373739"/>
              <a:gd name="connsiteY12" fmla="*/ 511175 h 1031875"/>
              <a:gd name="connsiteX13" fmla="*/ 187325 w 373739"/>
              <a:gd name="connsiteY13" fmla="*/ 536575 h 1031875"/>
              <a:gd name="connsiteX14" fmla="*/ 187325 w 373739"/>
              <a:gd name="connsiteY14" fmla="*/ 584200 h 1031875"/>
              <a:gd name="connsiteX15" fmla="*/ 196850 w 373739"/>
              <a:gd name="connsiteY15" fmla="*/ 615950 h 1031875"/>
              <a:gd name="connsiteX16" fmla="*/ 184150 w 373739"/>
              <a:gd name="connsiteY16" fmla="*/ 647700 h 1031875"/>
              <a:gd name="connsiteX17" fmla="*/ 193675 w 373739"/>
              <a:gd name="connsiteY17" fmla="*/ 695325 h 1031875"/>
              <a:gd name="connsiteX18" fmla="*/ 193675 w 373739"/>
              <a:gd name="connsiteY18" fmla="*/ 730250 h 1031875"/>
              <a:gd name="connsiteX19" fmla="*/ 180975 w 373739"/>
              <a:gd name="connsiteY19" fmla="*/ 755650 h 1031875"/>
              <a:gd name="connsiteX20" fmla="*/ 180975 w 373739"/>
              <a:gd name="connsiteY20" fmla="*/ 800100 h 1031875"/>
              <a:gd name="connsiteX21" fmla="*/ 155575 w 373739"/>
              <a:gd name="connsiteY21" fmla="*/ 831850 h 1031875"/>
              <a:gd name="connsiteX22" fmla="*/ 0 w 373739"/>
              <a:gd name="connsiteY22" fmla="*/ 917575 h 1031875"/>
              <a:gd name="connsiteX23" fmla="*/ 44450 w 373739"/>
              <a:gd name="connsiteY23" fmla="*/ 933450 h 1031875"/>
              <a:gd name="connsiteX24" fmla="*/ 79375 w 373739"/>
              <a:gd name="connsiteY24" fmla="*/ 923925 h 1031875"/>
              <a:gd name="connsiteX25" fmla="*/ 130175 w 373739"/>
              <a:gd name="connsiteY25" fmla="*/ 917575 h 1031875"/>
              <a:gd name="connsiteX26" fmla="*/ 139700 w 373739"/>
              <a:gd name="connsiteY26" fmla="*/ 939800 h 1031875"/>
              <a:gd name="connsiteX27" fmla="*/ 133350 w 373739"/>
              <a:gd name="connsiteY27" fmla="*/ 974725 h 1031875"/>
              <a:gd name="connsiteX28" fmla="*/ 123825 w 373739"/>
              <a:gd name="connsiteY28" fmla="*/ 1006475 h 1031875"/>
              <a:gd name="connsiteX29" fmla="*/ 136525 w 373739"/>
              <a:gd name="connsiteY29" fmla="*/ 1025525 h 1031875"/>
              <a:gd name="connsiteX30" fmla="*/ 152400 w 373739"/>
              <a:gd name="connsiteY30" fmla="*/ 1031875 h 1031875"/>
              <a:gd name="connsiteX31" fmla="*/ 152400 w 373739"/>
              <a:gd name="connsiteY31" fmla="*/ 1031875 h 1031875"/>
              <a:gd name="connsiteX32" fmla="*/ 155575 w 373739"/>
              <a:gd name="connsiteY32" fmla="*/ 1000125 h 1031875"/>
              <a:gd name="connsiteX33" fmla="*/ 184150 w 373739"/>
              <a:gd name="connsiteY33" fmla="*/ 984250 h 1031875"/>
              <a:gd name="connsiteX34" fmla="*/ 212725 w 373739"/>
              <a:gd name="connsiteY34" fmla="*/ 965200 h 1031875"/>
              <a:gd name="connsiteX35" fmla="*/ 222250 w 373739"/>
              <a:gd name="connsiteY35" fmla="*/ 927100 h 1031875"/>
              <a:gd name="connsiteX36" fmla="*/ 254000 w 373739"/>
              <a:gd name="connsiteY36" fmla="*/ 936625 h 1031875"/>
              <a:gd name="connsiteX37" fmla="*/ 292100 w 373739"/>
              <a:gd name="connsiteY37" fmla="*/ 968375 h 1031875"/>
              <a:gd name="connsiteX38" fmla="*/ 327025 w 373739"/>
              <a:gd name="connsiteY38" fmla="*/ 993775 h 1031875"/>
              <a:gd name="connsiteX39" fmla="*/ 355600 w 373739"/>
              <a:gd name="connsiteY39" fmla="*/ 1012825 h 1031875"/>
              <a:gd name="connsiteX40" fmla="*/ 342900 w 373739"/>
              <a:gd name="connsiteY40" fmla="*/ 974725 h 1031875"/>
              <a:gd name="connsiteX41" fmla="*/ 330200 w 373739"/>
              <a:gd name="connsiteY41" fmla="*/ 939800 h 1031875"/>
              <a:gd name="connsiteX42" fmla="*/ 330200 w 373739"/>
              <a:gd name="connsiteY42" fmla="*/ 939800 h 1031875"/>
              <a:gd name="connsiteX43" fmla="*/ 368300 w 373739"/>
              <a:gd name="connsiteY43" fmla="*/ 911225 h 1031875"/>
              <a:gd name="connsiteX44" fmla="*/ 203200 w 373739"/>
              <a:gd name="connsiteY44" fmla="*/ 190501 h 1031875"/>
              <a:gd name="connsiteX45" fmla="*/ 82550 w 373739"/>
              <a:gd name="connsiteY45" fmla="*/ 0 h 1031875"/>
              <a:gd name="connsiteX0" fmla="*/ 76200 w 373739"/>
              <a:gd name="connsiteY0" fmla="*/ 3175 h 1031875"/>
              <a:gd name="connsiteX1" fmla="*/ 69850 w 373739"/>
              <a:gd name="connsiteY1" fmla="*/ 44450 h 1031875"/>
              <a:gd name="connsiteX2" fmla="*/ 85725 w 373739"/>
              <a:gd name="connsiteY2" fmla="*/ 69850 h 1031875"/>
              <a:gd name="connsiteX3" fmla="*/ 114300 w 373739"/>
              <a:gd name="connsiteY3" fmla="*/ 98425 h 1031875"/>
              <a:gd name="connsiteX4" fmla="*/ 149225 w 373739"/>
              <a:gd name="connsiteY4" fmla="*/ 130175 h 1031875"/>
              <a:gd name="connsiteX5" fmla="*/ 168275 w 373739"/>
              <a:gd name="connsiteY5" fmla="*/ 161925 h 1031875"/>
              <a:gd name="connsiteX6" fmla="*/ 174625 w 373739"/>
              <a:gd name="connsiteY6" fmla="*/ 219075 h 1031875"/>
              <a:gd name="connsiteX7" fmla="*/ 168275 w 373739"/>
              <a:gd name="connsiteY7" fmla="*/ 269875 h 1031875"/>
              <a:gd name="connsiteX8" fmla="*/ 168275 w 373739"/>
              <a:gd name="connsiteY8" fmla="*/ 323850 h 1031875"/>
              <a:gd name="connsiteX9" fmla="*/ 184150 w 373739"/>
              <a:gd name="connsiteY9" fmla="*/ 403225 h 1031875"/>
              <a:gd name="connsiteX10" fmla="*/ 190500 w 373739"/>
              <a:gd name="connsiteY10" fmla="*/ 454025 h 1031875"/>
              <a:gd name="connsiteX11" fmla="*/ 190500 w 373739"/>
              <a:gd name="connsiteY11" fmla="*/ 454025 h 1031875"/>
              <a:gd name="connsiteX12" fmla="*/ 193675 w 373739"/>
              <a:gd name="connsiteY12" fmla="*/ 511175 h 1031875"/>
              <a:gd name="connsiteX13" fmla="*/ 187325 w 373739"/>
              <a:gd name="connsiteY13" fmla="*/ 536575 h 1031875"/>
              <a:gd name="connsiteX14" fmla="*/ 187325 w 373739"/>
              <a:gd name="connsiteY14" fmla="*/ 584200 h 1031875"/>
              <a:gd name="connsiteX15" fmla="*/ 196850 w 373739"/>
              <a:gd name="connsiteY15" fmla="*/ 615950 h 1031875"/>
              <a:gd name="connsiteX16" fmla="*/ 184150 w 373739"/>
              <a:gd name="connsiteY16" fmla="*/ 647700 h 1031875"/>
              <a:gd name="connsiteX17" fmla="*/ 193675 w 373739"/>
              <a:gd name="connsiteY17" fmla="*/ 695325 h 1031875"/>
              <a:gd name="connsiteX18" fmla="*/ 193675 w 373739"/>
              <a:gd name="connsiteY18" fmla="*/ 730250 h 1031875"/>
              <a:gd name="connsiteX19" fmla="*/ 180975 w 373739"/>
              <a:gd name="connsiteY19" fmla="*/ 755650 h 1031875"/>
              <a:gd name="connsiteX20" fmla="*/ 180975 w 373739"/>
              <a:gd name="connsiteY20" fmla="*/ 800100 h 1031875"/>
              <a:gd name="connsiteX21" fmla="*/ 155575 w 373739"/>
              <a:gd name="connsiteY21" fmla="*/ 831850 h 1031875"/>
              <a:gd name="connsiteX22" fmla="*/ 0 w 373739"/>
              <a:gd name="connsiteY22" fmla="*/ 917575 h 1031875"/>
              <a:gd name="connsiteX23" fmla="*/ 44450 w 373739"/>
              <a:gd name="connsiteY23" fmla="*/ 933450 h 1031875"/>
              <a:gd name="connsiteX24" fmla="*/ 79375 w 373739"/>
              <a:gd name="connsiteY24" fmla="*/ 923925 h 1031875"/>
              <a:gd name="connsiteX25" fmla="*/ 130175 w 373739"/>
              <a:gd name="connsiteY25" fmla="*/ 917575 h 1031875"/>
              <a:gd name="connsiteX26" fmla="*/ 139700 w 373739"/>
              <a:gd name="connsiteY26" fmla="*/ 939800 h 1031875"/>
              <a:gd name="connsiteX27" fmla="*/ 133350 w 373739"/>
              <a:gd name="connsiteY27" fmla="*/ 974725 h 1031875"/>
              <a:gd name="connsiteX28" fmla="*/ 123825 w 373739"/>
              <a:gd name="connsiteY28" fmla="*/ 1006475 h 1031875"/>
              <a:gd name="connsiteX29" fmla="*/ 136525 w 373739"/>
              <a:gd name="connsiteY29" fmla="*/ 1025525 h 1031875"/>
              <a:gd name="connsiteX30" fmla="*/ 152400 w 373739"/>
              <a:gd name="connsiteY30" fmla="*/ 1031875 h 1031875"/>
              <a:gd name="connsiteX31" fmla="*/ 152400 w 373739"/>
              <a:gd name="connsiteY31" fmla="*/ 1031875 h 1031875"/>
              <a:gd name="connsiteX32" fmla="*/ 155575 w 373739"/>
              <a:gd name="connsiteY32" fmla="*/ 1000125 h 1031875"/>
              <a:gd name="connsiteX33" fmla="*/ 184150 w 373739"/>
              <a:gd name="connsiteY33" fmla="*/ 984250 h 1031875"/>
              <a:gd name="connsiteX34" fmla="*/ 212725 w 373739"/>
              <a:gd name="connsiteY34" fmla="*/ 965200 h 1031875"/>
              <a:gd name="connsiteX35" fmla="*/ 222250 w 373739"/>
              <a:gd name="connsiteY35" fmla="*/ 927100 h 1031875"/>
              <a:gd name="connsiteX36" fmla="*/ 254000 w 373739"/>
              <a:gd name="connsiteY36" fmla="*/ 936625 h 1031875"/>
              <a:gd name="connsiteX37" fmla="*/ 292100 w 373739"/>
              <a:gd name="connsiteY37" fmla="*/ 968375 h 1031875"/>
              <a:gd name="connsiteX38" fmla="*/ 327025 w 373739"/>
              <a:gd name="connsiteY38" fmla="*/ 993775 h 1031875"/>
              <a:gd name="connsiteX39" fmla="*/ 355600 w 373739"/>
              <a:gd name="connsiteY39" fmla="*/ 1012825 h 1031875"/>
              <a:gd name="connsiteX40" fmla="*/ 342900 w 373739"/>
              <a:gd name="connsiteY40" fmla="*/ 974725 h 1031875"/>
              <a:gd name="connsiteX41" fmla="*/ 330200 w 373739"/>
              <a:gd name="connsiteY41" fmla="*/ 939800 h 1031875"/>
              <a:gd name="connsiteX42" fmla="*/ 330200 w 373739"/>
              <a:gd name="connsiteY42" fmla="*/ 939800 h 1031875"/>
              <a:gd name="connsiteX43" fmla="*/ 368300 w 373739"/>
              <a:gd name="connsiteY43" fmla="*/ 911225 h 1031875"/>
              <a:gd name="connsiteX44" fmla="*/ 203200 w 373739"/>
              <a:gd name="connsiteY44" fmla="*/ 190501 h 1031875"/>
              <a:gd name="connsiteX45" fmla="*/ 203201 w 373739"/>
              <a:gd name="connsiteY45" fmla="*/ 95251 h 1031875"/>
              <a:gd name="connsiteX46" fmla="*/ 82550 w 373739"/>
              <a:gd name="connsiteY46" fmla="*/ 0 h 1031875"/>
              <a:gd name="connsiteX0" fmla="*/ 76200 w 373739"/>
              <a:gd name="connsiteY0" fmla="*/ 3175 h 1031875"/>
              <a:gd name="connsiteX1" fmla="*/ 69850 w 373739"/>
              <a:gd name="connsiteY1" fmla="*/ 44450 h 1031875"/>
              <a:gd name="connsiteX2" fmla="*/ 85725 w 373739"/>
              <a:gd name="connsiteY2" fmla="*/ 69850 h 1031875"/>
              <a:gd name="connsiteX3" fmla="*/ 114300 w 373739"/>
              <a:gd name="connsiteY3" fmla="*/ 98425 h 1031875"/>
              <a:gd name="connsiteX4" fmla="*/ 149225 w 373739"/>
              <a:gd name="connsiteY4" fmla="*/ 130175 h 1031875"/>
              <a:gd name="connsiteX5" fmla="*/ 168275 w 373739"/>
              <a:gd name="connsiteY5" fmla="*/ 161925 h 1031875"/>
              <a:gd name="connsiteX6" fmla="*/ 174625 w 373739"/>
              <a:gd name="connsiteY6" fmla="*/ 219075 h 1031875"/>
              <a:gd name="connsiteX7" fmla="*/ 168275 w 373739"/>
              <a:gd name="connsiteY7" fmla="*/ 269875 h 1031875"/>
              <a:gd name="connsiteX8" fmla="*/ 168275 w 373739"/>
              <a:gd name="connsiteY8" fmla="*/ 323850 h 1031875"/>
              <a:gd name="connsiteX9" fmla="*/ 184150 w 373739"/>
              <a:gd name="connsiteY9" fmla="*/ 403225 h 1031875"/>
              <a:gd name="connsiteX10" fmla="*/ 190500 w 373739"/>
              <a:gd name="connsiteY10" fmla="*/ 454025 h 1031875"/>
              <a:gd name="connsiteX11" fmla="*/ 190500 w 373739"/>
              <a:gd name="connsiteY11" fmla="*/ 454025 h 1031875"/>
              <a:gd name="connsiteX12" fmla="*/ 193675 w 373739"/>
              <a:gd name="connsiteY12" fmla="*/ 511175 h 1031875"/>
              <a:gd name="connsiteX13" fmla="*/ 187325 w 373739"/>
              <a:gd name="connsiteY13" fmla="*/ 536575 h 1031875"/>
              <a:gd name="connsiteX14" fmla="*/ 187325 w 373739"/>
              <a:gd name="connsiteY14" fmla="*/ 584200 h 1031875"/>
              <a:gd name="connsiteX15" fmla="*/ 196850 w 373739"/>
              <a:gd name="connsiteY15" fmla="*/ 615950 h 1031875"/>
              <a:gd name="connsiteX16" fmla="*/ 184150 w 373739"/>
              <a:gd name="connsiteY16" fmla="*/ 647700 h 1031875"/>
              <a:gd name="connsiteX17" fmla="*/ 193675 w 373739"/>
              <a:gd name="connsiteY17" fmla="*/ 695325 h 1031875"/>
              <a:gd name="connsiteX18" fmla="*/ 193675 w 373739"/>
              <a:gd name="connsiteY18" fmla="*/ 730250 h 1031875"/>
              <a:gd name="connsiteX19" fmla="*/ 180975 w 373739"/>
              <a:gd name="connsiteY19" fmla="*/ 755650 h 1031875"/>
              <a:gd name="connsiteX20" fmla="*/ 180975 w 373739"/>
              <a:gd name="connsiteY20" fmla="*/ 800100 h 1031875"/>
              <a:gd name="connsiteX21" fmla="*/ 155575 w 373739"/>
              <a:gd name="connsiteY21" fmla="*/ 831850 h 1031875"/>
              <a:gd name="connsiteX22" fmla="*/ 0 w 373739"/>
              <a:gd name="connsiteY22" fmla="*/ 917575 h 1031875"/>
              <a:gd name="connsiteX23" fmla="*/ 44450 w 373739"/>
              <a:gd name="connsiteY23" fmla="*/ 933450 h 1031875"/>
              <a:gd name="connsiteX24" fmla="*/ 79375 w 373739"/>
              <a:gd name="connsiteY24" fmla="*/ 923925 h 1031875"/>
              <a:gd name="connsiteX25" fmla="*/ 130175 w 373739"/>
              <a:gd name="connsiteY25" fmla="*/ 917575 h 1031875"/>
              <a:gd name="connsiteX26" fmla="*/ 139700 w 373739"/>
              <a:gd name="connsiteY26" fmla="*/ 939800 h 1031875"/>
              <a:gd name="connsiteX27" fmla="*/ 133350 w 373739"/>
              <a:gd name="connsiteY27" fmla="*/ 974725 h 1031875"/>
              <a:gd name="connsiteX28" fmla="*/ 123825 w 373739"/>
              <a:gd name="connsiteY28" fmla="*/ 1006475 h 1031875"/>
              <a:gd name="connsiteX29" fmla="*/ 136525 w 373739"/>
              <a:gd name="connsiteY29" fmla="*/ 1025525 h 1031875"/>
              <a:gd name="connsiteX30" fmla="*/ 152400 w 373739"/>
              <a:gd name="connsiteY30" fmla="*/ 1031875 h 1031875"/>
              <a:gd name="connsiteX31" fmla="*/ 152400 w 373739"/>
              <a:gd name="connsiteY31" fmla="*/ 1031875 h 1031875"/>
              <a:gd name="connsiteX32" fmla="*/ 155575 w 373739"/>
              <a:gd name="connsiteY32" fmla="*/ 1000125 h 1031875"/>
              <a:gd name="connsiteX33" fmla="*/ 184150 w 373739"/>
              <a:gd name="connsiteY33" fmla="*/ 984250 h 1031875"/>
              <a:gd name="connsiteX34" fmla="*/ 212725 w 373739"/>
              <a:gd name="connsiteY34" fmla="*/ 965200 h 1031875"/>
              <a:gd name="connsiteX35" fmla="*/ 222250 w 373739"/>
              <a:gd name="connsiteY35" fmla="*/ 927100 h 1031875"/>
              <a:gd name="connsiteX36" fmla="*/ 254000 w 373739"/>
              <a:gd name="connsiteY36" fmla="*/ 936625 h 1031875"/>
              <a:gd name="connsiteX37" fmla="*/ 292100 w 373739"/>
              <a:gd name="connsiteY37" fmla="*/ 968375 h 1031875"/>
              <a:gd name="connsiteX38" fmla="*/ 327025 w 373739"/>
              <a:gd name="connsiteY38" fmla="*/ 993775 h 1031875"/>
              <a:gd name="connsiteX39" fmla="*/ 355600 w 373739"/>
              <a:gd name="connsiteY39" fmla="*/ 1012825 h 1031875"/>
              <a:gd name="connsiteX40" fmla="*/ 342900 w 373739"/>
              <a:gd name="connsiteY40" fmla="*/ 974725 h 1031875"/>
              <a:gd name="connsiteX41" fmla="*/ 330200 w 373739"/>
              <a:gd name="connsiteY41" fmla="*/ 939800 h 1031875"/>
              <a:gd name="connsiteX42" fmla="*/ 330200 w 373739"/>
              <a:gd name="connsiteY42" fmla="*/ 939800 h 1031875"/>
              <a:gd name="connsiteX43" fmla="*/ 368300 w 373739"/>
              <a:gd name="connsiteY43" fmla="*/ 911225 h 1031875"/>
              <a:gd name="connsiteX44" fmla="*/ 203200 w 373739"/>
              <a:gd name="connsiteY44" fmla="*/ 190501 h 1031875"/>
              <a:gd name="connsiteX45" fmla="*/ 212726 w 373739"/>
              <a:gd name="connsiteY45" fmla="*/ 101601 h 1031875"/>
              <a:gd name="connsiteX46" fmla="*/ 82550 w 373739"/>
              <a:gd name="connsiteY46" fmla="*/ 0 h 1031875"/>
              <a:gd name="connsiteX0" fmla="*/ 76200 w 376085"/>
              <a:gd name="connsiteY0" fmla="*/ 3175 h 1031875"/>
              <a:gd name="connsiteX1" fmla="*/ 69850 w 376085"/>
              <a:gd name="connsiteY1" fmla="*/ 44450 h 1031875"/>
              <a:gd name="connsiteX2" fmla="*/ 85725 w 376085"/>
              <a:gd name="connsiteY2" fmla="*/ 69850 h 1031875"/>
              <a:gd name="connsiteX3" fmla="*/ 114300 w 376085"/>
              <a:gd name="connsiteY3" fmla="*/ 98425 h 1031875"/>
              <a:gd name="connsiteX4" fmla="*/ 149225 w 376085"/>
              <a:gd name="connsiteY4" fmla="*/ 130175 h 1031875"/>
              <a:gd name="connsiteX5" fmla="*/ 168275 w 376085"/>
              <a:gd name="connsiteY5" fmla="*/ 161925 h 1031875"/>
              <a:gd name="connsiteX6" fmla="*/ 174625 w 376085"/>
              <a:gd name="connsiteY6" fmla="*/ 219075 h 1031875"/>
              <a:gd name="connsiteX7" fmla="*/ 168275 w 376085"/>
              <a:gd name="connsiteY7" fmla="*/ 269875 h 1031875"/>
              <a:gd name="connsiteX8" fmla="*/ 168275 w 376085"/>
              <a:gd name="connsiteY8" fmla="*/ 323850 h 1031875"/>
              <a:gd name="connsiteX9" fmla="*/ 184150 w 376085"/>
              <a:gd name="connsiteY9" fmla="*/ 403225 h 1031875"/>
              <a:gd name="connsiteX10" fmla="*/ 190500 w 376085"/>
              <a:gd name="connsiteY10" fmla="*/ 454025 h 1031875"/>
              <a:gd name="connsiteX11" fmla="*/ 190500 w 376085"/>
              <a:gd name="connsiteY11" fmla="*/ 454025 h 1031875"/>
              <a:gd name="connsiteX12" fmla="*/ 193675 w 376085"/>
              <a:gd name="connsiteY12" fmla="*/ 511175 h 1031875"/>
              <a:gd name="connsiteX13" fmla="*/ 187325 w 376085"/>
              <a:gd name="connsiteY13" fmla="*/ 536575 h 1031875"/>
              <a:gd name="connsiteX14" fmla="*/ 187325 w 376085"/>
              <a:gd name="connsiteY14" fmla="*/ 584200 h 1031875"/>
              <a:gd name="connsiteX15" fmla="*/ 196850 w 376085"/>
              <a:gd name="connsiteY15" fmla="*/ 615950 h 1031875"/>
              <a:gd name="connsiteX16" fmla="*/ 184150 w 376085"/>
              <a:gd name="connsiteY16" fmla="*/ 647700 h 1031875"/>
              <a:gd name="connsiteX17" fmla="*/ 193675 w 376085"/>
              <a:gd name="connsiteY17" fmla="*/ 695325 h 1031875"/>
              <a:gd name="connsiteX18" fmla="*/ 193675 w 376085"/>
              <a:gd name="connsiteY18" fmla="*/ 730250 h 1031875"/>
              <a:gd name="connsiteX19" fmla="*/ 180975 w 376085"/>
              <a:gd name="connsiteY19" fmla="*/ 755650 h 1031875"/>
              <a:gd name="connsiteX20" fmla="*/ 180975 w 376085"/>
              <a:gd name="connsiteY20" fmla="*/ 800100 h 1031875"/>
              <a:gd name="connsiteX21" fmla="*/ 155575 w 376085"/>
              <a:gd name="connsiteY21" fmla="*/ 831850 h 1031875"/>
              <a:gd name="connsiteX22" fmla="*/ 0 w 376085"/>
              <a:gd name="connsiteY22" fmla="*/ 917575 h 1031875"/>
              <a:gd name="connsiteX23" fmla="*/ 44450 w 376085"/>
              <a:gd name="connsiteY23" fmla="*/ 933450 h 1031875"/>
              <a:gd name="connsiteX24" fmla="*/ 79375 w 376085"/>
              <a:gd name="connsiteY24" fmla="*/ 923925 h 1031875"/>
              <a:gd name="connsiteX25" fmla="*/ 130175 w 376085"/>
              <a:gd name="connsiteY25" fmla="*/ 917575 h 1031875"/>
              <a:gd name="connsiteX26" fmla="*/ 139700 w 376085"/>
              <a:gd name="connsiteY26" fmla="*/ 939800 h 1031875"/>
              <a:gd name="connsiteX27" fmla="*/ 133350 w 376085"/>
              <a:gd name="connsiteY27" fmla="*/ 974725 h 1031875"/>
              <a:gd name="connsiteX28" fmla="*/ 123825 w 376085"/>
              <a:gd name="connsiteY28" fmla="*/ 1006475 h 1031875"/>
              <a:gd name="connsiteX29" fmla="*/ 136525 w 376085"/>
              <a:gd name="connsiteY29" fmla="*/ 1025525 h 1031875"/>
              <a:gd name="connsiteX30" fmla="*/ 152400 w 376085"/>
              <a:gd name="connsiteY30" fmla="*/ 1031875 h 1031875"/>
              <a:gd name="connsiteX31" fmla="*/ 152400 w 376085"/>
              <a:gd name="connsiteY31" fmla="*/ 1031875 h 1031875"/>
              <a:gd name="connsiteX32" fmla="*/ 155575 w 376085"/>
              <a:gd name="connsiteY32" fmla="*/ 1000125 h 1031875"/>
              <a:gd name="connsiteX33" fmla="*/ 184150 w 376085"/>
              <a:gd name="connsiteY33" fmla="*/ 984250 h 1031875"/>
              <a:gd name="connsiteX34" fmla="*/ 212725 w 376085"/>
              <a:gd name="connsiteY34" fmla="*/ 965200 h 1031875"/>
              <a:gd name="connsiteX35" fmla="*/ 222250 w 376085"/>
              <a:gd name="connsiteY35" fmla="*/ 927100 h 1031875"/>
              <a:gd name="connsiteX36" fmla="*/ 254000 w 376085"/>
              <a:gd name="connsiteY36" fmla="*/ 936625 h 1031875"/>
              <a:gd name="connsiteX37" fmla="*/ 292100 w 376085"/>
              <a:gd name="connsiteY37" fmla="*/ 968375 h 1031875"/>
              <a:gd name="connsiteX38" fmla="*/ 327025 w 376085"/>
              <a:gd name="connsiteY38" fmla="*/ 993775 h 1031875"/>
              <a:gd name="connsiteX39" fmla="*/ 355600 w 376085"/>
              <a:gd name="connsiteY39" fmla="*/ 1012825 h 1031875"/>
              <a:gd name="connsiteX40" fmla="*/ 342900 w 376085"/>
              <a:gd name="connsiteY40" fmla="*/ 974725 h 1031875"/>
              <a:gd name="connsiteX41" fmla="*/ 330200 w 376085"/>
              <a:gd name="connsiteY41" fmla="*/ 939800 h 1031875"/>
              <a:gd name="connsiteX42" fmla="*/ 330200 w 376085"/>
              <a:gd name="connsiteY42" fmla="*/ 939800 h 1031875"/>
              <a:gd name="connsiteX43" fmla="*/ 347325 w 376085"/>
              <a:gd name="connsiteY43" fmla="*/ 908846 h 1031875"/>
              <a:gd name="connsiteX44" fmla="*/ 368300 w 376085"/>
              <a:gd name="connsiteY44" fmla="*/ 911225 h 1031875"/>
              <a:gd name="connsiteX45" fmla="*/ 203200 w 376085"/>
              <a:gd name="connsiteY45" fmla="*/ 190501 h 1031875"/>
              <a:gd name="connsiteX46" fmla="*/ 212726 w 376085"/>
              <a:gd name="connsiteY46" fmla="*/ 101601 h 1031875"/>
              <a:gd name="connsiteX47" fmla="*/ 82550 w 376085"/>
              <a:gd name="connsiteY47" fmla="*/ 0 h 1031875"/>
              <a:gd name="connsiteX0" fmla="*/ 76200 w 355600"/>
              <a:gd name="connsiteY0" fmla="*/ 3175 h 1031875"/>
              <a:gd name="connsiteX1" fmla="*/ 69850 w 355600"/>
              <a:gd name="connsiteY1" fmla="*/ 44450 h 1031875"/>
              <a:gd name="connsiteX2" fmla="*/ 85725 w 355600"/>
              <a:gd name="connsiteY2" fmla="*/ 69850 h 1031875"/>
              <a:gd name="connsiteX3" fmla="*/ 114300 w 355600"/>
              <a:gd name="connsiteY3" fmla="*/ 98425 h 1031875"/>
              <a:gd name="connsiteX4" fmla="*/ 149225 w 355600"/>
              <a:gd name="connsiteY4" fmla="*/ 130175 h 1031875"/>
              <a:gd name="connsiteX5" fmla="*/ 168275 w 355600"/>
              <a:gd name="connsiteY5" fmla="*/ 161925 h 1031875"/>
              <a:gd name="connsiteX6" fmla="*/ 174625 w 355600"/>
              <a:gd name="connsiteY6" fmla="*/ 219075 h 1031875"/>
              <a:gd name="connsiteX7" fmla="*/ 168275 w 355600"/>
              <a:gd name="connsiteY7" fmla="*/ 269875 h 1031875"/>
              <a:gd name="connsiteX8" fmla="*/ 168275 w 355600"/>
              <a:gd name="connsiteY8" fmla="*/ 323850 h 1031875"/>
              <a:gd name="connsiteX9" fmla="*/ 184150 w 355600"/>
              <a:gd name="connsiteY9" fmla="*/ 403225 h 1031875"/>
              <a:gd name="connsiteX10" fmla="*/ 190500 w 355600"/>
              <a:gd name="connsiteY10" fmla="*/ 454025 h 1031875"/>
              <a:gd name="connsiteX11" fmla="*/ 190500 w 355600"/>
              <a:gd name="connsiteY11" fmla="*/ 454025 h 1031875"/>
              <a:gd name="connsiteX12" fmla="*/ 193675 w 355600"/>
              <a:gd name="connsiteY12" fmla="*/ 511175 h 1031875"/>
              <a:gd name="connsiteX13" fmla="*/ 187325 w 355600"/>
              <a:gd name="connsiteY13" fmla="*/ 536575 h 1031875"/>
              <a:gd name="connsiteX14" fmla="*/ 187325 w 355600"/>
              <a:gd name="connsiteY14" fmla="*/ 584200 h 1031875"/>
              <a:gd name="connsiteX15" fmla="*/ 196850 w 355600"/>
              <a:gd name="connsiteY15" fmla="*/ 615950 h 1031875"/>
              <a:gd name="connsiteX16" fmla="*/ 184150 w 355600"/>
              <a:gd name="connsiteY16" fmla="*/ 647700 h 1031875"/>
              <a:gd name="connsiteX17" fmla="*/ 193675 w 355600"/>
              <a:gd name="connsiteY17" fmla="*/ 695325 h 1031875"/>
              <a:gd name="connsiteX18" fmla="*/ 193675 w 355600"/>
              <a:gd name="connsiteY18" fmla="*/ 730250 h 1031875"/>
              <a:gd name="connsiteX19" fmla="*/ 180975 w 355600"/>
              <a:gd name="connsiteY19" fmla="*/ 755650 h 1031875"/>
              <a:gd name="connsiteX20" fmla="*/ 180975 w 355600"/>
              <a:gd name="connsiteY20" fmla="*/ 800100 h 1031875"/>
              <a:gd name="connsiteX21" fmla="*/ 155575 w 355600"/>
              <a:gd name="connsiteY21" fmla="*/ 831850 h 1031875"/>
              <a:gd name="connsiteX22" fmla="*/ 0 w 355600"/>
              <a:gd name="connsiteY22" fmla="*/ 917575 h 1031875"/>
              <a:gd name="connsiteX23" fmla="*/ 44450 w 355600"/>
              <a:gd name="connsiteY23" fmla="*/ 933450 h 1031875"/>
              <a:gd name="connsiteX24" fmla="*/ 79375 w 355600"/>
              <a:gd name="connsiteY24" fmla="*/ 923925 h 1031875"/>
              <a:gd name="connsiteX25" fmla="*/ 130175 w 355600"/>
              <a:gd name="connsiteY25" fmla="*/ 917575 h 1031875"/>
              <a:gd name="connsiteX26" fmla="*/ 139700 w 355600"/>
              <a:gd name="connsiteY26" fmla="*/ 939800 h 1031875"/>
              <a:gd name="connsiteX27" fmla="*/ 133350 w 355600"/>
              <a:gd name="connsiteY27" fmla="*/ 974725 h 1031875"/>
              <a:gd name="connsiteX28" fmla="*/ 123825 w 355600"/>
              <a:gd name="connsiteY28" fmla="*/ 1006475 h 1031875"/>
              <a:gd name="connsiteX29" fmla="*/ 136525 w 355600"/>
              <a:gd name="connsiteY29" fmla="*/ 1025525 h 1031875"/>
              <a:gd name="connsiteX30" fmla="*/ 152400 w 355600"/>
              <a:gd name="connsiteY30" fmla="*/ 1031875 h 1031875"/>
              <a:gd name="connsiteX31" fmla="*/ 152400 w 355600"/>
              <a:gd name="connsiteY31" fmla="*/ 1031875 h 1031875"/>
              <a:gd name="connsiteX32" fmla="*/ 155575 w 355600"/>
              <a:gd name="connsiteY32" fmla="*/ 1000125 h 1031875"/>
              <a:gd name="connsiteX33" fmla="*/ 184150 w 355600"/>
              <a:gd name="connsiteY33" fmla="*/ 984250 h 1031875"/>
              <a:gd name="connsiteX34" fmla="*/ 212725 w 355600"/>
              <a:gd name="connsiteY34" fmla="*/ 965200 h 1031875"/>
              <a:gd name="connsiteX35" fmla="*/ 222250 w 355600"/>
              <a:gd name="connsiteY35" fmla="*/ 927100 h 1031875"/>
              <a:gd name="connsiteX36" fmla="*/ 254000 w 355600"/>
              <a:gd name="connsiteY36" fmla="*/ 936625 h 1031875"/>
              <a:gd name="connsiteX37" fmla="*/ 292100 w 355600"/>
              <a:gd name="connsiteY37" fmla="*/ 968375 h 1031875"/>
              <a:gd name="connsiteX38" fmla="*/ 327025 w 355600"/>
              <a:gd name="connsiteY38" fmla="*/ 993775 h 1031875"/>
              <a:gd name="connsiteX39" fmla="*/ 355600 w 355600"/>
              <a:gd name="connsiteY39" fmla="*/ 1012825 h 1031875"/>
              <a:gd name="connsiteX40" fmla="*/ 342900 w 355600"/>
              <a:gd name="connsiteY40" fmla="*/ 974725 h 1031875"/>
              <a:gd name="connsiteX41" fmla="*/ 330200 w 355600"/>
              <a:gd name="connsiteY41" fmla="*/ 939800 h 1031875"/>
              <a:gd name="connsiteX42" fmla="*/ 330200 w 355600"/>
              <a:gd name="connsiteY42" fmla="*/ 939800 h 1031875"/>
              <a:gd name="connsiteX43" fmla="*/ 347325 w 355600"/>
              <a:gd name="connsiteY43" fmla="*/ 908846 h 1031875"/>
              <a:gd name="connsiteX44" fmla="*/ 276225 w 355600"/>
              <a:gd name="connsiteY44" fmla="*/ 835025 h 1031875"/>
              <a:gd name="connsiteX45" fmla="*/ 203200 w 355600"/>
              <a:gd name="connsiteY45" fmla="*/ 190501 h 1031875"/>
              <a:gd name="connsiteX46" fmla="*/ 212726 w 355600"/>
              <a:gd name="connsiteY46" fmla="*/ 101601 h 1031875"/>
              <a:gd name="connsiteX47" fmla="*/ 82550 w 355600"/>
              <a:gd name="connsiteY47" fmla="*/ 0 h 1031875"/>
              <a:gd name="connsiteX0" fmla="*/ 76200 w 407929"/>
              <a:gd name="connsiteY0" fmla="*/ 3175 h 1031875"/>
              <a:gd name="connsiteX1" fmla="*/ 69850 w 407929"/>
              <a:gd name="connsiteY1" fmla="*/ 44450 h 1031875"/>
              <a:gd name="connsiteX2" fmla="*/ 85725 w 407929"/>
              <a:gd name="connsiteY2" fmla="*/ 69850 h 1031875"/>
              <a:gd name="connsiteX3" fmla="*/ 114300 w 407929"/>
              <a:gd name="connsiteY3" fmla="*/ 98425 h 1031875"/>
              <a:gd name="connsiteX4" fmla="*/ 149225 w 407929"/>
              <a:gd name="connsiteY4" fmla="*/ 130175 h 1031875"/>
              <a:gd name="connsiteX5" fmla="*/ 168275 w 407929"/>
              <a:gd name="connsiteY5" fmla="*/ 161925 h 1031875"/>
              <a:gd name="connsiteX6" fmla="*/ 174625 w 407929"/>
              <a:gd name="connsiteY6" fmla="*/ 219075 h 1031875"/>
              <a:gd name="connsiteX7" fmla="*/ 168275 w 407929"/>
              <a:gd name="connsiteY7" fmla="*/ 269875 h 1031875"/>
              <a:gd name="connsiteX8" fmla="*/ 168275 w 407929"/>
              <a:gd name="connsiteY8" fmla="*/ 323850 h 1031875"/>
              <a:gd name="connsiteX9" fmla="*/ 184150 w 407929"/>
              <a:gd name="connsiteY9" fmla="*/ 403225 h 1031875"/>
              <a:gd name="connsiteX10" fmla="*/ 190500 w 407929"/>
              <a:gd name="connsiteY10" fmla="*/ 454025 h 1031875"/>
              <a:gd name="connsiteX11" fmla="*/ 190500 w 407929"/>
              <a:gd name="connsiteY11" fmla="*/ 454025 h 1031875"/>
              <a:gd name="connsiteX12" fmla="*/ 193675 w 407929"/>
              <a:gd name="connsiteY12" fmla="*/ 511175 h 1031875"/>
              <a:gd name="connsiteX13" fmla="*/ 187325 w 407929"/>
              <a:gd name="connsiteY13" fmla="*/ 536575 h 1031875"/>
              <a:gd name="connsiteX14" fmla="*/ 187325 w 407929"/>
              <a:gd name="connsiteY14" fmla="*/ 584200 h 1031875"/>
              <a:gd name="connsiteX15" fmla="*/ 196850 w 407929"/>
              <a:gd name="connsiteY15" fmla="*/ 615950 h 1031875"/>
              <a:gd name="connsiteX16" fmla="*/ 184150 w 407929"/>
              <a:gd name="connsiteY16" fmla="*/ 647700 h 1031875"/>
              <a:gd name="connsiteX17" fmla="*/ 193675 w 407929"/>
              <a:gd name="connsiteY17" fmla="*/ 695325 h 1031875"/>
              <a:gd name="connsiteX18" fmla="*/ 193675 w 407929"/>
              <a:gd name="connsiteY18" fmla="*/ 730250 h 1031875"/>
              <a:gd name="connsiteX19" fmla="*/ 180975 w 407929"/>
              <a:gd name="connsiteY19" fmla="*/ 755650 h 1031875"/>
              <a:gd name="connsiteX20" fmla="*/ 180975 w 407929"/>
              <a:gd name="connsiteY20" fmla="*/ 800100 h 1031875"/>
              <a:gd name="connsiteX21" fmla="*/ 155575 w 407929"/>
              <a:gd name="connsiteY21" fmla="*/ 831850 h 1031875"/>
              <a:gd name="connsiteX22" fmla="*/ 0 w 407929"/>
              <a:gd name="connsiteY22" fmla="*/ 917575 h 1031875"/>
              <a:gd name="connsiteX23" fmla="*/ 44450 w 407929"/>
              <a:gd name="connsiteY23" fmla="*/ 933450 h 1031875"/>
              <a:gd name="connsiteX24" fmla="*/ 79375 w 407929"/>
              <a:gd name="connsiteY24" fmla="*/ 923925 h 1031875"/>
              <a:gd name="connsiteX25" fmla="*/ 130175 w 407929"/>
              <a:gd name="connsiteY25" fmla="*/ 917575 h 1031875"/>
              <a:gd name="connsiteX26" fmla="*/ 139700 w 407929"/>
              <a:gd name="connsiteY26" fmla="*/ 939800 h 1031875"/>
              <a:gd name="connsiteX27" fmla="*/ 133350 w 407929"/>
              <a:gd name="connsiteY27" fmla="*/ 974725 h 1031875"/>
              <a:gd name="connsiteX28" fmla="*/ 123825 w 407929"/>
              <a:gd name="connsiteY28" fmla="*/ 1006475 h 1031875"/>
              <a:gd name="connsiteX29" fmla="*/ 136525 w 407929"/>
              <a:gd name="connsiteY29" fmla="*/ 1025525 h 1031875"/>
              <a:gd name="connsiteX30" fmla="*/ 152400 w 407929"/>
              <a:gd name="connsiteY30" fmla="*/ 1031875 h 1031875"/>
              <a:gd name="connsiteX31" fmla="*/ 152400 w 407929"/>
              <a:gd name="connsiteY31" fmla="*/ 1031875 h 1031875"/>
              <a:gd name="connsiteX32" fmla="*/ 155575 w 407929"/>
              <a:gd name="connsiteY32" fmla="*/ 1000125 h 1031875"/>
              <a:gd name="connsiteX33" fmla="*/ 184150 w 407929"/>
              <a:gd name="connsiteY33" fmla="*/ 984250 h 1031875"/>
              <a:gd name="connsiteX34" fmla="*/ 212725 w 407929"/>
              <a:gd name="connsiteY34" fmla="*/ 965200 h 1031875"/>
              <a:gd name="connsiteX35" fmla="*/ 222250 w 407929"/>
              <a:gd name="connsiteY35" fmla="*/ 927100 h 1031875"/>
              <a:gd name="connsiteX36" fmla="*/ 254000 w 407929"/>
              <a:gd name="connsiteY36" fmla="*/ 936625 h 1031875"/>
              <a:gd name="connsiteX37" fmla="*/ 292100 w 407929"/>
              <a:gd name="connsiteY37" fmla="*/ 968375 h 1031875"/>
              <a:gd name="connsiteX38" fmla="*/ 327025 w 407929"/>
              <a:gd name="connsiteY38" fmla="*/ 993775 h 1031875"/>
              <a:gd name="connsiteX39" fmla="*/ 355600 w 407929"/>
              <a:gd name="connsiteY39" fmla="*/ 1012825 h 1031875"/>
              <a:gd name="connsiteX40" fmla="*/ 342900 w 407929"/>
              <a:gd name="connsiteY40" fmla="*/ 974725 h 1031875"/>
              <a:gd name="connsiteX41" fmla="*/ 330200 w 407929"/>
              <a:gd name="connsiteY41" fmla="*/ 939800 h 1031875"/>
              <a:gd name="connsiteX42" fmla="*/ 330200 w 407929"/>
              <a:gd name="connsiteY42" fmla="*/ 939800 h 1031875"/>
              <a:gd name="connsiteX43" fmla="*/ 407650 w 407929"/>
              <a:gd name="connsiteY43" fmla="*/ 883446 h 1031875"/>
              <a:gd name="connsiteX44" fmla="*/ 276225 w 407929"/>
              <a:gd name="connsiteY44" fmla="*/ 835025 h 1031875"/>
              <a:gd name="connsiteX45" fmla="*/ 203200 w 407929"/>
              <a:gd name="connsiteY45" fmla="*/ 190501 h 1031875"/>
              <a:gd name="connsiteX46" fmla="*/ 212726 w 407929"/>
              <a:gd name="connsiteY46" fmla="*/ 101601 h 1031875"/>
              <a:gd name="connsiteX47" fmla="*/ 82550 w 407929"/>
              <a:gd name="connsiteY47" fmla="*/ 0 h 1031875"/>
              <a:gd name="connsiteX0" fmla="*/ 76200 w 407917"/>
              <a:gd name="connsiteY0" fmla="*/ 3175 h 1031875"/>
              <a:gd name="connsiteX1" fmla="*/ 69850 w 407917"/>
              <a:gd name="connsiteY1" fmla="*/ 44450 h 1031875"/>
              <a:gd name="connsiteX2" fmla="*/ 85725 w 407917"/>
              <a:gd name="connsiteY2" fmla="*/ 69850 h 1031875"/>
              <a:gd name="connsiteX3" fmla="*/ 114300 w 407917"/>
              <a:gd name="connsiteY3" fmla="*/ 98425 h 1031875"/>
              <a:gd name="connsiteX4" fmla="*/ 149225 w 407917"/>
              <a:gd name="connsiteY4" fmla="*/ 130175 h 1031875"/>
              <a:gd name="connsiteX5" fmla="*/ 168275 w 407917"/>
              <a:gd name="connsiteY5" fmla="*/ 161925 h 1031875"/>
              <a:gd name="connsiteX6" fmla="*/ 174625 w 407917"/>
              <a:gd name="connsiteY6" fmla="*/ 219075 h 1031875"/>
              <a:gd name="connsiteX7" fmla="*/ 168275 w 407917"/>
              <a:gd name="connsiteY7" fmla="*/ 269875 h 1031875"/>
              <a:gd name="connsiteX8" fmla="*/ 168275 w 407917"/>
              <a:gd name="connsiteY8" fmla="*/ 323850 h 1031875"/>
              <a:gd name="connsiteX9" fmla="*/ 184150 w 407917"/>
              <a:gd name="connsiteY9" fmla="*/ 403225 h 1031875"/>
              <a:gd name="connsiteX10" fmla="*/ 190500 w 407917"/>
              <a:gd name="connsiteY10" fmla="*/ 454025 h 1031875"/>
              <a:gd name="connsiteX11" fmla="*/ 190500 w 407917"/>
              <a:gd name="connsiteY11" fmla="*/ 454025 h 1031875"/>
              <a:gd name="connsiteX12" fmla="*/ 193675 w 407917"/>
              <a:gd name="connsiteY12" fmla="*/ 511175 h 1031875"/>
              <a:gd name="connsiteX13" fmla="*/ 187325 w 407917"/>
              <a:gd name="connsiteY13" fmla="*/ 536575 h 1031875"/>
              <a:gd name="connsiteX14" fmla="*/ 187325 w 407917"/>
              <a:gd name="connsiteY14" fmla="*/ 584200 h 1031875"/>
              <a:gd name="connsiteX15" fmla="*/ 196850 w 407917"/>
              <a:gd name="connsiteY15" fmla="*/ 615950 h 1031875"/>
              <a:gd name="connsiteX16" fmla="*/ 184150 w 407917"/>
              <a:gd name="connsiteY16" fmla="*/ 647700 h 1031875"/>
              <a:gd name="connsiteX17" fmla="*/ 193675 w 407917"/>
              <a:gd name="connsiteY17" fmla="*/ 695325 h 1031875"/>
              <a:gd name="connsiteX18" fmla="*/ 193675 w 407917"/>
              <a:gd name="connsiteY18" fmla="*/ 730250 h 1031875"/>
              <a:gd name="connsiteX19" fmla="*/ 180975 w 407917"/>
              <a:gd name="connsiteY19" fmla="*/ 755650 h 1031875"/>
              <a:gd name="connsiteX20" fmla="*/ 180975 w 407917"/>
              <a:gd name="connsiteY20" fmla="*/ 800100 h 1031875"/>
              <a:gd name="connsiteX21" fmla="*/ 155575 w 407917"/>
              <a:gd name="connsiteY21" fmla="*/ 831850 h 1031875"/>
              <a:gd name="connsiteX22" fmla="*/ 0 w 407917"/>
              <a:gd name="connsiteY22" fmla="*/ 917575 h 1031875"/>
              <a:gd name="connsiteX23" fmla="*/ 44450 w 407917"/>
              <a:gd name="connsiteY23" fmla="*/ 933450 h 1031875"/>
              <a:gd name="connsiteX24" fmla="*/ 79375 w 407917"/>
              <a:gd name="connsiteY24" fmla="*/ 923925 h 1031875"/>
              <a:gd name="connsiteX25" fmla="*/ 130175 w 407917"/>
              <a:gd name="connsiteY25" fmla="*/ 917575 h 1031875"/>
              <a:gd name="connsiteX26" fmla="*/ 139700 w 407917"/>
              <a:gd name="connsiteY26" fmla="*/ 939800 h 1031875"/>
              <a:gd name="connsiteX27" fmla="*/ 133350 w 407917"/>
              <a:gd name="connsiteY27" fmla="*/ 974725 h 1031875"/>
              <a:gd name="connsiteX28" fmla="*/ 123825 w 407917"/>
              <a:gd name="connsiteY28" fmla="*/ 1006475 h 1031875"/>
              <a:gd name="connsiteX29" fmla="*/ 136525 w 407917"/>
              <a:gd name="connsiteY29" fmla="*/ 1025525 h 1031875"/>
              <a:gd name="connsiteX30" fmla="*/ 152400 w 407917"/>
              <a:gd name="connsiteY30" fmla="*/ 1031875 h 1031875"/>
              <a:gd name="connsiteX31" fmla="*/ 152400 w 407917"/>
              <a:gd name="connsiteY31" fmla="*/ 1031875 h 1031875"/>
              <a:gd name="connsiteX32" fmla="*/ 155575 w 407917"/>
              <a:gd name="connsiteY32" fmla="*/ 1000125 h 1031875"/>
              <a:gd name="connsiteX33" fmla="*/ 184150 w 407917"/>
              <a:gd name="connsiteY33" fmla="*/ 984250 h 1031875"/>
              <a:gd name="connsiteX34" fmla="*/ 212725 w 407917"/>
              <a:gd name="connsiteY34" fmla="*/ 965200 h 1031875"/>
              <a:gd name="connsiteX35" fmla="*/ 222250 w 407917"/>
              <a:gd name="connsiteY35" fmla="*/ 927100 h 1031875"/>
              <a:gd name="connsiteX36" fmla="*/ 254000 w 407917"/>
              <a:gd name="connsiteY36" fmla="*/ 936625 h 1031875"/>
              <a:gd name="connsiteX37" fmla="*/ 292100 w 407917"/>
              <a:gd name="connsiteY37" fmla="*/ 968375 h 1031875"/>
              <a:gd name="connsiteX38" fmla="*/ 327025 w 407917"/>
              <a:gd name="connsiteY38" fmla="*/ 993775 h 1031875"/>
              <a:gd name="connsiteX39" fmla="*/ 355600 w 407917"/>
              <a:gd name="connsiteY39" fmla="*/ 1012825 h 1031875"/>
              <a:gd name="connsiteX40" fmla="*/ 342900 w 407917"/>
              <a:gd name="connsiteY40" fmla="*/ 974725 h 1031875"/>
              <a:gd name="connsiteX41" fmla="*/ 330200 w 407917"/>
              <a:gd name="connsiteY41" fmla="*/ 939800 h 1031875"/>
              <a:gd name="connsiteX42" fmla="*/ 330200 w 407917"/>
              <a:gd name="connsiteY42" fmla="*/ 939800 h 1031875"/>
              <a:gd name="connsiteX43" fmla="*/ 407650 w 407917"/>
              <a:gd name="connsiteY43" fmla="*/ 883446 h 1031875"/>
              <a:gd name="connsiteX44" fmla="*/ 276225 w 407917"/>
              <a:gd name="connsiteY44" fmla="*/ 835025 h 1031875"/>
              <a:gd name="connsiteX45" fmla="*/ 233025 w 407917"/>
              <a:gd name="connsiteY45" fmla="*/ 740571 h 1031875"/>
              <a:gd name="connsiteX46" fmla="*/ 203200 w 407917"/>
              <a:gd name="connsiteY46" fmla="*/ 190501 h 1031875"/>
              <a:gd name="connsiteX47" fmla="*/ 212726 w 407917"/>
              <a:gd name="connsiteY47" fmla="*/ 101601 h 1031875"/>
              <a:gd name="connsiteX48" fmla="*/ 82550 w 407917"/>
              <a:gd name="connsiteY48" fmla="*/ 0 h 1031875"/>
              <a:gd name="connsiteX0" fmla="*/ 76200 w 407917"/>
              <a:gd name="connsiteY0" fmla="*/ 3175 h 1031875"/>
              <a:gd name="connsiteX1" fmla="*/ 69850 w 407917"/>
              <a:gd name="connsiteY1" fmla="*/ 44450 h 1031875"/>
              <a:gd name="connsiteX2" fmla="*/ 85725 w 407917"/>
              <a:gd name="connsiteY2" fmla="*/ 69850 h 1031875"/>
              <a:gd name="connsiteX3" fmla="*/ 114300 w 407917"/>
              <a:gd name="connsiteY3" fmla="*/ 98425 h 1031875"/>
              <a:gd name="connsiteX4" fmla="*/ 149225 w 407917"/>
              <a:gd name="connsiteY4" fmla="*/ 130175 h 1031875"/>
              <a:gd name="connsiteX5" fmla="*/ 168275 w 407917"/>
              <a:gd name="connsiteY5" fmla="*/ 161925 h 1031875"/>
              <a:gd name="connsiteX6" fmla="*/ 174625 w 407917"/>
              <a:gd name="connsiteY6" fmla="*/ 219075 h 1031875"/>
              <a:gd name="connsiteX7" fmla="*/ 168275 w 407917"/>
              <a:gd name="connsiteY7" fmla="*/ 269875 h 1031875"/>
              <a:gd name="connsiteX8" fmla="*/ 168275 w 407917"/>
              <a:gd name="connsiteY8" fmla="*/ 323850 h 1031875"/>
              <a:gd name="connsiteX9" fmla="*/ 184150 w 407917"/>
              <a:gd name="connsiteY9" fmla="*/ 403225 h 1031875"/>
              <a:gd name="connsiteX10" fmla="*/ 190500 w 407917"/>
              <a:gd name="connsiteY10" fmla="*/ 454025 h 1031875"/>
              <a:gd name="connsiteX11" fmla="*/ 190500 w 407917"/>
              <a:gd name="connsiteY11" fmla="*/ 454025 h 1031875"/>
              <a:gd name="connsiteX12" fmla="*/ 193675 w 407917"/>
              <a:gd name="connsiteY12" fmla="*/ 511175 h 1031875"/>
              <a:gd name="connsiteX13" fmla="*/ 187325 w 407917"/>
              <a:gd name="connsiteY13" fmla="*/ 536575 h 1031875"/>
              <a:gd name="connsiteX14" fmla="*/ 187325 w 407917"/>
              <a:gd name="connsiteY14" fmla="*/ 584200 h 1031875"/>
              <a:gd name="connsiteX15" fmla="*/ 196850 w 407917"/>
              <a:gd name="connsiteY15" fmla="*/ 615950 h 1031875"/>
              <a:gd name="connsiteX16" fmla="*/ 184150 w 407917"/>
              <a:gd name="connsiteY16" fmla="*/ 647700 h 1031875"/>
              <a:gd name="connsiteX17" fmla="*/ 193675 w 407917"/>
              <a:gd name="connsiteY17" fmla="*/ 695325 h 1031875"/>
              <a:gd name="connsiteX18" fmla="*/ 193675 w 407917"/>
              <a:gd name="connsiteY18" fmla="*/ 730250 h 1031875"/>
              <a:gd name="connsiteX19" fmla="*/ 180975 w 407917"/>
              <a:gd name="connsiteY19" fmla="*/ 755650 h 1031875"/>
              <a:gd name="connsiteX20" fmla="*/ 180975 w 407917"/>
              <a:gd name="connsiteY20" fmla="*/ 800100 h 1031875"/>
              <a:gd name="connsiteX21" fmla="*/ 155575 w 407917"/>
              <a:gd name="connsiteY21" fmla="*/ 831850 h 1031875"/>
              <a:gd name="connsiteX22" fmla="*/ 0 w 407917"/>
              <a:gd name="connsiteY22" fmla="*/ 917575 h 1031875"/>
              <a:gd name="connsiteX23" fmla="*/ 44450 w 407917"/>
              <a:gd name="connsiteY23" fmla="*/ 933450 h 1031875"/>
              <a:gd name="connsiteX24" fmla="*/ 79375 w 407917"/>
              <a:gd name="connsiteY24" fmla="*/ 923925 h 1031875"/>
              <a:gd name="connsiteX25" fmla="*/ 130175 w 407917"/>
              <a:gd name="connsiteY25" fmla="*/ 917575 h 1031875"/>
              <a:gd name="connsiteX26" fmla="*/ 139700 w 407917"/>
              <a:gd name="connsiteY26" fmla="*/ 939800 h 1031875"/>
              <a:gd name="connsiteX27" fmla="*/ 133350 w 407917"/>
              <a:gd name="connsiteY27" fmla="*/ 974725 h 1031875"/>
              <a:gd name="connsiteX28" fmla="*/ 123825 w 407917"/>
              <a:gd name="connsiteY28" fmla="*/ 1006475 h 1031875"/>
              <a:gd name="connsiteX29" fmla="*/ 136525 w 407917"/>
              <a:gd name="connsiteY29" fmla="*/ 1025525 h 1031875"/>
              <a:gd name="connsiteX30" fmla="*/ 152400 w 407917"/>
              <a:gd name="connsiteY30" fmla="*/ 1031875 h 1031875"/>
              <a:gd name="connsiteX31" fmla="*/ 152400 w 407917"/>
              <a:gd name="connsiteY31" fmla="*/ 1031875 h 1031875"/>
              <a:gd name="connsiteX32" fmla="*/ 155575 w 407917"/>
              <a:gd name="connsiteY32" fmla="*/ 1000125 h 1031875"/>
              <a:gd name="connsiteX33" fmla="*/ 184150 w 407917"/>
              <a:gd name="connsiteY33" fmla="*/ 984250 h 1031875"/>
              <a:gd name="connsiteX34" fmla="*/ 212725 w 407917"/>
              <a:gd name="connsiteY34" fmla="*/ 965200 h 1031875"/>
              <a:gd name="connsiteX35" fmla="*/ 222250 w 407917"/>
              <a:gd name="connsiteY35" fmla="*/ 927100 h 1031875"/>
              <a:gd name="connsiteX36" fmla="*/ 254000 w 407917"/>
              <a:gd name="connsiteY36" fmla="*/ 936625 h 1031875"/>
              <a:gd name="connsiteX37" fmla="*/ 292100 w 407917"/>
              <a:gd name="connsiteY37" fmla="*/ 968375 h 1031875"/>
              <a:gd name="connsiteX38" fmla="*/ 327025 w 407917"/>
              <a:gd name="connsiteY38" fmla="*/ 993775 h 1031875"/>
              <a:gd name="connsiteX39" fmla="*/ 355600 w 407917"/>
              <a:gd name="connsiteY39" fmla="*/ 1012825 h 1031875"/>
              <a:gd name="connsiteX40" fmla="*/ 342900 w 407917"/>
              <a:gd name="connsiteY40" fmla="*/ 974725 h 1031875"/>
              <a:gd name="connsiteX41" fmla="*/ 330200 w 407917"/>
              <a:gd name="connsiteY41" fmla="*/ 939800 h 1031875"/>
              <a:gd name="connsiteX42" fmla="*/ 330200 w 407917"/>
              <a:gd name="connsiteY42" fmla="*/ 939800 h 1031875"/>
              <a:gd name="connsiteX43" fmla="*/ 407650 w 407917"/>
              <a:gd name="connsiteY43" fmla="*/ 883446 h 1031875"/>
              <a:gd name="connsiteX44" fmla="*/ 276225 w 407917"/>
              <a:gd name="connsiteY44" fmla="*/ 835025 h 1031875"/>
              <a:gd name="connsiteX45" fmla="*/ 233025 w 407917"/>
              <a:gd name="connsiteY45" fmla="*/ 740571 h 1031875"/>
              <a:gd name="connsiteX46" fmla="*/ 236200 w 407917"/>
              <a:gd name="connsiteY46" fmla="*/ 562771 h 1031875"/>
              <a:gd name="connsiteX47" fmla="*/ 203200 w 407917"/>
              <a:gd name="connsiteY47" fmla="*/ 190501 h 1031875"/>
              <a:gd name="connsiteX48" fmla="*/ 212726 w 407917"/>
              <a:gd name="connsiteY48" fmla="*/ 101601 h 1031875"/>
              <a:gd name="connsiteX49" fmla="*/ 82550 w 407917"/>
              <a:gd name="connsiteY49" fmla="*/ 0 h 1031875"/>
              <a:gd name="connsiteX0" fmla="*/ 76200 w 407917"/>
              <a:gd name="connsiteY0" fmla="*/ 3175 h 1031875"/>
              <a:gd name="connsiteX1" fmla="*/ 69850 w 407917"/>
              <a:gd name="connsiteY1" fmla="*/ 44450 h 1031875"/>
              <a:gd name="connsiteX2" fmla="*/ 85725 w 407917"/>
              <a:gd name="connsiteY2" fmla="*/ 69850 h 1031875"/>
              <a:gd name="connsiteX3" fmla="*/ 114300 w 407917"/>
              <a:gd name="connsiteY3" fmla="*/ 98425 h 1031875"/>
              <a:gd name="connsiteX4" fmla="*/ 149225 w 407917"/>
              <a:gd name="connsiteY4" fmla="*/ 130175 h 1031875"/>
              <a:gd name="connsiteX5" fmla="*/ 168275 w 407917"/>
              <a:gd name="connsiteY5" fmla="*/ 161925 h 1031875"/>
              <a:gd name="connsiteX6" fmla="*/ 174625 w 407917"/>
              <a:gd name="connsiteY6" fmla="*/ 219075 h 1031875"/>
              <a:gd name="connsiteX7" fmla="*/ 168275 w 407917"/>
              <a:gd name="connsiteY7" fmla="*/ 269875 h 1031875"/>
              <a:gd name="connsiteX8" fmla="*/ 168275 w 407917"/>
              <a:gd name="connsiteY8" fmla="*/ 323850 h 1031875"/>
              <a:gd name="connsiteX9" fmla="*/ 184150 w 407917"/>
              <a:gd name="connsiteY9" fmla="*/ 403225 h 1031875"/>
              <a:gd name="connsiteX10" fmla="*/ 190500 w 407917"/>
              <a:gd name="connsiteY10" fmla="*/ 454025 h 1031875"/>
              <a:gd name="connsiteX11" fmla="*/ 190500 w 407917"/>
              <a:gd name="connsiteY11" fmla="*/ 454025 h 1031875"/>
              <a:gd name="connsiteX12" fmla="*/ 193675 w 407917"/>
              <a:gd name="connsiteY12" fmla="*/ 511175 h 1031875"/>
              <a:gd name="connsiteX13" fmla="*/ 187325 w 407917"/>
              <a:gd name="connsiteY13" fmla="*/ 536575 h 1031875"/>
              <a:gd name="connsiteX14" fmla="*/ 187325 w 407917"/>
              <a:gd name="connsiteY14" fmla="*/ 584200 h 1031875"/>
              <a:gd name="connsiteX15" fmla="*/ 196850 w 407917"/>
              <a:gd name="connsiteY15" fmla="*/ 615950 h 1031875"/>
              <a:gd name="connsiteX16" fmla="*/ 184150 w 407917"/>
              <a:gd name="connsiteY16" fmla="*/ 647700 h 1031875"/>
              <a:gd name="connsiteX17" fmla="*/ 193675 w 407917"/>
              <a:gd name="connsiteY17" fmla="*/ 695325 h 1031875"/>
              <a:gd name="connsiteX18" fmla="*/ 193675 w 407917"/>
              <a:gd name="connsiteY18" fmla="*/ 730250 h 1031875"/>
              <a:gd name="connsiteX19" fmla="*/ 180975 w 407917"/>
              <a:gd name="connsiteY19" fmla="*/ 755650 h 1031875"/>
              <a:gd name="connsiteX20" fmla="*/ 180975 w 407917"/>
              <a:gd name="connsiteY20" fmla="*/ 800100 h 1031875"/>
              <a:gd name="connsiteX21" fmla="*/ 155575 w 407917"/>
              <a:gd name="connsiteY21" fmla="*/ 831850 h 1031875"/>
              <a:gd name="connsiteX22" fmla="*/ 0 w 407917"/>
              <a:gd name="connsiteY22" fmla="*/ 917575 h 1031875"/>
              <a:gd name="connsiteX23" fmla="*/ 44450 w 407917"/>
              <a:gd name="connsiteY23" fmla="*/ 933450 h 1031875"/>
              <a:gd name="connsiteX24" fmla="*/ 79375 w 407917"/>
              <a:gd name="connsiteY24" fmla="*/ 923925 h 1031875"/>
              <a:gd name="connsiteX25" fmla="*/ 130175 w 407917"/>
              <a:gd name="connsiteY25" fmla="*/ 917575 h 1031875"/>
              <a:gd name="connsiteX26" fmla="*/ 139700 w 407917"/>
              <a:gd name="connsiteY26" fmla="*/ 939800 h 1031875"/>
              <a:gd name="connsiteX27" fmla="*/ 133350 w 407917"/>
              <a:gd name="connsiteY27" fmla="*/ 974725 h 1031875"/>
              <a:gd name="connsiteX28" fmla="*/ 123825 w 407917"/>
              <a:gd name="connsiteY28" fmla="*/ 1006475 h 1031875"/>
              <a:gd name="connsiteX29" fmla="*/ 136525 w 407917"/>
              <a:gd name="connsiteY29" fmla="*/ 1025525 h 1031875"/>
              <a:gd name="connsiteX30" fmla="*/ 152400 w 407917"/>
              <a:gd name="connsiteY30" fmla="*/ 1031875 h 1031875"/>
              <a:gd name="connsiteX31" fmla="*/ 152400 w 407917"/>
              <a:gd name="connsiteY31" fmla="*/ 1031875 h 1031875"/>
              <a:gd name="connsiteX32" fmla="*/ 155575 w 407917"/>
              <a:gd name="connsiteY32" fmla="*/ 1000125 h 1031875"/>
              <a:gd name="connsiteX33" fmla="*/ 184150 w 407917"/>
              <a:gd name="connsiteY33" fmla="*/ 984250 h 1031875"/>
              <a:gd name="connsiteX34" fmla="*/ 212725 w 407917"/>
              <a:gd name="connsiteY34" fmla="*/ 965200 h 1031875"/>
              <a:gd name="connsiteX35" fmla="*/ 222250 w 407917"/>
              <a:gd name="connsiteY35" fmla="*/ 927100 h 1031875"/>
              <a:gd name="connsiteX36" fmla="*/ 254000 w 407917"/>
              <a:gd name="connsiteY36" fmla="*/ 936625 h 1031875"/>
              <a:gd name="connsiteX37" fmla="*/ 292100 w 407917"/>
              <a:gd name="connsiteY37" fmla="*/ 968375 h 1031875"/>
              <a:gd name="connsiteX38" fmla="*/ 327025 w 407917"/>
              <a:gd name="connsiteY38" fmla="*/ 993775 h 1031875"/>
              <a:gd name="connsiteX39" fmla="*/ 355600 w 407917"/>
              <a:gd name="connsiteY39" fmla="*/ 1012825 h 1031875"/>
              <a:gd name="connsiteX40" fmla="*/ 342900 w 407917"/>
              <a:gd name="connsiteY40" fmla="*/ 974725 h 1031875"/>
              <a:gd name="connsiteX41" fmla="*/ 330200 w 407917"/>
              <a:gd name="connsiteY41" fmla="*/ 939800 h 1031875"/>
              <a:gd name="connsiteX42" fmla="*/ 330200 w 407917"/>
              <a:gd name="connsiteY42" fmla="*/ 939800 h 1031875"/>
              <a:gd name="connsiteX43" fmla="*/ 407650 w 407917"/>
              <a:gd name="connsiteY43" fmla="*/ 883446 h 1031875"/>
              <a:gd name="connsiteX44" fmla="*/ 276225 w 407917"/>
              <a:gd name="connsiteY44" fmla="*/ 835025 h 1031875"/>
              <a:gd name="connsiteX45" fmla="*/ 233025 w 407917"/>
              <a:gd name="connsiteY45" fmla="*/ 740571 h 1031875"/>
              <a:gd name="connsiteX46" fmla="*/ 236200 w 407917"/>
              <a:gd name="connsiteY46" fmla="*/ 562771 h 1031875"/>
              <a:gd name="connsiteX47" fmla="*/ 203200 w 407917"/>
              <a:gd name="connsiteY47" fmla="*/ 190501 h 1031875"/>
              <a:gd name="connsiteX48" fmla="*/ 184151 w 407917"/>
              <a:gd name="connsiteY48" fmla="*/ 73026 h 1031875"/>
              <a:gd name="connsiteX49" fmla="*/ 82550 w 407917"/>
              <a:gd name="connsiteY49" fmla="*/ 0 h 1031875"/>
              <a:gd name="connsiteX0" fmla="*/ 76200 w 407917"/>
              <a:gd name="connsiteY0" fmla="*/ 3175 h 1031875"/>
              <a:gd name="connsiteX1" fmla="*/ 69850 w 407917"/>
              <a:gd name="connsiteY1" fmla="*/ 44450 h 1031875"/>
              <a:gd name="connsiteX2" fmla="*/ 85725 w 407917"/>
              <a:gd name="connsiteY2" fmla="*/ 69850 h 1031875"/>
              <a:gd name="connsiteX3" fmla="*/ 114300 w 407917"/>
              <a:gd name="connsiteY3" fmla="*/ 98425 h 1031875"/>
              <a:gd name="connsiteX4" fmla="*/ 149225 w 407917"/>
              <a:gd name="connsiteY4" fmla="*/ 130175 h 1031875"/>
              <a:gd name="connsiteX5" fmla="*/ 168275 w 407917"/>
              <a:gd name="connsiteY5" fmla="*/ 161925 h 1031875"/>
              <a:gd name="connsiteX6" fmla="*/ 174625 w 407917"/>
              <a:gd name="connsiteY6" fmla="*/ 219075 h 1031875"/>
              <a:gd name="connsiteX7" fmla="*/ 168275 w 407917"/>
              <a:gd name="connsiteY7" fmla="*/ 269875 h 1031875"/>
              <a:gd name="connsiteX8" fmla="*/ 168275 w 407917"/>
              <a:gd name="connsiteY8" fmla="*/ 323850 h 1031875"/>
              <a:gd name="connsiteX9" fmla="*/ 184150 w 407917"/>
              <a:gd name="connsiteY9" fmla="*/ 403225 h 1031875"/>
              <a:gd name="connsiteX10" fmla="*/ 190500 w 407917"/>
              <a:gd name="connsiteY10" fmla="*/ 454025 h 1031875"/>
              <a:gd name="connsiteX11" fmla="*/ 190500 w 407917"/>
              <a:gd name="connsiteY11" fmla="*/ 454025 h 1031875"/>
              <a:gd name="connsiteX12" fmla="*/ 193675 w 407917"/>
              <a:gd name="connsiteY12" fmla="*/ 511175 h 1031875"/>
              <a:gd name="connsiteX13" fmla="*/ 187325 w 407917"/>
              <a:gd name="connsiteY13" fmla="*/ 536575 h 1031875"/>
              <a:gd name="connsiteX14" fmla="*/ 187325 w 407917"/>
              <a:gd name="connsiteY14" fmla="*/ 584200 h 1031875"/>
              <a:gd name="connsiteX15" fmla="*/ 196850 w 407917"/>
              <a:gd name="connsiteY15" fmla="*/ 615950 h 1031875"/>
              <a:gd name="connsiteX16" fmla="*/ 184150 w 407917"/>
              <a:gd name="connsiteY16" fmla="*/ 647700 h 1031875"/>
              <a:gd name="connsiteX17" fmla="*/ 193675 w 407917"/>
              <a:gd name="connsiteY17" fmla="*/ 695325 h 1031875"/>
              <a:gd name="connsiteX18" fmla="*/ 193675 w 407917"/>
              <a:gd name="connsiteY18" fmla="*/ 730250 h 1031875"/>
              <a:gd name="connsiteX19" fmla="*/ 180975 w 407917"/>
              <a:gd name="connsiteY19" fmla="*/ 755650 h 1031875"/>
              <a:gd name="connsiteX20" fmla="*/ 180975 w 407917"/>
              <a:gd name="connsiteY20" fmla="*/ 800100 h 1031875"/>
              <a:gd name="connsiteX21" fmla="*/ 155575 w 407917"/>
              <a:gd name="connsiteY21" fmla="*/ 831850 h 1031875"/>
              <a:gd name="connsiteX22" fmla="*/ 0 w 407917"/>
              <a:gd name="connsiteY22" fmla="*/ 917575 h 1031875"/>
              <a:gd name="connsiteX23" fmla="*/ 44450 w 407917"/>
              <a:gd name="connsiteY23" fmla="*/ 933450 h 1031875"/>
              <a:gd name="connsiteX24" fmla="*/ 79375 w 407917"/>
              <a:gd name="connsiteY24" fmla="*/ 923925 h 1031875"/>
              <a:gd name="connsiteX25" fmla="*/ 130175 w 407917"/>
              <a:gd name="connsiteY25" fmla="*/ 917575 h 1031875"/>
              <a:gd name="connsiteX26" fmla="*/ 139700 w 407917"/>
              <a:gd name="connsiteY26" fmla="*/ 939800 h 1031875"/>
              <a:gd name="connsiteX27" fmla="*/ 133350 w 407917"/>
              <a:gd name="connsiteY27" fmla="*/ 974725 h 1031875"/>
              <a:gd name="connsiteX28" fmla="*/ 123825 w 407917"/>
              <a:gd name="connsiteY28" fmla="*/ 1006475 h 1031875"/>
              <a:gd name="connsiteX29" fmla="*/ 136525 w 407917"/>
              <a:gd name="connsiteY29" fmla="*/ 1025525 h 1031875"/>
              <a:gd name="connsiteX30" fmla="*/ 152400 w 407917"/>
              <a:gd name="connsiteY30" fmla="*/ 1031875 h 1031875"/>
              <a:gd name="connsiteX31" fmla="*/ 152400 w 407917"/>
              <a:gd name="connsiteY31" fmla="*/ 1031875 h 1031875"/>
              <a:gd name="connsiteX32" fmla="*/ 155575 w 407917"/>
              <a:gd name="connsiteY32" fmla="*/ 1000125 h 1031875"/>
              <a:gd name="connsiteX33" fmla="*/ 184150 w 407917"/>
              <a:gd name="connsiteY33" fmla="*/ 984250 h 1031875"/>
              <a:gd name="connsiteX34" fmla="*/ 212725 w 407917"/>
              <a:gd name="connsiteY34" fmla="*/ 965200 h 1031875"/>
              <a:gd name="connsiteX35" fmla="*/ 222250 w 407917"/>
              <a:gd name="connsiteY35" fmla="*/ 927100 h 1031875"/>
              <a:gd name="connsiteX36" fmla="*/ 254000 w 407917"/>
              <a:gd name="connsiteY36" fmla="*/ 936625 h 1031875"/>
              <a:gd name="connsiteX37" fmla="*/ 292100 w 407917"/>
              <a:gd name="connsiteY37" fmla="*/ 968375 h 1031875"/>
              <a:gd name="connsiteX38" fmla="*/ 327025 w 407917"/>
              <a:gd name="connsiteY38" fmla="*/ 993775 h 1031875"/>
              <a:gd name="connsiteX39" fmla="*/ 355600 w 407917"/>
              <a:gd name="connsiteY39" fmla="*/ 1012825 h 1031875"/>
              <a:gd name="connsiteX40" fmla="*/ 342900 w 407917"/>
              <a:gd name="connsiteY40" fmla="*/ 974725 h 1031875"/>
              <a:gd name="connsiteX41" fmla="*/ 330200 w 407917"/>
              <a:gd name="connsiteY41" fmla="*/ 939800 h 1031875"/>
              <a:gd name="connsiteX42" fmla="*/ 330200 w 407917"/>
              <a:gd name="connsiteY42" fmla="*/ 939800 h 1031875"/>
              <a:gd name="connsiteX43" fmla="*/ 407650 w 407917"/>
              <a:gd name="connsiteY43" fmla="*/ 883446 h 1031875"/>
              <a:gd name="connsiteX44" fmla="*/ 276225 w 407917"/>
              <a:gd name="connsiteY44" fmla="*/ 835025 h 1031875"/>
              <a:gd name="connsiteX45" fmla="*/ 233025 w 407917"/>
              <a:gd name="connsiteY45" fmla="*/ 740571 h 1031875"/>
              <a:gd name="connsiteX46" fmla="*/ 236200 w 407917"/>
              <a:gd name="connsiteY46" fmla="*/ 562771 h 1031875"/>
              <a:gd name="connsiteX47" fmla="*/ 203200 w 407917"/>
              <a:gd name="connsiteY47" fmla="*/ 190501 h 1031875"/>
              <a:gd name="connsiteX48" fmla="*/ 184151 w 407917"/>
              <a:gd name="connsiteY48" fmla="*/ 73026 h 1031875"/>
              <a:gd name="connsiteX49" fmla="*/ 82550 w 407917"/>
              <a:gd name="connsiteY49" fmla="*/ 0 h 1031875"/>
              <a:gd name="connsiteX0" fmla="*/ 76200 w 407917"/>
              <a:gd name="connsiteY0" fmla="*/ 3175 h 1031875"/>
              <a:gd name="connsiteX1" fmla="*/ 69850 w 407917"/>
              <a:gd name="connsiteY1" fmla="*/ 44450 h 1031875"/>
              <a:gd name="connsiteX2" fmla="*/ 85725 w 407917"/>
              <a:gd name="connsiteY2" fmla="*/ 69850 h 1031875"/>
              <a:gd name="connsiteX3" fmla="*/ 114300 w 407917"/>
              <a:gd name="connsiteY3" fmla="*/ 98425 h 1031875"/>
              <a:gd name="connsiteX4" fmla="*/ 149225 w 407917"/>
              <a:gd name="connsiteY4" fmla="*/ 130175 h 1031875"/>
              <a:gd name="connsiteX5" fmla="*/ 168275 w 407917"/>
              <a:gd name="connsiteY5" fmla="*/ 161925 h 1031875"/>
              <a:gd name="connsiteX6" fmla="*/ 174625 w 407917"/>
              <a:gd name="connsiteY6" fmla="*/ 219075 h 1031875"/>
              <a:gd name="connsiteX7" fmla="*/ 168275 w 407917"/>
              <a:gd name="connsiteY7" fmla="*/ 269875 h 1031875"/>
              <a:gd name="connsiteX8" fmla="*/ 168275 w 407917"/>
              <a:gd name="connsiteY8" fmla="*/ 323850 h 1031875"/>
              <a:gd name="connsiteX9" fmla="*/ 184150 w 407917"/>
              <a:gd name="connsiteY9" fmla="*/ 403225 h 1031875"/>
              <a:gd name="connsiteX10" fmla="*/ 190500 w 407917"/>
              <a:gd name="connsiteY10" fmla="*/ 454025 h 1031875"/>
              <a:gd name="connsiteX11" fmla="*/ 190500 w 407917"/>
              <a:gd name="connsiteY11" fmla="*/ 454025 h 1031875"/>
              <a:gd name="connsiteX12" fmla="*/ 193675 w 407917"/>
              <a:gd name="connsiteY12" fmla="*/ 511175 h 1031875"/>
              <a:gd name="connsiteX13" fmla="*/ 187325 w 407917"/>
              <a:gd name="connsiteY13" fmla="*/ 536575 h 1031875"/>
              <a:gd name="connsiteX14" fmla="*/ 187325 w 407917"/>
              <a:gd name="connsiteY14" fmla="*/ 584200 h 1031875"/>
              <a:gd name="connsiteX15" fmla="*/ 196850 w 407917"/>
              <a:gd name="connsiteY15" fmla="*/ 615950 h 1031875"/>
              <a:gd name="connsiteX16" fmla="*/ 184150 w 407917"/>
              <a:gd name="connsiteY16" fmla="*/ 647700 h 1031875"/>
              <a:gd name="connsiteX17" fmla="*/ 193675 w 407917"/>
              <a:gd name="connsiteY17" fmla="*/ 695325 h 1031875"/>
              <a:gd name="connsiteX18" fmla="*/ 193675 w 407917"/>
              <a:gd name="connsiteY18" fmla="*/ 730250 h 1031875"/>
              <a:gd name="connsiteX19" fmla="*/ 180975 w 407917"/>
              <a:gd name="connsiteY19" fmla="*/ 755650 h 1031875"/>
              <a:gd name="connsiteX20" fmla="*/ 180975 w 407917"/>
              <a:gd name="connsiteY20" fmla="*/ 800100 h 1031875"/>
              <a:gd name="connsiteX21" fmla="*/ 155575 w 407917"/>
              <a:gd name="connsiteY21" fmla="*/ 831850 h 1031875"/>
              <a:gd name="connsiteX22" fmla="*/ 0 w 407917"/>
              <a:gd name="connsiteY22" fmla="*/ 917575 h 1031875"/>
              <a:gd name="connsiteX23" fmla="*/ 44450 w 407917"/>
              <a:gd name="connsiteY23" fmla="*/ 933450 h 1031875"/>
              <a:gd name="connsiteX24" fmla="*/ 79375 w 407917"/>
              <a:gd name="connsiteY24" fmla="*/ 923925 h 1031875"/>
              <a:gd name="connsiteX25" fmla="*/ 130175 w 407917"/>
              <a:gd name="connsiteY25" fmla="*/ 917575 h 1031875"/>
              <a:gd name="connsiteX26" fmla="*/ 139700 w 407917"/>
              <a:gd name="connsiteY26" fmla="*/ 939800 h 1031875"/>
              <a:gd name="connsiteX27" fmla="*/ 133350 w 407917"/>
              <a:gd name="connsiteY27" fmla="*/ 974725 h 1031875"/>
              <a:gd name="connsiteX28" fmla="*/ 123825 w 407917"/>
              <a:gd name="connsiteY28" fmla="*/ 1006475 h 1031875"/>
              <a:gd name="connsiteX29" fmla="*/ 136525 w 407917"/>
              <a:gd name="connsiteY29" fmla="*/ 1025525 h 1031875"/>
              <a:gd name="connsiteX30" fmla="*/ 152400 w 407917"/>
              <a:gd name="connsiteY30" fmla="*/ 1031875 h 1031875"/>
              <a:gd name="connsiteX31" fmla="*/ 152400 w 407917"/>
              <a:gd name="connsiteY31" fmla="*/ 1031875 h 1031875"/>
              <a:gd name="connsiteX32" fmla="*/ 155575 w 407917"/>
              <a:gd name="connsiteY32" fmla="*/ 1000125 h 1031875"/>
              <a:gd name="connsiteX33" fmla="*/ 184150 w 407917"/>
              <a:gd name="connsiteY33" fmla="*/ 984250 h 1031875"/>
              <a:gd name="connsiteX34" fmla="*/ 212725 w 407917"/>
              <a:gd name="connsiteY34" fmla="*/ 965200 h 1031875"/>
              <a:gd name="connsiteX35" fmla="*/ 222250 w 407917"/>
              <a:gd name="connsiteY35" fmla="*/ 927100 h 1031875"/>
              <a:gd name="connsiteX36" fmla="*/ 254000 w 407917"/>
              <a:gd name="connsiteY36" fmla="*/ 936625 h 1031875"/>
              <a:gd name="connsiteX37" fmla="*/ 292100 w 407917"/>
              <a:gd name="connsiteY37" fmla="*/ 968375 h 1031875"/>
              <a:gd name="connsiteX38" fmla="*/ 327025 w 407917"/>
              <a:gd name="connsiteY38" fmla="*/ 993775 h 1031875"/>
              <a:gd name="connsiteX39" fmla="*/ 355600 w 407917"/>
              <a:gd name="connsiteY39" fmla="*/ 1012825 h 1031875"/>
              <a:gd name="connsiteX40" fmla="*/ 342900 w 407917"/>
              <a:gd name="connsiteY40" fmla="*/ 974725 h 1031875"/>
              <a:gd name="connsiteX41" fmla="*/ 330200 w 407917"/>
              <a:gd name="connsiteY41" fmla="*/ 939800 h 1031875"/>
              <a:gd name="connsiteX42" fmla="*/ 330200 w 407917"/>
              <a:gd name="connsiteY42" fmla="*/ 939800 h 1031875"/>
              <a:gd name="connsiteX43" fmla="*/ 407650 w 407917"/>
              <a:gd name="connsiteY43" fmla="*/ 883446 h 1031875"/>
              <a:gd name="connsiteX44" fmla="*/ 276225 w 407917"/>
              <a:gd name="connsiteY44" fmla="*/ 835025 h 1031875"/>
              <a:gd name="connsiteX45" fmla="*/ 233025 w 407917"/>
              <a:gd name="connsiteY45" fmla="*/ 740571 h 1031875"/>
              <a:gd name="connsiteX46" fmla="*/ 236200 w 407917"/>
              <a:gd name="connsiteY46" fmla="*/ 562771 h 1031875"/>
              <a:gd name="connsiteX47" fmla="*/ 203200 w 407917"/>
              <a:gd name="connsiteY47" fmla="*/ 190501 h 1031875"/>
              <a:gd name="connsiteX48" fmla="*/ 280650 w 407917"/>
              <a:gd name="connsiteY48" fmla="*/ 45246 h 1031875"/>
              <a:gd name="connsiteX49" fmla="*/ 184151 w 407917"/>
              <a:gd name="connsiteY49" fmla="*/ 73026 h 1031875"/>
              <a:gd name="connsiteX50" fmla="*/ 82550 w 407917"/>
              <a:gd name="connsiteY50" fmla="*/ 0 h 1031875"/>
              <a:gd name="connsiteX0" fmla="*/ 76200 w 407917"/>
              <a:gd name="connsiteY0" fmla="*/ 3175 h 1031875"/>
              <a:gd name="connsiteX1" fmla="*/ 69850 w 407917"/>
              <a:gd name="connsiteY1" fmla="*/ 44450 h 1031875"/>
              <a:gd name="connsiteX2" fmla="*/ 85725 w 407917"/>
              <a:gd name="connsiteY2" fmla="*/ 69850 h 1031875"/>
              <a:gd name="connsiteX3" fmla="*/ 114300 w 407917"/>
              <a:gd name="connsiteY3" fmla="*/ 98425 h 1031875"/>
              <a:gd name="connsiteX4" fmla="*/ 149225 w 407917"/>
              <a:gd name="connsiteY4" fmla="*/ 130175 h 1031875"/>
              <a:gd name="connsiteX5" fmla="*/ 168275 w 407917"/>
              <a:gd name="connsiteY5" fmla="*/ 161925 h 1031875"/>
              <a:gd name="connsiteX6" fmla="*/ 174625 w 407917"/>
              <a:gd name="connsiteY6" fmla="*/ 219075 h 1031875"/>
              <a:gd name="connsiteX7" fmla="*/ 168275 w 407917"/>
              <a:gd name="connsiteY7" fmla="*/ 269875 h 1031875"/>
              <a:gd name="connsiteX8" fmla="*/ 168275 w 407917"/>
              <a:gd name="connsiteY8" fmla="*/ 323850 h 1031875"/>
              <a:gd name="connsiteX9" fmla="*/ 184150 w 407917"/>
              <a:gd name="connsiteY9" fmla="*/ 403225 h 1031875"/>
              <a:gd name="connsiteX10" fmla="*/ 190500 w 407917"/>
              <a:gd name="connsiteY10" fmla="*/ 454025 h 1031875"/>
              <a:gd name="connsiteX11" fmla="*/ 190500 w 407917"/>
              <a:gd name="connsiteY11" fmla="*/ 454025 h 1031875"/>
              <a:gd name="connsiteX12" fmla="*/ 193675 w 407917"/>
              <a:gd name="connsiteY12" fmla="*/ 511175 h 1031875"/>
              <a:gd name="connsiteX13" fmla="*/ 187325 w 407917"/>
              <a:gd name="connsiteY13" fmla="*/ 536575 h 1031875"/>
              <a:gd name="connsiteX14" fmla="*/ 187325 w 407917"/>
              <a:gd name="connsiteY14" fmla="*/ 584200 h 1031875"/>
              <a:gd name="connsiteX15" fmla="*/ 196850 w 407917"/>
              <a:gd name="connsiteY15" fmla="*/ 615950 h 1031875"/>
              <a:gd name="connsiteX16" fmla="*/ 184150 w 407917"/>
              <a:gd name="connsiteY16" fmla="*/ 647700 h 1031875"/>
              <a:gd name="connsiteX17" fmla="*/ 193675 w 407917"/>
              <a:gd name="connsiteY17" fmla="*/ 695325 h 1031875"/>
              <a:gd name="connsiteX18" fmla="*/ 193675 w 407917"/>
              <a:gd name="connsiteY18" fmla="*/ 730250 h 1031875"/>
              <a:gd name="connsiteX19" fmla="*/ 180975 w 407917"/>
              <a:gd name="connsiteY19" fmla="*/ 755650 h 1031875"/>
              <a:gd name="connsiteX20" fmla="*/ 180975 w 407917"/>
              <a:gd name="connsiteY20" fmla="*/ 800100 h 1031875"/>
              <a:gd name="connsiteX21" fmla="*/ 155575 w 407917"/>
              <a:gd name="connsiteY21" fmla="*/ 831850 h 1031875"/>
              <a:gd name="connsiteX22" fmla="*/ 0 w 407917"/>
              <a:gd name="connsiteY22" fmla="*/ 917575 h 1031875"/>
              <a:gd name="connsiteX23" fmla="*/ 44450 w 407917"/>
              <a:gd name="connsiteY23" fmla="*/ 933450 h 1031875"/>
              <a:gd name="connsiteX24" fmla="*/ 79375 w 407917"/>
              <a:gd name="connsiteY24" fmla="*/ 923925 h 1031875"/>
              <a:gd name="connsiteX25" fmla="*/ 130175 w 407917"/>
              <a:gd name="connsiteY25" fmla="*/ 917575 h 1031875"/>
              <a:gd name="connsiteX26" fmla="*/ 139700 w 407917"/>
              <a:gd name="connsiteY26" fmla="*/ 939800 h 1031875"/>
              <a:gd name="connsiteX27" fmla="*/ 133350 w 407917"/>
              <a:gd name="connsiteY27" fmla="*/ 974725 h 1031875"/>
              <a:gd name="connsiteX28" fmla="*/ 123825 w 407917"/>
              <a:gd name="connsiteY28" fmla="*/ 1006475 h 1031875"/>
              <a:gd name="connsiteX29" fmla="*/ 136525 w 407917"/>
              <a:gd name="connsiteY29" fmla="*/ 1025525 h 1031875"/>
              <a:gd name="connsiteX30" fmla="*/ 152400 w 407917"/>
              <a:gd name="connsiteY30" fmla="*/ 1031875 h 1031875"/>
              <a:gd name="connsiteX31" fmla="*/ 152400 w 407917"/>
              <a:gd name="connsiteY31" fmla="*/ 1031875 h 1031875"/>
              <a:gd name="connsiteX32" fmla="*/ 155575 w 407917"/>
              <a:gd name="connsiteY32" fmla="*/ 1000125 h 1031875"/>
              <a:gd name="connsiteX33" fmla="*/ 184150 w 407917"/>
              <a:gd name="connsiteY33" fmla="*/ 984250 h 1031875"/>
              <a:gd name="connsiteX34" fmla="*/ 212725 w 407917"/>
              <a:gd name="connsiteY34" fmla="*/ 965200 h 1031875"/>
              <a:gd name="connsiteX35" fmla="*/ 222250 w 407917"/>
              <a:gd name="connsiteY35" fmla="*/ 927100 h 1031875"/>
              <a:gd name="connsiteX36" fmla="*/ 254000 w 407917"/>
              <a:gd name="connsiteY36" fmla="*/ 936625 h 1031875"/>
              <a:gd name="connsiteX37" fmla="*/ 292100 w 407917"/>
              <a:gd name="connsiteY37" fmla="*/ 968375 h 1031875"/>
              <a:gd name="connsiteX38" fmla="*/ 327025 w 407917"/>
              <a:gd name="connsiteY38" fmla="*/ 993775 h 1031875"/>
              <a:gd name="connsiteX39" fmla="*/ 355600 w 407917"/>
              <a:gd name="connsiteY39" fmla="*/ 1012825 h 1031875"/>
              <a:gd name="connsiteX40" fmla="*/ 342900 w 407917"/>
              <a:gd name="connsiteY40" fmla="*/ 974725 h 1031875"/>
              <a:gd name="connsiteX41" fmla="*/ 330200 w 407917"/>
              <a:gd name="connsiteY41" fmla="*/ 939800 h 1031875"/>
              <a:gd name="connsiteX42" fmla="*/ 330200 w 407917"/>
              <a:gd name="connsiteY42" fmla="*/ 939800 h 1031875"/>
              <a:gd name="connsiteX43" fmla="*/ 407650 w 407917"/>
              <a:gd name="connsiteY43" fmla="*/ 883446 h 1031875"/>
              <a:gd name="connsiteX44" fmla="*/ 276225 w 407917"/>
              <a:gd name="connsiteY44" fmla="*/ 835025 h 1031875"/>
              <a:gd name="connsiteX45" fmla="*/ 233025 w 407917"/>
              <a:gd name="connsiteY45" fmla="*/ 740571 h 1031875"/>
              <a:gd name="connsiteX46" fmla="*/ 236200 w 407917"/>
              <a:gd name="connsiteY46" fmla="*/ 562771 h 1031875"/>
              <a:gd name="connsiteX47" fmla="*/ 203200 w 407917"/>
              <a:gd name="connsiteY47" fmla="*/ 190501 h 1031875"/>
              <a:gd name="connsiteX48" fmla="*/ 337800 w 407917"/>
              <a:gd name="connsiteY48" fmla="*/ 54771 h 1031875"/>
              <a:gd name="connsiteX49" fmla="*/ 280650 w 407917"/>
              <a:gd name="connsiteY49" fmla="*/ 45246 h 1031875"/>
              <a:gd name="connsiteX50" fmla="*/ 184151 w 407917"/>
              <a:gd name="connsiteY50" fmla="*/ 73026 h 1031875"/>
              <a:gd name="connsiteX51" fmla="*/ 82550 w 407917"/>
              <a:gd name="connsiteY51" fmla="*/ 0 h 1031875"/>
              <a:gd name="connsiteX0" fmla="*/ 76200 w 407917"/>
              <a:gd name="connsiteY0" fmla="*/ 3175 h 1031875"/>
              <a:gd name="connsiteX1" fmla="*/ 69850 w 407917"/>
              <a:gd name="connsiteY1" fmla="*/ 44450 h 1031875"/>
              <a:gd name="connsiteX2" fmla="*/ 85725 w 407917"/>
              <a:gd name="connsiteY2" fmla="*/ 69850 h 1031875"/>
              <a:gd name="connsiteX3" fmla="*/ 114300 w 407917"/>
              <a:gd name="connsiteY3" fmla="*/ 98425 h 1031875"/>
              <a:gd name="connsiteX4" fmla="*/ 149225 w 407917"/>
              <a:gd name="connsiteY4" fmla="*/ 130175 h 1031875"/>
              <a:gd name="connsiteX5" fmla="*/ 168275 w 407917"/>
              <a:gd name="connsiteY5" fmla="*/ 161925 h 1031875"/>
              <a:gd name="connsiteX6" fmla="*/ 174625 w 407917"/>
              <a:gd name="connsiteY6" fmla="*/ 219075 h 1031875"/>
              <a:gd name="connsiteX7" fmla="*/ 168275 w 407917"/>
              <a:gd name="connsiteY7" fmla="*/ 269875 h 1031875"/>
              <a:gd name="connsiteX8" fmla="*/ 168275 w 407917"/>
              <a:gd name="connsiteY8" fmla="*/ 323850 h 1031875"/>
              <a:gd name="connsiteX9" fmla="*/ 184150 w 407917"/>
              <a:gd name="connsiteY9" fmla="*/ 403225 h 1031875"/>
              <a:gd name="connsiteX10" fmla="*/ 190500 w 407917"/>
              <a:gd name="connsiteY10" fmla="*/ 454025 h 1031875"/>
              <a:gd name="connsiteX11" fmla="*/ 190500 w 407917"/>
              <a:gd name="connsiteY11" fmla="*/ 454025 h 1031875"/>
              <a:gd name="connsiteX12" fmla="*/ 193675 w 407917"/>
              <a:gd name="connsiteY12" fmla="*/ 511175 h 1031875"/>
              <a:gd name="connsiteX13" fmla="*/ 187325 w 407917"/>
              <a:gd name="connsiteY13" fmla="*/ 536575 h 1031875"/>
              <a:gd name="connsiteX14" fmla="*/ 187325 w 407917"/>
              <a:gd name="connsiteY14" fmla="*/ 584200 h 1031875"/>
              <a:gd name="connsiteX15" fmla="*/ 196850 w 407917"/>
              <a:gd name="connsiteY15" fmla="*/ 615950 h 1031875"/>
              <a:gd name="connsiteX16" fmla="*/ 184150 w 407917"/>
              <a:gd name="connsiteY16" fmla="*/ 647700 h 1031875"/>
              <a:gd name="connsiteX17" fmla="*/ 193675 w 407917"/>
              <a:gd name="connsiteY17" fmla="*/ 695325 h 1031875"/>
              <a:gd name="connsiteX18" fmla="*/ 193675 w 407917"/>
              <a:gd name="connsiteY18" fmla="*/ 730250 h 1031875"/>
              <a:gd name="connsiteX19" fmla="*/ 180975 w 407917"/>
              <a:gd name="connsiteY19" fmla="*/ 755650 h 1031875"/>
              <a:gd name="connsiteX20" fmla="*/ 180975 w 407917"/>
              <a:gd name="connsiteY20" fmla="*/ 800100 h 1031875"/>
              <a:gd name="connsiteX21" fmla="*/ 155575 w 407917"/>
              <a:gd name="connsiteY21" fmla="*/ 831850 h 1031875"/>
              <a:gd name="connsiteX22" fmla="*/ 0 w 407917"/>
              <a:gd name="connsiteY22" fmla="*/ 917575 h 1031875"/>
              <a:gd name="connsiteX23" fmla="*/ 44450 w 407917"/>
              <a:gd name="connsiteY23" fmla="*/ 933450 h 1031875"/>
              <a:gd name="connsiteX24" fmla="*/ 79375 w 407917"/>
              <a:gd name="connsiteY24" fmla="*/ 923925 h 1031875"/>
              <a:gd name="connsiteX25" fmla="*/ 130175 w 407917"/>
              <a:gd name="connsiteY25" fmla="*/ 917575 h 1031875"/>
              <a:gd name="connsiteX26" fmla="*/ 139700 w 407917"/>
              <a:gd name="connsiteY26" fmla="*/ 939800 h 1031875"/>
              <a:gd name="connsiteX27" fmla="*/ 133350 w 407917"/>
              <a:gd name="connsiteY27" fmla="*/ 974725 h 1031875"/>
              <a:gd name="connsiteX28" fmla="*/ 123825 w 407917"/>
              <a:gd name="connsiteY28" fmla="*/ 1006475 h 1031875"/>
              <a:gd name="connsiteX29" fmla="*/ 136525 w 407917"/>
              <a:gd name="connsiteY29" fmla="*/ 1025525 h 1031875"/>
              <a:gd name="connsiteX30" fmla="*/ 152400 w 407917"/>
              <a:gd name="connsiteY30" fmla="*/ 1031875 h 1031875"/>
              <a:gd name="connsiteX31" fmla="*/ 152400 w 407917"/>
              <a:gd name="connsiteY31" fmla="*/ 1031875 h 1031875"/>
              <a:gd name="connsiteX32" fmla="*/ 155575 w 407917"/>
              <a:gd name="connsiteY32" fmla="*/ 1000125 h 1031875"/>
              <a:gd name="connsiteX33" fmla="*/ 184150 w 407917"/>
              <a:gd name="connsiteY33" fmla="*/ 984250 h 1031875"/>
              <a:gd name="connsiteX34" fmla="*/ 212725 w 407917"/>
              <a:gd name="connsiteY34" fmla="*/ 965200 h 1031875"/>
              <a:gd name="connsiteX35" fmla="*/ 222250 w 407917"/>
              <a:gd name="connsiteY35" fmla="*/ 927100 h 1031875"/>
              <a:gd name="connsiteX36" fmla="*/ 254000 w 407917"/>
              <a:gd name="connsiteY36" fmla="*/ 936625 h 1031875"/>
              <a:gd name="connsiteX37" fmla="*/ 292100 w 407917"/>
              <a:gd name="connsiteY37" fmla="*/ 968375 h 1031875"/>
              <a:gd name="connsiteX38" fmla="*/ 327025 w 407917"/>
              <a:gd name="connsiteY38" fmla="*/ 993775 h 1031875"/>
              <a:gd name="connsiteX39" fmla="*/ 355600 w 407917"/>
              <a:gd name="connsiteY39" fmla="*/ 1012825 h 1031875"/>
              <a:gd name="connsiteX40" fmla="*/ 342900 w 407917"/>
              <a:gd name="connsiteY40" fmla="*/ 974725 h 1031875"/>
              <a:gd name="connsiteX41" fmla="*/ 330200 w 407917"/>
              <a:gd name="connsiteY41" fmla="*/ 939800 h 1031875"/>
              <a:gd name="connsiteX42" fmla="*/ 330200 w 407917"/>
              <a:gd name="connsiteY42" fmla="*/ 939800 h 1031875"/>
              <a:gd name="connsiteX43" fmla="*/ 407650 w 407917"/>
              <a:gd name="connsiteY43" fmla="*/ 883446 h 1031875"/>
              <a:gd name="connsiteX44" fmla="*/ 276225 w 407917"/>
              <a:gd name="connsiteY44" fmla="*/ 835025 h 1031875"/>
              <a:gd name="connsiteX45" fmla="*/ 233025 w 407917"/>
              <a:gd name="connsiteY45" fmla="*/ 740571 h 1031875"/>
              <a:gd name="connsiteX46" fmla="*/ 236200 w 407917"/>
              <a:gd name="connsiteY46" fmla="*/ 562771 h 1031875"/>
              <a:gd name="connsiteX47" fmla="*/ 203200 w 407917"/>
              <a:gd name="connsiteY47" fmla="*/ 190501 h 1031875"/>
              <a:gd name="connsiteX48" fmla="*/ 337800 w 407917"/>
              <a:gd name="connsiteY48" fmla="*/ 54771 h 1031875"/>
              <a:gd name="connsiteX49" fmla="*/ 280650 w 407917"/>
              <a:gd name="connsiteY49" fmla="*/ 45246 h 1031875"/>
              <a:gd name="connsiteX50" fmla="*/ 184151 w 407917"/>
              <a:gd name="connsiteY50" fmla="*/ 73026 h 1031875"/>
              <a:gd name="connsiteX51" fmla="*/ 66675 w 407917"/>
              <a:gd name="connsiteY51" fmla="*/ 0 h 1031875"/>
              <a:gd name="connsiteX0" fmla="*/ 76200 w 407917"/>
              <a:gd name="connsiteY0" fmla="*/ 3175 h 1031875"/>
              <a:gd name="connsiteX1" fmla="*/ 69850 w 407917"/>
              <a:gd name="connsiteY1" fmla="*/ 44450 h 1031875"/>
              <a:gd name="connsiteX2" fmla="*/ 85725 w 407917"/>
              <a:gd name="connsiteY2" fmla="*/ 69850 h 1031875"/>
              <a:gd name="connsiteX3" fmla="*/ 114300 w 407917"/>
              <a:gd name="connsiteY3" fmla="*/ 98425 h 1031875"/>
              <a:gd name="connsiteX4" fmla="*/ 149225 w 407917"/>
              <a:gd name="connsiteY4" fmla="*/ 130175 h 1031875"/>
              <a:gd name="connsiteX5" fmla="*/ 168275 w 407917"/>
              <a:gd name="connsiteY5" fmla="*/ 161925 h 1031875"/>
              <a:gd name="connsiteX6" fmla="*/ 174625 w 407917"/>
              <a:gd name="connsiteY6" fmla="*/ 219075 h 1031875"/>
              <a:gd name="connsiteX7" fmla="*/ 168275 w 407917"/>
              <a:gd name="connsiteY7" fmla="*/ 269875 h 1031875"/>
              <a:gd name="connsiteX8" fmla="*/ 168275 w 407917"/>
              <a:gd name="connsiteY8" fmla="*/ 323850 h 1031875"/>
              <a:gd name="connsiteX9" fmla="*/ 184150 w 407917"/>
              <a:gd name="connsiteY9" fmla="*/ 403225 h 1031875"/>
              <a:gd name="connsiteX10" fmla="*/ 190500 w 407917"/>
              <a:gd name="connsiteY10" fmla="*/ 454025 h 1031875"/>
              <a:gd name="connsiteX11" fmla="*/ 190500 w 407917"/>
              <a:gd name="connsiteY11" fmla="*/ 454025 h 1031875"/>
              <a:gd name="connsiteX12" fmla="*/ 193675 w 407917"/>
              <a:gd name="connsiteY12" fmla="*/ 511175 h 1031875"/>
              <a:gd name="connsiteX13" fmla="*/ 187325 w 407917"/>
              <a:gd name="connsiteY13" fmla="*/ 536575 h 1031875"/>
              <a:gd name="connsiteX14" fmla="*/ 187325 w 407917"/>
              <a:gd name="connsiteY14" fmla="*/ 584200 h 1031875"/>
              <a:gd name="connsiteX15" fmla="*/ 196850 w 407917"/>
              <a:gd name="connsiteY15" fmla="*/ 615950 h 1031875"/>
              <a:gd name="connsiteX16" fmla="*/ 184150 w 407917"/>
              <a:gd name="connsiteY16" fmla="*/ 647700 h 1031875"/>
              <a:gd name="connsiteX17" fmla="*/ 193675 w 407917"/>
              <a:gd name="connsiteY17" fmla="*/ 695325 h 1031875"/>
              <a:gd name="connsiteX18" fmla="*/ 193675 w 407917"/>
              <a:gd name="connsiteY18" fmla="*/ 730250 h 1031875"/>
              <a:gd name="connsiteX19" fmla="*/ 180975 w 407917"/>
              <a:gd name="connsiteY19" fmla="*/ 755650 h 1031875"/>
              <a:gd name="connsiteX20" fmla="*/ 180975 w 407917"/>
              <a:gd name="connsiteY20" fmla="*/ 800100 h 1031875"/>
              <a:gd name="connsiteX21" fmla="*/ 155575 w 407917"/>
              <a:gd name="connsiteY21" fmla="*/ 831850 h 1031875"/>
              <a:gd name="connsiteX22" fmla="*/ 0 w 407917"/>
              <a:gd name="connsiteY22" fmla="*/ 917575 h 1031875"/>
              <a:gd name="connsiteX23" fmla="*/ 44450 w 407917"/>
              <a:gd name="connsiteY23" fmla="*/ 933450 h 1031875"/>
              <a:gd name="connsiteX24" fmla="*/ 79375 w 407917"/>
              <a:gd name="connsiteY24" fmla="*/ 923925 h 1031875"/>
              <a:gd name="connsiteX25" fmla="*/ 130175 w 407917"/>
              <a:gd name="connsiteY25" fmla="*/ 917575 h 1031875"/>
              <a:gd name="connsiteX26" fmla="*/ 139700 w 407917"/>
              <a:gd name="connsiteY26" fmla="*/ 939800 h 1031875"/>
              <a:gd name="connsiteX27" fmla="*/ 133350 w 407917"/>
              <a:gd name="connsiteY27" fmla="*/ 974725 h 1031875"/>
              <a:gd name="connsiteX28" fmla="*/ 123825 w 407917"/>
              <a:gd name="connsiteY28" fmla="*/ 1006475 h 1031875"/>
              <a:gd name="connsiteX29" fmla="*/ 136525 w 407917"/>
              <a:gd name="connsiteY29" fmla="*/ 1025525 h 1031875"/>
              <a:gd name="connsiteX30" fmla="*/ 152400 w 407917"/>
              <a:gd name="connsiteY30" fmla="*/ 1031875 h 1031875"/>
              <a:gd name="connsiteX31" fmla="*/ 152400 w 407917"/>
              <a:gd name="connsiteY31" fmla="*/ 1031875 h 1031875"/>
              <a:gd name="connsiteX32" fmla="*/ 155575 w 407917"/>
              <a:gd name="connsiteY32" fmla="*/ 1000125 h 1031875"/>
              <a:gd name="connsiteX33" fmla="*/ 184150 w 407917"/>
              <a:gd name="connsiteY33" fmla="*/ 984250 h 1031875"/>
              <a:gd name="connsiteX34" fmla="*/ 212725 w 407917"/>
              <a:gd name="connsiteY34" fmla="*/ 965200 h 1031875"/>
              <a:gd name="connsiteX35" fmla="*/ 222250 w 407917"/>
              <a:gd name="connsiteY35" fmla="*/ 927100 h 1031875"/>
              <a:gd name="connsiteX36" fmla="*/ 254000 w 407917"/>
              <a:gd name="connsiteY36" fmla="*/ 936625 h 1031875"/>
              <a:gd name="connsiteX37" fmla="*/ 292100 w 407917"/>
              <a:gd name="connsiteY37" fmla="*/ 968375 h 1031875"/>
              <a:gd name="connsiteX38" fmla="*/ 327025 w 407917"/>
              <a:gd name="connsiteY38" fmla="*/ 993775 h 1031875"/>
              <a:gd name="connsiteX39" fmla="*/ 355600 w 407917"/>
              <a:gd name="connsiteY39" fmla="*/ 1012825 h 1031875"/>
              <a:gd name="connsiteX40" fmla="*/ 342900 w 407917"/>
              <a:gd name="connsiteY40" fmla="*/ 974725 h 1031875"/>
              <a:gd name="connsiteX41" fmla="*/ 330200 w 407917"/>
              <a:gd name="connsiteY41" fmla="*/ 939800 h 1031875"/>
              <a:gd name="connsiteX42" fmla="*/ 330200 w 407917"/>
              <a:gd name="connsiteY42" fmla="*/ 939800 h 1031875"/>
              <a:gd name="connsiteX43" fmla="*/ 328275 w 407917"/>
              <a:gd name="connsiteY43" fmla="*/ 921546 h 1031875"/>
              <a:gd name="connsiteX44" fmla="*/ 407650 w 407917"/>
              <a:gd name="connsiteY44" fmla="*/ 883446 h 1031875"/>
              <a:gd name="connsiteX45" fmla="*/ 276225 w 407917"/>
              <a:gd name="connsiteY45" fmla="*/ 835025 h 1031875"/>
              <a:gd name="connsiteX46" fmla="*/ 233025 w 407917"/>
              <a:gd name="connsiteY46" fmla="*/ 740571 h 1031875"/>
              <a:gd name="connsiteX47" fmla="*/ 236200 w 407917"/>
              <a:gd name="connsiteY47" fmla="*/ 562771 h 1031875"/>
              <a:gd name="connsiteX48" fmla="*/ 203200 w 407917"/>
              <a:gd name="connsiteY48" fmla="*/ 190501 h 1031875"/>
              <a:gd name="connsiteX49" fmla="*/ 337800 w 407917"/>
              <a:gd name="connsiteY49" fmla="*/ 54771 h 1031875"/>
              <a:gd name="connsiteX50" fmla="*/ 280650 w 407917"/>
              <a:gd name="connsiteY50" fmla="*/ 45246 h 1031875"/>
              <a:gd name="connsiteX51" fmla="*/ 184151 w 407917"/>
              <a:gd name="connsiteY51" fmla="*/ 73026 h 1031875"/>
              <a:gd name="connsiteX52" fmla="*/ 66675 w 407917"/>
              <a:gd name="connsiteY52" fmla="*/ 0 h 1031875"/>
              <a:gd name="connsiteX0" fmla="*/ 76200 w 407917"/>
              <a:gd name="connsiteY0" fmla="*/ 3175 h 1031875"/>
              <a:gd name="connsiteX1" fmla="*/ 69850 w 407917"/>
              <a:gd name="connsiteY1" fmla="*/ 44450 h 1031875"/>
              <a:gd name="connsiteX2" fmla="*/ 85725 w 407917"/>
              <a:gd name="connsiteY2" fmla="*/ 69850 h 1031875"/>
              <a:gd name="connsiteX3" fmla="*/ 114300 w 407917"/>
              <a:gd name="connsiteY3" fmla="*/ 98425 h 1031875"/>
              <a:gd name="connsiteX4" fmla="*/ 149225 w 407917"/>
              <a:gd name="connsiteY4" fmla="*/ 130175 h 1031875"/>
              <a:gd name="connsiteX5" fmla="*/ 168275 w 407917"/>
              <a:gd name="connsiteY5" fmla="*/ 161925 h 1031875"/>
              <a:gd name="connsiteX6" fmla="*/ 174625 w 407917"/>
              <a:gd name="connsiteY6" fmla="*/ 219075 h 1031875"/>
              <a:gd name="connsiteX7" fmla="*/ 168275 w 407917"/>
              <a:gd name="connsiteY7" fmla="*/ 269875 h 1031875"/>
              <a:gd name="connsiteX8" fmla="*/ 168275 w 407917"/>
              <a:gd name="connsiteY8" fmla="*/ 323850 h 1031875"/>
              <a:gd name="connsiteX9" fmla="*/ 184150 w 407917"/>
              <a:gd name="connsiteY9" fmla="*/ 403225 h 1031875"/>
              <a:gd name="connsiteX10" fmla="*/ 190500 w 407917"/>
              <a:gd name="connsiteY10" fmla="*/ 454025 h 1031875"/>
              <a:gd name="connsiteX11" fmla="*/ 190500 w 407917"/>
              <a:gd name="connsiteY11" fmla="*/ 454025 h 1031875"/>
              <a:gd name="connsiteX12" fmla="*/ 193675 w 407917"/>
              <a:gd name="connsiteY12" fmla="*/ 511175 h 1031875"/>
              <a:gd name="connsiteX13" fmla="*/ 187325 w 407917"/>
              <a:gd name="connsiteY13" fmla="*/ 536575 h 1031875"/>
              <a:gd name="connsiteX14" fmla="*/ 187325 w 407917"/>
              <a:gd name="connsiteY14" fmla="*/ 584200 h 1031875"/>
              <a:gd name="connsiteX15" fmla="*/ 196850 w 407917"/>
              <a:gd name="connsiteY15" fmla="*/ 615950 h 1031875"/>
              <a:gd name="connsiteX16" fmla="*/ 184150 w 407917"/>
              <a:gd name="connsiteY16" fmla="*/ 647700 h 1031875"/>
              <a:gd name="connsiteX17" fmla="*/ 193675 w 407917"/>
              <a:gd name="connsiteY17" fmla="*/ 695325 h 1031875"/>
              <a:gd name="connsiteX18" fmla="*/ 193675 w 407917"/>
              <a:gd name="connsiteY18" fmla="*/ 730250 h 1031875"/>
              <a:gd name="connsiteX19" fmla="*/ 180975 w 407917"/>
              <a:gd name="connsiteY19" fmla="*/ 755650 h 1031875"/>
              <a:gd name="connsiteX20" fmla="*/ 180975 w 407917"/>
              <a:gd name="connsiteY20" fmla="*/ 800100 h 1031875"/>
              <a:gd name="connsiteX21" fmla="*/ 155575 w 407917"/>
              <a:gd name="connsiteY21" fmla="*/ 831850 h 1031875"/>
              <a:gd name="connsiteX22" fmla="*/ 0 w 407917"/>
              <a:gd name="connsiteY22" fmla="*/ 917575 h 1031875"/>
              <a:gd name="connsiteX23" fmla="*/ 44450 w 407917"/>
              <a:gd name="connsiteY23" fmla="*/ 933450 h 1031875"/>
              <a:gd name="connsiteX24" fmla="*/ 79375 w 407917"/>
              <a:gd name="connsiteY24" fmla="*/ 923925 h 1031875"/>
              <a:gd name="connsiteX25" fmla="*/ 130175 w 407917"/>
              <a:gd name="connsiteY25" fmla="*/ 917575 h 1031875"/>
              <a:gd name="connsiteX26" fmla="*/ 139700 w 407917"/>
              <a:gd name="connsiteY26" fmla="*/ 939800 h 1031875"/>
              <a:gd name="connsiteX27" fmla="*/ 133350 w 407917"/>
              <a:gd name="connsiteY27" fmla="*/ 974725 h 1031875"/>
              <a:gd name="connsiteX28" fmla="*/ 123825 w 407917"/>
              <a:gd name="connsiteY28" fmla="*/ 1006475 h 1031875"/>
              <a:gd name="connsiteX29" fmla="*/ 136525 w 407917"/>
              <a:gd name="connsiteY29" fmla="*/ 1025525 h 1031875"/>
              <a:gd name="connsiteX30" fmla="*/ 152400 w 407917"/>
              <a:gd name="connsiteY30" fmla="*/ 1031875 h 1031875"/>
              <a:gd name="connsiteX31" fmla="*/ 152400 w 407917"/>
              <a:gd name="connsiteY31" fmla="*/ 1031875 h 1031875"/>
              <a:gd name="connsiteX32" fmla="*/ 155575 w 407917"/>
              <a:gd name="connsiteY32" fmla="*/ 1000125 h 1031875"/>
              <a:gd name="connsiteX33" fmla="*/ 184150 w 407917"/>
              <a:gd name="connsiteY33" fmla="*/ 984250 h 1031875"/>
              <a:gd name="connsiteX34" fmla="*/ 212725 w 407917"/>
              <a:gd name="connsiteY34" fmla="*/ 965200 h 1031875"/>
              <a:gd name="connsiteX35" fmla="*/ 222250 w 407917"/>
              <a:gd name="connsiteY35" fmla="*/ 927100 h 1031875"/>
              <a:gd name="connsiteX36" fmla="*/ 254000 w 407917"/>
              <a:gd name="connsiteY36" fmla="*/ 936625 h 1031875"/>
              <a:gd name="connsiteX37" fmla="*/ 292100 w 407917"/>
              <a:gd name="connsiteY37" fmla="*/ 968375 h 1031875"/>
              <a:gd name="connsiteX38" fmla="*/ 327025 w 407917"/>
              <a:gd name="connsiteY38" fmla="*/ 993775 h 1031875"/>
              <a:gd name="connsiteX39" fmla="*/ 355600 w 407917"/>
              <a:gd name="connsiteY39" fmla="*/ 1012825 h 1031875"/>
              <a:gd name="connsiteX40" fmla="*/ 365125 w 407917"/>
              <a:gd name="connsiteY40" fmla="*/ 993775 h 1031875"/>
              <a:gd name="connsiteX41" fmla="*/ 330200 w 407917"/>
              <a:gd name="connsiteY41" fmla="*/ 939800 h 1031875"/>
              <a:gd name="connsiteX42" fmla="*/ 330200 w 407917"/>
              <a:gd name="connsiteY42" fmla="*/ 939800 h 1031875"/>
              <a:gd name="connsiteX43" fmla="*/ 328275 w 407917"/>
              <a:gd name="connsiteY43" fmla="*/ 921546 h 1031875"/>
              <a:gd name="connsiteX44" fmla="*/ 407650 w 407917"/>
              <a:gd name="connsiteY44" fmla="*/ 883446 h 1031875"/>
              <a:gd name="connsiteX45" fmla="*/ 276225 w 407917"/>
              <a:gd name="connsiteY45" fmla="*/ 835025 h 1031875"/>
              <a:gd name="connsiteX46" fmla="*/ 233025 w 407917"/>
              <a:gd name="connsiteY46" fmla="*/ 740571 h 1031875"/>
              <a:gd name="connsiteX47" fmla="*/ 236200 w 407917"/>
              <a:gd name="connsiteY47" fmla="*/ 562771 h 1031875"/>
              <a:gd name="connsiteX48" fmla="*/ 203200 w 407917"/>
              <a:gd name="connsiteY48" fmla="*/ 190501 h 1031875"/>
              <a:gd name="connsiteX49" fmla="*/ 337800 w 407917"/>
              <a:gd name="connsiteY49" fmla="*/ 54771 h 1031875"/>
              <a:gd name="connsiteX50" fmla="*/ 280650 w 407917"/>
              <a:gd name="connsiteY50" fmla="*/ 45246 h 1031875"/>
              <a:gd name="connsiteX51" fmla="*/ 184151 w 407917"/>
              <a:gd name="connsiteY51" fmla="*/ 73026 h 1031875"/>
              <a:gd name="connsiteX52" fmla="*/ 66675 w 407917"/>
              <a:gd name="connsiteY52" fmla="*/ 0 h 10318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</a:cxnLst>
            <a:rect l="l" t="t" r="r" b="b"/>
            <a:pathLst>
              <a:path w="407917" h="1031875">
                <a:moveTo>
                  <a:pt x="76200" y="3175"/>
                </a:moveTo>
                <a:lnTo>
                  <a:pt x="69850" y="44450"/>
                </a:lnTo>
                <a:lnTo>
                  <a:pt x="85725" y="69850"/>
                </a:lnTo>
                <a:lnTo>
                  <a:pt x="114300" y="98425"/>
                </a:lnTo>
                <a:lnTo>
                  <a:pt x="149225" y="130175"/>
                </a:lnTo>
                <a:lnTo>
                  <a:pt x="168275" y="161925"/>
                </a:lnTo>
                <a:lnTo>
                  <a:pt x="174625" y="219075"/>
                </a:lnTo>
                <a:lnTo>
                  <a:pt x="168275" y="269875"/>
                </a:lnTo>
                <a:lnTo>
                  <a:pt x="168275" y="323850"/>
                </a:lnTo>
                <a:lnTo>
                  <a:pt x="184150" y="403225"/>
                </a:lnTo>
                <a:lnTo>
                  <a:pt x="190500" y="454025"/>
                </a:lnTo>
                <a:lnTo>
                  <a:pt x="190500" y="454025"/>
                </a:lnTo>
                <a:lnTo>
                  <a:pt x="193675" y="511175"/>
                </a:lnTo>
                <a:lnTo>
                  <a:pt x="187325" y="536575"/>
                </a:lnTo>
                <a:lnTo>
                  <a:pt x="187325" y="584200"/>
                </a:lnTo>
                <a:lnTo>
                  <a:pt x="196850" y="615950"/>
                </a:lnTo>
                <a:lnTo>
                  <a:pt x="184150" y="647700"/>
                </a:lnTo>
                <a:lnTo>
                  <a:pt x="193675" y="695325"/>
                </a:lnTo>
                <a:lnTo>
                  <a:pt x="193675" y="730250"/>
                </a:lnTo>
                <a:lnTo>
                  <a:pt x="180975" y="755650"/>
                </a:lnTo>
                <a:lnTo>
                  <a:pt x="180975" y="800100"/>
                </a:lnTo>
                <a:lnTo>
                  <a:pt x="155575" y="831850"/>
                </a:lnTo>
                <a:lnTo>
                  <a:pt x="0" y="917575"/>
                </a:lnTo>
                <a:lnTo>
                  <a:pt x="44450" y="933450"/>
                </a:lnTo>
                <a:lnTo>
                  <a:pt x="79375" y="923925"/>
                </a:lnTo>
                <a:lnTo>
                  <a:pt x="130175" y="917575"/>
                </a:lnTo>
                <a:lnTo>
                  <a:pt x="139700" y="939800"/>
                </a:lnTo>
                <a:lnTo>
                  <a:pt x="133350" y="974725"/>
                </a:lnTo>
                <a:lnTo>
                  <a:pt x="123825" y="1006475"/>
                </a:lnTo>
                <a:lnTo>
                  <a:pt x="136525" y="1025525"/>
                </a:lnTo>
                <a:lnTo>
                  <a:pt x="152400" y="1031875"/>
                </a:lnTo>
                <a:lnTo>
                  <a:pt x="152400" y="1031875"/>
                </a:lnTo>
                <a:lnTo>
                  <a:pt x="155575" y="1000125"/>
                </a:lnTo>
                <a:lnTo>
                  <a:pt x="184150" y="984250"/>
                </a:lnTo>
                <a:lnTo>
                  <a:pt x="212725" y="965200"/>
                </a:lnTo>
                <a:lnTo>
                  <a:pt x="222250" y="927100"/>
                </a:lnTo>
                <a:lnTo>
                  <a:pt x="254000" y="936625"/>
                </a:lnTo>
                <a:lnTo>
                  <a:pt x="292100" y="968375"/>
                </a:lnTo>
                <a:lnTo>
                  <a:pt x="327025" y="993775"/>
                </a:lnTo>
                <a:lnTo>
                  <a:pt x="355600" y="1012825"/>
                </a:lnTo>
                <a:lnTo>
                  <a:pt x="365125" y="993775"/>
                </a:lnTo>
                <a:lnTo>
                  <a:pt x="330200" y="939800"/>
                </a:lnTo>
                <a:lnTo>
                  <a:pt x="330200" y="939800"/>
                </a:lnTo>
                <a:cubicBezTo>
                  <a:pt x="329879" y="936758"/>
                  <a:pt x="321508" y="926572"/>
                  <a:pt x="328275" y="921546"/>
                </a:cubicBezTo>
                <a:lnTo>
                  <a:pt x="407650" y="883446"/>
                </a:lnTo>
                <a:cubicBezTo>
                  <a:pt x="414000" y="878684"/>
                  <a:pt x="305329" y="858837"/>
                  <a:pt x="276225" y="835025"/>
                </a:cubicBezTo>
                <a:cubicBezTo>
                  <a:pt x="247121" y="811213"/>
                  <a:pt x="242342" y="784359"/>
                  <a:pt x="233025" y="740571"/>
                </a:cubicBezTo>
                <a:cubicBezTo>
                  <a:pt x="223708" y="696783"/>
                  <a:pt x="241171" y="654449"/>
                  <a:pt x="236200" y="562771"/>
                </a:cubicBezTo>
                <a:cubicBezTo>
                  <a:pt x="231229" y="471093"/>
                  <a:pt x="198967" y="272522"/>
                  <a:pt x="203200" y="190501"/>
                </a:cubicBezTo>
                <a:cubicBezTo>
                  <a:pt x="207433" y="108480"/>
                  <a:pt x="324892" y="78980"/>
                  <a:pt x="337800" y="54771"/>
                </a:cubicBezTo>
                <a:cubicBezTo>
                  <a:pt x="350708" y="30562"/>
                  <a:pt x="293558" y="44849"/>
                  <a:pt x="280650" y="45246"/>
                </a:cubicBezTo>
                <a:cubicBezTo>
                  <a:pt x="267742" y="45643"/>
                  <a:pt x="206584" y="90621"/>
                  <a:pt x="184151" y="73026"/>
                </a:cubicBezTo>
                <a:cubicBezTo>
                  <a:pt x="164043" y="41276"/>
                  <a:pt x="84667" y="25929"/>
                  <a:pt x="66675" y="0"/>
                </a:cubicBezTo>
              </a:path>
            </a:pathLst>
          </a:custGeom>
          <a:solidFill>
            <a:schemeClr val="tx2"/>
          </a:solidFill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286B95F1-F5BC-EB49-9C3F-D59F41843A2E}"/>
              </a:ext>
            </a:extLst>
          </p:cNvPr>
          <p:cNvSpPr/>
          <p:nvPr/>
        </p:nvSpPr>
        <p:spPr>
          <a:xfrm>
            <a:off x="8061401" y="4568305"/>
            <a:ext cx="382660" cy="341951"/>
          </a:xfrm>
          <a:prstGeom prst="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78000">
                <a:schemeClr val="accent1">
                  <a:lumMod val="45000"/>
                  <a:lumOff val="55000"/>
                </a:schemeClr>
              </a:gs>
              <a:gs pos="86000">
                <a:schemeClr val="accent1">
                  <a:lumMod val="45000"/>
                  <a:lumOff val="55000"/>
                </a:schemeClr>
              </a:gs>
              <a:gs pos="100000">
                <a:schemeClr val="accent1">
                  <a:lumMod val="30000"/>
                  <a:lumOff val="70000"/>
                </a:schemeClr>
              </a:gs>
            </a:gsLst>
            <a:lin ang="540000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51" name="Group 50">
            <a:extLst>
              <a:ext uri="{FF2B5EF4-FFF2-40B4-BE49-F238E27FC236}">
                <a16:creationId xmlns:a16="http://schemas.microsoft.com/office/drawing/2014/main" id="{ABCC67CC-8A9D-D546-85BC-CA2C8EC1C7FE}"/>
              </a:ext>
            </a:extLst>
          </p:cNvPr>
          <p:cNvGrpSpPr/>
          <p:nvPr/>
        </p:nvGrpSpPr>
        <p:grpSpPr>
          <a:xfrm>
            <a:off x="6352879" y="1346710"/>
            <a:ext cx="3211585" cy="2388110"/>
            <a:chOff x="7173218" y="2687426"/>
            <a:chExt cx="3650877" cy="2681041"/>
          </a:xfrm>
        </p:grpSpPr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2FE689F7-B410-AF43-B614-1CFD8C74D595}"/>
                </a:ext>
              </a:extLst>
            </p:cNvPr>
            <p:cNvSpPr/>
            <p:nvPr/>
          </p:nvSpPr>
          <p:spPr>
            <a:xfrm>
              <a:off x="7401561" y="3422147"/>
              <a:ext cx="3141460" cy="1910786"/>
            </a:xfrm>
            <a:prstGeom prst="rect">
              <a:avLst/>
            </a:prstGeom>
            <a:solidFill>
              <a:schemeClr val="accent6">
                <a:alpha val="1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2708C95C-084F-EE4E-B417-1F51EF68BE0B}"/>
                </a:ext>
              </a:extLst>
            </p:cNvPr>
            <p:cNvSpPr/>
            <p:nvPr/>
          </p:nvSpPr>
          <p:spPr>
            <a:xfrm>
              <a:off x="7906952" y="3810774"/>
              <a:ext cx="2205402" cy="520951"/>
            </a:xfrm>
            <a:prstGeom prst="rect">
              <a:avLst/>
            </a:prstGeom>
            <a:gradFill>
              <a:gsLst>
                <a:gs pos="0">
                  <a:schemeClr val="accent1">
                    <a:lumMod val="5000"/>
                    <a:lumOff val="95000"/>
                  </a:schemeClr>
                </a:gs>
                <a:gs pos="78000">
                  <a:schemeClr val="accent1">
                    <a:lumMod val="45000"/>
                    <a:lumOff val="55000"/>
                  </a:schemeClr>
                </a:gs>
                <a:gs pos="86000">
                  <a:schemeClr val="accent1">
                    <a:lumMod val="45000"/>
                    <a:lumOff val="55000"/>
                  </a:schemeClr>
                </a:gs>
                <a:gs pos="100000">
                  <a:schemeClr val="accent1">
                    <a:lumMod val="30000"/>
                    <a:lumOff val="70000"/>
                  </a:schemeClr>
                </a:gs>
              </a:gsLst>
              <a:lin ang="5400000" scaled="1"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316AAEF9-CD86-EB40-8E3B-C7EED62E2DAC}"/>
                </a:ext>
              </a:extLst>
            </p:cNvPr>
            <p:cNvGrpSpPr/>
            <p:nvPr/>
          </p:nvGrpSpPr>
          <p:grpSpPr>
            <a:xfrm>
              <a:off x="7173218" y="2687426"/>
              <a:ext cx="3650877" cy="2681041"/>
              <a:chOff x="2334216" y="2981631"/>
              <a:chExt cx="2681870" cy="2303462"/>
            </a:xfrm>
          </p:grpSpPr>
          <p:sp>
            <p:nvSpPr>
              <p:cNvPr id="20" name="Freeform 19">
                <a:extLst>
                  <a:ext uri="{FF2B5EF4-FFF2-40B4-BE49-F238E27FC236}">
                    <a16:creationId xmlns:a16="http://schemas.microsoft.com/office/drawing/2014/main" id="{8A5AF9CD-EF9F-594F-B80F-B8544FEAD37A}"/>
                  </a:ext>
                </a:extLst>
              </p:cNvPr>
              <p:cNvSpPr/>
              <p:nvPr/>
            </p:nvSpPr>
            <p:spPr>
              <a:xfrm>
                <a:off x="3338257" y="4309447"/>
                <a:ext cx="233905" cy="457420"/>
              </a:xfrm>
              <a:custGeom>
                <a:avLst/>
                <a:gdLst>
                  <a:gd name="connsiteX0" fmla="*/ 157497 w 1289611"/>
                  <a:gd name="connsiteY0" fmla="*/ 174171 h 1859149"/>
                  <a:gd name="connsiteX1" fmla="*/ 44285 w 1289611"/>
                  <a:gd name="connsiteY1" fmla="*/ 156754 h 1859149"/>
                  <a:gd name="connsiteX2" fmla="*/ 18160 w 1289611"/>
                  <a:gd name="connsiteY2" fmla="*/ 182880 h 1859149"/>
                  <a:gd name="connsiteX3" fmla="*/ 18160 w 1289611"/>
                  <a:gd name="connsiteY3" fmla="*/ 444137 h 1859149"/>
                  <a:gd name="connsiteX4" fmla="*/ 26868 w 1289611"/>
                  <a:gd name="connsiteY4" fmla="*/ 505097 h 1859149"/>
                  <a:gd name="connsiteX5" fmla="*/ 35577 w 1289611"/>
                  <a:gd name="connsiteY5" fmla="*/ 618309 h 1859149"/>
                  <a:gd name="connsiteX6" fmla="*/ 44285 w 1289611"/>
                  <a:gd name="connsiteY6" fmla="*/ 679269 h 1859149"/>
                  <a:gd name="connsiteX7" fmla="*/ 52994 w 1289611"/>
                  <a:gd name="connsiteY7" fmla="*/ 757646 h 1859149"/>
                  <a:gd name="connsiteX8" fmla="*/ 44285 w 1289611"/>
                  <a:gd name="connsiteY8" fmla="*/ 914400 h 1859149"/>
                  <a:gd name="connsiteX9" fmla="*/ 35577 w 1289611"/>
                  <a:gd name="connsiteY9" fmla="*/ 966651 h 1859149"/>
                  <a:gd name="connsiteX10" fmla="*/ 18160 w 1289611"/>
                  <a:gd name="connsiteY10" fmla="*/ 1236617 h 1859149"/>
                  <a:gd name="connsiteX11" fmla="*/ 9451 w 1289611"/>
                  <a:gd name="connsiteY11" fmla="*/ 1323703 h 1859149"/>
                  <a:gd name="connsiteX12" fmla="*/ 18160 w 1289611"/>
                  <a:gd name="connsiteY12" fmla="*/ 1541417 h 1859149"/>
                  <a:gd name="connsiteX13" fmla="*/ 26868 w 1289611"/>
                  <a:gd name="connsiteY13" fmla="*/ 1576251 h 1859149"/>
                  <a:gd name="connsiteX14" fmla="*/ 35577 w 1289611"/>
                  <a:gd name="connsiteY14" fmla="*/ 1619794 h 1859149"/>
                  <a:gd name="connsiteX15" fmla="*/ 61703 w 1289611"/>
                  <a:gd name="connsiteY15" fmla="*/ 1698171 h 1859149"/>
                  <a:gd name="connsiteX16" fmla="*/ 105245 w 1289611"/>
                  <a:gd name="connsiteY16" fmla="*/ 1776549 h 1859149"/>
                  <a:gd name="connsiteX17" fmla="*/ 122663 w 1289611"/>
                  <a:gd name="connsiteY17" fmla="*/ 1793966 h 1859149"/>
                  <a:gd name="connsiteX18" fmla="*/ 174914 w 1289611"/>
                  <a:gd name="connsiteY18" fmla="*/ 1811383 h 1859149"/>
                  <a:gd name="connsiteX19" fmla="*/ 201040 w 1289611"/>
                  <a:gd name="connsiteY19" fmla="*/ 1820091 h 1859149"/>
                  <a:gd name="connsiteX20" fmla="*/ 349085 w 1289611"/>
                  <a:gd name="connsiteY20" fmla="*/ 1837509 h 1859149"/>
                  <a:gd name="connsiteX21" fmla="*/ 976103 w 1289611"/>
                  <a:gd name="connsiteY21" fmla="*/ 1837509 h 1859149"/>
                  <a:gd name="connsiteX22" fmla="*/ 1010937 w 1289611"/>
                  <a:gd name="connsiteY22" fmla="*/ 1828800 h 1859149"/>
                  <a:gd name="connsiteX23" fmla="*/ 1063188 w 1289611"/>
                  <a:gd name="connsiteY23" fmla="*/ 1820091 h 1859149"/>
                  <a:gd name="connsiteX24" fmla="*/ 1089314 w 1289611"/>
                  <a:gd name="connsiteY24" fmla="*/ 1811383 h 1859149"/>
                  <a:gd name="connsiteX25" fmla="*/ 1150274 w 1289611"/>
                  <a:gd name="connsiteY25" fmla="*/ 1793966 h 1859149"/>
                  <a:gd name="connsiteX26" fmla="*/ 1176400 w 1289611"/>
                  <a:gd name="connsiteY26" fmla="*/ 1776549 h 1859149"/>
                  <a:gd name="connsiteX27" fmla="*/ 1202525 w 1289611"/>
                  <a:gd name="connsiteY27" fmla="*/ 1767840 h 1859149"/>
                  <a:gd name="connsiteX28" fmla="*/ 1237360 w 1289611"/>
                  <a:gd name="connsiteY28" fmla="*/ 1715589 h 1859149"/>
                  <a:gd name="connsiteX29" fmla="*/ 1254777 w 1289611"/>
                  <a:gd name="connsiteY29" fmla="*/ 1698171 h 1859149"/>
                  <a:gd name="connsiteX30" fmla="*/ 1280903 w 1289611"/>
                  <a:gd name="connsiteY30" fmla="*/ 1576251 h 1859149"/>
                  <a:gd name="connsiteX31" fmla="*/ 1289611 w 1289611"/>
                  <a:gd name="connsiteY31" fmla="*/ 1349829 h 1859149"/>
                  <a:gd name="connsiteX32" fmla="*/ 1280903 w 1289611"/>
                  <a:gd name="connsiteY32" fmla="*/ 949234 h 1859149"/>
                  <a:gd name="connsiteX33" fmla="*/ 1263485 w 1289611"/>
                  <a:gd name="connsiteY33" fmla="*/ 539931 h 1859149"/>
                  <a:gd name="connsiteX34" fmla="*/ 1246068 w 1289611"/>
                  <a:gd name="connsiteY34" fmla="*/ 139337 h 1859149"/>
                  <a:gd name="connsiteX35" fmla="*/ 1219943 w 1289611"/>
                  <a:gd name="connsiteY35" fmla="*/ 43543 h 1859149"/>
                  <a:gd name="connsiteX36" fmla="*/ 1211234 w 1289611"/>
                  <a:gd name="connsiteY36" fmla="*/ 17417 h 1859149"/>
                  <a:gd name="connsiteX37" fmla="*/ 1158983 w 1289611"/>
                  <a:gd name="connsiteY37" fmla="*/ 0 h 1859149"/>
                  <a:gd name="connsiteX38" fmla="*/ 1141565 w 1289611"/>
                  <a:gd name="connsiteY38" fmla="*/ 26126 h 1859149"/>
                  <a:gd name="connsiteX39" fmla="*/ 1124148 w 1289611"/>
                  <a:gd name="connsiteY39" fmla="*/ 87086 h 1859149"/>
                  <a:gd name="connsiteX40" fmla="*/ 1115440 w 1289611"/>
                  <a:gd name="connsiteY40" fmla="*/ 113211 h 1859149"/>
                  <a:gd name="connsiteX41" fmla="*/ 1124148 w 1289611"/>
                  <a:gd name="connsiteY41" fmla="*/ 191589 h 1859149"/>
                  <a:gd name="connsiteX42" fmla="*/ 1132857 w 1289611"/>
                  <a:gd name="connsiteY42" fmla="*/ 243840 h 1859149"/>
                  <a:gd name="connsiteX43" fmla="*/ 1141565 w 1289611"/>
                  <a:gd name="connsiteY43" fmla="*/ 322217 h 1859149"/>
                  <a:gd name="connsiteX44" fmla="*/ 1132857 w 1289611"/>
                  <a:gd name="connsiteY44" fmla="*/ 444137 h 1859149"/>
                  <a:gd name="connsiteX45" fmla="*/ 1089314 w 1289611"/>
                  <a:gd name="connsiteY45" fmla="*/ 435429 h 1859149"/>
                  <a:gd name="connsiteX46" fmla="*/ 1080605 w 1289611"/>
                  <a:gd name="connsiteY46" fmla="*/ 409303 h 1859149"/>
                  <a:gd name="connsiteX47" fmla="*/ 1063188 w 1289611"/>
                  <a:gd name="connsiteY47" fmla="*/ 374469 h 1859149"/>
                  <a:gd name="connsiteX48" fmla="*/ 1045771 w 1289611"/>
                  <a:gd name="connsiteY48" fmla="*/ 322217 h 1859149"/>
                  <a:gd name="connsiteX49" fmla="*/ 1037063 w 1289611"/>
                  <a:gd name="connsiteY49" fmla="*/ 252549 h 1859149"/>
                  <a:gd name="connsiteX50" fmla="*/ 1028354 w 1289611"/>
                  <a:gd name="connsiteY50" fmla="*/ 156754 h 1859149"/>
                  <a:gd name="connsiteX51" fmla="*/ 1019645 w 1289611"/>
                  <a:gd name="connsiteY51" fmla="*/ 130629 h 1859149"/>
                  <a:gd name="connsiteX52" fmla="*/ 967394 w 1289611"/>
                  <a:gd name="connsiteY52" fmla="*/ 113211 h 1859149"/>
                  <a:gd name="connsiteX53" fmla="*/ 949977 w 1289611"/>
                  <a:gd name="connsiteY53" fmla="*/ 165463 h 1859149"/>
                  <a:gd name="connsiteX54" fmla="*/ 941268 w 1289611"/>
                  <a:gd name="connsiteY54" fmla="*/ 191589 h 1859149"/>
                  <a:gd name="connsiteX55" fmla="*/ 949977 w 1289611"/>
                  <a:gd name="connsiteY55" fmla="*/ 313509 h 1859149"/>
                  <a:gd name="connsiteX56" fmla="*/ 958685 w 1289611"/>
                  <a:gd name="connsiteY56" fmla="*/ 339634 h 1859149"/>
                  <a:gd name="connsiteX57" fmla="*/ 967394 w 1289611"/>
                  <a:gd name="connsiteY57" fmla="*/ 374469 h 1859149"/>
                  <a:gd name="connsiteX58" fmla="*/ 958685 w 1289611"/>
                  <a:gd name="connsiteY58" fmla="*/ 461554 h 1859149"/>
                  <a:gd name="connsiteX59" fmla="*/ 932560 w 1289611"/>
                  <a:gd name="connsiteY59" fmla="*/ 452846 h 1859149"/>
                  <a:gd name="connsiteX60" fmla="*/ 915143 w 1289611"/>
                  <a:gd name="connsiteY60" fmla="*/ 426720 h 1859149"/>
                  <a:gd name="connsiteX61" fmla="*/ 906434 w 1289611"/>
                  <a:gd name="connsiteY61" fmla="*/ 383177 h 1859149"/>
                  <a:gd name="connsiteX62" fmla="*/ 889017 w 1289611"/>
                  <a:gd name="connsiteY62" fmla="*/ 313509 h 1859149"/>
                  <a:gd name="connsiteX63" fmla="*/ 871600 w 1289611"/>
                  <a:gd name="connsiteY63" fmla="*/ 191589 h 1859149"/>
                  <a:gd name="connsiteX64" fmla="*/ 862891 w 1289611"/>
                  <a:gd name="connsiteY64" fmla="*/ 156754 h 1859149"/>
                  <a:gd name="connsiteX65" fmla="*/ 810640 w 1289611"/>
                  <a:gd name="connsiteY65" fmla="*/ 121920 h 1859149"/>
                  <a:gd name="connsiteX66" fmla="*/ 784514 w 1289611"/>
                  <a:gd name="connsiteY66" fmla="*/ 104503 h 1859149"/>
                  <a:gd name="connsiteX67" fmla="*/ 767097 w 1289611"/>
                  <a:gd name="connsiteY67" fmla="*/ 156754 h 1859149"/>
                  <a:gd name="connsiteX68" fmla="*/ 784514 w 1289611"/>
                  <a:gd name="connsiteY68" fmla="*/ 330926 h 1859149"/>
                  <a:gd name="connsiteX69" fmla="*/ 749680 w 1289611"/>
                  <a:gd name="connsiteY69" fmla="*/ 452846 h 1859149"/>
                  <a:gd name="connsiteX70" fmla="*/ 723554 w 1289611"/>
                  <a:gd name="connsiteY70" fmla="*/ 444137 h 1859149"/>
                  <a:gd name="connsiteX71" fmla="*/ 697428 w 1289611"/>
                  <a:gd name="connsiteY71" fmla="*/ 365760 h 1859149"/>
                  <a:gd name="connsiteX72" fmla="*/ 688720 w 1289611"/>
                  <a:gd name="connsiteY72" fmla="*/ 339634 h 1859149"/>
                  <a:gd name="connsiteX73" fmla="*/ 688720 w 1289611"/>
                  <a:gd name="connsiteY73" fmla="*/ 104503 h 1859149"/>
                  <a:gd name="connsiteX74" fmla="*/ 662594 w 1289611"/>
                  <a:gd name="connsiteY74" fmla="*/ 87086 h 1859149"/>
                  <a:gd name="connsiteX75" fmla="*/ 601634 w 1289611"/>
                  <a:gd name="connsiteY75" fmla="*/ 156754 h 1859149"/>
                  <a:gd name="connsiteX76" fmla="*/ 584217 w 1289611"/>
                  <a:gd name="connsiteY76" fmla="*/ 209006 h 1859149"/>
                  <a:gd name="connsiteX77" fmla="*/ 592925 w 1289611"/>
                  <a:gd name="connsiteY77" fmla="*/ 365760 h 1859149"/>
                  <a:gd name="connsiteX78" fmla="*/ 584217 w 1289611"/>
                  <a:gd name="connsiteY78" fmla="*/ 452846 h 1859149"/>
                  <a:gd name="connsiteX79" fmla="*/ 566800 w 1289611"/>
                  <a:gd name="connsiteY79" fmla="*/ 400594 h 1859149"/>
                  <a:gd name="connsiteX80" fmla="*/ 549383 w 1289611"/>
                  <a:gd name="connsiteY80" fmla="*/ 348343 h 1859149"/>
                  <a:gd name="connsiteX81" fmla="*/ 540674 w 1289611"/>
                  <a:gd name="connsiteY81" fmla="*/ 322217 h 1859149"/>
                  <a:gd name="connsiteX82" fmla="*/ 505840 w 1289611"/>
                  <a:gd name="connsiteY82" fmla="*/ 269966 h 1859149"/>
                  <a:gd name="connsiteX83" fmla="*/ 505840 w 1289611"/>
                  <a:gd name="connsiteY83" fmla="*/ 8709 h 1859149"/>
                  <a:gd name="connsiteX84" fmla="*/ 479714 w 1289611"/>
                  <a:gd name="connsiteY84" fmla="*/ 0 h 1859149"/>
                  <a:gd name="connsiteX85" fmla="*/ 453588 w 1289611"/>
                  <a:gd name="connsiteY85" fmla="*/ 8709 h 1859149"/>
                  <a:gd name="connsiteX86" fmla="*/ 444880 w 1289611"/>
                  <a:gd name="connsiteY86" fmla="*/ 34834 h 1859149"/>
                  <a:gd name="connsiteX87" fmla="*/ 410045 w 1289611"/>
                  <a:gd name="connsiteY87" fmla="*/ 78377 h 1859149"/>
                  <a:gd name="connsiteX88" fmla="*/ 410045 w 1289611"/>
                  <a:gd name="connsiteY88" fmla="*/ 243840 h 1859149"/>
                  <a:gd name="connsiteX89" fmla="*/ 418754 w 1289611"/>
                  <a:gd name="connsiteY89" fmla="*/ 296091 h 1859149"/>
                  <a:gd name="connsiteX90" fmla="*/ 427463 w 1289611"/>
                  <a:gd name="connsiteY90" fmla="*/ 374469 h 1859149"/>
                  <a:gd name="connsiteX91" fmla="*/ 418754 w 1289611"/>
                  <a:gd name="connsiteY91" fmla="*/ 461554 h 1859149"/>
                  <a:gd name="connsiteX92" fmla="*/ 349085 w 1289611"/>
                  <a:gd name="connsiteY92" fmla="*/ 426720 h 1859149"/>
                  <a:gd name="connsiteX93" fmla="*/ 331668 w 1289611"/>
                  <a:gd name="connsiteY93" fmla="*/ 374469 h 1859149"/>
                  <a:gd name="connsiteX94" fmla="*/ 322960 w 1289611"/>
                  <a:gd name="connsiteY94" fmla="*/ 165463 h 1859149"/>
                  <a:gd name="connsiteX95" fmla="*/ 314251 w 1289611"/>
                  <a:gd name="connsiteY95" fmla="*/ 139337 h 1859149"/>
                  <a:gd name="connsiteX96" fmla="*/ 296834 w 1289611"/>
                  <a:gd name="connsiteY96" fmla="*/ 113211 h 1859149"/>
                  <a:gd name="connsiteX97" fmla="*/ 270708 w 1289611"/>
                  <a:gd name="connsiteY97" fmla="*/ 95794 h 1859149"/>
                  <a:gd name="connsiteX98" fmla="*/ 235874 w 1289611"/>
                  <a:gd name="connsiteY98" fmla="*/ 104503 h 1859149"/>
                  <a:gd name="connsiteX99" fmla="*/ 209748 w 1289611"/>
                  <a:gd name="connsiteY99" fmla="*/ 156754 h 1859149"/>
                  <a:gd name="connsiteX100" fmla="*/ 218457 w 1289611"/>
                  <a:gd name="connsiteY100" fmla="*/ 278674 h 1859149"/>
                  <a:gd name="connsiteX101" fmla="*/ 227165 w 1289611"/>
                  <a:gd name="connsiteY101" fmla="*/ 313509 h 1859149"/>
                  <a:gd name="connsiteX102" fmla="*/ 235874 w 1289611"/>
                  <a:gd name="connsiteY102" fmla="*/ 357051 h 1859149"/>
                  <a:gd name="connsiteX103" fmla="*/ 201040 w 1289611"/>
                  <a:gd name="connsiteY103" fmla="*/ 487680 h 1859149"/>
                  <a:gd name="connsiteX104" fmla="*/ 174914 w 1289611"/>
                  <a:gd name="connsiteY104" fmla="*/ 478971 h 1859149"/>
                  <a:gd name="connsiteX105" fmla="*/ 157497 w 1289611"/>
                  <a:gd name="connsiteY105" fmla="*/ 452846 h 1859149"/>
                  <a:gd name="connsiteX106" fmla="*/ 140080 w 1289611"/>
                  <a:gd name="connsiteY106" fmla="*/ 400594 h 1859149"/>
                  <a:gd name="connsiteX107" fmla="*/ 131371 w 1289611"/>
                  <a:gd name="connsiteY107" fmla="*/ 200297 h 1859149"/>
                  <a:gd name="connsiteX108" fmla="*/ 157497 w 1289611"/>
                  <a:gd name="connsiteY108" fmla="*/ 174171 h 185914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  <a:cxn ang="0">
                    <a:pos x="connsiteX73" y="connsiteY73"/>
                  </a:cxn>
                  <a:cxn ang="0">
                    <a:pos x="connsiteX74" y="connsiteY74"/>
                  </a:cxn>
                  <a:cxn ang="0">
                    <a:pos x="connsiteX75" y="connsiteY75"/>
                  </a:cxn>
                  <a:cxn ang="0">
                    <a:pos x="connsiteX76" y="connsiteY76"/>
                  </a:cxn>
                  <a:cxn ang="0">
                    <a:pos x="connsiteX77" y="connsiteY77"/>
                  </a:cxn>
                  <a:cxn ang="0">
                    <a:pos x="connsiteX78" y="connsiteY78"/>
                  </a:cxn>
                  <a:cxn ang="0">
                    <a:pos x="connsiteX79" y="connsiteY79"/>
                  </a:cxn>
                  <a:cxn ang="0">
                    <a:pos x="connsiteX80" y="connsiteY80"/>
                  </a:cxn>
                  <a:cxn ang="0">
                    <a:pos x="connsiteX81" y="connsiteY81"/>
                  </a:cxn>
                  <a:cxn ang="0">
                    <a:pos x="connsiteX82" y="connsiteY82"/>
                  </a:cxn>
                  <a:cxn ang="0">
                    <a:pos x="connsiteX83" y="connsiteY83"/>
                  </a:cxn>
                  <a:cxn ang="0">
                    <a:pos x="connsiteX84" y="connsiteY84"/>
                  </a:cxn>
                  <a:cxn ang="0">
                    <a:pos x="connsiteX85" y="connsiteY85"/>
                  </a:cxn>
                  <a:cxn ang="0">
                    <a:pos x="connsiteX86" y="connsiteY86"/>
                  </a:cxn>
                  <a:cxn ang="0">
                    <a:pos x="connsiteX87" y="connsiteY87"/>
                  </a:cxn>
                  <a:cxn ang="0">
                    <a:pos x="connsiteX88" y="connsiteY88"/>
                  </a:cxn>
                  <a:cxn ang="0">
                    <a:pos x="connsiteX89" y="connsiteY89"/>
                  </a:cxn>
                  <a:cxn ang="0">
                    <a:pos x="connsiteX90" y="connsiteY90"/>
                  </a:cxn>
                  <a:cxn ang="0">
                    <a:pos x="connsiteX91" y="connsiteY91"/>
                  </a:cxn>
                  <a:cxn ang="0">
                    <a:pos x="connsiteX92" y="connsiteY92"/>
                  </a:cxn>
                  <a:cxn ang="0">
                    <a:pos x="connsiteX93" y="connsiteY93"/>
                  </a:cxn>
                  <a:cxn ang="0">
                    <a:pos x="connsiteX94" y="connsiteY94"/>
                  </a:cxn>
                  <a:cxn ang="0">
                    <a:pos x="connsiteX95" y="connsiteY95"/>
                  </a:cxn>
                  <a:cxn ang="0">
                    <a:pos x="connsiteX96" y="connsiteY96"/>
                  </a:cxn>
                  <a:cxn ang="0">
                    <a:pos x="connsiteX97" y="connsiteY97"/>
                  </a:cxn>
                  <a:cxn ang="0">
                    <a:pos x="connsiteX98" y="connsiteY98"/>
                  </a:cxn>
                  <a:cxn ang="0">
                    <a:pos x="connsiteX99" y="connsiteY99"/>
                  </a:cxn>
                  <a:cxn ang="0">
                    <a:pos x="connsiteX100" y="connsiteY100"/>
                  </a:cxn>
                  <a:cxn ang="0">
                    <a:pos x="connsiteX101" y="connsiteY101"/>
                  </a:cxn>
                  <a:cxn ang="0">
                    <a:pos x="connsiteX102" y="connsiteY102"/>
                  </a:cxn>
                  <a:cxn ang="0">
                    <a:pos x="connsiteX103" y="connsiteY103"/>
                  </a:cxn>
                  <a:cxn ang="0">
                    <a:pos x="connsiteX104" y="connsiteY104"/>
                  </a:cxn>
                  <a:cxn ang="0">
                    <a:pos x="connsiteX105" y="connsiteY105"/>
                  </a:cxn>
                  <a:cxn ang="0">
                    <a:pos x="connsiteX106" y="connsiteY106"/>
                  </a:cxn>
                  <a:cxn ang="0">
                    <a:pos x="connsiteX107" y="connsiteY107"/>
                  </a:cxn>
                  <a:cxn ang="0">
                    <a:pos x="connsiteX108" y="connsiteY108"/>
                  </a:cxn>
                </a:cxnLst>
                <a:rect l="l" t="t" r="r" b="b"/>
                <a:pathLst>
                  <a:path w="1289611" h="1859149">
                    <a:moveTo>
                      <a:pt x="157497" y="174171"/>
                    </a:moveTo>
                    <a:cubicBezTo>
                      <a:pt x="142983" y="166914"/>
                      <a:pt x="109336" y="133099"/>
                      <a:pt x="44285" y="156754"/>
                    </a:cubicBezTo>
                    <a:cubicBezTo>
                      <a:pt x="32711" y="160963"/>
                      <a:pt x="26868" y="174171"/>
                      <a:pt x="18160" y="182880"/>
                    </a:cubicBezTo>
                    <a:cubicBezTo>
                      <a:pt x="-14822" y="281823"/>
                      <a:pt x="4588" y="213403"/>
                      <a:pt x="18160" y="444137"/>
                    </a:cubicBezTo>
                    <a:cubicBezTo>
                      <a:pt x="19365" y="464628"/>
                      <a:pt x="24826" y="484673"/>
                      <a:pt x="26868" y="505097"/>
                    </a:cubicBezTo>
                    <a:cubicBezTo>
                      <a:pt x="30634" y="542758"/>
                      <a:pt x="31811" y="580648"/>
                      <a:pt x="35577" y="618309"/>
                    </a:cubicBezTo>
                    <a:cubicBezTo>
                      <a:pt x="37619" y="638733"/>
                      <a:pt x="41739" y="658901"/>
                      <a:pt x="44285" y="679269"/>
                    </a:cubicBezTo>
                    <a:cubicBezTo>
                      <a:pt x="47545" y="705352"/>
                      <a:pt x="50091" y="731520"/>
                      <a:pt x="52994" y="757646"/>
                    </a:cubicBezTo>
                    <a:cubicBezTo>
                      <a:pt x="50091" y="809897"/>
                      <a:pt x="48631" y="862249"/>
                      <a:pt x="44285" y="914400"/>
                    </a:cubicBezTo>
                    <a:cubicBezTo>
                      <a:pt x="42819" y="931996"/>
                      <a:pt x="37334" y="949081"/>
                      <a:pt x="35577" y="966651"/>
                    </a:cubicBezTo>
                    <a:cubicBezTo>
                      <a:pt x="28170" y="1040721"/>
                      <a:pt x="23407" y="1165779"/>
                      <a:pt x="18160" y="1236617"/>
                    </a:cubicBezTo>
                    <a:cubicBezTo>
                      <a:pt x="16005" y="1265711"/>
                      <a:pt x="12354" y="1294674"/>
                      <a:pt x="9451" y="1323703"/>
                    </a:cubicBezTo>
                    <a:cubicBezTo>
                      <a:pt x="12354" y="1396274"/>
                      <a:pt x="13163" y="1468960"/>
                      <a:pt x="18160" y="1541417"/>
                    </a:cubicBezTo>
                    <a:cubicBezTo>
                      <a:pt x="18983" y="1553357"/>
                      <a:pt x="24272" y="1564567"/>
                      <a:pt x="26868" y="1576251"/>
                    </a:cubicBezTo>
                    <a:cubicBezTo>
                      <a:pt x="30079" y="1590700"/>
                      <a:pt x="31682" y="1605514"/>
                      <a:pt x="35577" y="1619794"/>
                    </a:cubicBezTo>
                    <a:cubicBezTo>
                      <a:pt x="35589" y="1619837"/>
                      <a:pt x="57342" y="1685087"/>
                      <a:pt x="61703" y="1698171"/>
                    </a:cubicBezTo>
                    <a:cubicBezTo>
                      <a:pt x="72654" y="1731024"/>
                      <a:pt x="75298" y="1746604"/>
                      <a:pt x="105245" y="1776549"/>
                    </a:cubicBezTo>
                    <a:cubicBezTo>
                      <a:pt x="111051" y="1782355"/>
                      <a:pt x="115319" y="1790294"/>
                      <a:pt x="122663" y="1793966"/>
                    </a:cubicBezTo>
                    <a:cubicBezTo>
                      <a:pt x="139084" y="1802176"/>
                      <a:pt x="157497" y="1805577"/>
                      <a:pt x="174914" y="1811383"/>
                    </a:cubicBezTo>
                    <a:lnTo>
                      <a:pt x="201040" y="1820091"/>
                    </a:lnTo>
                    <a:cubicBezTo>
                      <a:pt x="265824" y="1841686"/>
                      <a:pt x="217981" y="1828144"/>
                      <a:pt x="349085" y="1837509"/>
                    </a:cubicBezTo>
                    <a:cubicBezTo>
                      <a:pt x="586588" y="1877090"/>
                      <a:pt x="424407" y="1853272"/>
                      <a:pt x="976103" y="1837509"/>
                    </a:cubicBezTo>
                    <a:cubicBezTo>
                      <a:pt x="988067" y="1837167"/>
                      <a:pt x="999201" y="1831147"/>
                      <a:pt x="1010937" y="1828800"/>
                    </a:cubicBezTo>
                    <a:cubicBezTo>
                      <a:pt x="1028251" y="1825337"/>
                      <a:pt x="1045951" y="1823921"/>
                      <a:pt x="1063188" y="1820091"/>
                    </a:cubicBezTo>
                    <a:cubicBezTo>
                      <a:pt x="1072149" y="1818100"/>
                      <a:pt x="1080488" y="1813905"/>
                      <a:pt x="1089314" y="1811383"/>
                    </a:cubicBezTo>
                    <a:cubicBezTo>
                      <a:pt x="1165859" y="1789513"/>
                      <a:pt x="1087633" y="1814845"/>
                      <a:pt x="1150274" y="1793966"/>
                    </a:cubicBezTo>
                    <a:cubicBezTo>
                      <a:pt x="1158983" y="1788160"/>
                      <a:pt x="1167039" y="1781230"/>
                      <a:pt x="1176400" y="1776549"/>
                    </a:cubicBezTo>
                    <a:cubicBezTo>
                      <a:pt x="1184610" y="1772444"/>
                      <a:pt x="1196034" y="1774331"/>
                      <a:pt x="1202525" y="1767840"/>
                    </a:cubicBezTo>
                    <a:cubicBezTo>
                      <a:pt x="1217327" y="1753038"/>
                      <a:pt x="1222559" y="1730391"/>
                      <a:pt x="1237360" y="1715589"/>
                    </a:cubicBezTo>
                    <a:lnTo>
                      <a:pt x="1254777" y="1698171"/>
                    </a:lnTo>
                    <a:cubicBezTo>
                      <a:pt x="1279595" y="1623717"/>
                      <a:pt x="1269917" y="1664137"/>
                      <a:pt x="1280903" y="1576251"/>
                    </a:cubicBezTo>
                    <a:cubicBezTo>
                      <a:pt x="1283806" y="1500777"/>
                      <a:pt x="1289611" y="1425359"/>
                      <a:pt x="1289611" y="1349829"/>
                    </a:cubicBezTo>
                    <a:cubicBezTo>
                      <a:pt x="1289611" y="1216266"/>
                      <a:pt x="1284371" y="1082752"/>
                      <a:pt x="1280903" y="949234"/>
                    </a:cubicBezTo>
                    <a:cubicBezTo>
                      <a:pt x="1274097" y="687216"/>
                      <a:pt x="1276051" y="740980"/>
                      <a:pt x="1263485" y="539931"/>
                    </a:cubicBezTo>
                    <a:cubicBezTo>
                      <a:pt x="1259188" y="376634"/>
                      <a:pt x="1267398" y="277986"/>
                      <a:pt x="1246068" y="139337"/>
                    </a:cubicBezTo>
                    <a:cubicBezTo>
                      <a:pt x="1239034" y="93614"/>
                      <a:pt x="1235499" y="90211"/>
                      <a:pt x="1219943" y="43543"/>
                    </a:cubicBezTo>
                    <a:cubicBezTo>
                      <a:pt x="1217040" y="34834"/>
                      <a:pt x="1219943" y="20320"/>
                      <a:pt x="1211234" y="17417"/>
                    </a:cubicBezTo>
                    <a:lnTo>
                      <a:pt x="1158983" y="0"/>
                    </a:lnTo>
                    <a:cubicBezTo>
                      <a:pt x="1153177" y="8709"/>
                      <a:pt x="1146246" y="16764"/>
                      <a:pt x="1141565" y="26126"/>
                    </a:cubicBezTo>
                    <a:cubicBezTo>
                      <a:pt x="1134607" y="40042"/>
                      <a:pt x="1127866" y="74071"/>
                      <a:pt x="1124148" y="87086"/>
                    </a:cubicBezTo>
                    <a:cubicBezTo>
                      <a:pt x="1121626" y="95912"/>
                      <a:pt x="1118343" y="104503"/>
                      <a:pt x="1115440" y="113211"/>
                    </a:cubicBezTo>
                    <a:cubicBezTo>
                      <a:pt x="1118343" y="139337"/>
                      <a:pt x="1120674" y="165533"/>
                      <a:pt x="1124148" y="191589"/>
                    </a:cubicBezTo>
                    <a:cubicBezTo>
                      <a:pt x="1126482" y="209091"/>
                      <a:pt x="1130523" y="226338"/>
                      <a:pt x="1132857" y="243840"/>
                    </a:cubicBezTo>
                    <a:cubicBezTo>
                      <a:pt x="1136331" y="269896"/>
                      <a:pt x="1138662" y="296091"/>
                      <a:pt x="1141565" y="322217"/>
                    </a:cubicBezTo>
                    <a:cubicBezTo>
                      <a:pt x="1138662" y="362857"/>
                      <a:pt x="1149931" y="407143"/>
                      <a:pt x="1132857" y="444137"/>
                    </a:cubicBezTo>
                    <a:cubicBezTo>
                      <a:pt x="1126654" y="457576"/>
                      <a:pt x="1101630" y="443639"/>
                      <a:pt x="1089314" y="435429"/>
                    </a:cubicBezTo>
                    <a:cubicBezTo>
                      <a:pt x="1081676" y="430337"/>
                      <a:pt x="1084221" y="417741"/>
                      <a:pt x="1080605" y="409303"/>
                    </a:cubicBezTo>
                    <a:cubicBezTo>
                      <a:pt x="1075491" y="397371"/>
                      <a:pt x="1068009" y="386522"/>
                      <a:pt x="1063188" y="374469"/>
                    </a:cubicBezTo>
                    <a:cubicBezTo>
                      <a:pt x="1056370" y="357423"/>
                      <a:pt x="1045771" y="322217"/>
                      <a:pt x="1045771" y="322217"/>
                    </a:cubicBezTo>
                    <a:cubicBezTo>
                      <a:pt x="1042868" y="298994"/>
                      <a:pt x="1039513" y="275824"/>
                      <a:pt x="1037063" y="252549"/>
                    </a:cubicBezTo>
                    <a:cubicBezTo>
                      <a:pt x="1033706" y="220662"/>
                      <a:pt x="1032889" y="188495"/>
                      <a:pt x="1028354" y="156754"/>
                    </a:cubicBezTo>
                    <a:cubicBezTo>
                      <a:pt x="1027056" y="147667"/>
                      <a:pt x="1027115" y="135964"/>
                      <a:pt x="1019645" y="130629"/>
                    </a:cubicBezTo>
                    <a:cubicBezTo>
                      <a:pt x="1004705" y="119958"/>
                      <a:pt x="967394" y="113211"/>
                      <a:pt x="967394" y="113211"/>
                    </a:cubicBezTo>
                    <a:lnTo>
                      <a:pt x="949977" y="165463"/>
                    </a:lnTo>
                    <a:lnTo>
                      <a:pt x="941268" y="191589"/>
                    </a:lnTo>
                    <a:cubicBezTo>
                      <a:pt x="944171" y="232229"/>
                      <a:pt x="945216" y="273045"/>
                      <a:pt x="949977" y="313509"/>
                    </a:cubicBezTo>
                    <a:cubicBezTo>
                      <a:pt x="951050" y="322625"/>
                      <a:pt x="956163" y="330808"/>
                      <a:pt x="958685" y="339634"/>
                    </a:cubicBezTo>
                    <a:cubicBezTo>
                      <a:pt x="961973" y="351143"/>
                      <a:pt x="964491" y="362857"/>
                      <a:pt x="967394" y="374469"/>
                    </a:cubicBezTo>
                    <a:cubicBezTo>
                      <a:pt x="964491" y="403497"/>
                      <a:pt x="970533" y="434895"/>
                      <a:pt x="958685" y="461554"/>
                    </a:cubicBezTo>
                    <a:cubicBezTo>
                      <a:pt x="954957" y="469942"/>
                      <a:pt x="939728" y="458580"/>
                      <a:pt x="932560" y="452846"/>
                    </a:cubicBezTo>
                    <a:cubicBezTo>
                      <a:pt x="924387" y="446308"/>
                      <a:pt x="920949" y="435429"/>
                      <a:pt x="915143" y="426720"/>
                    </a:cubicBezTo>
                    <a:cubicBezTo>
                      <a:pt x="912240" y="412206"/>
                      <a:pt x="909762" y="397600"/>
                      <a:pt x="906434" y="383177"/>
                    </a:cubicBezTo>
                    <a:cubicBezTo>
                      <a:pt x="901051" y="359853"/>
                      <a:pt x="889017" y="313509"/>
                      <a:pt x="889017" y="313509"/>
                    </a:cubicBezTo>
                    <a:cubicBezTo>
                      <a:pt x="881410" y="245051"/>
                      <a:pt x="883922" y="247038"/>
                      <a:pt x="871600" y="191589"/>
                    </a:cubicBezTo>
                    <a:cubicBezTo>
                      <a:pt x="869004" y="179905"/>
                      <a:pt x="870773" y="165762"/>
                      <a:pt x="862891" y="156754"/>
                    </a:cubicBezTo>
                    <a:cubicBezTo>
                      <a:pt x="849107" y="141001"/>
                      <a:pt x="828057" y="133531"/>
                      <a:pt x="810640" y="121920"/>
                    </a:cubicBezTo>
                    <a:lnTo>
                      <a:pt x="784514" y="104503"/>
                    </a:lnTo>
                    <a:cubicBezTo>
                      <a:pt x="778708" y="121920"/>
                      <a:pt x="765952" y="138431"/>
                      <a:pt x="767097" y="156754"/>
                    </a:cubicBezTo>
                    <a:cubicBezTo>
                      <a:pt x="776552" y="308037"/>
                      <a:pt x="764518" y="250944"/>
                      <a:pt x="784514" y="330926"/>
                    </a:cubicBezTo>
                    <a:cubicBezTo>
                      <a:pt x="782728" y="352362"/>
                      <a:pt x="802556" y="444034"/>
                      <a:pt x="749680" y="452846"/>
                    </a:cubicBezTo>
                    <a:cubicBezTo>
                      <a:pt x="740625" y="454355"/>
                      <a:pt x="732263" y="447040"/>
                      <a:pt x="723554" y="444137"/>
                    </a:cubicBezTo>
                    <a:lnTo>
                      <a:pt x="697428" y="365760"/>
                    </a:lnTo>
                    <a:lnTo>
                      <a:pt x="688720" y="339634"/>
                    </a:lnTo>
                    <a:cubicBezTo>
                      <a:pt x="691878" y="289110"/>
                      <a:pt x="706843" y="163403"/>
                      <a:pt x="688720" y="104503"/>
                    </a:cubicBezTo>
                    <a:cubicBezTo>
                      <a:pt x="685642" y="94499"/>
                      <a:pt x="671303" y="92892"/>
                      <a:pt x="662594" y="87086"/>
                    </a:cubicBezTo>
                    <a:cubicBezTo>
                      <a:pt x="632114" y="107406"/>
                      <a:pt x="616148" y="113211"/>
                      <a:pt x="601634" y="156754"/>
                    </a:cubicBezTo>
                    <a:lnTo>
                      <a:pt x="584217" y="209006"/>
                    </a:lnTo>
                    <a:cubicBezTo>
                      <a:pt x="587120" y="261257"/>
                      <a:pt x="592925" y="313428"/>
                      <a:pt x="592925" y="365760"/>
                    </a:cubicBezTo>
                    <a:cubicBezTo>
                      <a:pt x="592925" y="394933"/>
                      <a:pt x="601721" y="429507"/>
                      <a:pt x="584217" y="452846"/>
                    </a:cubicBezTo>
                    <a:cubicBezTo>
                      <a:pt x="573201" y="467534"/>
                      <a:pt x="572606" y="418011"/>
                      <a:pt x="566800" y="400594"/>
                    </a:cubicBezTo>
                    <a:lnTo>
                      <a:pt x="549383" y="348343"/>
                    </a:lnTo>
                    <a:cubicBezTo>
                      <a:pt x="546480" y="339634"/>
                      <a:pt x="545766" y="329855"/>
                      <a:pt x="540674" y="322217"/>
                    </a:cubicBezTo>
                    <a:lnTo>
                      <a:pt x="505840" y="269966"/>
                    </a:lnTo>
                    <a:cubicBezTo>
                      <a:pt x="506802" y="250719"/>
                      <a:pt x="524950" y="61262"/>
                      <a:pt x="505840" y="8709"/>
                    </a:cubicBezTo>
                    <a:cubicBezTo>
                      <a:pt x="502703" y="82"/>
                      <a:pt x="488423" y="2903"/>
                      <a:pt x="479714" y="0"/>
                    </a:cubicBezTo>
                    <a:cubicBezTo>
                      <a:pt x="471005" y="2903"/>
                      <a:pt x="460079" y="2218"/>
                      <a:pt x="453588" y="8709"/>
                    </a:cubicBezTo>
                    <a:cubicBezTo>
                      <a:pt x="447097" y="15200"/>
                      <a:pt x="448985" y="26624"/>
                      <a:pt x="444880" y="34834"/>
                    </a:cubicBezTo>
                    <a:cubicBezTo>
                      <a:pt x="433893" y="56808"/>
                      <a:pt x="426247" y="62176"/>
                      <a:pt x="410045" y="78377"/>
                    </a:cubicBezTo>
                    <a:cubicBezTo>
                      <a:pt x="387276" y="146690"/>
                      <a:pt x="397449" y="105287"/>
                      <a:pt x="410045" y="243840"/>
                    </a:cubicBezTo>
                    <a:cubicBezTo>
                      <a:pt x="411644" y="261425"/>
                      <a:pt x="416420" y="278589"/>
                      <a:pt x="418754" y="296091"/>
                    </a:cubicBezTo>
                    <a:cubicBezTo>
                      <a:pt x="422228" y="322147"/>
                      <a:pt x="424560" y="348343"/>
                      <a:pt x="427463" y="374469"/>
                    </a:cubicBezTo>
                    <a:cubicBezTo>
                      <a:pt x="424560" y="403497"/>
                      <a:pt x="436665" y="438526"/>
                      <a:pt x="418754" y="461554"/>
                    </a:cubicBezTo>
                    <a:cubicBezTo>
                      <a:pt x="388804" y="500061"/>
                      <a:pt x="356959" y="438530"/>
                      <a:pt x="349085" y="426720"/>
                    </a:cubicBezTo>
                    <a:cubicBezTo>
                      <a:pt x="343279" y="409303"/>
                      <a:pt x="332432" y="392812"/>
                      <a:pt x="331668" y="374469"/>
                    </a:cubicBezTo>
                    <a:cubicBezTo>
                      <a:pt x="328765" y="304800"/>
                      <a:pt x="328111" y="235002"/>
                      <a:pt x="322960" y="165463"/>
                    </a:cubicBezTo>
                    <a:cubicBezTo>
                      <a:pt x="322282" y="156308"/>
                      <a:pt x="318356" y="147548"/>
                      <a:pt x="314251" y="139337"/>
                    </a:cubicBezTo>
                    <a:cubicBezTo>
                      <a:pt x="309570" y="129976"/>
                      <a:pt x="304235" y="120612"/>
                      <a:pt x="296834" y="113211"/>
                    </a:cubicBezTo>
                    <a:cubicBezTo>
                      <a:pt x="289433" y="105810"/>
                      <a:pt x="279417" y="101600"/>
                      <a:pt x="270708" y="95794"/>
                    </a:cubicBezTo>
                    <a:cubicBezTo>
                      <a:pt x="259097" y="98697"/>
                      <a:pt x="245832" y="97864"/>
                      <a:pt x="235874" y="104503"/>
                    </a:cubicBezTo>
                    <a:cubicBezTo>
                      <a:pt x="221405" y="114149"/>
                      <a:pt x="214716" y="141852"/>
                      <a:pt x="209748" y="156754"/>
                    </a:cubicBezTo>
                    <a:cubicBezTo>
                      <a:pt x="212651" y="197394"/>
                      <a:pt x="213958" y="238180"/>
                      <a:pt x="218457" y="278674"/>
                    </a:cubicBezTo>
                    <a:cubicBezTo>
                      <a:pt x="219779" y="290570"/>
                      <a:pt x="224569" y="301825"/>
                      <a:pt x="227165" y="313509"/>
                    </a:cubicBezTo>
                    <a:cubicBezTo>
                      <a:pt x="230376" y="327958"/>
                      <a:pt x="232971" y="342537"/>
                      <a:pt x="235874" y="357051"/>
                    </a:cubicBezTo>
                    <a:cubicBezTo>
                      <a:pt x="233357" y="392280"/>
                      <a:pt x="264275" y="487680"/>
                      <a:pt x="201040" y="487680"/>
                    </a:cubicBezTo>
                    <a:cubicBezTo>
                      <a:pt x="191860" y="487680"/>
                      <a:pt x="183623" y="481874"/>
                      <a:pt x="174914" y="478971"/>
                    </a:cubicBezTo>
                    <a:cubicBezTo>
                      <a:pt x="169108" y="470263"/>
                      <a:pt x="161748" y="462410"/>
                      <a:pt x="157497" y="452846"/>
                    </a:cubicBezTo>
                    <a:cubicBezTo>
                      <a:pt x="150041" y="436069"/>
                      <a:pt x="140080" y="400594"/>
                      <a:pt x="140080" y="400594"/>
                    </a:cubicBezTo>
                    <a:cubicBezTo>
                      <a:pt x="137177" y="333828"/>
                      <a:pt x="139031" y="266685"/>
                      <a:pt x="131371" y="200297"/>
                    </a:cubicBezTo>
                    <a:cubicBezTo>
                      <a:pt x="130171" y="189900"/>
                      <a:pt x="172011" y="181428"/>
                      <a:pt x="157497" y="174171"/>
                    </a:cubicBezTo>
                    <a:close/>
                  </a:path>
                </a:pathLst>
              </a:custGeom>
              <a:solidFill>
                <a:srgbClr val="B3C7E7"/>
              </a:solidFill>
              <a:ln>
                <a:solidFill>
                  <a:srgbClr val="2F559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charset="0"/>
                  <a:ea typeface="Arial" charset="0"/>
                  <a:cs typeface="Arial" charset="0"/>
                </a:endParaRPr>
              </a:p>
            </p:txBody>
          </p:sp>
          <p:grpSp>
            <p:nvGrpSpPr>
              <p:cNvPr id="21" name="Group 20">
                <a:extLst>
                  <a:ext uri="{FF2B5EF4-FFF2-40B4-BE49-F238E27FC236}">
                    <a16:creationId xmlns:a16="http://schemas.microsoft.com/office/drawing/2014/main" id="{A83B5415-A9AA-3245-9815-F8622B3391FA}"/>
                  </a:ext>
                </a:extLst>
              </p:cNvPr>
              <p:cNvGrpSpPr/>
              <p:nvPr/>
            </p:nvGrpSpPr>
            <p:grpSpPr>
              <a:xfrm>
                <a:off x="2334216" y="2981631"/>
                <a:ext cx="2681870" cy="1846218"/>
                <a:chOff x="1054817" y="2511277"/>
                <a:chExt cx="527197" cy="332817"/>
              </a:xfrm>
            </p:grpSpPr>
            <p:cxnSp>
              <p:nvCxnSpPr>
                <p:cNvPr id="41" name="Straight Connector 40">
                  <a:extLst>
                    <a:ext uri="{FF2B5EF4-FFF2-40B4-BE49-F238E27FC236}">
                      <a16:creationId xmlns:a16="http://schemas.microsoft.com/office/drawing/2014/main" id="{4511456A-C3A4-4243-B343-83A0427C02C3}"/>
                    </a:ext>
                  </a:extLst>
                </p:cNvPr>
                <p:cNvCxnSpPr/>
                <p:nvPr/>
              </p:nvCxnSpPr>
              <p:spPr>
                <a:xfrm>
                  <a:off x="1054817" y="2519835"/>
                  <a:ext cx="89876" cy="0"/>
                </a:xfrm>
                <a:prstGeom prst="line">
                  <a:avLst/>
                </a:prstGeom>
                <a:ln w="762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2" name="Straight Connector 41">
                  <a:extLst>
                    <a:ext uri="{FF2B5EF4-FFF2-40B4-BE49-F238E27FC236}">
                      <a16:creationId xmlns:a16="http://schemas.microsoft.com/office/drawing/2014/main" id="{8D828E70-760D-F242-8B1C-10678B56D77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37352" y="2514510"/>
                  <a:ext cx="34305" cy="329584"/>
                </a:xfrm>
                <a:prstGeom prst="line">
                  <a:avLst/>
                </a:prstGeom>
                <a:ln w="762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3" name="Straight Connector 42">
                  <a:extLst>
                    <a:ext uri="{FF2B5EF4-FFF2-40B4-BE49-F238E27FC236}">
                      <a16:creationId xmlns:a16="http://schemas.microsoft.com/office/drawing/2014/main" id="{AF39083F-3602-904D-B523-B4E2DA62A7C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65548" y="2836884"/>
                  <a:ext cx="304709" cy="0"/>
                </a:xfrm>
                <a:prstGeom prst="line">
                  <a:avLst/>
                </a:prstGeom>
                <a:ln w="76200">
                  <a:prstDash val="sysDash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4" name="Straight Connector 43">
                  <a:extLst>
                    <a:ext uri="{FF2B5EF4-FFF2-40B4-BE49-F238E27FC236}">
                      <a16:creationId xmlns:a16="http://schemas.microsoft.com/office/drawing/2014/main" id="{FD28A321-4A72-B247-AFBD-4DDF60C4FA1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465867" y="2511277"/>
                  <a:ext cx="34153" cy="329677"/>
                </a:xfrm>
                <a:prstGeom prst="line">
                  <a:avLst/>
                </a:prstGeom>
                <a:ln w="762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5" name="Straight Connector 44">
                  <a:extLst>
                    <a:ext uri="{FF2B5EF4-FFF2-40B4-BE49-F238E27FC236}">
                      <a16:creationId xmlns:a16="http://schemas.microsoft.com/office/drawing/2014/main" id="{FBC0EE58-DA09-184B-BEA3-88ADF1C1186C}"/>
                    </a:ext>
                  </a:extLst>
                </p:cNvPr>
                <p:cNvCxnSpPr/>
                <p:nvPr/>
              </p:nvCxnSpPr>
              <p:spPr>
                <a:xfrm>
                  <a:off x="1492138" y="2517422"/>
                  <a:ext cx="89876" cy="0"/>
                </a:xfrm>
                <a:prstGeom prst="line">
                  <a:avLst/>
                </a:prstGeom>
                <a:ln w="762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22" name="Straight Connector 21">
                <a:extLst>
                  <a:ext uri="{FF2B5EF4-FFF2-40B4-BE49-F238E27FC236}">
                    <a16:creationId xmlns:a16="http://schemas.microsoft.com/office/drawing/2014/main" id="{997826DF-A5F2-0346-B49A-EC47F1705C0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01953" y="3127109"/>
                <a:ext cx="0" cy="2157984"/>
              </a:xfrm>
              <a:prstGeom prst="line">
                <a:avLst/>
              </a:prstGeom>
              <a:ln w="762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3" name="Straight Connector 22">
                <a:extLst>
                  <a:ext uri="{FF2B5EF4-FFF2-40B4-BE49-F238E27FC236}">
                    <a16:creationId xmlns:a16="http://schemas.microsoft.com/office/drawing/2014/main" id="{E2885AF8-02BB-9446-8ABD-085ABD7B40D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809614" y="3122202"/>
                <a:ext cx="0" cy="2160925"/>
              </a:xfrm>
              <a:prstGeom prst="line">
                <a:avLst/>
              </a:prstGeom>
              <a:ln w="762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4" name="Straight Connector 23">
                <a:extLst>
                  <a:ext uri="{FF2B5EF4-FFF2-40B4-BE49-F238E27FC236}">
                    <a16:creationId xmlns:a16="http://schemas.microsoft.com/office/drawing/2014/main" id="{D7189F7B-1573-2146-8DF5-61B0EDDE6B4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478670" y="5254563"/>
                <a:ext cx="2359152" cy="0"/>
              </a:xfrm>
              <a:prstGeom prst="line">
                <a:avLst/>
              </a:prstGeom>
              <a:ln w="762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25" name="Group 24">
                <a:extLst>
                  <a:ext uri="{FF2B5EF4-FFF2-40B4-BE49-F238E27FC236}">
                    <a16:creationId xmlns:a16="http://schemas.microsoft.com/office/drawing/2014/main" id="{3088914C-3FBB-5442-8DC8-93669EA76ADD}"/>
                  </a:ext>
                </a:extLst>
              </p:cNvPr>
              <p:cNvGrpSpPr/>
              <p:nvPr/>
            </p:nvGrpSpPr>
            <p:grpSpPr>
              <a:xfrm>
                <a:off x="2939480" y="4302354"/>
                <a:ext cx="1479155" cy="467176"/>
                <a:chOff x="5289050" y="2610438"/>
                <a:chExt cx="1658946" cy="400905"/>
              </a:xfrm>
            </p:grpSpPr>
            <p:sp>
              <p:nvSpPr>
                <p:cNvPr id="29" name="Rounded Rectangle 28">
                  <a:extLst>
                    <a:ext uri="{FF2B5EF4-FFF2-40B4-BE49-F238E27FC236}">
                      <a16:creationId xmlns:a16="http://schemas.microsoft.com/office/drawing/2014/main" id="{DE425C60-7D0C-9643-86EC-3D1B32492871}"/>
                    </a:ext>
                  </a:extLst>
                </p:cNvPr>
                <p:cNvSpPr/>
                <p:nvPr/>
              </p:nvSpPr>
              <p:spPr>
                <a:xfrm>
                  <a:off x="6477526" y="2668855"/>
                  <a:ext cx="222422" cy="321535"/>
                </a:xfrm>
                <a:prstGeom prst="roundRect">
                  <a:avLst/>
                </a:prstGeom>
                <a:solidFill>
                  <a:srgbClr val="A9D28E"/>
                </a:solidFill>
                <a:ln>
                  <a:solidFill>
                    <a:srgbClr val="54823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30" name="Freeform 29">
                  <a:extLst>
                    <a:ext uri="{FF2B5EF4-FFF2-40B4-BE49-F238E27FC236}">
                      <a16:creationId xmlns:a16="http://schemas.microsoft.com/office/drawing/2014/main" id="{5E599B00-2222-1C4D-BB3E-36CA7061685C}"/>
                    </a:ext>
                  </a:extLst>
                </p:cNvPr>
                <p:cNvSpPr/>
                <p:nvPr/>
              </p:nvSpPr>
              <p:spPr>
                <a:xfrm>
                  <a:off x="6225223" y="2611056"/>
                  <a:ext cx="248048" cy="392533"/>
                </a:xfrm>
                <a:custGeom>
                  <a:avLst/>
                  <a:gdLst>
                    <a:gd name="connsiteX0" fmla="*/ 157497 w 1289611"/>
                    <a:gd name="connsiteY0" fmla="*/ 174171 h 1859149"/>
                    <a:gd name="connsiteX1" fmla="*/ 44285 w 1289611"/>
                    <a:gd name="connsiteY1" fmla="*/ 156754 h 1859149"/>
                    <a:gd name="connsiteX2" fmla="*/ 18160 w 1289611"/>
                    <a:gd name="connsiteY2" fmla="*/ 182880 h 1859149"/>
                    <a:gd name="connsiteX3" fmla="*/ 18160 w 1289611"/>
                    <a:gd name="connsiteY3" fmla="*/ 444137 h 1859149"/>
                    <a:gd name="connsiteX4" fmla="*/ 26868 w 1289611"/>
                    <a:gd name="connsiteY4" fmla="*/ 505097 h 1859149"/>
                    <a:gd name="connsiteX5" fmla="*/ 35577 w 1289611"/>
                    <a:gd name="connsiteY5" fmla="*/ 618309 h 1859149"/>
                    <a:gd name="connsiteX6" fmla="*/ 44285 w 1289611"/>
                    <a:gd name="connsiteY6" fmla="*/ 679269 h 1859149"/>
                    <a:gd name="connsiteX7" fmla="*/ 52994 w 1289611"/>
                    <a:gd name="connsiteY7" fmla="*/ 757646 h 1859149"/>
                    <a:gd name="connsiteX8" fmla="*/ 44285 w 1289611"/>
                    <a:gd name="connsiteY8" fmla="*/ 914400 h 1859149"/>
                    <a:gd name="connsiteX9" fmla="*/ 35577 w 1289611"/>
                    <a:gd name="connsiteY9" fmla="*/ 966651 h 1859149"/>
                    <a:gd name="connsiteX10" fmla="*/ 18160 w 1289611"/>
                    <a:gd name="connsiteY10" fmla="*/ 1236617 h 1859149"/>
                    <a:gd name="connsiteX11" fmla="*/ 9451 w 1289611"/>
                    <a:gd name="connsiteY11" fmla="*/ 1323703 h 1859149"/>
                    <a:gd name="connsiteX12" fmla="*/ 18160 w 1289611"/>
                    <a:gd name="connsiteY12" fmla="*/ 1541417 h 1859149"/>
                    <a:gd name="connsiteX13" fmla="*/ 26868 w 1289611"/>
                    <a:gd name="connsiteY13" fmla="*/ 1576251 h 1859149"/>
                    <a:gd name="connsiteX14" fmla="*/ 35577 w 1289611"/>
                    <a:gd name="connsiteY14" fmla="*/ 1619794 h 1859149"/>
                    <a:gd name="connsiteX15" fmla="*/ 61703 w 1289611"/>
                    <a:gd name="connsiteY15" fmla="*/ 1698171 h 1859149"/>
                    <a:gd name="connsiteX16" fmla="*/ 105245 w 1289611"/>
                    <a:gd name="connsiteY16" fmla="*/ 1776549 h 1859149"/>
                    <a:gd name="connsiteX17" fmla="*/ 122663 w 1289611"/>
                    <a:gd name="connsiteY17" fmla="*/ 1793966 h 1859149"/>
                    <a:gd name="connsiteX18" fmla="*/ 174914 w 1289611"/>
                    <a:gd name="connsiteY18" fmla="*/ 1811383 h 1859149"/>
                    <a:gd name="connsiteX19" fmla="*/ 201040 w 1289611"/>
                    <a:gd name="connsiteY19" fmla="*/ 1820091 h 1859149"/>
                    <a:gd name="connsiteX20" fmla="*/ 349085 w 1289611"/>
                    <a:gd name="connsiteY20" fmla="*/ 1837509 h 1859149"/>
                    <a:gd name="connsiteX21" fmla="*/ 976103 w 1289611"/>
                    <a:gd name="connsiteY21" fmla="*/ 1837509 h 1859149"/>
                    <a:gd name="connsiteX22" fmla="*/ 1010937 w 1289611"/>
                    <a:gd name="connsiteY22" fmla="*/ 1828800 h 1859149"/>
                    <a:gd name="connsiteX23" fmla="*/ 1063188 w 1289611"/>
                    <a:gd name="connsiteY23" fmla="*/ 1820091 h 1859149"/>
                    <a:gd name="connsiteX24" fmla="*/ 1089314 w 1289611"/>
                    <a:gd name="connsiteY24" fmla="*/ 1811383 h 1859149"/>
                    <a:gd name="connsiteX25" fmla="*/ 1150274 w 1289611"/>
                    <a:gd name="connsiteY25" fmla="*/ 1793966 h 1859149"/>
                    <a:gd name="connsiteX26" fmla="*/ 1176400 w 1289611"/>
                    <a:gd name="connsiteY26" fmla="*/ 1776549 h 1859149"/>
                    <a:gd name="connsiteX27" fmla="*/ 1202525 w 1289611"/>
                    <a:gd name="connsiteY27" fmla="*/ 1767840 h 1859149"/>
                    <a:gd name="connsiteX28" fmla="*/ 1237360 w 1289611"/>
                    <a:gd name="connsiteY28" fmla="*/ 1715589 h 1859149"/>
                    <a:gd name="connsiteX29" fmla="*/ 1254777 w 1289611"/>
                    <a:gd name="connsiteY29" fmla="*/ 1698171 h 1859149"/>
                    <a:gd name="connsiteX30" fmla="*/ 1280903 w 1289611"/>
                    <a:gd name="connsiteY30" fmla="*/ 1576251 h 1859149"/>
                    <a:gd name="connsiteX31" fmla="*/ 1289611 w 1289611"/>
                    <a:gd name="connsiteY31" fmla="*/ 1349829 h 1859149"/>
                    <a:gd name="connsiteX32" fmla="*/ 1280903 w 1289611"/>
                    <a:gd name="connsiteY32" fmla="*/ 949234 h 1859149"/>
                    <a:gd name="connsiteX33" fmla="*/ 1263485 w 1289611"/>
                    <a:gd name="connsiteY33" fmla="*/ 539931 h 1859149"/>
                    <a:gd name="connsiteX34" fmla="*/ 1246068 w 1289611"/>
                    <a:gd name="connsiteY34" fmla="*/ 139337 h 1859149"/>
                    <a:gd name="connsiteX35" fmla="*/ 1219943 w 1289611"/>
                    <a:gd name="connsiteY35" fmla="*/ 43543 h 1859149"/>
                    <a:gd name="connsiteX36" fmla="*/ 1211234 w 1289611"/>
                    <a:gd name="connsiteY36" fmla="*/ 17417 h 1859149"/>
                    <a:gd name="connsiteX37" fmla="*/ 1158983 w 1289611"/>
                    <a:gd name="connsiteY37" fmla="*/ 0 h 1859149"/>
                    <a:gd name="connsiteX38" fmla="*/ 1141565 w 1289611"/>
                    <a:gd name="connsiteY38" fmla="*/ 26126 h 1859149"/>
                    <a:gd name="connsiteX39" fmla="*/ 1124148 w 1289611"/>
                    <a:gd name="connsiteY39" fmla="*/ 87086 h 1859149"/>
                    <a:gd name="connsiteX40" fmla="*/ 1115440 w 1289611"/>
                    <a:gd name="connsiteY40" fmla="*/ 113211 h 1859149"/>
                    <a:gd name="connsiteX41" fmla="*/ 1124148 w 1289611"/>
                    <a:gd name="connsiteY41" fmla="*/ 191589 h 1859149"/>
                    <a:gd name="connsiteX42" fmla="*/ 1132857 w 1289611"/>
                    <a:gd name="connsiteY42" fmla="*/ 243840 h 1859149"/>
                    <a:gd name="connsiteX43" fmla="*/ 1141565 w 1289611"/>
                    <a:gd name="connsiteY43" fmla="*/ 322217 h 1859149"/>
                    <a:gd name="connsiteX44" fmla="*/ 1132857 w 1289611"/>
                    <a:gd name="connsiteY44" fmla="*/ 444137 h 1859149"/>
                    <a:gd name="connsiteX45" fmla="*/ 1089314 w 1289611"/>
                    <a:gd name="connsiteY45" fmla="*/ 435429 h 1859149"/>
                    <a:gd name="connsiteX46" fmla="*/ 1080605 w 1289611"/>
                    <a:gd name="connsiteY46" fmla="*/ 409303 h 1859149"/>
                    <a:gd name="connsiteX47" fmla="*/ 1063188 w 1289611"/>
                    <a:gd name="connsiteY47" fmla="*/ 374469 h 1859149"/>
                    <a:gd name="connsiteX48" fmla="*/ 1045771 w 1289611"/>
                    <a:gd name="connsiteY48" fmla="*/ 322217 h 1859149"/>
                    <a:gd name="connsiteX49" fmla="*/ 1037063 w 1289611"/>
                    <a:gd name="connsiteY49" fmla="*/ 252549 h 1859149"/>
                    <a:gd name="connsiteX50" fmla="*/ 1028354 w 1289611"/>
                    <a:gd name="connsiteY50" fmla="*/ 156754 h 1859149"/>
                    <a:gd name="connsiteX51" fmla="*/ 1019645 w 1289611"/>
                    <a:gd name="connsiteY51" fmla="*/ 130629 h 1859149"/>
                    <a:gd name="connsiteX52" fmla="*/ 967394 w 1289611"/>
                    <a:gd name="connsiteY52" fmla="*/ 113211 h 1859149"/>
                    <a:gd name="connsiteX53" fmla="*/ 949977 w 1289611"/>
                    <a:gd name="connsiteY53" fmla="*/ 165463 h 1859149"/>
                    <a:gd name="connsiteX54" fmla="*/ 941268 w 1289611"/>
                    <a:gd name="connsiteY54" fmla="*/ 191589 h 1859149"/>
                    <a:gd name="connsiteX55" fmla="*/ 949977 w 1289611"/>
                    <a:gd name="connsiteY55" fmla="*/ 313509 h 1859149"/>
                    <a:gd name="connsiteX56" fmla="*/ 958685 w 1289611"/>
                    <a:gd name="connsiteY56" fmla="*/ 339634 h 1859149"/>
                    <a:gd name="connsiteX57" fmla="*/ 967394 w 1289611"/>
                    <a:gd name="connsiteY57" fmla="*/ 374469 h 1859149"/>
                    <a:gd name="connsiteX58" fmla="*/ 958685 w 1289611"/>
                    <a:gd name="connsiteY58" fmla="*/ 461554 h 1859149"/>
                    <a:gd name="connsiteX59" fmla="*/ 932560 w 1289611"/>
                    <a:gd name="connsiteY59" fmla="*/ 452846 h 1859149"/>
                    <a:gd name="connsiteX60" fmla="*/ 915143 w 1289611"/>
                    <a:gd name="connsiteY60" fmla="*/ 426720 h 1859149"/>
                    <a:gd name="connsiteX61" fmla="*/ 906434 w 1289611"/>
                    <a:gd name="connsiteY61" fmla="*/ 383177 h 1859149"/>
                    <a:gd name="connsiteX62" fmla="*/ 889017 w 1289611"/>
                    <a:gd name="connsiteY62" fmla="*/ 313509 h 1859149"/>
                    <a:gd name="connsiteX63" fmla="*/ 871600 w 1289611"/>
                    <a:gd name="connsiteY63" fmla="*/ 191589 h 1859149"/>
                    <a:gd name="connsiteX64" fmla="*/ 862891 w 1289611"/>
                    <a:gd name="connsiteY64" fmla="*/ 156754 h 1859149"/>
                    <a:gd name="connsiteX65" fmla="*/ 810640 w 1289611"/>
                    <a:gd name="connsiteY65" fmla="*/ 121920 h 1859149"/>
                    <a:gd name="connsiteX66" fmla="*/ 784514 w 1289611"/>
                    <a:gd name="connsiteY66" fmla="*/ 104503 h 1859149"/>
                    <a:gd name="connsiteX67" fmla="*/ 767097 w 1289611"/>
                    <a:gd name="connsiteY67" fmla="*/ 156754 h 1859149"/>
                    <a:gd name="connsiteX68" fmla="*/ 784514 w 1289611"/>
                    <a:gd name="connsiteY68" fmla="*/ 330926 h 1859149"/>
                    <a:gd name="connsiteX69" fmla="*/ 749680 w 1289611"/>
                    <a:gd name="connsiteY69" fmla="*/ 452846 h 1859149"/>
                    <a:gd name="connsiteX70" fmla="*/ 723554 w 1289611"/>
                    <a:gd name="connsiteY70" fmla="*/ 444137 h 1859149"/>
                    <a:gd name="connsiteX71" fmla="*/ 697428 w 1289611"/>
                    <a:gd name="connsiteY71" fmla="*/ 365760 h 1859149"/>
                    <a:gd name="connsiteX72" fmla="*/ 688720 w 1289611"/>
                    <a:gd name="connsiteY72" fmla="*/ 339634 h 1859149"/>
                    <a:gd name="connsiteX73" fmla="*/ 688720 w 1289611"/>
                    <a:gd name="connsiteY73" fmla="*/ 104503 h 1859149"/>
                    <a:gd name="connsiteX74" fmla="*/ 662594 w 1289611"/>
                    <a:gd name="connsiteY74" fmla="*/ 87086 h 1859149"/>
                    <a:gd name="connsiteX75" fmla="*/ 601634 w 1289611"/>
                    <a:gd name="connsiteY75" fmla="*/ 156754 h 1859149"/>
                    <a:gd name="connsiteX76" fmla="*/ 584217 w 1289611"/>
                    <a:gd name="connsiteY76" fmla="*/ 209006 h 1859149"/>
                    <a:gd name="connsiteX77" fmla="*/ 592925 w 1289611"/>
                    <a:gd name="connsiteY77" fmla="*/ 365760 h 1859149"/>
                    <a:gd name="connsiteX78" fmla="*/ 584217 w 1289611"/>
                    <a:gd name="connsiteY78" fmla="*/ 452846 h 1859149"/>
                    <a:gd name="connsiteX79" fmla="*/ 566800 w 1289611"/>
                    <a:gd name="connsiteY79" fmla="*/ 400594 h 1859149"/>
                    <a:gd name="connsiteX80" fmla="*/ 549383 w 1289611"/>
                    <a:gd name="connsiteY80" fmla="*/ 348343 h 1859149"/>
                    <a:gd name="connsiteX81" fmla="*/ 540674 w 1289611"/>
                    <a:gd name="connsiteY81" fmla="*/ 322217 h 1859149"/>
                    <a:gd name="connsiteX82" fmla="*/ 505840 w 1289611"/>
                    <a:gd name="connsiteY82" fmla="*/ 269966 h 1859149"/>
                    <a:gd name="connsiteX83" fmla="*/ 505840 w 1289611"/>
                    <a:gd name="connsiteY83" fmla="*/ 8709 h 1859149"/>
                    <a:gd name="connsiteX84" fmla="*/ 479714 w 1289611"/>
                    <a:gd name="connsiteY84" fmla="*/ 0 h 1859149"/>
                    <a:gd name="connsiteX85" fmla="*/ 453588 w 1289611"/>
                    <a:gd name="connsiteY85" fmla="*/ 8709 h 1859149"/>
                    <a:gd name="connsiteX86" fmla="*/ 444880 w 1289611"/>
                    <a:gd name="connsiteY86" fmla="*/ 34834 h 1859149"/>
                    <a:gd name="connsiteX87" fmla="*/ 410045 w 1289611"/>
                    <a:gd name="connsiteY87" fmla="*/ 78377 h 1859149"/>
                    <a:gd name="connsiteX88" fmla="*/ 410045 w 1289611"/>
                    <a:gd name="connsiteY88" fmla="*/ 243840 h 1859149"/>
                    <a:gd name="connsiteX89" fmla="*/ 418754 w 1289611"/>
                    <a:gd name="connsiteY89" fmla="*/ 296091 h 1859149"/>
                    <a:gd name="connsiteX90" fmla="*/ 427463 w 1289611"/>
                    <a:gd name="connsiteY90" fmla="*/ 374469 h 1859149"/>
                    <a:gd name="connsiteX91" fmla="*/ 418754 w 1289611"/>
                    <a:gd name="connsiteY91" fmla="*/ 461554 h 1859149"/>
                    <a:gd name="connsiteX92" fmla="*/ 349085 w 1289611"/>
                    <a:gd name="connsiteY92" fmla="*/ 426720 h 1859149"/>
                    <a:gd name="connsiteX93" fmla="*/ 331668 w 1289611"/>
                    <a:gd name="connsiteY93" fmla="*/ 374469 h 1859149"/>
                    <a:gd name="connsiteX94" fmla="*/ 322960 w 1289611"/>
                    <a:gd name="connsiteY94" fmla="*/ 165463 h 1859149"/>
                    <a:gd name="connsiteX95" fmla="*/ 314251 w 1289611"/>
                    <a:gd name="connsiteY95" fmla="*/ 139337 h 1859149"/>
                    <a:gd name="connsiteX96" fmla="*/ 296834 w 1289611"/>
                    <a:gd name="connsiteY96" fmla="*/ 113211 h 1859149"/>
                    <a:gd name="connsiteX97" fmla="*/ 270708 w 1289611"/>
                    <a:gd name="connsiteY97" fmla="*/ 95794 h 1859149"/>
                    <a:gd name="connsiteX98" fmla="*/ 235874 w 1289611"/>
                    <a:gd name="connsiteY98" fmla="*/ 104503 h 1859149"/>
                    <a:gd name="connsiteX99" fmla="*/ 209748 w 1289611"/>
                    <a:gd name="connsiteY99" fmla="*/ 156754 h 1859149"/>
                    <a:gd name="connsiteX100" fmla="*/ 218457 w 1289611"/>
                    <a:gd name="connsiteY100" fmla="*/ 278674 h 1859149"/>
                    <a:gd name="connsiteX101" fmla="*/ 227165 w 1289611"/>
                    <a:gd name="connsiteY101" fmla="*/ 313509 h 1859149"/>
                    <a:gd name="connsiteX102" fmla="*/ 235874 w 1289611"/>
                    <a:gd name="connsiteY102" fmla="*/ 357051 h 1859149"/>
                    <a:gd name="connsiteX103" fmla="*/ 201040 w 1289611"/>
                    <a:gd name="connsiteY103" fmla="*/ 487680 h 1859149"/>
                    <a:gd name="connsiteX104" fmla="*/ 174914 w 1289611"/>
                    <a:gd name="connsiteY104" fmla="*/ 478971 h 1859149"/>
                    <a:gd name="connsiteX105" fmla="*/ 157497 w 1289611"/>
                    <a:gd name="connsiteY105" fmla="*/ 452846 h 1859149"/>
                    <a:gd name="connsiteX106" fmla="*/ 140080 w 1289611"/>
                    <a:gd name="connsiteY106" fmla="*/ 400594 h 1859149"/>
                    <a:gd name="connsiteX107" fmla="*/ 131371 w 1289611"/>
                    <a:gd name="connsiteY107" fmla="*/ 200297 h 1859149"/>
                    <a:gd name="connsiteX108" fmla="*/ 157497 w 1289611"/>
                    <a:gd name="connsiteY108" fmla="*/ 174171 h 1859149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  <a:cxn ang="0">
                      <a:pos x="connsiteX40" y="connsiteY40"/>
                    </a:cxn>
                    <a:cxn ang="0">
                      <a:pos x="connsiteX41" y="connsiteY41"/>
                    </a:cxn>
                    <a:cxn ang="0">
                      <a:pos x="connsiteX42" y="connsiteY42"/>
                    </a:cxn>
                    <a:cxn ang="0">
                      <a:pos x="connsiteX43" y="connsiteY43"/>
                    </a:cxn>
                    <a:cxn ang="0">
                      <a:pos x="connsiteX44" y="connsiteY44"/>
                    </a:cxn>
                    <a:cxn ang="0">
                      <a:pos x="connsiteX45" y="connsiteY45"/>
                    </a:cxn>
                    <a:cxn ang="0">
                      <a:pos x="connsiteX46" y="connsiteY46"/>
                    </a:cxn>
                    <a:cxn ang="0">
                      <a:pos x="connsiteX47" y="connsiteY47"/>
                    </a:cxn>
                    <a:cxn ang="0">
                      <a:pos x="connsiteX48" y="connsiteY48"/>
                    </a:cxn>
                    <a:cxn ang="0">
                      <a:pos x="connsiteX49" y="connsiteY49"/>
                    </a:cxn>
                    <a:cxn ang="0">
                      <a:pos x="connsiteX50" y="connsiteY50"/>
                    </a:cxn>
                    <a:cxn ang="0">
                      <a:pos x="connsiteX51" y="connsiteY51"/>
                    </a:cxn>
                    <a:cxn ang="0">
                      <a:pos x="connsiteX52" y="connsiteY52"/>
                    </a:cxn>
                    <a:cxn ang="0">
                      <a:pos x="connsiteX53" y="connsiteY53"/>
                    </a:cxn>
                    <a:cxn ang="0">
                      <a:pos x="connsiteX54" y="connsiteY54"/>
                    </a:cxn>
                    <a:cxn ang="0">
                      <a:pos x="connsiteX55" y="connsiteY55"/>
                    </a:cxn>
                    <a:cxn ang="0">
                      <a:pos x="connsiteX56" y="connsiteY56"/>
                    </a:cxn>
                    <a:cxn ang="0">
                      <a:pos x="connsiteX57" y="connsiteY57"/>
                    </a:cxn>
                    <a:cxn ang="0">
                      <a:pos x="connsiteX58" y="connsiteY58"/>
                    </a:cxn>
                    <a:cxn ang="0">
                      <a:pos x="connsiteX59" y="connsiteY59"/>
                    </a:cxn>
                    <a:cxn ang="0">
                      <a:pos x="connsiteX60" y="connsiteY60"/>
                    </a:cxn>
                    <a:cxn ang="0">
                      <a:pos x="connsiteX61" y="connsiteY61"/>
                    </a:cxn>
                    <a:cxn ang="0">
                      <a:pos x="connsiteX62" y="connsiteY62"/>
                    </a:cxn>
                    <a:cxn ang="0">
                      <a:pos x="connsiteX63" y="connsiteY63"/>
                    </a:cxn>
                    <a:cxn ang="0">
                      <a:pos x="connsiteX64" y="connsiteY64"/>
                    </a:cxn>
                    <a:cxn ang="0">
                      <a:pos x="connsiteX65" y="connsiteY65"/>
                    </a:cxn>
                    <a:cxn ang="0">
                      <a:pos x="connsiteX66" y="connsiteY66"/>
                    </a:cxn>
                    <a:cxn ang="0">
                      <a:pos x="connsiteX67" y="connsiteY67"/>
                    </a:cxn>
                    <a:cxn ang="0">
                      <a:pos x="connsiteX68" y="connsiteY68"/>
                    </a:cxn>
                    <a:cxn ang="0">
                      <a:pos x="connsiteX69" y="connsiteY69"/>
                    </a:cxn>
                    <a:cxn ang="0">
                      <a:pos x="connsiteX70" y="connsiteY70"/>
                    </a:cxn>
                    <a:cxn ang="0">
                      <a:pos x="connsiteX71" y="connsiteY71"/>
                    </a:cxn>
                    <a:cxn ang="0">
                      <a:pos x="connsiteX72" y="connsiteY72"/>
                    </a:cxn>
                    <a:cxn ang="0">
                      <a:pos x="connsiteX73" y="connsiteY73"/>
                    </a:cxn>
                    <a:cxn ang="0">
                      <a:pos x="connsiteX74" y="connsiteY74"/>
                    </a:cxn>
                    <a:cxn ang="0">
                      <a:pos x="connsiteX75" y="connsiteY75"/>
                    </a:cxn>
                    <a:cxn ang="0">
                      <a:pos x="connsiteX76" y="connsiteY76"/>
                    </a:cxn>
                    <a:cxn ang="0">
                      <a:pos x="connsiteX77" y="connsiteY77"/>
                    </a:cxn>
                    <a:cxn ang="0">
                      <a:pos x="connsiteX78" y="connsiteY78"/>
                    </a:cxn>
                    <a:cxn ang="0">
                      <a:pos x="connsiteX79" y="connsiteY79"/>
                    </a:cxn>
                    <a:cxn ang="0">
                      <a:pos x="connsiteX80" y="connsiteY80"/>
                    </a:cxn>
                    <a:cxn ang="0">
                      <a:pos x="connsiteX81" y="connsiteY81"/>
                    </a:cxn>
                    <a:cxn ang="0">
                      <a:pos x="connsiteX82" y="connsiteY82"/>
                    </a:cxn>
                    <a:cxn ang="0">
                      <a:pos x="connsiteX83" y="connsiteY83"/>
                    </a:cxn>
                    <a:cxn ang="0">
                      <a:pos x="connsiteX84" y="connsiteY84"/>
                    </a:cxn>
                    <a:cxn ang="0">
                      <a:pos x="connsiteX85" y="connsiteY85"/>
                    </a:cxn>
                    <a:cxn ang="0">
                      <a:pos x="connsiteX86" y="connsiteY86"/>
                    </a:cxn>
                    <a:cxn ang="0">
                      <a:pos x="connsiteX87" y="connsiteY87"/>
                    </a:cxn>
                    <a:cxn ang="0">
                      <a:pos x="connsiteX88" y="connsiteY88"/>
                    </a:cxn>
                    <a:cxn ang="0">
                      <a:pos x="connsiteX89" y="connsiteY89"/>
                    </a:cxn>
                    <a:cxn ang="0">
                      <a:pos x="connsiteX90" y="connsiteY90"/>
                    </a:cxn>
                    <a:cxn ang="0">
                      <a:pos x="connsiteX91" y="connsiteY91"/>
                    </a:cxn>
                    <a:cxn ang="0">
                      <a:pos x="connsiteX92" y="connsiteY92"/>
                    </a:cxn>
                    <a:cxn ang="0">
                      <a:pos x="connsiteX93" y="connsiteY93"/>
                    </a:cxn>
                    <a:cxn ang="0">
                      <a:pos x="connsiteX94" y="connsiteY94"/>
                    </a:cxn>
                    <a:cxn ang="0">
                      <a:pos x="connsiteX95" y="connsiteY95"/>
                    </a:cxn>
                    <a:cxn ang="0">
                      <a:pos x="connsiteX96" y="connsiteY96"/>
                    </a:cxn>
                    <a:cxn ang="0">
                      <a:pos x="connsiteX97" y="connsiteY97"/>
                    </a:cxn>
                    <a:cxn ang="0">
                      <a:pos x="connsiteX98" y="connsiteY98"/>
                    </a:cxn>
                    <a:cxn ang="0">
                      <a:pos x="connsiteX99" y="connsiteY99"/>
                    </a:cxn>
                    <a:cxn ang="0">
                      <a:pos x="connsiteX100" y="connsiteY100"/>
                    </a:cxn>
                    <a:cxn ang="0">
                      <a:pos x="connsiteX101" y="connsiteY101"/>
                    </a:cxn>
                    <a:cxn ang="0">
                      <a:pos x="connsiteX102" y="connsiteY102"/>
                    </a:cxn>
                    <a:cxn ang="0">
                      <a:pos x="connsiteX103" y="connsiteY103"/>
                    </a:cxn>
                    <a:cxn ang="0">
                      <a:pos x="connsiteX104" y="connsiteY104"/>
                    </a:cxn>
                    <a:cxn ang="0">
                      <a:pos x="connsiteX105" y="connsiteY105"/>
                    </a:cxn>
                    <a:cxn ang="0">
                      <a:pos x="connsiteX106" y="connsiteY106"/>
                    </a:cxn>
                    <a:cxn ang="0">
                      <a:pos x="connsiteX107" y="connsiteY107"/>
                    </a:cxn>
                    <a:cxn ang="0">
                      <a:pos x="connsiteX108" y="connsiteY108"/>
                    </a:cxn>
                  </a:cxnLst>
                  <a:rect l="l" t="t" r="r" b="b"/>
                  <a:pathLst>
                    <a:path w="1289611" h="1859149">
                      <a:moveTo>
                        <a:pt x="157497" y="174171"/>
                      </a:moveTo>
                      <a:cubicBezTo>
                        <a:pt x="142983" y="166914"/>
                        <a:pt x="109336" y="133099"/>
                        <a:pt x="44285" y="156754"/>
                      </a:cubicBezTo>
                      <a:cubicBezTo>
                        <a:pt x="32711" y="160963"/>
                        <a:pt x="26868" y="174171"/>
                        <a:pt x="18160" y="182880"/>
                      </a:cubicBezTo>
                      <a:cubicBezTo>
                        <a:pt x="-14822" y="281823"/>
                        <a:pt x="4588" y="213403"/>
                        <a:pt x="18160" y="444137"/>
                      </a:cubicBezTo>
                      <a:cubicBezTo>
                        <a:pt x="19365" y="464628"/>
                        <a:pt x="24826" y="484673"/>
                        <a:pt x="26868" y="505097"/>
                      </a:cubicBezTo>
                      <a:cubicBezTo>
                        <a:pt x="30634" y="542758"/>
                        <a:pt x="31811" y="580648"/>
                        <a:pt x="35577" y="618309"/>
                      </a:cubicBezTo>
                      <a:cubicBezTo>
                        <a:pt x="37619" y="638733"/>
                        <a:pt x="41739" y="658901"/>
                        <a:pt x="44285" y="679269"/>
                      </a:cubicBezTo>
                      <a:cubicBezTo>
                        <a:pt x="47545" y="705352"/>
                        <a:pt x="50091" y="731520"/>
                        <a:pt x="52994" y="757646"/>
                      </a:cubicBezTo>
                      <a:cubicBezTo>
                        <a:pt x="50091" y="809897"/>
                        <a:pt x="48631" y="862249"/>
                        <a:pt x="44285" y="914400"/>
                      </a:cubicBezTo>
                      <a:cubicBezTo>
                        <a:pt x="42819" y="931996"/>
                        <a:pt x="37334" y="949081"/>
                        <a:pt x="35577" y="966651"/>
                      </a:cubicBezTo>
                      <a:cubicBezTo>
                        <a:pt x="28170" y="1040721"/>
                        <a:pt x="23407" y="1165779"/>
                        <a:pt x="18160" y="1236617"/>
                      </a:cubicBezTo>
                      <a:cubicBezTo>
                        <a:pt x="16005" y="1265711"/>
                        <a:pt x="12354" y="1294674"/>
                        <a:pt x="9451" y="1323703"/>
                      </a:cubicBezTo>
                      <a:cubicBezTo>
                        <a:pt x="12354" y="1396274"/>
                        <a:pt x="13163" y="1468960"/>
                        <a:pt x="18160" y="1541417"/>
                      </a:cubicBezTo>
                      <a:cubicBezTo>
                        <a:pt x="18983" y="1553357"/>
                        <a:pt x="24272" y="1564567"/>
                        <a:pt x="26868" y="1576251"/>
                      </a:cubicBezTo>
                      <a:cubicBezTo>
                        <a:pt x="30079" y="1590700"/>
                        <a:pt x="31682" y="1605514"/>
                        <a:pt x="35577" y="1619794"/>
                      </a:cubicBezTo>
                      <a:cubicBezTo>
                        <a:pt x="35589" y="1619837"/>
                        <a:pt x="57342" y="1685087"/>
                        <a:pt x="61703" y="1698171"/>
                      </a:cubicBezTo>
                      <a:cubicBezTo>
                        <a:pt x="72654" y="1731024"/>
                        <a:pt x="75298" y="1746604"/>
                        <a:pt x="105245" y="1776549"/>
                      </a:cubicBezTo>
                      <a:cubicBezTo>
                        <a:pt x="111051" y="1782355"/>
                        <a:pt x="115319" y="1790294"/>
                        <a:pt x="122663" y="1793966"/>
                      </a:cubicBezTo>
                      <a:cubicBezTo>
                        <a:pt x="139084" y="1802176"/>
                        <a:pt x="157497" y="1805577"/>
                        <a:pt x="174914" y="1811383"/>
                      </a:cubicBezTo>
                      <a:lnTo>
                        <a:pt x="201040" y="1820091"/>
                      </a:lnTo>
                      <a:cubicBezTo>
                        <a:pt x="265824" y="1841686"/>
                        <a:pt x="217981" y="1828144"/>
                        <a:pt x="349085" y="1837509"/>
                      </a:cubicBezTo>
                      <a:cubicBezTo>
                        <a:pt x="586588" y="1877090"/>
                        <a:pt x="424407" y="1853272"/>
                        <a:pt x="976103" y="1837509"/>
                      </a:cubicBezTo>
                      <a:cubicBezTo>
                        <a:pt x="988067" y="1837167"/>
                        <a:pt x="999201" y="1831147"/>
                        <a:pt x="1010937" y="1828800"/>
                      </a:cubicBezTo>
                      <a:cubicBezTo>
                        <a:pt x="1028251" y="1825337"/>
                        <a:pt x="1045951" y="1823921"/>
                        <a:pt x="1063188" y="1820091"/>
                      </a:cubicBezTo>
                      <a:cubicBezTo>
                        <a:pt x="1072149" y="1818100"/>
                        <a:pt x="1080488" y="1813905"/>
                        <a:pt x="1089314" y="1811383"/>
                      </a:cubicBezTo>
                      <a:cubicBezTo>
                        <a:pt x="1165859" y="1789513"/>
                        <a:pt x="1087633" y="1814845"/>
                        <a:pt x="1150274" y="1793966"/>
                      </a:cubicBezTo>
                      <a:cubicBezTo>
                        <a:pt x="1158983" y="1788160"/>
                        <a:pt x="1167039" y="1781230"/>
                        <a:pt x="1176400" y="1776549"/>
                      </a:cubicBezTo>
                      <a:cubicBezTo>
                        <a:pt x="1184610" y="1772444"/>
                        <a:pt x="1196034" y="1774331"/>
                        <a:pt x="1202525" y="1767840"/>
                      </a:cubicBezTo>
                      <a:cubicBezTo>
                        <a:pt x="1217327" y="1753038"/>
                        <a:pt x="1222559" y="1730391"/>
                        <a:pt x="1237360" y="1715589"/>
                      </a:cubicBezTo>
                      <a:lnTo>
                        <a:pt x="1254777" y="1698171"/>
                      </a:lnTo>
                      <a:cubicBezTo>
                        <a:pt x="1279595" y="1623717"/>
                        <a:pt x="1269917" y="1664137"/>
                        <a:pt x="1280903" y="1576251"/>
                      </a:cubicBezTo>
                      <a:cubicBezTo>
                        <a:pt x="1283806" y="1500777"/>
                        <a:pt x="1289611" y="1425359"/>
                        <a:pt x="1289611" y="1349829"/>
                      </a:cubicBezTo>
                      <a:cubicBezTo>
                        <a:pt x="1289611" y="1216266"/>
                        <a:pt x="1284371" y="1082752"/>
                        <a:pt x="1280903" y="949234"/>
                      </a:cubicBezTo>
                      <a:cubicBezTo>
                        <a:pt x="1274097" y="687216"/>
                        <a:pt x="1276051" y="740980"/>
                        <a:pt x="1263485" y="539931"/>
                      </a:cubicBezTo>
                      <a:cubicBezTo>
                        <a:pt x="1259188" y="376634"/>
                        <a:pt x="1267398" y="277986"/>
                        <a:pt x="1246068" y="139337"/>
                      </a:cubicBezTo>
                      <a:cubicBezTo>
                        <a:pt x="1239034" y="93614"/>
                        <a:pt x="1235499" y="90211"/>
                        <a:pt x="1219943" y="43543"/>
                      </a:cubicBezTo>
                      <a:cubicBezTo>
                        <a:pt x="1217040" y="34834"/>
                        <a:pt x="1219943" y="20320"/>
                        <a:pt x="1211234" y="17417"/>
                      </a:cubicBezTo>
                      <a:lnTo>
                        <a:pt x="1158983" y="0"/>
                      </a:lnTo>
                      <a:cubicBezTo>
                        <a:pt x="1153177" y="8709"/>
                        <a:pt x="1146246" y="16764"/>
                        <a:pt x="1141565" y="26126"/>
                      </a:cubicBezTo>
                      <a:cubicBezTo>
                        <a:pt x="1134607" y="40042"/>
                        <a:pt x="1127866" y="74071"/>
                        <a:pt x="1124148" y="87086"/>
                      </a:cubicBezTo>
                      <a:cubicBezTo>
                        <a:pt x="1121626" y="95912"/>
                        <a:pt x="1118343" y="104503"/>
                        <a:pt x="1115440" y="113211"/>
                      </a:cubicBezTo>
                      <a:cubicBezTo>
                        <a:pt x="1118343" y="139337"/>
                        <a:pt x="1120674" y="165533"/>
                        <a:pt x="1124148" y="191589"/>
                      </a:cubicBezTo>
                      <a:cubicBezTo>
                        <a:pt x="1126482" y="209091"/>
                        <a:pt x="1130523" y="226338"/>
                        <a:pt x="1132857" y="243840"/>
                      </a:cubicBezTo>
                      <a:cubicBezTo>
                        <a:pt x="1136331" y="269896"/>
                        <a:pt x="1138662" y="296091"/>
                        <a:pt x="1141565" y="322217"/>
                      </a:cubicBezTo>
                      <a:cubicBezTo>
                        <a:pt x="1138662" y="362857"/>
                        <a:pt x="1149931" y="407143"/>
                        <a:pt x="1132857" y="444137"/>
                      </a:cubicBezTo>
                      <a:cubicBezTo>
                        <a:pt x="1126654" y="457576"/>
                        <a:pt x="1101630" y="443639"/>
                        <a:pt x="1089314" y="435429"/>
                      </a:cubicBezTo>
                      <a:cubicBezTo>
                        <a:pt x="1081676" y="430337"/>
                        <a:pt x="1084221" y="417741"/>
                        <a:pt x="1080605" y="409303"/>
                      </a:cubicBezTo>
                      <a:cubicBezTo>
                        <a:pt x="1075491" y="397371"/>
                        <a:pt x="1068009" y="386522"/>
                        <a:pt x="1063188" y="374469"/>
                      </a:cubicBezTo>
                      <a:cubicBezTo>
                        <a:pt x="1056370" y="357423"/>
                        <a:pt x="1045771" y="322217"/>
                        <a:pt x="1045771" y="322217"/>
                      </a:cubicBezTo>
                      <a:cubicBezTo>
                        <a:pt x="1042868" y="298994"/>
                        <a:pt x="1039513" y="275824"/>
                        <a:pt x="1037063" y="252549"/>
                      </a:cubicBezTo>
                      <a:cubicBezTo>
                        <a:pt x="1033706" y="220662"/>
                        <a:pt x="1032889" y="188495"/>
                        <a:pt x="1028354" y="156754"/>
                      </a:cubicBezTo>
                      <a:cubicBezTo>
                        <a:pt x="1027056" y="147667"/>
                        <a:pt x="1027115" y="135964"/>
                        <a:pt x="1019645" y="130629"/>
                      </a:cubicBezTo>
                      <a:cubicBezTo>
                        <a:pt x="1004705" y="119958"/>
                        <a:pt x="967394" y="113211"/>
                        <a:pt x="967394" y="113211"/>
                      </a:cubicBezTo>
                      <a:lnTo>
                        <a:pt x="949977" y="165463"/>
                      </a:lnTo>
                      <a:lnTo>
                        <a:pt x="941268" y="191589"/>
                      </a:lnTo>
                      <a:cubicBezTo>
                        <a:pt x="944171" y="232229"/>
                        <a:pt x="945216" y="273045"/>
                        <a:pt x="949977" y="313509"/>
                      </a:cubicBezTo>
                      <a:cubicBezTo>
                        <a:pt x="951050" y="322625"/>
                        <a:pt x="956163" y="330808"/>
                        <a:pt x="958685" y="339634"/>
                      </a:cubicBezTo>
                      <a:cubicBezTo>
                        <a:pt x="961973" y="351143"/>
                        <a:pt x="964491" y="362857"/>
                        <a:pt x="967394" y="374469"/>
                      </a:cubicBezTo>
                      <a:cubicBezTo>
                        <a:pt x="964491" y="403497"/>
                        <a:pt x="970533" y="434895"/>
                        <a:pt x="958685" y="461554"/>
                      </a:cubicBezTo>
                      <a:cubicBezTo>
                        <a:pt x="954957" y="469942"/>
                        <a:pt x="939728" y="458580"/>
                        <a:pt x="932560" y="452846"/>
                      </a:cubicBezTo>
                      <a:cubicBezTo>
                        <a:pt x="924387" y="446308"/>
                        <a:pt x="920949" y="435429"/>
                        <a:pt x="915143" y="426720"/>
                      </a:cubicBezTo>
                      <a:cubicBezTo>
                        <a:pt x="912240" y="412206"/>
                        <a:pt x="909762" y="397600"/>
                        <a:pt x="906434" y="383177"/>
                      </a:cubicBezTo>
                      <a:cubicBezTo>
                        <a:pt x="901051" y="359853"/>
                        <a:pt x="889017" y="313509"/>
                        <a:pt x="889017" y="313509"/>
                      </a:cubicBezTo>
                      <a:cubicBezTo>
                        <a:pt x="881410" y="245051"/>
                        <a:pt x="883922" y="247038"/>
                        <a:pt x="871600" y="191589"/>
                      </a:cubicBezTo>
                      <a:cubicBezTo>
                        <a:pt x="869004" y="179905"/>
                        <a:pt x="870773" y="165762"/>
                        <a:pt x="862891" y="156754"/>
                      </a:cubicBezTo>
                      <a:cubicBezTo>
                        <a:pt x="849107" y="141001"/>
                        <a:pt x="828057" y="133531"/>
                        <a:pt x="810640" y="121920"/>
                      </a:cubicBezTo>
                      <a:lnTo>
                        <a:pt x="784514" y="104503"/>
                      </a:lnTo>
                      <a:cubicBezTo>
                        <a:pt x="778708" y="121920"/>
                        <a:pt x="765952" y="138431"/>
                        <a:pt x="767097" y="156754"/>
                      </a:cubicBezTo>
                      <a:cubicBezTo>
                        <a:pt x="776552" y="308037"/>
                        <a:pt x="764518" y="250944"/>
                        <a:pt x="784514" y="330926"/>
                      </a:cubicBezTo>
                      <a:cubicBezTo>
                        <a:pt x="782728" y="352362"/>
                        <a:pt x="802556" y="444034"/>
                        <a:pt x="749680" y="452846"/>
                      </a:cubicBezTo>
                      <a:cubicBezTo>
                        <a:pt x="740625" y="454355"/>
                        <a:pt x="732263" y="447040"/>
                        <a:pt x="723554" y="444137"/>
                      </a:cubicBezTo>
                      <a:lnTo>
                        <a:pt x="697428" y="365760"/>
                      </a:lnTo>
                      <a:lnTo>
                        <a:pt x="688720" y="339634"/>
                      </a:lnTo>
                      <a:cubicBezTo>
                        <a:pt x="691878" y="289110"/>
                        <a:pt x="706843" y="163403"/>
                        <a:pt x="688720" y="104503"/>
                      </a:cubicBezTo>
                      <a:cubicBezTo>
                        <a:pt x="685642" y="94499"/>
                        <a:pt x="671303" y="92892"/>
                        <a:pt x="662594" y="87086"/>
                      </a:cubicBezTo>
                      <a:cubicBezTo>
                        <a:pt x="632114" y="107406"/>
                        <a:pt x="616148" y="113211"/>
                        <a:pt x="601634" y="156754"/>
                      </a:cubicBezTo>
                      <a:lnTo>
                        <a:pt x="584217" y="209006"/>
                      </a:lnTo>
                      <a:cubicBezTo>
                        <a:pt x="587120" y="261257"/>
                        <a:pt x="592925" y="313428"/>
                        <a:pt x="592925" y="365760"/>
                      </a:cubicBezTo>
                      <a:cubicBezTo>
                        <a:pt x="592925" y="394933"/>
                        <a:pt x="601721" y="429507"/>
                        <a:pt x="584217" y="452846"/>
                      </a:cubicBezTo>
                      <a:cubicBezTo>
                        <a:pt x="573201" y="467534"/>
                        <a:pt x="572606" y="418011"/>
                        <a:pt x="566800" y="400594"/>
                      </a:cubicBezTo>
                      <a:lnTo>
                        <a:pt x="549383" y="348343"/>
                      </a:lnTo>
                      <a:cubicBezTo>
                        <a:pt x="546480" y="339634"/>
                        <a:pt x="545766" y="329855"/>
                        <a:pt x="540674" y="322217"/>
                      </a:cubicBezTo>
                      <a:lnTo>
                        <a:pt x="505840" y="269966"/>
                      </a:lnTo>
                      <a:cubicBezTo>
                        <a:pt x="506802" y="250719"/>
                        <a:pt x="524950" y="61262"/>
                        <a:pt x="505840" y="8709"/>
                      </a:cubicBezTo>
                      <a:cubicBezTo>
                        <a:pt x="502703" y="82"/>
                        <a:pt x="488423" y="2903"/>
                        <a:pt x="479714" y="0"/>
                      </a:cubicBezTo>
                      <a:cubicBezTo>
                        <a:pt x="471005" y="2903"/>
                        <a:pt x="460079" y="2218"/>
                        <a:pt x="453588" y="8709"/>
                      </a:cubicBezTo>
                      <a:cubicBezTo>
                        <a:pt x="447097" y="15200"/>
                        <a:pt x="448985" y="26624"/>
                        <a:pt x="444880" y="34834"/>
                      </a:cubicBezTo>
                      <a:cubicBezTo>
                        <a:pt x="433893" y="56808"/>
                        <a:pt x="426247" y="62176"/>
                        <a:pt x="410045" y="78377"/>
                      </a:cubicBezTo>
                      <a:cubicBezTo>
                        <a:pt x="387276" y="146690"/>
                        <a:pt x="397449" y="105287"/>
                        <a:pt x="410045" y="243840"/>
                      </a:cubicBezTo>
                      <a:cubicBezTo>
                        <a:pt x="411644" y="261425"/>
                        <a:pt x="416420" y="278589"/>
                        <a:pt x="418754" y="296091"/>
                      </a:cubicBezTo>
                      <a:cubicBezTo>
                        <a:pt x="422228" y="322147"/>
                        <a:pt x="424560" y="348343"/>
                        <a:pt x="427463" y="374469"/>
                      </a:cubicBezTo>
                      <a:cubicBezTo>
                        <a:pt x="424560" y="403497"/>
                        <a:pt x="436665" y="438526"/>
                        <a:pt x="418754" y="461554"/>
                      </a:cubicBezTo>
                      <a:cubicBezTo>
                        <a:pt x="388804" y="500061"/>
                        <a:pt x="356959" y="438530"/>
                        <a:pt x="349085" y="426720"/>
                      </a:cubicBezTo>
                      <a:cubicBezTo>
                        <a:pt x="343279" y="409303"/>
                        <a:pt x="332432" y="392812"/>
                        <a:pt x="331668" y="374469"/>
                      </a:cubicBezTo>
                      <a:cubicBezTo>
                        <a:pt x="328765" y="304800"/>
                        <a:pt x="328111" y="235002"/>
                        <a:pt x="322960" y="165463"/>
                      </a:cubicBezTo>
                      <a:cubicBezTo>
                        <a:pt x="322282" y="156308"/>
                        <a:pt x="318356" y="147548"/>
                        <a:pt x="314251" y="139337"/>
                      </a:cubicBezTo>
                      <a:cubicBezTo>
                        <a:pt x="309570" y="129976"/>
                        <a:pt x="304235" y="120612"/>
                        <a:pt x="296834" y="113211"/>
                      </a:cubicBezTo>
                      <a:cubicBezTo>
                        <a:pt x="289433" y="105810"/>
                        <a:pt x="279417" y="101600"/>
                        <a:pt x="270708" y="95794"/>
                      </a:cubicBezTo>
                      <a:cubicBezTo>
                        <a:pt x="259097" y="98697"/>
                        <a:pt x="245832" y="97864"/>
                        <a:pt x="235874" y="104503"/>
                      </a:cubicBezTo>
                      <a:cubicBezTo>
                        <a:pt x="221405" y="114149"/>
                        <a:pt x="214716" y="141852"/>
                        <a:pt x="209748" y="156754"/>
                      </a:cubicBezTo>
                      <a:cubicBezTo>
                        <a:pt x="212651" y="197394"/>
                        <a:pt x="213958" y="238180"/>
                        <a:pt x="218457" y="278674"/>
                      </a:cubicBezTo>
                      <a:cubicBezTo>
                        <a:pt x="219779" y="290570"/>
                        <a:pt x="224569" y="301825"/>
                        <a:pt x="227165" y="313509"/>
                      </a:cubicBezTo>
                      <a:cubicBezTo>
                        <a:pt x="230376" y="327958"/>
                        <a:pt x="232971" y="342537"/>
                        <a:pt x="235874" y="357051"/>
                      </a:cubicBezTo>
                      <a:cubicBezTo>
                        <a:pt x="233357" y="392280"/>
                        <a:pt x="264275" y="487680"/>
                        <a:pt x="201040" y="487680"/>
                      </a:cubicBezTo>
                      <a:cubicBezTo>
                        <a:pt x="191860" y="487680"/>
                        <a:pt x="183623" y="481874"/>
                        <a:pt x="174914" y="478971"/>
                      </a:cubicBezTo>
                      <a:cubicBezTo>
                        <a:pt x="169108" y="470263"/>
                        <a:pt x="161748" y="462410"/>
                        <a:pt x="157497" y="452846"/>
                      </a:cubicBezTo>
                      <a:cubicBezTo>
                        <a:pt x="150041" y="436069"/>
                        <a:pt x="140080" y="400594"/>
                        <a:pt x="140080" y="400594"/>
                      </a:cubicBezTo>
                      <a:cubicBezTo>
                        <a:pt x="137177" y="333828"/>
                        <a:pt x="139031" y="266685"/>
                        <a:pt x="131371" y="200297"/>
                      </a:cubicBezTo>
                      <a:cubicBezTo>
                        <a:pt x="130171" y="189900"/>
                        <a:pt x="172011" y="181428"/>
                        <a:pt x="157497" y="174171"/>
                      </a:cubicBezTo>
                      <a:close/>
                    </a:path>
                  </a:pathLst>
                </a:custGeom>
                <a:solidFill>
                  <a:srgbClr val="B3C7E7"/>
                </a:solidFill>
                <a:ln>
                  <a:solidFill>
                    <a:srgbClr val="2F5597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31" name="Freeform 30">
                  <a:extLst>
                    <a:ext uri="{FF2B5EF4-FFF2-40B4-BE49-F238E27FC236}">
                      <a16:creationId xmlns:a16="http://schemas.microsoft.com/office/drawing/2014/main" id="{15C168E5-9B1E-164D-BF42-B958BA6F6413}"/>
                    </a:ext>
                  </a:extLst>
                </p:cNvPr>
                <p:cNvSpPr/>
                <p:nvPr/>
              </p:nvSpPr>
              <p:spPr>
                <a:xfrm>
                  <a:off x="5985707" y="2612854"/>
                  <a:ext cx="248048" cy="392533"/>
                </a:xfrm>
                <a:custGeom>
                  <a:avLst/>
                  <a:gdLst>
                    <a:gd name="connsiteX0" fmla="*/ 157497 w 1289611"/>
                    <a:gd name="connsiteY0" fmla="*/ 174171 h 1859149"/>
                    <a:gd name="connsiteX1" fmla="*/ 44285 w 1289611"/>
                    <a:gd name="connsiteY1" fmla="*/ 156754 h 1859149"/>
                    <a:gd name="connsiteX2" fmla="*/ 18160 w 1289611"/>
                    <a:gd name="connsiteY2" fmla="*/ 182880 h 1859149"/>
                    <a:gd name="connsiteX3" fmla="*/ 18160 w 1289611"/>
                    <a:gd name="connsiteY3" fmla="*/ 444137 h 1859149"/>
                    <a:gd name="connsiteX4" fmla="*/ 26868 w 1289611"/>
                    <a:gd name="connsiteY4" fmla="*/ 505097 h 1859149"/>
                    <a:gd name="connsiteX5" fmla="*/ 35577 w 1289611"/>
                    <a:gd name="connsiteY5" fmla="*/ 618309 h 1859149"/>
                    <a:gd name="connsiteX6" fmla="*/ 44285 w 1289611"/>
                    <a:gd name="connsiteY6" fmla="*/ 679269 h 1859149"/>
                    <a:gd name="connsiteX7" fmla="*/ 52994 w 1289611"/>
                    <a:gd name="connsiteY7" fmla="*/ 757646 h 1859149"/>
                    <a:gd name="connsiteX8" fmla="*/ 44285 w 1289611"/>
                    <a:gd name="connsiteY8" fmla="*/ 914400 h 1859149"/>
                    <a:gd name="connsiteX9" fmla="*/ 35577 w 1289611"/>
                    <a:gd name="connsiteY9" fmla="*/ 966651 h 1859149"/>
                    <a:gd name="connsiteX10" fmla="*/ 18160 w 1289611"/>
                    <a:gd name="connsiteY10" fmla="*/ 1236617 h 1859149"/>
                    <a:gd name="connsiteX11" fmla="*/ 9451 w 1289611"/>
                    <a:gd name="connsiteY11" fmla="*/ 1323703 h 1859149"/>
                    <a:gd name="connsiteX12" fmla="*/ 18160 w 1289611"/>
                    <a:gd name="connsiteY12" fmla="*/ 1541417 h 1859149"/>
                    <a:gd name="connsiteX13" fmla="*/ 26868 w 1289611"/>
                    <a:gd name="connsiteY13" fmla="*/ 1576251 h 1859149"/>
                    <a:gd name="connsiteX14" fmla="*/ 35577 w 1289611"/>
                    <a:gd name="connsiteY14" fmla="*/ 1619794 h 1859149"/>
                    <a:gd name="connsiteX15" fmla="*/ 61703 w 1289611"/>
                    <a:gd name="connsiteY15" fmla="*/ 1698171 h 1859149"/>
                    <a:gd name="connsiteX16" fmla="*/ 105245 w 1289611"/>
                    <a:gd name="connsiteY16" fmla="*/ 1776549 h 1859149"/>
                    <a:gd name="connsiteX17" fmla="*/ 122663 w 1289611"/>
                    <a:gd name="connsiteY17" fmla="*/ 1793966 h 1859149"/>
                    <a:gd name="connsiteX18" fmla="*/ 174914 w 1289611"/>
                    <a:gd name="connsiteY18" fmla="*/ 1811383 h 1859149"/>
                    <a:gd name="connsiteX19" fmla="*/ 201040 w 1289611"/>
                    <a:gd name="connsiteY19" fmla="*/ 1820091 h 1859149"/>
                    <a:gd name="connsiteX20" fmla="*/ 349085 w 1289611"/>
                    <a:gd name="connsiteY20" fmla="*/ 1837509 h 1859149"/>
                    <a:gd name="connsiteX21" fmla="*/ 976103 w 1289611"/>
                    <a:gd name="connsiteY21" fmla="*/ 1837509 h 1859149"/>
                    <a:gd name="connsiteX22" fmla="*/ 1010937 w 1289611"/>
                    <a:gd name="connsiteY22" fmla="*/ 1828800 h 1859149"/>
                    <a:gd name="connsiteX23" fmla="*/ 1063188 w 1289611"/>
                    <a:gd name="connsiteY23" fmla="*/ 1820091 h 1859149"/>
                    <a:gd name="connsiteX24" fmla="*/ 1089314 w 1289611"/>
                    <a:gd name="connsiteY24" fmla="*/ 1811383 h 1859149"/>
                    <a:gd name="connsiteX25" fmla="*/ 1150274 w 1289611"/>
                    <a:gd name="connsiteY25" fmla="*/ 1793966 h 1859149"/>
                    <a:gd name="connsiteX26" fmla="*/ 1176400 w 1289611"/>
                    <a:gd name="connsiteY26" fmla="*/ 1776549 h 1859149"/>
                    <a:gd name="connsiteX27" fmla="*/ 1202525 w 1289611"/>
                    <a:gd name="connsiteY27" fmla="*/ 1767840 h 1859149"/>
                    <a:gd name="connsiteX28" fmla="*/ 1237360 w 1289611"/>
                    <a:gd name="connsiteY28" fmla="*/ 1715589 h 1859149"/>
                    <a:gd name="connsiteX29" fmla="*/ 1254777 w 1289611"/>
                    <a:gd name="connsiteY29" fmla="*/ 1698171 h 1859149"/>
                    <a:gd name="connsiteX30" fmla="*/ 1280903 w 1289611"/>
                    <a:gd name="connsiteY30" fmla="*/ 1576251 h 1859149"/>
                    <a:gd name="connsiteX31" fmla="*/ 1289611 w 1289611"/>
                    <a:gd name="connsiteY31" fmla="*/ 1349829 h 1859149"/>
                    <a:gd name="connsiteX32" fmla="*/ 1280903 w 1289611"/>
                    <a:gd name="connsiteY32" fmla="*/ 949234 h 1859149"/>
                    <a:gd name="connsiteX33" fmla="*/ 1263485 w 1289611"/>
                    <a:gd name="connsiteY33" fmla="*/ 539931 h 1859149"/>
                    <a:gd name="connsiteX34" fmla="*/ 1246068 w 1289611"/>
                    <a:gd name="connsiteY34" fmla="*/ 139337 h 1859149"/>
                    <a:gd name="connsiteX35" fmla="*/ 1219943 w 1289611"/>
                    <a:gd name="connsiteY35" fmla="*/ 43543 h 1859149"/>
                    <a:gd name="connsiteX36" fmla="*/ 1211234 w 1289611"/>
                    <a:gd name="connsiteY36" fmla="*/ 17417 h 1859149"/>
                    <a:gd name="connsiteX37" fmla="*/ 1158983 w 1289611"/>
                    <a:gd name="connsiteY37" fmla="*/ 0 h 1859149"/>
                    <a:gd name="connsiteX38" fmla="*/ 1141565 w 1289611"/>
                    <a:gd name="connsiteY38" fmla="*/ 26126 h 1859149"/>
                    <a:gd name="connsiteX39" fmla="*/ 1124148 w 1289611"/>
                    <a:gd name="connsiteY39" fmla="*/ 87086 h 1859149"/>
                    <a:gd name="connsiteX40" fmla="*/ 1115440 w 1289611"/>
                    <a:gd name="connsiteY40" fmla="*/ 113211 h 1859149"/>
                    <a:gd name="connsiteX41" fmla="*/ 1124148 w 1289611"/>
                    <a:gd name="connsiteY41" fmla="*/ 191589 h 1859149"/>
                    <a:gd name="connsiteX42" fmla="*/ 1132857 w 1289611"/>
                    <a:gd name="connsiteY42" fmla="*/ 243840 h 1859149"/>
                    <a:gd name="connsiteX43" fmla="*/ 1141565 w 1289611"/>
                    <a:gd name="connsiteY43" fmla="*/ 322217 h 1859149"/>
                    <a:gd name="connsiteX44" fmla="*/ 1132857 w 1289611"/>
                    <a:gd name="connsiteY44" fmla="*/ 444137 h 1859149"/>
                    <a:gd name="connsiteX45" fmla="*/ 1089314 w 1289611"/>
                    <a:gd name="connsiteY45" fmla="*/ 435429 h 1859149"/>
                    <a:gd name="connsiteX46" fmla="*/ 1080605 w 1289611"/>
                    <a:gd name="connsiteY46" fmla="*/ 409303 h 1859149"/>
                    <a:gd name="connsiteX47" fmla="*/ 1063188 w 1289611"/>
                    <a:gd name="connsiteY47" fmla="*/ 374469 h 1859149"/>
                    <a:gd name="connsiteX48" fmla="*/ 1045771 w 1289611"/>
                    <a:gd name="connsiteY48" fmla="*/ 322217 h 1859149"/>
                    <a:gd name="connsiteX49" fmla="*/ 1037063 w 1289611"/>
                    <a:gd name="connsiteY49" fmla="*/ 252549 h 1859149"/>
                    <a:gd name="connsiteX50" fmla="*/ 1028354 w 1289611"/>
                    <a:gd name="connsiteY50" fmla="*/ 156754 h 1859149"/>
                    <a:gd name="connsiteX51" fmla="*/ 1019645 w 1289611"/>
                    <a:gd name="connsiteY51" fmla="*/ 130629 h 1859149"/>
                    <a:gd name="connsiteX52" fmla="*/ 967394 w 1289611"/>
                    <a:gd name="connsiteY52" fmla="*/ 113211 h 1859149"/>
                    <a:gd name="connsiteX53" fmla="*/ 949977 w 1289611"/>
                    <a:gd name="connsiteY53" fmla="*/ 165463 h 1859149"/>
                    <a:gd name="connsiteX54" fmla="*/ 941268 w 1289611"/>
                    <a:gd name="connsiteY54" fmla="*/ 191589 h 1859149"/>
                    <a:gd name="connsiteX55" fmla="*/ 949977 w 1289611"/>
                    <a:gd name="connsiteY55" fmla="*/ 313509 h 1859149"/>
                    <a:gd name="connsiteX56" fmla="*/ 958685 w 1289611"/>
                    <a:gd name="connsiteY56" fmla="*/ 339634 h 1859149"/>
                    <a:gd name="connsiteX57" fmla="*/ 967394 w 1289611"/>
                    <a:gd name="connsiteY57" fmla="*/ 374469 h 1859149"/>
                    <a:gd name="connsiteX58" fmla="*/ 958685 w 1289611"/>
                    <a:gd name="connsiteY58" fmla="*/ 461554 h 1859149"/>
                    <a:gd name="connsiteX59" fmla="*/ 932560 w 1289611"/>
                    <a:gd name="connsiteY59" fmla="*/ 452846 h 1859149"/>
                    <a:gd name="connsiteX60" fmla="*/ 915143 w 1289611"/>
                    <a:gd name="connsiteY60" fmla="*/ 426720 h 1859149"/>
                    <a:gd name="connsiteX61" fmla="*/ 906434 w 1289611"/>
                    <a:gd name="connsiteY61" fmla="*/ 383177 h 1859149"/>
                    <a:gd name="connsiteX62" fmla="*/ 889017 w 1289611"/>
                    <a:gd name="connsiteY62" fmla="*/ 313509 h 1859149"/>
                    <a:gd name="connsiteX63" fmla="*/ 871600 w 1289611"/>
                    <a:gd name="connsiteY63" fmla="*/ 191589 h 1859149"/>
                    <a:gd name="connsiteX64" fmla="*/ 862891 w 1289611"/>
                    <a:gd name="connsiteY64" fmla="*/ 156754 h 1859149"/>
                    <a:gd name="connsiteX65" fmla="*/ 810640 w 1289611"/>
                    <a:gd name="connsiteY65" fmla="*/ 121920 h 1859149"/>
                    <a:gd name="connsiteX66" fmla="*/ 784514 w 1289611"/>
                    <a:gd name="connsiteY66" fmla="*/ 104503 h 1859149"/>
                    <a:gd name="connsiteX67" fmla="*/ 767097 w 1289611"/>
                    <a:gd name="connsiteY67" fmla="*/ 156754 h 1859149"/>
                    <a:gd name="connsiteX68" fmla="*/ 784514 w 1289611"/>
                    <a:gd name="connsiteY68" fmla="*/ 330926 h 1859149"/>
                    <a:gd name="connsiteX69" fmla="*/ 749680 w 1289611"/>
                    <a:gd name="connsiteY69" fmla="*/ 452846 h 1859149"/>
                    <a:gd name="connsiteX70" fmla="*/ 723554 w 1289611"/>
                    <a:gd name="connsiteY70" fmla="*/ 444137 h 1859149"/>
                    <a:gd name="connsiteX71" fmla="*/ 697428 w 1289611"/>
                    <a:gd name="connsiteY71" fmla="*/ 365760 h 1859149"/>
                    <a:gd name="connsiteX72" fmla="*/ 688720 w 1289611"/>
                    <a:gd name="connsiteY72" fmla="*/ 339634 h 1859149"/>
                    <a:gd name="connsiteX73" fmla="*/ 688720 w 1289611"/>
                    <a:gd name="connsiteY73" fmla="*/ 104503 h 1859149"/>
                    <a:gd name="connsiteX74" fmla="*/ 662594 w 1289611"/>
                    <a:gd name="connsiteY74" fmla="*/ 87086 h 1859149"/>
                    <a:gd name="connsiteX75" fmla="*/ 601634 w 1289611"/>
                    <a:gd name="connsiteY75" fmla="*/ 156754 h 1859149"/>
                    <a:gd name="connsiteX76" fmla="*/ 584217 w 1289611"/>
                    <a:gd name="connsiteY76" fmla="*/ 209006 h 1859149"/>
                    <a:gd name="connsiteX77" fmla="*/ 592925 w 1289611"/>
                    <a:gd name="connsiteY77" fmla="*/ 365760 h 1859149"/>
                    <a:gd name="connsiteX78" fmla="*/ 584217 w 1289611"/>
                    <a:gd name="connsiteY78" fmla="*/ 452846 h 1859149"/>
                    <a:gd name="connsiteX79" fmla="*/ 566800 w 1289611"/>
                    <a:gd name="connsiteY79" fmla="*/ 400594 h 1859149"/>
                    <a:gd name="connsiteX80" fmla="*/ 549383 w 1289611"/>
                    <a:gd name="connsiteY80" fmla="*/ 348343 h 1859149"/>
                    <a:gd name="connsiteX81" fmla="*/ 540674 w 1289611"/>
                    <a:gd name="connsiteY81" fmla="*/ 322217 h 1859149"/>
                    <a:gd name="connsiteX82" fmla="*/ 505840 w 1289611"/>
                    <a:gd name="connsiteY82" fmla="*/ 269966 h 1859149"/>
                    <a:gd name="connsiteX83" fmla="*/ 505840 w 1289611"/>
                    <a:gd name="connsiteY83" fmla="*/ 8709 h 1859149"/>
                    <a:gd name="connsiteX84" fmla="*/ 479714 w 1289611"/>
                    <a:gd name="connsiteY84" fmla="*/ 0 h 1859149"/>
                    <a:gd name="connsiteX85" fmla="*/ 453588 w 1289611"/>
                    <a:gd name="connsiteY85" fmla="*/ 8709 h 1859149"/>
                    <a:gd name="connsiteX86" fmla="*/ 444880 w 1289611"/>
                    <a:gd name="connsiteY86" fmla="*/ 34834 h 1859149"/>
                    <a:gd name="connsiteX87" fmla="*/ 410045 w 1289611"/>
                    <a:gd name="connsiteY87" fmla="*/ 78377 h 1859149"/>
                    <a:gd name="connsiteX88" fmla="*/ 410045 w 1289611"/>
                    <a:gd name="connsiteY88" fmla="*/ 243840 h 1859149"/>
                    <a:gd name="connsiteX89" fmla="*/ 418754 w 1289611"/>
                    <a:gd name="connsiteY89" fmla="*/ 296091 h 1859149"/>
                    <a:gd name="connsiteX90" fmla="*/ 427463 w 1289611"/>
                    <a:gd name="connsiteY90" fmla="*/ 374469 h 1859149"/>
                    <a:gd name="connsiteX91" fmla="*/ 418754 w 1289611"/>
                    <a:gd name="connsiteY91" fmla="*/ 461554 h 1859149"/>
                    <a:gd name="connsiteX92" fmla="*/ 349085 w 1289611"/>
                    <a:gd name="connsiteY92" fmla="*/ 426720 h 1859149"/>
                    <a:gd name="connsiteX93" fmla="*/ 331668 w 1289611"/>
                    <a:gd name="connsiteY93" fmla="*/ 374469 h 1859149"/>
                    <a:gd name="connsiteX94" fmla="*/ 322960 w 1289611"/>
                    <a:gd name="connsiteY94" fmla="*/ 165463 h 1859149"/>
                    <a:gd name="connsiteX95" fmla="*/ 314251 w 1289611"/>
                    <a:gd name="connsiteY95" fmla="*/ 139337 h 1859149"/>
                    <a:gd name="connsiteX96" fmla="*/ 296834 w 1289611"/>
                    <a:gd name="connsiteY96" fmla="*/ 113211 h 1859149"/>
                    <a:gd name="connsiteX97" fmla="*/ 270708 w 1289611"/>
                    <a:gd name="connsiteY97" fmla="*/ 95794 h 1859149"/>
                    <a:gd name="connsiteX98" fmla="*/ 235874 w 1289611"/>
                    <a:gd name="connsiteY98" fmla="*/ 104503 h 1859149"/>
                    <a:gd name="connsiteX99" fmla="*/ 209748 w 1289611"/>
                    <a:gd name="connsiteY99" fmla="*/ 156754 h 1859149"/>
                    <a:gd name="connsiteX100" fmla="*/ 218457 w 1289611"/>
                    <a:gd name="connsiteY100" fmla="*/ 278674 h 1859149"/>
                    <a:gd name="connsiteX101" fmla="*/ 227165 w 1289611"/>
                    <a:gd name="connsiteY101" fmla="*/ 313509 h 1859149"/>
                    <a:gd name="connsiteX102" fmla="*/ 235874 w 1289611"/>
                    <a:gd name="connsiteY102" fmla="*/ 357051 h 1859149"/>
                    <a:gd name="connsiteX103" fmla="*/ 201040 w 1289611"/>
                    <a:gd name="connsiteY103" fmla="*/ 487680 h 1859149"/>
                    <a:gd name="connsiteX104" fmla="*/ 174914 w 1289611"/>
                    <a:gd name="connsiteY104" fmla="*/ 478971 h 1859149"/>
                    <a:gd name="connsiteX105" fmla="*/ 157497 w 1289611"/>
                    <a:gd name="connsiteY105" fmla="*/ 452846 h 1859149"/>
                    <a:gd name="connsiteX106" fmla="*/ 140080 w 1289611"/>
                    <a:gd name="connsiteY106" fmla="*/ 400594 h 1859149"/>
                    <a:gd name="connsiteX107" fmla="*/ 131371 w 1289611"/>
                    <a:gd name="connsiteY107" fmla="*/ 200297 h 1859149"/>
                    <a:gd name="connsiteX108" fmla="*/ 157497 w 1289611"/>
                    <a:gd name="connsiteY108" fmla="*/ 174171 h 1859149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  <a:cxn ang="0">
                      <a:pos x="connsiteX40" y="connsiteY40"/>
                    </a:cxn>
                    <a:cxn ang="0">
                      <a:pos x="connsiteX41" y="connsiteY41"/>
                    </a:cxn>
                    <a:cxn ang="0">
                      <a:pos x="connsiteX42" y="connsiteY42"/>
                    </a:cxn>
                    <a:cxn ang="0">
                      <a:pos x="connsiteX43" y="connsiteY43"/>
                    </a:cxn>
                    <a:cxn ang="0">
                      <a:pos x="connsiteX44" y="connsiteY44"/>
                    </a:cxn>
                    <a:cxn ang="0">
                      <a:pos x="connsiteX45" y="connsiteY45"/>
                    </a:cxn>
                    <a:cxn ang="0">
                      <a:pos x="connsiteX46" y="connsiteY46"/>
                    </a:cxn>
                    <a:cxn ang="0">
                      <a:pos x="connsiteX47" y="connsiteY47"/>
                    </a:cxn>
                    <a:cxn ang="0">
                      <a:pos x="connsiteX48" y="connsiteY48"/>
                    </a:cxn>
                    <a:cxn ang="0">
                      <a:pos x="connsiteX49" y="connsiteY49"/>
                    </a:cxn>
                    <a:cxn ang="0">
                      <a:pos x="connsiteX50" y="connsiteY50"/>
                    </a:cxn>
                    <a:cxn ang="0">
                      <a:pos x="connsiteX51" y="connsiteY51"/>
                    </a:cxn>
                    <a:cxn ang="0">
                      <a:pos x="connsiteX52" y="connsiteY52"/>
                    </a:cxn>
                    <a:cxn ang="0">
                      <a:pos x="connsiteX53" y="connsiteY53"/>
                    </a:cxn>
                    <a:cxn ang="0">
                      <a:pos x="connsiteX54" y="connsiteY54"/>
                    </a:cxn>
                    <a:cxn ang="0">
                      <a:pos x="connsiteX55" y="connsiteY55"/>
                    </a:cxn>
                    <a:cxn ang="0">
                      <a:pos x="connsiteX56" y="connsiteY56"/>
                    </a:cxn>
                    <a:cxn ang="0">
                      <a:pos x="connsiteX57" y="connsiteY57"/>
                    </a:cxn>
                    <a:cxn ang="0">
                      <a:pos x="connsiteX58" y="connsiteY58"/>
                    </a:cxn>
                    <a:cxn ang="0">
                      <a:pos x="connsiteX59" y="connsiteY59"/>
                    </a:cxn>
                    <a:cxn ang="0">
                      <a:pos x="connsiteX60" y="connsiteY60"/>
                    </a:cxn>
                    <a:cxn ang="0">
                      <a:pos x="connsiteX61" y="connsiteY61"/>
                    </a:cxn>
                    <a:cxn ang="0">
                      <a:pos x="connsiteX62" y="connsiteY62"/>
                    </a:cxn>
                    <a:cxn ang="0">
                      <a:pos x="connsiteX63" y="connsiteY63"/>
                    </a:cxn>
                    <a:cxn ang="0">
                      <a:pos x="connsiteX64" y="connsiteY64"/>
                    </a:cxn>
                    <a:cxn ang="0">
                      <a:pos x="connsiteX65" y="connsiteY65"/>
                    </a:cxn>
                    <a:cxn ang="0">
                      <a:pos x="connsiteX66" y="connsiteY66"/>
                    </a:cxn>
                    <a:cxn ang="0">
                      <a:pos x="connsiteX67" y="connsiteY67"/>
                    </a:cxn>
                    <a:cxn ang="0">
                      <a:pos x="connsiteX68" y="connsiteY68"/>
                    </a:cxn>
                    <a:cxn ang="0">
                      <a:pos x="connsiteX69" y="connsiteY69"/>
                    </a:cxn>
                    <a:cxn ang="0">
                      <a:pos x="connsiteX70" y="connsiteY70"/>
                    </a:cxn>
                    <a:cxn ang="0">
                      <a:pos x="connsiteX71" y="connsiteY71"/>
                    </a:cxn>
                    <a:cxn ang="0">
                      <a:pos x="connsiteX72" y="connsiteY72"/>
                    </a:cxn>
                    <a:cxn ang="0">
                      <a:pos x="connsiteX73" y="connsiteY73"/>
                    </a:cxn>
                    <a:cxn ang="0">
                      <a:pos x="connsiteX74" y="connsiteY74"/>
                    </a:cxn>
                    <a:cxn ang="0">
                      <a:pos x="connsiteX75" y="connsiteY75"/>
                    </a:cxn>
                    <a:cxn ang="0">
                      <a:pos x="connsiteX76" y="connsiteY76"/>
                    </a:cxn>
                    <a:cxn ang="0">
                      <a:pos x="connsiteX77" y="connsiteY77"/>
                    </a:cxn>
                    <a:cxn ang="0">
                      <a:pos x="connsiteX78" y="connsiteY78"/>
                    </a:cxn>
                    <a:cxn ang="0">
                      <a:pos x="connsiteX79" y="connsiteY79"/>
                    </a:cxn>
                    <a:cxn ang="0">
                      <a:pos x="connsiteX80" y="connsiteY80"/>
                    </a:cxn>
                    <a:cxn ang="0">
                      <a:pos x="connsiteX81" y="connsiteY81"/>
                    </a:cxn>
                    <a:cxn ang="0">
                      <a:pos x="connsiteX82" y="connsiteY82"/>
                    </a:cxn>
                    <a:cxn ang="0">
                      <a:pos x="connsiteX83" y="connsiteY83"/>
                    </a:cxn>
                    <a:cxn ang="0">
                      <a:pos x="connsiteX84" y="connsiteY84"/>
                    </a:cxn>
                    <a:cxn ang="0">
                      <a:pos x="connsiteX85" y="connsiteY85"/>
                    </a:cxn>
                    <a:cxn ang="0">
                      <a:pos x="connsiteX86" y="connsiteY86"/>
                    </a:cxn>
                    <a:cxn ang="0">
                      <a:pos x="connsiteX87" y="connsiteY87"/>
                    </a:cxn>
                    <a:cxn ang="0">
                      <a:pos x="connsiteX88" y="connsiteY88"/>
                    </a:cxn>
                    <a:cxn ang="0">
                      <a:pos x="connsiteX89" y="connsiteY89"/>
                    </a:cxn>
                    <a:cxn ang="0">
                      <a:pos x="connsiteX90" y="connsiteY90"/>
                    </a:cxn>
                    <a:cxn ang="0">
                      <a:pos x="connsiteX91" y="connsiteY91"/>
                    </a:cxn>
                    <a:cxn ang="0">
                      <a:pos x="connsiteX92" y="connsiteY92"/>
                    </a:cxn>
                    <a:cxn ang="0">
                      <a:pos x="connsiteX93" y="connsiteY93"/>
                    </a:cxn>
                    <a:cxn ang="0">
                      <a:pos x="connsiteX94" y="connsiteY94"/>
                    </a:cxn>
                    <a:cxn ang="0">
                      <a:pos x="connsiteX95" y="connsiteY95"/>
                    </a:cxn>
                    <a:cxn ang="0">
                      <a:pos x="connsiteX96" y="connsiteY96"/>
                    </a:cxn>
                    <a:cxn ang="0">
                      <a:pos x="connsiteX97" y="connsiteY97"/>
                    </a:cxn>
                    <a:cxn ang="0">
                      <a:pos x="connsiteX98" y="connsiteY98"/>
                    </a:cxn>
                    <a:cxn ang="0">
                      <a:pos x="connsiteX99" y="connsiteY99"/>
                    </a:cxn>
                    <a:cxn ang="0">
                      <a:pos x="connsiteX100" y="connsiteY100"/>
                    </a:cxn>
                    <a:cxn ang="0">
                      <a:pos x="connsiteX101" y="connsiteY101"/>
                    </a:cxn>
                    <a:cxn ang="0">
                      <a:pos x="connsiteX102" y="connsiteY102"/>
                    </a:cxn>
                    <a:cxn ang="0">
                      <a:pos x="connsiteX103" y="connsiteY103"/>
                    </a:cxn>
                    <a:cxn ang="0">
                      <a:pos x="connsiteX104" y="connsiteY104"/>
                    </a:cxn>
                    <a:cxn ang="0">
                      <a:pos x="connsiteX105" y="connsiteY105"/>
                    </a:cxn>
                    <a:cxn ang="0">
                      <a:pos x="connsiteX106" y="connsiteY106"/>
                    </a:cxn>
                    <a:cxn ang="0">
                      <a:pos x="connsiteX107" y="connsiteY107"/>
                    </a:cxn>
                    <a:cxn ang="0">
                      <a:pos x="connsiteX108" y="connsiteY108"/>
                    </a:cxn>
                  </a:cxnLst>
                  <a:rect l="l" t="t" r="r" b="b"/>
                  <a:pathLst>
                    <a:path w="1289611" h="1859149">
                      <a:moveTo>
                        <a:pt x="157497" y="174171"/>
                      </a:moveTo>
                      <a:cubicBezTo>
                        <a:pt x="142983" y="166914"/>
                        <a:pt x="109336" y="133099"/>
                        <a:pt x="44285" y="156754"/>
                      </a:cubicBezTo>
                      <a:cubicBezTo>
                        <a:pt x="32711" y="160963"/>
                        <a:pt x="26868" y="174171"/>
                        <a:pt x="18160" y="182880"/>
                      </a:cubicBezTo>
                      <a:cubicBezTo>
                        <a:pt x="-14822" y="281823"/>
                        <a:pt x="4588" y="213403"/>
                        <a:pt x="18160" y="444137"/>
                      </a:cubicBezTo>
                      <a:cubicBezTo>
                        <a:pt x="19365" y="464628"/>
                        <a:pt x="24826" y="484673"/>
                        <a:pt x="26868" y="505097"/>
                      </a:cubicBezTo>
                      <a:cubicBezTo>
                        <a:pt x="30634" y="542758"/>
                        <a:pt x="31811" y="580648"/>
                        <a:pt x="35577" y="618309"/>
                      </a:cubicBezTo>
                      <a:cubicBezTo>
                        <a:pt x="37619" y="638733"/>
                        <a:pt x="41739" y="658901"/>
                        <a:pt x="44285" y="679269"/>
                      </a:cubicBezTo>
                      <a:cubicBezTo>
                        <a:pt x="47545" y="705352"/>
                        <a:pt x="50091" y="731520"/>
                        <a:pt x="52994" y="757646"/>
                      </a:cubicBezTo>
                      <a:cubicBezTo>
                        <a:pt x="50091" y="809897"/>
                        <a:pt x="48631" y="862249"/>
                        <a:pt x="44285" y="914400"/>
                      </a:cubicBezTo>
                      <a:cubicBezTo>
                        <a:pt x="42819" y="931996"/>
                        <a:pt x="37334" y="949081"/>
                        <a:pt x="35577" y="966651"/>
                      </a:cubicBezTo>
                      <a:cubicBezTo>
                        <a:pt x="28170" y="1040721"/>
                        <a:pt x="23407" y="1165779"/>
                        <a:pt x="18160" y="1236617"/>
                      </a:cubicBezTo>
                      <a:cubicBezTo>
                        <a:pt x="16005" y="1265711"/>
                        <a:pt x="12354" y="1294674"/>
                        <a:pt x="9451" y="1323703"/>
                      </a:cubicBezTo>
                      <a:cubicBezTo>
                        <a:pt x="12354" y="1396274"/>
                        <a:pt x="13163" y="1468960"/>
                        <a:pt x="18160" y="1541417"/>
                      </a:cubicBezTo>
                      <a:cubicBezTo>
                        <a:pt x="18983" y="1553357"/>
                        <a:pt x="24272" y="1564567"/>
                        <a:pt x="26868" y="1576251"/>
                      </a:cubicBezTo>
                      <a:cubicBezTo>
                        <a:pt x="30079" y="1590700"/>
                        <a:pt x="31682" y="1605514"/>
                        <a:pt x="35577" y="1619794"/>
                      </a:cubicBezTo>
                      <a:cubicBezTo>
                        <a:pt x="35589" y="1619837"/>
                        <a:pt x="57342" y="1685087"/>
                        <a:pt x="61703" y="1698171"/>
                      </a:cubicBezTo>
                      <a:cubicBezTo>
                        <a:pt x="72654" y="1731024"/>
                        <a:pt x="75298" y="1746604"/>
                        <a:pt x="105245" y="1776549"/>
                      </a:cubicBezTo>
                      <a:cubicBezTo>
                        <a:pt x="111051" y="1782355"/>
                        <a:pt x="115319" y="1790294"/>
                        <a:pt x="122663" y="1793966"/>
                      </a:cubicBezTo>
                      <a:cubicBezTo>
                        <a:pt x="139084" y="1802176"/>
                        <a:pt x="157497" y="1805577"/>
                        <a:pt x="174914" y="1811383"/>
                      </a:cubicBezTo>
                      <a:lnTo>
                        <a:pt x="201040" y="1820091"/>
                      </a:lnTo>
                      <a:cubicBezTo>
                        <a:pt x="265824" y="1841686"/>
                        <a:pt x="217981" y="1828144"/>
                        <a:pt x="349085" y="1837509"/>
                      </a:cubicBezTo>
                      <a:cubicBezTo>
                        <a:pt x="586588" y="1877090"/>
                        <a:pt x="424407" y="1853272"/>
                        <a:pt x="976103" y="1837509"/>
                      </a:cubicBezTo>
                      <a:cubicBezTo>
                        <a:pt x="988067" y="1837167"/>
                        <a:pt x="999201" y="1831147"/>
                        <a:pt x="1010937" y="1828800"/>
                      </a:cubicBezTo>
                      <a:cubicBezTo>
                        <a:pt x="1028251" y="1825337"/>
                        <a:pt x="1045951" y="1823921"/>
                        <a:pt x="1063188" y="1820091"/>
                      </a:cubicBezTo>
                      <a:cubicBezTo>
                        <a:pt x="1072149" y="1818100"/>
                        <a:pt x="1080488" y="1813905"/>
                        <a:pt x="1089314" y="1811383"/>
                      </a:cubicBezTo>
                      <a:cubicBezTo>
                        <a:pt x="1165859" y="1789513"/>
                        <a:pt x="1087633" y="1814845"/>
                        <a:pt x="1150274" y="1793966"/>
                      </a:cubicBezTo>
                      <a:cubicBezTo>
                        <a:pt x="1158983" y="1788160"/>
                        <a:pt x="1167039" y="1781230"/>
                        <a:pt x="1176400" y="1776549"/>
                      </a:cubicBezTo>
                      <a:cubicBezTo>
                        <a:pt x="1184610" y="1772444"/>
                        <a:pt x="1196034" y="1774331"/>
                        <a:pt x="1202525" y="1767840"/>
                      </a:cubicBezTo>
                      <a:cubicBezTo>
                        <a:pt x="1217327" y="1753038"/>
                        <a:pt x="1222559" y="1730391"/>
                        <a:pt x="1237360" y="1715589"/>
                      </a:cubicBezTo>
                      <a:lnTo>
                        <a:pt x="1254777" y="1698171"/>
                      </a:lnTo>
                      <a:cubicBezTo>
                        <a:pt x="1279595" y="1623717"/>
                        <a:pt x="1269917" y="1664137"/>
                        <a:pt x="1280903" y="1576251"/>
                      </a:cubicBezTo>
                      <a:cubicBezTo>
                        <a:pt x="1283806" y="1500777"/>
                        <a:pt x="1289611" y="1425359"/>
                        <a:pt x="1289611" y="1349829"/>
                      </a:cubicBezTo>
                      <a:cubicBezTo>
                        <a:pt x="1289611" y="1216266"/>
                        <a:pt x="1284371" y="1082752"/>
                        <a:pt x="1280903" y="949234"/>
                      </a:cubicBezTo>
                      <a:cubicBezTo>
                        <a:pt x="1274097" y="687216"/>
                        <a:pt x="1276051" y="740980"/>
                        <a:pt x="1263485" y="539931"/>
                      </a:cubicBezTo>
                      <a:cubicBezTo>
                        <a:pt x="1259188" y="376634"/>
                        <a:pt x="1267398" y="277986"/>
                        <a:pt x="1246068" y="139337"/>
                      </a:cubicBezTo>
                      <a:cubicBezTo>
                        <a:pt x="1239034" y="93614"/>
                        <a:pt x="1235499" y="90211"/>
                        <a:pt x="1219943" y="43543"/>
                      </a:cubicBezTo>
                      <a:cubicBezTo>
                        <a:pt x="1217040" y="34834"/>
                        <a:pt x="1219943" y="20320"/>
                        <a:pt x="1211234" y="17417"/>
                      </a:cubicBezTo>
                      <a:lnTo>
                        <a:pt x="1158983" y="0"/>
                      </a:lnTo>
                      <a:cubicBezTo>
                        <a:pt x="1153177" y="8709"/>
                        <a:pt x="1146246" y="16764"/>
                        <a:pt x="1141565" y="26126"/>
                      </a:cubicBezTo>
                      <a:cubicBezTo>
                        <a:pt x="1134607" y="40042"/>
                        <a:pt x="1127866" y="74071"/>
                        <a:pt x="1124148" y="87086"/>
                      </a:cubicBezTo>
                      <a:cubicBezTo>
                        <a:pt x="1121626" y="95912"/>
                        <a:pt x="1118343" y="104503"/>
                        <a:pt x="1115440" y="113211"/>
                      </a:cubicBezTo>
                      <a:cubicBezTo>
                        <a:pt x="1118343" y="139337"/>
                        <a:pt x="1120674" y="165533"/>
                        <a:pt x="1124148" y="191589"/>
                      </a:cubicBezTo>
                      <a:cubicBezTo>
                        <a:pt x="1126482" y="209091"/>
                        <a:pt x="1130523" y="226338"/>
                        <a:pt x="1132857" y="243840"/>
                      </a:cubicBezTo>
                      <a:cubicBezTo>
                        <a:pt x="1136331" y="269896"/>
                        <a:pt x="1138662" y="296091"/>
                        <a:pt x="1141565" y="322217"/>
                      </a:cubicBezTo>
                      <a:cubicBezTo>
                        <a:pt x="1138662" y="362857"/>
                        <a:pt x="1149931" y="407143"/>
                        <a:pt x="1132857" y="444137"/>
                      </a:cubicBezTo>
                      <a:cubicBezTo>
                        <a:pt x="1126654" y="457576"/>
                        <a:pt x="1101630" y="443639"/>
                        <a:pt x="1089314" y="435429"/>
                      </a:cubicBezTo>
                      <a:cubicBezTo>
                        <a:pt x="1081676" y="430337"/>
                        <a:pt x="1084221" y="417741"/>
                        <a:pt x="1080605" y="409303"/>
                      </a:cubicBezTo>
                      <a:cubicBezTo>
                        <a:pt x="1075491" y="397371"/>
                        <a:pt x="1068009" y="386522"/>
                        <a:pt x="1063188" y="374469"/>
                      </a:cubicBezTo>
                      <a:cubicBezTo>
                        <a:pt x="1056370" y="357423"/>
                        <a:pt x="1045771" y="322217"/>
                        <a:pt x="1045771" y="322217"/>
                      </a:cubicBezTo>
                      <a:cubicBezTo>
                        <a:pt x="1042868" y="298994"/>
                        <a:pt x="1039513" y="275824"/>
                        <a:pt x="1037063" y="252549"/>
                      </a:cubicBezTo>
                      <a:cubicBezTo>
                        <a:pt x="1033706" y="220662"/>
                        <a:pt x="1032889" y="188495"/>
                        <a:pt x="1028354" y="156754"/>
                      </a:cubicBezTo>
                      <a:cubicBezTo>
                        <a:pt x="1027056" y="147667"/>
                        <a:pt x="1027115" y="135964"/>
                        <a:pt x="1019645" y="130629"/>
                      </a:cubicBezTo>
                      <a:cubicBezTo>
                        <a:pt x="1004705" y="119958"/>
                        <a:pt x="967394" y="113211"/>
                        <a:pt x="967394" y="113211"/>
                      </a:cubicBezTo>
                      <a:lnTo>
                        <a:pt x="949977" y="165463"/>
                      </a:lnTo>
                      <a:lnTo>
                        <a:pt x="941268" y="191589"/>
                      </a:lnTo>
                      <a:cubicBezTo>
                        <a:pt x="944171" y="232229"/>
                        <a:pt x="945216" y="273045"/>
                        <a:pt x="949977" y="313509"/>
                      </a:cubicBezTo>
                      <a:cubicBezTo>
                        <a:pt x="951050" y="322625"/>
                        <a:pt x="956163" y="330808"/>
                        <a:pt x="958685" y="339634"/>
                      </a:cubicBezTo>
                      <a:cubicBezTo>
                        <a:pt x="961973" y="351143"/>
                        <a:pt x="964491" y="362857"/>
                        <a:pt x="967394" y="374469"/>
                      </a:cubicBezTo>
                      <a:cubicBezTo>
                        <a:pt x="964491" y="403497"/>
                        <a:pt x="970533" y="434895"/>
                        <a:pt x="958685" y="461554"/>
                      </a:cubicBezTo>
                      <a:cubicBezTo>
                        <a:pt x="954957" y="469942"/>
                        <a:pt x="939728" y="458580"/>
                        <a:pt x="932560" y="452846"/>
                      </a:cubicBezTo>
                      <a:cubicBezTo>
                        <a:pt x="924387" y="446308"/>
                        <a:pt x="920949" y="435429"/>
                        <a:pt x="915143" y="426720"/>
                      </a:cubicBezTo>
                      <a:cubicBezTo>
                        <a:pt x="912240" y="412206"/>
                        <a:pt x="909762" y="397600"/>
                        <a:pt x="906434" y="383177"/>
                      </a:cubicBezTo>
                      <a:cubicBezTo>
                        <a:pt x="901051" y="359853"/>
                        <a:pt x="889017" y="313509"/>
                        <a:pt x="889017" y="313509"/>
                      </a:cubicBezTo>
                      <a:cubicBezTo>
                        <a:pt x="881410" y="245051"/>
                        <a:pt x="883922" y="247038"/>
                        <a:pt x="871600" y="191589"/>
                      </a:cubicBezTo>
                      <a:cubicBezTo>
                        <a:pt x="869004" y="179905"/>
                        <a:pt x="870773" y="165762"/>
                        <a:pt x="862891" y="156754"/>
                      </a:cubicBezTo>
                      <a:cubicBezTo>
                        <a:pt x="849107" y="141001"/>
                        <a:pt x="828057" y="133531"/>
                        <a:pt x="810640" y="121920"/>
                      </a:cubicBezTo>
                      <a:lnTo>
                        <a:pt x="784514" y="104503"/>
                      </a:lnTo>
                      <a:cubicBezTo>
                        <a:pt x="778708" y="121920"/>
                        <a:pt x="765952" y="138431"/>
                        <a:pt x="767097" y="156754"/>
                      </a:cubicBezTo>
                      <a:cubicBezTo>
                        <a:pt x="776552" y="308037"/>
                        <a:pt x="764518" y="250944"/>
                        <a:pt x="784514" y="330926"/>
                      </a:cubicBezTo>
                      <a:cubicBezTo>
                        <a:pt x="782728" y="352362"/>
                        <a:pt x="802556" y="444034"/>
                        <a:pt x="749680" y="452846"/>
                      </a:cubicBezTo>
                      <a:cubicBezTo>
                        <a:pt x="740625" y="454355"/>
                        <a:pt x="732263" y="447040"/>
                        <a:pt x="723554" y="444137"/>
                      </a:cubicBezTo>
                      <a:lnTo>
                        <a:pt x="697428" y="365760"/>
                      </a:lnTo>
                      <a:lnTo>
                        <a:pt x="688720" y="339634"/>
                      </a:lnTo>
                      <a:cubicBezTo>
                        <a:pt x="691878" y="289110"/>
                        <a:pt x="706843" y="163403"/>
                        <a:pt x="688720" y="104503"/>
                      </a:cubicBezTo>
                      <a:cubicBezTo>
                        <a:pt x="685642" y="94499"/>
                        <a:pt x="671303" y="92892"/>
                        <a:pt x="662594" y="87086"/>
                      </a:cubicBezTo>
                      <a:cubicBezTo>
                        <a:pt x="632114" y="107406"/>
                        <a:pt x="616148" y="113211"/>
                        <a:pt x="601634" y="156754"/>
                      </a:cubicBezTo>
                      <a:lnTo>
                        <a:pt x="584217" y="209006"/>
                      </a:lnTo>
                      <a:cubicBezTo>
                        <a:pt x="587120" y="261257"/>
                        <a:pt x="592925" y="313428"/>
                        <a:pt x="592925" y="365760"/>
                      </a:cubicBezTo>
                      <a:cubicBezTo>
                        <a:pt x="592925" y="394933"/>
                        <a:pt x="601721" y="429507"/>
                        <a:pt x="584217" y="452846"/>
                      </a:cubicBezTo>
                      <a:cubicBezTo>
                        <a:pt x="573201" y="467534"/>
                        <a:pt x="572606" y="418011"/>
                        <a:pt x="566800" y="400594"/>
                      </a:cubicBezTo>
                      <a:lnTo>
                        <a:pt x="549383" y="348343"/>
                      </a:lnTo>
                      <a:cubicBezTo>
                        <a:pt x="546480" y="339634"/>
                        <a:pt x="545766" y="329855"/>
                        <a:pt x="540674" y="322217"/>
                      </a:cubicBezTo>
                      <a:lnTo>
                        <a:pt x="505840" y="269966"/>
                      </a:lnTo>
                      <a:cubicBezTo>
                        <a:pt x="506802" y="250719"/>
                        <a:pt x="524950" y="61262"/>
                        <a:pt x="505840" y="8709"/>
                      </a:cubicBezTo>
                      <a:cubicBezTo>
                        <a:pt x="502703" y="82"/>
                        <a:pt x="488423" y="2903"/>
                        <a:pt x="479714" y="0"/>
                      </a:cubicBezTo>
                      <a:cubicBezTo>
                        <a:pt x="471005" y="2903"/>
                        <a:pt x="460079" y="2218"/>
                        <a:pt x="453588" y="8709"/>
                      </a:cubicBezTo>
                      <a:cubicBezTo>
                        <a:pt x="447097" y="15200"/>
                        <a:pt x="448985" y="26624"/>
                        <a:pt x="444880" y="34834"/>
                      </a:cubicBezTo>
                      <a:cubicBezTo>
                        <a:pt x="433893" y="56808"/>
                        <a:pt x="426247" y="62176"/>
                        <a:pt x="410045" y="78377"/>
                      </a:cubicBezTo>
                      <a:cubicBezTo>
                        <a:pt x="387276" y="146690"/>
                        <a:pt x="397449" y="105287"/>
                        <a:pt x="410045" y="243840"/>
                      </a:cubicBezTo>
                      <a:cubicBezTo>
                        <a:pt x="411644" y="261425"/>
                        <a:pt x="416420" y="278589"/>
                        <a:pt x="418754" y="296091"/>
                      </a:cubicBezTo>
                      <a:cubicBezTo>
                        <a:pt x="422228" y="322147"/>
                        <a:pt x="424560" y="348343"/>
                        <a:pt x="427463" y="374469"/>
                      </a:cubicBezTo>
                      <a:cubicBezTo>
                        <a:pt x="424560" y="403497"/>
                        <a:pt x="436665" y="438526"/>
                        <a:pt x="418754" y="461554"/>
                      </a:cubicBezTo>
                      <a:cubicBezTo>
                        <a:pt x="388804" y="500061"/>
                        <a:pt x="356959" y="438530"/>
                        <a:pt x="349085" y="426720"/>
                      </a:cubicBezTo>
                      <a:cubicBezTo>
                        <a:pt x="343279" y="409303"/>
                        <a:pt x="332432" y="392812"/>
                        <a:pt x="331668" y="374469"/>
                      </a:cubicBezTo>
                      <a:cubicBezTo>
                        <a:pt x="328765" y="304800"/>
                        <a:pt x="328111" y="235002"/>
                        <a:pt x="322960" y="165463"/>
                      </a:cubicBezTo>
                      <a:cubicBezTo>
                        <a:pt x="322282" y="156308"/>
                        <a:pt x="318356" y="147548"/>
                        <a:pt x="314251" y="139337"/>
                      </a:cubicBezTo>
                      <a:cubicBezTo>
                        <a:pt x="309570" y="129976"/>
                        <a:pt x="304235" y="120612"/>
                        <a:pt x="296834" y="113211"/>
                      </a:cubicBezTo>
                      <a:cubicBezTo>
                        <a:pt x="289433" y="105810"/>
                        <a:pt x="279417" y="101600"/>
                        <a:pt x="270708" y="95794"/>
                      </a:cubicBezTo>
                      <a:cubicBezTo>
                        <a:pt x="259097" y="98697"/>
                        <a:pt x="245832" y="97864"/>
                        <a:pt x="235874" y="104503"/>
                      </a:cubicBezTo>
                      <a:cubicBezTo>
                        <a:pt x="221405" y="114149"/>
                        <a:pt x="214716" y="141852"/>
                        <a:pt x="209748" y="156754"/>
                      </a:cubicBezTo>
                      <a:cubicBezTo>
                        <a:pt x="212651" y="197394"/>
                        <a:pt x="213958" y="238180"/>
                        <a:pt x="218457" y="278674"/>
                      </a:cubicBezTo>
                      <a:cubicBezTo>
                        <a:pt x="219779" y="290570"/>
                        <a:pt x="224569" y="301825"/>
                        <a:pt x="227165" y="313509"/>
                      </a:cubicBezTo>
                      <a:cubicBezTo>
                        <a:pt x="230376" y="327958"/>
                        <a:pt x="232971" y="342537"/>
                        <a:pt x="235874" y="357051"/>
                      </a:cubicBezTo>
                      <a:cubicBezTo>
                        <a:pt x="233357" y="392280"/>
                        <a:pt x="264275" y="487680"/>
                        <a:pt x="201040" y="487680"/>
                      </a:cubicBezTo>
                      <a:cubicBezTo>
                        <a:pt x="191860" y="487680"/>
                        <a:pt x="183623" y="481874"/>
                        <a:pt x="174914" y="478971"/>
                      </a:cubicBezTo>
                      <a:cubicBezTo>
                        <a:pt x="169108" y="470263"/>
                        <a:pt x="161748" y="462410"/>
                        <a:pt x="157497" y="452846"/>
                      </a:cubicBezTo>
                      <a:cubicBezTo>
                        <a:pt x="150041" y="436069"/>
                        <a:pt x="140080" y="400594"/>
                        <a:pt x="140080" y="400594"/>
                      </a:cubicBezTo>
                      <a:cubicBezTo>
                        <a:pt x="137177" y="333828"/>
                        <a:pt x="139031" y="266685"/>
                        <a:pt x="131371" y="200297"/>
                      </a:cubicBezTo>
                      <a:cubicBezTo>
                        <a:pt x="130171" y="189900"/>
                        <a:pt x="172011" y="181428"/>
                        <a:pt x="157497" y="174171"/>
                      </a:cubicBezTo>
                      <a:close/>
                    </a:path>
                  </a:pathLst>
                </a:custGeom>
                <a:solidFill>
                  <a:srgbClr val="B3C7E7"/>
                </a:solidFill>
                <a:ln>
                  <a:solidFill>
                    <a:srgbClr val="2F5597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32" name="Freeform 31">
                  <a:extLst>
                    <a:ext uri="{FF2B5EF4-FFF2-40B4-BE49-F238E27FC236}">
                      <a16:creationId xmlns:a16="http://schemas.microsoft.com/office/drawing/2014/main" id="{3946DFF2-69E2-E542-9D01-6F67A8B69995}"/>
                    </a:ext>
                  </a:extLst>
                </p:cNvPr>
                <p:cNvSpPr/>
                <p:nvPr/>
              </p:nvSpPr>
              <p:spPr>
                <a:xfrm>
                  <a:off x="6699948" y="2610438"/>
                  <a:ext cx="248048" cy="392533"/>
                </a:xfrm>
                <a:custGeom>
                  <a:avLst/>
                  <a:gdLst>
                    <a:gd name="connsiteX0" fmla="*/ 157497 w 1289611"/>
                    <a:gd name="connsiteY0" fmla="*/ 174171 h 1859149"/>
                    <a:gd name="connsiteX1" fmla="*/ 44285 w 1289611"/>
                    <a:gd name="connsiteY1" fmla="*/ 156754 h 1859149"/>
                    <a:gd name="connsiteX2" fmla="*/ 18160 w 1289611"/>
                    <a:gd name="connsiteY2" fmla="*/ 182880 h 1859149"/>
                    <a:gd name="connsiteX3" fmla="*/ 18160 w 1289611"/>
                    <a:gd name="connsiteY3" fmla="*/ 444137 h 1859149"/>
                    <a:gd name="connsiteX4" fmla="*/ 26868 w 1289611"/>
                    <a:gd name="connsiteY4" fmla="*/ 505097 h 1859149"/>
                    <a:gd name="connsiteX5" fmla="*/ 35577 w 1289611"/>
                    <a:gd name="connsiteY5" fmla="*/ 618309 h 1859149"/>
                    <a:gd name="connsiteX6" fmla="*/ 44285 w 1289611"/>
                    <a:gd name="connsiteY6" fmla="*/ 679269 h 1859149"/>
                    <a:gd name="connsiteX7" fmla="*/ 52994 w 1289611"/>
                    <a:gd name="connsiteY7" fmla="*/ 757646 h 1859149"/>
                    <a:gd name="connsiteX8" fmla="*/ 44285 w 1289611"/>
                    <a:gd name="connsiteY8" fmla="*/ 914400 h 1859149"/>
                    <a:gd name="connsiteX9" fmla="*/ 35577 w 1289611"/>
                    <a:gd name="connsiteY9" fmla="*/ 966651 h 1859149"/>
                    <a:gd name="connsiteX10" fmla="*/ 18160 w 1289611"/>
                    <a:gd name="connsiteY10" fmla="*/ 1236617 h 1859149"/>
                    <a:gd name="connsiteX11" fmla="*/ 9451 w 1289611"/>
                    <a:gd name="connsiteY11" fmla="*/ 1323703 h 1859149"/>
                    <a:gd name="connsiteX12" fmla="*/ 18160 w 1289611"/>
                    <a:gd name="connsiteY12" fmla="*/ 1541417 h 1859149"/>
                    <a:gd name="connsiteX13" fmla="*/ 26868 w 1289611"/>
                    <a:gd name="connsiteY13" fmla="*/ 1576251 h 1859149"/>
                    <a:gd name="connsiteX14" fmla="*/ 35577 w 1289611"/>
                    <a:gd name="connsiteY14" fmla="*/ 1619794 h 1859149"/>
                    <a:gd name="connsiteX15" fmla="*/ 61703 w 1289611"/>
                    <a:gd name="connsiteY15" fmla="*/ 1698171 h 1859149"/>
                    <a:gd name="connsiteX16" fmla="*/ 105245 w 1289611"/>
                    <a:gd name="connsiteY16" fmla="*/ 1776549 h 1859149"/>
                    <a:gd name="connsiteX17" fmla="*/ 122663 w 1289611"/>
                    <a:gd name="connsiteY17" fmla="*/ 1793966 h 1859149"/>
                    <a:gd name="connsiteX18" fmla="*/ 174914 w 1289611"/>
                    <a:gd name="connsiteY18" fmla="*/ 1811383 h 1859149"/>
                    <a:gd name="connsiteX19" fmla="*/ 201040 w 1289611"/>
                    <a:gd name="connsiteY19" fmla="*/ 1820091 h 1859149"/>
                    <a:gd name="connsiteX20" fmla="*/ 349085 w 1289611"/>
                    <a:gd name="connsiteY20" fmla="*/ 1837509 h 1859149"/>
                    <a:gd name="connsiteX21" fmla="*/ 976103 w 1289611"/>
                    <a:gd name="connsiteY21" fmla="*/ 1837509 h 1859149"/>
                    <a:gd name="connsiteX22" fmla="*/ 1010937 w 1289611"/>
                    <a:gd name="connsiteY22" fmla="*/ 1828800 h 1859149"/>
                    <a:gd name="connsiteX23" fmla="*/ 1063188 w 1289611"/>
                    <a:gd name="connsiteY23" fmla="*/ 1820091 h 1859149"/>
                    <a:gd name="connsiteX24" fmla="*/ 1089314 w 1289611"/>
                    <a:gd name="connsiteY24" fmla="*/ 1811383 h 1859149"/>
                    <a:gd name="connsiteX25" fmla="*/ 1150274 w 1289611"/>
                    <a:gd name="connsiteY25" fmla="*/ 1793966 h 1859149"/>
                    <a:gd name="connsiteX26" fmla="*/ 1176400 w 1289611"/>
                    <a:gd name="connsiteY26" fmla="*/ 1776549 h 1859149"/>
                    <a:gd name="connsiteX27" fmla="*/ 1202525 w 1289611"/>
                    <a:gd name="connsiteY27" fmla="*/ 1767840 h 1859149"/>
                    <a:gd name="connsiteX28" fmla="*/ 1237360 w 1289611"/>
                    <a:gd name="connsiteY28" fmla="*/ 1715589 h 1859149"/>
                    <a:gd name="connsiteX29" fmla="*/ 1254777 w 1289611"/>
                    <a:gd name="connsiteY29" fmla="*/ 1698171 h 1859149"/>
                    <a:gd name="connsiteX30" fmla="*/ 1280903 w 1289611"/>
                    <a:gd name="connsiteY30" fmla="*/ 1576251 h 1859149"/>
                    <a:gd name="connsiteX31" fmla="*/ 1289611 w 1289611"/>
                    <a:gd name="connsiteY31" fmla="*/ 1349829 h 1859149"/>
                    <a:gd name="connsiteX32" fmla="*/ 1280903 w 1289611"/>
                    <a:gd name="connsiteY32" fmla="*/ 949234 h 1859149"/>
                    <a:gd name="connsiteX33" fmla="*/ 1263485 w 1289611"/>
                    <a:gd name="connsiteY33" fmla="*/ 539931 h 1859149"/>
                    <a:gd name="connsiteX34" fmla="*/ 1246068 w 1289611"/>
                    <a:gd name="connsiteY34" fmla="*/ 139337 h 1859149"/>
                    <a:gd name="connsiteX35" fmla="*/ 1219943 w 1289611"/>
                    <a:gd name="connsiteY35" fmla="*/ 43543 h 1859149"/>
                    <a:gd name="connsiteX36" fmla="*/ 1211234 w 1289611"/>
                    <a:gd name="connsiteY36" fmla="*/ 17417 h 1859149"/>
                    <a:gd name="connsiteX37" fmla="*/ 1158983 w 1289611"/>
                    <a:gd name="connsiteY37" fmla="*/ 0 h 1859149"/>
                    <a:gd name="connsiteX38" fmla="*/ 1141565 w 1289611"/>
                    <a:gd name="connsiteY38" fmla="*/ 26126 h 1859149"/>
                    <a:gd name="connsiteX39" fmla="*/ 1124148 w 1289611"/>
                    <a:gd name="connsiteY39" fmla="*/ 87086 h 1859149"/>
                    <a:gd name="connsiteX40" fmla="*/ 1115440 w 1289611"/>
                    <a:gd name="connsiteY40" fmla="*/ 113211 h 1859149"/>
                    <a:gd name="connsiteX41" fmla="*/ 1124148 w 1289611"/>
                    <a:gd name="connsiteY41" fmla="*/ 191589 h 1859149"/>
                    <a:gd name="connsiteX42" fmla="*/ 1132857 w 1289611"/>
                    <a:gd name="connsiteY42" fmla="*/ 243840 h 1859149"/>
                    <a:gd name="connsiteX43" fmla="*/ 1141565 w 1289611"/>
                    <a:gd name="connsiteY43" fmla="*/ 322217 h 1859149"/>
                    <a:gd name="connsiteX44" fmla="*/ 1132857 w 1289611"/>
                    <a:gd name="connsiteY44" fmla="*/ 444137 h 1859149"/>
                    <a:gd name="connsiteX45" fmla="*/ 1089314 w 1289611"/>
                    <a:gd name="connsiteY45" fmla="*/ 435429 h 1859149"/>
                    <a:gd name="connsiteX46" fmla="*/ 1080605 w 1289611"/>
                    <a:gd name="connsiteY46" fmla="*/ 409303 h 1859149"/>
                    <a:gd name="connsiteX47" fmla="*/ 1063188 w 1289611"/>
                    <a:gd name="connsiteY47" fmla="*/ 374469 h 1859149"/>
                    <a:gd name="connsiteX48" fmla="*/ 1045771 w 1289611"/>
                    <a:gd name="connsiteY48" fmla="*/ 322217 h 1859149"/>
                    <a:gd name="connsiteX49" fmla="*/ 1037063 w 1289611"/>
                    <a:gd name="connsiteY49" fmla="*/ 252549 h 1859149"/>
                    <a:gd name="connsiteX50" fmla="*/ 1028354 w 1289611"/>
                    <a:gd name="connsiteY50" fmla="*/ 156754 h 1859149"/>
                    <a:gd name="connsiteX51" fmla="*/ 1019645 w 1289611"/>
                    <a:gd name="connsiteY51" fmla="*/ 130629 h 1859149"/>
                    <a:gd name="connsiteX52" fmla="*/ 967394 w 1289611"/>
                    <a:gd name="connsiteY52" fmla="*/ 113211 h 1859149"/>
                    <a:gd name="connsiteX53" fmla="*/ 949977 w 1289611"/>
                    <a:gd name="connsiteY53" fmla="*/ 165463 h 1859149"/>
                    <a:gd name="connsiteX54" fmla="*/ 941268 w 1289611"/>
                    <a:gd name="connsiteY54" fmla="*/ 191589 h 1859149"/>
                    <a:gd name="connsiteX55" fmla="*/ 949977 w 1289611"/>
                    <a:gd name="connsiteY55" fmla="*/ 313509 h 1859149"/>
                    <a:gd name="connsiteX56" fmla="*/ 958685 w 1289611"/>
                    <a:gd name="connsiteY56" fmla="*/ 339634 h 1859149"/>
                    <a:gd name="connsiteX57" fmla="*/ 967394 w 1289611"/>
                    <a:gd name="connsiteY57" fmla="*/ 374469 h 1859149"/>
                    <a:gd name="connsiteX58" fmla="*/ 958685 w 1289611"/>
                    <a:gd name="connsiteY58" fmla="*/ 461554 h 1859149"/>
                    <a:gd name="connsiteX59" fmla="*/ 932560 w 1289611"/>
                    <a:gd name="connsiteY59" fmla="*/ 452846 h 1859149"/>
                    <a:gd name="connsiteX60" fmla="*/ 915143 w 1289611"/>
                    <a:gd name="connsiteY60" fmla="*/ 426720 h 1859149"/>
                    <a:gd name="connsiteX61" fmla="*/ 906434 w 1289611"/>
                    <a:gd name="connsiteY61" fmla="*/ 383177 h 1859149"/>
                    <a:gd name="connsiteX62" fmla="*/ 889017 w 1289611"/>
                    <a:gd name="connsiteY62" fmla="*/ 313509 h 1859149"/>
                    <a:gd name="connsiteX63" fmla="*/ 871600 w 1289611"/>
                    <a:gd name="connsiteY63" fmla="*/ 191589 h 1859149"/>
                    <a:gd name="connsiteX64" fmla="*/ 862891 w 1289611"/>
                    <a:gd name="connsiteY64" fmla="*/ 156754 h 1859149"/>
                    <a:gd name="connsiteX65" fmla="*/ 810640 w 1289611"/>
                    <a:gd name="connsiteY65" fmla="*/ 121920 h 1859149"/>
                    <a:gd name="connsiteX66" fmla="*/ 784514 w 1289611"/>
                    <a:gd name="connsiteY66" fmla="*/ 104503 h 1859149"/>
                    <a:gd name="connsiteX67" fmla="*/ 767097 w 1289611"/>
                    <a:gd name="connsiteY67" fmla="*/ 156754 h 1859149"/>
                    <a:gd name="connsiteX68" fmla="*/ 784514 w 1289611"/>
                    <a:gd name="connsiteY68" fmla="*/ 330926 h 1859149"/>
                    <a:gd name="connsiteX69" fmla="*/ 749680 w 1289611"/>
                    <a:gd name="connsiteY69" fmla="*/ 452846 h 1859149"/>
                    <a:gd name="connsiteX70" fmla="*/ 723554 w 1289611"/>
                    <a:gd name="connsiteY70" fmla="*/ 444137 h 1859149"/>
                    <a:gd name="connsiteX71" fmla="*/ 697428 w 1289611"/>
                    <a:gd name="connsiteY71" fmla="*/ 365760 h 1859149"/>
                    <a:gd name="connsiteX72" fmla="*/ 688720 w 1289611"/>
                    <a:gd name="connsiteY72" fmla="*/ 339634 h 1859149"/>
                    <a:gd name="connsiteX73" fmla="*/ 688720 w 1289611"/>
                    <a:gd name="connsiteY73" fmla="*/ 104503 h 1859149"/>
                    <a:gd name="connsiteX74" fmla="*/ 662594 w 1289611"/>
                    <a:gd name="connsiteY74" fmla="*/ 87086 h 1859149"/>
                    <a:gd name="connsiteX75" fmla="*/ 601634 w 1289611"/>
                    <a:gd name="connsiteY75" fmla="*/ 156754 h 1859149"/>
                    <a:gd name="connsiteX76" fmla="*/ 584217 w 1289611"/>
                    <a:gd name="connsiteY76" fmla="*/ 209006 h 1859149"/>
                    <a:gd name="connsiteX77" fmla="*/ 592925 w 1289611"/>
                    <a:gd name="connsiteY77" fmla="*/ 365760 h 1859149"/>
                    <a:gd name="connsiteX78" fmla="*/ 584217 w 1289611"/>
                    <a:gd name="connsiteY78" fmla="*/ 452846 h 1859149"/>
                    <a:gd name="connsiteX79" fmla="*/ 566800 w 1289611"/>
                    <a:gd name="connsiteY79" fmla="*/ 400594 h 1859149"/>
                    <a:gd name="connsiteX80" fmla="*/ 549383 w 1289611"/>
                    <a:gd name="connsiteY80" fmla="*/ 348343 h 1859149"/>
                    <a:gd name="connsiteX81" fmla="*/ 540674 w 1289611"/>
                    <a:gd name="connsiteY81" fmla="*/ 322217 h 1859149"/>
                    <a:gd name="connsiteX82" fmla="*/ 505840 w 1289611"/>
                    <a:gd name="connsiteY82" fmla="*/ 269966 h 1859149"/>
                    <a:gd name="connsiteX83" fmla="*/ 505840 w 1289611"/>
                    <a:gd name="connsiteY83" fmla="*/ 8709 h 1859149"/>
                    <a:gd name="connsiteX84" fmla="*/ 479714 w 1289611"/>
                    <a:gd name="connsiteY84" fmla="*/ 0 h 1859149"/>
                    <a:gd name="connsiteX85" fmla="*/ 453588 w 1289611"/>
                    <a:gd name="connsiteY85" fmla="*/ 8709 h 1859149"/>
                    <a:gd name="connsiteX86" fmla="*/ 444880 w 1289611"/>
                    <a:gd name="connsiteY86" fmla="*/ 34834 h 1859149"/>
                    <a:gd name="connsiteX87" fmla="*/ 410045 w 1289611"/>
                    <a:gd name="connsiteY87" fmla="*/ 78377 h 1859149"/>
                    <a:gd name="connsiteX88" fmla="*/ 410045 w 1289611"/>
                    <a:gd name="connsiteY88" fmla="*/ 243840 h 1859149"/>
                    <a:gd name="connsiteX89" fmla="*/ 418754 w 1289611"/>
                    <a:gd name="connsiteY89" fmla="*/ 296091 h 1859149"/>
                    <a:gd name="connsiteX90" fmla="*/ 427463 w 1289611"/>
                    <a:gd name="connsiteY90" fmla="*/ 374469 h 1859149"/>
                    <a:gd name="connsiteX91" fmla="*/ 418754 w 1289611"/>
                    <a:gd name="connsiteY91" fmla="*/ 461554 h 1859149"/>
                    <a:gd name="connsiteX92" fmla="*/ 349085 w 1289611"/>
                    <a:gd name="connsiteY92" fmla="*/ 426720 h 1859149"/>
                    <a:gd name="connsiteX93" fmla="*/ 331668 w 1289611"/>
                    <a:gd name="connsiteY93" fmla="*/ 374469 h 1859149"/>
                    <a:gd name="connsiteX94" fmla="*/ 322960 w 1289611"/>
                    <a:gd name="connsiteY94" fmla="*/ 165463 h 1859149"/>
                    <a:gd name="connsiteX95" fmla="*/ 314251 w 1289611"/>
                    <a:gd name="connsiteY95" fmla="*/ 139337 h 1859149"/>
                    <a:gd name="connsiteX96" fmla="*/ 296834 w 1289611"/>
                    <a:gd name="connsiteY96" fmla="*/ 113211 h 1859149"/>
                    <a:gd name="connsiteX97" fmla="*/ 270708 w 1289611"/>
                    <a:gd name="connsiteY97" fmla="*/ 95794 h 1859149"/>
                    <a:gd name="connsiteX98" fmla="*/ 235874 w 1289611"/>
                    <a:gd name="connsiteY98" fmla="*/ 104503 h 1859149"/>
                    <a:gd name="connsiteX99" fmla="*/ 209748 w 1289611"/>
                    <a:gd name="connsiteY99" fmla="*/ 156754 h 1859149"/>
                    <a:gd name="connsiteX100" fmla="*/ 218457 w 1289611"/>
                    <a:gd name="connsiteY100" fmla="*/ 278674 h 1859149"/>
                    <a:gd name="connsiteX101" fmla="*/ 227165 w 1289611"/>
                    <a:gd name="connsiteY101" fmla="*/ 313509 h 1859149"/>
                    <a:gd name="connsiteX102" fmla="*/ 235874 w 1289611"/>
                    <a:gd name="connsiteY102" fmla="*/ 357051 h 1859149"/>
                    <a:gd name="connsiteX103" fmla="*/ 201040 w 1289611"/>
                    <a:gd name="connsiteY103" fmla="*/ 487680 h 1859149"/>
                    <a:gd name="connsiteX104" fmla="*/ 174914 w 1289611"/>
                    <a:gd name="connsiteY104" fmla="*/ 478971 h 1859149"/>
                    <a:gd name="connsiteX105" fmla="*/ 157497 w 1289611"/>
                    <a:gd name="connsiteY105" fmla="*/ 452846 h 1859149"/>
                    <a:gd name="connsiteX106" fmla="*/ 140080 w 1289611"/>
                    <a:gd name="connsiteY106" fmla="*/ 400594 h 1859149"/>
                    <a:gd name="connsiteX107" fmla="*/ 131371 w 1289611"/>
                    <a:gd name="connsiteY107" fmla="*/ 200297 h 1859149"/>
                    <a:gd name="connsiteX108" fmla="*/ 157497 w 1289611"/>
                    <a:gd name="connsiteY108" fmla="*/ 174171 h 1859149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  <a:cxn ang="0">
                      <a:pos x="connsiteX40" y="connsiteY40"/>
                    </a:cxn>
                    <a:cxn ang="0">
                      <a:pos x="connsiteX41" y="connsiteY41"/>
                    </a:cxn>
                    <a:cxn ang="0">
                      <a:pos x="connsiteX42" y="connsiteY42"/>
                    </a:cxn>
                    <a:cxn ang="0">
                      <a:pos x="connsiteX43" y="connsiteY43"/>
                    </a:cxn>
                    <a:cxn ang="0">
                      <a:pos x="connsiteX44" y="connsiteY44"/>
                    </a:cxn>
                    <a:cxn ang="0">
                      <a:pos x="connsiteX45" y="connsiteY45"/>
                    </a:cxn>
                    <a:cxn ang="0">
                      <a:pos x="connsiteX46" y="connsiteY46"/>
                    </a:cxn>
                    <a:cxn ang="0">
                      <a:pos x="connsiteX47" y="connsiteY47"/>
                    </a:cxn>
                    <a:cxn ang="0">
                      <a:pos x="connsiteX48" y="connsiteY48"/>
                    </a:cxn>
                    <a:cxn ang="0">
                      <a:pos x="connsiteX49" y="connsiteY49"/>
                    </a:cxn>
                    <a:cxn ang="0">
                      <a:pos x="connsiteX50" y="connsiteY50"/>
                    </a:cxn>
                    <a:cxn ang="0">
                      <a:pos x="connsiteX51" y="connsiteY51"/>
                    </a:cxn>
                    <a:cxn ang="0">
                      <a:pos x="connsiteX52" y="connsiteY52"/>
                    </a:cxn>
                    <a:cxn ang="0">
                      <a:pos x="connsiteX53" y="connsiteY53"/>
                    </a:cxn>
                    <a:cxn ang="0">
                      <a:pos x="connsiteX54" y="connsiteY54"/>
                    </a:cxn>
                    <a:cxn ang="0">
                      <a:pos x="connsiteX55" y="connsiteY55"/>
                    </a:cxn>
                    <a:cxn ang="0">
                      <a:pos x="connsiteX56" y="connsiteY56"/>
                    </a:cxn>
                    <a:cxn ang="0">
                      <a:pos x="connsiteX57" y="connsiteY57"/>
                    </a:cxn>
                    <a:cxn ang="0">
                      <a:pos x="connsiteX58" y="connsiteY58"/>
                    </a:cxn>
                    <a:cxn ang="0">
                      <a:pos x="connsiteX59" y="connsiteY59"/>
                    </a:cxn>
                    <a:cxn ang="0">
                      <a:pos x="connsiteX60" y="connsiteY60"/>
                    </a:cxn>
                    <a:cxn ang="0">
                      <a:pos x="connsiteX61" y="connsiteY61"/>
                    </a:cxn>
                    <a:cxn ang="0">
                      <a:pos x="connsiteX62" y="connsiteY62"/>
                    </a:cxn>
                    <a:cxn ang="0">
                      <a:pos x="connsiteX63" y="connsiteY63"/>
                    </a:cxn>
                    <a:cxn ang="0">
                      <a:pos x="connsiteX64" y="connsiteY64"/>
                    </a:cxn>
                    <a:cxn ang="0">
                      <a:pos x="connsiteX65" y="connsiteY65"/>
                    </a:cxn>
                    <a:cxn ang="0">
                      <a:pos x="connsiteX66" y="connsiteY66"/>
                    </a:cxn>
                    <a:cxn ang="0">
                      <a:pos x="connsiteX67" y="connsiteY67"/>
                    </a:cxn>
                    <a:cxn ang="0">
                      <a:pos x="connsiteX68" y="connsiteY68"/>
                    </a:cxn>
                    <a:cxn ang="0">
                      <a:pos x="connsiteX69" y="connsiteY69"/>
                    </a:cxn>
                    <a:cxn ang="0">
                      <a:pos x="connsiteX70" y="connsiteY70"/>
                    </a:cxn>
                    <a:cxn ang="0">
                      <a:pos x="connsiteX71" y="connsiteY71"/>
                    </a:cxn>
                    <a:cxn ang="0">
                      <a:pos x="connsiteX72" y="connsiteY72"/>
                    </a:cxn>
                    <a:cxn ang="0">
                      <a:pos x="connsiteX73" y="connsiteY73"/>
                    </a:cxn>
                    <a:cxn ang="0">
                      <a:pos x="connsiteX74" y="connsiteY74"/>
                    </a:cxn>
                    <a:cxn ang="0">
                      <a:pos x="connsiteX75" y="connsiteY75"/>
                    </a:cxn>
                    <a:cxn ang="0">
                      <a:pos x="connsiteX76" y="connsiteY76"/>
                    </a:cxn>
                    <a:cxn ang="0">
                      <a:pos x="connsiteX77" y="connsiteY77"/>
                    </a:cxn>
                    <a:cxn ang="0">
                      <a:pos x="connsiteX78" y="connsiteY78"/>
                    </a:cxn>
                    <a:cxn ang="0">
                      <a:pos x="connsiteX79" y="connsiteY79"/>
                    </a:cxn>
                    <a:cxn ang="0">
                      <a:pos x="connsiteX80" y="connsiteY80"/>
                    </a:cxn>
                    <a:cxn ang="0">
                      <a:pos x="connsiteX81" y="connsiteY81"/>
                    </a:cxn>
                    <a:cxn ang="0">
                      <a:pos x="connsiteX82" y="connsiteY82"/>
                    </a:cxn>
                    <a:cxn ang="0">
                      <a:pos x="connsiteX83" y="connsiteY83"/>
                    </a:cxn>
                    <a:cxn ang="0">
                      <a:pos x="connsiteX84" y="connsiteY84"/>
                    </a:cxn>
                    <a:cxn ang="0">
                      <a:pos x="connsiteX85" y="connsiteY85"/>
                    </a:cxn>
                    <a:cxn ang="0">
                      <a:pos x="connsiteX86" y="connsiteY86"/>
                    </a:cxn>
                    <a:cxn ang="0">
                      <a:pos x="connsiteX87" y="connsiteY87"/>
                    </a:cxn>
                    <a:cxn ang="0">
                      <a:pos x="connsiteX88" y="connsiteY88"/>
                    </a:cxn>
                    <a:cxn ang="0">
                      <a:pos x="connsiteX89" y="connsiteY89"/>
                    </a:cxn>
                    <a:cxn ang="0">
                      <a:pos x="connsiteX90" y="connsiteY90"/>
                    </a:cxn>
                    <a:cxn ang="0">
                      <a:pos x="connsiteX91" y="connsiteY91"/>
                    </a:cxn>
                    <a:cxn ang="0">
                      <a:pos x="connsiteX92" y="connsiteY92"/>
                    </a:cxn>
                    <a:cxn ang="0">
                      <a:pos x="connsiteX93" y="connsiteY93"/>
                    </a:cxn>
                    <a:cxn ang="0">
                      <a:pos x="connsiteX94" y="connsiteY94"/>
                    </a:cxn>
                    <a:cxn ang="0">
                      <a:pos x="connsiteX95" y="connsiteY95"/>
                    </a:cxn>
                    <a:cxn ang="0">
                      <a:pos x="connsiteX96" y="connsiteY96"/>
                    </a:cxn>
                    <a:cxn ang="0">
                      <a:pos x="connsiteX97" y="connsiteY97"/>
                    </a:cxn>
                    <a:cxn ang="0">
                      <a:pos x="connsiteX98" y="connsiteY98"/>
                    </a:cxn>
                    <a:cxn ang="0">
                      <a:pos x="connsiteX99" y="connsiteY99"/>
                    </a:cxn>
                    <a:cxn ang="0">
                      <a:pos x="connsiteX100" y="connsiteY100"/>
                    </a:cxn>
                    <a:cxn ang="0">
                      <a:pos x="connsiteX101" y="connsiteY101"/>
                    </a:cxn>
                    <a:cxn ang="0">
                      <a:pos x="connsiteX102" y="connsiteY102"/>
                    </a:cxn>
                    <a:cxn ang="0">
                      <a:pos x="connsiteX103" y="connsiteY103"/>
                    </a:cxn>
                    <a:cxn ang="0">
                      <a:pos x="connsiteX104" y="connsiteY104"/>
                    </a:cxn>
                    <a:cxn ang="0">
                      <a:pos x="connsiteX105" y="connsiteY105"/>
                    </a:cxn>
                    <a:cxn ang="0">
                      <a:pos x="connsiteX106" y="connsiteY106"/>
                    </a:cxn>
                    <a:cxn ang="0">
                      <a:pos x="connsiteX107" y="connsiteY107"/>
                    </a:cxn>
                    <a:cxn ang="0">
                      <a:pos x="connsiteX108" y="connsiteY108"/>
                    </a:cxn>
                  </a:cxnLst>
                  <a:rect l="l" t="t" r="r" b="b"/>
                  <a:pathLst>
                    <a:path w="1289611" h="1859149">
                      <a:moveTo>
                        <a:pt x="157497" y="174171"/>
                      </a:moveTo>
                      <a:cubicBezTo>
                        <a:pt x="142983" y="166914"/>
                        <a:pt x="109336" y="133099"/>
                        <a:pt x="44285" y="156754"/>
                      </a:cubicBezTo>
                      <a:cubicBezTo>
                        <a:pt x="32711" y="160963"/>
                        <a:pt x="26868" y="174171"/>
                        <a:pt x="18160" y="182880"/>
                      </a:cubicBezTo>
                      <a:cubicBezTo>
                        <a:pt x="-14822" y="281823"/>
                        <a:pt x="4588" y="213403"/>
                        <a:pt x="18160" y="444137"/>
                      </a:cubicBezTo>
                      <a:cubicBezTo>
                        <a:pt x="19365" y="464628"/>
                        <a:pt x="24826" y="484673"/>
                        <a:pt x="26868" y="505097"/>
                      </a:cubicBezTo>
                      <a:cubicBezTo>
                        <a:pt x="30634" y="542758"/>
                        <a:pt x="31811" y="580648"/>
                        <a:pt x="35577" y="618309"/>
                      </a:cubicBezTo>
                      <a:cubicBezTo>
                        <a:pt x="37619" y="638733"/>
                        <a:pt x="41739" y="658901"/>
                        <a:pt x="44285" y="679269"/>
                      </a:cubicBezTo>
                      <a:cubicBezTo>
                        <a:pt x="47545" y="705352"/>
                        <a:pt x="50091" y="731520"/>
                        <a:pt x="52994" y="757646"/>
                      </a:cubicBezTo>
                      <a:cubicBezTo>
                        <a:pt x="50091" y="809897"/>
                        <a:pt x="48631" y="862249"/>
                        <a:pt x="44285" y="914400"/>
                      </a:cubicBezTo>
                      <a:cubicBezTo>
                        <a:pt x="42819" y="931996"/>
                        <a:pt x="37334" y="949081"/>
                        <a:pt x="35577" y="966651"/>
                      </a:cubicBezTo>
                      <a:cubicBezTo>
                        <a:pt x="28170" y="1040721"/>
                        <a:pt x="23407" y="1165779"/>
                        <a:pt x="18160" y="1236617"/>
                      </a:cubicBezTo>
                      <a:cubicBezTo>
                        <a:pt x="16005" y="1265711"/>
                        <a:pt x="12354" y="1294674"/>
                        <a:pt x="9451" y="1323703"/>
                      </a:cubicBezTo>
                      <a:cubicBezTo>
                        <a:pt x="12354" y="1396274"/>
                        <a:pt x="13163" y="1468960"/>
                        <a:pt x="18160" y="1541417"/>
                      </a:cubicBezTo>
                      <a:cubicBezTo>
                        <a:pt x="18983" y="1553357"/>
                        <a:pt x="24272" y="1564567"/>
                        <a:pt x="26868" y="1576251"/>
                      </a:cubicBezTo>
                      <a:cubicBezTo>
                        <a:pt x="30079" y="1590700"/>
                        <a:pt x="31682" y="1605514"/>
                        <a:pt x="35577" y="1619794"/>
                      </a:cubicBezTo>
                      <a:cubicBezTo>
                        <a:pt x="35589" y="1619837"/>
                        <a:pt x="57342" y="1685087"/>
                        <a:pt x="61703" y="1698171"/>
                      </a:cubicBezTo>
                      <a:cubicBezTo>
                        <a:pt x="72654" y="1731024"/>
                        <a:pt x="75298" y="1746604"/>
                        <a:pt x="105245" y="1776549"/>
                      </a:cubicBezTo>
                      <a:cubicBezTo>
                        <a:pt x="111051" y="1782355"/>
                        <a:pt x="115319" y="1790294"/>
                        <a:pt x="122663" y="1793966"/>
                      </a:cubicBezTo>
                      <a:cubicBezTo>
                        <a:pt x="139084" y="1802176"/>
                        <a:pt x="157497" y="1805577"/>
                        <a:pt x="174914" y="1811383"/>
                      </a:cubicBezTo>
                      <a:lnTo>
                        <a:pt x="201040" y="1820091"/>
                      </a:lnTo>
                      <a:cubicBezTo>
                        <a:pt x="265824" y="1841686"/>
                        <a:pt x="217981" y="1828144"/>
                        <a:pt x="349085" y="1837509"/>
                      </a:cubicBezTo>
                      <a:cubicBezTo>
                        <a:pt x="586588" y="1877090"/>
                        <a:pt x="424407" y="1853272"/>
                        <a:pt x="976103" y="1837509"/>
                      </a:cubicBezTo>
                      <a:cubicBezTo>
                        <a:pt x="988067" y="1837167"/>
                        <a:pt x="999201" y="1831147"/>
                        <a:pt x="1010937" y="1828800"/>
                      </a:cubicBezTo>
                      <a:cubicBezTo>
                        <a:pt x="1028251" y="1825337"/>
                        <a:pt x="1045951" y="1823921"/>
                        <a:pt x="1063188" y="1820091"/>
                      </a:cubicBezTo>
                      <a:cubicBezTo>
                        <a:pt x="1072149" y="1818100"/>
                        <a:pt x="1080488" y="1813905"/>
                        <a:pt x="1089314" y="1811383"/>
                      </a:cubicBezTo>
                      <a:cubicBezTo>
                        <a:pt x="1165859" y="1789513"/>
                        <a:pt x="1087633" y="1814845"/>
                        <a:pt x="1150274" y="1793966"/>
                      </a:cubicBezTo>
                      <a:cubicBezTo>
                        <a:pt x="1158983" y="1788160"/>
                        <a:pt x="1167039" y="1781230"/>
                        <a:pt x="1176400" y="1776549"/>
                      </a:cubicBezTo>
                      <a:cubicBezTo>
                        <a:pt x="1184610" y="1772444"/>
                        <a:pt x="1196034" y="1774331"/>
                        <a:pt x="1202525" y="1767840"/>
                      </a:cubicBezTo>
                      <a:cubicBezTo>
                        <a:pt x="1217327" y="1753038"/>
                        <a:pt x="1222559" y="1730391"/>
                        <a:pt x="1237360" y="1715589"/>
                      </a:cubicBezTo>
                      <a:lnTo>
                        <a:pt x="1254777" y="1698171"/>
                      </a:lnTo>
                      <a:cubicBezTo>
                        <a:pt x="1279595" y="1623717"/>
                        <a:pt x="1269917" y="1664137"/>
                        <a:pt x="1280903" y="1576251"/>
                      </a:cubicBezTo>
                      <a:cubicBezTo>
                        <a:pt x="1283806" y="1500777"/>
                        <a:pt x="1289611" y="1425359"/>
                        <a:pt x="1289611" y="1349829"/>
                      </a:cubicBezTo>
                      <a:cubicBezTo>
                        <a:pt x="1289611" y="1216266"/>
                        <a:pt x="1284371" y="1082752"/>
                        <a:pt x="1280903" y="949234"/>
                      </a:cubicBezTo>
                      <a:cubicBezTo>
                        <a:pt x="1274097" y="687216"/>
                        <a:pt x="1276051" y="740980"/>
                        <a:pt x="1263485" y="539931"/>
                      </a:cubicBezTo>
                      <a:cubicBezTo>
                        <a:pt x="1259188" y="376634"/>
                        <a:pt x="1267398" y="277986"/>
                        <a:pt x="1246068" y="139337"/>
                      </a:cubicBezTo>
                      <a:cubicBezTo>
                        <a:pt x="1239034" y="93614"/>
                        <a:pt x="1235499" y="90211"/>
                        <a:pt x="1219943" y="43543"/>
                      </a:cubicBezTo>
                      <a:cubicBezTo>
                        <a:pt x="1217040" y="34834"/>
                        <a:pt x="1219943" y="20320"/>
                        <a:pt x="1211234" y="17417"/>
                      </a:cubicBezTo>
                      <a:lnTo>
                        <a:pt x="1158983" y="0"/>
                      </a:lnTo>
                      <a:cubicBezTo>
                        <a:pt x="1153177" y="8709"/>
                        <a:pt x="1146246" y="16764"/>
                        <a:pt x="1141565" y="26126"/>
                      </a:cubicBezTo>
                      <a:cubicBezTo>
                        <a:pt x="1134607" y="40042"/>
                        <a:pt x="1127866" y="74071"/>
                        <a:pt x="1124148" y="87086"/>
                      </a:cubicBezTo>
                      <a:cubicBezTo>
                        <a:pt x="1121626" y="95912"/>
                        <a:pt x="1118343" y="104503"/>
                        <a:pt x="1115440" y="113211"/>
                      </a:cubicBezTo>
                      <a:cubicBezTo>
                        <a:pt x="1118343" y="139337"/>
                        <a:pt x="1120674" y="165533"/>
                        <a:pt x="1124148" y="191589"/>
                      </a:cubicBezTo>
                      <a:cubicBezTo>
                        <a:pt x="1126482" y="209091"/>
                        <a:pt x="1130523" y="226338"/>
                        <a:pt x="1132857" y="243840"/>
                      </a:cubicBezTo>
                      <a:cubicBezTo>
                        <a:pt x="1136331" y="269896"/>
                        <a:pt x="1138662" y="296091"/>
                        <a:pt x="1141565" y="322217"/>
                      </a:cubicBezTo>
                      <a:cubicBezTo>
                        <a:pt x="1138662" y="362857"/>
                        <a:pt x="1149931" y="407143"/>
                        <a:pt x="1132857" y="444137"/>
                      </a:cubicBezTo>
                      <a:cubicBezTo>
                        <a:pt x="1126654" y="457576"/>
                        <a:pt x="1101630" y="443639"/>
                        <a:pt x="1089314" y="435429"/>
                      </a:cubicBezTo>
                      <a:cubicBezTo>
                        <a:pt x="1081676" y="430337"/>
                        <a:pt x="1084221" y="417741"/>
                        <a:pt x="1080605" y="409303"/>
                      </a:cubicBezTo>
                      <a:cubicBezTo>
                        <a:pt x="1075491" y="397371"/>
                        <a:pt x="1068009" y="386522"/>
                        <a:pt x="1063188" y="374469"/>
                      </a:cubicBezTo>
                      <a:cubicBezTo>
                        <a:pt x="1056370" y="357423"/>
                        <a:pt x="1045771" y="322217"/>
                        <a:pt x="1045771" y="322217"/>
                      </a:cubicBezTo>
                      <a:cubicBezTo>
                        <a:pt x="1042868" y="298994"/>
                        <a:pt x="1039513" y="275824"/>
                        <a:pt x="1037063" y="252549"/>
                      </a:cubicBezTo>
                      <a:cubicBezTo>
                        <a:pt x="1033706" y="220662"/>
                        <a:pt x="1032889" y="188495"/>
                        <a:pt x="1028354" y="156754"/>
                      </a:cubicBezTo>
                      <a:cubicBezTo>
                        <a:pt x="1027056" y="147667"/>
                        <a:pt x="1027115" y="135964"/>
                        <a:pt x="1019645" y="130629"/>
                      </a:cubicBezTo>
                      <a:cubicBezTo>
                        <a:pt x="1004705" y="119958"/>
                        <a:pt x="967394" y="113211"/>
                        <a:pt x="967394" y="113211"/>
                      </a:cubicBezTo>
                      <a:lnTo>
                        <a:pt x="949977" y="165463"/>
                      </a:lnTo>
                      <a:lnTo>
                        <a:pt x="941268" y="191589"/>
                      </a:lnTo>
                      <a:cubicBezTo>
                        <a:pt x="944171" y="232229"/>
                        <a:pt x="945216" y="273045"/>
                        <a:pt x="949977" y="313509"/>
                      </a:cubicBezTo>
                      <a:cubicBezTo>
                        <a:pt x="951050" y="322625"/>
                        <a:pt x="956163" y="330808"/>
                        <a:pt x="958685" y="339634"/>
                      </a:cubicBezTo>
                      <a:cubicBezTo>
                        <a:pt x="961973" y="351143"/>
                        <a:pt x="964491" y="362857"/>
                        <a:pt x="967394" y="374469"/>
                      </a:cubicBezTo>
                      <a:cubicBezTo>
                        <a:pt x="964491" y="403497"/>
                        <a:pt x="970533" y="434895"/>
                        <a:pt x="958685" y="461554"/>
                      </a:cubicBezTo>
                      <a:cubicBezTo>
                        <a:pt x="954957" y="469942"/>
                        <a:pt x="939728" y="458580"/>
                        <a:pt x="932560" y="452846"/>
                      </a:cubicBezTo>
                      <a:cubicBezTo>
                        <a:pt x="924387" y="446308"/>
                        <a:pt x="920949" y="435429"/>
                        <a:pt x="915143" y="426720"/>
                      </a:cubicBezTo>
                      <a:cubicBezTo>
                        <a:pt x="912240" y="412206"/>
                        <a:pt x="909762" y="397600"/>
                        <a:pt x="906434" y="383177"/>
                      </a:cubicBezTo>
                      <a:cubicBezTo>
                        <a:pt x="901051" y="359853"/>
                        <a:pt x="889017" y="313509"/>
                        <a:pt x="889017" y="313509"/>
                      </a:cubicBezTo>
                      <a:cubicBezTo>
                        <a:pt x="881410" y="245051"/>
                        <a:pt x="883922" y="247038"/>
                        <a:pt x="871600" y="191589"/>
                      </a:cubicBezTo>
                      <a:cubicBezTo>
                        <a:pt x="869004" y="179905"/>
                        <a:pt x="870773" y="165762"/>
                        <a:pt x="862891" y="156754"/>
                      </a:cubicBezTo>
                      <a:cubicBezTo>
                        <a:pt x="849107" y="141001"/>
                        <a:pt x="828057" y="133531"/>
                        <a:pt x="810640" y="121920"/>
                      </a:cubicBezTo>
                      <a:lnTo>
                        <a:pt x="784514" y="104503"/>
                      </a:lnTo>
                      <a:cubicBezTo>
                        <a:pt x="778708" y="121920"/>
                        <a:pt x="765952" y="138431"/>
                        <a:pt x="767097" y="156754"/>
                      </a:cubicBezTo>
                      <a:cubicBezTo>
                        <a:pt x="776552" y="308037"/>
                        <a:pt x="764518" y="250944"/>
                        <a:pt x="784514" y="330926"/>
                      </a:cubicBezTo>
                      <a:cubicBezTo>
                        <a:pt x="782728" y="352362"/>
                        <a:pt x="802556" y="444034"/>
                        <a:pt x="749680" y="452846"/>
                      </a:cubicBezTo>
                      <a:cubicBezTo>
                        <a:pt x="740625" y="454355"/>
                        <a:pt x="732263" y="447040"/>
                        <a:pt x="723554" y="444137"/>
                      </a:cubicBezTo>
                      <a:lnTo>
                        <a:pt x="697428" y="365760"/>
                      </a:lnTo>
                      <a:lnTo>
                        <a:pt x="688720" y="339634"/>
                      </a:lnTo>
                      <a:cubicBezTo>
                        <a:pt x="691878" y="289110"/>
                        <a:pt x="706843" y="163403"/>
                        <a:pt x="688720" y="104503"/>
                      </a:cubicBezTo>
                      <a:cubicBezTo>
                        <a:pt x="685642" y="94499"/>
                        <a:pt x="671303" y="92892"/>
                        <a:pt x="662594" y="87086"/>
                      </a:cubicBezTo>
                      <a:cubicBezTo>
                        <a:pt x="632114" y="107406"/>
                        <a:pt x="616148" y="113211"/>
                        <a:pt x="601634" y="156754"/>
                      </a:cubicBezTo>
                      <a:lnTo>
                        <a:pt x="584217" y="209006"/>
                      </a:lnTo>
                      <a:cubicBezTo>
                        <a:pt x="587120" y="261257"/>
                        <a:pt x="592925" y="313428"/>
                        <a:pt x="592925" y="365760"/>
                      </a:cubicBezTo>
                      <a:cubicBezTo>
                        <a:pt x="592925" y="394933"/>
                        <a:pt x="601721" y="429507"/>
                        <a:pt x="584217" y="452846"/>
                      </a:cubicBezTo>
                      <a:cubicBezTo>
                        <a:pt x="573201" y="467534"/>
                        <a:pt x="572606" y="418011"/>
                        <a:pt x="566800" y="400594"/>
                      </a:cubicBezTo>
                      <a:lnTo>
                        <a:pt x="549383" y="348343"/>
                      </a:lnTo>
                      <a:cubicBezTo>
                        <a:pt x="546480" y="339634"/>
                        <a:pt x="545766" y="329855"/>
                        <a:pt x="540674" y="322217"/>
                      </a:cubicBezTo>
                      <a:lnTo>
                        <a:pt x="505840" y="269966"/>
                      </a:lnTo>
                      <a:cubicBezTo>
                        <a:pt x="506802" y="250719"/>
                        <a:pt x="524950" y="61262"/>
                        <a:pt x="505840" y="8709"/>
                      </a:cubicBezTo>
                      <a:cubicBezTo>
                        <a:pt x="502703" y="82"/>
                        <a:pt x="488423" y="2903"/>
                        <a:pt x="479714" y="0"/>
                      </a:cubicBezTo>
                      <a:cubicBezTo>
                        <a:pt x="471005" y="2903"/>
                        <a:pt x="460079" y="2218"/>
                        <a:pt x="453588" y="8709"/>
                      </a:cubicBezTo>
                      <a:cubicBezTo>
                        <a:pt x="447097" y="15200"/>
                        <a:pt x="448985" y="26624"/>
                        <a:pt x="444880" y="34834"/>
                      </a:cubicBezTo>
                      <a:cubicBezTo>
                        <a:pt x="433893" y="56808"/>
                        <a:pt x="426247" y="62176"/>
                        <a:pt x="410045" y="78377"/>
                      </a:cubicBezTo>
                      <a:cubicBezTo>
                        <a:pt x="387276" y="146690"/>
                        <a:pt x="397449" y="105287"/>
                        <a:pt x="410045" y="243840"/>
                      </a:cubicBezTo>
                      <a:cubicBezTo>
                        <a:pt x="411644" y="261425"/>
                        <a:pt x="416420" y="278589"/>
                        <a:pt x="418754" y="296091"/>
                      </a:cubicBezTo>
                      <a:cubicBezTo>
                        <a:pt x="422228" y="322147"/>
                        <a:pt x="424560" y="348343"/>
                        <a:pt x="427463" y="374469"/>
                      </a:cubicBezTo>
                      <a:cubicBezTo>
                        <a:pt x="424560" y="403497"/>
                        <a:pt x="436665" y="438526"/>
                        <a:pt x="418754" y="461554"/>
                      </a:cubicBezTo>
                      <a:cubicBezTo>
                        <a:pt x="388804" y="500061"/>
                        <a:pt x="356959" y="438530"/>
                        <a:pt x="349085" y="426720"/>
                      </a:cubicBezTo>
                      <a:cubicBezTo>
                        <a:pt x="343279" y="409303"/>
                        <a:pt x="332432" y="392812"/>
                        <a:pt x="331668" y="374469"/>
                      </a:cubicBezTo>
                      <a:cubicBezTo>
                        <a:pt x="328765" y="304800"/>
                        <a:pt x="328111" y="235002"/>
                        <a:pt x="322960" y="165463"/>
                      </a:cubicBezTo>
                      <a:cubicBezTo>
                        <a:pt x="322282" y="156308"/>
                        <a:pt x="318356" y="147548"/>
                        <a:pt x="314251" y="139337"/>
                      </a:cubicBezTo>
                      <a:cubicBezTo>
                        <a:pt x="309570" y="129976"/>
                        <a:pt x="304235" y="120612"/>
                        <a:pt x="296834" y="113211"/>
                      </a:cubicBezTo>
                      <a:cubicBezTo>
                        <a:pt x="289433" y="105810"/>
                        <a:pt x="279417" y="101600"/>
                        <a:pt x="270708" y="95794"/>
                      </a:cubicBezTo>
                      <a:cubicBezTo>
                        <a:pt x="259097" y="98697"/>
                        <a:pt x="245832" y="97864"/>
                        <a:pt x="235874" y="104503"/>
                      </a:cubicBezTo>
                      <a:cubicBezTo>
                        <a:pt x="221405" y="114149"/>
                        <a:pt x="214716" y="141852"/>
                        <a:pt x="209748" y="156754"/>
                      </a:cubicBezTo>
                      <a:cubicBezTo>
                        <a:pt x="212651" y="197394"/>
                        <a:pt x="213958" y="238180"/>
                        <a:pt x="218457" y="278674"/>
                      </a:cubicBezTo>
                      <a:cubicBezTo>
                        <a:pt x="219779" y="290570"/>
                        <a:pt x="224569" y="301825"/>
                        <a:pt x="227165" y="313509"/>
                      </a:cubicBezTo>
                      <a:cubicBezTo>
                        <a:pt x="230376" y="327958"/>
                        <a:pt x="232971" y="342537"/>
                        <a:pt x="235874" y="357051"/>
                      </a:cubicBezTo>
                      <a:cubicBezTo>
                        <a:pt x="233357" y="392280"/>
                        <a:pt x="264275" y="487680"/>
                        <a:pt x="201040" y="487680"/>
                      </a:cubicBezTo>
                      <a:cubicBezTo>
                        <a:pt x="191860" y="487680"/>
                        <a:pt x="183623" y="481874"/>
                        <a:pt x="174914" y="478971"/>
                      </a:cubicBezTo>
                      <a:cubicBezTo>
                        <a:pt x="169108" y="470263"/>
                        <a:pt x="161748" y="462410"/>
                        <a:pt x="157497" y="452846"/>
                      </a:cubicBezTo>
                      <a:cubicBezTo>
                        <a:pt x="150041" y="436069"/>
                        <a:pt x="140080" y="400594"/>
                        <a:pt x="140080" y="400594"/>
                      </a:cubicBezTo>
                      <a:cubicBezTo>
                        <a:pt x="137177" y="333828"/>
                        <a:pt x="139031" y="266685"/>
                        <a:pt x="131371" y="200297"/>
                      </a:cubicBezTo>
                      <a:cubicBezTo>
                        <a:pt x="130171" y="189900"/>
                        <a:pt x="172011" y="181428"/>
                        <a:pt x="157497" y="174171"/>
                      </a:cubicBezTo>
                      <a:close/>
                    </a:path>
                  </a:pathLst>
                </a:custGeom>
                <a:solidFill>
                  <a:srgbClr val="B3C7E7"/>
                </a:solidFill>
                <a:ln>
                  <a:solidFill>
                    <a:srgbClr val="2F5597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33" name="Freeform 32">
                  <a:extLst>
                    <a:ext uri="{FF2B5EF4-FFF2-40B4-BE49-F238E27FC236}">
                      <a16:creationId xmlns:a16="http://schemas.microsoft.com/office/drawing/2014/main" id="{CB88EAA4-71AA-7444-A193-5452348A565A}"/>
                    </a:ext>
                  </a:extLst>
                </p:cNvPr>
                <p:cNvSpPr/>
                <p:nvPr/>
              </p:nvSpPr>
              <p:spPr>
                <a:xfrm>
                  <a:off x="5289050" y="2618810"/>
                  <a:ext cx="248048" cy="392533"/>
                </a:xfrm>
                <a:custGeom>
                  <a:avLst/>
                  <a:gdLst>
                    <a:gd name="connsiteX0" fmla="*/ 157497 w 1289611"/>
                    <a:gd name="connsiteY0" fmla="*/ 174171 h 1859149"/>
                    <a:gd name="connsiteX1" fmla="*/ 44285 w 1289611"/>
                    <a:gd name="connsiteY1" fmla="*/ 156754 h 1859149"/>
                    <a:gd name="connsiteX2" fmla="*/ 18160 w 1289611"/>
                    <a:gd name="connsiteY2" fmla="*/ 182880 h 1859149"/>
                    <a:gd name="connsiteX3" fmla="*/ 18160 w 1289611"/>
                    <a:gd name="connsiteY3" fmla="*/ 444137 h 1859149"/>
                    <a:gd name="connsiteX4" fmla="*/ 26868 w 1289611"/>
                    <a:gd name="connsiteY4" fmla="*/ 505097 h 1859149"/>
                    <a:gd name="connsiteX5" fmla="*/ 35577 w 1289611"/>
                    <a:gd name="connsiteY5" fmla="*/ 618309 h 1859149"/>
                    <a:gd name="connsiteX6" fmla="*/ 44285 w 1289611"/>
                    <a:gd name="connsiteY6" fmla="*/ 679269 h 1859149"/>
                    <a:gd name="connsiteX7" fmla="*/ 52994 w 1289611"/>
                    <a:gd name="connsiteY7" fmla="*/ 757646 h 1859149"/>
                    <a:gd name="connsiteX8" fmla="*/ 44285 w 1289611"/>
                    <a:gd name="connsiteY8" fmla="*/ 914400 h 1859149"/>
                    <a:gd name="connsiteX9" fmla="*/ 35577 w 1289611"/>
                    <a:gd name="connsiteY9" fmla="*/ 966651 h 1859149"/>
                    <a:gd name="connsiteX10" fmla="*/ 18160 w 1289611"/>
                    <a:gd name="connsiteY10" fmla="*/ 1236617 h 1859149"/>
                    <a:gd name="connsiteX11" fmla="*/ 9451 w 1289611"/>
                    <a:gd name="connsiteY11" fmla="*/ 1323703 h 1859149"/>
                    <a:gd name="connsiteX12" fmla="*/ 18160 w 1289611"/>
                    <a:gd name="connsiteY12" fmla="*/ 1541417 h 1859149"/>
                    <a:gd name="connsiteX13" fmla="*/ 26868 w 1289611"/>
                    <a:gd name="connsiteY13" fmla="*/ 1576251 h 1859149"/>
                    <a:gd name="connsiteX14" fmla="*/ 35577 w 1289611"/>
                    <a:gd name="connsiteY14" fmla="*/ 1619794 h 1859149"/>
                    <a:gd name="connsiteX15" fmla="*/ 61703 w 1289611"/>
                    <a:gd name="connsiteY15" fmla="*/ 1698171 h 1859149"/>
                    <a:gd name="connsiteX16" fmla="*/ 105245 w 1289611"/>
                    <a:gd name="connsiteY16" fmla="*/ 1776549 h 1859149"/>
                    <a:gd name="connsiteX17" fmla="*/ 122663 w 1289611"/>
                    <a:gd name="connsiteY17" fmla="*/ 1793966 h 1859149"/>
                    <a:gd name="connsiteX18" fmla="*/ 174914 w 1289611"/>
                    <a:gd name="connsiteY18" fmla="*/ 1811383 h 1859149"/>
                    <a:gd name="connsiteX19" fmla="*/ 201040 w 1289611"/>
                    <a:gd name="connsiteY19" fmla="*/ 1820091 h 1859149"/>
                    <a:gd name="connsiteX20" fmla="*/ 349085 w 1289611"/>
                    <a:gd name="connsiteY20" fmla="*/ 1837509 h 1859149"/>
                    <a:gd name="connsiteX21" fmla="*/ 976103 w 1289611"/>
                    <a:gd name="connsiteY21" fmla="*/ 1837509 h 1859149"/>
                    <a:gd name="connsiteX22" fmla="*/ 1010937 w 1289611"/>
                    <a:gd name="connsiteY22" fmla="*/ 1828800 h 1859149"/>
                    <a:gd name="connsiteX23" fmla="*/ 1063188 w 1289611"/>
                    <a:gd name="connsiteY23" fmla="*/ 1820091 h 1859149"/>
                    <a:gd name="connsiteX24" fmla="*/ 1089314 w 1289611"/>
                    <a:gd name="connsiteY24" fmla="*/ 1811383 h 1859149"/>
                    <a:gd name="connsiteX25" fmla="*/ 1150274 w 1289611"/>
                    <a:gd name="connsiteY25" fmla="*/ 1793966 h 1859149"/>
                    <a:gd name="connsiteX26" fmla="*/ 1176400 w 1289611"/>
                    <a:gd name="connsiteY26" fmla="*/ 1776549 h 1859149"/>
                    <a:gd name="connsiteX27" fmla="*/ 1202525 w 1289611"/>
                    <a:gd name="connsiteY27" fmla="*/ 1767840 h 1859149"/>
                    <a:gd name="connsiteX28" fmla="*/ 1237360 w 1289611"/>
                    <a:gd name="connsiteY28" fmla="*/ 1715589 h 1859149"/>
                    <a:gd name="connsiteX29" fmla="*/ 1254777 w 1289611"/>
                    <a:gd name="connsiteY29" fmla="*/ 1698171 h 1859149"/>
                    <a:gd name="connsiteX30" fmla="*/ 1280903 w 1289611"/>
                    <a:gd name="connsiteY30" fmla="*/ 1576251 h 1859149"/>
                    <a:gd name="connsiteX31" fmla="*/ 1289611 w 1289611"/>
                    <a:gd name="connsiteY31" fmla="*/ 1349829 h 1859149"/>
                    <a:gd name="connsiteX32" fmla="*/ 1280903 w 1289611"/>
                    <a:gd name="connsiteY32" fmla="*/ 949234 h 1859149"/>
                    <a:gd name="connsiteX33" fmla="*/ 1263485 w 1289611"/>
                    <a:gd name="connsiteY33" fmla="*/ 539931 h 1859149"/>
                    <a:gd name="connsiteX34" fmla="*/ 1246068 w 1289611"/>
                    <a:gd name="connsiteY34" fmla="*/ 139337 h 1859149"/>
                    <a:gd name="connsiteX35" fmla="*/ 1219943 w 1289611"/>
                    <a:gd name="connsiteY35" fmla="*/ 43543 h 1859149"/>
                    <a:gd name="connsiteX36" fmla="*/ 1211234 w 1289611"/>
                    <a:gd name="connsiteY36" fmla="*/ 17417 h 1859149"/>
                    <a:gd name="connsiteX37" fmla="*/ 1158983 w 1289611"/>
                    <a:gd name="connsiteY37" fmla="*/ 0 h 1859149"/>
                    <a:gd name="connsiteX38" fmla="*/ 1141565 w 1289611"/>
                    <a:gd name="connsiteY38" fmla="*/ 26126 h 1859149"/>
                    <a:gd name="connsiteX39" fmla="*/ 1124148 w 1289611"/>
                    <a:gd name="connsiteY39" fmla="*/ 87086 h 1859149"/>
                    <a:gd name="connsiteX40" fmla="*/ 1115440 w 1289611"/>
                    <a:gd name="connsiteY40" fmla="*/ 113211 h 1859149"/>
                    <a:gd name="connsiteX41" fmla="*/ 1124148 w 1289611"/>
                    <a:gd name="connsiteY41" fmla="*/ 191589 h 1859149"/>
                    <a:gd name="connsiteX42" fmla="*/ 1132857 w 1289611"/>
                    <a:gd name="connsiteY42" fmla="*/ 243840 h 1859149"/>
                    <a:gd name="connsiteX43" fmla="*/ 1141565 w 1289611"/>
                    <a:gd name="connsiteY43" fmla="*/ 322217 h 1859149"/>
                    <a:gd name="connsiteX44" fmla="*/ 1132857 w 1289611"/>
                    <a:gd name="connsiteY44" fmla="*/ 444137 h 1859149"/>
                    <a:gd name="connsiteX45" fmla="*/ 1089314 w 1289611"/>
                    <a:gd name="connsiteY45" fmla="*/ 435429 h 1859149"/>
                    <a:gd name="connsiteX46" fmla="*/ 1080605 w 1289611"/>
                    <a:gd name="connsiteY46" fmla="*/ 409303 h 1859149"/>
                    <a:gd name="connsiteX47" fmla="*/ 1063188 w 1289611"/>
                    <a:gd name="connsiteY47" fmla="*/ 374469 h 1859149"/>
                    <a:gd name="connsiteX48" fmla="*/ 1045771 w 1289611"/>
                    <a:gd name="connsiteY48" fmla="*/ 322217 h 1859149"/>
                    <a:gd name="connsiteX49" fmla="*/ 1037063 w 1289611"/>
                    <a:gd name="connsiteY49" fmla="*/ 252549 h 1859149"/>
                    <a:gd name="connsiteX50" fmla="*/ 1028354 w 1289611"/>
                    <a:gd name="connsiteY50" fmla="*/ 156754 h 1859149"/>
                    <a:gd name="connsiteX51" fmla="*/ 1019645 w 1289611"/>
                    <a:gd name="connsiteY51" fmla="*/ 130629 h 1859149"/>
                    <a:gd name="connsiteX52" fmla="*/ 967394 w 1289611"/>
                    <a:gd name="connsiteY52" fmla="*/ 113211 h 1859149"/>
                    <a:gd name="connsiteX53" fmla="*/ 949977 w 1289611"/>
                    <a:gd name="connsiteY53" fmla="*/ 165463 h 1859149"/>
                    <a:gd name="connsiteX54" fmla="*/ 941268 w 1289611"/>
                    <a:gd name="connsiteY54" fmla="*/ 191589 h 1859149"/>
                    <a:gd name="connsiteX55" fmla="*/ 949977 w 1289611"/>
                    <a:gd name="connsiteY55" fmla="*/ 313509 h 1859149"/>
                    <a:gd name="connsiteX56" fmla="*/ 958685 w 1289611"/>
                    <a:gd name="connsiteY56" fmla="*/ 339634 h 1859149"/>
                    <a:gd name="connsiteX57" fmla="*/ 967394 w 1289611"/>
                    <a:gd name="connsiteY57" fmla="*/ 374469 h 1859149"/>
                    <a:gd name="connsiteX58" fmla="*/ 958685 w 1289611"/>
                    <a:gd name="connsiteY58" fmla="*/ 461554 h 1859149"/>
                    <a:gd name="connsiteX59" fmla="*/ 932560 w 1289611"/>
                    <a:gd name="connsiteY59" fmla="*/ 452846 h 1859149"/>
                    <a:gd name="connsiteX60" fmla="*/ 915143 w 1289611"/>
                    <a:gd name="connsiteY60" fmla="*/ 426720 h 1859149"/>
                    <a:gd name="connsiteX61" fmla="*/ 906434 w 1289611"/>
                    <a:gd name="connsiteY61" fmla="*/ 383177 h 1859149"/>
                    <a:gd name="connsiteX62" fmla="*/ 889017 w 1289611"/>
                    <a:gd name="connsiteY62" fmla="*/ 313509 h 1859149"/>
                    <a:gd name="connsiteX63" fmla="*/ 871600 w 1289611"/>
                    <a:gd name="connsiteY63" fmla="*/ 191589 h 1859149"/>
                    <a:gd name="connsiteX64" fmla="*/ 862891 w 1289611"/>
                    <a:gd name="connsiteY64" fmla="*/ 156754 h 1859149"/>
                    <a:gd name="connsiteX65" fmla="*/ 810640 w 1289611"/>
                    <a:gd name="connsiteY65" fmla="*/ 121920 h 1859149"/>
                    <a:gd name="connsiteX66" fmla="*/ 784514 w 1289611"/>
                    <a:gd name="connsiteY66" fmla="*/ 104503 h 1859149"/>
                    <a:gd name="connsiteX67" fmla="*/ 767097 w 1289611"/>
                    <a:gd name="connsiteY67" fmla="*/ 156754 h 1859149"/>
                    <a:gd name="connsiteX68" fmla="*/ 784514 w 1289611"/>
                    <a:gd name="connsiteY68" fmla="*/ 330926 h 1859149"/>
                    <a:gd name="connsiteX69" fmla="*/ 749680 w 1289611"/>
                    <a:gd name="connsiteY69" fmla="*/ 452846 h 1859149"/>
                    <a:gd name="connsiteX70" fmla="*/ 723554 w 1289611"/>
                    <a:gd name="connsiteY70" fmla="*/ 444137 h 1859149"/>
                    <a:gd name="connsiteX71" fmla="*/ 697428 w 1289611"/>
                    <a:gd name="connsiteY71" fmla="*/ 365760 h 1859149"/>
                    <a:gd name="connsiteX72" fmla="*/ 688720 w 1289611"/>
                    <a:gd name="connsiteY72" fmla="*/ 339634 h 1859149"/>
                    <a:gd name="connsiteX73" fmla="*/ 688720 w 1289611"/>
                    <a:gd name="connsiteY73" fmla="*/ 104503 h 1859149"/>
                    <a:gd name="connsiteX74" fmla="*/ 662594 w 1289611"/>
                    <a:gd name="connsiteY74" fmla="*/ 87086 h 1859149"/>
                    <a:gd name="connsiteX75" fmla="*/ 601634 w 1289611"/>
                    <a:gd name="connsiteY75" fmla="*/ 156754 h 1859149"/>
                    <a:gd name="connsiteX76" fmla="*/ 584217 w 1289611"/>
                    <a:gd name="connsiteY76" fmla="*/ 209006 h 1859149"/>
                    <a:gd name="connsiteX77" fmla="*/ 592925 w 1289611"/>
                    <a:gd name="connsiteY77" fmla="*/ 365760 h 1859149"/>
                    <a:gd name="connsiteX78" fmla="*/ 584217 w 1289611"/>
                    <a:gd name="connsiteY78" fmla="*/ 452846 h 1859149"/>
                    <a:gd name="connsiteX79" fmla="*/ 566800 w 1289611"/>
                    <a:gd name="connsiteY79" fmla="*/ 400594 h 1859149"/>
                    <a:gd name="connsiteX80" fmla="*/ 549383 w 1289611"/>
                    <a:gd name="connsiteY80" fmla="*/ 348343 h 1859149"/>
                    <a:gd name="connsiteX81" fmla="*/ 540674 w 1289611"/>
                    <a:gd name="connsiteY81" fmla="*/ 322217 h 1859149"/>
                    <a:gd name="connsiteX82" fmla="*/ 505840 w 1289611"/>
                    <a:gd name="connsiteY82" fmla="*/ 269966 h 1859149"/>
                    <a:gd name="connsiteX83" fmla="*/ 505840 w 1289611"/>
                    <a:gd name="connsiteY83" fmla="*/ 8709 h 1859149"/>
                    <a:gd name="connsiteX84" fmla="*/ 479714 w 1289611"/>
                    <a:gd name="connsiteY84" fmla="*/ 0 h 1859149"/>
                    <a:gd name="connsiteX85" fmla="*/ 453588 w 1289611"/>
                    <a:gd name="connsiteY85" fmla="*/ 8709 h 1859149"/>
                    <a:gd name="connsiteX86" fmla="*/ 444880 w 1289611"/>
                    <a:gd name="connsiteY86" fmla="*/ 34834 h 1859149"/>
                    <a:gd name="connsiteX87" fmla="*/ 410045 w 1289611"/>
                    <a:gd name="connsiteY87" fmla="*/ 78377 h 1859149"/>
                    <a:gd name="connsiteX88" fmla="*/ 410045 w 1289611"/>
                    <a:gd name="connsiteY88" fmla="*/ 243840 h 1859149"/>
                    <a:gd name="connsiteX89" fmla="*/ 418754 w 1289611"/>
                    <a:gd name="connsiteY89" fmla="*/ 296091 h 1859149"/>
                    <a:gd name="connsiteX90" fmla="*/ 427463 w 1289611"/>
                    <a:gd name="connsiteY90" fmla="*/ 374469 h 1859149"/>
                    <a:gd name="connsiteX91" fmla="*/ 418754 w 1289611"/>
                    <a:gd name="connsiteY91" fmla="*/ 461554 h 1859149"/>
                    <a:gd name="connsiteX92" fmla="*/ 349085 w 1289611"/>
                    <a:gd name="connsiteY92" fmla="*/ 426720 h 1859149"/>
                    <a:gd name="connsiteX93" fmla="*/ 331668 w 1289611"/>
                    <a:gd name="connsiteY93" fmla="*/ 374469 h 1859149"/>
                    <a:gd name="connsiteX94" fmla="*/ 322960 w 1289611"/>
                    <a:gd name="connsiteY94" fmla="*/ 165463 h 1859149"/>
                    <a:gd name="connsiteX95" fmla="*/ 314251 w 1289611"/>
                    <a:gd name="connsiteY95" fmla="*/ 139337 h 1859149"/>
                    <a:gd name="connsiteX96" fmla="*/ 296834 w 1289611"/>
                    <a:gd name="connsiteY96" fmla="*/ 113211 h 1859149"/>
                    <a:gd name="connsiteX97" fmla="*/ 270708 w 1289611"/>
                    <a:gd name="connsiteY97" fmla="*/ 95794 h 1859149"/>
                    <a:gd name="connsiteX98" fmla="*/ 235874 w 1289611"/>
                    <a:gd name="connsiteY98" fmla="*/ 104503 h 1859149"/>
                    <a:gd name="connsiteX99" fmla="*/ 209748 w 1289611"/>
                    <a:gd name="connsiteY99" fmla="*/ 156754 h 1859149"/>
                    <a:gd name="connsiteX100" fmla="*/ 218457 w 1289611"/>
                    <a:gd name="connsiteY100" fmla="*/ 278674 h 1859149"/>
                    <a:gd name="connsiteX101" fmla="*/ 227165 w 1289611"/>
                    <a:gd name="connsiteY101" fmla="*/ 313509 h 1859149"/>
                    <a:gd name="connsiteX102" fmla="*/ 235874 w 1289611"/>
                    <a:gd name="connsiteY102" fmla="*/ 357051 h 1859149"/>
                    <a:gd name="connsiteX103" fmla="*/ 201040 w 1289611"/>
                    <a:gd name="connsiteY103" fmla="*/ 487680 h 1859149"/>
                    <a:gd name="connsiteX104" fmla="*/ 174914 w 1289611"/>
                    <a:gd name="connsiteY104" fmla="*/ 478971 h 1859149"/>
                    <a:gd name="connsiteX105" fmla="*/ 157497 w 1289611"/>
                    <a:gd name="connsiteY105" fmla="*/ 452846 h 1859149"/>
                    <a:gd name="connsiteX106" fmla="*/ 140080 w 1289611"/>
                    <a:gd name="connsiteY106" fmla="*/ 400594 h 1859149"/>
                    <a:gd name="connsiteX107" fmla="*/ 131371 w 1289611"/>
                    <a:gd name="connsiteY107" fmla="*/ 200297 h 1859149"/>
                    <a:gd name="connsiteX108" fmla="*/ 157497 w 1289611"/>
                    <a:gd name="connsiteY108" fmla="*/ 174171 h 1859149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  <a:cxn ang="0">
                      <a:pos x="connsiteX40" y="connsiteY40"/>
                    </a:cxn>
                    <a:cxn ang="0">
                      <a:pos x="connsiteX41" y="connsiteY41"/>
                    </a:cxn>
                    <a:cxn ang="0">
                      <a:pos x="connsiteX42" y="connsiteY42"/>
                    </a:cxn>
                    <a:cxn ang="0">
                      <a:pos x="connsiteX43" y="connsiteY43"/>
                    </a:cxn>
                    <a:cxn ang="0">
                      <a:pos x="connsiteX44" y="connsiteY44"/>
                    </a:cxn>
                    <a:cxn ang="0">
                      <a:pos x="connsiteX45" y="connsiteY45"/>
                    </a:cxn>
                    <a:cxn ang="0">
                      <a:pos x="connsiteX46" y="connsiteY46"/>
                    </a:cxn>
                    <a:cxn ang="0">
                      <a:pos x="connsiteX47" y="connsiteY47"/>
                    </a:cxn>
                    <a:cxn ang="0">
                      <a:pos x="connsiteX48" y="connsiteY48"/>
                    </a:cxn>
                    <a:cxn ang="0">
                      <a:pos x="connsiteX49" y="connsiteY49"/>
                    </a:cxn>
                    <a:cxn ang="0">
                      <a:pos x="connsiteX50" y="connsiteY50"/>
                    </a:cxn>
                    <a:cxn ang="0">
                      <a:pos x="connsiteX51" y="connsiteY51"/>
                    </a:cxn>
                    <a:cxn ang="0">
                      <a:pos x="connsiteX52" y="connsiteY52"/>
                    </a:cxn>
                    <a:cxn ang="0">
                      <a:pos x="connsiteX53" y="connsiteY53"/>
                    </a:cxn>
                    <a:cxn ang="0">
                      <a:pos x="connsiteX54" y="connsiteY54"/>
                    </a:cxn>
                    <a:cxn ang="0">
                      <a:pos x="connsiteX55" y="connsiteY55"/>
                    </a:cxn>
                    <a:cxn ang="0">
                      <a:pos x="connsiteX56" y="connsiteY56"/>
                    </a:cxn>
                    <a:cxn ang="0">
                      <a:pos x="connsiteX57" y="connsiteY57"/>
                    </a:cxn>
                    <a:cxn ang="0">
                      <a:pos x="connsiteX58" y="connsiteY58"/>
                    </a:cxn>
                    <a:cxn ang="0">
                      <a:pos x="connsiteX59" y="connsiteY59"/>
                    </a:cxn>
                    <a:cxn ang="0">
                      <a:pos x="connsiteX60" y="connsiteY60"/>
                    </a:cxn>
                    <a:cxn ang="0">
                      <a:pos x="connsiteX61" y="connsiteY61"/>
                    </a:cxn>
                    <a:cxn ang="0">
                      <a:pos x="connsiteX62" y="connsiteY62"/>
                    </a:cxn>
                    <a:cxn ang="0">
                      <a:pos x="connsiteX63" y="connsiteY63"/>
                    </a:cxn>
                    <a:cxn ang="0">
                      <a:pos x="connsiteX64" y="connsiteY64"/>
                    </a:cxn>
                    <a:cxn ang="0">
                      <a:pos x="connsiteX65" y="connsiteY65"/>
                    </a:cxn>
                    <a:cxn ang="0">
                      <a:pos x="connsiteX66" y="connsiteY66"/>
                    </a:cxn>
                    <a:cxn ang="0">
                      <a:pos x="connsiteX67" y="connsiteY67"/>
                    </a:cxn>
                    <a:cxn ang="0">
                      <a:pos x="connsiteX68" y="connsiteY68"/>
                    </a:cxn>
                    <a:cxn ang="0">
                      <a:pos x="connsiteX69" y="connsiteY69"/>
                    </a:cxn>
                    <a:cxn ang="0">
                      <a:pos x="connsiteX70" y="connsiteY70"/>
                    </a:cxn>
                    <a:cxn ang="0">
                      <a:pos x="connsiteX71" y="connsiteY71"/>
                    </a:cxn>
                    <a:cxn ang="0">
                      <a:pos x="connsiteX72" y="connsiteY72"/>
                    </a:cxn>
                    <a:cxn ang="0">
                      <a:pos x="connsiteX73" y="connsiteY73"/>
                    </a:cxn>
                    <a:cxn ang="0">
                      <a:pos x="connsiteX74" y="connsiteY74"/>
                    </a:cxn>
                    <a:cxn ang="0">
                      <a:pos x="connsiteX75" y="connsiteY75"/>
                    </a:cxn>
                    <a:cxn ang="0">
                      <a:pos x="connsiteX76" y="connsiteY76"/>
                    </a:cxn>
                    <a:cxn ang="0">
                      <a:pos x="connsiteX77" y="connsiteY77"/>
                    </a:cxn>
                    <a:cxn ang="0">
                      <a:pos x="connsiteX78" y="connsiteY78"/>
                    </a:cxn>
                    <a:cxn ang="0">
                      <a:pos x="connsiteX79" y="connsiteY79"/>
                    </a:cxn>
                    <a:cxn ang="0">
                      <a:pos x="connsiteX80" y="connsiteY80"/>
                    </a:cxn>
                    <a:cxn ang="0">
                      <a:pos x="connsiteX81" y="connsiteY81"/>
                    </a:cxn>
                    <a:cxn ang="0">
                      <a:pos x="connsiteX82" y="connsiteY82"/>
                    </a:cxn>
                    <a:cxn ang="0">
                      <a:pos x="connsiteX83" y="connsiteY83"/>
                    </a:cxn>
                    <a:cxn ang="0">
                      <a:pos x="connsiteX84" y="connsiteY84"/>
                    </a:cxn>
                    <a:cxn ang="0">
                      <a:pos x="connsiteX85" y="connsiteY85"/>
                    </a:cxn>
                    <a:cxn ang="0">
                      <a:pos x="connsiteX86" y="connsiteY86"/>
                    </a:cxn>
                    <a:cxn ang="0">
                      <a:pos x="connsiteX87" y="connsiteY87"/>
                    </a:cxn>
                    <a:cxn ang="0">
                      <a:pos x="connsiteX88" y="connsiteY88"/>
                    </a:cxn>
                    <a:cxn ang="0">
                      <a:pos x="connsiteX89" y="connsiteY89"/>
                    </a:cxn>
                    <a:cxn ang="0">
                      <a:pos x="connsiteX90" y="connsiteY90"/>
                    </a:cxn>
                    <a:cxn ang="0">
                      <a:pos x="connsiteX91" y="connsiteY91"/>
                    </a:cxn>
                    <a:cxn ang="0">
                      <a:pos x="connsiteX92" y="connsiteY92"/>
                    </a:cxn>
                    <a:cxn ang="0">
                      <a:pos x="connsiteX93" y="connsiteY93"/>
                    </a:cxn>
                    <a:cxn ang="0">
                      <a:pos x="connsiteX94" y="connsiteY94"/>
                    </a:cxn>
                    <a:cxn ang="0">
                      <a:pos x="connsiteX95" y="connsiteY95"/>
                    </a:cxn>
                    <a:cxn ang="0">
                      <a:pos x="connsiteX96" y="connsiteY96"/>
                    </a:cxn>
                    <a:cxn ang="0">
                      <a:pos x="connsiteX97" y="connsiteY97"/>
                    </a:cxn>
                    <a:cxn ang="0">
                      <a:pos x="connsiteX98" y="connsiteY98"/>
                    </a:cxn>
                    <a:cxn ang="0">
                      <a:pos x="connsiteX99" y="connsiteY99"/>
                    </a:cxn>
                    <a:cxn ang="0">
                      <a:pos x="connsiteX100" y="connsiteY100"/>
                    </a:cxn>
                    <a:cxn ang="0">
                      <a:pos x="connsiteX101" y="connsiteY101"/>
                    </a:cxn>
                    <a:cxn ang="0">
                      <a:pos x="connsiteX102" y="connsiteY102"/>
                    </a:cxn>
                    <a:cxn ang="0">
                      <a:pos x="connsiteX103" y="connsiteY103"/>
                    </a:cxn>
                    <a:cxn ang="0">
                      <a:pos x="connsiteX104" y="connsiteY104"/>
                    </a:cxn>
                    <a:cxn ang="0">
                      <a:pos x="connsiteX105" y="connsiteY105"/>
                    </a:cxn>
                    <a:cxn ang="0">
                      <a:pos x="connsiteX106" y="connsiteY106"/>
                    </a:cxn>
                    <a:cxn ang="0">
                      <a:pos x="connsiteX107" y="connsiteY107"/>
                    </a:cxn>
                    <a:cxn ang="0">
                      <a:pos x="connsiteX108" y="connsiteY108"/>
                    </a:cxn>
                  </a:cxnLst>
                  <a:rect l="l" t="t" r="r" b="b"/>
                  <a:pathLst>
                    <a:path w="1289611" h="1859149">
                      <a:moveTo>
                        <a:pt x="157497" y="174171"/>
                      </a:moveTo>
                      <a:cubicBezTo>
                        <a:pt x="142983" y="166914"/>
                        <a:pt x="109336" y="133099"/>
                        <a:pt x="44285" y="156754"/>
                      </a:cubicBezTo>
                      <a:cubicBezTo>
                        <a:pt x="32711" y="160963"/>
                        <a:pt x="26868" y="174171"/>
                        <a:pt x="18160" y="182880"/>
                      </a:cubicBezTo>
                      <a:cubicBezTo>
                        <a:pt x="-14822" y="281823"/>
                        <a:pt x="4588" y="213403"/>
                        <a:pt x="18160" y="444137"/>
                      </a:cubicBezTo>
                      <a:cubicBezTo>
                        <a:pt x="19365" y="464628"/>
                        <a:pt x="24826" y="484673"/>
                        <a:pt x="26868" y="505097"/>
                      </a:cubicBezTo>
                      <a:cubicBezTo>
                        <a:pt x="30634" y="542758"/>
                        <a:pt x="31811" y="580648"/>
                        <a:pt x="35577" y="618309"/>
                      </a:cubicBezTo>
                      <a:cubicBezTo>
                        <a:pt x="37619" y="638733"/>
                        <a:pt x="41739" y="658901"/>
                        <a:pt x="44285" y="679269"/>
                      </a:cubicBezTo>
                      <a:cubicBezTo>
                        <a:pt x="47545" y="705352"/>
                        <a:pt x="50091" y="731520"/>
                        <a:pt x="52994" y="757646"/>
                      </a:cubicBezTo>
                      <a:cubicBezTo>
                        <a:pt x="50091" y="809897"/>
                        <a:pt x="48631" y="862249"/>
                        <a:pt x="44285" y="914400"/>
                      </a:cubicBezTo>
                      <a:cubicBezTo>
                        <a:pt x="42819" y="931996"/>
                        <a:pt x="37334" y="949081"/>
                        <a:pt x="35577" y="966651"/>
                      </a:cubicBezTo>
                      <a:cubicBezTo>
                        <a:pt x="28170" y="1040721"/>
                        <a:pt x="23407" y="1165779"/>
                        <a:pt x="18160" y="1236617"/>
                      </a:cubicBezTo>
                      <a:cubicBezTo>
                        <a:pt x="16005" y="1265711"/>
                        <a:pt x="12354" y="1294674"/>
                        <a:pt x="9451" y="1323703"/>
                      </a:cubicBezTo>
                      <a:cubicBezTo>
                        <a:pt x="12354" y="1396274"/>
                        <a:pt x="13163" y="1468960"/>
                        <a:pt x="18160" y="1541417"/>
                      </a:cubicBezTo>
                      <a:cubicBezTo>
                        <a:pt x="18983" y="1553357"/>
                        <a:pt x="24272" y="1564567"/>
                        <a:pt x="26868" y="1576251"/>
                      </a:cubicBezTo>
                      <a:cubicBezTo>
                        <a:pt x="30079" y="1590700"/>
                        <a:pt x="31682" y="1605514"/>
                        <a:pt x="35577" y="1619794"/>
                      </a:cubicBezTo>
                      <a:cubicBezTo>
                        <a:pt x="35589" y="1619837"/>
                        <a:pt x="57342" y="1685087"/>
                        <a:pt x="61703" y="1698171"/>
                      </a:cubicBezTo>
                      <a:cubicBezTo>
                        <a:pt x="72654" y="1731024"/>
                        <a:pt x="75298" y="1746604"/>
                        <a:pt x="105245" y="1776549"/>
                      </a:cubicBezTo>
                      <a:cubicBezTo>
                        <a:pt x="111051" y="1782355"/>
                        <a:pt x="115319" y="1790294"/>
                        <a:pt x="122663" y="1793966"/>
                      </a:cubicBezTo>
                      <a:cubicBezTo>
                        <a:pt x="139084" y="1802176"/>
                        <a:pt x="157497" y="1805577"/>
                        <a:pt x="174914" y="1811383"/>
                      </a:cubicBezTo>
                      <a:lnTo>
                        <a:pt x="201040" y="1820091"/>
                      </a:lnTo>
                      <a:cubicBezTo>
                        <a:pt x="265824" y="1841686"/>
                        <a:pt x="217981" y="1828144"/>
                        <a:pt x="349085" y="1837509"/>
                      </a:cubicBezTo>
                      <a:cubicBezTo>
                        <a:pt x="586588" y="1877090"/>
                        <a:pt x="424407" y="1853272"/>
                        <a:pt x="976103" y="1837509"/>
                      </a:cubicBezTo>
                      <a:cubicBezTo>
                        <a:pt x="988067" y="1837167"/>
                        <a:pt x="999201" y="1831147"/>
                        <a:pt x="1010937" y="1828800"/>
                      </a:cubicBezTo>
                      <a:cubicBezTo>
                        <a:pt x="1028251" y="1825337"/>
                        <a:pt x="1045951" y="1823921"/>
                        <a:pt x="1063188" y="1820091"/>
                      </a:cubicBezTo>
                      <a:cubicBezTo>
                        <a:pt x="1072149" y="1818100"/>
                        <a:pt x="1080488" y="1813905"/>
                        <a:pt x="1089314" y="1811383"/>
                      </a:cubicBezTo>
                      <a:cubicBezTo>
                        <a:pt x="1165859" y="1789513"/>
                        <a:pt x="1087633" y="1814845"/>
                        <a:pt x="1150274" y="1793966"/>
                      </a:cubicBezTo>
                      <a:cubicBezTo>
                        <a:pt x="1158983" y="1788160"/>
                        <a:pt x="1167039" y="1781230"/>
                        <a:pt x="1176400" y="1776549"/>
                      </a:cubicBezTo>
                      <a:cubicBezTo>
                        <a:pt x="1184610" y="1772444"/>
                        <a:pt x="1196034" y="1774331"/>
                        <a:pt x="1202525" y="1767840"/>
                      </a:cubicBezTo>
                      <a:cubicBezTo>
                        <a:pt x="1217327" y="1753038"/>
                        <a:pt x="1222559" y="1730391"/>
                        <a:pt x="1237360" y="1715589"/>
                      </a:cubicBezTo>
                      <a:lnTo>
                        <a:pt x="1254777" y="1698171"/>
                      </a:lnTo>
                      <a:cubicBezTo>
                        <a:pt x="1279595" y="1623717"/>
                        <a:pt x="1269917" y="1664137"/>
                        <a:pt x="1280903" y="1576251"/>
                      </a:cubicBezTo>
                      <a:cubicBezTo>
                        <a:pt x="1283806" y="1500777"/>
                        <a:pt x="1289611" y="1425359"/>
                        <a:pt x="1289611" y="1349829"/>
                      </a:cubicBezTo>
                      <a:cubicBezTo>
                        <a:pt x="1289611" y="1216266"/>
                        <a:pt x="1284371" y="1082752"/>
                        <a:pt x="1280903" y="949234"/>
                      </a:cubicBezTo>
                      <a:cubicBezTo>
                        <a:pt x="1274097" y="687216"/>
                        <a:pt x="1276051" y="740980"/>
                        <a:pt x="1263485" y="539931"/>
                      </a:cubicBezTo>
                      <a:cubicBezTo>
                        <a:pt x="1259188" y="376634"/>
                        <a:pt x="1267398" y="277986"/>
                        <a:pt x="1246068" y="139337"/>
                      </a:cubicBezTo>
                      <a:cubicBezTo>
                        <a:pt x="1239034" y="93614"/>
                        <a:pt x="1235499" y="90211"/>
                        <a:pt x="1219943" y="43543"/>
                      </a:cubicBezTo>
                      <a:cubicBezTo>
                        <a:pt x="1217040" y="34834"/>
                        <a:pt x="1219943" y="20320"/>
                        <a:pt x="1211234" y="17417"/>
                      </a:cubicBezTo>
                      <a:lnTo>
                        <a:pt x="1158983" y="0"/>
                      </a:lnTo>
                      <a:cubicBezTo>
                        <a:pt x="1153177" y="8709"/>
                        <a:pt x="1146246" y="16764"/>
                        <a:pt x="1141565" y="26126"/>
                      </a:cubicBezTo>
                      <a:cubicBezTo>
                        <a:pt x="1134607" y="40042"/>
                        <a:pt x="1127866" y="74071"/>
                        <a:pt x="1124148" y="87086"/>
                      </a:cubicBezTo>
                      <a:cubicBezTo>
                        <a:pt x="1121626" y="95912"/>
                        <a:pt x="1118343" y="104503"/>
                        <a:pt x="1115440" y="113211"/>
                      </a:cubicBezTo>
                      <a:cubicBezTo>
                        <a:pt x="1118343" y="139337"/>
                        <a:pt x="1120674" y="165533"/>
                        <a:pt x="1124148" y="191589"/>
                      </a:cubicBezTo>
                      <a:cubicBezTo>
                        <a:pt x="1126482" y="209091"/>
                        <a:pt x="1130523" y="226338"/>
                        <a:pt x="1132857" y="243840"/>
                      </a:cubicBezTo>
                      <a:cubicBezTo>
                        <a:pt x="1136331" y="269896"/>
                        <a:pt x="1138662" y="296091"/>
                        <a:pt x="1141565" y="322217"/>
                      </a:cubicBezTo>
                      <a:cubicBezTo>
                        <a:pt x="1138662" y="362857"/>
                        <a:pt x="1149931" y="407143"/>
                        <a:pt x="1132857" y="444137"/>
                      </a:cubicBezTo>
                      <a:cubicBezTo>
                        <a:pt x="1126654" y="457576"/>
                        <a:pt x="1101630" y="443639"/>
                        <a:pt x="1089314" y="435429"/>
                      </a:cubicBezTo>
                      <a:cubicBezTo>
                        <a:pt x="1081676" y="430337"/>
                        <a:pt x="1084221" y="417741"/>
                        <a:pt x="1080605" y="409303"/>
                      </a:cubicBezTo>
                      <a:cubicBezTo>
                        <a:pt x="1075491" y="397371"/>
                        <a:pt x="1068009" y="386522"/>
                        <a:pt x="1063188" y="374469"/>
                      </a:cubicBezTo>
                      <a:cubicBezTo>
                        <a:pt x="1056370" y="357423"/>
                        <a:pt x="1045771" y="322217"/>
                        <a:pt x="1045771" y="322217"/>
                      </a:cubicBezTo>
                      <a:cubicBezTo>
                        <a:pt x="1042868" y="298994"/>
                        <a:pt x="1039513" y="275824"/>
                        <a:pt x="1037063" y="252549"/>
                      </a:cubicBezTo>
                      <a:cubicBezTo>
                        <a:pt x="1033706" y="220662"/>
                        <a:pt x="1032889" y="188495"/>
                        <a:pt x="1028354" y="156754"/>
                      </a:cubicBezTo>
                      <a:cubicBezTo>
                        <a:pt x="1027056" y="147667"/>
                        <a:pt x="1027115" y="135964"/>
                        <a:pt x="1019645" y="130629"/>
                      </a:cubicBezTo>
                      <a:cubicBezTo>
                        <a:pt x="1004705" y="119958"/>
                        <a:pt x="967394" y="113211"/>
                        <a:pt x="967394" y="113211"/>
                      </a:cubicBezTo>
                      <a:lnTo>
                        <a:pt x="949977" y="165463"/>
                      </a:lnTo>
                      <a:lnTo>
                        <a:pt x="941268" y="191589"/>
                      </a:lnTo>
                      <a:cubicBezTo>
                        <a:pt x="944171" y="232229"/>
                        <a:pt x="945216" y="273045"/>
                        <a:pt x="949977" y="313509"/>
                      </a:cubicBezTo>
                      <a:cubicBezTo>
                        <a:pt x="951050" y="322625"/>
                        <a:pt x="956163" y="330808"/>
                        <a:pt x="958685" y="339634"/>
                      </a:cubicBezTo>
                      <a:cubicBezTo>
                        <a:pt x="961973" y="351143"/>
                        <a:pt x="964491" y="362857"/>
                        <a:pt x="967394" y="374469"/>
                      </a:cubicBezTo>
                      <a:cubicBezTo>
                        <a:pt x="964491" y="403497"/>
                        <a:pt x="970533" y="434895"/>
                        <a:pt x="958685" y="461554"/>
                      </a:cubicBezTo>
                      <a:cubicBezTo>
                        <a:pt x="954957" y="469942"/>
                        <a:pt x="939728" y="458580"/>
                        <a:pt x="932560" y="452846"/>
                      </a:cubicBezTo>
                      <a:cubicBezTo>
                        <a:pt x="924387" y="446308"/>
                        <a:pt x="920949" y="435429"/>
                        <a:pt x="915143" y="426720"/>
                      </a:cubicBezTo>
                      <a:cubicBezTo>
                        <a:pt x="912240" y="412206"/>
                        <a:pt x="909762" y="397600"/>
                        <a:pt x="906434" y="383177"/>
                      </a:cubicBezTo>
                      <a:cubicBezTo>
                        <a:pt x="901051" y="359853"/>
                        <a:pt x="889017" y="313509"/>
                        <a:pt x="889017" y="313509"/>
                      </a:cubicBezTo>
                      <a:cubicBezTo>
                        <a:pt x="881410" y="245051"/>
                        <a:pt x="883922" y="247038"/>
                        <a:pt x="871600" y="191589"/>
                      </a:cubicBezTo>
                      <a:cubicBezTo>
                        <a:pt x="869004" y="179905"/>
                        <a:pt x="870773" y="165762"/>
                        <a:pt x="862891" y="156754"/>
                      </a:cubicBezTo>
                      <a:cubicBezTo>
                        <a:pt x="849107" y="141001"/>
                        <a:pt x="828057" y="133531"/>
                        <a:pt x="810640" y="121920"/>
                      </a:cubicBezTo>
                      <a:lnTo>
                        <a:pt x="784514" y="104503"/>
                      </a:lnTo>
                      <a:cubicBezTo>
                        <a:pt x="778708" y="121920"/>
                        <a:pt x="765952" y="138431"/>
                        <a:pt x="767097" y="156754"/>
                      </a:cubicBezTo>
                      <a:cubicBezTo>
                        <a:pt x="776552" y="308037"/>
                        <a:pt x="764518" y="250944"/>
                        <a:pt x="784514" y="330926"/>
                      </a:cubicBezTo>
                      <a:cubicBezTo>
                        <a:pt x="782728" y="352362"/>
                        <a:pt x="802556" y="444034"/>
                        <a:pt x="749680" y="452846"/>
                      </a:cubicBezTo>
                      <a:cubicBezTo>
                        <a:pt x="740625" y="454355"/>
                        <a:pt x="732263" y="447040"/>
                        <a:pt x="723554" y="444137"/>
                      </a:cubicBezTo>
                      <a:lnTo>
                        <a:pt x="697428" y="365760"/>
                      </a:lnTo>
                      <a:lnTo>
                        <a:pt x="688720" y="339634"/>
                      </a:lnTo>
                      <a:cubicBezTo>
                        <a:pt x="691878" y="289110"/>
                        <a:pt x="706843" y="163403"/>
                        <a:pt x="688720" y="104503"/>
                      </a:cubicBezTo>
                      <a:cubicBezTo>
                        <a:pt x="685642" y="94499"/>
                        <a:pt x="671303" y="92892"/>
                        <a:pt x="662594" y="87086"/>
                      </a:cubicBezTo>
                      <a:cubicBezTo>
                        <a:pt x="632114" y="107406"/>
                        <a:pt x="616148" y="113211"/>
                        <a:pt x="601634" y="156754"/>
                      </a:cubicBezTo>
                      <a:lnTo>
                        <a:pt x="584217" y="209006"/>
                      </a:lnTo>
                      <a:cubicBezTo>
                        <a:pt x="587120" y="261257"/>
                        <a:pt x="592925" y="313428"/>
                        <a:pt x="592925" y="365760"/>
                      </a:cubicBezTo>
                      <a:cubicBezTo>
                        <a:pt x="592925" y="394933"/>
                        <a:pt x="601721" y="429507"/>
                        <a:pt x="584217" y="452846"/>
                      </a:cubicBezTo>
                      <a:cubicBezTo>
                        <a:pt x="573201" y="467534"/>
                        <a:pt x="572606" y="418011"/>
                        <a:pt x="566800" y="400594"/>
                      </a:cubicBezTo>
                      <a:lnTo>
                        <a:pt x="549383" y="348343"/>
                      </a:lnTo>
                      <a:cubicBezTo>
                        <a:pt x="546480" y="339634"/>
                        <a:pt x="545766" y="329855"/>
                        <a:pt x="540674" y="322217"/>
                      </a:cubicBezTo>
                      <a:lnTo>
                        <a:pt x="505840" y="269966"/>
                      </a:lnTo>
                      <a:cubicBezTo>
                        <a:pt x="506802" y="250719"/>
                        <a:pt x="524950" y="61262"/>
                        <a:pt x="505840" y="8709"/>
                      </a:cubicBezTo>
                      <a:cubicBezTo>
                        <a:pt x="502703" y="82"/>
                        <a:pt x="488423" y="2903"/>
                        <a:pt x="479714" y="0"/>
                      </a:cubicBezTo>
                      <a:cubicBezTo>
                        <a:pt x="471005" y="2903"/>
                        <a:pt x="460079" y="2218"/>
                        <a:pt x="453588" y="8709"/>
                      </a:cubicBezTo>
                      <a:cubicBezTo>
                        <a:pt x="447097" y="15200"/>
                        <a:pt x="448985" y="26624"/>
                        <a:pt x="444880" y="34834"/>
                      </a:cubicBezTo>
                      <a:cubicBezTo>
                        <a:pt x="433893" y="56808"/>
                        <a:pt x="426247" y="62176"/>
                        <a:pt x="410045" y="78377"/>
                      </a:cubicBezTo>
                      <a:cubicBezTo>
                        <a:pt x="387276" y="146690"/>
                        <a:pt x="397449" y="105287"/>
                        <a:pt x="410045" y="243840"/>
                      </a:cubicBezTo>
                      <a:cubicBezTo>
                        <a:pt x="411644" y="261425"/>
                        <a:pt x="416420" y="278589"/>
                        <a:pt x="418754" y="296091"/>
                      </a:cubicBezTo>
                      <a:cubicBezTo>
                        <a:pt x="422228" y="322147"/>
                        <a:pt x="424560" y="348343"/>
                        <a:pt x="427463" y="374469"/>
                      </a:cubicBezTo>
                      <a:cubicBezTo>
                        <a:pt x="424560" y="403497"/>
                        <a:pt x="436665" y="438526"/>
                        <a:pt x="418754" y="461554"/>
                      </a:cubicBezTo>
                      <a:cubicBezTo>
                        <a:pt x="388804" y="500061"/>
                        <a:pt x="356959" y="438530"/>
                        <a:pt x="349085" y="426720"/>
                      </a:cubicBezTo>
                      <a:cubicBezTo>
                        <a:pt x="343279" y="409303"/>
                        <a:pt x="332432" y="392812"/>
                        <a:pt x="331668" y="374469"/>
                      </a:cubicBezTo>
                      <a:cubicBezTo>
                        <a:pt x="328765" y="304800"/>
                        <a:pt x="328111" y="235002"/>
                        <a:pt x="322960" y="165463"/>
                      </a:cubicBezTo>
                      <a:cubicBezTo>
                        <a:pt x="322282" y="156308"/>
                        <a:pt x="318356" y="147548"/>
                        <a:pt x="314251" y="139337"/>
                      </a:cubicBezTo>
                      <a:cubicBezTo>
                        <a:pt x="309570" y="129976"/>
                        <a:pt x="304235" y="120612"/>
                        <a:pt x="296834" y="113211"/>
                      </a:cubicBezTo>
                      <a:cubicBezTo>
                        <a:pt x="289433" y="105810"/>
                        <a:pt x="279417" y="101600"/>
                        <a:pt x="270708" y="95794"/>
                      </a:cubicBezTo>
                      <a:cubicBezTo>
                        <a:pt x="259097" y="98697"/>
                        <a:pt x="245832" y="97864"/>
                        <a:pt x="235874" y="104503"/>
                      </a:cubicBezTo>
                      <a:cubicBezTo>
                        <a:pt x="221405" y="114149"/>
                        <a:pt x="214716" y="141852"/>
                        <a:pt x="209748" y="156754"/>
                      </a:cubicBezTo>
                      <a:cubicBezTo>
                        <a:pt x="212651" y="197394"/>
                        <a:pt x="213958" y="238180"/>
                        <a:pt x="218457" y="278674"/>
                      </a:cubicBezTo>
                      <a:cubicBezTo>
                        <a:pt x="219779" y="290570"/>
                        <a:pt x="224569" y="301825"/>
                        <a:pt x="227165" y="313509"/>
                      </a:cubicBezTo>
                      <a:cubicBezTo>
                        <a:pt x="230376" y="327958"/>
                        <a:pt x="232971" y="342537"/>
                        <a:pt x="235874" y="357051"/>
                      </a:cubicBezTo>
                      <a:cubicBezTo>
                        <a:pt x="233357" y="392280"/>
                        <a:pt x="264275" y="487680"/>
                        <a:pt x="201040" y="487680"/>
                      </a:cubicBezTo>
                      <a:cubicBezTo>
                        <a:pt x="191860" y="487680"/>
                        <a:pt x="183623" y="481874"/>
                        <a:pt x="174914" y="478971"/>
                      </a:cubicBezTo>
                      <a:cubicBezTo>
                        <a:pt x="169108" y="470263"/>
                        <a:pt x="161748" y="462410"/>
                        <a:pt x="157497" y="452846"/>
                      </a:cubicBezTo>
                      <a:cubicBezTo>
                        <a:pt x="150041" y="436069"/>
                        <a:pt x="140080" y="400594"/>
                        <a:pt x="140080" y="400594"/>
                      </a:cubicBezTo>
                      <a:cubicBezTo>
                        <a:pt x="137177" y="333828"/>
                        <a:pt x="139031" y="266685"/>
                        <a:pt x="131371" y="200297"/>
                      </a:cubicBezTo>
                      <a:cubicBezTo>
                        <a:pt x="130171" y="189900"/>
                        <a:pt x="172011" y="181428"/>
                        <a:pt x="157497" y="174171"/>
                      </a:cubicBezTo>
                      <a:close/>
                    </a:path>
                  </a:pathLst>
                </a:custGeom>
                <a:solidFill>
                  <a:srgbClr val="B3C7E7"/>
                </a:solidFill>
                <a:ln>
                  <a:solidFill>
                    <a:srgbClr val="2F5597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34" name="Oval 33">
                  <a:extLst>
                    <a:ext uri="{FF2B5EF4-FFF2-40B4-BE49-F238E27FC236}">
                      <a16:creationId xmlns:a16="http://schemas.microsoft.com/office/drawing/2014/main" id="{71C2399D-C0E9-DF45-AF9A-11C2B985132B}"/>
                    </a:ext>
                  </a:extLst>
                </p:cNvPr>
                <p:cNvSpPr/>
                <p:nvPr/>
              </p:nvSpPr>
              <p:spPr>
                <a:xfrm>
                  <a:off x="6769204" y="2864310"/>
                  <a:ext cx="133179" cy="75493"/>
                </a:xfrm>
                <a:prstGeom prst="ellipse">
                  <a:avLst/>
                </a:prstGeom>
                <a:solidFill>
                  <a:srgbClr val="2F5597"/>
                </a:solidFill>
                <a:ln>
                  <a:solidFill>
                    <a:srgbClr val="2F5597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35" name="Oval 34">
                  <a:extLst>
                    <a:ext uri="{FF2B5EF4-FFF2-40B4-BE49-F238E27FC236}">
                      <a16:creationId xmlns:a16="http://schemas.microsoft.com/office/drawing/2014/main" id="{800CCFD6-3FE9-6D44-B04C-4DE33EAA4381}"/>
                    </a:ext>
                  </a:extLst>
                </p:cNvPr>
                <p:cNvSpPr/>
                <p:nvPr/>
              </p:nvSpPr>
              <p:spPr>
                <a:xfrm>
                  <a:off x="6286923" y="2876301"/>
                  <a:ext cx="133179" cy="75493"/>
                </a:xfrm>
                <a:prstGeom prst="ellipse">
                  <a:avLst/>
                </a:prstGeom>
                <a:solidFill>
                  <a:srgbClr val="2F5597"/>
                </a:solidFill>
                <a:ln>
                  <a:solidFill>
                    <a:srgbClr val="2F5597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36" name="Oval 35">
                  <a:extLst>
                    <a:ext uri="{FF2B5EF4-FFF2-40B4-BE49-F238E27FC236}">
                      <a16:creationId xmlns:a16="http://schemas.microsoft.com/office/drawing/2014/main" id="{A96E1CC3-50C4-0C4F-ABFB-3BB4EB49EE44}"/>
                    </a:ext>
                  </a:extLst>
                </p:cNvPr>
                <p:cNvSpPr/>
                <p:nvPr/>
              </p:nvSpPr>
              <p:spPr>
                <a:xfrm>
                  <a:off x="6032456" y="2869046"/>
                  <a:ext cx="133179" cy="75493"/>
                </a:xfrm>
                <a:prstGeom prst="ellipse">
                  <a:avLst/>
                </a:prstGeom>
                <a:solidFill>
                  <a:srgbClr val="2F5597"/>
                </a:solidFill>
                <a:ln>
                  <a:solidFill>
                    <a:srgbClr val="2F5597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37" name="Oval 36">
                  <a:extLst>
                    <a:ext uri="{FF2B5EF4-FFF2-40B4-BE49-F238E27FC236}">
                      <a16:creationId xmlns:a16="http://schemas.microsoft.com/office/drawing/2014/main" id="{D30969C7-CD47-074F-8ABC-32AEA30E9A41}"/>
                    </a:ext>
                  </a:extLst>
                </p:cNvPr>
                <p:cNvSpPr/>
                <p:nvPr/>
              </p:nvSpPr>
              <p:spPr>
                <a:xfrm>
                  <a:off x="5349159" y="2873178"/>
                  <a:ext cx="133179" cy="75493"/>
                </a:xfrm>
                <a:prstGeom prst="ellipse">
                  <a:avLst/>
                </a:prstGeom>
                <a:solidFill>
                  <a:srgbClr val="2F5597"/>
                </a:solidFill>
                <a:ln>
                  <a:solidFill>
                    <a:srgbClr val="2F5597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38" name="Oval 37">
                  <a:extLst>
                    <a:ext uri="{FF2B5EF4-FFF2-40B4-BE49-F238E27FC236}">
                      <a16:creationId xmlns:a16="http://schemas.microsoft.com/office/drawing/2014/main" id="{DE22B89C-886E-B046-A5E0-5924E846E0AC}"/>
                    </a:ext>
                  </a:extLst>
                </p:cNvPr>
                <p:cNvSpPr/>
                <p:nvPr/>
              </p:nvSpPr>
              <p:spPr>
                <a:xfrm>
                  <a:off x="6513348" y="2855425"/>
                  <a:ext cx="133179" cy="75493"/>
                </a:xfrm>
                <a:prstGeom prst="ellipse">
                  <a:avLst/>
                </a:prstGeom>
                <a:solidFill>
                  <a:srgbClr val="548234"/>
                </a:solidFill>
                <a:ln>
                  <a:solidFill>
                    <a:srgbClr val="54823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39" name="Rounded Rectangle 38">
                  <a:extLst>
                    <a:ext uri="{FF2B5EF4-FFF2-40B4-BE49-F238E27FC236}">
                      <a16:creationId xmlns:a16="http://schemas.microsoft.com/office/drawing/2014/main" id="{2E5EE8EA-8AB3-2446-8633-606EEEDD5D7B}"/>
                    </a:ext>
                  </a:extLst>
                </p:cNvPr>
                <p:cNvSpPr/>
                <p:nvPr/>
              </p:nvSpPr>
              <p:spPr>
                <a:xfrm>
                  <a:off x="5546021" y="2674836"/>
                  <a:ext cx="222422" cy="321535"/>
                </a:xfrm>
                <a:prstGeom prst="roundRect">
                  <a:avLst/>
                </a:prstGeom>
                <a:solidFill>
                  <a:srgbClr val="A9D28E"/>
                </a:solidFill>
                <a:ln>
                  <a:solidFill>
                    <a:srgbClr val="54823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40" name="Oval 39">
                  <a:extLst>
                    <a:ext uri="{FF2B5EF4-FFF2-40B4-BE49-F238E27FC236}">
                      <a16:creationId xmlns:a16="http://schemas.microsoft.com/office/drawing/2014/main" id="{4412C11D-9648-FB44-AA84-722149808A7D}"/>
                    </a:ext>
                  </a:extLst>
                </p:cNvPr>
                <p:cNvSpPr/>
                <p:nvPr/>
              </p:nvSpPr>
              <p:spPr>
                <a:xfrm>
                  <a:off x="5596686" y="2859471"/>
                  <a:ext cx="133179" cy="75493"/>
                </a:xfrm>
                <a:prstGeom prst="ellipse">
                  <a:avLst/>
                </a:prstGeom>
                <a:solidFill>
                  <a:srgbClr val="548234"/>
                </a:solidFill>
                <a:ln>
                  <a:solidFill>
                    <a:srgbClr val="54823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sp>
            <p:nvSpPr>
              <p:cNvPr id="26" name="Oval 25">
                <a:extLst>
                  <a:ext uri="{FF2B5EF4-FFF2-40B4-BE49-F238E27FC236}">
                    <a16:creationId xmlns:a16="http://schemas.microsoft.com/office/drawing/2014/main" id="{9F1813F9-4CF9-9B4C-BB98-B1587C98ECBE}"/>
                  </a:ext>
                </a:extLst>
              </p:cNvPr>
              <p:cNvSpPr/>
              <p:nvPr/>
            </p:nvSpPr>
            <p:spPr>
              <a:xfrm>
                <a:off x="3386869" y="4628258"/>
                <a:ext cx="125585" cy="87972"/>
              </a:xfrm>
              <a:prstGeom prst="ellipse">
                <a:avLst/>
              </a:prstGeom>
              <a:solidFill>
                <a:srgbClr val="2F5597"/>
              </a:solidFill>
              <a:ln>
                <a:solidFill>
                  <a:srgbClr val="2F559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7" name="Freeform 26">
                <a:extLst>
                  <a:ext uri="{FF2B5EF4-FFF2-40B4-BE49-F238E27FC236}">
                    <a16:creationId xmlns:a16="http://schemas.microsoft.com/office/drawing/2014/main" id="{E340FF7F-F6D8-5842-B195-7675AC50A862}"/>
                  </a:ext>
                </a:extLst>
              </p:cNvPr>
              <p:cNvSpPr/>
              <p:nvPr/>
            </p:nvSpPr>
            <p:spPr>
              <a:xfrm>
                <a:off x="3226353" y="4247989"/>
                <a:ext cx="251278" cy="711138"/>
              </a:xfrm>
              <a:custGeom>
                <a:avLst/>
                <a:gdLst>
                  <a:gd name="connsiteX0" fmla="*/ 76200 w 368300"/>
                  <a:gd name="connsiteY0" fmla="*/ 0 h 1028700"/>
                  <a:gd name="connsiteX1" fmla="*/ 69850 w 368300"/>
                  <a:gd name="connsiteY1" fmla="*/ 41275 h 1028700"/>
                  <a:gd name="connsiteX2" fmla="*/ 85725 w 368300"/>
                  <a:gd name="connsiteY2" fmla="*/ 66675 h 1028700"/>
                  <a:gd name="connsiteX3" fmla="*/ 114300 w 368300"/>
                  <a:gd name="connsiteY3" fmla="*/ 95250 h 1028700"/>
                  <a:gd name="connsiteX4" fmla="*/ 149225 w 368300"/>
                  <a:gd name="connsiteY4" fmla="*/ 127000 h 1028700"/>
                  <a:gd name="connsiteX5" fmla="*/ 168275 w 368300"/>
                  <a:gd name="connsiteY5" fmla="*/ 158750 h 1028700"/>
                  <a:gd name="connsiteX6" fmla="*/ 174625 w 368300"/>
                  <a:gd name="connsiteY6" fmla="*/ 215900 h 1028700"/>
                  <a:gd name="connsiteX7" fmla="*/ 168275 w 368300"/>
                  <a:gd name="connsiteY7" fmla="*/ 266700 h 1028700"/>
                  <a:gd name="connsiteX8" fmla="*/ 168275 w 368300"/>
                  <a:gd name="connsiteY8" fmla="*/ 320675 h 1028700"/>
                  <a:gd name="connsiteX9" fmla="*/ 184150 w 368300"/>
                  <a:gd name="connsiteY9" fmla="*/ 400050 h 1028700"/>
                  <a:gd name="connsiteX10" fmla="*/ 190500 w 368300"/>
                  <a:gd name="connsiteY10" fmla="*/ 450850 h 1028700"/>
                  <a:gd name="connsiteX11" fmla="*/ 190500 w 368300"/>
                  <a:gd name="connsiteY11" fmla="*/ 450850 h 1028700"/>
                  <a:gd name="connsiteX12" fmla="*/ 193675 w 368300"/>
                  <a:gd name="connsiteY12" fmla="*/ 508000 h 1028700"/>
                  <a:gd name="connsiteX13" fmla="*/ 187325 w 368300"/>
                  <a:gd name="connsiteY13" fmla="*/ 533400 h 1028700"/>
                  <a:gd name="connsiteX14" fmla="*/ 187325 w 368300"/>
                  <a:gd name="connsiteY14" fmla="*/ 581025 h 1028700"/>
                  <a:gd name="connsiteX15" fmla="*/ 196850 w 368300"/>
                  <a:gd name="connsiteY15" fmla="*/ 612775 h 1028700"/>
                  <a:gd name="connsiteX16" fmla="*/ 184150 w 368300"/>
                  <a:gd name="connsiteY16" fmla="*/ 644525 h 1028700"/>
                  <a:gd name="connsiteX17" fmla="*/ 193675 w 368300"/>
                  <a:gd name="connsiteY17" fmla="*/ 692150 h 1028700"/>
                  <a:gd name="connsiteX18" fmla="*/ 193675 w 368300"/>
                  <a:gd name="connsiteY18" fmla="*/ 727075 h 1028700"/>
                  <a:gd name="connsiteX19" fmla="*/ 180975 w 368300"/>
                  <a:gd name="connsiteY19" fmla="*/ 752475 h 1028700"/>
                  <a:gd name="connsiteX20" fmla="*/ 180975 w 368300"/>
                  <a:gd name="connsiteY20" fmla="*/ 796925 h 1028700"/>
                  <a:gd name="connsiteX21" fmla="*/ 155575 w 368300"/>
                  <a:gd name="connsiteY21" fmla="*/ 828675 h 1028700"/>
                  <a:gd name="connsiteX22" fmla="*/ 0 w 368300"/>
                  <a:gd name="connsiteY22" fmla="*/ 914400 h 1028700"/>
                  <a:gd name="connsiteX23" fmla="*/ 44450 w 368300"/>
                  <a:gd name="connsiteY23" fmla="*/ 930275 h 1028700"/>
                  <a:gd name="connsiteX24" fmla="*/ 79375 w 368300"/>
                  <a:gd name="connsiteY24" fmla="*/ 920750 h 1028700"/>
                  <a:gd name="connsiteX25" fmla="*/ 130175 w 368300"/>
                  <a:gd name="connsiteY25" fmla="*/ 914400 h 1028700"/>
                  <a:gd name="connsiteX26" fmla="*/ 139700 w 368300"/>
                  <a:gd name="connsiteY26" fmla="*/ 936625 h 1028700"/>
                  <a:gd name="connsiteX27" fmla="*/ 133350 w 368300"/>
                  <a:gd name="connsiteY27" fmla="*/ 971550 h 1028700"/>
                  <a:gd name="connsiteX28" fmla="*/ 123825 w 368300"/>
                  <a:gd name="connsiteY28" fmla="*/ 1003300 h 1028700"/>
                  <a:gd name="connsiteX29" fmla="*/ 136525 w 368300"/>
                  <a:gd name="connsiteY29" fmla="*/ 1022350 h 1028700"/>
                  <a:gd name="connsiteX30" fmla="*/ 152400 w 368300"/>
                  <a:gd name="connsiteY30" fmla="*/ 1028700 h 1028700"/>
                  <a:gd name="connsiteX31" fmla="*/ 152400 w 368300"/>
                  <a:gd name="connsiteY31" fmla="*/ 1028700 h 1028700"/>
                  <a:gd name="connsiteX32" fmla="*/ 155575 w 368300"/>
                  <a:gd name="connsiteY32" fmla="*/ 996950 h 1028700"/>
                  <a:gd name="connsiteX33" fmla="*/ 184150 w 368300"/>
                  <a:gd name="connsiteY33" fmla="*/ 981075 h 1028700"/>
                  <a:gd name="connsiteX34" fmla="*/ 212725 w 368300"/>
                  <a:gd name="connsiteY34" fmla="*/ 962025 h 1028700"/>
                  <a:gd name="connsiteX35" fmla="*/ 222250 w 368300"/>
                  <a:gd name="connsiteY35" fmla="*/ 923925 h 1028700"/>
                  <a:gd name="connsiteX36" fmla="*/ 254000 w 368300"/>
                  <a:gd name="connsiteY36" fmla="*/ 933450 h 1028700"/>
                  <a:gd name="connsiteX37" fmla="*/ 292100 w 368300"/>
                  <a:gd name="connsiteY37" fmla="*/ 965200 h 1028700"/>
                  <a:gd name="connsiteX38" fmla="*/ 327025 w 368300"/>
                  <a:gd name="connsiteY38" fmla="*/ 990600 h 1028700"/>
                  <a:gd name="connsiteX39" fmla="*/ 355600 w 368300"/>
                  <a:gd name="connsiteY39" fmla="*/ 1009650 h 1028700"/>
                  <a:gd name="connsiteX40" fmla="*/ 342900 w 368300"/>
                  <a:gd name="connsiteY40" fmla="*/ 971550 h 1028700"/>
                  <a:gd name="connsiteX41" fmla="*/ 330200 w 368300"/>
                  <a:gd name="connsiteY41" fmla="*/ 936625 h 1028700"/>
                  <a:gd name="connsiteX42" fmla="*/ 330200 w 368300"/>
                  <a:gd name="connsiteY42" fmla="*/ 936625 h 1028700"/>
                  <a:gd name="connsiteX43" fmla="*/ 368300 w 368300"/>
                  <a:gd name="connsiteY43" fmla="*/ 908050 h 1028700"/>
                  <a:gd name="connsiteX44" fmla="*/ 368300 w 368300"/>
                  <a:gd name="connsiteY44" fmla="*/ 908050 h 1028700"/>
                  <a:gd name="connsiteX0" fmla="*/ 76200 w 593725"/>
                  <a:gd name="connsiteY0" fmla="*/ 0 h 1028700"/>
                  <a:gd name="connsiteX1" fmla="*/ 69850 w 593725"/>
                  <a:gd name="connsiteY1" fmla="*/ 41275 h 1028700"/>
                  <a:gd name="connsiteX2" fmla="*/ 85725 w 593725"/>
                  <a:gd name="connsiteY2" fmla="*/ 66675 h 1028700"/>
                  <a:gd name="connsiteX3" fmla="*/ 114300 w 593725"/>
                  <a:gd name="connsiteY3" fmla="*/ 95250 h 1028700"/>
                  <a:gd name="connsiteX4" fmla="*/ 149225 w 593725"/>
                  <a:gd name="connsiteY4" fmla="*/ 127000 h 1028700"/>
                  <a:gd name="connsiteX5" fmla="*/ 168275 w 593725"/>
                  <a:gd name="connsiteY5" fmla="*/ 158750 h 1028700"/>
                  <a:gd name="connsiteX6" fmla="*/ 174625 w 593725"/>
                  <a:gd name="connsiteY6" fmla="*/ 215900 h 1028700"/>
                  <a:gd name="connsiteX7" fmla="*/ 168275 w 593725"/>
                  <a:gd name="connsiteY7" fmla="*/ 266700 h 1028700"/>
                  <a:gd name="connsiteX8" fmla="*/ 168275 w 593725"/>
                  <a:gd name="connsiteY8" fmla="*/ 320675 h 1028700"/>
                  <a:gd name="connsiteX9" fmla="*/ 184150 w 593725"/>
                  <a:gd name="connsiteY9" fmla="*/ 400050 h 1028700"/>
                  <a:gd name="connsiteX10" fmla="*/ 190500 w 593725"/>
                  <a:gd name="connsiteY10" fmla="*/ 450850 h 1028700"/>
                  <a:gd name="connsiteX11" fmla="*/ 190500 w 593725"/>
                  <a:gd name="connsiteY11" fmla="*/ 450850 h 1028700"/>
                  <a:gd name="connsiteX12" fmla="*/ 193675 w 593725"/>
                  <a:gd name="connsiteY12" fmla="*/ 508000 h 1028700"/>
                  <a:gd name="connsiteX13" fmla="*/ 187325 w 593725"/>
                  <a:gd name="connsiteY13" fmla="*/ 533400 h 1028700"/>
                  <a:gd name="connsiteX14" fmla="*/ 187325 w 593725"/>
                  <a:gd name="connsiteY14" fmla="*/ 581025 h 1028700"/>
                  <a:gd name="connsiteX15" fmla="*/ 196850 w 593725"/>
                  <a:gd name="connsiteY15" fmla="*/ 612775 h 1028700"/>
                  <a:gd name="connsiteX16" fmla="*/ 184150 w 593725"/>
                  <a:gd name="connsiteY16" fmla="*/ 644525 h 1028700"/>
                  <a:gd name="connsiteX17" fmla="*/ 193675 w 593725"/>
                  <a:gd name="connsiteY17" fmla="*/ 692150 h 1028700"/>
                  <a:gd name="connsiteX18" fmla="*/ 193675 w 593725"/>
                  <a:gd name="connsiteY18" fmla="*/ 727075 h 1028700"/>
                  <a:gd name="connsiteX19" fmla="*/ 180975 w 593725"/>
                  <a:gd name="connsiteY19" fmla="*/ 752475 h 1028700"/>
                  <a:gd name="connsiteX20" fmla="*/ 180975 w 593725"/>
                  <a:gd name="connsiteY20" fmla="*/ 796925 h 1028700"/>
                  <a:gd name="connsiteX21" fmla="*/ 155575 w 593725"/>
                  <a:gd name="connsiteY21" fmla="*/ 828675 h 1028700"/>
                  <a:gd name="connsiteX22" fmla="*/ 0 w 593725"/>
                  <a:gd name="connsiteY22" fmla="*/ 914400 h 1028700"/>
                  <a:gd name="connsiteX23" fmla="*/ 44450 w 593725"/>
                  <a:gd name="connsiteY23" fmla="*/ 930275 h 1028700"/>
                  <a:gd name="connsiteX24" fmla="*/ 79375 w 593725"/>
                  <a:gd name="connsiteY24" fmla="*/ 920750 h 1028700"/>
                  <a:gd name="connsiteX25" fmla="*/ 130175 w 593725"/>
                  <a:gd name="connsiteY25" fmla="*/ 914400 h 1028700"/>
                  <a:gd name="connsiteX26" fmla="*/ 139700 w 593725"/>
                  <a:gd name="connsiteY26" fmla="*/ 936625 h 1028700"/>
                  <a:gd name="connsiteX27" fmla="*/ 133350 w 593725"/>
                  <a:gd name="connsiteY27" fmla="*/ 971550 h 1028700"/>
                  <a:gd name="connsiteX28" fmla="*/ 123825 w 593725"/>
                  <a:gd name="connsiteY28" fmla="*/ 1003300 h 1028700"/>
                  <a:gd name="connsiteX29" fmla="*/ 136525 w 593725"/>
                  <a:gd name="connsiteY29" fmla="*/ 1022350 h 1028700"/>
                  <a:gd name="connsiteX30" fmla="*/ 152400 w 593725"/>
                  <a:gd name="connsiteY30" fmla="*/ 1028700 h 1028700"/>
                  <a:gd name="connsiteX31" fmla="*/ 152400 w 593725"/>
                  <a:gd name="connsiteY31" fmla="*/ 1028700 h 1028700"/>
                  <a:gd name="connsiteX32" fmla="*/ 155575 w 593725"/>
                  <a:gd name="connsiteY32" fmla="*/ 996950 h 1028700"/>
                  <a:gd name="connsiteX33" fmla="*/ 184150 w 593725"/>
                  <a:gd name="connsiteY33" fmla="*/ 981075 h 1028700"/>
                  <a:gd name="connsiteX34" fmla="*/ 212725 w 593725"/>
                  <a:gd name="connsiteY34" fmla="*/ 962025 h 1028700"/>
                  <a:gd name="connsiteX35" fmla="*/ 222250 w 593725"/>
                  <a:gd name="connsiteY35" fmla="*/ 923925 h 1028700"/>
                  <a:gd name="connsiteX36" fmla="*/ 254000 w 593725"/>
                  <a:gd name="connsiteY36" fmla="*/ 933450 h 1028700"/>
                  <a:gd name="connsiteX37" fmla="*/ 292100 w 593725"/>
                  <a:gd name="connsiteY37" fmla="*/ 965200 h 1028700"/>
                  <a:gd name="connsiteX38" fmla="*/ 327025 w 593725"/>
                  <a:gd name="connsiteY38" fmla="*/ 990600 h 1028700"/>
                  <a:gd name="connsiteX39" fmla="*/ 355600 w 593725"/>
                  <a:gd name="connsiteY39" fmla="*/ 1009650 h 1028700"/>
                  <a:gd name="connsiteX40" fmla="*/ 342900 w 593725"/>
                  <a:gd name="connsiteY40" fmla="*/ 971550 h 1028700"/>
                  <a:gd name="connsiteX41" fmla="*/ 330200 w 593725"/>
                  <a:gd name="connsiteY41" fmla="*/ 936625 h 1028700"/>
                  <a:gd name="connsiteX42" fmla="*/ 330200 w 593725"/>
                  <a:gd name="connsiteY42" fmla="*/ 936625 h 1028700"/>
                  <a:gd name="connsiteX43" fmla="*/ 368300 w 593725"/>
                  <a:gd name="connsiteY43" fmla="*/ 908050 h 1028700"/>
                  <a:gd name="connsiteX44" fmla="*/ 593725 w 593725"/>
                  <a:gd name="connsiteY44" fmla="*/ 457200 h 1028700"/>
                  <a:gd name="connsiteX0" fmla="*/ 76200 w 381618"/>
                  <a:gd name="connsiteY0" fmla="*/ 3175 h 1031875"/>
                  <a:gd name="connsiteX1" fmla="*/ 69850 w 381618"/>
                  <a:gd name="connsiteY1" fmla="*/ 44450 h 1031875"/>
                  <a:gd name="connsiteX2" fmla="*/ 85725 w 381618"/>
                  <a:gd name="connsiteY2" fmla="*/ 69850 h 1031875"/>
                  <a:gd name="connsiteX3" fmla="*/ 114300 w 381618"/>
                  <a:gd name="connsiteY3" fmla="*/ 98425 h 1031875"/>
                  <a:gd name="connsiteX4" fmla="*/ 149225 w 381618"/>
                  <a:gd name="connsiteY4" fmla="*/ 130175 h 1031875"/>
                  <a:gd name="connsiteX5" fmla="*/ 168275 w 381618"/>
                  <a:gd name="connsiteY5" fmla="*/ 161925 h 1031875"/>
                  <a:gd name="connsiteX6" fmla="*/ 174625 w 381618"/>
                  <a:gd name="connsiteY6" fmla="*/ 219075 h 1031875"/>
                  <a:gd name="connsiteX7" fmla="*/ 168275 w 381618"/>
                  <a:gd name="connsiteY7" fmla="*/ 269875 h 1031875"/>
                  <a:gd name="connsiteX8" fmla="*/ 168275 w 381618"/>
                  <a:gd name="connsiteY8" fmla="*/ 323850 h 1031875"/>
                  <a:gd name="connsiteX9" fmla="*/ 184150 w 381618"/>
                  <a:gd name="connsiteY9" fmla="*/ 403225 h 1031875"/>
                  <a:gd name="connsiteX10" fmla="*/ 190500 w 381618"/>
                  <a:gd name="connsiteY10" fmla="*/ 454025 h 1031875"/>
                  <a:gd name="connsiteX11" fmla="*/ 190500 w 381618"/>
                  <a:gd name="connsiteY11" fmla="*/ 454025 h 1031875"/>
                  <a:gd name="connsiteX12" fmla="*/ 193675 w 381618"/>
                  <a:gd name="connsiteY12" fmla="*/ 511175 h 1031875"/>
                  <a:gd name="connsiteX13" fmla="*/ 187325 w 381618"/>
                  <a:gd name="connsiteY13" fmla="*/ 536575 h 1031875"/>
                  <a:gd name="connsiteX14" fmla="*/ 187325 w 381618"/>
                  <a:gd name="connsiteY14" fmla="*/ 584200 h 1031875"/>
                  <a:gd name="connsiteX15" fmla="*/ 196850 w 381618"/>
                  <a:gd name="connsiteY15" fmla="*/ 615950 h 1031875"/>
                  <a:gd name="connsiteX16" fmla="*/ 184150 w 381618"/>
                  <a:gd name="connsiteY16" fmla="*/ 647700 h 1031875"/>
                  <a:gd name="connsiteX17" fmla="*/ 193675 w 381618"/>
                  <a:gd name="connsiteY17" fmla="*/ 695325 h 1031875"/>
                  <a:gd name="connsiteX18" fmla="*/ 193675 w 381618"/>
                  <a:gd name="connsiteY18" fmla="*/ 730250 h 1031875"/>
                  <a:gd name="connsiteX19" fmla="*/ 180975 w 381618"/>
                  <a:gd name="connsiteY19" fmla="*/ 755650 h 1031875"/>
                  <a:gd name="connsiteX20" fmla="*/ 180975 w 381618"/>
                  <a:gd name="connsiteY20" fmla="*/ 800100 h 1031875"/>
                  <a:gd name="connsiteX21" fmla="*/ 155575 w 381618"/>
                  <a:gd name="connsiteY21" fmla="*/ 831850 h 1031875"/>
                  <a:gd name="connsiteX22" fmla="*/ 0 w 381618"/>
                  <a:gd name="connsiteY22" fmla="*/ 917575 h 1031875"/>
                  <a:gd name="connsiteX23" fmla="*/ 44450 w 381618"/>
                  <a:gd name="connsiteY23" fmla="*/ 933450 h 1031875"/>
                  <a:gd name="connsiteX24" fmla="*/ 79375 w 381618"/>
                  <a:gd name="connsiteY24" fmla="*/ 923925 h 1031875"/>
                  <a:gd name="connsiteX25" fmla="*/ 130175 w 381618"/>
                  <a:gd name="connsiteY25" fmla="*/ 917575 h 1031875"/>
                  <a:gd name="connsiteX26" fmla="*/ 139700 w 381618"/>
                  <a:gd name="connsiteY26" fmla="*/ 939800 h 1031875"/>
                  <a:gd name="connsiteX27" fmla="*/ 133350 w 381618"/>
                  <a:gd name="connsiteY27" fmla="*/ 974725 h 1031875"/>
                  <a:gd name="connsiteX28" fmla="*/ 123825 w 381618"/>
                  <a:gd name="connsiteY28" fmla="*/ 1006475 h 1031875"/>
                  <a:gd name="connsiteX29" fmla="*/ 136525 w 381618"/>
                  <a:gd name="connsiteY29" fmla="*/ 1025525 h 1031875"/>
                  <a:gd name="connsiteX30" fmla="*/ 152400 w 381618"/>
                  <a:gd name="connsiteY30" fmla="*/ 1031875 h 1031875"/>
                  <a:gd name="connsiteX31" fmla="*/ 152400 w 381618"/>
                  <a:gd name="connsiteY31" fmla="*/ 1031875 h 1031875"/>
                  <a:gd name="connsiteX32" fmla="*/ 155575 w 381618"/>
                  <a:gd name="connsiteY32" fmla="*/ 1000125 h 1031875"/>
                  <a:gd name="connsiteX33" fmla="*/ 184150 w 381618"/>
                  <a:gd name="connsiteY33" fmla="*/ 984250 h 1031875"/>
                  <a:gd name="connsiteX34" fmla="*/ 212725 w 381618"/>
                  <a:gd name="connsiteY34" fmla="*/ 965200 h 1031875"/>
                  <a:gd name="connsiteX35" fmla="*/ 222250 w 381618"/>
                  <a:gd name="connsiteY35" fmla="*/ 927100 h 1031875"/>
                  <a:gd name="connsiteX36" fmla="*/ 254000 w 381618"/>
                  <a:gd name="connsiteY36" fmla="*/ 936625 h 1031875"/>
                  <a:gd name="connsiteX37" fmla="*/ 292100 w 381618"/>
                  <a:gd name="connsiteY37" fmla="*/ 968375 h 1031875"/>
                  <a:gd name="connsiteX38" fmla="*/ 327025 w 381618"/>
                  <a:gd name="connsiteY38" fmla="*/ 993775 h 1031875"/>
                  <a:gd name="connsiteX39" fmla="*/ 355600 w 381618"/>
                  <a:gd name="connsiteY39" fmla="*/ 1012825 h 1031875"/>
                  <a:gd name="connsiteX40" fmla="*/ 342900 w 381618"/>
                  <a:gd name="connsiteY40" fmla="*/ 974725 h 1031875"/>
                  <a:gd name="connsiteX41" fmla="*/ 330200 w 381618"/>
                  <a:gd name="connsiteY41" fmla="*/ 939800 h 1031875"/>
                  <a:gd name="connsiteX42" fmla="*/ 330200 w 381618"/>
                  <a:gd name="connsiteY42" fmla="*/ 939800 h 1031875"/>
                  <a:gd name="connsiteX43" fmla="*/ 368300 w 381618"/>
                  <a:gd name="connsiteY43" fmla="*/ 911225 h 1031875"/>
                  <a:gd name="connsiteX44" fmla="*/ 82550 w 381618"/>
                  <a:gd name="connsiteY44" fmla="*/ 0 h 1031875"/>
                  <a:gd name="connsiteX0" fmla="*/ 76200 w 373739"/>
                  <a:gd name="connsiteY0" fmla="*/ 3175 h 1031875"/>
                  <a:gd name="connsiteX1" fmla="*/ 69850 w 373739"/>
                  <a:gd name="connsiteY1" fmla="*/ 44450 h 1031875"/>
                  <a:gd name="connsiteX2" fmla="*/ 85725 w 373739"/>
                  <a:gd name="connsiteY2" fmla="*/ 69850 h 1031875"/>
                  <a:gd name="connsiteX3" fmla="*/ 114300 w 373739"/>
                  <a:gd name="connsiteY3" fmla="*/ 98425 h 1031875"/>
                  <a:gd name="connsiteX4" fmla="*/ 149225 w 373739"/>
                  <a:gd name="connsiteY4" fmla="*/ 130175 h 1031875"/>
                  <a:gd name="connsiteX5" fmla="*/ 168275 w 373739"/>
                  <a:gd name="connsiteY5" fmla="*/ 161925 h 1031875"/>
                  <a:gd name="connsiteX6" fmla="*/ 174625 w 373739"/>
                  <a:gd name="connsiteY6" fmla="*/ 219075 h 1031875"/>
                  <a:gd name="connsiteX7" fmla="*/ 168275 w 373739"/>
                  <a:gd name="connsiteY7" fmla="*/ 269875 h 1031875"/>
                  <a:gd name="connsiteX8" fmla="*/ 168275 w 373739"/>
                  <a:gd name="connsiteY8" fmla="*/ 323850 h 1031875"/>
                  <a:gd name="connsiteX9" fmla="*/ 184150 w 373739"/>
                  <a:gd name="connsiteY9" fmla="*/ 403225 h 1031875"/>
                  <a:gd name="connsiteX10" fmla="*/ 190500 w 373739"/>
                  <a:gd name="connsiteY10" fmla="*/ 454025 h 1031875"/>
                  <a:gd name="connsiteX11" fmla="*/ 190500 w 373739"/>
                  <a:gd name="connsiteY11" fmla="*/ 454025 h 1031875"/>
                  <a:gd name="connsiteX12" fmla="*/ 193675 w 373739"/>
                  <a:gd name="connsiteY12" fmla="*/ 511175 h 1031875"/>
                  <a:gd name="connsiteX13" fmla="*/ 187325 w 373739"/>
                  <a:gd name="connsiteY13" fmla="*/ 536575 h 1031875"/>
                  <a:gd name="connsiteX14" fmla="*/ 187325 w 373739"/>
                  <a:gd name="connsiteY14" fmla="*/ 584200 h 1031875"/>
                  <a:gd name="connsiteX15" fmla="*/ 196850 w 373739"/>
                  <a:gd name="connsiteY15" fmla="*/ 615950 h 1031875"/>
                  <a:gd name="connsiteX16" fmla="*/ 184150 w 373739"/>
                  <a:gd name="connsiteY16" fmla="*/ 647700 h 1031875"/>
                  <a:gd name="connsiteX17" fmla="*/ 193675 w 373739"/>
                  <a:gd name="connsiteY17" fmla="*/ 695325 h 1031875"/>
                  <a:gd name="connsiteX18" fmla="*/ 193675 w 373739"/>
                  <a:gd name="connsiteY18" fmla="*/ 730250 h 1031875"/>
                  <a:gd name="connsiteX19" fmla="*/ 180975 w 373739"/>
                  <a:gd name="connsiteY19" fmla="*/ 755650 h 1031875"/>
                  <a:gd name="connsiteX20" fmla="*/ 180975 w 373739"/>
                  <a:gd name="connsiteY20" fmla="*/ 800100 h 1031875"/>
                  <a:gd name="connsiteX21" fmla="*/ 155575 w 373739"/>
                  <a:gd name="connsiteY21" fmla="*/ 831850 h 1031875"/>
                  <a:gd name="connsiteX22" fmla="*/ 0 w 373739"/>
                  <a:gd name="connsiteY22" fmla="*/ 917575 h 1031875"/>
                  <a:gd name="connsiteX23" fmla="*/ 44450 w 373739"/>
                  <a:gd name="connsiteY23" fmla="*/ 933450 h 1031875"/>
                  <a:gd name="connsiteX24" fmla="*/ 79375 w 373739"/>
                  <a:gd name="connsiteY24" fmla="*/ 923925 h 1031875"/>
                  <a:gd name="connsiteX25" fmla="*/ 130175 w 373739"/>
                  <a:gd name="connsiteY25" fmla="*/ 917575 h 1031875"/>
                  <a:gd name="connsiteX26" fmla="*/ 139700 w 373739"/>
                  <a:gd name="connsiteY26" fmla="*/ 939800 h 1031875"/>
                  <a:gd name="connsiteX27" fmla="*/ 133350 w 373739"/>
                  <a:gd name="connsiteY27" fmla="*/ 974725 h 1031875"/>
                  <a:gd name="connsiteX28" fmla="*/ 123825 w 373739"/>
                  <a:gd name="connsiteY28" fmla="*/ 1006475 h 1031875"/>
                  <a:gd name="connsiteX29" fmla="*/ 136525 w 373739"/>
                  <a:gd name="connsiteY29" fmla="*/ 1025525 h 1031875"/>
                  <a:gd name="connsiteX30" fmla="*/ 152400 w 373739"/>
                  <a:gd name="connsiteY30" fmla="*/ 1031875 h 1031875"/>
                  <a:gd name="connsiteX31" fmla="*/ 152400 w 373739"/>
                  <a:gd name="connsiteY31" fmla="*/ 1031875 h 1031875"/>
                  <a:gd name="connsiteX32" fmla="*/ 155575 w 373739"/>
                  <a:gd name="connsiteY32" fmla="*/ 1000125 h 1031875"/>
                  <a:gd name="connsiteX33" fmla="*/ 184150 w 373739"/>
                  <a:gd name="connsiteY33" fmla="*/ 984250 h 1031875"/>
                  <a:gd name="connsiteX34" fmla="*/ 212725 w 373739"/>
                  <a:gd name="connsiteY34" fmla="*/ 965200 h 1031875"/>
                  <a:gd name="connsiteX35" fmla="*/ 222250 w 373739"/>
                  <a:gd name="connsiteY35" fmla="*/ 927100 h 1031875"/>
                  <a:gd name="connsiteX36" fmla="*/ 254000 w 373739"/>
                  <a:gd name="connsiteY36" fmla="*/ 936625 h 1031875"/>
                  <a:gd name="connsiteX37" fmla="*/ 292100 w 373739"/>
                  <a:gd name="connsiteY37" fmla="*/ 968375 h 1031875"/>
                  <a:gd name="connsiteX38" fmla="*/ 327025 w 373739"/>
                  <a:gd name="connsiteY38" fmla="*/ 993775 h 1031875"/>
                  <a:gd name="connsiteX39" fmla="*/ 355600 w 373739"/>
                  <a:gd name="connsiteY39" fmla="*/ 1012825 h 1031875"/>
                  <a:gd name="connsiteX40" fmla="*/ 342900 w 373739"/>
                  <a:gd name="connsiteY40" fmla="*/ 974725 h 1031875"/>
                  <a:gd name="connsiteX41" fmla="*/ 330200 w 373739"/>
                  <a:gd name="connsiteY41" fmla="*/ 939800 h 1031875"/>
                  <a:gd name="connsiteX42" fmla="*/ 330200 w 373739"/>
                  <a:gd name="connsiteY42" fmla="*/ 939800 h 1031875"/>
                  <a:gd name="connsiteX43" fmla="*/ 368300 w 373739"/>
                  <a:gd name="connsiteY43" fmla="*/ 911225 h 1031875"/>
                  <a:gd name="connsiteX44" fmla="*/ 203200 w 373739"/>
                  <a:gd name="connsiteY44" fmla="*/ 190501 h 1031875"/>
                  <a:gd name="connsiteX45" fmla="*/ 82550 w 373739"/>
                  <a:gd name="connsiteY45" fmla="*/ 0 h 1031875"/>
                  <a:gd name="connsiteX0" fmla="*/ 76200 w 373739"/>
                  <a:gd name="connsiteY0" fmla="*/ 3175 h 1031875"/>
                  <a:gd name="connsiteX1" fmla="*/ 69850 w 373739"/>
                  <a:gd name="connsiteY1" fmla="*/ 44450 h 1031875"/>
                  <a:gd name="connsiteX2" fmla="*/ 85725 w 373739"/>
                  <a:gd name="connsiteY2" fmla="*/ 69850 h 1031875"/>
                  <a:gd name="connsiteX3" fmla="*/ 114300 w 373739"/>
                  <a:gd name="connsiteY3" fmla="*/ 98425 h 1031875"/>
                  <a:gd name="connsiteX4" fmla="*/ 149225 w 373739"/>
                  <a:gd name="connsiteY4" fmla="*/ 130175 h 1031875"/>
                  <a:gd name="connsiteX5" fmla="*/ 168275 w 373739"/>
                  <a:gd name="connsiteY5" fmla="*/ 161925 h 1031875"/>
                  <a:gd name="connsiteX6" fmla="*/ 174625 w 373739"/>
                  <a:gd name="connsiteY6" fmla="*/ 219075 h 1031875"/>
                  <a:gd name="connsiteX7" fmla="*/ 168275 w 373739"/>
                  <a:gd name="connsiteY7" fmla="*/ 269875 h 1031875"/>
                  <a:gd name="connsiteX8" fmla="*/ 168275 w 373739"/>
                  <a:gd name="connsiteY8" fmla="*/ 323850 h 1031875"/>
                  <a:gd name="connsiteX9" fmla="*/ 184150 w 373739"/>
                  <a:gd name="connsiteY9" fmla="*/ 403225 h 1031875"/>
                  <a:gd name="connsiteX10" fmla="*/ 190500 w 373739"/>
                  <a:gd name="connsiteY10" fmla="*/ 454025 h 1031875"/>
                  <a:gd name="connsiteX11" fmla="*/ 190500 w 373739"/>
                  <a:gd name="connsiteY11" fmla="*/ 454025 h 1031875"/>
                  <a:gd name="connsiteX12" fmla="*/ 193675 w 373739"/>
                  <a:gd name="connsiteY12" fmla="*/ 511175 h 1031875"/>
                  <a:gd name="connsiteX13" fmla="*/ 187325 w 373739"/>
                  <a:gd name="connsiteY13" fmla="*/ 536575 h 1031875"/>
                  <a:gd name="connsiteX14" fmla="*/ 187325 w 373739"/>
                  <a:gd name="connsiteY14" fmla="*/ 584200 h 1031875"/>
                  <a:gd name="connsiteX15" fmla="*/ 196850 w 373739"/>
                  <a:gd name="connsiteY15" fmla="*/ 615950 h 1031875"/>
                  <a:gd name="connsiteX16" fmla="*/ 184150 w 373739"/>
                  <a:gd name="connsiteY16" fmla="*/ 647700 h 1031875"/>
                  <a:gd name="connsiteX17" fmla="*/ 193675 w 373739"/>
                  <a:gd name="connsiteY17" fmla="*/ 695325 h 1031875"/>
                  <a:gd name="connsiteX18" fmla="*/ 193675 w 373739"/>
                  <a:gd name="connsiteY18" fmla="*/ 730250 h 1031875"/>
                  <a:gd name="connsiteX19" fmla="*/ 180975 w 373739"/>
                  <a:gd name="connsiteY19" fmla="*/ 755650 h 1031875"/>
                  <a:gd name="connsiteX20" fmla="*/ 180975 w 373739"/>
                  <a:gd name="connsiteY20" fmla="*/ 800100 h 1031875"/>
                  <a:gd name="connsiteX21" fmla="*/ 155575 w 373739"/>
                  <a:gd name="connsiteY21" fmla="*/ 831850 h 1031875"/>
                  <a:gd name="connsiteX22" fmla="*/ 0 w 373739"/>
                  <a:gd name="connsiteY22" fmla="*/ 917575 h 1031875"/>
                  <a:gd name="connsiteX23" fmla="*/ 44450 w 373739"/>
                  <a:gd name="connsiteY23" fmla="*/ 933450 h 1031875"/>
                  <a:gd name="connsiteX24" fmla="*/ 79375 w 373739"/>
                  <a:gd name="connsiteY24" fmla="*/ 923925 h 1031875"/>
                  <a:gd name="connsiteX25" fmla="*/ 130175 w 373739"/>
                  <a:gd name="connsiteY25" fmla="*/ 917575 h 1031875"/>
                  <a:gd name="connsiteX26" fmla="*/ 139700 w 373739"/>
                  <a:gd name="connsiteY26" fmla="*/ 939800 h 1031875"/>
                  <a:gd name="connsiteX27" fmla="*/ 133350 w 373739"/>
                  <a:gd name="connsiteY27" fmla="*/ 974725 h 1031875"/>
                  <a:gd name="connsiteX28" fmla="*/ 123825 w 373739"/>
                  <a:gd name="connsiteY28" fmla="*/ 1006475 h 1031875"/>
                  <a:gd name="connsiteX29" fmla="*/ 136525 w 373739"/>
                  <a:gd name="connsiteY29" fmla="*/ 1025525 h 1031875"/>
                  <a:gd name="connsiteX30" fmla="*/ 152400 w 373739"/>
                  <a:gd name="connsiteY30" fmla="*/ 1031875 h 1031875"/>
                  <a:gd name="connsiteX31" fmla="*/ 152400 w 373739"/>
                  <a:gd name="connsiteY31" fmla="*/ 1031875 h 1031875"/>
                  <a:gd name="connsiteX32" fmla="*/ 155575 w 373739"/>
                  <a:gd name="connsiteY32" fmla="*/ 1000125 h 1031875"/>
                  <a:gd name="connsiteX33" fmla="*/ 184150 w 373739"/>
                  <a:gd name="connsiteY33" fmla="*/ 984250 h 1031875"/>
                  <a:gd name="connsiteX34" fmla="*/ 212725 w 373739"/>
                  <a:gd name="connsiteY34" fmla="*/ 965200 h 1031875"/>
                  <a:gd name="connsiteX35" fmla="*/ 222250 w 373739"/>
                  <a:gd name="connsiteY35" fmla="*/ 927100 h 1031875"/>
                  <a:gd name="connsiteX36" fmla="*/ 254000 w 373739"/>
                  <a:gd name="connsiteY36" fmla="*/ 936625 h 1031875"/>
                  <a:gd name="connsiteX37" fmla="*/ 292100 w 373739"/>
                  <a:gd name="connsiteY37" fmla="*/ 968375 h 1031875"/>
                  <a:gd name="connsiteX38" fmla="*/ 327025 w 373739"/>
                  <a:gd name="connsiteY38" fmla="*/ 993775 h 1031875"/>
                  <a:gd name="connsiteX39" fmla="*/ 355600 w 373739"/>
                  <a:gd name="connsiteY39" fmla="*/ 1012825 h 1031875"/>
                  <a:gd name="connsiteX40" fmla="*/ 342900 w 373739"/>
                  <a:gd name="connsiteY40" fmla="*/ 974725 h 1031875"/>
                  <a:gd name="connsiteX41" fmla="*/ 330200 w 373739"/>
                  <a:gd name="connsiteY41" fmla="*/ 939800 h 1031875"/>
                  <a:gd name="connsiteX42" fmla="*/ 330200 w 373739"/>
                  <a:gd name="connsiteY42" fmla="*/ 939800 h 1031875"/>
                  <a:gd name="connsiteX43" fmla="*/ 368300 w 373739"/>
                  <a:gd name="connsiteY43" fmla="*/ 911225 h 1031875"/>
                  <a:gd name="connsiteX44" fmla="*/ 203200 w 373739"/>
                  <a:gd name="connsiteY44" fmla="*/ 190501 h 1031875"/>
                  <a:gd name="connsiteX45" fmla="*/ 203201 w 373739"/>
                  <a:gd name="connsiteY45" fmla="*/ 95251 h 1031875"/>
                  <a:gd name="connsiteX46" fmla="*/ 82550 w 373739"/>
                  <a:gd name="connsiteY46" fmla="*/ 0 h 1031875"/>
                  <a:gd name="connsiteX0" fmla="*/ 76200 w 373739"/>
                  <a:gd name="connsiteY0" fmla="*/ 3175 h 1031875"/>
                  <a:gd name="connsiteX1" fmla="*/ 69850 w 373739"/>
                  <a:gd name="connsiteY1" fmla="*/ 44450 h 1031875"/>
                  <a:gd name="connsiteX2" fmla="*/ 85725 w 373739"/>
                  <a:gd name="connsiteY2" fmla="*/ 69850 h 1031875"/>
                  <a:gd name="connsiteX3" fmla="*/ 114300 w 373739"/>
                  <a:gd name="connsiteY3" fmla="*/ 98425 h 1031875"/>
                  <a:gd name="connsiteX4" fmla="*/ 149225 w 373739"/>
                  <a:gd name="connsiteY4" fmla="*/ 130175 h 1031875"/>
                  <a:gd name="connsiteX5" fmla="*/ 168275 w 373739"/>
                  <a:gd name="connsiteY5" fmla="*/ 161925 h 1031875"/>
                  <a:gd name="connsiteX6" fmla="*/ 174625 w 373739"/>
                  <a:gd name="connsiteY6" fmla="*/ 219075 h 1031875"/>
                  <a:gd name="connsiteX7" fmla="*/ 168275 w 373739"/>
                  <a:gd name="connsiteY7" fmla="*/ 269875 h 1031875"/>
                  <a:gd name="connsiteX8" fmla="*/ 168275 w 373739"/>
                  <a:gd name="connsiteY8" fmla="*/ 323850 h 1031875"/>
                  <a:gd name="connsiteX9" fmla="*/ 184150 w 373739"/>
                  <a:gd name="connsiteY9" fmla="*/ 403225 h 1031875"/>
                  <a:gd name="connsiteX10" fmla="*/ 190500 w 373739"/>
                  <a:gd name="connsiteY10" fmla="*/ 454025 h 1031875"/>
                  <a:gd name="connsiteX11" fmla="*/ 190500 w 373739"/>
                  <a:gd name="connsiteY11" fmla="*/ 454025 h 1031875"/>
                  <a:gd name="connsiteX12" fmla="*/ 193675 w 373739"/>
                  <a:gd name="connsiteY12" fmla="*/ 511175 h 1031875"/>
                  <a:gd name="connsiteX13" fmla="*/ 187325 w 373739"/>
                  <a:gd name="connsiteY13" fmla="*/ 536575 h 1031875"/>
                  <a:gd name="connsiteX14" fmla="*/ 187325 w 373739"/>
                  <a:gd name="connsiteY14" fmla="*/ 584200 h 1031875"/>
                  <a:gd name="connsiteX15" fmla="*/ 196850 w 373739"/>
                  <a:gd name="connsiteY15" fmla="*/ 615950 h 1031875"/>
                  <a:gd name="connsiteX16" fmla="*/ 184150 w 373739"/>
                  <a:gd name="connsiteY16" fmla="*/ 647700 h 1031875"/>
                  <a:gd name="connsiteX17" fmla="*/ 193675 w 373739"/>
                  <a:gd name="connsiteY17" fmla="*/ 695325 h 1031875"/>
                  <a:gd name="connsiteX18" fmla="*/ 193675 w 373739"/>
                  <a:gd name="connsiteY18" fmla="*/ 730250 h 1031875"/>
                  <a:gd name="connsiteX19" fmla="*/ 180975 w 373739"/>
                  <a:gd name="connsiteY19" fmla="*/ 755650 h 1031875"/>
                  <a:gd name="connsiteX20" fmla="*/ 180975 w 373739"/>
                  <a:gd name="connsiteY20" fmla="*/ 800100 h 1031875"/>
                  <a:gd name="connsiteX21" fmla="*/ 155575 w 373739"/>
                  <a:gd name="connsiteY21" fmla="*/ 831850 h 1031875"/>
                  <a:gd name="connsiteX22" fmla="*/ 0 w 373739"/>
                  <a:gd name="connsiteY22" fmla="*/ 917575 h 1031875"/>
                  <a:gd name="connsiteX23" fmla="*/ 44450 w 373739"/>
                  <a:gd name="connsiteY23" fmla="*/ 933450 h 1031875"/>
                  <a:gd name="connsiteX24" fmla="*/ 79375 w 373739"/>
                  <a:gd name="connsiteY24" fmla="*/ 923925 h 1031875"/>
                  <a:gd name="connsiteX25" fmla="*/ 130175 w 373739"/>
                  <a:gd name="connsiteY25" fmla="*/ 917575 h 1031875"/>
                  <a:gd name="connsiteX26" fmla="*/ 139700 w 373739"/>
                  <a:gd name="connsiteY26" fmla="*/ 939800 h 1031875"/>
                  <a:gd name="connsiteX27" fmla="*/ 133350 w 373739"/>
                  <a:gd name="connsiteY27" fmla="*/ 974725 h 1031875"/>
                  <a:gd name="connsiteX28" fmla="*/ 123825 w 373739"/>
                  <a:gd name="connsiteY28" fmla="*/ 1006475 h 1031875"/>
                  <a:gd name="connsiteX29" fmla="*/ 136525 w 373739"/>
                  <a:gd name="connsiteY29" fmla="*/ 1025525 h 1031875"/>
                  <a:gd name="connsiteX30" fmla="*/ 152400 w 373739"/>
                  <a:gd name="connsiteY30" fmla="*/ 1031875 h 1031875"/>
                  <a:gd name="connsiteX31" fmla="*/ 152400 w 373739"/>
                  <a:gd name="connsiteY31" fmla="*/ 1031875 h 1031875"/>
                  <a:gd name="connsiteX32" fmla="*/ 155575 w 373739"/>
                  <a:gd name="connsiteY32" fmla="*/ 1000125 h 1031875"/>
                  <a:gd name="connsiteX33" fmla="*/ 184150 w 373739"/>
                  <a:gd name="connsiteY33" fmla="*/ 984250 h 1031875"/>
                  <a:gd name="connsiteX34" fmla="*/ 212725 w 373739"/>
                  <a:gd name="connsiteY34" fmla="*/ 965200 h 1031875"/>
                  <a:gd name="connsiteX35" fmla="*/ 222250 w 373739"/>
                  <a:gd name="connsiteY35" fmla="*/ 927100 h 1031875"/>
                  <a:gd name="connsiteX36" fmla="*/ 254000 w 373739"/>
                  <a:gd name="connsiteY36" fmla="*/ 936625 h 1031875"/>
                  <a:gd name="connsiteX37" fmla="*/ 292100 w 373739"/>
                  <a:gd name="connsiteY37" fmla="*/ 968375 h 1031875"/>
                  <a:gd name="connsiteX38" fmla="*/ 327025 w 373739"/>
                  <a:gd name="connsiteY38" fmla="*/ 993775 h 1031875"/>
                  <a:gd name="connsiteX39" fmla="*/ 355600 w 373739"/>
                  <a:gd name="connsiteY39" fmla="*/ 1012825 h 1031875"/>
                  <a:gd name="connsiteX40" fmla="*/ 342900 w 373739"/>
                  <a:gd name="connsiteY40" fmla="*/ 974725 h 1031875"/>
                  <a:gd name="connsiteX41" fmla="*/ 330200 w 373739"/>
                  <a:gd name="connsiteY41" fmla="*/ 939800 h 1031875"/>
                  <a:gd name="connsiteX42" fmla="*/ 330200 w 373739"/>
                  <a:gd name="connsiteY42" fmla="*/ 939800 h 1031875"/>
                  <a:gd name="connsiteX43" fmla="*/ 368300 w 373739"/>
                  <a:gd name="connsiteY43" fmla="*/ 911225 h 1031875"/>
                  <a:gd name="connsiteX44" fmla="*/ 203200 w 373739"/>
                  <a:gd name="connsiteY44" fmla="*/ 190501 h 1031875"/>
                  <a:gd name="connsiteX45" fmla="*/ 212726 w 373739"/>
                  <a:gd name="connsiteY45" fmla="*/ 101601 h 1031875"/>
                  <a:gd name="connsiteX46" fmla="*/ 82550 w 373739"/>
                  <a:gd name="connsiteY46" fmla="*/ 0 h 1031875"/>
                  <a:gd name="connsiteX0" fmla="*/ 76200 w 376085"/>
                  <a:gd name="connsiteY0" fmla="*/ 3175 h 1031875"/>
                  <a:gd name="connsiteX1" fmla="*/ 69850 w 376085"/>
                  <a:gd name="connsiteY1" fmla="*/ 44450 h 1031875"/>
                  <a:gd name="connsiteX2" fmla="*/ 85725 w 376085"/>
                  <a:gd name="connsiteY2" fmla="*/ 69850 h 1031875"/>
                  <a:gd name="connsiteX3" fmla="*/ 114300 w 376085"/>
                  <a:gd name="connsiteY3" fmla="*/ 98425 h 1031875"/>
                  <a:gd name="connsiteX4" fmla="*/ 149225 w 376085"/>
                  <a:gd name="connsiteY4" fmla="*/ 130175 h 1031875"/>
                  <a:gd name="connsiteX5" fmla="*/ 168275 w 376085"/>
                  <a:gd name="connsiteY5" fmla="*/ 161925 h 1031875"/>
                  <a:gd name="connsiteX6" fmla="*/ 174625 w 376085"/>
                  <a:gd name="connsiteY6" fmla="*/ 219075 h 1031875"/>
                  <a:gd name="connsiteX7" fmla="*/ 168275 w 376085"/>
                  <a:gd name="connsiteY7" fmla="*/ 269875 h 1031875"/>
                  <a:gd name="connsiteX8" fmla="*/ 168275 w 376085"/>
                  <a:gd name="connsiteY8" fmla="*/ 323850 h 1031875"/>
                  <a:gd name="connsiteX9" fmla="*/ 184150 w 376085"/>
                  <a:gd name="connsiteY9" fmla="*/ 403225 h 1031875"/>
                  <a:gd name="connsiteX10" fmla="*/ 190500 w 376085"/>
                  <a:gd name="connsiteY10" fmla="*/ 454025 h 1031875"/>
                  <a:gd name="connsiteX11" fmla="*/ 190500 w 376085"/>
                  <a:gd name="connsiteY11" fmla="*/ 454025 h 1031875"/>
                  <a:gd name="connsiteX12" fmla="*/ 193675 w 376085"/>
                  <a:gd name="connsiteY12" fmla="*/ 511175 h 1031875"/>
                  <a:gd name="connsiteX13" fmla="*/ 187325 w 376085"/>
                  <a:gd name="connsiteY13" fmla="*/ 536575 h 1031875"/>
                  <a:gd name="connsiteX14" fmla="*/ 187325 w 376085"/>
                  <a:gd name="connsiteY14" fmla="*/ 584200 h 1031875"/>
                  <a:gd name="connsiteX15" fmla="*/ 196850 w 376085"/>
                  <a:gd name="connsiteY15" fmla="*/ 615950 h 1031875"/>
                  <a:gd name="connsiteX16" fmla="*/ 184150 w 376085"/>
                  <a:gd name="connsiteY16" fmla="*/ 647700 h 1031875"/>
                  <a:gd name="connsiteX17" fmla="*/ 193675 w 376085"/>
                  <a:gd name="connsiteY17" fmla="*/ 695325 h 1031875"/>
                  <a:gd name="connsiteX18" fmla="*/ 193675 w 376085"/>
                  <a:gd name="connsiteY18" fmla="*/ 730250 h 1031875"/>
                  <a:gd name="connsiteX19" fmla="*/ 180975 w 376085"/>
                  <a:gd name="connsiteY19" fmla="*/ 755650 h 1031875"/>
                  <a:gd name="connsiteX20" fmla="*/ 180975 w 376085"/>
                  <a:gd name="connsiteY20" fmla="*/ 800100 h 1031875"/>
                  <a:gd name="connsiteX21" fmla="*/ 155575 w 376085"/>
                  <a:gd name="connsiteY21" fmla="*/ 831850 h 1031875"/>
                  <a:gd name="connsiteX22" fmla="*/ 0 w 376085"/>
                  <a:gd name="connsiteY22" fmla="*/ 917575 h 1031875"/>
                  <a:gd name="connsiteX23" fmla="*/ 44450 w 376085"/>
                  <a:gd name="connsiteY23" fmla="*/ 933450 h 1031875"/>
                  <a:gd name="connsiteX24" fmla="*/ 79375 w 376085"/>
                  <a:gd name="connsiteY24" fmla="*/ 923925 h 1031875"/>
                  <a:gd name="connsiteX25" fmla="*/ 130175 w 376085"/>
                  <a:gd name="connsiteY25" fmla="*/ 917575 h 1031875"/>
                  <a:gd name="connsiteX26" fmla="*/ 139700 w 376085"/>
                  <a:gd name="connsiteY26" fmla="*/ 939800 h 1031875"/>
                  <a:gd name="connsiteX27" fmla="*/ 133350 w 376085"/>
                  <a:gd name="connsiteY27" fmla="*/ 974725 h 1031875"/>
                  <a:gd name="connsiteX28" fmla="*/ 123825 w 376085"/>
                  <a:gd name="connsiteY28" fmla="*/ 1006475 h 1031875"/>
                  <a:gd name="connsiteX29" fmla="*/ 136525 w 376085"/>
                  <a:gd name="connsiteY29" fmla="*/ 1025525 h 1031875"/>
                  <a:gd name="connsiteX30" fmla="*/ 152400 w 376085"/>
                  <a:gd name="connsiteY30" fmla="*/ 1031875 h 1031875"/>
                  <a:gd name="connsiteX31" fmla="*/ 152400 w 376085"/>
                  <a:gd name="connsiteY31" fmla="*/ 1031875 h 1031875"/>
                  <a:gd name="connsiteX32" fmla="*/ 155575 w 376085"/>
                  <a:gd name="connsiteY32" fmla="*/ 1000125 h 1031875"/>
                  <a:gd name="connsiteX33" fmla="*/ 184150 w 376085"/>
                  <a:gd name="connsiteY33" fmla="*/ 984250 h 1031875"/>
                  <a:gd name="connsiteX34" fmla="*/ 212725 w 376085"/>
                  <a:gd name="connsiteY34" fmla="*/ 965200 h 1031875"/>
                  <a:gd name="connsiteX35" fmla="*/ 222250 w 376085"/>
                  <a:gd name="connsiteY35" fmla="*/ 927100 h 1031875"/>
                  <a:gd name="connsiteX36" fmla="*/ 254000 w 376085"/>
                  <a:gd name="connsiteY36" fmla="*/ 936625 h 1031875"/>
                  <a:gd name="connsiteX37" fmla="*/ 292100 w 376085"/>
                  <a:gd name="connsiteY37" fmla="*/ 968375 h 1031875"/>
                  <a:gd name="connsiteX38" fmla="*/ 327025 w 376085"/>
                  <a:gd name="connsiteY38" fmla="*/ 993775 h 1031875"/>
                  <a:gd name="connsiteX39" fmla="*/ 355600 w 376085"/>
                  <a:gd name="connsiteY39" fmla="*/ 1012825 h 1031875"/>
                  <a:gd name="connsiteX40" fmla="*/ 342900 w 376085"/>
                  <a:gd name="connsiteY40" fmla="*/ 974725 h 1031875"/>
                  <a:gd name="connsiteX41" fmla="*/ 330200 w 376085"/>
                  <a:gd name="connsiteY41" fmla="*/ 939800 h 1031875"/>
                  <a:gd name="connsiteX42" fmla="*/ 330200 w 376085"/>
                  <a:gd name="connsiteY42" fmla="*/ 939800 h 1031875"/>
                  <a:gd name="connsiteX43" fmla="*/ 347325 w 376085"/>
                  <a:gd name="connsiteY43" fmla="*/ 908846 h 1031875"/>
                  <a:gd name="connsiteX44" fmla="*/ 368300 w 376085"/>
                  <a:gd name="connsiteY44" fmla="*/ 911225 h 1031875"/>
                  <a:gd name="connsiteX45" fmla="*/ 203200 w 376085"/>
                  <a:gd name="connsiteY45" fmla="*/ 190501 h 1031875"/>
                  <a:gd name="connsiteX46" fmla="*/ 212726 w 376085"/>
                  <a:gd name="connsiteY46" fmla="*/ 101601 h 1031875"/>
                  <a:gd name="connsiteX47" fmla="*/ 82550 w 376085"/>
                  <a:gd name="connsiteY47" fmla="*/ 0 h 1031875"/>
                  <a:gd name="connsiteX0" fmla="*/ 76200 w 355600"/>
                  <a:gd name="connsiteY0" fmla="*/ 3175 h 1031875"/>
                  <a:gd name="connsiteX1" fmla="*/ 69850 w 355600"/>
                  <a:gd name="connsiteY1" fmla="*/ 44450 h 1031875"/>
                  <a:gd name="connsiteX2" fmla="*/ 85725 w 355600"/>
                  <a:gd name="connsiteY2" fmla="*/ 69850 h 1031875"/>
                  <a:gd name="connsiteX3" fmla="*/ 114300 w 355600"/>
                  <a:gd name="connsiteY3" fmla="*/ 98425 h 1031875"/>
                  <a:gd name="connsiteX4" fmla="*/ 149225 w 355600"/>
                  <a:gd name="connsiteY4" fmla="*/ 130175 h 1031875"/>
                  <a:gd name="connsiteX5" fmla="*/ 168275 w 355600"/>
                  <a:gd name="connsiteY5" fmla="*/ 161925 h 1031875"/>
                  <a:gd name="connsiteX6" fmla="*/ 174625 w 355600"/>
                  <a:gd name="connsiteY6" fmla="*/ 219075 h 1031875"/>
                  <a:gd name="connsiteX7" fmla="*/ 168275 w 355600"/>
                  <a:gd name="connsiteY7" fmla="*/ 269875 h 1031875"/>
                  <a:gd name="connsiteX8" fmla="*/ 168275 w 355600"/>
                  <a:gd name="connsiteY8" fmla="*/ 323850 h 1031875"/>
                  <a:gd name="connsiteX9" fmla="*/ 184150 w 355600"/>
                  <a:gd name="connsiteY9" fmla="*/ 403225 h 1031875"/>
                  <a:gd name="connsiteX10" fmla="*/ 190500 w 355600"/>
                  <a:gd name="connsiteY10" fmla="*/ 454025 h 1031875"/>
                  <a:gd name="connsiteX11" fmla="*/ 190500 w 355600"/>
                  <a:gd name="connsiteY11" fmla="*/ 454025 h 1031875"/>
                  <a:gd name="connsiteX12" fmla="*/ 193675 w 355600"/>
                  <a:gd name="connsiteY12" fmla="*/ 511175 h 1031875"/>
                  <a:gd name="connsiteX13" fmla="*/ 187325 w 355600"/>
                  <a:gd name="connsiteY13" fmla="*/ 536575 h 1031875"/>
                  <a:gd name="connsiteX14" fmla="*/ 187325 w 355600"/>
                  <a:gd name="connsiteY14" fmla="*/ 584200 h 1031875"/>
                  <a:gd name="connsiteX15" fmla="*/ 196850 w 355600"/>
                  <a:gd name="connsiteY15" fmla="*/ 615950 h 1031875"/>
                  <a:gd name="connsiteX16" fmla="*/ 184150 w 355600"/>
                  <a:gd name="connsiteY16" fmla="*/ 647700 h 1031875"/>
                  <a:gd name="connsiteX17" fmla="*/ 193675 w 355600"/>
                  <a:gd name="connsiteY17" fmla="*/ 695325 h 1031875"/>
                  <a:gd name="connsiteX18" fmla="*/ 193675 w 355600"/>
                  <a:gd name="connsiteY18" fmla="*/ 730250 h 1031875"/>
                  <a:gd name="connsiteX19" fmla="*/ 180975 w 355600"/>
                  <a:gd name="connsiteY19" fmla="*/ 755650 h 1031875"/>
                  <a:gd name="connsiteX20" fmla="*/ 180975 w 355600"/>
                  <a:gd name="connsiteY20" fmla="*/ 800100 h 1031875"/>
                  <a:gd name="connsiteX21" fmla="*/ 155575 w 355600"/>
                  <a:gd name="connsiteY21" fmla="*/ 831850 h 1031875"/>
                  <a:gd name="connsiteX22" fmla="*/ 0 w 355600"/>
                  <a:gd name="connsiteY22" fmla="*/ 917575 h 1031875"/>
                  <a:gd name="connsiteX23" fmla="*/ 44450 w 355600"/>
                  <a:gd name="connsiteY23" fmla="*/ 933450 h 1031875"/>
                  <a:gd name="connsiteX24" fmla="*/ 79375 w 355600"/>
                  <a:gd name="connsiteY24" fmla="*/ 923925 h 1031875"/>
                  <a:gd name="connsiteX25" fmla="*/ 130175 w 355600"/>
                  <a:gd name="connsiteY25" fmla="*/ 917575 h 1031875"/>
                  <a:gd name="connsiteX26" fmla="*/ 139700 w 355600"/>
                  <a:gd name="connsiteY26" fmla="*/ 939800 h 1031875"/>
                  <a:gd name="connsiteX27" fmla="*/ 133350 w 355600"/>
                  <a:gd name="connsiteY27" fmla="*/ 974725 h 1031875"/>
                  <a:gd name="connsiteX28" fmla="*/ 123825 w 355600"/>
                  <a:gd name="connsiteY28" fmla="*/ 1006475 h 1031875"/>
                  <a:gd name="connsiteX29" fmla="*/ 136525 w 355600"/>
                  <a:gd name="connsiteY29" fmla="*/ 1025525 h 1031875"/>
                  <a:gd name="connsiteX30" fmla="*/ 152400 w 355600"/>
                  <a:gd name="connsiteY30" fmla="*/ 1031875 h 1031875"/>
                  <a:gd name="connsiteX31" fmla="*/ 152400 w 355600"/>
                  <a:gd name="connsiteY31" fmla="*/ 1031875 h 1031875"/>
                  <a:gd name="connsiteX32" fmla="*/ 155575 w 355600"/>
                  <a:gd name="connsiteY32" fmla="*/ 1000125 h 1031875"/>
                  <a:gd name="connsiteX33" fmla="*/ 184150 w 355600"/>
                  <a:gd name="connsiteY33" fmla="*/ 984250 h 1031875"/>
                  <a:gd name="connsiteX34" fmla="*/ 212725 w 355600"/>
                  <a:gd name="connsiteY34" fmla="*/ 965200 h 1031875"/>
                  <a:gd name="connsiteX35" fmla="*/ 222250 w 355600"/>
                  <a:gd name="connsiteY35" fmla="*/ 927100 h 1031875"/>
                  <a:gd name="connsiteX36" fmla="*/ 254000 w 355600"/>
                  <a:gd name="connsiteY36" fmla="*/ 936625 h 1031875"/>
                  <a:gd name="connsiteX37" fmla="*/ 292100 w 355600"/>
                  <a:gd name="connsiteY37" fmla="*/ 968375 h 1031875"/>
                  <a:gd name="connsiteX38" fmla="*/ 327025 w 355600"/>
                  <a:gd name="connsiteY38" fmla="*/ 993775 h 1031875"/>
                  <a:gd name="connsiteX39" fmla="*/ 355600 w 355600"/>
                  <a:gd name="connsiteY39" fmla="*/ 1012825 h 1031875"/>
                  <a:gd name="connsiteX40" fmla="*/ 342900 w 355600"/>
                  <a:gd name="connsiteY40" fmla="*/ 974725 h 1031875"/>
                  <a:gd name="connsiteX41" fmla="*/ 330200 w 355600"/>
                  <a:gd name="connsiteY41" fmla="*/ 939800 h 1031875"/>
                  <a:gd name="connsiteX42" fmla="*/ 330200 w 355600"/>
                  <a:gd name="connsiteY42" fmla="*/ 939800 h 1031875"/>
                  <a:gd name="connsiteX43" fmla="*/ 347325 w 355600"/>
                  <a:gd name="connsiteY43" fmla="*/ 908846 h 1031875"/>
                  <a:gd name="connsiteX44" fmla="*/ 276225 w 355600"/>
                  <a:gd name="connsiteY44" fmla="*/ 835025 h 1031875"/>
                  <a:gd name="connsiteX45" fmla="*/ 203200 w 355600"/>
                  <a:gd name="connsiteY45" fmla="*/ 190501 h 1031875"/>
                  <a:gd name="connsiteX46" fmla="*/ 212726 w 355600"/>
                  <a:gd name="connsiteY46" fmla="*/ 101601 h 1031875"/>
                  <a:gd name="connsiteX47" fmla="*/ 82550 w 355600"/>
                  <a:gd name="connsiteY47" fmla="*/ 0 h 1031875"/>
                  <a:gd name="connsiteX0" fmla="*/ 76200 w 407929"/>
                  <a:gd name="connsiteY0" fmla="*/ 3175 h 1031875"/>
                  <a:gd name="connsiteX1" fmla="*/ 69850 w 407929"/>
                  <a:gd name="connsiteY1" fmla="*/ 44450 h 1031875"/>
                  <a:gd name="connsiteX2" fmla="*/ 85725 w 407929"/>
                  <a:gd name="connsiteY2" fmla="*/ 69850 h 1031875"/>
                  <a:gd name="connsiteX3" fmla="*/ 114300 w 407929"/>
                  <a:gd name="connsiteY3" fmla="*/ 98425 h 1031875"/>
                  <a:gd name="connsiteX4" fmla="*/ 149225 w 407929"/>
                  <a:gd name="connsiteY4" fmla="*/ 130175 h 1031875"/>
                  <a:gd name="connsiteX5" fmla="*/ 168275 w 407929"/>
                  <a:gd name="connsiteY5" fmla="*/ 161925 h 1031875"/>
                  <a:gd name="connsiteX6" fmla="*/ 174625 w 407929"/>
                  <a:gd name="connsiteY6" fmla="*/ 219075 h 1031875"/>
                  <a:gd name="connsiteX7" fmla="*/ 168275 w 407929"/>
                  <a:gd name="connsiteY7" fmla="*/ 269875 h 1031875"/>
                  <a:gd name="connsiteX8" fmla="*/ 168275 w 407929"/>
                  <a:gd name="connsiteY8" fmla="*/ 323850 h 1031875"/>
                  <a:gd name="connsiteX9" fmla="*/ 184150 w 407929"/>
                  <a:gd name="connsiteY9" fmla="*/ 403225 h 1031875"/>
                  <a:gd name="connsiteX10" fmla="*/ 190500 w 407929"/>
                  <a:gd name="connsiteY10" fmla="*/ 454025 h 1031875"/>
                  <a:gd name="connsiteX11" fmla="*/ 190500 w 407929"/>
                  <a:gd name="connsiteY11" fmla="*/ 454025 h 1031875"/>
                  <a:gd name="connsiteX12" fmla="*/ 193675 w 407929"/>
                  <a:gd name="connsiteY12" fmla="*/ 511175 h 1031875"/>
                  <a:gd name="connsiteX13" fmla="*/ 187325 w 407929"/>
                  <a:gd name="connsiteY13" fmla="*/ 536575 h 1031875"/>
                  <a:gd name="connsiteX14" fmla="*/ 187325 w 407929"/>
                  <a:gd name="connsiteY14" fmla="*/ 584200 h 1031875"/>
                  <a:gd name="connsiteX15" fmla="*/ 196850 w 407929"/>
                  <a:gd name="connsiteY15" fmla="*/ 615950 h 1031875"/>
                  <a:gd name="connsiteX16" fmla="*/ 184150 w 407929"/>
                  <a:gd name="connsiteY16" fmla="*/ 647700 h 1031875"/>
                  <a:gd name="connsiteX17" fmla="*/ 193675 w 407929"/>
                  <a:gd name="connsiteY17" fmla="*/ 695325 h 1031875"/>
                  <a:gd name="connsiteX18" fmla="*/ 193675 w 407929"/>
                  <a:gd name="connsiteY18" fmla="*/ 730250 h 1031875"/>
                  <a:gd name="connsiteX19" fmla="*/ 180975 w 407929"/>
                  <a:gd name="connsiteY19" fmla="*/ 755650 h 1031875"/>
                  <a:gd name="connsiteX20" fmla="*/ 180975 w 407929"/>
                  <a:gd name="connsiteY20" fmla="*/ 800100 h 1031875"/>
                  <a:gd name="connsiteX21" fmla="*/ 155575 w 407929"/>
                  <a:gd name="connsiteY21" fmla="*/ 831850 h 1031875"/>
                  <a:gd name="connsiteX22" fmla="*/ 0 w 407929"/>
                  <a:gd name="connsiteY22" fmla="*/ 917575 h 1031875"/>
                  <a:gd name="connsiteX23" fmla="*/ 44450 w 407929"/>
                  <a:gd name="connsiteY23" fmla="*/ 933450 h 1031875"/>
                  <a:gd name="connsiteX24" fmla="*/ 79375 w 407929"/>
                  <a:gd name="connsiteY24" fmla="*/ 923925 h 1031875"/>
                  <a:gd name="connsiteX25" fmla="*/ 130175 w 407929"/>
                  <a:gd name="connsiteY25" fmla="*/ 917575 h 1031875"/>
                  <a:gd name="connsiteX26" fmla="*/ 139700 w 407929"/>
                  <a:gd name="connsiteY26" fmla="*/ 939800 h 1031875"/>
                  <a:gd name="connsiteX27" fmla="*/ 133350 w 407929"/>
                  <a:gd name="connsiteY27" fmla="*/ 974725 h 1031875"/>
                  <a:gd name="connsiteX28" fmla="*/ 123825 w 407929"/>
                  <a:gd name="connsiteY28" fmla="*/ 1006475 h 1031875"/>
                  <a:gd name="connsiteX29" fmla="*/ 136525 w 407929"/>
                  <a:gd name="connsiteY29" fmla="*/ 1025525 h 1031875"/>
                  <a:gd name="connsiteX30" fmla="*/ 152400 w 407929"/>
                  <a:gd name="connsiteY30" fmla="*/ 1031875 h 1031875"/>
                  <a:gd name="connsiteX31" fmla="*/ 152400 w 407929"/>
                  <a:gd name="connsiteY31" fmla="*/ 1031875 h 1031875"/>
                  <a:gd name="connsiteX32" fmla="*/ 155575 w 407929"/>
                  <a:gd name="connsiteY32" fmla="*/ 1000125 h 1031875"/>
                  <a:gd name="connsiteX33" fmla="*/ 184150 w 407929"/>
                  <a:gd name="connsiteY33" fmla="*/ 984250 h 1031875"/>
                  <a:gd name="connsiteX34" fmla="*/ 212725 w 407929"/>
                  <a:gd name="connsiteY34" fmla="*/ 965200 h 1031875"/>
                  <a:gd name="connsiteX35" fmla="*/ 222250 w 407929"/>
                  <a:gd name="connsiteY35" fmla="*/ 927100 h 1031875"/>
                  <a:gd name="connsiteX36" fmla="*/ 254000 w 407929"/>
                  <a:gd name="connsiteY36" fmla="*/ 936625 h 1031875"/>
                  <a:gd name="connsiteX37" fmla="*/ 292100 w 407929"/>
                  <a:gd name="connsiteY37" fmla="*/ 968375 h 1031875"/>
                  <a:gd name="connsiteX38" fmla="*/ 327025 w 407929"/>
                  <a:gd name="connsiteY38" fmla="*/ 993775 h 1031875"/>
                  <a:gd name="connsiteX39" fmla="*/ 355600 w 407929"/>
                  <a:gd name="connsiteY39" fmla="*/ 1012825 h 1031875"/>
                  <a:gd name="connsiteX40" fmla="*/ 342900 w 407929"/>
                  <a:gd name="connsiteY40" fmla="*/ 974725 h 1031875"/>
                  <a:gd name="connsiteX41" fmla="*/ 330200 w 407929"/>
                  <a:gd name="connsiteY41" fmla="*/ 939800 h 1031875"/>
                  <a:gd name="connsiteX42" fmla="*/ 330200 w 407929"/>
                  <a:gd name="connsiteY42" fmla="*/ 939800 h 1031875"/>
                  <a:gd name="connsiteX43" fmla="*/ 407650 w 407929"/>
                  <a:gd name="connsiteY43" fmla="*/ 883446 h 1031875"/>
                  <a:gd name="connsiteX44" fmla="*/ 276225 w 407929"/>
                  <a:gd name="connsiteY44" fmla="*/ 835025 h 1031875"/>
                  <a:gd name="connsiteX45" fmla="*/ 203200 w 407929"/>
                  <a:gd name="connsiteY45" fmla="*/ 190501 h 1031875"/>
                  <a:gd name="connsiteX46" fmla="*/ 212726 w 407929"/>
                  <a:gd name="connsiteY46" fmla="*/ 101601 h 1031875"/>
                  <a:gd name="connsiteX47" fmla="*/ 82550 w 407929"/>
                  <a:gd name="connsiteY47" fmla="*/ 0 h 1031875"/>
                  <a:gd name="connsiteX0" fmla="*/ 76200 w 407917"/>
                  <a:gd name="connsiteY0" fmla="*/ 3175 h 1031875"/>
                  <a:gd name="connsiteX1" fmla="*/ 69850 w 407917"/>
                  <a:gd name="connsiteY1" fmla="*/ 44450 h 1031875"/>
                  <a:gd name="connsiteX2" fmla="*/ 85725 w 407917"/>
                  <a:gd name="connsiteY2" fmla="*/ 69850 h 1031875"/>
                  <a:gd name="connsiteX3" fmla="*/ 114300 w 407917"/>
                  <a:gd name="connsiteY3" fmla="*/ 98425 h 1031875"/>
                  <a:gd name="connsiteX4" fmla="*/ 149225 w 407917"/>
                  <a:gd name="connsiteY4" fmla="*/ 130175 h 1031875"/>
                  <a:gd name="connsiteX5" fmla="*/ 168275 w 407917"/>
                  <a:gd name="connsiteY5" fmla="*/ 161925 h 1031875"/>
                  <a:gd name="connsiteX6" fmla="*/ 174625 w 407917"/>
                  <a:gd name="connsiteY6" fmla="*/ 219075 h 1031875"/>
                  <a:gd name="connsiteX7" fmla="*/ 168275 w 407917"/>
                  <a:gd name="connsiteY7" fmla="*/ 269875 h 1031875"/>
                  <a:gd name="connsiteX8" fmla="*/ 168275 w 407917"/>
                  <a:gd name="connsiteY8" fmla="*/ 323850 h 1031875"/>
                  <a:gd name="connsiteX9" fmla="*/ 184150 w 407917"/>
                  <a:gd name="connsiteY9" fmla="*/ 403225 h 1031875"/>
                  <a:gd name="connsiteX10" fmla="*/ 190500 w 407917"/>
                  <a:gd name="connsiteY10" fmla="*/ 454025 h 1031875"/>
                  <a:gd name="connsiteX11" fmla="*/ 190500 w 407917"/>
                  <a:gd name="connsiteY11" fmla="*/ 454025 h 1031875"/>
                  <a:gd name="connsiteX12" fmla="*/ 193675 w 407917"/>
                  <a:gd name="connsiteY12" fmla="*/ 511175 h 1031875"/>
                  <a:gd name="connsiteX13" fmla="*/ 187325 w 407917"/>
                  <a:gd name="connsiteY13" fmla="*/ 536575 h 1031875"/>
                  <a:gd name="connsiteX14" fmla="*/ 187325 w 407917"/>
                  <a:gd name="connsiteY14" fmla="*/ 584200 h 1031875"/>
                  <a:gd name="connsiteX15" fmla="*/ 196850 w 407917"/>
                  <a:gd name="connsiteY15" fmla="*/ 615950 h 1031875"/>
                  <a:gd name="connsiteX16" fmla="*/ 184150 w 407917"/>
                  <a:gd name="connsiteY16" fmla="*/ 647700 h 1031875"/>
                  <a:gd name="connsiteX17" fmla="*/ 193675 w 407917"/>
                  <a:gd name="connsiteY17" fmla="*/ 695325 h 1031875"/>
                  <a:gd name="connsiteX18" fmla="*/ 193675 w 407917"/>
                  <a:gd name="connsiteY18" fmla="*/ 730250 h 1031875"/>
                  <a:gd name="connsiteX19" fmla="*/ 180975 w 407917"/>
                  <a:gd name="connsiteY19" fmla="*/ 755650 h 1031875"/>
                  <a:gd name="connsiteX20" fmla="*/ 180975 w 407917"/>
                  <a:gd name="connsiteY20" fmla="*/ 800100 h 1031875"/>
                  <a:gd name="connsiteX21" fmla="*/ 155575 w 407917"/>
                  <a:gd name="connsiteY21" fmla="*/ 831850 h 1031875"/>
                  <a:gd name="connsiteX22" fmla="*/ 0 w 407917"/>
                  <a:gd name="connsiteY22" fmla="*/ 917575 h 1031875"/>
                  <a:gd name="connsiteX23" fmla="*/ 44450 w 407917"/>
                  <a:gd name="connsiteY23" fmla="*/ 933450 h 1031875"/>
                  <a:gd name="connsiteX24" fmla="*/ 79375 w 407917"/>
                  <a:gd name="connsiteY24" fmla="*/ 923925 h 1031875"/>
                  <a:gd name="connsiteX25" fmla="*/ 130175 w 407917"/>
                  <a:gd name="connsiteY25" fmla="*/ 917575 h 1031875"/>
                  <a:gd name="connsiteX26" fmla="*/ 139700 w 407917"/>
                  <a:gd name="connsiteY26" fmla="*/ 939800 h 1031875"/>
                  <a:gd name="connsiteX27" fmla="*/ 133350 w 407917"/>
                  <a:gd name="connsiteY27" fmla="*/ 974725 h 1031875"/>
                  <a:gd name="connsiteX28" fmla="*/ 123825 w 407917"/>
                  <a:gd name="connsiteY28" fmla="*/ 1006475 h 1031875"/>
                  <a:gd name="connsiteX29" fmla="*/ 136525 w 407917"/>
                  <a:gd name="connsiteY29" fmla="*/ 1025525 h 1031875"/>
                  <a:gd name="connsiteX30" fmla="*/ 152400 w 407917"/>
                  <a:gd name="connsiteY30" fmla="*/ 1031875 h 1031875"/>
                  <a:gd name="connsiteX31" fmla="*/ 152400 w 407917"/>
                  <a:gd name="connsiteY31" fmla="*/ 1031875 h 1031875"/>
                  <a:gd name="connsiteX32" fmla="*/ 155575 w 407917"/>
                  <a:gd name="connsiteY32" fmla="*/ 1000125 h 1031875"/>
                  <a:gd name="connsiteX33" fmla="*/ 184150 w 407917"/>
                  <a:gd name="connsiteY33" fmla="*/ 984250 h 1031875"/>
                  <a:gd name="connsiteX34" fmla="*/ 212725 w 407917"/>
                  <a:gd name="connsiteY34" fmla="*/ 965200 h 1031875"/>
                  <a:gd name="connsiteX35" fmla="*/ 222250 w 407917"/>
                  <a:gd name="connsiteY35" fmla="*/ 927100 h 1031875"/>
                  <a:gd name="connsiteX36" fmla="*/ 254000 w 407917"/>
                  <a:gd name="connsiteY36" fmla="*/ 936625 h 1031875"/>
                  <a:gd name="connsiteX37" fmla="*/ 292100 w 407917"/>
                  <a:gd name="connsiteY37" fmla="*/ 968375 h 1031875"/>
                  <a:gd name="connsiteX38" fmla="*/ 327025 w 407917"/>
                  <a:gd name="connsiteY38" fmla="*/ 993775 h 1031875"/>
                  <a:gd name="connsiteX39" fmla="*/ 355600 w 407917"/>
                  <a:gd name="connsiteY39" fmla="*/ 1012825 h 1031875"/>
                  <a:gd name="connsiteX40" fmla="*/ 342900 w 407917"/>
                  <a:gd name="connsiteY40" fmla="*/ 974725 h 1031875"/>
                  <a:gd name="connsiteX41" fmla="*/ 330200 w 407917"/>
                  <a:gd name="connsiteY41" fmla="*/ 939800 h 1031875"/>
                  <a:gd name="connsiteX42" fmla="*/ 330200 w 407917"/>
                  <a:gd name="connsiteY42" fmla="*/ 939800 h 1031875"/>
                  <a:gd name="connsiteX43" fmla="*/ 407650 w 407917"/>
                  <a:gd name="connsiteY43" fmla="*/ 883446 h 1031875"/>
                  <a:gd name="connsiteX44" fmla="*/ 276225 w 407917"/>
                  <a:gd name="connsiteY44" fmla="*/ 835025 h 1031875"/>
                  <a:gd name="connsiteX45" fmla="*/ 233025 w 407917"/>
                  <a:gd name="connsiteY45" fmla="*/ 740571 h 1031875"/>
                  <a:gd name="connsiteX46" fmla="*/ 203200 w 407917"/>
                  <a:gd name="connsiteY46" fmla="*/ 190501 h 1031875"/>
                  <a:gd name="connsiteX47" fmla="*/ 212726 w 407917"/>
                  <a:gd name="connsiteY47" fmla="*/ 101601 h 1031875"/>
                  <a:gd name="connsiteX48" fmla="*/ 82550 w 407917"/>
                  <a:gd name="connsiteY48" fmla="*/ 0 h 1031875"/>
                  <a:gd name="connsiteX0" fmla="*/ 76200 w 407917"/>
                  <a:gd name="connsiteY0" fmla="*/ 3175 h 1031875"/>
                  <a:gd name="connsiteX1" fmla="*/ 69850 w 407917"/>
                  <a:gd name="connsiteY1" fmla="*/ 44450 h 1031875"/>
                  <a:gd name="connsiteX2" fmla="*/ 85725 w 407917"/>
                  <a:gd name="connsiteY2" fmla="*/ 69850 h 1031875"/>
                  <a:gd name="connsiteX3" fmla="*/ 114300 w 407917"/>
                  <a:gd name="connsiteY3" fmla="*/ 98425 h 1031875"/>
                  <a:gd name="connsiteX4" fmla="*/ 149225 w 407917"/>
                  <a:gd name="connsiteY4" fmla="*/ 130175 h 1031875"/>
                  <a:gd name="connsiteX5" fmla="*/ 168275 w 407917"/>
                  <a:gd name="connsiteY5" fmla="*/ 161925 h 1031875"/>
                  <a:gd name="connsiteX6" fmla="*/ 174625 w 407917"/>
                  <a:gd name="connsiteY6" fmla="*/ 219075 h 1031875"/>
                  <a:gd name="connsiteX7" fmla="*/ 168275 w 407917"/>
                  <a:gd name="connsiteY7" fmla="*/ 269875 h 1031875"/>
                  <a:gd name="connsiteX8" fmla="*/ 168275 w 407917"/>
                  <a:gd name="connsiteY8" fmla="*/ 323850 h 1031875"/>
                  <a:gd name="connsiteX9" fmla="*/ 184150 w 407917"/>
                  <a:gd name="connsiteY9" fmla="*/ 403225 h 1031875"/>
                  <a:gd name="connsiteX10" fmla="*/ 190500 w 407917"/>
                  <a:gd name="connsiteY10" fmla="*/ 454025 h 1031875"/>
                  <a:gd name="connsiteX11" fmla="*/ 190500 w 407917"/>
                  <a:gd name="connsiteY11" fmla="*/ 454025 h 1031875"/>
                  <a:gd name="connsiteX12" fmla="*/ 193675 w 407917"/>
                  <a:gd name="connsiteY12" fmla="*/ 511175 h 1031875"/>
                  <a:gd name="connsiteX13" fmla="*/ 187325 w 407917"/>
                  <a:gd name="connsiteY13" fmla="*/ 536575 h 1031875"/>
                  <a:gd name="connsiteX14" fmla="*/ 187325 w 407917"/>
                  <a:gd name="connsiteY14" fmla="*/ 584200 h 1031875"/>
                  <a:gd name="connsiteX15" fmla="*/ 196850 w 407917"/>
                  <a:gd name="connsiteY15" fmla="*/ 615950 h 1031875"/>
                  <a:gd name="connsiteX16" fmla="*/ 184150 w 407917"/>
                  <a:gd name="connsiteY16" fmla="*/ 647700 h 1031875"/>
                  <a:gd name="connsiteX17" fmla="*/ 193675 w 407917"/>
                  <a:gd name="connsiteY17" fmla="*/ 695325 h 1031875"/>
                  <a:gd name="connsiteX18" fmla="*/ 193675 w 407917"/>
                  <a:gd name="connsiteY18" fmla="*/ 730250 h 1031875"/>
                  <a:gd name="connsiteX19" fmla="*/ 180975 w 407917"/>
                  <a:gd name="connsiteY19" fmla="*/ 755650 h 1031875"/>
                  <a:gd name="connsiteX20" fmla="*/ 180975 w 407917"/>
                  <a:gd name="connsiteY20" fmla="*/ 800100 h 1031875"/>
                  <a:gd name="connsiteX21" fmla="*/ 155575 w 407917"/>
                  <a:gd name="connsiteY21" fmla="*/ 831850 h 1031875"/>
                  <a:gd name="connsiteX22" fmla="*/ 0 w 407917"/>
                  <a:gd name="connsiteY22" fmla="*/ 917575 h 1031875"/>
                  <a:gd name="connsiteX23" fmla="*/ 44450 w 407917"/>
                  <a:gd name="connsiteY23" fmla="*/ 933450 h 1031875"/>
                  <a:gd name="connsiteX24" fmla="*/ 79375 w 407917"/>
                  <a:gd name="connsiteY24" fmla="*/ 923925 h 1031875"/>
                  <a:gd name="connsiteX25" fmla="*/ 130175 w 407917"/>
                  <a:gd name="connsiteY25" fmla="*/ 917575 h 1031875"/>
                  <a:gd name="connsiteX26" fmla="*/ 139700 w 407917"/>
                  <a:gd name="connsiteY26" fmla="*/ 939800 h 1031875"/>
                  <a:gd name="connsiteX27" fmla="*/ 133350 w 407917"/>
                  <a:gd name="connsiteY27" fmla="*/ 974725 h 1031875"/>
                  <a:gd name="connsiteX28" fmla="*/ 123825 w 407917"/>
                  <a:gd name="connsiteY28" fmla="*/ 1006475 h 1031875"/>
                  <a:gd name="connsiteX29" fmla="*/ 136525 w 407917"/>
                  <a:gd name="connsiteY29" fmla="*/ 1025525 h 1031875"/>
                  <a:gd name="connsiteX30" fmla="*/ 152400 w 407917"/>
                  <a:gd name="connsiteY30" fmla="*/ 1031875 h 1031875"/>
                  <a:gd name="connsiteX31" fmla="*/ 152400 w 407917"/>
                  <a:gd name="connsiteY31" fmla="*/ 1031875 h 1031875"/>
                  <a:gd name="connsiteX32" fmla="*/ 155575 w 407917"/>
                  <a:gd name="connsiteY32" fmla="*/ 1000125 h 1031875"/>
                  <a:gd name="connsiteX33" fmla="*/ 184150 w 407917"/>
                  <a:gd name="connsiteY33" fmla="*/ 984250 h 1031875"/>
                  <a:gd name="connsiteX34" fmla="*/ 212725 w 407917"/>
                  <a:gd name="connsiteY34" fmla="*/ 965200 h 1031875"/>
                  <a:gd name="connsiteX35" fmla="*/ 222250 w 407917"/>
                  <a:gd name="connsiteY35" fmla="*/ 927100 h 1031875"/>
                  <a:gd name="connsiteX36" fmla="*/ 254000 w 407917"/>
                  <a:gd name="connsiteY36" fmla="*/ 936625 h 1031875"/>
                  <a:gd name="connsiteX37" fmla="*/ 292100 w 407917"/>
                  <a:gd name="connsiteY37" fmla="*/ 968375 h 1031875"/>
                  <a:gd name="connsiteX38" fmla="*/ 327025 w 407917"/>
                  <a:gd name="connsiteY38" fmla="*/ 993775 h 1031875"/>
                  <a:gd name="connsiteX39" fmla="*/ 355600 w 407917"/>
                  <a:gd name="connsiteY39" fmla="*/ 1012825 h 1031875"/>
                  <a:gd name="connsiteX40" fmla="*/ 342900 w 407917"/>
                  <a:gd name="connsiteY40" fmla="*/ 974725 h 1031875"/>
                  <a:gd name="connsiteX41" fmla="*/ 330200 w 407917"/>
                  <a:gd name="connsiteY41" fmla="*/ 939800 h 1031875"/>
                  <a:gd name="connsiteX42" fmla="*/ 330200 w 407917"/>
                  <a:gd name="connsiteY42" fmla="*/ 939800 h 1031875"/>
                  <a:gd name="connsiteX43" fmla="*/ 407650 w 407917"/>
                  <a:gd name="connsiteY43" fmla="*/ 883446 h 1031875"/>
                  <a:gd name="connsiteX44" fmla="*/ 276225 w 407917"/>
                  <a:gd name="connsiteY44" fmla="*/ 835025 h 1031875"/>
                  <a:gd name="connsiteX45" fmla="*/ 233025 w 407917"/>
                  <a:gd name="connsiteY45" fmla="*/ 740571 h 1031875"/>
                  <a:gd name="connsiteX46" fmla="*/ 236200 w 407917"/>
                  <a:gd name="connsiteY46" fmla="*/ 562771 h 1031875"/>
                  <a:gd name="connsiteX47" fmla="*/ 203200 w 407917"/>
                  <a:gd name="connsiteY47" fmla="*/ 190501 h 1031875"/>
                  <a:gd name="connsiteX48" fmla="*/ 212726 w 407917"/>
                  <a:gd name="connsiteY48" fmla="*/ 101601 h 1031875"/>
                  <a:gd name="connsiteX49" fmla="*/ 82550 w 407917"/>
                  <a:gd name="connsiteY49" fmla="*/ 0 h 1031875"/>
                  <a:gd name="connsiteX0" fmla="*/ 76200 w 407917"/>
                  <a:gd name="connsiteY0" fmla="*/ 3175 h 1031875"/>
                  <a:gd name="connsiteX1" fmla="*/ 69850 w 407917"/>
                  <a:gd name="connsiteY1" fmla="*/ 44450 h 1031875"/>
                  <a:gd name="connsiteX2" fmla="*/ 85725 w 407917"/>
                  <a:gd name="connsiteY2" fmla="*/ 69850 h 1031875"/>
                  <a:gd name="connsiteX3" fmla="*/ 114300 w 407917"/>
                  <a:gd name="connsiteY3" fmla="*/ 98425 h 1031875"/>
                  <a:gd name="connsiteX4" fmla="*/ 149225 w 407917"/>
                  <a:gd name="connsiteY4" fmla="*/ 130175 h 1031875"/>
                  <a:gd name="connsiteX5" fmla="*/ 168275 w 407917"/>
                  <a:gd name="connsiteY5" fmla="*/ 161925 h 1031875"/>
                  <a:gd name="connsiteX6" fmla="*/ 174625 w 407917"/>
                  <a:gd name="connsiteY6" fmla="*/ 219075 h 1031875"/>
                  <a:gd name="connsiteX7" fmla="*/ 168275 w 407917"/>
                  <a:gd name="connsiteY7" fmla="*/ 269875 h 1031875"/>
                  <a:gd name="connsiteX8" fmla="*/ 168275 w 407917"/>
                  <a:gd name="connsiteY8" fmla="*/ 323850 h 1031875"/>
                  <a:gd name="connsiteX9" fmla="*/ 184150 w 407917"/>
                  <a:gd name="connsiteY9" fmla="*/ 403225 h 1031875"/>
                  <a:gd name="connsiteX10" fmla="*/ 190500 w 407917"/>
                  <a:gd name="connsiteY10" fmla="*/ 454025 h 1031875"/>
                  <a:gd name="connsiteX11" fmla="*/ 190500 w 407917"/>
                  <a:gd name="connsiteY11" fmla="*/ 454025 h 1031875"/>
                  <a:gd name="connsiteX12" fmla="*/ 193675 w 407917"/>
                  <a:gd name="connsiteY12" fmla="*/ 511175 h 1031875"/>
                  <a:gd name="connsiteX13" fmla="*/ 187325 w 407917"/>
                  <a:gd name="connsiteY13" fmla="*/ 536575 h 1031875"/>
                  <a:gd name="connsiteX14" fmla="*/ 187325 w 407917"/>
                  <a:gd name="connsiteY14" fmla="*/ 584200 h 1031875"/>
                  <a:gd name="connsiteX15" fmla="*/ 196850 w 407917"/>
                  <a:gd name="connsiteY15" fmla="*/ 615950 h 1031875"/>
                  <a:gd name="connsiteX16" fmla="*/ 184150 w 407917"/>
                  <a:gd name="connsiteY16" fmla="*/ 647700 h 1031875"/>
                  <a:gd name="connsiteX17" fmla="*/ 193675 w 407917"/>
                  <a:gd name="connsiteY17" fmla="*/ 695325 h 1031875"/>
                  <a:gd name="connsiteX18" fmla="*/ 193675 w 407917"/>
                  <a:gd name="connsiteY18" fmla="*/ 730250 h 1031875"/>
                  <a:gd name="connsiteX19" fmla="*/ 180975 w 407917"/>
                  <a:gd name="connsiteY19" fmla="*/ 755650 h 1031875"/>
                  <a:gd name="connsiteX20" fmla="*/ 180975 w 407917"/>
                  <a:gd name="connsiteY20" fmla="*/ 800100 h 1031875"/>
                  <a:gd name="connsiteX21" fmla="*/ 155575 w 407917"/>
                  <a:gd name="connsiteY21" fmla="*/ 831850 h 1031875"/>
                  <a:gd name="connsiteX22" fmla="*/ 0 w 407917"/>
                  <a:gd name="connsiteY22" fmla="*/ 917575 h 1031875"/>
                  <a:gd name="connsiteX23" fmla="*/ 44450 w 407917"/>
                  <a:gd name="connsiteY23" fmla="*/ 933450 h 1031875"/>
                  <a:gd name="connsiteX24" fmla="*/ 79375 w 407917"/>
                  <a:gd name="connsiteY24" fmla="*/ 923925 h 1031875"/>
                  <a:gd name="connsiteX25" fmla="*/ 130175 w 407917"/>
                  <a:gd name="connsiteY25" fmla="*/ 917575 h 1031875"/>
                  <a:gd name="connsiteX26" fmla="*/ 139700 w 407917"/>
                  <a:gd name="connsiteY26" fmla="*/ 939800 h 1031875"/>
                  <a:gd name="connsiteX27" fmla="*/ 133350 w 407917"/>
                  <a:gd name="connsiteY27" fmla="*/ 974725 h 1031875"/>
                  <a:gd name="connsiteX28" fmla="*/ 123825 w 407917"/>
                  <a:gd name="connsiteY28" fmla="*/ 1006475 h 1031875"/>
                  <a:gd name="connsiteX29" fmla="*/ 136525 w 407917"/>
                  <a:gd name="connsiteY29" fmla="*/ 1025525 h 1031875"/>
                  <a:gd name="connsiteX30" fmla="*/ 152400 w 407917"/>
                  <a:gd name="connsiteY30" fmla="*/ 1031875 h 1031875"/>
                  <a:gd name="connsiteX31" fmla="*/ 152400 w 407917"/>
                  <a:gd name="connsiteY31" fmla="*/ 1031875 h 1031875"/>
                  <a:gd name="connsiteX32" fmla="*/ 155575 w 407917"/>
                  <a:gd name="connsiteY32" fmla="*/ 1000125 h 1031875"/>
                  <a:gd name="connsiteX33" fmla="*/ 184150 w 407917"/>
                  <a:gd name="connsiteY33" fmla="*/ 984250 h 1031875"/>
                  <a:gd name="connsiteX34" fmla="*/ 212725 w 407917"/>
                  <a:gd name="connsiteY34" fmla="*/ 965200 h 1031875"/>
                  <a:gd name="connsiteX35" fmla="*/ 222250 w 407917"/>
                  <a:gd name="connsiteY35" fmla="*/ 927100 h 1031875"/>
                  <a:gd name="connsiteX36" fmla="*/ 254000 w 407917"/>
                  <a:gd name="connsiteY36" fmla="*/ 936625 h 1031875"/>
                  <a:gd name="connsiteX37" fmla="*/ 292100 w 407917"/>
                  <a:gd name="connsiteY37" fmla="*/ 968375 h 1031875"/>
                  <a:gd name="connsiteX38" fmla="*/ 327025 w 407917"/>
                  <a:gd name="connsiteY38" fmla="*/ 993775 h 1031875"/>
                  <a:gd name="connsiteX39" fmla="*/ 355600 w 407917"/>
                  <a:gd name="connsiteY39" fmla="*/ 1012825 h 1031875"/>
                  <a:gd name="connsiteX40" fmla="*/ 342900 w 407917"/>
                  <a:gd name="connsiteY40" fmla="*/ 974725 h 1031875"/>
                  <a:gd name="connsiteX41" fmla="*/ 330200 w 407917"/>
                  <a:gd name="connsiteY41" fmla="*/ 939800 h 1031875"/>
                  <a:gd name="connsiteX42" fmla="*/ 330200 w 407917"/>
                  <a:gd name="connsiteY42" fmla="*/ 939800 h 1031875"/>
                  <a:gd name="connsiteX43" fmla="*/ 407650 w 407917"/>
                  <a:gd name="connsiteY43" fmla="*/ 883446 h 1031875"/>
                  <a:gd name="connsiteX44" fmla="*/ 276225 w 407917"/>
                  <a:gd name="connsiteY44" fmla="*/ 835025 h 1031875"/>
                  <a:gd name="connsiteX45" fmla="*/ 233025 w 407917"/>
                  <a:gd name="connsiteY45" fmla="*/ 740571 h 1031875"/>
                  <a:gd name="connsiteX46" fmla="*/ 236200 w 407917"/>
                  <a:gd name="connsiteY46" fmla="*/ 562771 h 1031875"/>
                  <a:gd name="connsiteX47" fmla="*/ 203200 w 407917"/>
                  <a:gd name="connsiteY47" fmla="*/ 190501 h 1031875"/>
                  <a:gd name="connsiteX48" fmla="*/ 184151 w 407917"/>
                  <a:gd name="connsiteY48" fmla="*/ 73026 h 1031875"/>
                  <a:gd name="connsiteX49" fmla="*/ 82550 w 407917"/>
                  <a:gd name="connsiteY49" fmla="*/ 0 h 1031875"/>
                  <a:gd name="connsiteX0" fmla="*/ 76200 w 407917"/>
                  <a:gd name="connsiteY0" fmla="*/ 3175 h 1031875"/>
                  <a:gd name="connsiteX1" fmla="*/ 69850 w 407917"/>
                  <a:gd name="connsiteY1" fmla="*/ 44450 h 1031875"/>
                  <a:gd name="connsiteX2" fmla="*/ 85725 w 407917"/>
                  <a:gd name="connsiteY2" fmla="*/ 69850 h 1031875"/>
                  <a:gd name="connsiteX3" fmla="*/ 114300 w 407917"/>
                  <a:gd name="connsiteY3" fmla="*/ 98425 h 1031875"/>
                  <a:gd name="connsiteX4" fmla="*/ 149225 w 407917"/>
                  <a:gd name="connsiteY4" fmla="*/ 130175 h 1031875"/>
                  <a:gd name="connsiteX5" fmla="*/ 168275 w 407917"/>
                  <a:gd name="connsiteY5" fmla="*/ 161925 h 1031875"/>
                  <a:gd name="connsiteX6" fmla="*/ 174625 w 407917"/>
                  <a:gd name="connsiteY6" fmla="*/ 219075 h 1031875"/>
                  <a:gd name="connsiteX7" fmla="*/ 168275 w 407917"/>
                  <a:gd name="connsiteY7" fmla="*/ 269875 h 1031875"/>
                  <a:gd name="connsiteX8" fmla="*/ 168275 w 407917"/>
                  <a:gd name="connsiteY8" fmla="*/ 323850 h 1031875"/>
                  <a:gd name="connsiteX9" fmla="*/ 184150 w 407917"/>
                  <a:gd name="connsiteY9" fmla="*/ 403225 h 1031875"/>
                  <a:gd name="connsiteX10" fmla="*/ 190500 w 407917"/>
                  <a:gd name="connsiteY10" fmla="*/ 454025 h 1031875"/>
                  <a:gd name="connsiteX11" fmla="*/ 190500 w 407917"/>
                  <a:gd name="connsiteY11" fmla="*/ 454025 h 1031875"/>
                  <a:gd name="connsiteX12" fmla="*/ 193675 w 407917"/>
                  <a:gd name="connsiteY12" fmla="*/ 511175 h 1031875"/>
                  <a:gd name="connsiteX13" fmla="*/ 187325 w 407917"/>
                  <a:gd name="connsiteY13" fmla="*/ 536575 h 1031875"/>
                  <a:gd name="connsiteX14" fmla="*/ 187325 w 407917"/>
                  <a:gd name="connsiteY14" fmla="*/ 584200 h 1031875"/>
                  <a:gd name="connsiteX15" fmla="*/ 196850 w 407917"/>
                  <a:gd name="connsiteY15" fmla="*/ 615950 h 1031875"/>
                  <a:gd name="connsiteX16" fmla="*/ 184150 w 407917"/>
                  <a:gd name="connsiteY16" fmla="*/ 647700 h 1031875"/>
                  <a:gd name="connsiteX17" fmla="*/ 193675 w 407917"/>
                  <a:gd name="connsiteY17" fmla="*/ 695325 h 1031875"/>
                  <a:gd name="connsiteX18" fmla="*/ 193675 w 407917"/>
                  <a:gd name="connsiteY18" fmla="*/ 730250 h 1031875"/>
                  <a:gd name="connsiteX19" fmla="*/ 180975 w 407917"/>
                  <a:gd name="connsiteY19" fmla="*/ 755650 h 1031875"/>
                  <a:gd name="connsiteX20" fmla="*/ 180975 w 407917"/>
                  <a:gd name="connsiteY20" fmla="*/ 800100 h 1031875"/>
                  <a:gd name="connsiteX21" fmla="*/ 155575 w 407917"/>
                  <a:gd name="connsiteY21" fmla="*/ 831850 h 1031875"/>
                  <a:gd name="connsiteX22" fmla="*/ 0 w 407917"/>
                  <a:gd name="connsiteY22" fmla="*/ 917575 h 1031875"/>
                  <a:gd name="connsiteX23" fmla="*/ 44450 w 407917"/>
                  <a:gd name="connsiteY23" fmla="*/ 933450 h 1031875"/>
                  <a:gd name="connsiteX24" fmla="*/ 79375 w 407917"/>
                  <a:gd name="connsiteY24" fmla="*/ 923925 h 1031875"/>
                  <a:gd name="connsiteX25" fmla="*/ 130175 w 407917"/>
                  <a:gd name="connsiteY25" fmla="*/ 917575 h 1031875"/>
                  <a:gd name="connsiteX26" fmla="*/ 139700 w 407917"/>
                  <a:gd name="connsiteY26" fmla="*/ 939800 h 1031875"/>
                  <a:gd name="connsiteX27" fmla="*/ 133350 w 407917"/>
                  <a:gd name="connsiteY27" fmla="*/ 974725 h 1031875"/>
                  <a:gd name="connsiteX28" fmla="*/ 123825 w 407917"/>
                  <a:gd name="connsiteY28" fmla="*/ 1006475 h 1031875"/>
                  <a:gd name="connsiteX29" fmla="*/ 136525 w 407917"/>
                  <a:gd name="connsiteY29" fmla="*/ 1025525 h 1031875"/>
                  <a:gd name="connsiteX30" fmla="*/ 152400 w 407917"/>
                  <a:gd name="connsiteY30" fmla="*/ 1031875 h 1031875"/>
                  <a:gd name="connsiteX31" fmla="*/ 152400 w 407917"/>
                  <a:gd name="connsiteY31" fmla="*/ 1031875 h 1031875"/>
                  <a:gd name="connsiteX32" fmla="*/ 155575 w 407917"/>
                  <a:gd name="connsiteY32" fmla="*/ 1000125 h 1031875"/>
                  <a:gd name="connsiteX33" fmla="*/ 184150 w 407917"/>
                  <a:gd name="connsiteY33" fmla="*/ 984250 h 1031875"/>
                  <a:gd name="connsiteX34" fmla="*/ 212725 w 407917"/>
                  <a:gd name="connsiteY34" fmla="*/ 965200 h 1031875"/>
                  <a:gd name="connsiteX35" fmla="*/ 222250 w 407917"/>
                  <a:gd name="connsiteY35" fmla="*/ 927100 h 1031875"/>
                  <a:gd name="connsiteX36" fmla="*/ 254000 w 407917"/>
                  <a:gd name="connsiteY36" fmla="*/ 936625 h 1031875"/>
                  <a:gd name="connsiteX37" fmla="*/ 292100 w 407917"/>
                  <a:gd name="connsiteY37" fmla="*/ 968375 h 1031875"/>
                  <a:gd name="connsiteX38" fmla="*/ 327025 w 407917"/>
                  <a:gd name="connsiteY38" fmla="*/ 993775 h 1031875"/>
                  <a:gd name="connsiteX39" fmla="*/ 355600 w 407917"/>
                  <a:gd name="connsiteY39" fmla="*/ 1012825 h 1031875"/>
                  <a:gd name="connsiteX40" fmla="*/ 342900 w 407917"/>
                  <a:gd name="connsiteY40" fmla="*/ 974725 h 1031875"/>
                  <a:gd name="connsiteX41" fmla="*/ 330200 w 407917"/>
                  <a:gd name="connsiteY41" fmla="*/ 939800 h 1031875"/>
                  <a:gd name="connsiteX42" fmla="*/ 330200 w 407917"/>
                  <a:gd name="connsiteY42" fmla="*/ 939800 h 1031875"/>
                  <a:gd name="connsiteX43" fmla="*/ 407650 w 407917"/>
                  <a:gd name="connsiteY43" fmla="*/ 883446 h 1031875"/>
                  <a:gd name="connsiteX44" fmla="*/ 276225 w 407917"/>
                  <a:gd name="connsiteY44" fmla="*/ 835025 h 1031875"/>
                  <a:gd name="connsiteX45" fmla="*/ 233025 w 407917"/>
                  <a:gd name="connsiteY45" fmla="*/ 740571 h 1031875"/>
                  <a:gd name="connsiteX46" fmla="*/ 236200 w 407917"/>
                  <a:gd name="connsiteY46" fmla="*/ 562771 h 1031875"/>
                  <a:gd name="connsiteX47" fmla="*/ 203200 w 407917"/>
                  <a:gd name="connsiteY47" fmla="*/ 190501 h 1031875"/>
                  <a:gd name="connsiteX48" fmla="*/ 184151 w 407917"/>
                  <a:gd name="connsiteY48" fmla="*/ 73026 h 1031875"/>
                  <a:gd name="connsiteX49" fmla="*/ 82550 w 407917"/>
                  <a:gd name="connsiteY49" fmla="*/ 0 h 1031875"/>
                  <a:gd name="connsiteX0" fmla="*/ 76200 w 407917"/>
                  <a:gd name="connsiteY0" fmla="*/ 3175 h 1031875"/>
                  <a:gd name="connsiteX1" fmla="*/ 69850 w 407917"/>
                  <a:gd name="connsiteY1" fmla="*/ 44450 h 1031875"/>
                  <a:gd name="connsiteX2" fmla="*/ 85725 w 407917"/>
                  <a:gd name="connsiteY2" fmla="*/ 69850 h 1031875"/>
                  <a:gd name="connsiteX3" fmla="*/ 114300 w 407917"/>
                  <a:gd name="connsiteY3" fmla="*/ 98425 h 1031875"/>
                  <a:gd name="connsiteX4" fmla="*/ 149225 w 407917"/>
                  <a:gd name="connsiteY4" fmla="*/ 130175 h 1031875"/>
                  <a:gd name="connsiteX5" fmla="*/ 168275 w 407917"/>
                  <a:gd name="connsiteY5" fmla="*/ 161925 h 1031875"/>
                  <a:gd name="connsiteX6" fmla="*/ 174625 w 407917"/>
                  <a:gd name="connsiteY6" fmla="*/ 219075 h 1031875"/>
                  <a:gd name="connsiteX7" fmla="*/ 168275 w 407917"/>
                  <a:gd name="connsiteY7" fmla="*/ 269875 h 1031875"/>
                  <a:gd name="connsiteX8" fmla="*/ 168275 w 407917"/>
                  <a:gd name="connsiteY8" fmla="*/ 323850 h 1031875"/>
                  <a:gd name="connsiteX9" fmla="*/ 184150 w 407917"/>
                  <a:gd name="connsiteY9" fmla="*/ 403225 h 1031875"/>
                  <a:gd name="connsiteX10" fmla="*/ 190500 w 407917"/>
                  <a:gd name="connsiteY10" fmla="*/ 454025 h 1031875"/>
                  <a:gd name="connsiteX11" fmla="*/ 190500 w 407917"/>
                  <a:gd name="connsiteY11" fmla="*/ 454025 h 1031875"/>
                  <a:gd name="connsiteX12" fmla="*/ 193675 w 407917"/>
                  <a:gd name="connsiteY12" fmla="*/ 511175 h 1031875"/>
                  <a:gd name="connsiteX13" fmla="*/ 187325 w 407917"/>
                  <a:gd name="connsiteY13" fmla="*/ 536575 h 1031875"/>
                  <a:gd name="connsiteX14" fmla="*/ 187325 w 407917"/>
                  <a:gd name="connsiteY14" fmla="*/ 584200 h 1031875"/>
                  <a:gd name="connsiteX15" fmla="*/ 196850 w 407917"/>
                  <a:gd name="connsiteY15" fmla="*/ 615950 h 1031875"/>
                  <a:gd name="connsiteX16" fmla="*/ 184150 w 407917"/>
                  <a:gd name="connsiteY16" fmla="*/ 647700 h 1031875"/>
                  <a:gd name="connsiteX17" fmla="*/ 193675 w 407917"/>
                  <a:gd name="connsiteY17" fmla="*/ 695325 h 1031875"/>
                  <a:gd name="connsiteX18" fmla="*/ 193675 w 407917"/>
                  <a:gd name="connsiteY18" fmla="*/ 730250 h 1031875"/>
                  <a:gd name="connsiteX19" fmla="*/ 180975 w 407917"/>
                  <a:gd name="connsiteY19" fmla="*/ 755650 h 1031875"/>
                  <a:gd name="connsiteX20" fmla="*/ 180975 w 407917"/>
                  <a:gd name="connsiteY20" fmla="*/ 800100 h 1031875"/>
                  <a:gd name="connsiteX21" fmla="*/ 155575 w 407917"/>
                  <a:gd name="connsiteY21" fmla="*/ 831850 h 1031875"/>
                  <a:gd name="connsiteX22" fmla="*/ 0 w 407917"/>
                  <a:gd name="connsiteY22" fmla="*/ 917575 h 1031875"/>
                  <a:gd name="connsiteX23" fmla="*/ 44450 w 407917"/>
                  <a:gd name="connsiteY23" fmla="*/ 933450 h 1031875"/>
                  <a:gd name="connsiteX24" fmla="*/ 79375 w 407917"/>
                  <a:gd name="connsiteY24" fmla="*/ 923925 h 1031875"/>
                  <a:gd name="connsiteX25" fmla="*/ 130175 w 407917"/>
                  <a:gd name="connsiteY25" fmla="*/ 917575 h 1031875"/>
                  <a:gd name="connsiteX26" fmla="*/ 139700 w 407917"/>
                  <a:gd name="connsiteY26" fmla="*/ 939800 h 1031875"/>
                  <a:gd name="connsiteX27" fmla="*/ 133350 w 407917"/>
                  <a:gd name="connsiteY27" fmla="*/ 974725 h 1031875"/>
                  <a:gd name="connsiteX28" fmla="*/ 123825 w 407917"/>
                  <a:gd name="connsiteY28" fmla="*/ 1006475 h 1031875"/>
                  <a:gd name="connsiteX29" fmla="*/ 136525 w 407917"/>
                  <a:gd name="connsiteY29" fmla="*/ 1025525 h 1031875"/>
                  <a:gd name="connsiteX30" fmla="*/ 152400 w 407917"/>
                  <a:gd name="connsiteY30" fmla="*/ 1031875 h 1031875"/>
                  <a:gd name="connsiteX31" fmla="*/ 152400 w 407917"/>
                  <a:gd name="connsiteY31" fmla="*/ 1031875 h 1031875"/>
                  <a:gd name="connsiteX32" fmla="*/ 155575 w 407917"/>
                  <a:gd name="connsiteY32" fmla="*/ 1000125 h 1031875"/>
                  <a:gd name="connsiteX33" fmla="*/ 184150 w 407917"/>
                  <a:gd name="connsiteY33" fmla="*/ 984250 h 1031875"/>
                  <a:gd name="connsiteX34" fmla="*/ 212725 w 407917"/>
                  <a:gd name="connsiteY34" fmla="*/ 965200 h 1031875"/>
                  <a:gd name="connsiteX35" fmla="*/ 222250 w 407917"/>
                  <a:gd name="connsiteY35" fmla="*/ 927100 h 1031875"/>
                  <a:gd name="connsiteX36" fmla="*/ 254000 w 407917"/>
                  <a:gd name="connsiteY36" fmla="*/ 936625 h 1031875"/>
                  <a:gd name="connsiteX37" fmla="*/ 292100 w 407917"/>
                  <a:gd name="connsiteY37" fmla="*/ 968375 h 1031875"/>
                  <a:gd name="connsiteX38" fmla="*/ 327025 w 407917"/>
                  <a:gd name="connsiteY38" fmla="*/ 993775 h 1031875"/>
                  <a:gd name="connsiteX39" fmla="*/ 355600 w 407917"/>
                  <a:gd name="connsiteY39" fmla="*/ 1012825 h 1031875"/>
                  <a:gd name="connsiteX40" fmla="*/ 342900 w 407917"/>
                  <a:gd name="connsiteY40" fmla="*/ 974725 h 1031875"/>
                  <a:gd name="connsiteX41" fmla="*/ 330200 w 407917"/>
                  <a:gd name="connsiteY41" fmla="*/ 939800 h 1031875"/>
                  <a:gd name="connsiteX42" fmla="*/ 330200 w 407917"/>
                  <a:gd name="connsiteY42" fmla="*/ 939800 h 1031875"/>
                  <a:gd name="connsiteX43" fmla="*/ 407650 w 407917"/>
                  <a:gd name="connsiteY43" fmla="*/ 883446 h 1031875"/>
                  <a:gd name="connsiteX44" fmla="*/ 276225 w 407917"/>
                  <a:gd name="connsiteY44" fmla="*/ 835025 h 1031875"/>
                  <a:gd name="connsiteX45" fmla="*/ 233025 w 407917"/>
                  <a:gd name="connsiteY45" fmla="*/ 740571 h 1031875"/>
                  <a:gd name="connsiteX46" fmla="*/ 236200 w 407917"/>
                  <a:gd name="connsiteY46" fmla="*/ 562771 h 1031875"/>
                  <a:gd name="connsiteX47" fmla="*/ 203200 w 407917"/>
                  <a:gd name="connsiteY47" fmla="*/ 190501 h 1031875"/>
                  <a:gd name="connsiteX48" fmla="*/ 280650 w 407917"/>
                  <a:gd name="connsiteY48" fmla="*/ 45246 h 1031875"/>
                  <a:gd name="connsiteX49" fmla="*/ 184151 w 407917"/>
                  <a:gd name="connsiteY49" fmla="*/ 73026 h 1031875"/>
                  <a:gd name="connsiteX50" fmla="*/ 82550 w 407917"/>
                  <a:gd name="connsiteY50" fmla="*/ 0 h 1031875"/>
                  <a:gd name="connsiteX0" fmla="*/ 76200 w 407917"/>
                  <a:gd name="connsiteY0" fmla="*/ 3175 h 1031875"/>
                  <a:gd name="connsiteX1" fmla="*/ 69850 w 407917"/>
                  <a:gd name="connsiteY1" fmla="*/ 44450 h 1031875"/>
                  <a:gd name="connsiteX2" fmla="*/ 85725 w 407917"/>
                  <a:gd name="connsiteY2" fmla="*/ 69850 h 1031875"/>
                  <a:gd name="connsiteX3" fmla="*/ 114300 w 407917"/>
                  <a:gd name="connsiteY3" fmla="*/ 98425 h 1031875"/>
                  <a:gd name="connsiteX4" fmla="*/ 149225 w 407917"/>
                  <a:gd name="connsiteY4" fmla="*/ 130175 h 1031875"/>
                  <a:gd name="connsiteX5" fmla="*/ 168275 w 407917"/>
                  <a:gd name="connsiteY5" fmla="*/ 161925 h 1031875"/>
                  <a:gd name="connsiteX6" fmla="*/ 174625 w 407917"/>
                  <a:gd name="connsiteY6" fmla="*/ 219075 h 1031875"/>
                  <a:gd name="connsiteX7" fmla="*/ 168275 w 407917"/>
                  <a:gd name="connsiteY7" fmla="*/ 269875 h 1031875"/>
                  <a:gd name="connsiteX8" fmla="*/ 168275 w 407917"/>
                  <a:gd name="connsiteY8" fmla="*/ 323850 h 1031875"/>
                  <a:gd name="connsiteX9" fmla="*/ 184150 w 407917"/>
                  <a:gd name="connsiteY9" fmla="*/ 403225 h 1031875"/>
                  <a:gd name="connsiteX10" fmla="*/ 190500 w 407917"/>
                  <a:gd name="connsiteY10" fmla="*/ 454025 h 1031875"/>
                  <a:gd name="connsiteX11" fmla="*/ 190500 w 407917"/>
                  <a:gd name="connsiteY11" fmla="*/ 454025 h 1031875"/>
                  <a:gd name="connsiteX12" fmla="*/ 193675 w 407917"/>
                  <a:gd name="connsiteY12" fmla="*/ 511175 h 1031875"/>
                  <a:gd name="connsiteX13" fmla="*/ 187325 w 407917"/>
                  <a:gd name="connsiteY13" fmla="*/ 536575 h 1031875"/>
                  <a:gd name="connsiteX14" fmla="*/ 187325 w 407917"/>
                  <a:gd name="connsiteY14" fmla="*/ 584200 h 1031875"/>
                  <a:gd name="connsiteX15" fmla="*/ 196850 w 407917"/>
                  <a:gd name="connsiteY15" fmla="*/ 615950 h 1031875"/>
                  <a:gd name="connsiteX16" fmla="*/ 184150 w 407917"/>
                  <a:gd name="connsiteY16" fmla="*/ 647700 h 1031875"/>
                  <a:gd name="connsiteX17" fmla="*/ 193675 w 407917"/>
                  <a:gd name="connsiteY17" fmla="*/ 695325 h 1031875"/>
                  <a:gd name="connsiteX18" fmla="*/ 193675 w 407917"/>
                  <a:gd name="connsiteY18" fmla="*/ 730250 h 1031875"/>
                  <a:gd name="connsiteX19" fmla="*/ 180975 w 407917"/>
                  <a:gd name="connsiteY19" fmla="*/ 755650 h 1031875"/>
                  <a:gd name="connsiteX20" fmla="*/ 180975 w 407917"/>
                  <a:gd name="connsiteY20" fmla="*/ 800100 h 1031875"/>
                  <a:gd name="connsiteX21" fmla="*/ 155575 w 407917"/>
                  <a:gd name="connsiteY21" fmla="*/ 831850 h 1031875"/>
                  <a:gd name="connsiteX22" fmla="*/ 0 w 407917"/>
                  <a:gd name="connsiteY22" fmla="*/ 917575 h 1031875"/>
                  <a:gd name="connsiteX23" fmla="*/ 44450 w 407917"/>
                  <a:gd name="connsiteY23" fmla="*/ 933450 h 1031875"/>
                  <a:gd name="connsiteX24" fmla="*/ 79375 w 407917"/>
                  <a:gd name="connsiteY24" fmla="*/ 923925 h 1031875"/>
                  <a:gd name="connsiteX25" fmla="*/ 130175 w 407917"/>
                  <a:gd name="connsiteY25" fmla="*/ 917575 h 1031875"/>
                  <a:gd name="connsiteX26" fmla="*/ 139700 w 407917"/>
                  <a:gd name="connsiteY26" fmla="*/ 939800 h 1031875"/>
                  <a:gd name="connsiteX27" fmla="*/ 133350 w 407917"/>
                  <a:gd name="connsiteY27" fmla="*/ 974725 h 1031875"/>
                  <a:gd name="connsiteX28" fmla="*/ 123825 w 407917"/>
                  <a:gd name="connsiteY28" fmla="*/ 1006475 h 1031875"/>
                  <a:gd name="connsiteX29" fmla="*/ 136525 w 407917"/>
                  <a:gd name="connsiteY29" fmla="*/ 1025525 h 1031875"/>
                  <a:gd name="connsiteX30" fmla="*/ 152400 w 407917"/>
                  <a:gd name="connsiteY30" fmla="*/ 1031875 h 1031875"/>
                  <a:gd name="connsiteX31" fmla="*/ 152400 w 407917"/>
                  <a:gd name="connsiteY31" fmla="*/ 1031875 h 1031875"/>
                  <a:gd name="connsiteX32" fmla="*/ 155575 w 407917"/>
                  <a:gd name="connsiteY32" fmla="*/ 1000125 h 1031875"/>
                  <a:gd name="connsiteX33" fmla="*/ 184150 w 407917"/>
                  <a:gd name="connsiteY33" fmla="*/ 984250 h 1031875"/>
                  <a:gd name="connsiteX34" fmla="*/ 212725 w 407917"/>
                  <a:gd name="connsiteY34" fmla="*/ 965200 h 1031875"/>
                  <a:gd name="connsiteX35" fmla="*/ 222250 w 407917"/>
                  <a:gd name="connsiteY35" fmla="*/ 927100 h 1031875"/>
                  <a:gd name="connsiteX36" fmla="*/ 254000 w 407917"/>
                  <a:gd name="connsiteY36" fmla="*/ 936625 h 1031875"/>
                  <a:gd name="connsiteX37" fmla="*/ 292100 w 407917"/>
                  <a:gd name="connsiteY37" fmla="*/ 968375 h 1031875"/>
                  <a:gd name="connsiteX38" fmla="*/ 327025 w 407917"/>
                  <a:gd name="connsiteY38" fmla="*/ 993775 h 1031875"/>
                  <a:gd name="connsiteX39" fmla="*/ 355600 w 407917"/>
                  <a:gd name="connsiteY39" fmla="*/ 1012825 h 1031875"/>
                  <a:gd name="connsiteX40" fmla="*/ 342900 w 407917"/>
                  <a:gd name="connsiteY40" fmla="*/ 974725 h 1031875"/>
                  <a:gd name="connsiteX41" fmla="*/ 330200 w 407917"/>
                  <a:gd name="connsiteY41" fmla="*/ 939800 h 1031875"/>
                  <a:gd name="connsiteX42" fmla="*/ 330200 w 407917"/>
                  <a:gd name="connsiteY42" fmla="*/ 939800 h 1031875"/>
                  <a:gd name="connsiteX43" fmla="*/ 407650 w 407917"/>
                  <a:gd name="connsiteY43" fmla="*/ 883446 h 1031875"/>
                  <a:gd name="connsiteX44" fmla="*/ 276225 w 407917"/>
                  <a:gd name="connsiteY44" fmla="*/ 835025 h 1031875"/>
                  <a:gd name="connsiteX45" fmla="*/ 233025 w 407917"/>
                  <a:gd name="connsiteY45" fmla="*/ 740571 h 1031875"/>
                  <a:gd name="connsiteX46" fmla="*/ 236200 w 407917"/>
                  <a:gd name="connsiteY46" fmla="*/ 562771 h 1031875"/>
                  <a:gd name="connsiteX47" fmla="*/ 203200 w 407917"/>
                  <a:gd name="connsiteY47" fmla="*/ 190501 h 1031875"/>
                  <a:gd name="connsiteX48" fmla="*/ 337800 w 407917"/>
                  <a:gd name="connsiteY48" fmla="*/ 54771 h 1031875"/>
                  <a:gd name="connsiteX49" fmla="*/ 280650 w 407917"/>
                  <a:gd name="connsiteY49" fmla="*/ 45246 h 1031875"/>
                  <a:gd name="connsiteX50" fmla="*/ 184151 w 407917"/>
                  <a:gd name="connsiteY50" fmla="*/ 73026 h 1031875"/>
                  <a:gd name="connsiteX51" fmla="*/ 82550 w 407917"/>
                  <a:gd name="connsiteY51" fmla="*/ 0 h 1031875"/>
                  <a:gd name="connsiteX0" fmla="*/ 76200 w 407917"/>
                  <a:gd name="connsiteY0" fmla="*/ 3175 h 1031875"/>
                  <a:gd name="connsiteX1" fmla="*/ 69850 w 407917"/>
                  <a:gd name="connsiteY1" fmla="*/ 44450 h 1031875"/>
                  <a:gd name="connsiteX2" fmla="*/ 85725 w 407917"/>
                  <a:gd name="connsiteY2" fmla="*/ 69850 h 1031875"/>
                  <a:gd name="connsiteX3" fmla="*/ 114300 w 407917"/>
                  <a:gd name="connsiteY3" fmla="*/ 98425 h 1031875"/>
                  <a:gd name="connsiteX4" fmla="*/ 149225 w 407917"/>
                  <a:gd name="connsiteY4" fmla="*/ 130175 h 1031875"/>
                  <a:gd name="connsiteX5" fmla="*/ 168275 w 407917"/>
                  <a:gd name="connsiteY5" fmla="*/ 161925 h 1031875"/>
                  <a:gd name="connsiteX6" fmla="*/ 174625 w 407917"/>
                  <a:gd name="connsiteY6" fmla="*/ 219075 h 1031875"/>
                  <a:gd name="connsiteX7" fmla="*/ 168275 w 407917"/>
                  <a:gd name="connsiteY7" fmla="*/ 269875 h 1031875"/>
                  <a:gd name="connsiteX8" fmla="*/ 168275 w 407917"/>
                  <a:gd name="connsiteY8" fmla="*/ 323850 h 1031875"/>
                  <a:gd name="connsiteX9" fmla="*/ 184150 w 407917"/>
                  <a:gd name="connsiteY9" fmla="*/ 403225 h 1031875"/>
                  <a:gd name="connsiteX10" fmla="*/ 190500 w 407917"/>
                  <a:gd name="connsiteY10" fmla="*/ 454025 h 1031875"/>
                  <a:gd name="connsiteX11" fmla="*/ 190500 w 407917"/>
                  <a:gd name="connsiteY11" fmla="*/ 454025 h 1031875"/>
                  <a:gd name="connsiteX12" fmla="*/ 193675 w 407917"/>
                  <a:gd name="connsiteY12" fmla="*/ 511175 h 1031875"/>
                  <a:gd name="connsiteX13" fmla="*/ 187325 w 407917"/>
                  <a:gd name="connsiteY13" fmla="*/ 536575 h 1031875"/>
                  <a:gd name="connsiteX14" fmla="*/ 187325 w 407917"/>
                  <a:gd name="connsiteY14" fmla="*/ 584200 h 1031875"/>
                  <a:gd name="connsiteX15" fmla="*/ 196850 w 407917"/>
                  <a:gd name="connsiteY15" fmla="*/ 615950 h 1031875"/>
                  <a:gd name="connsiteX16" fmla="*/ 184150 w 407917"/>
                  <a:gd name="connsiteY16" fmla="*/ 647700 h 1031875"/>
                  <a:gd name="connsiteX17" fmla="*/ 193675 w 407917"/>
                  <a:gd name="connsiteY17" fmla="*/ 695325 h 1031875"/>
                  <a:gd name="connsiteX18" fmla="*/ 193675 w 407917"/>
                  <a:gd name="connsiteY18" fmla="*/ 730250 h 1031875"/>
                  <a:gd name="connsiteX19" fmla="*/ 180975 w 407917"/>
                  <a:gd name="connsiteY19" fmla="*/ 755650 h 1031875"/>
                  <a:gd name="connsiteX20" fmla="*/ 180975 w 407917"/>
                  <a:gd name="connsiteY20" fmla="*/ 800100 h 1031875"/>
                  <a:gd name="connsiteX21" fmla="*/ 155575 w 407917"/>
                  <a:gd name="connsiteY21" fmla="*/ 831850 h 1031875"/>
                  <a:gd name="connsiteX22" fmla="*/ 0 w 407917"/>
                  <a:gd name="connsiteY22" fmla="*/ 917575 h 1031875"/>
                  <a:gd name="connsiteX23" fmla="*/ 44450 w 407917"/>
                  <a:gd name="connsiteY23" fmla="*/ 933450 h 1031875"/>
                  <a:gd name="connsiteX24" fmla="*/ 79375 w 407917"/>
                  <a:gd name="connsiteY24" fmla="*/ 923925 h 1031875"/>
                  <a:gd name="connsiteX25" fmla="*/ 130175 w 407917"/>
                  <a:gd name="connsiteY25" fmla="*/ 917575 h 1031875"/>
                  <a:gd name="connsiteX26" fmla="*/ 139700 w 407917"/>
                  <a:gd name="connsiteY26" fmla="*/ 939800 h 1031875"/>
                  <a:gd name="connsiteX27" fmla="*/ 133350 w 407917"/>
                  <a:gd name="connsiteY27" fmla="*/ 974725 h 1031875"/>
                  <a:gd name="connsiteX28" fmla="*/ 123825 w 407917"/>
                  <a:gd name="connsiteY28" fmla="*/ 1006475 h 1031875"/>
                  <a:gd name="connsiteX29" fmla="*/ 136525 w 407917"/>
                  <a:gd name="connsiteY29" fmla="*/ 1025525 h 1031875"/>
                  <a:gd name="connsiteX30" fmla="*/ 152400 w 407917"/>
                  <a:gd name="connsiteY30" fmla="*/ 1031875 h 1031875"/>
                  <a:gd name="connsiteX31" fmla="*/ 152400 w 407917"/>
                  <a:gd name="connsiteY31" fmla="*/ 1031875 h 1031875"/>
                  <a:gd name="connsiteX32" fmla="*/ 155575 w 407917"/>
                  <a:gd name="connsiteY32" fmla="*/ 1000125 h 1031875"/>
                  <a:gd name="connsiteX33" fmla="*/ 184150 w 407917"/>
                  <a:gd name="connsiteY33" fmla="*/ 984250 h 1031875"/>
                  <a:gd name="connsiteX34" fmla="*/ 212725 w 407917"/>
                  <a:gd name="connsiteY34" fmla="*/ 965200 h 1031875"/>
                  <a:gd name="connsiteX35" fmla="*/ 222250 w 407917"/>
                  <a:gd name="connsiteY35" fmla="*/ 927100 h 1031875"/>
                  <a:gd name="connsiteX36" fmla="*/ 254000 w 407917"/>
                  <a:gd name="connsiteY36" fmla="*/ 936625 h 1031875"/>
                  <a:gd name="connsiteX37" fmla="*/ 292100 w 407917"/>
                  <a:gd name="connsiteY37" fmla="*/ 968375 h 1031875"/>
                  <a:gd name="connsiteX38" fmla="*/ 327025 w 407917"/>
                  <a:gd name="connsiteY38" fmla="*/ 993775 h 1031875"/>
                  <a:gd name="connsiteX39" fmla="*/ 355600 w 407917"/>
                  <a:gd name="connsiteY39" fmla="*/ 1012825 h 1031875"/>
                  <a:gd name="connsiteX40" fmla="*/ 342900 w 407917"/>
                  <a:gd name="connsiteY40" fmla="*/ 974725 h 1031875"/>
                  <a:gd name="connsiteX41" fmla="*/ 330200 w 407917"/>
                  <a:gd name="connsiteY41" fmla="*/ 939800 h 1031875"/>
                  <a:gd name="connsiteX42" fmla="*/ 330200 w 407917"/>
                  <a:gd name="connsiteY42" fmla="*/ 939800 h 1031875"/>
                  <a:gd name="connsiteX43" fmla="*/ 407650 w 407917"/>
                  <a:gd name="connsiteY43" fmla="*/ 883446 h 1031875"/>
                  <a:gd name="connsiteX44" fmla="*/ 276225 w 407917"/>
                  <a:gd name="connsiteY44" fmla="*/ 835025 h 1031875"/>
                  <a:gd name="connsiteX45" fmla="*/ 233025 w 407917"/>
                  <a:gd name="connsiteY45" fmla="*/ 740571 h 1031875"/>
                  <a:gd name="connsiteX46" fmla="*/ 236200 w 407917"/>
                  <a:gd name="connsiteY46" fmla="*/ 562771 h 1031875"/>
                  <a:gd name="connsiteX47" fmla="*/ 203200 w 407917"/>
                  <a:gd name="connsiteY47" fmla="*/ 190501 h 1031875"/>
                  <a:gd name="connsiteX48" fmla="*/ 337800 w 407917"/>
                  <a:gd name="connsiteY48" fmla="*/ 54771 h 1031875"/>
                  <a:gd name="connsiteX49" fmla="*/ 280650 w 407917"/>
                  <a:gd name="connsiteY49" fmla="*/ 45246 h 1031875"/>
                  <a:gd name="connsiteX50" fmla="*/ 184151 w 407917"/>
                  <a:gd name="connsiteY50" fmla="*/ 73026 h 1031875"/>
                  <a:gd name="connsiteX51" fmla="*/ 66675 w 407917"/>
                  <a:gd name="connsiteY51" fmla="*/ 0 h 1031875"/>
                  <a:gd name="connsiteX0" fmla="*/ 76200 w 407917"/>
                  <a:gd name="connsiteY0" fmla="*/ 3175 h 1031875"/>
                  <a:gd name="connsiteX1" fmla="*/ 69850 w 407917"/>
                  <a:gd name="connsiteY1" fmla="*/ 44450 h 1031875"/>
                  <a:gd name="connsiteX2" fmla="*/ 85725 w 407917"/>
                  <a:gd name="connsiteY2" fmla="*/ 69850 h 1031875"/>
                  <a:gd name="connsiteX3" fmla="*/ 114300 w 407917"/>
                  <a:gd name="connsiteY3" fmla="*/ 98425 h 1031875"/>
                  <a:gd name="connsiteX4" fmla="*/ 149225 w 407917"/>
                  <a:gd name="connsiteY4" fmla="*/ 130175 h 1031875"/>
                  <a:gd name="connsiteX5" fmla="*/ 168275 w 407917"/>
                  <a:gd name="connsiteY5" fmla="*/ 161925 h 1031875"/>
                  <a:gd name="connsiteX6" fmla="*/ 174625 w 407917"/>
                  <a:gd name="connsiteY6" fmla="*/ 219075 h 1031875"/>
                  <a:gd name="connsiteX7" fmla="*/ 168275 w 407917"/>
                  <a:gd name="connsiteY7" fmla="*/ 269875 h 1031875"/>
                  <a:gd name="connsiteX8" fmla="*/ 168275 w 407917"/>
                  <a:gd name="connsiteY8" fmla="*/ 323850 h 1031875"/>
                  <a:gd name="connsiteX9" fmla="*/ 184150 w 407917"/>
                  <a:gd name="connsiteY9" fmla="*/ 403225 h 1031875"/>
                  <a:gd name="connsiteX10" fmla="*/ 190500 w 407917"/>
                  <a:gd name="connsiteY10" fmla="*/ 454025 h 1031875"/>
                  <a:gd name="connsiteX11" fmla="*/ 190500 w 407917"/>
                  <a:gd name="connsiteY11" fmla="*/ 454025 h 1031875"/>
                  <a:gd name="connsiteX12" fmla="*/ 193675 w 407917"/>
                  <a:gd name="connsiteY12" fmla="*/ 511175 h 1031875"/>
                  <a:gd name="connsiteX13" fmla="*/ 187325 w 407917"/>
                  <a:gd name="connsiteY13" fmla="*/ 536575 h 1031875"/>
                  <a:gd name="connsiteX14" fmla="*/ 187325 w 407917"/>
                  <a:gd name="connsiteY14" fmla="*/ 584200 h 1031875"/>
                  <a:gd name="connsiteX15" fmla="*/ 196850 w 407917"/>
                  <a:gd name="connsiteY15" fmla="*/ 615950 h 1031875"/>
                  <a:gd name="connsiteX16" fmla="*/ 184150 w 407917"/>
                  <a:gd name="connsiteY16" fmla="*/ 647700 h 1031875"/>
                  <a:gd name="connsiteX17" fmla="*/ 193675 w 407917"/>
                  <a:gd name="connsiteY17" fmla="*/ 695325 h 1031875"/>
                  <a:gd name="connsiteX18" fmla="*/ 193675 w 407917"/>
                  <a:gd name="connsiteY18" fmla="*/ 730250 h 1031875"/>
                  <a:gd name="connsiteX19" fmla="*/ 180975 w 407917"/>
                  <a:gd name="connsiteY19" fmla="*/ 755650 h 1031875"/>
                  <a:gd name="connsiteX20" fmla="*/ 180975 w 407917"/>
                  <a:gd name="connsiteY20" fmla="*/ 800100 h 1031875"/>
                  <a:gd name="connsiteX21" fmla="*/ 155575 w 407917"/>
                  <a:gd name="connsiteY21" fmla="*/ 831850 h 1031875"/>
                  <a:gd name="connsiteX22" fmla="*/ 0 w 407917"/>
                  <a:gd name="connsiteY22" fmla="*/ 917575 h 1031875"/>
                  <a:gd name="connsiteX23" fmla="*/ 44450 w 407917"/>
                  <a:gd name="connsiteY23" fmla="*/ 933450 h 1031875"/>
                  <a:gd name="connsiteX24" fmla="*/ 79375 w 407917"/>
                  <a:gd name="connsiteY24" fmla="*/ 923925 h 1031875"/>
                  <a:gd name="connsiteX25" fmla="*/ 130175 w 407917"/>
                  <a:gd name="connsiteY25" fmla="*/ 917575 h 1031875"/>
                  <a:gd name="connsiteX26" fmla="*/ 139700 w 407917"/>
                  <a:gd name="connsiteY26" fmla="*/ 939800 h 1031875"/>
                  <a:gd name="connsiteX27" fmla="*/ 133350 w 407917"/>
                  <a:gd name="connsiteY27" fmla="*/ 974725 h 1031875"/>
                  <a:gd name="connsiteX28" fmla="*/ 123825 w 407917"/>
                  <a:gd name="connsiteY28" fmla="*/ 1006475 h 1031875"/>
                  <a:gd name="connsiteX29" fmla="*/ 136525 w 407917"/>
                  <a:gd name="connsiteY29" fmla="*/ 1025525 h 1031875"/>
                  <a:gd name="connsiteX30" fmla="*/ 152400 w 407917"/>
                  <a:gd name="connsiteY30" fmla="*/ 1031875 h 1031875"/>
                  <a:gd name="connsiteX31" fmla="*/ 152400 w 407917"/>
                  <a:gd name="connsiteY31" fmla="*/ 1031875 h 1031875"/>
                  <a:gd name="connsiteX32" fmla="*/ 155575 w 407917"/>
                  <a:gd name="connsiteY32" fmla="*/ 1000125 h 1031875"/>
                  <a:gd name="connsiteX33" fmla="*/ 184150 w 407917"/>
                  <a:gd name="connsiteY33" fmla="*/ 984250 h 1031875"/>
                  <a:gd name="connsiteX34" fmla="*/ 212725 w 407917"/>
                  <a:gd name="connsiteY34" fmla="*/ 965200 h 1031875"/>
                  <a:gd name="connsiteX35" fmla="*/ 222250 w 407917"/>
                  <a:gd name="connsiteY35" fmla="*/ 927100 h 1031875"/>
                  <a:gd name="connsiteX36" fmla="*/ 254000 w 407917"/>
                  <a:gd name="connsiteY36" fmla="*/ 936625 h 1031875"/>
                  <a:gd name="connsiteX37" fmla="*/ 292100 w 407917"/>
                  <a:gd name="connsiteY37" fmla="*/ 968375 h 1031875"/>
                  <a:gd name="connsiteX38" fmla="*/ 327025 w 407917"/>
                  <a:gd name="connsiteY38" fmla="*/ 993775 h 1031875"/>
                  <a:gd name="connsiteX39" fmla="*/ 355600 w 407917"/>
                  <a:gd name="connsiteY39" fmla="*/ 1012825 h 1031875"/>
                  <a:gd name="connsiteX40" fmla="*/ 342900 w 407917"/>
                  <a:gd name="connsiteY40" fmla="*/ 974725 h 1031875"/>
                  <a:gd name="connsiteX41" fmla="*/ 330200 w 407917"/>
                  <a:gd name="connsiteY41" fmla="*/ 939800 h 1031875"/>
                  <a:gd name="connsiteX42" fmla="*/ 330200 w 407917"/>
                  <a:gd name="connsiteY42" fmla="*/ 939800 h 1031875"/>
                  <a:gd name="connsiteX43" fmla="*/ 328275 w 407917"/>
                  <a:gd name="connsiteY43" fmla="*/ 921546 h 1031875"/>
                  <a:gd name="connsiteX44" fmla="*/ 407650 w 407917"/>
                  <a:gd name="connsiteY44" fmla="*/ 883446 h 1031875"/>
                  <a:gd name="connsiteX45" fmla="*/ 276225 w 407917"/>
                  <a:gd name="connsiteY45" fmla="*/ 835025 h 1031875"/>
                  <a:gd name="connsiteX46" fmla="*/ 233025 w 407917"/>
                  <a:gd name="connsiteY46" fmla="*/ 740571 h 1031875"/>
                  <a:gd name="connsiteX47" fmla="*/ 236200 w 407917"/>
                  <a:gd name="connsiteY47" fmla="*/ 562771 h 1031875"/>
                  <a:gd name="connsiteX48" fmla="*/ 203200 w 407917"/>
                  <a:gd name="connsiteY48" fmla="*/ 190501 h 1031875"/>
                  <a:gd name="connsiteX49" fmla="*/ 337800 w 407917"/>
                  <a:gd name="connsiteY49" fmla="*/ 54771 h 1031875"/>
                  <a:gd name="connsiteX50" fmla="*/ 280650 w 407917"/>
                  <a:gd name="connsiteY50" fmla="*/ 45246 h 1031875"/>
                  <a:gd name="connsiteX51" fmla="*/ 184151 w 407917"/>
                  <a:gd name="connsiteY51" fmla="*/ 73026 h 1031875"/>
                  <a:gd name="connsiteX52" fmla="*/ 66675 w 407917"/>
                  <a:gd name="connsiteY52" fmla="*/ 0 h 1031875"/>
                  <a:gd name="connsiteX0" fmla="*/ 76200 w 407917"/>
                  <a:gd name="connsiteY0" fmla="*/ 3175 h 1031875"/>
                  <a:gd name="connsiteX1" fmla="*/ 69850 w 407917"/>
                  <a:gd name="connsiteY1" fmla="*/ 44450 h 1031875"/>
                  <a:gd name="connsiteX2" fmla="*/ 85725 w 407917"/>
                  <a:gd name="connsiteY2" fmla="*/ 69850 h 1031875"/>
                  <a:gd name="connsiteX3" fmla="*/ 114300 w 407917"/>
                  <a:gd name="connsiteY3" fmla="*/ 98425 h 1031875"/>
                  <a:gd name="connsiteX4" fmla="*/ 149225 w 407917"/>
                  <a:gd name="connsiteY4" fmla="*/ 130175 h 1031875"/>
                  <a:gd name="connsiteX5" fmla="*/ 168275 w 407917"/>
                  <a:gd name="connsiteY5" fmla="*/ 161925 h 1031875"/>
                  <a:gd name="connsiteX6" fmla="*/ 174625 w 407917"/>
                  <a:gd name="connsiteY6" fmla="*/ 219075 h 1031875"/>
                  <a:gd name="connsiteX7" fmla="*/ 168275 w 407917"/>
                  <a:gd name="connsiteY7" fmla="*/ 269875 h 1031875"/>
                  <a:gd name="connsiteX8" fmla="*/ 168275 w 407917"/>
                  <a:gd name="connsiteY8" fmla="*/ 323850 h 1031875"/>
                  <a:gd name="connsiteX9" fmla="*/ 184150 w 407917"/>
                  <a:gd name="connsiteY9" fmla="*/ 403225 h 1031875"/>
                  <a:gd name="connsiteX10" fmla="*/ 190500 w 407917"/>
                  <a:gd name="connsiteY10" fmla="*/ 454025 h 1031875"/>
                  <a:gd name="connsiteX11" fmla="*/ 190500 w 407917"/>
                  <a:gd name="connsiteY11" fmla="*/ 454025 h 1031875"/>
                  <a:gd name="connsiteX12" fmla="*/ 193675 w 407917"/>
                  <a:gd name="connsiteY12" fmla="*/ 511175 h 1031875"/>
                  <a:gd name="connsiteX13" fmla="*/ 187325 w 407917"/>
                  <a:gd name="connsiteY13" fmla="*/ 536575 h 1031875"/>
                  <a:gd name="connsiteX14" fmla="*/ 187325 w 407917"/>
                  <a:gd name="connsiteY14" fmla="*/ 584200 h 1031875"/>
                  <a:gd name="connsiteX15" fmla="*/ 196850 w 407917"/>
                  <a:gd name="connsiteY15" fmla="*/ 615950 h 1031875"/>
                  <a:gd name="connsiteX16" fmla="*/ 184150 w 407917"/>
                  <a:gd name="connsiteY16" fmla="*/ 647700 h 1031875"/>
                  <a:gd name="connsiteX17" fmla="*/ 193675 w 407917"/>
                  <a:gd name="connsiteY17" fmla="*/ 695325 h 1031875"/>
                  <a:gd name="connsiteX18" fmla="*/ 193675 w 407917"/>
                  <a:gd name="connsiteY18" fmla="*/ 730250 h 1031875"/>
                  <a:gd name="connsiteX19" fmla="*/ 180975 w 407917"/>
                  <a:gd name="connsiteY19" fmla="*/ 755650 h 1031875"/>
                  <a:gd name="connsiteX20" fmla="*/ 180975 w 407917"/>
                  <a:gd name="connsiteY20" fmla="*/ 800100 h 1031875"/>
                  <a:gd name="connsiteX21" fmla="*/ 155575 w 407917"/>
                  <a:gd name="connsiteY21" fmla="*/ 831850 h 1031875"/>
                  <a:gd name="connsiteX22" fmla="*/ 0 w 407917"/>
                  <a:gd name="connsiteY22" fmla="*/ 917575 h 1031875"/>
                  <a:gd name="connsiteX23" fmla="*/ 44450 w 407917"/>
                  <a:gd name="connsiteY23" fmla="*/ 933450 h 1031875"/>
                  <a:gd name="connsiteX24" fmla="*/ 79375 w 407917"/>
                  <a:gd name="connsiteY24" fmla="*/ 923925 h 1031875"/>
                  <a:gd name="connsiteX25" fmla="*/ 130175 w 407917"/>
                  <a:gd name="connsiteY25" fmla="*/ 917575 h 1031875"/>
                  <a:gd name="connsiteX26" fmla="*/ 139700 w 407917"/>
                  <a:gd name="connsiteY26" fmla="*/ 939800 h 1031875"/>
                  <a:gd name="connsiteX27" fmla="*/ 133350 w 407917"/>
                  <a:gd name="connsiteY27" fmla="*/ 974725 h 1031875"/>
                  <a:gd name="connsiteX28" fmla="*/ 123825 w 407917"/>
                  <a:gd name="connsiteY28" fmla="*/ 1006475 h 1031875"/>
                  <a:gd name="connsiteX29" fmla="*/ 136525 w 407917"/>
                  <a:gd name="connsiteY29" fmla="*/ 1025525 h 1031875"/>
                  <a:gd name="connsiteX30" fmla="*/ 152400 w 407917"/>
                  <a:gd name="connsiteY30" fmla="*/ 1031875 h 1031875"/>
                  <a:gd name="connsiteX31" fmla="*/ 152400 w 407917"/>
                  <a:gd name="connsiteY31" fmla="*/ 1031875 h 1031875"/>
                  <a:gd name="connsiteX32" fmla="*/ 155575 w 407917"/>
                  <a:gd name="connsiteY32" fmla="*/ 1000125 h 1031875"/>
                  <a:gd name="connsiteX33" fmla="*/ 184150 w 407917"/>
                  <a:gd name="connsiteY33" fmla="*/ 984250 h 1031875"/>
                  <a:gd name="connsiteX34" fmla="*/ 212725 w 407917"/>
                  <a:gd name="connsiteY34" fmla="*/ 965200 h 1031875"/>
                  <a:gd name="connsiteX35" fmla="*/ 222250 w 407917"/>
                  <a:gd name="connsiteY35" fmla="*/ 927100 h 1031875"/>
                  <a:gd name="connsiteX36" fmla="*/ 254000 w 407917"/>
                  <a:gd name="connsiteY36" fmla="*/ 936625 h 1031875"/>
                  <a:gd name="connsiteX37" fmla="*/ 292100 w 407917"/>
                  <a:gd name="connsiteY37" fmla="*/ 968375 h 1031875"/>
                  <a:gd name="connsiteX38" fmla="*/ 327025 w 407917"/>
                  <a:gd name="connsiteY38" fmla="*/ 993775 h 1031875"/>
                  <a:gd name="connsiteX39" fmla="*/ 355600 w 407917"/>
                  <a:gd name="connsiteY39" fmla="*/ 1012825 h 1031875"/>
                  <a:gd name="connsiteX40" fmla="*/ 365125 w 407917"/>
                  <a:gd name="connsiteY40" fmla="*/ 993775 h 1031875"/>
                  <a:gd name="connsiteX41" fmla="*/ 330200 w 407917"/>
                  <a:gd name="connsiteY41" fmla="*/ 939800 h 1031875"/>
                  <a:gd name="connsiteX42" fmla="*/ 330200 w 407917"/>
                  <a:gd name="connsiteY42" fmla="*/ 939800 h 1031875"/>
                  <a:gd name="connsiteX43" fmla="*/ 328275 w 407917"/>
                  <a:gd name="connsiteY43" fmla="*/ 921546 h 1031875"/>
                  <a:gd name="connsiteX44" fmla="*/ 407650 w 407917"/>
                  <a:gd name="connsiteY44" fmla="*/ 883446 h 1031875"/>
                  <a:gd name="connsiteX45" fmla="*/ 276225 w 407917"/>
                  <a:gd name="connsiteY45" fmla="*/ 835025 h 1031875"/>
                  <a:gd name="connsiteX46" fmla="*/ 233025 w 407917"/>
                  <a:gd name="connsiteY46" fmla="*/ 740571 h 1031875"/>
                  <a:gd name="connsiteX47" fmla="*/ 236200 w 407917"/>
                  <a:gd name="connsiteY47" fmla="*/ 562771 h 1031875"/>
                  <a:gd name="connsiteX48" fmla="*/ 203200 w 407917"/>
                  <a:gd name="connsiteY48" fmla="*/ 190501 h 1031875"/>
                  <a:gd name="connsiteX49" fmla="*/ 337800 w 407917"/>
                  <a:gd name="connsiteY49" fmla="*/ 54771 h 1031875"/>
                  <a:gd name="connsiteX50" fmla="*/ 280650 w 407917"/>
                  <a:gd name="connsiteY50" fmla="*/ 45246 h 1031875"/>
                  <a:gd name="connsiteX51" fmla="*/ 184151 w 407917"/>
                  <a:gd name="connsiteY51" fmla="*/ 73026 h 1031875"/>
                  <a:gd name="connsiteX52" fmla="*/ 66675 w 407917"/>
                  <a:gd name="connsiteY52" fmla="*/ 0 h 103187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</a:cxnLst>
                <a:rect l="l" t="t" r="r" b="b"/>
                <a:pathLst>
                  <a:path w="407917" h="1031875">
                    <a:moveTo>
                      <a:pt x="76200" y="3175"/>
                    </a:moveTo>
                    <a:lnTo>
                      <a:pt x="69850" y="44450"/>
                    </a:lnTo>
                    <a:lnTo>
                      <a:pt x="85725" y="69850"/>
                    </a:lnTo>
                    <a:lnTo>
                      <a:pt x="114300" y="98425"/>
                    </a:lnTo>
                    <a:lnTo>
                      <a:pt x="149225" y="130175"/>
                    </a:lnTo>
                    <a:lnTo>
                      <a:pt x="168275" y="161925"/>
                    </a:lnTo>
                    <a:lnTo>
                      <a:pt x="174625" y="219075"/>
                    </a:lnTo>
                    <a:lnTo>
                      <a:pt x="168275" y="269875"/>
                    </a:lnTo>
                    <a:lnTo>
                      <a:pt x="168275" y="323850"/>
                    </a:lnTo>
                    <a:lnTo>
                      <a:pt x="184150" y="403225"/>
                    </a:lnTo>
                    <a:lnTo>
                      <a:pt x="190500" y="454025"/>
                    </a:lnTo>
                    <a:lnTo>
                      <a:pt x="190500" y="454025"/>
                    </a:lnTo>
                    <a:lnTo>
                      <a:pt x="193675" y="511175"/>
                    </a:lnTo>
                    <a:lnTo>
                      <a:pt x="187325" y="536575"/>
                    </a:lnTo>
                    <a:lnTo>
                      <a:pt x="187325" y="584200"/>
                    </a:lnTo>
                    <a:lnTo>
                      <a:pt x="196850" y="615950"/>
                    </a:lnTo>
                    <a:lnTo>
                      <a:pt x="184150" y="647700"/>
                    </a:lnTo>
                    <a:lnTo>
                      <a:pt x="193675" y="695325"/>
                    </a:lnTo>
                    <a:lnTo>
                      <a:pt x="193675" y="730250"/>
                    </a:lnTo>
                    <a:lnTo>
                      <a:pt x="180975" y="755650"/>
                    </a:lnTo>
                    <a:lnTo>
                      <a:pt x="180975" y="800100"/>
                    </a:lnTo>
                    <a:lnTo>
                      <a:pt x="155575" y="831850"/>
                    </a:lnTo>
                    <a:lnTo>
                      <a:pt x="0" y="917575"/>
                    </a:lnTo>
                    <a:lnTo>
                      <a:pt x="44450" y="933450"/>
                    </a:lnTo>
                    <a:lnTo>
                      <a:pt x="79375" y="923925"/>
                    </a:lnTo>
                    <a:lnTo>
                      <a:pt x="130175" y="917575"/>
                    </a:lnTo>
                    <a:lnTo>
                      <a:pt x="139700" y="939800"/>
                    </a:lnTo>
                    <a:lnTo>
                      <a:pt x="133350" y="974725"/>
                    </a:lnTo>
                    <a:lnTo>
                      <a:pt x="123825" y="1006475"/>
                    </a:lnTo>
                    <a:lnTo>
                      <a:pt x="136525" y="1025525"/>
                    </a:lnTo>
                    <a:lnTo>
                      <a:pt x="152400" y="1031875"/>
                    </a:lnTo>
                    <a:lnTo>
                      <a:pt x="152400" y="1031875"/>
                    </a:lnTo>
                    <a:lnTo>
                      <a:pt x="155575" y="1000125"/>
                    </a:lnTo>
                    <a:lnTo>
                      <a:pt x="184150" y="984250"/>
                    </a:lnTo>
                    <a:lnTo>
                      <a:pt x="212725" y="965200"/>
                    </a:lnTo>
                    <a:lnTo>
                      <a:pt x="222250" y="927100"/>
                    </a:lnTo>
                    <a:lnTo>
                      <a:pt x="254000" y="936625"/>
                    </a:lnTo>
                    <a:lnTo>
                      <a:pt x="292100" y="968375"/>
                    </a:lnTo>
                    <a:lnTo>
                      <a:pt x="327025" y="993775"/>
                    </a:lnTo>
                    <a:lnTo>
                      <a:pt x="355600" y="1012825"/>
                    </a:lnTo>
                    <a:lnTo>
                      <a:pt x="365125" y="993775"/>
                    </a:lnTo>
                    <a:lnTo>
                      <a:pt x="330200" y="939800"/>
                    </a:lnTo>
                    <a:lnTo>
                      <a:pt x="330200" y="939800"/>
                    </a:lnTo>
                    <a:cubicBezTo>
                      <a:pt x="329879" y="936758"/>
                      <a:pt x="321508" y="926572"/>
                      <a:pt x="328275" y="921546"/>
                    </a:cubicBezTo>
                    <a:lnTo>
                      <a:pt x="407650" y="883446"/>
                    </a:lnTo>
                    <a:cubicBezTo>
                      <a:pt x="414000" y="878684"/>
                      <a:pt x="305329" y="858837"/>
                      <a:pt x="276225" y="835025"/>
                    </a:cubicBezTo>
                    <a:cubicBezTo>
                      <a:pt x="247121" y="811213"/>
                      <a:pt x="242342" y="784359"/>
                      <a:pt x="233025" y="740571"/>
                    </a:cubicBezTo>
                    <a:cubicBezTo>
                      <a:pt x="223708" y="696783"/>
                      <a:pt x="241171" y="654449"/>
                      <a:pt x="236200" y="562771"/>
                    </a:cubicBezTo>
                    <a:cubicBezTo>
                      <a:pt x="231229" y="471093"/>
                      <a:pt x="198967" y="272522"/>
                      <a:pt x="203200" y="190501"/>
                    </a:cubicBezTo>
                    <a:cubicBezTo>
                      <a:pt x="207433" y="108480"/>
                      <a:pt x="324892" y="78980"/>
                      <a:pt x="337800" y="54771"/>
                    </a:cubicBezTo>
                    <a:cubicBezTo>
                      <a:pt x="350708" y="30562"/>
                      <a:pt x="293558" y="44849"/>
                      <a:pt x="280650" y="45246"/>
                    </a:cubicBezTo>
                    <a:cubicBezTo>
                      <a:pt x="267742" y="45643"/>
                      <a:pt x="206584" y="90621"/>
                      <a:pt x="184151" y="73026"/>
                    </a:cubicBezTo>
                    <a:cubicBezTo>
                      <a:pt x="164043" y="41276"/>
                      <a:pt x="84667" y="25929"/>
                      <a:pt x="66675" y="0"/>
                    </a:cubicBezTo>
                  </a:path>
                </a:pathLst>
              </a:custGeom>
              <a:solidFill>
                <a:schemeClr val="tx2"/>
              </a:solidFill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8" name="Freeform 27">
                <a:extLst>
                  <a:ext uri="{FF2B5EF4-FFF2-40B4-BE49-F238E27FC236}">
                    <a16:creationId xmlns:a16="http://schemas.microsoft.com/office/drawing/2014/main" id="{5BB4B700-1419-C64E-A397-1D2E36EFBDB8}"/>
                  </a:ext>
                </a:extLst>
              </p:cNvPr>
              <p:cNvSpPr/>
              <p:nvPr/>
            </p:nvSpPr>
            <p:spPr>
              <a:xfrm>
                <a:off x="3876412" y="4272689"/>
                <a:ext cx="251278" cy="711138"/>
              </a:xfrm>
              <a:custGeom>
                <a:avLst/>
                <a:gdLst>
                  <a:gd name="connsiteX0" fmla="*/ 76200 w 368300"/>
                  <a:gd name="connsiteY0" fmla="*/ 0 h 1028700"/>
                  <a:gd name="connsiteX1" fmla="*/ 69850 w 368300"/>
                  <a:gd name="connsiteY1" fmla="*/ 41275 h 1028700"/>
                  <a:gd name="connsiteX2" fmla="*/ 85725 w 368300"/>
                  <a:gd name="connsiteY2" fmla="*/ 66675 h 1028700"/>
                  <a:gd name="connsiteX3" fmla="*/ 114300 w 368300"/>
                  <a:gd name="connsiteY3" fmla="*/ 95250 h 1028700"/>
                  <a:gd name="connsiteX4" fmla="*/ 149225 w 368300"/>
                  <a:gd name="connsiteY4" fmla="*/ 127000 h 1028700"/>
                  <a:gd name="connsiteX5" fmla="*/ 168275 w 368300"/>
                  <a:gd name="connsiteY5" fmla="*/ 158750 h 1028700"/>
                  <a:gd name="connsiteX6" fmla="*/ 174625 w 368300"/>
                  <a:gd name="connsiteY6" fmla="*/ 215900 h 1028700"/>
                  <a:gd name="connsiteX7" fmla="*/ 168275 w 368300"/>
                  <a:gd name="connsiteY7" fmla="*/ 266700 h 1028700"/>
                  <a:gd name="connsiteX8" fmla="*/ 168275 w 368300"/>
                  <a:gd name="connsiteY8" fmla="*/ 320675 h 1028700"/>
                  <a:gd name="connsiteX9" fmla="*/ 184150 w 368300"/>
                  <a:gd name="connsiteY9" fmla="*/ 400050 h 1028700"/>
                  <a:gd name="connsiteX10" fmla="*/ 190500 w 368300"/>
                  <a:gd name="connsiteY10" fmla="*/ 450850 h 1028700"/>
                  <a:gd name="connsiteX11" fmla="*/ 190500 w 368300"/>
                  <a:gd name="connsiteY11" fmla="*/ 450850 h 1028700"/>
                  <a:gd name="connsiteX12" fmla="*/ 193675 w 368300"/>
                  <a:gd name="connsiteY12" fmla="*/ 508000 h 1028700"/>
                  <a:gd name="connsiteX13" fmla="*/ 187325 w 368300"/>
                  <a:gd name="connsiteY13" fmla="*/ 533400 h 1028700"/>
                  <a:gd name="connsiteX14" fmla="*/ 187325 w 368300"/>
                  <a:gd name="connsiteY14" fmla="*/ 581025 h 1028700"/>
                  <a:gd name="connsiteX15" fmla="*/ 196850 w 368300"/>
                  <a:gd name="connsiteY15" fmla="*/ 612775 h 1028700"/>
                  <a:gd name="connsiteX16" fmla="*/ 184150 w 368300"/>
                  <a:gd name="connsiteY16" fmla="*/ 644525 h 1028700"/>
                  <a:gd name="connsiteX17" fmla="*/ 193675 w 368300"/>
                  <a:gd name="connsiteY17" fmla="*/ 692150 h 1028700"/>
                  <a:gd name="connsiteX18" fmla="*/ 193675 w 368300"/>
                  <a:gd name="connsiteY18" fmla="*/ 727075 h 1028700"/>
                  <a:gd name="connsiteX19" fmla="*/ 180975 w 368300"/>
                  <a:gd name="connsiteY19" fmla="*/ 752475 h 1028700"/>
                  <a:gd name="connsiteX20" fmla="*/ 180975 w 368300"/>
                  <a:gd name="connsiteY20" fmla="*/ 796925 h 1028700"/>
                  <a:gd name="connsiteX21" fmla="*/ 155575 w 368300"/>
                  <a:gd name="connsiteY21" fmla="*/ 828675 h 1028700"/>
                  <a:gd name="connsiteX22" fmla="*/ 0 w 368300"/>
                  <a:gd name="connsiteY22" fmla="*/ 914400 h 1028700"/>
                  <a:gd name="connsiteX23" fmla="*/ 44450 w 368300"/>
                  <a:gd name="connsiteY23" fmla="*/ 930275 h 1028700"/>
                  <a:gd name="connsiteX24" fmla="*/ 79375 w 368300"/>
                  <a:gd name="connsiteY24" fmla="*/ 920750 h 1028700"/>
                  <a:gd name="connsiteX25" fmla="*/ 130175 w 368300"/>
                  <a:gd name="connsiteY25" fmla="*/ 914400 h 1028700"/>
                  <a:gd name="connsiteX26" fmla="*/ 139700 w 368300"/>
                  <a:gd name="connsiteY26" fmla="*/ 936625 h 1028700"/>
                  <a:gd name="connsiteX27" fmla="*/ 133350 w 368300"/>
                  <a:gd name="connsiteY27" fmla="*/ 971550 h 1028700"/>
                  <a:gd name="connsiteX28" fmla="*/ 123825 w 368300"/>
                  <a:gd name="connsiteY28" fmla="*/ 1003300 h 1028700"/>
                  <a:gd name="connsiteX29" fmla="*/ 136525 w 368300"/>
                  <a:gd name="connsiteY29" fmla="*/ 1022350 h 1028700"/>
                  <a:gd name="connsiteX30" fmla="*/ 152400 w 368300"/>
                  <a:gd name="connsiteY30" fmla="*/ 1028700 h 1028700"/>
                  <a:gd name="connsiteX31" fmla="*/ 152400 w 368300"/>
                  <a:gd name="connsiteY31" fmla="*/ 1028700 h 1028700"/>
                  <a:gd name="connsiteX32" fmla="*/ 155575 w 368300"/>
                  <a:gd name="connsiteY32" fmla="*/ 996950 h 1028700"/>
                  <a:gd name="connsiteX33" fmla="*/ 184150 w 368300"/>
                  <a:gd name="connsiteY33" fmla="*/ 981075 h 1028700"/>
                  <a:gd name="connsiteX34" fmla="*/ 212725 w 368300"/>
                  <a:gd name="connsiteY34" fmla="*/ 962025 h 1028700"/>
                  <a:gd name="connsiteX35" fmla="*/ 222250 w 368300"/>
                  <a:gd name="connsiteY35" fmla="*/ 923925 h 1028700"/>
                  <a:gd name="connsiteX36" fmla="*/ 254000 w 368300"/>
                  <a:gd name="connsiteY36" fmla="*/ 933450 h 1028700"/>
                  <a:gd name="connsiteX37" fmla="*/ 292100 w 368300"/>
                  <a:gd name="connsiteY37" fmla="*/ 965200 h 1028700"/>
                  <a:gd name="connsiteX38" fmla="*/ 327025 w 368300"/>
                  <a:gd name="connsiteY38" fmla="*/ 990600 h 1028700"/>
                  <a:gd name="connsiteX39" fmla="*/ 355600 w 368300"/>
                  <a:gd name="connsiteY39" fmla="*/ 1009650 h 1028700"/>
                  <a:gd name="connsiteX40" fmla="*/ 342900 w 368300"/>
                  <a:gd name="connsiteY40" fmla="*/ 971550 h 1028700"/>
                  <a:gd name="connsiteX41" fmla="*/ 330200 w 368300"/>
                  <a:gd name="connsiteY41" fmla="*/ 936625 h 1028700"/>
                  <a:gd name="connsiteX42" fmla="*/ 330200 w 368300"/>
                  <a:gd name="connsiteY42" fmla="*/ 936625 h 1028700"/>
                  <a:gd name="connsiteX43" fmla="*/ 368300 w 368300"/>
                  <a:gd name="connsiteY43" fmla="*/ 908050 h 1028700"/>
                  <a:gd name="connsiteX44" fmla="*/ 368300 w 368300"/>
                  <a:gd name="connsiteY44" fmla="*/ 908050 h 1028700"/>
                  <a:gd name="connsiteX0" fmla="*/ 76200 w 593725"/>
                  <a:gd name="connsiteY0" fmla="*/ 0 h 1028700"/>
                  <a:gd name="connsiteX1" fmla="*/ 69850 w 593725"/>
                  <a:gd name="connsiteY1" fmla="*/ 41275 h 1028700"/>
                  <a:gd name="connsiteX2" fmla="*/ 85725 w 593725"/>
                  <a:gd name="connsiteY2" fmla="*/ 66675 h 1028700"/>
                  <a:gd name="connsiteX3" fmla="*/ 114300 w 593725"/>
                  <a:gd name="connsiteY3" fmla="*/ 95250 h 1028700"/>
                  <a:gd name="connsiteX4" fmla="*/ 149225 w 593725"/>
                  <a:gd name="connsiteY4" fmla="*/ 127000 h 1028700"/>
                  <a:gd name="connsiteX5" fmla="*/ 168275 w 593725"/>
                  <a:gd name="connsiteY5" fmla="*/ 158750 h 1028700"/>
                  <a:gd name="connsiteX6" fmla="*/ 174625 w 593725"/>
                  <a:gd name="connsiteY6" fmla="*/ 215900 h 1028700"/>
                  <a:gd name="connsiteX7" fmla="*/ 168275 w 593725"/>
                  <a:gd name="connsiteY7" fmla="*/ 266700 h 1028700"/>
                  <a:gd name="connsiteX8" fmla="*/ 168275 w 593725"/>
                  <a:gd name="connsiteY8" fmla="*/ 320675 h 1028700"/>
                  <a:gd name="connsiteX9" fmla="*/ 184150 w 593725"/>
                  <a:gd name="connsiteY9" fmla="*/ 400050 h 1028700"/>
                  <a:gd name="connsiteX10" fmla="*/ 190500 w 593725"/>
                  <a:gd name="connsiteY10" fmla="*/ 450850 h 1028700"/>
                  <a:gd name="connsiteX11" fmla="*/ 190500 w 593725"/>
                  <a:gd name="connsiteY11" fmla="*/ 450850 h 1028700"/>
                  <a:gd name="connsiteX12" fmla="*/ 193675 w 593725"/>
                  <a:gd name="connsiteY12" fmla="*/ 508000 h 1028700"/>
                  <a:gd name="connsiteX13" fmla="*/ 187325 w 593725"/>
                  <a:gd name="connsiteY13" fmla="*/ 533400 h 1028700"/>
                  <a:gd name="connsiteX14" fmla="*/ 187325 w 593725"/>
                  <a:gd name="connsiteY14" fmla="*/ 581025 h 1028700"/>
                  <a:gd name="connsiteX15" fmla="*/ 196850 w 593725"/>
                  <a:gd name="connsiteY15" fmla="*/ 612775 h 1028700"/>
                  <a:gd name="connsiteX16" fmla="*/ 184150 w 593725"/>
                  <a:gd name="connsiteY16" fmla="*/ 644525 h 1028700"/>
                  <a:gd name="connsiteX17" fmla="*/ 193675 w 593725"/>
                  <a:gd name="connsiteY17" fmla="*/ 692150 h 1028700"/>
                  <a:gd name="connsiteX18" fmla="*/ 193675 w 593725"/>
                  <a:gd name="connsiteY18" fmla="*/ 727075 h 1028700"/>
                  <a:gd name="connsiteX19" fmla="*/ 180975 w 593725"/>
                  <a:gd name="connsiteY19" fmla="*/ 752475 h 1028700"/>
                  <a:gd name="connsiteX20" fmla="*/ 180975 w 593725"/>
                  <a:gd name="connsiteY20" fmla="*/ 796925 h 1028700"/>
                  <a:gd name="connsiteX21" fmla="*/ 155575 w 593725"/>
                  <a:gd name="connsiteY21" fmla="*/ 828675 h 1028700"/>
                  <a:gd name="connsiteX22" fmla="*/ 0 w 593725"/>
                  <a:gd name="connsiteY22" fmla="*/ 914400 h 1028700"/>
                  <a:gd name="connsiteX23" fmla="*/ 44450 w 593725"/>
                  <a:gd name="connsiteY23" fmla="*/ 930275 h 1028700"/>
                  <a:gd name="connsiteX24" fmla="*/ 79375 w 593725"/>
                  <a:gd name="connsiteY24" fmla="*/ 920750 h 1028700"/>
                  <a:gd name="connsiteX25" fmla="*/ 130175 w 593725"/>
                  <a:gd name="connsiteY25" fmla="*/ 914400 h 1028700"/>
                  <a:gd name="connsiteX26" fmla="*/ 139700 w 593725"/>
                  <a:gd name="connsiteY26" fmla="*/ 936625 h 1028700"/>
                  <a:gd name="connsiteX27" fmla="*/ 133350 w 593725"/>
                  <a:gd name="connsiteY27" fmla="*/ 971550 h 1028700"/>
                  <a:gd name="connsiteX28" fmla="*/ 123825 w 593725"/>
                  <a:gd name="connsiteY28" fmla="*/ 1003300 h 1028700"/>
                  <a:gd name="connsiteX29" fmla="*/ 136525 w 593725"/>
                  <a:gd name="connsiteY29" fmla="*/ 1022350 h 1028700"/>
                  <a:gd name="connsiteX30" fmla="*/ 152400 w 593725"/>
                  <a:gd name="connsiteY30" fmla="*/ 1028700 h 1028700"/>
                  <a:gd name="connsiteX31" fmla="*/ 152400 w 593725"/>
                  <a:gd name="connsiteY31" fmla="*/ 1028700 h 1028700"/>
                  <a:gd name="connsiteX32" fmla="*/ 155575 w 593725"/>
                  <a:gd name="connsiteY32" fmla="*/ 996950 h 1028700"/>
                  <a:gd name="connsiteX33" fmla="*/ 184150 w 593725"/>
                  <a:gd name="connsiteY33" fmla="*/ 981075 h 1028700"/>
                  <a:gd name="connsiteX34" fmla="*/ 212725 w 593725"/>
                  <a:gd name="connsiteY34" fmla="*/ 962025 h 1028700"/>
                  <a:gd name="connsiteX35" fmla="*/ 222250 w 593725"/>
                  <a:gd name="connsiteY35" fmla="*/ 923925 h 1028700"/>
                  <a:gd name="connsiteX36" fmla="*/ 254000 w 593725"/>
                  <a:gd name="connsiteY36" fmla="*/ 933450 h 1028700"/>
                  <a:gd name="connsiteX37" fmla="*/ 292100 w 593725"/>
                  <a:gd name="connsiteY37" fmla="*/ 965200 h 1028700"/>
                  <a:gd name="connsiteX38" fmla="*/ 327025 w 593725"/>
                  <a:gd name="connsiteY38" fmla="*/ 990600 h 1028700"/>
                  <a:gd name="connsiteX39" fmla="*/ 355600 w 593725"/>
                  <a:gd name="connsiteY39" fmla="*/ 1009650 h 1028700"/>
                  <a:gd name="connsiteX40" fmla="*/ 342900 w 593725"/>
                  <a:gd name="connsiteY40" fmla="*/ 971550 h 1028700"/>
                  <a:gd name="connsiteX41" fmla="*/ 330200 w 593725"/>
                  <a:gd name="connsiteY41" fmla="*/ 936625 h 1028700"/>
                  <a:gd name="connsiteX42" fmla="*/ 330200 w 593725"/>
                  <a:gd name="connsiteY42" fmla="*/ 936625 h 1028700"/>
                  <a:gd name="connsiteX43" fmla="*/ 368300 w 593725"/>
                  <a:gd name="connsiteY43" fmla="*/ 908050 h 1028700"/>
                  <a:gd name="connsiteX44" fmla="*/ 593725 w 593725"/>
                  <a:gd name="connsiteY44" fmla="*/ 457200 h 1028700"/>
                  <a:gd name="connsiteX0" fmla="*/ 76200 w 381618"/>
                  <a:gd name="connsiteY0" fmla="*/ 3175 h 1031875"/>
                  <a:gd name="connsiteX1" fmla="*/ 69850 w 381618"/>
                  <a:gd name="connsiteY1" fmla="*/ 44450 h 1031875"/>
                  <a:gd name="connsiteX2" fmla="*/ 85725 w 381618"/>
                  <a:gd name="connsiteY2" fmla="*/ 69850 h 1031875"/>
                  <a:gd name="connsiteX3" fmla="*/ 114300 w 381618"/>
                  <a:gd name="connsiteY3" fmla="*/ 98425 h 1031875"/>
                  <a:gd name="connsiteX4" fmla="*/ 149225 w 381618"/>
                  <a:gd name="connsiteY4" fmla="*/ 130175 h 1031875"/>
                  <a:gd name="connsiteX5" fmla="*/ 168275 w 381618"/>
                  <a:gd name="connsiteY5" fmla="*/ 161925 h 1031875"/>
                  <a:gd name="connsiteX6" fmla="*/ 174625 w 381618"/>
                  <a:gd name="connsiteY6" fmla="*/ 219075 h 1031875"/>
                  <a:gd name="connsiteX7" fmla="*/ 168275 w 381618"/>
                  <a:gd name="connsiteY7" fmla="*/ 269875 h 1031875"/>
                  <a:gd name="connsiteX8" fmla="*/ 168275 w 381618"/>
                  <a:gd name="connsiteY8" fmla="*/ 323850 h 1031875"/>
                  <a:gd name="connsiteX9" fmla="*/ 184150 w 381618"/>
                  <a:gd name="connsiteY9" fmla="*/ 403225 h 1031875"/>
                  <a:gd name="connsiteX10" fmla="*/ 190500 w 381618"/>
                  <a:gd name="connsiteY10" fmla="*/ 454025 h 1031875"/>
                  <a:gd name="connsiteX11" fmla="*/ 190500 w 381618"/>
                  <a:gd name="connsiteY11" fmla="*/ 454025 h 1031875"/>
                  <a:gd name="connsiteX12" fmla="*/ 193675 w 381618"/>
                  <a:gd name="connsiteY12" fmla="*/ 511175 h 1031875"/>
                  <a:gd name="connsiteX13" fmla="*/ 187325 w 381618"/>
                  <a:gd name="connsiteY13" fmla="*/ 536575 h 1031875"/>
                  <a:gd name="connsiteX14" fmla="*/ 187325 w 381618"/>
                  <a:gd name="connsiteY14" fmla="*/ 584200 h 1031875"/>
                  <a:gd name="connsiteX15" fmla="*/ 196850 w 381618"/>
                  <a:gd name="connsiteY15" fmla="*/ 615950 h 1031875"/>
                  <a:gd name="connsiteX16" fmla="*/ 184150 w 381618"/>
                  <a:gd name="connsiteY16" fmla="*/ 647700 h 1031875"/>
                  <a:gd name="connsiteX17" fmla="*/ 193675 w 381618"/>
                  <a:gd name="connsiteY17" fmla="*/ 695325 h 1031875"/>
                  <a:gd name="connsiteX18" fmla="*/ 193675 w 381618"/>
                  <a:gd name="connsiteY18" fmla="*/ 730250 h 1031875"/>
                  <a:gd name="connsiteX19" fmla="*/ 180975 w 381618"/>
                  <a:gd name="connsiteY19" fmla="*/ 755650 h 1031875"/>
                  <a:gd name="connsiteX20" fmla="*/ 180975 w 381618"/>
                  <a:gd name="connsiteY20" fmla="*/ 800100 h 1031875"/>
                  <a:gd name="connsiteX21" fmla="*/ 155575 w 381618"/>
                  <a:gd name="connsiteY21" fmla="*/ 831850 h 1031875"/>
                  <a:gd name="connsiteX22" fmla="*/ 0 w 381618"/>
                  <a:gd name="connsiteY22" fmla="*/ 917575 h 1031875"/>
                  <a:gd name="connsiteX23" fmla="*/ 44450 w 381618"/>
                  <a:gd name="connsiteY23" fmla="*/ 933450 h 1031875"/>
                  <a:gd name="connsiteX24" fmla="*/ 79375 w 381618"/>
                  <a:gd name="connsiteY24" fmla="*/ 923925 h 1031875"/>
                  <a:gd name="connsiteX25" fmla="*/ 130175 w 381618"/>
                  <a:gd name="connsiteY25" fmla="*/ 917575 h 1031875"/>
                  <a:gd name="connsiteX26" fmla="*/ 139700 w 381618"/>
                  <a:gd name="connsiteY26" fmla="*/ 939800 h 1031875"/>
                  <a:gd name="connsiteX27" fmla="*/ 133350 w 381618"/>
                  <a:gd name="connsiteY27" fmla="*/ 974725 h 1031875"/>
                  <a:gd name="connsiteX28" fmla="*/ 123825 w 381618"/>
                  <a:gd name="connsiteY28" fmla="*/ 1006475 h 1031875"/>
                  <a:gd name="connsiteX29" fmla="*/ 136525 w 381618"/>
                  <a:gd name="connsiteY29" fmla="*/ 1025525 h 1031875"/>
                  <a:gd name="connsiteX30" fmla="*/ 152400 w 381618"/>
                  <a:gd name="connsiteY30" fmla="*/ 1031875 h 1031875"/>
                  <a:gd name="connsiteX31" fmla="*/ 152400 w 381618"/>
                  <a:gd name="connsiteY31" fmla="*/ 1031875 h 1031875"/>
                  <a:gd name="connsiteX32" fmla="*/ 155575 w 381618"/>
                  <a:gd name="connsiteY32" fmla="*/ 1000125 h 1031875"/>
                  <a:gd name="connsiteX33" fmla="*/ 184150 w 381618"/>
                  <a:gd name="connsiteY33" fmla="*/ 984250 h 1031875"/>
                  <a:gd name="connsiteX34" fmla="*/ 212725 w 381618"/>
                  <a:gd name="connsiteY34" fmla="*/ 965200 h 1031875"/>
                  <a:gd name="connsiteX35" fmla="*/ 222250 w 381618"/>
                  <a:gd name="connsiteY35" fmla="*/ 927100 h 1031875"/>
                  <a:gd name="connsiteX36" fmla="*/ 254000 w 381618"/>
                  <a:gd name="connsiteY36" fmla="*/ 936625 h 1031875"/>
                  <a:gd name="connsiteX37" fmla="*/ 292100 w 381618"/>
                  <a:gd name="connsiteY37" fmla="*/ 968375 h 1031875"/>
                  <a:gd name="connsiteX38" fmla="*/ 327025 w 381618"/>
                  <a:gd name="connsiteY38" fmla="*/ 993775 h 1031875"/>
                  <a:gd name="connsiteX39" fmla="*/ 355600 w 381618"/>
                  <a:gd name="connsiteY39" fmla="*/ 1012825 h 1031875"/>
                  <a:gd name="connsiteX40" fmla="*/ 342900 w 381618"/>
                  <a:gd name="connsiteY40" fmla="*/ 974725 h 1031875"/>
                  <a:gd name="connsiteX41" fmla="*/ 330200 w 381618"/>
                  <a:gd name="connsiteY41" fmla="*/ 939800 h 1031875"/>
                  <a:gd name="connsiteX42" fmla="*/ 330200 w 381618"/>
                  <a:gd name="connsiteY42" fmla="*/ 939800 h 1031875"/>
                  <a:gd name="connsiteX43" fmla="*/ 368300 w 381618"/>
                  <a:gd name="connsiteY43" fmla="*/ 911225 h 1031875"/>
                  <a:gd name="connsiteX44" fmla="*/ 82550 w 381618"/>
                  <a:gd name="connsiteY44" fmla="*/ 0 h 1031875"/>
                  <a:gd name="connsiteX0" fmla="*/ 76200 w 373739"/>
                  <a:gd name="connsiteY0" fmla="*/ 3175 h 1031875"/>
                  <a:gd name="connsiteX1" fmla="*/ 69850 w 373739"/>
                  <a:gd name="connsiteY1" fmla="*/ 44450 h 1031875"/>
                  <a:gd name="connsiteX2" fmla="*/ 85725 w 373739"/>
                  <a:gd name="connsiteY2" fmla="*/ 69850 h 1031875"/>
                  <a:gd name="connsiteX3" fmla="*/ 114300 w 373739"/>
                  <a:gd name="connsiteY3" fmla="*/ 98425 h 1031875"/>
                  <a:gd name="connsiteX4" fmla="*/ 149225 w 373739"/>
                  <a:gd name="connsiteY4" fmla="*/ 130175 h 1031875"/>
                  <a:gd name="connsiteX5" fmla="*/ 168275 w 373739"/>
                  <a:gd name="connsiteY5" fmla="*/ 161925 h 1031875"/>
                  <a:gd name="connsiteX6" fmla="*/ 174625 w 373739"/>
                  <a:gd name="connsiteY6" fmla="*/ 219075 h 1031875"/>
                  <a:gd name="connsiteX7" fmla="*/ 168275 w 373739"/>
                  <a:gd name="connsiteY7" fmla="*/ 269875 h 1031875"/>
                  <a:gd name="connsiteX8" fmla="*/ 168275 w 373739"/>
                  <a:gd name="connsiteY8" fmla="*/ 323850 h 1031875"/>
                  <a:gd name="connsiteX9" fmla="*/ 184150 w 373739"/>
                  <a:gd name="connsiteY9" fmla="*/ 403225 h 1031875"/>
                  <a:gd name="connsiteX10" fmla="*/ 190500 w 373739"/>
                  <a:gd name="connsiteY10" fmla="*/ 454025 h 1031875"/>
                  <a:gd name="connsiteX11" fmla="*/ 190500 w 373739"/>
                  <a:gd name="connsiteY11" fmla="*/ 454025 h 1031875"/>
                  <a:gd name="connsiteX12" fmla="*/ 193675 w 373739"/>
                  <a:gd name="connsiteY12" fmla="*/ 511175 h 1031875"/>
                  <a:gd name="connsiteX13" fmla="*/ 187325 w 373739"/>
                  <a:gd name="connsiteY13" fmla="*/ 536575 h 1031875"/>
                  <a:gd name="connsiteX14" fmla="*/ 187325 w 373739"/>
                  <a:gd name="connsiteY14" fmla="*/ 584200 h 1031875"/>
                  <a:gd name="connsiteX15" fmla="*/ 196850 w 373739"/>
                  <a:gd name="connsiteY15" fmla="*/ 615950 h 1031875"/>
                  <a:gd name="connsiteX16" fmla="*/ 184150 w 373739"/>
                  <a:gd name="connsiteY16" fmla="*/ 647700 h 1031875"/>
                  <a:gd name="connsiteX17" fmla="*/ 193675 w 373739"/>
                  <a:gd name="connsiteY17" fmla="*/ 695325 h 1031875"/>
                  <a:gd name="connsiteX18" fmla="*/ 193675 w 373739"/>
                  <a:gd name="connsiteY18" fmla="*/ 730250 h 1031875"/>
                  <a:gd name="connsiteX19" fmla="*/ 180975 w 373739"/>
                  <a:gd name="connsiteY19" fmla="*/ 755650 h 1031875"/>
                  <a:gd name="connsiteX20" fmla="*/ 180975 w 373739"/>
                  <a:gd name="connsiteY20" fmla="*/ 800100 h 1031875"/>
                  <a:gd name="connsiteX21" fmla="*/ 155575 w 373739"/>
                  <a:gd name="connsiteY21" fmla="*/ 831850 h 1031875"/>
                  <a:gd name="connsiteX22" fmla="*/ 0 w 373739"/>
                  <a:gd name="connsiteY22" fmla="*/ 917575 h 1031875"/>
                  <a:gd name="connsiteX23" fmla="*/ 44450 w 373739"/>
                  <a:gd name="connsiteY23" fmla="*/ 933450 h 1031875"/>
                  <a:gd name="connsiteX24" fmla="*/ 79375 w 373739"/>
                  <a:gd name="connsiteY24" fmla="*/ 923925 h 1031875"/>
                  <a:gd name="connsiteX25" fmla="*/ 130175 w 373739"/>
                  <a:gd name="connsiteY25" fmla="*/ 917575 h 1031875"/>
                  <a:gd name="connsiteX26" fmla="*/ 139700 w 373739"/>
                  <a:gd name="connsiteY26" fmla="*/ 939800 h 1031875"/>
                  <a:gd name="connsiteX27" fmla="*/ 133350 w 373739"/>
                  <a:gd name="connsiteY27" fmla="*/ 974725 h 1031875"/>
                  <a:gd name="connsiteX28" fmla="*/ 123825 w 373739"/>
                  <a:gd name="connsiteY28" fmla="*/ 1006475 h 1031875"/>
                  <a:gd name="connsiteX29" fmla="*/ 136525 w 373739"/>
                  <a:gd name="connsiteY29" fmla="*/ 1025525 h 1031875"/>
                  <a:gd name="connsiteX30" fmla="*/ 152400 w 373739"/>
                  <a:gd name="connsiteY30" fmla="*/ 1031875 h 1031875"/>
                  <a:gd name="connsiteX31" fmla="*/ 152400 w 373739"/>
                  <a:gd name="connsiteY31" fmla="*/ 1031875 h 1031875"/>
                  <a:gd name="connsiteX32" fmla="*/ 155575 w 373739"/>
                  <a:gd name="connsiteY32" fmla="*/ 1000125 h 1031875"/>
                  <a:gd name="connsiteX33" fmla="*/ 184150 w 373739"/>
                  <a:gd name="connsiteY33" fmla="*/ 984250 h 1031875"/>
                  <a:gd name="connsiteX34" fmla="*/ 212725 w 373739"/>
                  <a:gd name="connsiteY34" fmla="*/ 965200 h 1031875"/>
                  <a:gd name="connsiteX35" fmla="*/ 222250 w 373739"/>
                  <a:gd name="connsiteY35" fmla="*/ 927100 h 1031875"/>
                  <a:gd name="connsiteX36" fmla="*/ 254000 w 373739"/>
                  <a:gd name="connsiteY36" fmla="*/ 936625 h 1031875"/>
                  <a:gd name="connsiteX37" fmla="*/ 292100 w 373739"/>
                  <a:gd name="connsiteY37" fmla="*/ 968375 h 1031875"/>
                  <a:gd name="connsiteX38" fmla="*/ 327025 w 373739"/>
                  <a:gd name="connsiteY38" fmla="*/ 993775 h 1031875"/>
                  <a:gd name="connsiteX39" fmla="*/ 355600 w 373739"/>
                  <a:gd name="connsiteY39" fmla="*/ 1012825 h 1031875"/>
                  <a:gd name="connsiteX40" fmla="*/ 342900 w 373739"/>
                  <a:gd name="connsiteY40" fmla="*/ 974725 h 1031875"/>
                  <a:gd name="connsiteX41" fmla="*/ 330200 w 373739"/>
                  <a:gd name="connsiteY41" fmla="*/ 939800 h 1031875"/>
                  <a:gd name="connsiteX42" fmla="*/ 330200 w 373739"/>
                  <a:gd name="connsiteY42" fmla="*/ 939800 h 1031875"/>
                  <a:gd name="connsiteX43" fmla="*/ 368300 w 373739"/>
                  <a:gd name="connsiteY43" fmla="*/ 911225 h 1031875"/>
                  <a:gd name="connsiteX44" fmla="*/ 203200 w 373739"/>
                  <a:gd name="connsiteY44" fmla="*/ 190501 h 1031875"/>
                  <a:gd name="connsiteX45" fmla="*/ 82550 w 373739"/>
                  <a:gd name="connsiteY45" fmla="*/ 0 h 1031875"/>
                  <a:gd name="connsiteX0" fmla="*/ 76200 w 373739"/>
                  <a:gd name="connsiteY0" fmla="*/ 3175 h 1031875"/>
                  <a:gd name="connsiteX1" fmla="*/ 69850 w 373739"/>
                  <a:gd name="connsiteY1" fmla="*/ 44450 h 1031875"/>
                  <a:gd name="connsiteX2" fmla="*/ 85725 w 373739"/>
                  <a:gd name="connsiteY2" fmla="*/ 69850 h 1031875"/>
                  <a:gd name="connsiteX3" fmla="*/ 114300 w 373739"/>
                  <a:gd name="connsiteY3" fmla="*/ 98425 h 1031875"/>
                  <a:gd name="connsiteX4" fmla="*/ 149225 w 373739"/>
                  <a:gd name="connsiteY4" fmla="*/ 130175 h 1031875"/>
                  <a:gd name="connsiteX5" fmla="*/ 168275 w 373739"/>
                  <a:gd name="connsiteY5" fmla="*/ 161925 h 1031875"/>
                  <a:gd name="connsiteX6" fmla="*/ 174625 w 373739"/>
                  <a:gd name="connsiteY6" fmla="*/ 219075 h 1031875"/>
                  <a:gd name="connsiteX7" fmla="*/ 168275 w 373739"/>
                  <a:gd name="connsiteY7" fmla="*/ 269875 h 1031875"/>
                  <a:gd name="connsiteX8" fmla="*/ 168275 w 373739"/>
                  <a:gd name="connsiteY8" fmla="*/ 323850 h 1031875"/>
                  <a:gd name="connsiteX9" fmla="*/ 184150 w 373739"/>
                  <a:gd name="connsiteY9" fmla="*/ 403225 h 1031875"/>
                  <a:gd name="connsiteX10" fmla="*/ 190500 w 373739"/>
                  <a:gd name="connsiteY10" fmla="*/ 454025 h 1031875"/>
                  <a:gd name="connsiteX11" fmla="*/ 190500 w 373739"/>
                  <a:gd name="connsiteY11" fmla="*/ 454025 h 1031875"/>
                  <a:gd name="connsiteX12" fmla="*/ 193675 w 373739"/>
                  <a:gd name="connsiteY12" fmla="*/ 511175 h 1031875"/>
                  <a:gd name="connsiteX13" fmla="*/ 187325 w 373739"/>
                  <a:gd name="connsiteY13" fmla="*/ 536575 h 1031875"/>
                  <a:gd name="connsiteX14" fmla="*/ 187325 w 373739"/>
                  <a:gd name="connsiteY14" fmla="*/ 584200 h 1031875"/>
                  <a:gd name="connsiteX15" fmla="*/ 196850 w 373739"/>
                  <a:gd name="connsiteY15" fmla="*/ 615950 h 1031875"/>
                  <a:gd name="connsiteX16" fmla="*/ 184150 w 373739"/>
                  <a:gd name="connsiteY16" fmla="*/ 647700 h 1031875"/>
                  <a:gd name="connsiteX17" fmla="*/ 193675 w 373739"/>
                  <a:gd name="connsiteY17" fmla="*/ 695325 h 1031875"/>
                  <a:gd name="connsiteX18" fmla="*/ 193675 w 373739"/>
                  <a:gd name="connsiteY18" fmla="*/ 730250 h 1031875"/>
                  <a:gd name="connsiteX19" fmla="*/ 180975 w 373739"/>
                  <a:gd name="connsiteY19" fmla="*/ 755650 h 1031875"/>
                  <a:gd name="connsiteX20" fmla="*/ 180975 w 373739"/>
                  <a:gd name="connsiteY20" fmla="*/ 800100 h 1031875"/>
                  <a:gd name="connsiteX21" fmla="*/ 155575 w 373739"/>
                  <a:gd name="connsiteY21" fmla="*/ 831850 h 1031875"/>
                  <a:gd name="connsiteX22" fmla="*/ 0 w 373739"/>
                  <a:gd name="connsiteY22" fmla="*/ 917575 h 1031875"/>
                  <a:gd name="connsiteX23" fmla="*/ 44450 w 373739"/>
                  <a:gd name="connsiteY23" fmla="*/ 933450 h 1031875"/>
                  <a:gd name="connsiteX24" fmla="*/ 79375 w 373739"/>
                  <a:gd name="connsiteY24" fmla="*/ 923925 h 1031875"/>
                  <a:gd name="connsiteX25" fmla="*/ 130175 w 373739"/>
                  <a:gd name="connsiteY25" fmla="*/ 917575 h 1031875"/>
                  <a:gd name="connsiteX26" fmla="*/ 139700 w 373739"/>
                  <a:gd name="connsiteY26" fmla="*/ 939800 h 1031875"/>
                  <a:gd name="connsiteX27" fmla="*/ 133350 w 373739"/>
                  <a:gd name="connsiteY27" fmla="*/ 974725 h 1031875"/>
                  <a:gd name="connsiteX28" fmla="*/ 123825 w 373739"/>
                  <a:gd name="connsiteY28" fmla="*/ 1006475 h 1031875"/>
                  <a:gd name="connsiteX29" fmla="*/ 136525 w 373739"/>
                  <a:gd name="connsiteY29" fmla="*/ 1025525 h 1031875"/>
                  <a:gd name="connsiteX30" fmla="*/ 152400 w 373739"/>
                  <a:gd name="connsiteY30" fmla="*/ 1031875 h 1031875"/>
                  <a:gd name="connsiteX31" fmla="*/ 152400 w 373739"/>
                  <a:gd name="connsiteY31" fmla="*/ 1031875 h 1031875"/>
                  <a:gd name="connsiteX32" fmla="*/ 155575 w 373739"/>
                  <a:gd name="connsiteY32" fmla="*/ 1000125 h 1031875"/>
                  <a:gd name="connsiteX33" fmla="*/ 184150 w 373739"/>
                  <a:gd name="connsiteY33" fmla="*/ 984250 h 1031875"/>
                  <a:gd name="connsiteX34" fmla="*/ 212725 w 373739"/>
                  <a:gd name="connsiteY34" fmla="*/ 965200 h 1031875"/>
                  <a:gd name="connsiteX35" fmla="*/ 222250 w 373739"/>
                  <a:gd name="connsiteY35" fmla="*/ 927100 h 1031875"/>
                  <a:gd name="connsiteX36" fmla="*/ 254000 w 373739"/>
                  <a:gd name="connsiteY36" fmla="*/ 936625 h 1031875"/>
                  <a:gd name="connsiteX37" fmla="*/ 292100 w 373739"/>
                  <a:gd name="connsiteY37" fmla="*/ 968375 h 1031875"/>
                  <a:gd name="connsiteX38" fmla="*/ 327025 w 373739"/>
                  <a:gd name="connsiteY38" fmla="*/ 993775 h 1031875"/>
                  <a:gd name="connsiteX39" fmla="*/ 355600 w 373739"/>
                  <a:gd name="connsiteY39" fmla="*/ 1012825 h 1031875"/>
                  <a:gd name="connsiteX40" fmla="*/ 342900 w 373739"/>
                  <a:gd name="connsiteY40" fmla="*/ 974725 h 1031875"/>
                  <a:gd name="connsiteX41" fmla="*/ 330200 w 373739"/>
                  <a:gd name="connsiteY41" fmla="*/ 939800 h 1031875"/>
                  <a:gd name="connsiteX42" fmla="*/ 330200 w 373739"/>
                  <a:gd name="connsiteY42" fmla="*/ 939800 h 1031875"/>
                  <a:gd name="connsiteX43" fmla="*/ 368300 w 373739"/>
                  <a:gd name="connsiteY43" fmla="*/ 911225 h 1031875"/>
                  <a:gd name="connsiteX44" fmla="*/ 203200 w 373739"/>
                  <a:gd name="connsiteY44" fmla="*/ 190501 h 1031875"/>
                  <a:gd name="connsiteX45" fmla="*/ 203201 w 373739"/>
                  <a:gd name="connsiteY45" fmla="*/ 95251 h 1031875"/>
                  <a:gd name="connsiteX46" fmla="*/ 82550 w 373739"/>
                  <a:gd name="connsiteY46" fmla="*/ 0 h 1031875"/>
                  <a:gd name="connsiteX0" fmla="*/ 76200 w 373739"/>
                  <a:gd name="connsiteY0" fmla="*/ 3175 h 1031875"/>
                  <a:gd name="connsiteX1" fmla="*/ 69850 w 373739"/>
                  <a:gd name="connsiteY1" fmla="*/ 44450 h 1031875"/>
                  <a:gd name="connsiteX2" fmla="*/ 85725 w 373739"/>
                  <a:gd name="connsiteY2" fmla="*/ 69850 h 1031875"/>
                  <a:gd name="connsiteX3" fmla="*/ 114300 w 373739"/>
                  <a:gd name="connsiteY3" fmla="*/ 98425 h 1031875"/>
                  <a:gd name="connsiteX4" fmla="*/ 149225 w 373739"/>
                  <a:gd name="connsiteY4" fmla="*/ 130175 h 1031875"/>
                  <a:gd name="connsiteX5" fmla="*/ 168275 w 373739"/>
                  <a:gd name="connsiteY5" fmla="*/ 161925 h 1031875"/>
                  <a:gd name="connsiteX6" fmla="*/ 174625 w 373739"/>
                  <a:gd name="connsiteY6" fmla="*/ 219075 h 1031875"/>
                  <a:gd name="connsiteX7" fmla="*/ 168275 w 373739"/>
                  <a:gd name="connsiteY7" fmla="*/ 269875 h 1031875"/>
                  <a:gd name="connsiteX8" fmla="*/ 168275 w 373739"/>
                  <a:gd name="connsiteY8" fmla="*/ 323850 h 1031875"/>
                  <a:gd name="connsiteX9" fmla="*/ 184150 w 373739"/>
                  <a:gd name="connsiteY9" fmla="*/ 403225 h 1031875"/>
                  <a:gd name="connsiteX10" fmla="*/ 190500 w 373739"/>
                  <a:gd name="connsiteY10" fmla="*/ 454025 h 1031875"/>
                  <a:gd name="connsiteX11" fmla="*/ 190500 w 373739"/>
                  <a:gd name="connsiteY11" fmla="*/ 454025 h 1031875"/>
                  <a:gd name="connsiteX12" fmla="*/ 193675 w 373739"/>
                  <a:gd name="connsiteY12" fmla="*/ 511175 h 1031875"/>
                  <a:gd name="connsiteX13" fmla="*/ 187325 w 373739"/>
                  <a:gd name="connsiteY13" fmla="*/ 536575 h 1031875"/>
                  <a:gd name="connsiteX14" fmla="*/ 187325 w 373739"/>
                  <a:gd name="connsiteY14" fmla="*/ 584200 h 1031875"/>
                  <a:gd name="connsiteX15" fmla="*/ 196850 w 373739"/>
                  <a:gd name="connsiteY15" fmla="*/ 615950 h 1031875"/>
                  <a:gd name="connsiteX16" fmla="*/ 184150 w 373739"/>
                  <a:gd name="connsiteY16" fmla="*/ 647700 h 1031875"/>
                  <a:gd name="connsiteX17" fmla="*/ 193675 w 373739"/>
                  <a:gd name="connsiteY17" fmla="*/ 695325 h 1031875"/>
                  <a:gd name="connsiteX18" fmla="*/ 193675 w 373739"/>
                  <a:gd name="connsiteY18" fmla="*/ 730250 h 1031875"/>
                  <a:gd name="connsiteX19" fmla="*/ 180975 w 373739"/>
                  <a:gd name="connsiteY19" fmla="*/ 755650 h 1031875"/>
                  <a:gd name="connsiteX20" fmla="*/ 180975 w 373739"/>
                  <a:gd name="connsiteY20" fmla="*/ 800100 h 1031875"/>
                  <a:gd name="connsiteX21" fmla="*/ 155575 w 373739"/>
                  <a:gd name="connsiteY21" fmla="*/ 831850 h 1031875"/>
                  <a:gd name="connsiteX22" fmla="*/ 0 w 373739"/>
                  <a:gd name="connsiteY22" fmla="*/ 917575 h 1031875"/>
                  <a:gd name="connsiteX23" fmla="*/ 44450 w 373739"/>
                  <a:gd name="connsiteY23" fmla="*/ 933450 h 1031875"/>
                  <a:gd name="connsiteX24" fmla="*/ 79375 w 373739"/>
                  <a:gd name="connsiteY24" fmla="*/ 923925 h 1031875"/>
                  <a:gd name="connsiteX25" fmla="*/ 130175 w 373739"/>
                  <a:gd name="connsiteY25" fmla="*/ 917575 h 1031875"/>
                  <a:gd name="connsiteX26" fmla="*/ 139700 w 373739"/>
                  <a:gd name="connsiteY26" fmla="*/ 939800 h 1031875"/>
                  <a:gd name="connsiteX27" fmla="*/ 133350 w 373739"/>
                  <a:gd name="connsiteY27" fmla="*/ 974725 h 1031875"/>
                  <a:gd name="connsiteX28" fmla="*/ 123825 w 373739"/>
                  <a:gd name="connsiteY28" fmla="*/ 1006475 h 1031875"/>
                  <a:gd name="connsiteX29" fmla="*/ 136525 w 373739"/>
                  <a:gd name="connsiteY29" fmla="*/ 1025525 h 1031875"/>
                  <a:gd name="connsiteX30" fmla="*/ 152400 w 373739"/>
                  <a:gd name="connsiteY30" fmla="*/ 1031875 h 1031875"/>
                  <a:gd name="connsiteX31" fmla="*/ 152400 w 373739"/>
                  <a:gd name="connsiteY31" fmla="*/ 1031875 h 1031875"/>
                  <a:gd name="connsiteX32" fmla="*/ 155575 w 373739"/>
                  <a:gd name="connsiteY32" fmla="*/ 1000125 h 1031875"/>
                  <a:gd name="connsiteX33" fmla="*/ 184150 w 373739"/>
                  <a:gd name="connsiteY33" fmla="*/ 984250 h 1031875"/>
                  <a:gd name="connsiteX34" fmla="*/ 212725 w 373739"/>
                  <a:gd name="connsiteY34" fmla="*/ 965200 h 1031875"/>
                  <a:gd name="connsiteX35" fmla="*/ 222250 w 373739"/>
                  <a:gd name="connsiteY35" fmla="*/ 927100 h 1031875"/>
                  <a:gd name="connsiteX36" fmla="*/ 254000 w 373739"/>
                  <a:gd name="connsiteY36" fmla="*/ 936625 h 1031875"/>
                  <a:gd name="connsiteX37" fmla="*/ 292100 w 373739"/>
                  <a:gd name="connsiteY37" fmla="*/ 968375 h 1031875"/>
                  <a:gd name="connsiteX38" fmla="*/ 327025 w 373739"/>
                  <a:gd name="connsiteY38" fmla="*/ 993775 h 1031875"/>
                  <a:gd name="connsiteX39" fmla="*/ 355600 w 373739"/>
                  <a:gd name="connsiteY39" fmla="*/ 1012825 h 1031875"/>
                  <a:gd name="connsiteX40" fmla="*/ 342900 w 373739"/>
                  <a:gd name="connsiteY40" fmla="*/ 974725 h 1031875"/>
                  <a:gd name="connsiteX41" fmla="*/ 330200 w 373739"/>
                  <a:gd name="connsiteY41" fmla="*/ 939800 h 1031875"/>
                  <a:gd name="connsiteX42" fmla="*/ 330200 w 373739"/>
                  <a:gd name="connsiteY42" fmla="*/ 939800 h 1031875"/>
                  <a:gd name="connsiteX43" fmla="*/ 368300 w 373739"/>
                  <a:gd name="connsiteY43" fmla="*/ 911225 h 1031875"/>
                  <a:gd name="connsiteX44" fmla="*/ 203200 w 373739"/>
                  <a:gd name="connsiteY44" fmla="*/ 190501 h 1031875"/>
                  <a:gd name="connsiteX45" fmla="*/ 212726 w 373739"/>
                  <a:gd name="connsiteY45" fmla="*/ 101601 h 1031875"/>
                  <a:gd name="connsiteX46" fmla="*/ 82550 w 373739"/>
                  <a:gd name="connsiteY46" fmla="*/ 0 h 1031875"/>
                  <a:gd name="connsiteX0" fmla="*/ 76200 w 376085"/>
                  <a:gd name="connsiteY0" fmla="*/ 3175 h 1031875"/>
                  <a:gd name="connsiteX1" fmla="*/ 69850 w 376085"/>
                  <a:gd name="connsiteY1" fmla="*/ 44450 h 1031875"/>
                  <a:gd name="connsiteX2" fmla="*/ 85725 w 376085"/>
                  <a:gd name="connsiteY2" fmla="*/ 69850 h 1031875"/>
                  <a:gd name="connsiteX3" fmla="*/ 114300 w 376085"/>
                  <a:gd name="connsiteY3" fmla="*/ 98425 h 1031875"/>
                  <a:gd name="connsiteX4" fmla="*/ 149225 w 376085"/>
                  <a:gd name="connsiteY4" fmla="*/ 130175 h 1031875"/>
                  <a:gd name="connsiteX5" fmla="*/ 168275 w 376085"/>
                  <a:gd name="connsiteY5" fmla="*/ 161925 h 1031875"/>
                  <a:gd name="connsiteX6" fmla="*/ 174625 w 376085"/>
                  <a:gd name="connsiteY6" fmla="*/ 219075 h 1031875"/>
                  <a:gd name="connsiteX7" fmla="*/ 168275 w 376085"/>
                  <a:gd name="connsiteY7" fmla="*/ 269875 h 1031875"/>
                  <a:gd name="connsiteX8" fmla="*/ 168275 w 376085"/>
                  <a:gd name="connsiteY8" fmla="*/ 323850 h 1031875"/>
                  <a:gd name="connsiteX9" fmla="*/ 184150 w 376085"/>
                  <a:gd name="connsiteY9" fmla="*/ 403225 h 1031875"/>
                  <a:gd name="connsiteX10" fmla="*/ 190500 w 376085"/>
                  <a:gd name="connsiteY10" fmla="*/ 454025 h 1031875"/>
                  <a:gd name="connsiteX11" fmla="*/ 190500 w 376085"/>
                  <a:gd name="connsiteY11" fmla="*/ 454025 h 1031875"/>
                  <a:gd name="connsiteX12" fmla="*/ 193675 w 376085"/>
                  <a:gd name="connsiteY12" fmla="*/ 511175 h 1031875"/>
                  <a:gd name="connsiteX13" fmla="*/ 187325 w 376085"/>
                  <a:gd name="connsiteY13" fmla="*/ 536575 h 1031875"/>
                  <a:gd name="connsiteX14" fmla="*/ 187325 w 376085"/>
                  <a:gd name="connsiteY14" fmla="*/ 584200 h 1031875"/>
                  <a:gd name="connsiteX15" fmla="*/ 196850 w 376085"/>
                  <a:gd name="connsiteY15" fmla="*/ 615950 h 1031875"/>
                  <a:gd name="connsiteX16" fmla="*/ 184150 w 376085"/>
                  <a:gd name="connsiteY16" fmla="*/ 647700 h 1031875"/>
                  <a:gd name="connsiteX17" fmla="*/ 193675 w 376085"/>
                  <a:gd name="connsiteY17" fmla="*/ 695325 h 1031875"/>
                  <a:gd name="connsiteX18" fmla="*/ 193675 w 376085"/>
                  <a:gd name="connsiteY18" fmla="*/ 730250 h 1031875"/>
                  <a:gd name="connsiteX19" fmla="*/ 180975 w 376085"/>
                  <a:gd name="connsiteY19" fmla="*/ 755650 h 1031875"/>
                  <a:gd name="connsiteX20" fmla="*/ 180975 w 376085"/>
                  <a:gd name="connsiteY20" fmla="*/ 800100 h 1031875"/>
                  <a:gd name="connsiteX21" fmla="*/ 155575 w 376085"/>
                  <a:gd name="connsiteY21" fmla="*/ 831850 h 1031875"/>
                  <a:gd name="connsiteX22" fmla="*/ 0 w 376085"/>
                  <a:gd name="connsiteY22" fmla="*/ 917575 h 1031875"/>
                  <a:gd name="connsiteX23" fmla="*/ 44450 w 376085"/>
                  <a:gd name="connsiteY23" fmla="*/ 933450 h 1031875"/>
                  <a:gd name="connsiteX24" fmla="*/ 79375 w 376085"/>
                  <a:gd name="connsiteY24" fmla="*/ 923925 h 1031875"/>
                  <a:gd name="connsiteX25" fmla="*/ 130175 w 376085"/>
                  <a:gd name="connsiteY25" fmla="*/ 917575 h 1031875"/>
                  <a:gd name="connsiteX26" fmla="*/ 139700 w 376085"/>
                  <a:gd name="connsiteY26" fmla="*/ 939800 h 1031875"/>
                  <a:gd name="connsiteX27" fmla="*/ 133350 w 376085"/>
                  <a:gd name="connsiteY27" fmla="*/ 974725 h 1031875"/>
                  <a:gd name="connsiteX28" fmla="*/ 123825 w 376085"/>
                  <a:gd name="connsiteY28" fmla="*/ 1006475 h 1031875"/>
                  <a:gd name="connsiteX29" fmla="*/ 136525 w 376085"/>
                  <a:gd name="connsiteY29" fmla="*/ 1025525 h 1031875"/>
                  <a:gd name="connsiteX30" fmla="*/ 152400 w 376085"/>
                  <a:gd name="connsiteY30" fmla="*/ 1031875 h 1031875"/>
                  <a:gd name="connsiteX31" fmla="*/ 152400 w 376085"/>
                  <a:gd name="connsiteY31" fmla="*/ 1031875 h 1031875"/>
                  <a:gd name="connsiteX32" fmla="*/ 155575 w 376085"/>
                  <a:gd name="connsiteY32" fmla="*/ 1000125 h 1031875"/>
                  <a:gd name="connsiteX33" fmla="*/ 184150 w 376085"/>
                  <a:gd name="connsiteY33" fmla="*/ 984250 h 1031875"/>
                  <a:gd name="connsiteX34" fmla="*/ 212725 w 376085"/>
                  <a:gd name="connsiteY34" fmla="*/ 965200 h 1031875"/>
                  <a:gd name="connsiteX35" fmla="*/ 222250 w 376085"/>
                  <a:gd name="connsiteY35" fmla="*/ 927100 h 1031875"/>
                  <a:gd name="connsiteX36" fmla="*/ 254000 w 376085"/>
                  <a:gd name="connsiteY36" fmla="*/ 936625 h 1031875"/>
                  <a:gd name="connsiteX37" fmla="*/ 292100 w 376085"/>
                  <a:gd name="connsiteY37" fmla="*/ 968375 h 1031875"/>
                  <a:gd name="connsiteX38" fmla="*/ 327025 w 376085"/>
                  <a:gd name="connsiteY38" fmla="*/ 993775 h 1031875"/>
                  <a:gd name="connsiteX39" fmla="*/ 355600 w 376085"/>
                  <a:gd name="connsiteY39" fmla="*/ 1012825 h 1031875"/>
                  <a:gd name="connsiteX40" fmla="*/ 342900 w 376085"/>
                  <a:gd name="connsiteY40" fmla="*/ 974725 h 1031875"/>
                  <a:gd name="connsiteX41" fmla="*/ 330200 w 376085"/>
                  <a:gd name="connsiteY41" fmla="*/ 939800 h 1031875"/>
                  <a:gd name="connsiteX42" fmla="*/ 330200 w 376085"/>
                  <a:gd name="connsiteY42" fmla="*/ 939800 h 1031875"/>
                  <a:gd name="connsiteX43" fmla="*/ 347325 w 376085"/>
                  <a:gd name="connsiteY43" fmla="*/ 908846 h 1031875"/>
                  <a:gd name="connsiteX44" fmla="*/ 368300 w 376085"/>
                  <a:gd name="connsiteY44" fmla="*/ 911225 h 1031875"/>
                  <a:gd name="connsiteX45" fmla="*/ 203200 w 376085"/>
                  <a:gd name="connsiteY45" fmla="*/ 190501 h 1031875"/>
                  <a:gd name="connsiteX46" fmla="*/ 212726 w 376085"/>
                  <a:gd name="connsiteY46" fmla="*/ 101601 h 1031875"/>
                  <a:gd name="connsiteX47" fmla="*/ 82550 w 376085"/>
                  <a:gd name="connsiteY47" fmla="*/ 0 h 1031875"/>
                  <a:gd name="connsiteX0" fmla="*/ 76200 w 355600"/>
                  <a:gd name="connsiteY0" fmla="*/ 3175 h 1031875"/>
                  <a:gd name="connsiteX1" fmla="*/ 69850 w 355600"/>
                  <a:gd name="connsiteY1" fmla="*/ 44450 h 1031875"/>
                  <a:gd name="connsiteX2" fmla="*/ 85725 w 355600"/>
                  <a:gd name="connsiteY2" fmla="*/ 69850 h 1031875"/>
                  <a:gd name="connsiteX3" fmla="*/ 114300 w 355600"/>
                  <a:gd name="connsiteY3" fmla="*/ 98425 h 1031875"/>
                  <a:gd name="connsiteX4" fmla="*/ 149225 w 355600"/>
                  <a:gd name="connsiteY4" fmla="*/ 130175 h 1031875"/>
                  <a:gd name="connsiteX5" fmla="*/ 168275 w 355600"/>
                  <a:gd name="connsiteY5" fmla="*/ 161925 h 1031875"/>
                  <a:gd name="connsiteX6" fmla="*/ 174625 w 355600"/>
                  <a:gd name="connsiteY6" fmla="*/ 219075 h 1031875"/>
                  <a:gd name="connsiteX7" fmla="*/ 168275 w 355600"/>
                  <a:gd name="connsiteY7" fmla="*/ 269875 h 1031875"/>
                  <a:gd name="connsiteX8" fmla="*/ 168275 w 355600"/>
                  <a:gd name="connsiteY8" fmla="*/ 323850 h 1031875"/>
                  <a:gd name="connsiteX9" fmla="*/ 184150 w 355600"/>
                  <a:gd name="connsiteY9" fmla="*/ 403225 h 1031875"/>
                  <a:gd name="connsiteX10" fmla="*/ 190500 w 355600"/>
                  <a:gd name="connsiteY10" fmla="*/ 454025 h 1031875"/>
                  <a:gd name="connsiteX11" fmla="*/ 190500 w 355600"/>
                  <a:gd name="connsiteY11" fmla="*/ 454025 h 1031875"/>
                  <a:gd name="connsiteX12" fmla="*/ 193675 w 355600"/>
                  <a:gd name="connsiteY12" fmla="*/ 511175 h 1031875"/>
                  <a:gd name="connsiteX13" fmla="*/ 187325 w 355600"/>
                  <a:gd name="connsiteY13" fmla="*/ 536575 h 1031875"/>
                  <a:gd name="connsiteX14" fmla="*/ 187325 w 355600"/>
                  <a:gd name="connsiteY14" fmla="*/ 584200 h 1031875"/>
                  <a:gd name="connsiteX15" fmla="*/ 196850 w 355600"/>
                  <a:gd name="connsiteY15" fmla="*/ 615950 h 1031875"/>
                  <a:gd name="connsiteX16" fmla="*/ 184150 w 355600"/>
                  <a:gd name="connsiteY16" fmla="*/ 647700 h 1031875"/>
                  <a:gd name="connsiteX17" fmla="*/ 193675 w 355600"/>
                  <a:gd name="connsiteY17" fmla="*/ 695325 h 1031875"/>
                  <a:gd name="connsiteX18" fmla="*/ 193675 w 355600"/>
                  <a:gd name="connsiteY18" fmla="*/ 730250 h 1031875"/>
                  <a:gd name="connsiteX19" fmla="*/ 180975 w 355600"/>
                  <a:gd name="connsiteY19" fmla="*/ 755650 h 1031875"/>
                  <a:gd name="connsiteX20" fmla="*/ 180975 w 355600"/>
                  <a:gd name="connsiteY20" fmla="*/ 800100 h 1031875"/>
                  <a:gd name="connsiteX21" fmla="*/ 155575 w 355600"/>
                  <a:gd name="connsiteY21" fmla="*/ 831850 h 1031875"/>
                  <a:gd name="connsiteX22" fmla="*/ 0 w 355600"/>
                  <a:gd name="connsiteY22" fmla="*/ 917575 h 1031875"/>
                  <a:gd name="connsiteX23" fmla="*/ 44450 w 355600"/>
                  <a:gd name="connsiteY23" fmla="*/ 933450 h 1031875"/>
                  <a:gd name="connsiteX24" fmla="*/ 79375 w 355600"/>
                  <a:gd name="connsiteY24" fmla="*/ 923925 h 1031875"/>
                  <a:gd name="connsiteX25" fmla="*/ 130175 w 355600"/>
                  <a:gd name="connsiteY25" fmla="*/ 917575 h 1031875"/>
                  <a:gd name="connsiteX26" fmla="*/ 139700 w 355600"/>
                  <a:gd name="connsiteY26" fmla="*/ 939800 h 1031875"/>
                  <a:gd name="connsiteX27" fmla="*/ 133350 w 355600"/>
                  <a:gd name="connsiteY27" fmla="*/ 974725 h 1031875"/>
                  <a:gd name="connsiteX28" fmla="*/ 123825 w 355600"/>
                  <a:gd name="connsiteY28" fmla="*/ 1006475 h 1031875"/>
                  <a:gd name="connsiteX29" fmla="*/ 136525 w 355600"/>
                  <a:gd name="connsiteY29" fmla="*/ 1025525 h 1031875"/>
                  <a:gd name="connsiteX30" fmla="*/ 152400 w 355600"/>
                  <a:gd name="connsiteY30" fmla="*/ 1031875 h 1031875"/>
                  <a:gd name="connsiteX31" fmla="*/ 152400 w 355600"/>
                  <a:gd name="connsiteY31" fmla="*/ 1031875 h 1031875"/>
                  <a:gd name="connsiteX32" fmla="*/ 155575 w 355600"/>
                  <a:gd name="connsiteY32" fmla="*/ 1000125 h 1031875"/>
                  <a:gd name="connsiteX33" fmla="*/ 184150 w 355600"/>
                  <a:gd name="connsiteY33" fmla="*/ 984250 h 1031875"/>
                  <a:gd name="connsiteX34" fmla="*/ 212725 w 355600"/>
                  <a:gd name="connsiteY34" fmla="*/ 965200 h 1031875"/>
                  <a:gd name="connsiteX35" fmla="*/ 222250 w 355600"/>
                  <a:gd name="connsiteY35" fmla="*/ 927100 h 1031875"/>
                  <a:gd name="connsiteX36" fmla="*/ 254000 w 355600"/>
                  <a:gd name="connsiteY36" fmla="*/ 936625 h 1031875"/>
                  <a:gd name="connsiteX37" fmla="*/ 292100 w 355600"/>
                  <a:gd name="connsiteY37" fmla="*/ 968375 h 1031875"/>
                  <a:gd name="connsiteX38" fmla="*/ 327025 w 355600"/>
                  <a:gd name="connsiteY38" fmla="*/ 993775 h 1031875"/>
                  <a:gd name="connsiteX39" fmla="*/ 355600 w 355600"/>
                  <a:gd name="connsiteY39" fmla="*/ 1012825 h 1031875"/>
                  <a:gd name="connsiteX40" fmla="*/ 342900 w 355600"/>
                  <a:gd name="connsiteY40" fmla="*/ 974725 h 1031875"/>
                  <a:gd name="connsiteX41" fmla="*/ 330200 w 355600"/>
                  <a:gd name="connsiteY41" fmla="*/ 939800 h 1031875"/>
                  <a:gd name="connsiteX42" fmla="*/ 330200 w 355600"/>
                  <a:gd name="connsiteY42" fmla="*/ 939800 h 1031875"/>
                  <a:gd name="connsiteX43" fmla="*/ 347325 w 355600"/>
                  <a:gd name="connsiteY43" fmla="*/ 908846 h 1031875"/>
                  <a:gd name="connsiteX44" fmla="*/ 276225 w 355600"/>
                  <a:gd name="connsiteY44" fmla="*/ 835025 h 1031875"/>
                  <a:gd name="connsiteX45" fmla="*/ 203200 w 355600"/>
                  <a:gd name="connsiteY45" fmla="*/ 190501 h 1031875"/>
                  <a:gd name="connsiteX46" fmla="*/ 212726 w 355600"/>
                  <a:gd name="connsiteY46" fmla="*/ 101601 h 1031875"/>
                  <a:gd name="connsiteX47" fmla="*/ 82550 w 355600"/>
                  <a:gd name="connsiteY47" fmla="*/ 0 h 1031875"/>
                  <a:gd name="connsiteX0" fmla="*/ 76200 w 407929"/>
                  <a:gd name="connsiteY0" fmla="*/ 3175 h 1031875"/>
                  <a:gd name="connsiteX1" fmla="*/ 69850 w 407929"/>
                  <a:gd name="connsiteY1" fmla="*/ 44450 h 1031875"/>
                  <a:gd name="connsiteX2" fmla="*/ 85725 w 407929"/>
                  <a:gd name="connsiteY2" fmla="*/ 69850 h 1031875"/>
                  <a:gd name="connsiteX3" fmla="*/ 114300 w 407929"/>
                  <a:gd name="connsiteY3" fmla="*/ 98425 h 1031875"/>
                  <a:gd name="connsiteX4" fmla="*/ 149225 w 407929"/>
                  <a:gd name="connsiteY4" fmla="*/ 130175 h 1031875"/>
                  <a:gd name="connsiteX5" fmla="*/ 168275 w 407929"/>
                  <a:gd name="connsiteY5" fmla="*/ 161925 h 1031875"/>
                  <a:gd name="connsiteX6" fmla="*/ 174625 w 407929"/>
                  <a:gd name="connsiteY6" fmla="*/ 219075 h 1031875"/>
                  <a:gd name="connsiteX7" fmla="*/ 168275 w 407929"/>
                  <a:gd name="connsiteY7" fmla="*/ 269875 h 1031875"/>
                  <a:gd name="connsiteX8" fmla="*/ 168275 w 407929"/>
                  <a:gd name="connsiteY8" fmla="*/ 323850 h 1031875"/>
                  <a:gd name="connsiteX9" fmla="*/ 184150 w 407929"/>
                  <a:gd name="connsiteY9" fmla="*/ 403225 h 1031875"/>
                  <a:gd name="connsiteX10" fmla="*/ 190500 w 407929"/>
                  <a:gd name="connsiteY10" fmla="*/ 454025 h 1031875"/>
                  <a:gd name="connsiteX11" fmla="*/ 190500 w 407929"/>
                  <a:gd name="connsiteY11" fmla="*/ 454025 h 1031875"/>
                  <a:gd name="connsiteX12" fmla="*/ 193675 w 407929"/>
                  <a:gd name="connsiteY12" fmla="*/ 511175 h 1031875"/>
                  <a:gd name="connsiteX13" fmla="*/ 187325 w 407929"/>
                  <a:gd name="connsiteY13" fmla="*/ 536575 h 1031875"/>
                  <a:gd name="connsiteX14" fmla="*/ 187325 w 407929"/>
                  <a:gd name="connsiteY14" fmla="*/ 584200 h 1031875"/>
                  <a:gd name="connsiteX15" fmla="*/ 196850 w 407929"/>
                  <a:gd name="connsiteY15" fmla="*/ 615950 h 1031875"/>
                  <a:gd name="connsiteX16" fmla="*/ 184150 w 407929"/>
                  <a:gd name="connsiteY16" fmla="*/ 647700 h 1031875"/>
                  <a:gd name="connsiteX17" fmla="*/ 193675 w 407929"/>
                  <a:gd name="connsiteY17" fmla="*/ 695325 h 1031875"/>
                  <a:gd name="connsiteX18" fmla="*/ 193675 w 407929"/>
                  <a:gd name="connsiteY18" fmla="*/ 730250 h 1031875"/>
                  <a:gd name="connsiteX19" fmla="*/ 180975 w 407929"/>
                  <a:gd name="connsiteY19" fmla="*/ 755650 h 1031875"/>
                  <a:gd name="connsiteX20" fmla="*/ 180975 w 407929"/>
                  <a:gd name="connsiteY20" fmla="*/ 800100 h 1031875"/>
                  <a:gd name="connsiteX21" fmla="*/ 155575 w 407929"/>
                  <a:gd name="connsiteY21" fmla="*/ 831850 h 1031875"/>
                  <a:gd name="connsiteX22" fmla="*/ 0 w 407929"/>
                  <a:gd name="connsiteY22" fmla="*/ 917575 h 1031875"/>
                  <a:gd name="connsiteX23" fmla="*/ 44450 w 407929"/>
                  <a:gd name="connsiteY23" fmla="*/ 933450 h 1031875"/>
                  <a:gd name="connsiteX24" fmla="*/ 79375 w 407929"/>
                  <a:gd name="connsiteY24" fmla="*/ 923925 h 1031875"/>
                  <a:gd name="connsiteX25" fmla="*/ 130175 w 407929"/>
                  <a:gd name="connsiteY25" fmla="*/ 917575 h 1031875"/>
                  <a:gd name="connsiteX26" fmla="*/ 139700 w 407929"/>
                  <a:gd name="connsiteY26" fmla="*/ 939800 h 1031875"/>
                  <a:gd name="connsiteX27" fmla="*/ 133350 w 407929"/>
                  <a:gd name="connsiteY27" fmla="*/ 974725 h 1031875"/>
                  <a:gd name="connsiteX28" fmla="*/ 123825 w 407929"/>
                  <a:gd name="connsiteY28" fmla="*/ 1006475 h 1031875"/>
                  <a:gd name="connsiteX29" fmla="*/ 136525 w 407929"/>
                  <a:gd name="connsiteY29" fmla="*/ 1025525 h 1031875"/>
                  <a:gd name="connsiteX30" fmla="*/ 152400 w 407929"/>
                  <a:gd name="connsiteY30" fmla="*/ 1031875 h 1031875"/>
                  <a:gd name="connsiteX31" fmla="*/ 152400 w 407929"/>
                  <a:gd name="connsiteY31" fmla="*/ 1031875 h 1031875"/>
                  <a:gd name="connsiteX32" fmla="*/ 155575 w 407929"/>
                  <a:gd name="connsiteY32" fmla="*/ 1000125 h 1031875"/>
                  <a:gd name="connsiteX33" fmla="*/ 184150 w 407929"/>
                  <a:gd name="connsiteY33" fmla="*/ 984250 h 1031875"/>
                  <a:gd name="connsiteX34" fmla="*/ 212725 w 407929"/>
                  <a:gd name="connsiteY34" fmla="*/ 965200 h 1031875"/>
                  <a:gd name="connsiteX35" fmla="*/ 222250 w 407929"/>
                  <a:gd name="connsiteY35" fmla="*/ 927100 h 1031875"/>
                  <a:gd name="connsiteX36" fmla="*/ 254000 w 407929"/>
                  <a:gd name="connsiteY36" fmla="*/ 936625 h 1031875"/>
                  <a:gd name="connsiteX37" fmla="*/ 292100 w 407929"/>
                  <a:gd name="connsiteY37" fmla="*/ 968375 h 1031875"/>
                  <a:gd name="connsiteX38" fmla="*/ 327025 w 407929"/>
                  <a:gd name="connsiteY38" fmla="*/ 993775 h 1031875"/>
                  <a:gd name="connsiteX39" fmla="*/ 355600 w 407929"/>
                  <a:gd name="connsiteY39" fmla="*/ 1012825 h 1031875"/>
                  <a:gd name="connsiteX40" fmla="*/ 342900 w 407929"/>
                  <a:gd name="connsiteY40" fmla="*/ 974725 h 1031875"/>
                  <a:gd name="connsiteX41" fmla="*/ 330200 w 407929"/>
                  <a:gd name="connsiteY41" fmla="*/ 939800 h 1031875"/>
                  <a:gd name="connsiteX42" fmla="*/ 330200 w 407929"/>
                  <a:gd name="connsiteY42" fmla="*/ 939800 h 1031875"/>
                  <a:gd name="connsiteX43" fmla="*/ 407650 w 407929"/>
                  <a:gd name="connsiteY43" fmla="*/ 883446 h 1031875"/>
                  <a:gd name="connsiteX44" fmla="*/ 276225 w 407929"/>
                  <a:gd name="connsiteY44" fmla="*/ 835025 h 1031875"/>
                  <a:gd name="connsiteX45" fmla="*/ 203200 w 407929"/>
                  <a:gd name="connsiteY45" fmla="*/ 190501 h 1031875"/>
                  <a:gd name="connsiteX46" fmla="*/ 212726 w 407929"/>
                  <a:gd name="connsiteY46" fmla="*/ 101601 h 1031875"/>
                  <a:gd name="connsiteX47" fmla="*/ 82550 w 407929"/>
                  <a:gd name="connsiteY47" fmla="*/ 0 h 1031875"/>
                  <a:gd name="connsiteX0" fmla="*/ 76200 w 407917"/>
                  <a:gd name="connsiteY0" fmla="*/ 3175 h 1031875"/>
                  <a:gd name="connsiteX1" fmla="*/ 69850 w 407917"/>
                  <a:gd name="connsiteY1" fmla="*/ 44450 h 1031875"/>
                  <a:gd name="connsiteX2" fmla="*/ 85725 w 407917"/>
                  <a:gd name="connsiteY2" fmla="*/ 69850 h 1031875"/>
                  <a:gd name="connsiteX3" fmla="*/ 114300 w 407917"/>
                  <a:gd name="connsiteY3" fmla="*/ 98425 h 1031875"/>
                  <a:gd name="connsiteX4" fmla="*/ 149225 w 407917"/>
                  <a:gd name="connsiteY4" fmla="*/ 130175 h 1031875"/>
                  <a:gd name="connsiteX5" fmla="*/ 168275 w 407917"/>
                  <a:gd name="connsiteY5" fmla="*/ 161925 h 1031875"/>
                  <a:gd name="connsiteX6" fmla="*/ 174625 w 407917"/>
                  <a:gd name="connsiteY6" fmla="*/ 219075 h 1031875"/>
                  <a:gd name="connsiteX7" fmla="*/ 168275 w 407917"/>
                  <a:gd name="connsiteY7" fmla="*/ 269875 h 1031875"/>
                  <a:gd name="connsiteX8" fmla="*/ 168275 w 407917"/>
                  <a:gd name="connsiteY8" fmla="*/ 323850 h 1031875"/>
                  <a:gd name="connsiteX9" fmla="*/ 184150 w 407917"/>
                  <a:gd name="connsiteY9" fmla="*/ 403225 h 1031875"/>
                  <a:gd name="connsiteX10" fmla="*/ 190500 w 407917"/>
                  <a:gd name="connsiteY10" fmla="*/ 454025 h 1031875"/>
                  <a:gd name="connsiteX11" fmla="*/ 190500 w 407917"/>
                  <a:gd name="connsiteY11" fmla="*/ 454025 h 1031875"/>
                  <a:gd name="connsiteX12" fmla="*/ 193675 w 407917"/>
                  <a:gd name="connsiteY12" fmla="*/ 511175 h 1031875"/>
                  <a:gd name="connsiteX13" fmla="*/ 187325 w 407917"/>
                  <a:gd name="connsiteY13" fmla="*/ 536575 h 1031875"/>
                  <a:gd name="connsiteX14" fmla="*/ 187325 w 407917"/>
                  <a:gd name="connsiteY14" fmla="*/ 584200 h 1031875"/>
                  <a:gd name="connsiteX15" fmla="*/ 196850 w 407917"/>
                  <a:gd name="connsiteY15" fmla="*/ 615950 h 1031875"/>
                  <a:gd name="connsiteX16" fmla="*/ 184150 w 407917"/>
                  <a:gd name="connsiteY16" fmla="*/ 647700 h 1031875"/>
                  <a:gd name="connsiteX17" fmla="*/ 193675 w 407917"/>
                  <a:gd name="connsiteY17" fmla="*/ 695325 h 1031875"/>
                  <a:gd name="connsiteX18" fmla="*/ 193675 w 407917"/>
                  <a:gd name="connsiteY18" fmla="*/ 730250 h 1031875"/>
                  <a:gd name="connsiteX19" fmla="*/ 180975 w 407917"/>
                  <a:gd name="connsiteY19" fmla="*/ 755650 h 1031875"/>
                  <a:gd name="connsiteX20" fmla="*/ 180975 w 407917"/>
                  <a:gd name="connsiteY20" fmla="*/ 800100 h 1031875"/>
                  <a:gd name="connsiteX21" fmla="*/ 155575 w 407917"/>
                  <a:gd name="connsiteY21" fmla="*/ 831850 h 1031875"/>
                  <a:gd name="connsiteX22" fmla="*/ 0 w 407917"/>
                  <a:gd name="connsiteY22" fmla="*/ 917575 h 1031875"/>
                  <a:gd name="connsiteX23" fmla="*/ 44450 w 407917"/>
                  <a:gd name="connsiteY23" fmla="*/ 933450 h 1031875"/>
                  <a:gd name="connsiteX24" fmla="*/ 79375 w 407917"/>
                  <a:gd name="connsiteY24" fmla="*/ 923925 h 1031875"/>
                  <a:gd name="connsiteX25" fmla="*/ 130175 w 407917"/>
                  <a:gd name="connsiteY25" fmla="*/ 917575 h 1031875"/>
                  <a:gd name="connsiteX26" fmla="*/ 139700 w 407917"/>
                  <a:gd name="connsiteY26" fmla="*/ 939800 h 1031875"/>
                  <a:gd name="connsiteX27" fmla="*/ 133350 w 407917"/>
                  <a:gd name="connsiteY27" fmla="*/ 974725 h 1031875"/>
                  <a:gd name="connsiteX28" fmla="*/ 123825 w 407917"/>
                  <a:gd name="connsiteY28" fmla="*/ 1006475 h 1031875"/>
                  <a:gd name="connsiteX29" fmla="*/ 136525 w 407917"/>
                  <a:gd name="connsiteY29" fmla="*/ 1025525 h 1031875"/>
                  <a:gd name="connsiteX30" fmla="*/ 152400 w 407917"/>
                  <a:gd name="connsiteY30" fmla="*/ 1031875 h 1031875"/>
                  <a:gd name="connsiteX31" fmla="*/ 152400 w 407917"/>
                  <a:gd name="connsiteY31" fmla="*/ 1031875 h 1031875"/>
                  <a:gd name="connsiteX32" fmla="*/ 155575 w 407917"/>
                  <a:gd name="connsiteY32" fmla="*/ 1000125 h 1031875"/>
                  <a:gd name="connsiteX33" fmla="*/ 184150 w 407917"/>
                  <a:gd name="connsiteY33" fmla="*/ 984250 h 1031875"/>
                  <a:gd name="connsiteX34" fmla="*/ 212725 w 407917"/>
                  <a:gd name="connsiteY34" fmla="*/ 965200 h 1031875"/>
                  <a:gd name="connsiteX35" fmla="*/ 222250 w 407917"/>
                  <a:gd name="connsiteY35" fmla="*/ 927100 h 1031875"/>
                  <a:gd name="connsiteX36" fmla="*/ 254000 w 407917"/>
                  <a:gd name="connsiteY36" fmla="*/ 936625 h 1031875"/>
                  <a:gd name="connsiteX37" fmla="*/ 292100 w 407917"/>
                  <a:gd name="connsiteY37" fmla="*/ 968375 h 1031875"/>
                  <a:gd name="connsiteX38" fmla="*/ 327025 w 407917"/>
                  <a:gd name="connsiteY38" fmla="*/ 993775 h 1031875"/>
                  <a:gd name="connsiteX39" fmla="*/ 355600 w 407917"/>
                  <a:gd name="connsiteY39" fmla="*/ 1012825 h 1031875"/>
                  <a:gd name="connsiteX40" fmla="*/ 342900 w 407917"/>
                  <a:gd name="connsiteY40" fmla="*/ 974725 h 1031875"/>
                  <a:gd name="connsiteX41" fmla="*/ 330200 w 407917"/>
                  <a:gd name="connsiteY41" fmla="*/ 939800 h 1031875"/>
                  <a:gd name="connsiteX42" fmla="*/ 330200 w 407917"/>
                  <a:gd name="connsiteY42" fmla="*/ 939800 h 1031875"/>
                  <a:gd name="connsiteX43" fmla="*/ 407650 w 407917"/>
                  <a:gd name="connsiteY43" fmla="*/ 883446 h 1031875"/>
                  <a:gd name="connsiteX44" fmla="*/ 276225 w 407917"/>
                  <a:gd name="connsiteY44" fmla="*/ 835025 h 1031875"/>
                  <a:gd name="connsiteX45" fmla="*/ 233025 w 407917"/>
                  <a:gd name="connsiteY45" fmla="*/ 740571 h 1031875"/>
                  <a:gd name="connsiteX46" fmla="*/ 203200 w 407917"/>
                  <a:gd name="connsiteY46" fmla="*/ 190501 h 1031875"/>
                  <a:gd name="connsiteX47" fmla="*/ 212726 w 407917"/>
                  <a:gd name="connsiteY47" fmla="*/ 101601 h 1031875"/>
                  <a:gd name="connsiteX48" fmla="*/ 82550 w 407917"/>
                  <a:gd name="connsiteY48" fmla="*/ 0 h 1031875"/>
                  <a:gd name="connsiteX0" fmla="*/ 76200 w 407917"/>
                  <a:gd name="connsiteY0" fmla="*/ 3175 h 1031875"/>
                  <a:gd name="connsiteX1" fmla="*/ 69850 w 407917"/>
                  <a:gd name="connsiteY1" fmla="*/ 44450 h 1031875"/>
                  <a:gd name="connsiteX2" fmla="*/ 85725 w 407917"/>
                  <a:gd name="connsiteY2" fmla="*/ 69850 h 1031875"/>
                  <a:gd name="connsiteX3" fmla="*/ 114300 w 407917"/>
                  <a:gd name="connsiteY3" fmla="*/ 98425 h 1031875"/>
                  <a:gd name="connsiteX4" fmla="*/ 149225 w 407917"/>
                  <a:gd name="connsiteY4" fmla="*/ 130175 h 1031875"/>
                  <a:gd name="connsiteX5" fmla="*/ 168275 w 407917"/>
                  <a:gd name="connsiteY5" fmla="*/ 161925 h 1031875"/>
                  <a:gd name="connsiteX6" fmla="*/ 174625 w 407917"/>
                  <a:gd name="connsiteY6" fmla="*/ 219075 h 1031875"/>
                  <a:gd name="connsiteX7" fmla="*/ 168275 w 407917"/>
                  <a:gd name="connsiteY7" fmla="*/ 269875 h 1031875"/>
                  <a:gd name="connsiteX8" fmla="*/ 168275 w 407917"/>
                  <a:gd name="connsiteY8" fmla="*/ 323850 h 1031875"/>
                  <a:gd name="connsiteX9" fmla="*/ 184150 w 407917"/>
                  <a:gd name="connsiteY9" fmla="*/ 403225 h 1031875"/>
                  <a:gd name="connsiteX10" fmla="*/ 190500 w 407917"/>
                  <a:gd name="connsiteY10" fmla="*/ 454025 h 1031875"/>
                  <a:gd name="connsiteX11" fmla="*/ 190500 w 407917"/>
                  <a:gd name="connsiteY11" fmla="*/ 454025 h 1031875"/>
                  <a:gd name="connsiteX12" fmla="*/ 193675 w 407917"/>
                  <a:gd name="connsiteY12" fmla="*/ 511175 h 1031875"/>
                  <a:gd name="connsiteX13" fmla="*/ 187325 w 407917"/>
                  <a:gd name="connsiteY13" fmla="*/ 536575 h 1031875"/>
                  <a:gd name="connsiteX14" fmla="*/ 187325 w 407917"/>
                  <a:gd name="connsiteY14" fmla="*/ 584200 h 1031875"/>
                  <a:gd name="connsiteX15" fmla="*/ 196850 w 407917"/>
                  <a:gd name="connsiteY15" fmla="*/ 615950 h 1031875"/>
                  <a:gd name="connsiteX16" fmla="*/ 184150 w 407917"/>
                  <a:gd name="connsiteY16" fmla="*/ 647700 h 1031875"/>
                  <a:gd name="connsiteX17" fmla="*/ 193675 w 407917"/>
                  <a:gd name="connsiteY17" fmla="*/ 695325 h 1031875"/>
                  <a:gd name="connsiteX18" fmla="*/ 193675 w 407917"/>
                  <a:gd name="connsiteY18" fmla="*/ 730250 h 1031875"/>
                  <a:gd name="connsiteX19" fmla="*/ 180975 w 407917"/>
                  <a:gd name="connsiteY19" fmla="*/ 755650 h 1031875"/>
                  <a:gd name="connsiteX20" fmla="*/ 180975 w 407917"/>
                  <a:gd name="connsiteY20" fmla="*/ 800100 h 1031875"/>
                  <a:gd name="connsiteX21" fmla="*/ 155575 w 407917"/>
                  <a:gd name="connsiteY21" fmla="*/ 831850 h 1031875"/>
                  <a:gd name="connsiteX22" fmla="*/ 0 w 407917"/>
                  <a:gd name="connsiteY22" fmla="*/ 917575 h 1031875"/>
                  <a:gd name="connsiteX23" fmla="*/ 44450 w 407917"/>
                  <a:gd name="connsiteY23" fmla="*/ 933450 h 1031875"/>
                  <a:gd name="connsiteX24" fmla="*/ 79375 w 407917"/>
                  <a:gd name="connsiteY24" fmla="*/ 923925 h 1031875"/>
                  <a:gd name="connsiteX25" fmla="*/ 130175 w 407917"/>
                  <a:gd name="connsiteY25" fmla="*/ 917575 h 1031875"/>
                  <a:gd name="connsiteX26" fmla="*/ 139700 w 407917"/>
                  <a:gd name="connsiteY26" fmla="*/ 939800 h 1031875"/>
                  <a:gd name="connsiteX27" fmla="*/ 133350 w 407917"/>
                  <a:gd name="connsiteY27" fmla="*/ 974725 h 1031875"/>
                  <a:gd name="connsiteX28" fmla="*/ 123825 w 407917"/>
                  <a:gd name="connsiteY28" fmla="*/ 1006475 h 1031875"/>
                  <a:gd name="connsiteX29" fmla="*/ 136525 w 407917"/>
                  <a:gd name="connsiteY29" fmla="*/ 1025525 h 1031875"/>
                  <a:gd name="connsiteX30" fmla="*/ 152400 w 407917"/>
                  <a:gd name="connsiteY30" fmla="*/ 1031875 h 1031875"/>
                  <a:gd name="connsiteX31" fmla="*/ 152400 w 407917"/>
                  <a:gd name="connsiteY31" fmla="*/ 1031875 h 1031875"/>
                  <a:gd name="connsiteX32" fmla="*/ 155575 w 407917"/>
                  <a:gd name="connsiteY32" fmla="*/ 1000125 h 1031875"/>
                  <a:gd name="connsiteX33" fmla="*/ 184150 w 407917"/>
                  <a:gd name="connsiteY33" fmla="*/ 984250 h 1031875"/>
                  <a:gd name="connsiteX34" fmla="*/ 212725 w 407917"/>
                  <a:gd name="connsiteY34" fmla="*/ 965200 h 1031875"/>
                  <a:gd name="connsiteX35" fmla="*/ 222250 w 407917"/>
                  <a:gd name="connsiteY35" fmla="*/ 927100 h 1031875"/>
                  <a:gd name="connsiteX36" fmla="*/ 254000 w 407917"/>
                  <a:gd name="connsiteY36" fmla="*/ 936625 h 1031875"/>
                  <a:gd name="connsiteX37" fmla="*/ 292100 w 407917"/>
                  <a:gd name="connsiteY37" fmla="*/ 968375 h 1031875"/>
                  <a:gd name="connsiteX38" fmla="*/ 327025 w 407917"/>
                  <a:gd name="connsiteY38" fmla="*/ 993775 h 1031875"/>
                  <a:gd name="connsiteX39" fmla="*/ 355600 w 407917"/>
                  <a:gd name="connsiteY39" fmla="*/ 1012825 h 1031875"/>
                  <a:gd name="connsiteX40" fmla="*/ 342900 w 407917"/>
                  <a:gd name="connsiteY40" fmla="*/ 974725 h 1031875"/>
                  <a:gd name="connsiteX41" fmla="*/ 330200 w 407917"/>
                  <a:gd name="connsiteY41" fmla="*/ 939800 h 1031875"/>
                  <a:gd name="connsiteX42" fmla="*/ 330200 w 407917"/>
                  <a:gd name="connsiteY42" fmla="*/ 939800 h 1031875"/>
                  <a:gd name="connsiteX43" fmla="*/ 407650 w 407917"/>
                  <a:gd name="connsiteY43" fmla="*/ 883446 h 1031875"/>
                  <a:gd name="connsiteX44" fmla="*/ 276225 w 407917"/>
                  <a:gd name="connsiteY44" fmla="*/ 835025 h 1031875"/>
                  <a:gd name="connsiteX45" fmla="*/ 233025 w 407917"/>
                  <a:gd name="connsiteY45" fmla="*/ 740571 h 1031875"/>
                  <a:gd name="connsiteX46" fmla="*/ 236200 w 407917"/>
                  <a:gd name="connsiteY46" fmla="*/ 562771 h 1031875"/>
                  <a:gd name="connsiteX47" fmla="*/ 203200 w 407917"/>
                  <a:gd name="connsiteY47" fmla="*/ 190501 h 1031875"/>
                  <a:gd name="connsiteX48" fmla="*/ 212726 w 407917"/>
                  <a:gd name="connsiteY48" fmla="*/ 101601 h 1031875"/>
                  <a:gd name="connsiteX49" fmla="*/ 82550 w 407917"/>
                  <a:gd name="connsiteY49" fmla="*/ 0 h 1031875"/>
                  <a:gd name="connsiteX0" fmla="*/ 76200 w 407917"/>
                  <a:gd name="connsiteY0" fmla="*/ 3175 h 1031875"/>
                  <a:gd name="connsiteX1" fmla="*/ 69850 w 407917"/>
                  <a:gd name="connsiteY1" fmla="*/ 44450 h 1031875"/>
                  <a:gd name="connsiteX2" fmla="*/ 85725 w 407917"/>
                  <a:gd name="connsiteY2" fmla="*/ 69850 h 1031875"/>
                  <a:gd name="connsiteX3" fmla="*/ 114300 w 407917"/>
                  <a:gd name="connsiteY3" fmla="*/ 98425 h 1031875"/>
                  <a:gd name="connsiteX4" fmla="*/ 149225 w 407917"/>
                  <a:gd name="connsiteY4" fmla="*/ 130175 h 1031875"/>
                  <a:gd name="connsiteX5" fmla="*/ 168275 w 407917"/>
                  <a:gd name="connsiteY5" fmla="*/ 161925 h 1031875"/>
                  <a:gd name="connsiteX6" fmla="*/ 174625 w 407917"/>
                  <a:gd name="connsiteY6" fmla="*/ 219075 h 1031875"/>
                  <a:gd name="connsiteX7" fmla="*/ 168275 w 407917"/>
                  <a:gd name="connsiteY7" fmla="*/ 269875 h 1031875"/>
                  <a:gd name="connsiteX8" fmla="*/ 168275 w 407917"/>
                  <a:gd name="connsiteY8" fmla="*/ 323850 h 1031875"/>
                  <a:gd name="connsiteX9" fmla="*/ 184150 w 407917"/>
                  <a:gd name="connsiteY9" fmla="*/ 403225 h 1031875"/>
                  <a:gd name="connsiteX10" fmla="*/ 190500 w 407917"/>
                  <a:gd name="connsiteY10" fmla="*/ 454025 h 1031875"/>
                  <a:gd name="connsiteX11" fmla="*/ 190500 w 407917"/>
                  <a:gd name="connsiteY11" fmla="*/ 454025 h 1031875"/>
                  <a:gd name="connsiteX12" fmla="*/ 193675 w 407917"/>
                  <a:gd name="connsiteY12" fmla="*/ 511175 h 1031875"/>
                  <a:gd name="connsiteX13" fmla="*/ 187325 w 407917"/>
                  <a:gd name="connsiteY13" fmla="*/ 536575 h 1031875"/>
                  <a:gd name="connsiteX14" fmla="*/ 187325 w 407917"/>
                  <a:gd name="connsiteY14" fmla="*/ 584200 h 1031875"/>
                  <a:gd name="connsiteX15" fmla="*/ 196850 w 407917"/>
                  <a:gd name="connsiteY15" fmla="*/ 615950 h 1031875"/>
                  <a:gd name="connsiteX16" fmla="*/ 184150 w 407917"/>
                  <a:gd name="connsiteY16" fmla="*/ 647700 h 1031875"/>
                  <a:gd name="connsiteX17" fmla="*/ 193675 w 407917"/>
                  <a:gd name="connsiteY17" fmla="*/ 695325 h 1031875"/>
                  <a:gd name="connsiteX18" fmla="*/ 193675 w 407917"/>
                  <a:gd name="connsiteY18" fmla="*/ 730250 h 1031875"/>
                  <a:gd name="connsiteX19" fmla="*/ 180975 w 407917"/>
                  <a:gd name="connsiteY19" fmla="*/ 755650 h 1031875"/>
                  <a:gd name="connsiteX20" fmla="*/ 180975 w 407917"/>
                  <a:gd name="connsiteY20" fmla="*/ 800100 h 1031875"/>
                  <a:gd name="connsiteX21" fmla="*/ 155575 w 407917"/>
                  <a:gd name="connsiteY21" fmla="*/ 831850 h 1031875"/>
                  <a:gd name="connsiteX22" fmla="*/ 0 w 407917"/>
                  <a:gd name="connsiteY22" fmla="*/ 917575 h 1031875"/>
                  <a:gd name="connsiteX23" fmla="*/ 44450 w 407917"/>
                  <a:gd name="connsiteY23" fmla="*/ 933450 h 1031875"/>
                  <a:gd name="connsiteX24" fmla="*/ 79375 w 407917"/>
                  <a:gd name="connsiteY24" fmla="*/ 923925 h 1031875"/>
                  <a:gd name="connsiteX25" fmla="*/ 130175 w 407917"/>
                  <a:gd name="connsiteY25" fmla="*/ 917575 h 1031875"/>
                  <a:gd name="connsiteX26" fmla="*/ 139700 w 407917"/>
                  <a:gd name="connsiteY26" fmla="*/ 939800 h 1031875"/>
                  <a:gd name="connsiteX27" fmla="*/ 133350 w 407917"/>
                  <a:gd name="connsiteY27" fmla="*/ 974725 h 1031875"/>
                  <a:gd name="connsiteX28" fmla="*/ 123825 w 407917"/>
                  <a:gd name="connsiteY28" fmla="*/ 1006475 h 1031875"/>
                  <a:gd name="connsiteX29" fmla="*/ 136525 w 407917"/>
                  <a:gd name="connsiteY29" fmla="*/ 1025525 h 1031875"/>
                  <a:gd name="connsiteX30" fmla="*/ 152400 w 407917"/>
                  <a:gd name="connsiteY30" fmla="*/ 1031875 h 1031875"/>
                  <a:gd name="connsiteX31" fmla="*/ 152400 w 407917"/>
                  <a:gd name="connsiteY31" fmla="*/ 1031875 h 1031875"/>
                  <a:gd name="connsiteX32" fmla="*/ 155575 w 407917"/>
                  <a:gd name="connsiteY32" fmla="*/ 1000125 h 1031875"/>
                  <a:gd name="connsiteX33" fmla="*/ 184150 w 407917"/>
                  <a:gd name="connsiteY33" fmla="*/ 984250 h 1031875"/>
                  <a:gd name="connsiteX34" fmla="*/ 212725 w 407917"/>
                  <a:gd name="connsiteY34" fmla="*/ 965200 h 1031875"/>
                  <a:gd name="connsiteX35" fmla="*/ 222250 w 407917"/>
                  <a:gd name="connsiteY35" fmla="*/ 927100 h 1031875"/>
                  <a:gd name="connsiteX36" fmla="*/ 254000 w 407917"/>
                  <a:gd name="connsiteY36" fmla="*/ 936625 h 1031875"/>
                  <a:gd name="connsiteX37" fmla="*/ 292100 w 407917"/>
                  <a:gd name="connsiteY37" fmla="*/ 968375 h 1031875"/>
                  <a:gd name="connsiteX38" fmla="*/ 327025 w 407917"/>
                  <a:gd name="connsiteY38" fmla="*/ 993775 h 1031875"/>
                  <a:gd name="connsiteX39" fmla="*/ 355600 w 407917"/>
                  <a:gd name="connsiteY39" fmla="*/ 1012825 h 1031875"/>
                  <a:gd name="connsiteX40" fmla="*/ 342900 w 407917"/>
                  <a:gd name="connsiteY40" fmla="*/ 974725 h 1031875"/>
                  <a:gd name="connsiteX41" fmla="*/ 330200 w 407917"/>
                  <a:gd name="connsiteY41" fmla="*/ 939800 h 1031875"/>
                  <a:gd name="connsiteX42" fmla="*/ 330200 w 407917"/>
                  <a:gd name="connsiteY42" fmla="*/ 939800 h 1031875"/>
                  <a:gd name="connsiteX43" fmla="*/ 407650 w 407917"/>
                  <a:gd name="connsiteY43" fmla="*/ 883446 h 1031875"/>
                  <a:gd name="connsiteX44" fmla="*/ 276225 w 407917"/>
                  <a:gd name="connsiteY44" fmla="*/ 835025 h 1031875"/>
                  <a:gd name="connsiteX45" fmla="*/ 233025 w 407917"/>
                  <a:gd name="connsiteY45" fmla="*/ 740571 h 1031875"/>
                  <a:gd name="connsiteX46" fmla="*/ 236200 w 407917"/>
                  <a:gd name="connsiteY46" fmla="*/ 562771 h 1031875"/>
                  <a:gd name="connsiteX47" fmla="*/ 203200 w 407917"/>
                  <a:gd name="connsiteY47" fmla="*/ 190501 h 1031875"/>
                  <a:gd name="connsiteX48" fmla="*/ 184151 w 407917"/>
                  <a:gd name="connsiteY48" fmla="*/ 73026 h 1031875"/>
                  <a:gd name="connsiteX49" fmla="*/ 82550 w 407917"/>
                  <a:gd name="connsiteY49" fmla="*/ 0 h 1031875"/>
                  <a:gd name="connsiteX0" fmla="*/ 76200 w 407917"/>
                  <a:gd name="connsiteY0" fmla="*/ 3175 h 1031875"/>
                  <a:gd name="connsiteX1" fmla="*/ 69850 w 407917"/>
                  <a:gd name="connsiteY1" fmla="*/ 44450 h 1031875"/>
                  <a:gd name="connsiteX2" fmla="*/ 85725 w 407917"/>
                  <a:gd name="connsiteY2" fmla="*/ 69850 h 1031875"/>
                  <a:gd name="connsiteX3" fmla="*/ 114300 w 407917"/>
                  <a:gd name="connsiteY3" fmla="*/ 98425 h 1031875"/>
                  <a:gd name="connsiteX4" fmla="*/ 149225 w 407917"/>
                  <a:gd name="connsiteY4" fmla="*/ 130175 h 1031875"/>
                  <a:gd name="connsiteX5" fmla="*/ 168275 w 407917"/>
                  <a:gd name="connsiteY5" fmla="*/ 161925 h 1031875"/>
                  <a:gd name="connsiteX6" fmla="*/ 174625 w 407917"/>
                  <a:gd name="connsiteY6" fmla="*/ 219075 h 1031875"/>
                  <a:gd name="connsiteX7" fmla="*/ 168275 w 407917"/>
                  <a:gd name="connsiteY7" fmla="*/ 269875 h 1031875"/>
                  <a:gd name="connsiteX8" fmla="*/ 168275 w 407917"/>
                  <a:gd name="connsiteY8" fmla="*/ 323850 h 1031875"/>
                  <a:gd name="connsiteX9" fmla="*/ 184150 w 407917"/>
                  <a:gd name="connsiteY9" fmla="*/ 403225 h 1031875"/>
                  <a:gd name="connsiteX10" fmla="*/ 190500 w 407917"/>
                  <a:gd name="connsiteY10" fmla="*/ 454025 h 1031875"/>
                  <a:gd name="connsiteX11" fmla="*/ 190500 w 407917"/>
                  <a:gd name="connsiteY11" fmla="*/ 454025 h 1031875"/>
                  <a:gd name="connsiteX12" fmla="*/ 193675 w 407917"/>
                  <a:gd name="connsiteY12" fmla="*/ 511175 h 1031875"/>
                  <a:gd name="connsiteX13" fmla="*/ 187325 w 407917"/>
                  <a:gd name="connsiteY13" fmla="*/ 536575 h 1031875"/>
                  <a:gd name="connsiteX14" fmla="*/ 187325 w 407917"/>
                  <a:gd name="connsiteY14" fmla="*/ 584200 h 1031875"/>
                  <a:gd name="connsiteX15" fmla="*/ 196850 w 407917"/>
                  <a:gd name="connsiteY15" fmla="*/ 615950 h 1031875"/>
                  <a:gd name="connsiteX16" fmla="*/ 184150 w 407917"/>
                  <a:gd name="connsiteY16" fmla="*/ 647700 h 1031875"/>
                  <a:gd name="connsiteX17" fmla="*/ 193675 w 407917"/>
                  <a:gd name="connsiteY17" fmla="*/ 695325 h 1031875"/>
                  <a:gd name="connsiteX18" fmla="*/ 193675 w 407917"/>
                  <a:gd name="connsiteY18" fmla="*/ 730250 h 1031875"/>
                  <a:gd name="connsiteX19" fmla="*/ 180975 w 407917"/>
                  <a:gd name="connsiteY19" fmla="*/ 755650 h 1031875"/>
                  <a:gd name="connsiteX20" fmla="*/ 180975 w 407917"/>
                  <a:gd name="connsiteY20" fmla="*/ 800100 h 1031875"/>
                  <a:gd name="connsiteX21" fmla="*/ 155575 w 407917"/>
                  <a:gd name="connsiteY21" fmla="*/ 831850 h 1031875"/>
                  <a:gd name="connsiteX22" fmla="*/ 0 w 407917"/>
                  <a:gd name="connsiteY22" fmla="*/ 917575 h 1031875"/>
                  <a:gd name="connsiteX23" fmla="*/ 44450 w 407917"/>
                  <a:gd name="connsiteY23" fmla="*/ 933450 h 1031875"/>
                  <a:gd name="connsiteX24" fmla="*/ 79375 w 407917"/>
                  <a:gd name="connsiteY24" fmla="*/ 923925 h 1031875"/>
                  <a:gd name="connsiteX25" fmla="*/ 130175 w 407917"/>
                  <a:gd name="connsiteY25" fmla="*/ 917575 h 1031875"/>
                  <a:gd name="connsiteX26" fmla="*/ 139700 w 407917"/>
                  <a:gd name="connsiteY26" fmla="*/ 939800 h 1031875"/>
                  <a:gd name="connsiteX27" fmla="*/ 133350 w 407917"/>
                  <a:gd name="connsiteY27" fmla="*/ 974725 h 1031875"/>
                  <a:gd name="connsiteX28" fmla="*/ 123825 w 407917"/>
                  <a:gd name="connsiteY28" fmla="*/ 1006475 h 1031875"/>
                  <a:gd name="connsiteX29" fmla="*/ 136525 w 407917"/>
                  <a:gd name="connsiteY29" fmla="*/ 1025525 h 1031875"/>
                  <a:gd name="connsiteX30" fmla="*/ 152400 w 407917"/>
                  <a:gd name="connsiteY30" fmla="*/ 1031875 h 1031875"/>
                  <a:gd name="connsiteX31" fmla="*/ 152400 w 407917"/>
                  <a:gd name="connsiteY31" fmla="*/ 1031875 h 1031875"/>
                  <a:gd name="connsiteX32" fmla="*/ 155575 w 407917"/>
                  <a:gd name="connsiteY32" fmla="*/ 1000125 h 1031875"/>
                  <a:gd name="connsiteX33" fmla="*/ 184150 w 407917"/>
                  <a:gd name="connsiteY33" fmla="*/ 984250 h 1031875"/>
                  <a:gd name="connsiteX34" fmla="*/ 212725 w 407917"/>
                  <a:gd name="connsiteY34" fmla="*/ 965200 h 1031875"/>
                  <a:gd name="connsiteX35" fmla="*/ 222250 w 407917"/>
                  <a:gd name="connsiteY35" fmla="*/ 927100 h 1031875"/>
                  <a:gd name="connsiteX36" fmla="*/ 254000 w 407917"/>
                  <a:gd name="connsiteY36" fmla="*/ 936625 h 1031875"/>
                  <a:gd name="connsiteX37" fmla="*/ 292100 w 407917"/>
                  <a:gd name="connsiteY37" fmla="*/ 968375 h 1031875"/>
                  <a:gd name="connsiteX38" fmla="*/ 327025 w 407917"/>
                  <a:gd name="connsiteY38" fmla="*/ 993775 h 1031875"/>
                  <a:gd name="connsiteX39" fmla="*/ 355600 w 407917"/>
                  <a:gd name="connsiteY39" fmla="*/ 1012825 h 1031875"/>
                  <a:gd name="connsiteX40" fmla="*/ 342900 w 407917"/>
                  <a:gd name="connsiteY40" fmla="*/ 974725 h 1031875"/>
                  <a:gd name="connsiteX41" fmla="*/ 330200 w 407917"/>
                  <a:gd name="connsiteY41" fmla="*/ 939800 h 1031875"/>
                  <a:gd name="connsiteX42" fmla="*/ 330200 w 407917"/>
                  <a:gd name="connsiteY42" fmla="*/ 939800 h 1031875"/>
                  <a:gd name="connsiteX43" fmla="*/ 407650 w 407917"/>
                  <a:gd name="connsiteY43" fmla="*/ 883446 h 1031875"/>
                  <a:gd name="connsiteX44" fmla="*/ 276225 w 407917"/>
                  <a:gd name="connsiteY44" fmla="*/ 835025 h 1031875"/>
                  <a:gd name="connsiteX45" fmla="*/ 233025 w 407917"/>
                  <a:gd name="connsiteY45" fmla="*/ 740571 h 1031875"/>
                  <a:gd name="connsiteX46" fmla="*/ 236200 w 407917"/>
                  <a:gd name="connsiteY46" fmla="*/ 562771 h 1031875"/>
                  <a:gd name="connsiteX47" fmla="*/ 203200 w 407917"/>
                  <a:gd name="connsiteY47" fmla="*/ 190501 h 1031875"/>
                  <a:gd name="connsiteX48" fmla="*/ 184151 w 407917"/>
                  <a:gd name="connsiteY48" fmla="*/ 73026 h 1031875"/>
                  <a:gd name="connsiteX49" fmla="*/ 82550 w 407917"/>
                  <a:gd name="connsiteY49" fmla="*/ 0 h 1031875"/>
                  <a:gd name="connsiteX0" fmla="*/ 76200 w 407917"/>
                  <a:gd name="connsiteY0" fmla="*/ 3175 h 1031875"/>
                  <a:gd name="connsiteX1" fmla="*/ 69850 w 407917"/>
                  <a:gd name="connsiteY1" fmla="*/ 44450 h 1031875"/>
                  <a:gd name="connsiteX2" fmla="*/ 85725 w 407917"/>
                  <a:gd name="connsiteY2" fmla="*/ 69850 h 1031875"/>
                  <a:gd name="connsiteX3" fmla="*/ 114300 w 407917"/>
                  <a:gd name="connsiteY3" fmla="*/ 98425 h 1031875"/>
                  <a:gd name="connsiteX4" fmla="*/ 149225 w 407917"/>
                  <a:gd name="connsiteY4" fmla="*/ 130175 h 1031875"/>
                  <a:gd name="connsiteX5" fmla="*/ 168275 w 407917"/>
                  <a:gd name="connsiteY5" fmla="*/ 161925 h 1031875"/>
                  <a:gd name="connsiteX6" fmla="*/ 174625 w 407917"/>
                  <a:gd name="connsiteY6" fmla="*/ 219075 h 1031875"/>
                  <a:gd name="connsiteX7" fmla="*/ 168275 w 407917"/>
                  <a:gd name="connsiteY7" fmla="*/ 269875 h 1031875"/>
                  <a:gd name="connsiteX8" fmla="*/ 168275 w 407917"/>
                  <a:gd name="connsiteY8" fmla="*/ 323850 h 1031875"/>
                  <a:gd name="connsiteX9" fmla="*/ 184150 w 407917"/>
                  <a:gd name="connsiteY9" fmla="*/ 403225 h 1031875"/>
                  <a:gd name="connsiteX10" fmla="*/ 190500 w 407917"/>
                  <a:gd name="connsiteY10" fmla="*/ 454025 h 1031875"/>
                  <a:gd name="connsiteX11" fmla="*/ 190500 w 407917"/>
                  <a:gd name="connsiteY11" fmla="*/ 454025 h 1031875"/>
                  <a:gd name="connsiteX12" fmla="*/ 193675 w 407917"/>
                  <a:gd name="connsiteY12" fmla="*/ 511175 h 1031875"/>
                  <a:gd name="connsiteX13" fmla="*/ 187325 w 407917"/>
                  <a:gd name="connsiteY13" fmla="*/ 536575 h 1031875"/>
                  <a:gd name="connsiteX14" fmla="*/ 187325 w 407917"/>
                  <a:gd name="connsiteY14" fmla="*/ 584200 h 1031875"/>
                  <a:gd name="connsiteX15" fmla="*/ 196850 w 407917"/>
                  <a:gd name="connsiteY15" fmla="*/ 615950 h 1031875"/>
                  <a:gd name="connsiteX16" fmla="*/ 184150 w 407917"/>
                  <a:gd name="connsiteY16" fmla="*/ 647700 h 1031875"/>
                  <a:gd name="connsiteX17" fmla="*/ 193675 w 407917"/>
                  <a:gd name="connsiteY17" fmla="*/ 695325 h 1031875"/>
                  <a:gd name="connsiteX18" fmla="*/ 193675 w 407917"/>
                  <a:gd name="connsiteY18" fmla="*/ 730250 h 1031875"/>
                  <a:gd name="connsiteX19" fmla="*/ 180975 w 407917"/>
                  <a:gd name="connsiteY19" fmla="*/ 755650 h 1031875"/>
                  <a:gd name="connsiteX20" fmla="*/ 180975 w 407917"/>
                  <a:gd name="connsiteY20" fmla="*/ 800100 h 1031875"/>
                  <a:gd name="connsiteX21" fmla="*/ 155575 w 407917"/>
                  <a:gd name="connsiteY21" fmla="*/ 831850 h 1031875"/>
                  <a:gd name="connsiteX22" fmla="*/ 0 w 407917"/>
                  <a:gd name="connsiteY22" fmla="*/ 917575 h 1031875"/>
                  <a:gd name="connsiteX23" fmla="*/ 44450 w 407917"/>
                  <a:gd name="connsiteY23" fmla="*/ 933450 h 1031875"/>
                  <a:gd name="connsiteX24" fmla="*/ 79375 w 407917"/>
                  <a:gd name="connsiteY24" fmla="*/ 923925 h 1031875"/>
                  <a:gd name="connsiteX25" fmla="*/ 130175 w 407917"/>
                  <a:gd name="connsiteY25" fmla="*/ 917575 h 1031875"/>
                  <a:gd name="connsiteX26" fmla="*/ 139700 w 407917"/>
                  <a:gd name="connsiteY26" fmla="*/ 939800 h 1031875"/>
                  <a:gd name="connsiteX27" fmla="*/ 133350 w 407917"/>
                  <a:gd name="connsiteY27" fmla="*/ 974725 h 1031875"/>
                  <a:gd name="connsiteX28" fmla="*/ 123825 w 407917"/>
                  <a:gd name="connsiteY28" fmla="*/ 1006475 h 1031875"/>
                  <a:gd name="connsiteX29" fmla="*/ 136525 w 407917"/>
                  <a:gd name="connsiteY29" fmla="*/ 1025525 h 1031875"/>
                  <a:gd name="connsiteX30" fmla="*/ 152400 w 407917"/>
                  <a:gd name="connsiteY30" fmla="*/ 1031875 h 1031875"/>
                  <a:gd name="connsiteX31" fmla="*/ 152400 w 407917"/>
                  <a:gd name="connsiteY31" fmla="*/ 1031875 h 1031875"/>
                  <a:gd name="connsiteX32" fmla="*/ 155575 w 407917"/>
                  <a:gd name="connsiteY32" fmla="*/ 1000125 h 1031875"/>
                  <a:gd name="connsiteX33" fmla="*/ 184150 w 407917"/>
                  <a:gd name="connsiteY33" fmla="*/ 984250 h 1031875"/>
                  <a:gd name="connsiteX34" fmla="*/ 212725 w 407917"/>
                  <a:gd name="connsiteY34" fmla="*/ 965200 h 1031875"/>
                  <a:gd name="connsiteX35" fmla="*/ 222250 w 407917"/>
                  <a:gd name="connsiteY35" fmla="*/ 927100 h 1031875"/>
                  <a:gd name="connsiteX36" fmla="*/ 254000 w 407917"/>
                  <a:gd name="connsiteY36" fmla="*/ 936625 h 1031875"/>
                  <a:gd name="connsiteX37" fmla="*/ 292100 w 407917"/>
                  <a:gd name="connsiteY37" fmla="*/ 968375 h 1031875"/>
                  <a:gd name="connsiteX38" fmla="*/ 327025 w 407917"/>
                  <a:gd name="connsiteY38" fmla="*/ 993775 h 1031875"/>
                  <a:gd name="connsiteX39" fmla="*/ 355600 w 407917"/>
                  <a:gd name="connsiteY39" fmla="*/ 1012825 h 1031875"/>
                  <a:gd name="connsiteX40" fmla="*/ 342900 w 407917"/>
                  <a:gd name="connsiteY40" fmla="*/ 974725 h 1031875"/>
                  <a:gd name="connsiteX41" fmla="*/ 330200 w 407917"/>
                  <a:gd name="connsiteY41" fmla="*/ 939800 h 1031875"/>
                  <a:gd name="connsiteX42" fmla="*/ 330200 w 407917"/>
                  <a:gd name="connsiteY42" fmla="*/ 939800 h 1031875"/>
                  <a:gd name="connsiteX43" fmla="*/ 407650 w 407917"/>
                  <a:gd name="connsiteY43" fmla="*/ 883446 h 1031875"/>
                  <a:gd name="connsiteX44" fmla="*/ 276225 w 407917"/>
                  <a:gd name="connsiteY44" fmla="*/ 835025 h 1031875"/>
                  <a:gd name="connsiteX45" fmla="*/ 233025 w 407917"/>
                  <a:gd name="connsiteY45" fmla="*/ 740571 h 1031875"/>
                  <a:gd name="connsiteX46" fmla="*/ 236200 w 407917"/>
                  <a:gd name="connsiteY46" fmla="*/ 562771 h 1031875"/>
                  <a:gd name="connsiteX47" fmla="*/ 203200 w 407917"/>
                  <a:gd name="connsiteY47" fmla="*/ 190501 h 1031875"/>
                  <a:gd name="connsiteX48" fmla="*/ 280650 w 407917"/>
                  <a:gd name="connsiteY48" fmla="*/ 45246 h 1031875"/>
                  <a:gd name="connsiteX49" fmla="*/ 184151 w 407917"/>
                  <a:gd name="connsiteY49" fmla="*/ 73026 h 1031875"/>
                  <a:gd name="connsiteX50" fmla="*/ 82550 w 407917"/>
                  <a:gd name="connsiteY50" fmla="*/ 0 h 1031875"/>
                  <a:gd name="connsiteX0" fmla="*/ 76200 w 407917"/>
                  <a:gd name="connsiteY0" fmla="*/ 3175 h 1031875"/>
                  <a:gd name="connsiteX1" fmla="*/ 69850 w 407917"/>
                  <a:gd name="connsiteY1" fmla="*/ 44450 h 1031875"/>
                  <a:gd name="connsiteX2" fmla="*/ 85725 w 407917"/>
                  <a:gd name="connsiteY2" fmla="*/ 69850 h 1031875"/>
                  <a:gd name="connsiteX3" fmla="*/ 114300 w 407917"/>
                  <a:gd name="connsiteY3" fmla="*/ 98425 h 1031875"/>
                  <a:gd name="connsiteX4" fmla="*/ 149225 w 407917"/>
                  <a:gd name="connsiteY4" fmla="*/ 130175 h 1031875"/>
                  <a:gd name="connsiteX5" fmla="*/ 168275 w 407917"/>
                  <a:gd name="connsiteY5" fmla="*/ 161925 h 1031875"/>
                  <a:gd name="connsiteX6" fmla="*/ 174625 w 407917"/>
                  <a:gd name="connsiteY6" fmla="*/ 219075 h 1031875"/>
                  <a:gd name="connsiteX7" fmla="*/ 168275 w 407917"/>
                  <a:gd name="connsiteY7" fmla="*/ 269875 h 1031875"/>
                  <a:gd name="connsiteX8" fmla="*/ 168275 w 407917"/>
                  <a:gd name="connsiteY8" fmla="*/ 323850 h 1031875"/>
                  <a:gd name="connsiteX9" fmla="*/ 184150 w 407917"/>
                  <a:gd name="connsiteY9" fmla="*/ 403225 h 1031875"/>
                  <a:gd name="connsiteX10" fmla="*/ 190500 w 407917"/>
                  <a:gd name="connsiteY10" fmla="*/ 454025 h 1031875"/>
                  <a:gd name="connsiteX11" fmla="*/ 190500 w 407917"/>
                  <a:gd name="connsiteY11" fmla="*/ 454025 h 1031875"/>
                  <a:gd name="connsiteX12" fmla="*/ 193675 w 407917"/>
                  <a:gd name="connsiteY12" fmla="*/ 511175 h 1031875"/>
                  <a:gd name="connsiteX13" fmla="*/ 187325 w 407917"/>
                  <a:gd name="connsiteY13" fmla="*/ 536575 h 1031875"/>
                  <a:gd name="connsiteX14" fmla="*/ 187325 w 407917"/>
                  <a:gd name="connsiteY14" fmla="*/ 584200 h 1031875"/>
                  <a:gd name="connsiteX15" fmla="*/ 196850 w 407917"/>
                  <a:gd name="connsiteY15" fmla="*/ 615950 h 1031875"/>
                  <a:gd name="connsiteX16" fmla="*/ 184150 w 407917"/>
                  <a:gd name="connsiteY16" fmla="*/ 647700 h 1031875"/>
                  <a:gd name="connsiteX17" fmla="*/ 193675 w 407917"/>
                  <a:gd name="connsiteY17" fmla="*/ 695325 h 1031875"/>
                  <a:gd name="connsiteX18" fmla="*/ 193675 w 407917"/>
                  <a:gd name="connsiteY18" fmla="*/ 730250 h 1031875"/>
                  <a:gd name="connsiteX19" fmla="*/ 180975 w 407917"/>
                  <a:gd name="connsiteY19" fmla="*/ 755650 h 1031875"/>
                  <a:gd name="connsiteX20" fmla="*/ 180975 w 407917"/>
                  <a:gd name="connsiteY20" fmla="*/ 800100 h 1031875"/>
                  <a:gd name="connsiteX21" fmla="*/ 155575 w 407917"/>
                  <a:gd name="connsiteY21" fmla="*/ 831850 h 1031875"/>
                  <a:gd name="connsiteX22" fmla="*/ 0 w 407917"/>
                  <a:gd name="connsiteY22" fmla="*/ 917575 h 1031875"/>
                  <a:gd name="connsiteX23" fmla="*/ 44450 w 407917"/>
                  <a:gd name="connsiteY23" fmla="*/ 933450 h 1031875"/>
                  <a:gd name="connsiteX24" fmla="*/ 79375 w 407917"/>
                  <a:gd name="connsiteY24" fmla="*/ 923925 h 1031875"/>
                  <a:gd name="connsiteX25" fmla="*/ 130175 w 407917"/>
                  <a:gd name="connsiteY25" fmla="*/ 917575 h 1031875"/>
                  <a:gd name="connsiteX26" fmla="*/ 139700 w 407917"/>
                  <a:gd name="connsiteY26" fmla="*/ 939800 h 1031875"/>
                  <a:gd name="connsiteX27" fmla="*/ 133350 w 407917"/>
                  <a:gd name="connsiteY27" fmla="*/ 974725 h 1031875"/>
                  <a:gd name="connsiteX28" fmla="*/ 123825 w 407917"/>
                  <a:gd name="connsiteY28" fmla="*/ 1006475 h 1031875"/>
                  <a:gd name="connsiteX29" fmla="*/ 136525 w 407917"/>
                  <a:gd name="connsiteY29" fmla="*/ 1025525 h 1031875"/>
                  <a:gd name="connsiteX30" fmla="*/ 152400 w 407917"/>
                  <a:gd name="connsiteY30" fmla="*/ 1031875 h 1031875"/>
                  <a:gd name="connsiteX31" fmla="*/ 152400 w 407917"/>
                  <a:gd name="connsiteY31" fmla="*/ 1031875 h 1031875"/>
                  <a:gd name="connsiteX32" fmla="*/ 155575 w 407917"/>
                  <a:gd name="connsiteY32" fmla="*/ 1000125 h 1031875"/>
                  <a:gd name="connsiteX33" fmla="*/ 184150 w 407917"/>
                  <a:gd name="connsiteY33" fmla="*/ 984250 h 1031875"/>
                  <a:gd name="connsiteX34" fmla="*/ 212725 w 407917"/>
                  <a:gd name="connsiteY34" fmla="*/ 965200 h 1031875"/>
                  <a:gd name="connsiteX35" fmla="*/ 222250 w 407917"/>
                  <a:gd name="connsiteY35" fmla="*/ 927100 h 1031875"/>
                  <a:gd name="connsiteX36" fmla="*/ 254000 w 407917"/>
                  <a:gd name="connsiteY36" fmla="*/ 936625 h 1031875"/>
                  <a:gd name="connsiteX37" fmla="*/ 292100 w 407917"/>
                  <a:gd name="connsiteY37" fmla="*/ 968375 h 1031875"/>
                  <a:gd name="connsiteX38" fmla="*/ 327025 w 407917"/>
                  <a:gd name="connsiteY38" fmla="*/ 993775 h 1031875"/>
                  <a:gd name="connsiteX39" fmla="*/ 355600 w 407917"/>
                  <a:gd name="connsiteY39" fmla="*/ 1012825 h 1031875"/>
                  <a:gd name="connsiteX40" fmla="*/ 342900 w 407917"/>
                  <a:gd name="connsiteY40" fmla="*/ 974725 h 1031875"/>
                  <a:gd name="connsiteX41" fmla="*/ 330200 w 407917"/>
                  <a:gd name="connsiteY41" fmla="*/ 939800 h 1031875"/>
                  <a:gd name="connsiteX42" fmla="*/ 330200 w 407917"/>
                  <a:gd name="connsiteY42" fmla="*/ 939800 h 1031875"/>
                  <a:gd name="connsiteX43" fmla="*/ 407650 w 407917"/>
                  <a:gd name="connsiteY43" fmla="*/ 883446 h 1031875"/>
                  <a:gd name="connsiteX44" fmla="*/ 276225 w 407917"/>
                  <a:gd name="connsiteY44" fmla="*/ 835025 h 1031875"/>
                  <a:gd name="connsiteX45" fmla="*/ 233025 w 407917"/>
                  <a:gd name="connsiteY45" fmla="*/ 740571 h 1031875"/>
                  <a:gd name="connsiteX46" fmla="*/ 236200 w 407917"/>
                  <a:gd name="connsiteY46" fmla="*/ 562771 h 1031875"/>
                  <a:gd name="connsiteX47" fmla="*/ 203200 w 407917"/>
                  <a:gd name="connsiteY47" fmla="*/ 190501 h 1031875"/>
                  <a:gd name="connsiteX48" fmla="*/ 337800 w 407917"/>
                  <a:gd name="connsiteY48" fmla="*/ 54771 h 1031875"/>
                  <a:gd name="connsiteX49" fmla="*/ 280650 w 407917"/>
                  <a:gd name="connsiteY49" fmla="*/ 45246 h 1031875"/>
                  <a:gd name="connsiteX50" fmla="*/ 184151 w 407917"/>
                  <a:gd name="connsiteY50" fmla="*/ 73026 h 1031875"/>
                  <a:gd name="connsiteX51" fmla="*/ 82550 w 407917"/>
                  <a:gd name="connsiteY51" fmla="*/ 0 h 1031875"/>
                  <a:gd name="connsiteX0" fmla="*/ 76200 w 407917"/>
                  <a:gd name="connsiteY0" fmla="*/ 3175 h 1031875"/>
                  <a:gd name="connsiteX1" fmla="*/ 69850 w 407917"/>
                  <a:gd name="connsiteY1" fmla="*/ 44450 h 1031875"/>
                  <a:gd name="connsiteX2" fmla="*/ 85725 w 407917"/>
                  <a:gd name="connsiteY2" fmla="*/ 69850 h 1031875"/>
                  <a:gd name="connsiteX3" fmla="*/ 114300 w 407917"/>
                  <a:gd name="connsiteY3" fmla="*/ 98425 h 1031875"/>
                  <a:gd name="connsiteX4" fmla="*/ 149225 w 407917"/>
                  <a:gd name="connsiteY4" fmla="*/ 130175 h 1031875"/>
                  <a:gd name="connsiteX5" fmla="*/ 168275 w 407917"/>
                  <a:gd name="connsiteY5" fmla="*/ 161925 h 1031875"/>
                  <a:gd name="connsiteX6" fmla="*/ 174625 w 407917"/>
                  <a:gd name="connsiteY6" fmla="*/ 219075 h 1031875"/>
                  <a:gd name="connsiteX7" fmla="*/ 168275 w 407917"/>
                  <a:gd name="connsiteY7" fmla="*/ 269875 h 1031875"/>
                  <a:gd name="connsiteX8" fmla="*/ 168275 w 407917"/>
                  <a:gd name="connsiteY8" fmla="*/ 323850 h 1031875"/>
                  <a:gd name="connsiteX9" fmla="*/ 184150 w 407917"/>
                  <a:gd name="connsiteY9" fmla="*/ 403225 h 1031875"/>
                  <a:gd name="connsiteX10" fmla="*/ 190500 w 407917"/>
                  <a:gd name="connsiteY10" fmla="*/ 454025 h 1031875"/>
                  <a:gd name="connsiteX11" fmla="*/ 190500 w 407917"/>
                  <a:gd name="connsiteY11" fmla="*/ 454025 h 1031875"/>
                  <a:gd name="connsiteX12" fmla="*/ 193675 w 407917"/>
                  <a:gd name="connsiteY12" fmla="*/ 511175 h 1031875"/>
                  <a:gd name="connsiteX13" fmla="*/ 187325 w 407917"/>
                  <a:gd name="connsiteY13" fmla="*/ 536575 h 1031875"/>
                  <a:gd name="connsiteX14" fmla="*/ 187325 w 407917"/>
                  <a:gd name="connsiteY14" fmla="*/ 584200 h 1031875"/>
                  <a:gd name="connsiteX15" fmla="*/ 196850 w 407917"/>
                  <a:gd name="connsiteY15" fmla="*/ 615950 h 1031875"/>
                  <a:gd name="connsiteX16" fmla="*/ 184150 w 407917"/>
                  <a:gd name="connsiteY16" fmla="*/ 647700 h 1031875"/>
                  <a:gd name="connsiteX17" fmla="*/ 193675 w 407917"/>
                  <a:gd name="connsiteY17" fmla="*/ 695325 h 1031875"/>
                  <a:gd name="connsiteX18" fmla="*/ 193675 w 407917"/>
                  <a:gd name="connsiteY18" fmla="*/ 730250 h 1031875"/>
                  <a:gd name="connsiteX19" fmla="*/ 180975 w 407917"/>
                  <a:gd name="connsiteY19" fmla="*/ 755650 h 1031875"/>
                  <a:gd name="connsiteX20" fmla="*/ 180975 w 407917"/>
                  <a:gd name="connsiteY20" fmla="*/ 800100 h 1031875"/>
                  <a:gd name="connsiteX21" fmla="*/ 155575 w 407917"/>
                  <a:gd name="connsiteY21" fmla="*/ 831850 h 1031875"/>
                  <a:gd name="connsiteX22" fmla="*/ 0 w 407917"/>
                  <a:gd name="connsiteY22" fmla="*/ 917575 h 1031875"/>
                  <a:gd name="connsiteX23" fmla="*/ 44450 w 407917"/>
                  <a:gd name="connsiteY23" fmla="*/ 933450 h 1031875"/>
                  <a:gd name="connsiteX24" fmla="*/ 79375 w 407917"/>
                  <a:gd name="connsiteY24" fmla="*/ 923925 h 1031875"/>
                  <a:gd name="connsiteX25" fmla="*/ 130175 w 407917"/>
                  <a:gd name="connsiteY25" fmla="*/ 917575 h 1031875"/>
                  <a:gd name="connsiteX26" fmla="*/ 139700 w 407917"/>
                  <a:gd name="connsiteY26" fmla="*/ 939800 h 1031875"/>
                  <a:gd name="connsiteX27" fmla="*/ 133350 w 407917"/>
                  <a:gd name="connsiteY27" fmla="*/ 974725 h 1031875"/>
                  <a:gd name="connsiteX28" fmla="*/ 123825 w 407917"/>
                  <a:gd name="connsiteY28" fmla="*/ 1006475 h 1031875"/>
                  <a:gd name="connsiteX29" fmla="*/ 136525 w 407917"/>
                  <a:gd name="connsiteY29" fmla="*/ 1025525 h 1031875"/>
                  <a:gd name="connsiteX30" fmla="*/ 152400 w 407917"/>
                  <a:gd name="connsiteY30" fmla="*/ 1031875 h 1031875"/>
                  <a:gd name="connsiteX31" fmla="*/ 152400 w 407917"/>
                  <a:gd name="connsiteY31" fmla="*/ 1031875 h 1031875"/>
                  <a:gd name="connsiteX32" fmla="*/ 155575 w 407917"/>
                  <a:gd name="connsiteY32" fmla="*/ 1000125 h 1031875"/>
                  <a:gd name="connsiteX33" fmla="*/ 184150 w 407917"/>
                  <a:gd name="connsiteY33" fmla="*/ 984250 h 1031875"/>
                  <a:gd name="connsiteX34" fmla="*/ 212725 w 407917"/>
                  <a:gd name="connsiteY34" fmla="*/ 965200 h 1031875"/>
                  <a:gd name="connsiteX35" fmla="*/ 222250 w 407917"/>
                  <a:gd name="connsiteY35" fmla="*/ 927100 h 1031875"/>
                  <a:gd name="connsiteX36" fmla="*/ 254000 w 407917"/>
                  <a:gd name="connsiteY36" fmla="*/ 936625 h 1031875"/>
                  <a:gd name="connsiteX37" fmla="*/ 292100 w 407917"/>
                  <a:gd name="connsiteY37" fmla="*/ 968375 h 1031875"/>
                  <a:gd name="connsiteX38" fmla="*/ 327025 w 407917"/>
                  <a:gd name="connsiteY38" fmla="*/ 993775 h 1031875"/>
                  <a:gd name="connsiteX39" fmla="*/ 355600 w 407917"/>
                  <a:gd name="connsiteY39" fmla="*/ 1012825 h 1031875"/>
                  <a:gd name="connsiteX40" fmla="*/ 342900 w 407917"/>
                  <a:gd name="connsiteY40" fmla="*/ 974725 h 1031875"/>
                  <a:gd name="connsiteX41" fmla="*/ 330200 w 407917"/>
                  <a:gd name="connsiteY41" fmla="*/ 939800 h 1031875"/>
                  <a:gd name="connsiteX42" fmla="*/ 330200 w 407917"/>
                  <a:gd name="connsiteY42" fmla="*/ 939800 h 1031875"/>
                  <a:gd name="connsiteX43" fmla="*/ 407650 w 407917"/>
                  <a:gd name="connsiteY43" fmla="*/ 883446 h 1031875"/>
                  <a:gd name="connsiteX44" fmla="*/ 276225 w 407917"/>
                  <a:gd name="connsiteY44" fmla="*/ 835025 h 1031875"/>
                  <a:gd name="connsiteX45" fmla="*/ 233025 w 407917"/>
                  <a:gd name="connsiteY45" fmla="*/ 740571 h 1031875"/>
                  <a:gd name="connsiteX46" fmla="*/ 236200 w 407917"/>
                  <a:gd name="connsiteY46" fmla="*/ 562771 h 1031875"/>
                  <a:gd name="connsiteX47" fmla="*/ 203200 w 407917"/>
                  <a:gd name="connsiteY47" fmla="*/ 190501 h 1031875"/>
                  <a:gd name="connsiteX48" fmla="*/ 337800 w 407917"/>
                  <a:gd name="connsiteY48" fmla="*/ 54771 h 1031875"/>
                  <a:gd name="connsiteX49" fmla="*/ 280650 w 407917"/>
                  <a:gd name="connsiteY49" fmla="*/ 45246 h 1031875"/>
                  <a:gd name="connsiteX50" fmla="*/ 184151 w 407917"/>
                  <a:gd name="connsiteY50" fmla="*/ 73026 h 1031875"/>
                  <a:gd name="connsiteX51" fmla="*/ 66675 w 407917"/>
                  <a:gd name="connsiteY51" fmla="*/ 0 h 1031875"/>
                  <a:gd name="connsiteX0" fmla="*/ 76200 w 407917"/>
                  <a:gd name="connsiteY0" fmla="*/ 3175 h 1031875"/>
                  <a:gd name="connsiteX1" fmla="*/ 69850 w 407917"/>
                  <a:gd name="connsiteY1" fmla="*/ 44450 h 1031875"/>
                  <a:gd name="connsiteX2" fmla="*/ 85725 w 407917"/>
                  <a:gd name="connsiteY2" fmla="*/ 69850 h 1031875"/>
                  <a:gd name="connsiteX3" fmla="*/ 114300 w 407917"/>
                  <a:gd name="connsiteY3" fmla="*/ 98425 h 1031875"/>
                  <a:gd name="connsiteX4" fmla="*/ 149225 w 407917"/>
                  <a:gd name="connsiteY4" fmla="*/ 130175 h 1031875"/>
                  <a:gd name="connsiteX5" fmla="*/ 168275 w 407917"/>
                  <a:gd name="connsiteY5" fmla="*/ 161925 h 1031875"/>
                  <a:gd name="connsiteX6" fmla="*/ 174625 w 407917"/>
                  <a:gd name="connsiteY6" fmla="*/ 219075 h 1031875"/>
                  <a:gd name="connsiteX7" fmla="*/ 168275 w 407917"/>
                  <a:gd name="connsiteY7" fmla="*/ 269875 h 1031875"/>
                  <a:gd name="connsiteX8" fmla="*/ 168275 w 407917"/>
                  <a:gd name="connsiteY8" fmla="*/ 323850 h 1031875"/>
                  <a:gd name="connsiteX9" fmla="*/ 184150 w 407917"/>
                  <a:gd name="connsiteY9" fmla="*/ 403225 h 1031875"/>
                  <a:gd name="connsiteX10" fmla="*/ 190500 w 407917"/>
                  <a:gd name="connsiteY10" fmla="*/ 454025 h 1031875"/>
                  <a:gd name="connsiteX11" fmla="*/ 190500 w 407917"/>
                  <a:gd name="connsiteY11" fmla="*/ 454025 h 1031875"/>
                  <a:gd name="connsiteX12" fmla="*/ 193675 w 407917"/>
                  <a:gd name="connsiteY12" fmla="*/ 511175 h 1031875"/>
                  <a:gd name="connsiteX13" fmla="*/ 187325 w 407917"/>
                  <a:gd name="connsiteY13" fmla="*/ 536575 h 1031875"/>
                  <a:gd name="connsiteX14" fmla="*/ 187325 w 407917"/>
                  <a:gd name="connsiteY14" fmla="*/ 584200 h 1031875"/>
                  <a:gd name="connsiteX15" fmla="*/ 196850 w 407917"/>
                  <a:gd name="connsiteY15" fmla="*/ 615950 h 1031875"/>
                  <a:gd name="connsiteX16" fmla="*/ 184150 w 407917"/>
                  <a:gd name="connsiteY16" fmla="*/ 647700 h 1031875"/>
                  <a:gd name="connsiteX17" fmla="*/ 193675 w 407917"/>
                  <a:gd name="connsiteY17" fmla="*/ 695325 h 1031875"/>
                  <a:gd name="connsiteX18" fmla="*/ 193675 w 407917"/>
                  <a:gd name="connsiteY18" fmla="*/ 730250 h 1031875"/>
                  <a:gd name="connsiteX19" fmla="*/ 180975 w 407917"/>
                  <a:gd name="connsiteY19" fmla="*/ 755650 h 1031875"/>
                  <a:gd name="connsiteX20" fmla="*/ 180975 w 407917"/>
                  <a:gd name="connsiteY20" fmla="*/ 800100 h 1031875"/>
                  <a:gd name="connsiteX21" fmla="*/ 155575 w 407917"/>
                  <a:gd name="connsiteY21" fmla="*/ 831850 h 1031875"/>
                  <a:gd name="connsiteX22" fmla="*/ 0 w 407917"/>
                  <a:gd name="connsiteY22" fmla="*/ 917575 h 1031875"/>
                  <a:gd name="connsiteX23" fmla="*/ 44450 w 407917"/>
                  <a:gd name="connsiteY23" fmla="*/ 933450 h 1031875"/>
                  <a:gd name="connsiteX24" fmla="*/ 79375 w 407917"/>
                  <a:gd name="connsiteY24" fmla="*/ 923925 h 1031875"/>
                  <a:gd name="connsiteX25" fmla="*/ 130175 w 407917"/>
                  <a:gd name="connsiteY25" fmla="*/ 917575 h 1031875"/>
                  <a:gd name="connsiteX26" fmla="*/ 139700 w 407917"/>
                  <a:gd name="connsiteY26" fmla="*/ 939800 h 1031875"/>
                  <a:gd name="connsiteX27" fmla="*/ 133350 w 407917"/>
                  <a:gd name="connsiteY27" fmla="*/ 974725 h 1031875"/>
                  <a:gd name="connsiteX28" fmla="*/ 123825 w 407917"/>
                  <a:gd name="connsiteY28" fmla="*/ 1006475 h 1031875"/>
                  <a:gd name="connsiteX29" fmla="*/ 136525 w 407917"/>
                  <a:gd name="connsiteY29" fmla="*/ 1025525 h 1031875"/>
                  <a:gd name="connsiteX30" fmla="*/ 152400 w 407917"/>
                  <a:gd name="connsiteY30" fmla="*/ 1031875 h 1031875"/>
                  <a:gd name="connsiteX31" fmla="*/ 152400 w 407917"/>
                  <a:gd name="connsiteY31" fmla="*/ 1031875 h 1031875"/>
                  <a:gd name="connsiteX32" fmla="*/ 155575 w 407917"/>
                  <a:gd name="connsiteY32" fmla="*/ 1000125 h 1031875"/>
                  <a:gd name="connsiteX33" fmla="*/ 184150 w 407917"/>
                  <a:gd name="connsiteY33" fmla="*/ 984250 h 1031875"/>
                  <a:gd name="connsiteX34" fmla="*/ 212725 w 407917"/>
                  <a:gd name="connsiteY34" fmla="*/ 965200 h 1031875"/>
                  <a:gd name="connsiteX35" fmla="*/ 222250 w 407917"/>
                  <a:gd name="connsiteY35" fmla="*/ 927100 h 1031875"/>
                  <a:gd name="connsiteX36" fmla="*/ 254000 w 407917"/>
                  <a:gd name="connsiteY36" fmla="*/ 936625 h 1031875"/>
                  <a:gd name="connsiteX37" fmla="*/ 292100 w 407917"/>
                  <a:gd name="connsiteY37" fmla="*/ 968375 h 1031875"/>
                  <a:gd name="connsiteX38" fmla="*/ 327025 w 407917"/>
                  <a:gd name="connsiteY38" fmla="*/ 993775 h 1031875"/>
                  <a:gd name="connsiteX39" fmla="*/ 355600 w 407917"/>
                  <a:gd name="connsiteY39" fmla="*/ 1012825 h 1031875"/>
                  <a:gd name="connsiteX40" fmla="*/ 342900 w 407917"/>
                  <a:gd name="connsiteY40" fmla="*/ 974725 h 1031875"/>
                  <a:gd name="connsiteX41" fmla="*/ 330200 w 407917"/>
                  <a:gd name="connsiteY41" fmla="*/ 939800 h 1031875"/>
                  <a:gd name="connsiteX42" fmla="*/ 330200 w 407917"/>
                  <a:gd name="connsiteY42" fmla="*/ 939800 h 1031875"/>
                  <a:gd name="connsiteX43" fmla="*/ 328275 w 407917"/>
                  <a:gd name="connsiteY43" fmla="*/ 921546 h 1031875"/>
                  <a:gd name="connsiteX44" fmla="*/ 407650 w 407917"/>
                  <a:gd name="connsiteY44" fmla="*/ 883446 h 1031875"/>
                  <a:gd name="connsiteX45" fmla="*/ 276225 w 407917"/>
                  <a:gd name="connsiteY45" fmla="*/ 835025 h 1031875"/>
                  <a:gd name="connsiteX46" fmla="*/ 233025 w 407917"/>
                  <a:gd name="connsiteY46" fmla="*/ 740571 h 1031875"/>
                  <a:gd name="connsiteX47" fmla="*/ 236200 w 407917"/>
                  <a:gd name="connsiteY47" fmla="*/ 562771 h 1031875"/>
                  <a:gd name="connsiteX48" fmla="*/ 203200 w 407917"/>
                  <a:gd name="connsiteY48" fmla="*/ 190501 h 1031875"/>
                  <a:gd name="connsiteX49" fmla="*/ 337800 w 407917"/>
                  <a:gd name="connsiteY49" fmla="*/ 54771 h 1031875"/>
                  <a:gd name="connsiteX50" fmla="*/ 280650 w 407917"/>
                  <a:gd name="connsiteY50" fmla="*/ 45246 h 1031875"/>
                  <a:gd name="connsiteX51" fmla="*/ 184151 w 407917"/>
                  <a:gd name="connsiteY51" fmla="*/ 73026 h 1031875"/>
                  <a:gd name="connsiteX52" fmla="*/ 66675 w 407917"/>
                  <a:gd name="connsiteY52" fmla="*/ 0 h 1031875"/>
                  <a:gd name="connsiteX0" fmla="*/ 76200 w 407917"/>
                  <a:gd name="connsiteY0" fmla="*/ 3175 h 1031875"/>
                  <a:gd name="connsiteX1" fmla="*/ 69850 w 407917"/>
                  <a:gd name="connsiteY1" fmla="*/ 44450 h 1031875"/>
                  <a:gd name="connsiteX2" fmla="*/ 85725 w 407917"/>
                  <a:gd name="connsiteY2" fmla="*/ 69850 h 1031875"/>
                  <a:gd name="connsiteX3" fmla="*/ 114300 w 407917"/>
                  <a:gd name="connsiteY3" fmla="*/ 98425 h 1031875"/>
                  <a:gd name="connsiteX4" fmla="*/ 149225 w 407917"/>
                  <a:gd name="connsiteY4" fmla="*/ 130175 h 1031875"/>
                  <a:gd name="connsiteX5" fmla="*/ 168275 w 407917"/>
                  <a:gd name="connsiteY5" fmla="*/ 161925 h 1031875"/>
                  <a:gd name="connsiteX6" fmla="*/ 174625 w 407917"/>
                  <a:gd name="connsiteY6" fmla="*/ 219075 h 1031875"/>
                  <a:gd name="connsiteX7" fmla="*/ 168275 w 407917"/>
                  <a:gd name="connsiteY7" fmla="*/ 269875 h 1031875"/>
                  <a:gd name="connsiteX8" fmla="*/ 168275 w 407917"/>
                  <a:gd name="connsiteY8" fmla="*/ 323850 h 1031875"/>
                  <a:gd name="connsiteX9" fmla="*/ 184150 w 407917"/>
                  <a:gd name="connsiteY9" fmla="*/ 403225 h 1031875"/>
                  <a:gd name="connsiteX10" fmla="*/ 190500 w 407917"/>
                  <a:gd name="connsiteY10" fmla="*/ 454025 h 1031875"/>
                  <a:gd name="connsiteX11" fmla="*/ 190500 w 407917"/>
                  <a:gd name="connsiteY11" fmla="*/ 454025 h 1031875"/>
                  <a:gd name="connsiteX12" fmla="*/ 193675 w 407917"/>
                  <a:gd name="connsiteY12" fmla="*/ 511175 h 1031875"/>
                  <a:gd name="connsiteX13" fmla="*/ 187325 w 407917"/>
                  <a:gd name="connsiteY13" fmla="*/ 536575 h 1031875"/>
                  <a:gd name="connsiteX14" fmla="*/ 187325 w 407917"/>
                  <a:gd name="connsiteY14" fmla="*/ 584200 h 1031875"/>
                  <a:gd name="connsiteX15" fmla="*/ 196850 w 407917"/>
                  <a:gd name="connsiteY15" fmla="*/ 615950 h 1031875"/>
                  <a:gd name="connsiteX16" fmla="*/ 184150 w 407917"/>
                  <a:gd name="connsiteY16" fmla="*/ 647700 h 1031875"/>
                  <a:gd name="connsiteX17" fmla="*/ 193675 w 407917"/>
                  <a:gd name="connsiteY17" fmla="*/ 695325 h 1031875"/>
                  <a:gd name="connsiteX18" fmla="*/ 193675 w 407917"/>
                  <a:gd name="connsiteY18" fmla="*/ 730250 h 1031875"/>
                  <a:gd name="connsiteX19" fmla="*/ 180975 w 407917"/>
                  <a:gd name="connsiteY19" fmla="*/ 755650 h 1031875"/>
                  <a:gd name="connsiteX20" fmla="*/ 180975 w 407917"/>
                  <a:gd name="connsiteY20" fmla="*/ 800100 h 1031875"/>
                  <a:gd name="connsiteX21" fmla="*/ 155575 w 407917"/>
                  <a:gd name="connsiteY21" fmla="*/ 831850 h 1031875"/>
                  <a:gd name="connsiteX22" fmla="*/ 0 w 407917"/>
                  <a:gd name="connsiteY22" fmla="*/ 917575 h 1031875"/>
                  <a:gd name="connsiteX23" fmla="*/ 44450 w 407917"/>
                  <a:gd name="connsiteY23" fmla="*/ 933450 h 1031875"/>
                  <a:gd name="connsiteX24" fmla="*/ 79375 w 407917"/>
                  <a:gd name="connsiteY24" fmla="*/ 923925 h 1031875"/>
                  <a:gd name="connsiteX25" fmla="*/ 130175 w 407917"/>
                  <a:gd name="connsiteY25" fmla="*/ 917575 h 1031875"/>
                  <a:gd name="connsiteX26" fmla="*/ 139700 w 407917"/>
                  <a:gd name="connsiteY26" fmla="*/ 939800 h 1031875"/>
                  <a:gd name="connsiteX27" fmla="*/ 133350 w 407917"/>
                  <a:gd name="connsiteY27" fmla="*/ 974725 h 1031875"/>
                  <a:gd name="connsiteX28" fmla="*/ 123825 w 407917"/>
                  <a:gd name="connsiteY28" fmla="*/ 1006475 h 1031875"/>
                  <a:gd name="connsiteX29" fmla="*/ 136525 w 407917"/>
                  <a:gd name="connsiteY29" fmla="*/ 1025525 h 1031875"/>
                  <a:gd name="connsiteX30" fmla="*/ 152400 w 407917"/>
                  <a:gd name="connsiteY30" fmla="*/ 1031875 h 1031875"/>
                  <a:gd name="connsiteX31" fmla="*/ 152400 w 407917"/>
                  <a:gd name="connsiteY31" fmla="*/ 1031875 h 1031875"/>
                  <a:gd name="connsiteX32" fmla="*/ 155575 w 407917"/>
                  <a:gd name="connsiteY32" fmla="*/ 1000125 h 1031875"/>
                  <a:gd name="connsiteX33" fmla="*/ 184150 w 407917"/>
                  <a:gd name="connsiteY33" fmla="*/ 984250 h 1031875"/>
                  <a:gd name="connsiteX34" fmla="*/ 212725 w 407917"/>
                  <a:gd name="connsiteY34" fmla="*/ 965200 h 1031875"/>
                  <a:gd name="connsiteX35" fmla="*/ 222250 w 407917"/>
                  <a:gd name="connsiteY35" fmla="*/ 927100 h 1031875"/>
                  <a:gd name="connsiteX36" fmla="*/ 254000 w 407917"/>
                  <a:gd name="connsiteY36" fmla="*/ 936625 h 1031875"/>
                  <a:gd name="connsiteX37" fmla="*/ 292100 w 407917"/>
                  <a:gd name="connsiteY37" fmla="*/ 968375 h 1031875"/>
                  <a:gd name="connsiteX38" fmla="*/ 327025 w 407917"/>
                  <a:gd name="connsiteY38" fmla="*/ 993775 h 1031875"/>
                  <a:gd name="connsiteX39" fmla="*/ 355600 w 407917"/>
                  <a:gd name="connsiteY39" fmla="*/ 1012825 h 1031875"/>
                  <a:gd name="connsiteX40" fmla="*/ 365125 w 407917"/>
                  <a:gd name="connsiteY40" fmla="*/ 993775 h 1031875"/>
                  <a:gd name="connsiteX41" fmla="*/ 330200 w 407917"/>
                  <a:gd name="connsiteY41" fmla="*/ 939800 h 1031875"/>
                  <a:gd name="connsiteX42" fmla="*/ 330200 w 407917"/>
                  <a:gd name="connsiteY42" fmla="*/ 939800 h 1031875"/>
                  <a:gd name="connsiteX43" fmla="*/ 328275 w 407917"/>
                  <a:gd name="connsiteY43" fmla="*/ 921546 h 1031875"/>
                  <a:gd name="connsiteX44" fmla="*/ 407650 w 407917"/>
                  <a:gd name="connsiteY44" fmla="*/ 883446 h 1031875"/>
                  <a:gd name="connsiteX45" fmla="*/ 276225 w 407917"/>
                  <a:gd name="connsiteY45" fmla="*/ 835025 h 1031875"/>
                  <a:gd name="connsiteX46" fmla="*/ 233025 w 407917"/>
                  <a:gd name="connsiteY46" fmla="*/ 740571 h 1031875"/>
                  <a:gd name="connsiteX47" fmla="*/ 236200 w 407917"/>
                  <a:gd name="connsiteY47" fmla="*/ 562771 h 1031875"/>
                  <a:gd name="connsiteX48" fmla="*/ 203200 w 407917"/>
                  <a:gd name="connsiteY48" fmla="*/ 190501 h 1031875"/>
                  <a:gd name="connsiteX49" fmla="*/ 337800 w 407917"/>
                  <a:gd name="connsiteY49" fmla="*/ 54771 h 1031875"/>
                  <a:gd name="connsiteX50" fmla="*/ 280650 w 407917"/>
                  <a:gd name="connsiteY50" fmla="*/ 45246 h 1031875"/>
                  <a:gd name="connsiteX51" fmla="*/ 184151 w 407917"/>
                  <a:gd name="connsiteY51" fmla="*/ 73026 h 1031875"/>
                  <a:gd name="connsiteX52" fmla="*/ 66675 w 407917"/>
                  <a:gd name="connsiteY52" fmla="*/ 0 h 103187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</a:cxnLst>
                <a:rect l="l" t="t" r="r" b="b"/>
                <a:pathLst>
                  <a:path w="407917" h="1031875">
                    <a:moveTo>
                      <a:pt x="76200" y="3175"/>
                    </a:moveTo>
                    <a:lnTo>
                      <a:pt x="69850" y="44450"/>
                    </a:lnTo>
                    <a:lnTo>
                      <a:pt x="85725" y="69850"/>
                    </a:lnTo>
                    <a:lnTo>
                      <a:pt x="114300" y="98425"/>
                    </a:lnTo>
                    <a:lnTo>
                      <a:pt x="149225" y="130175"/>
                    </a:lnTo>
                    <a:lnTo>
                      <a:pt x="168275" y="161925"/>
                    </a:lnTo>
                    <a:lnTo>
                      <a:pt x="174625" y="219075"/>
                    </a:lnTo>
                    <a:lnTo>
                      <a:pt x="168275" y="269875"/>
                    </a:lnTo>
                    <a:lnTo>
                      <a:pt x="168275" y="323850"/>
                    </a:lnTo>
                    <a:lnTo>
                      <a:pt x="184150" y="403225"/>
                    </a:lnTo>
                    <a:lnTo>
                      <a:pt x="190500" y="454025"/>
                    </a:lnTo>
                    <a:lnTo>
                      <a:pt x="190500" y="454025"/>
                    </a:lnTo>
                    <a:lnTo>
                      <a:pt x="193675" y="511175"/>
                    </a:lnTo>
                    <a:lnTo>
                      <a:pt x="187325" y="536575"/>
                    </a:lnTo>
                    <a:lnTo>
                      <a:pt x="187325" y="584200"/>
                    </a:lnTo>
                    <a:lnTo>
                      <a:pt x="196850" y="615950"/>
                    </a:lnTo>
                    <a:lnTo>
                      <a:pt x="184150" y="647700"/>
                    </a:lnTo>
                    <a:lnTo>
                      <a:pt x="193675" y="695325"/>
                    </a:lnTo>
                    <a:lnTo>
                      <a:pt x="193675" y="730250"/>
                    </a:lnTo>
                    <a:lnTo>
                      <a:pt x="180975" y="755650"/>
                    </a:lnTo>
                    <a:lnTo>
                      <a:pt x="180975" y="800100"/>
                    </a:lnTo>
                    <a:lnTo>
                      <a:pt x="155575" y="831850"/>
                    </a:lnTo>
                    <a:lnTo>
                      <a:pt x="0" y="917575"/>
                    </a:lnTo>
                    <a:lnTo>
                      <a:pt x="44450" y="933450"/>
                    </a:lnTo>
                    <a:lnTo>
                      <a:pt x="79375" y="923925"/>
                    </a:lnTo>
                    <a:lnTo>
                      <a:pt x="130175" y="917575"/>
                    </a:lnTo>
                    <a:lnTo>
                      <a:pt x="139700" y="939800"/>
                    </a:lnTo>
                    <a:lnTo>
                      <a:pt x="133350" y="974725"/>
                    </a:lnTo>
                    <a:lnTo>
                      <a:pt x="123825" y="1006475"/>
                    </a:lnTo>
                    <a:lnTo>
                      <a:pt x="136525" y="1025525"/>
                    </a:lnTo>
                    <a:lnTo>
                      <a:pt x="152400" y="1031875"/>
                    </a:lnTo>
                    <a:lnTo>
                      <a:pt x="152400" y="1031875"/>
                    </a:lnTo>
                    <a:lnTo>
                      <a:pt x="155575" y="1000125"/>
                    </a:lnTo>
                    <a:lnTo>
                      <a:pt x="184150" y="984250"/>
                    </a:lnTo>
                    <a:lnTo>
                      <a:pt x="212725" y="965200"/>
                    </a:lnTo>
                    <a:lnTo>
                      <a:pt x="222250" y="927100"/>
                    </a:lnTo>
                    <a:lnTo>
                      <a:pt x="254000" y="936625"/>
                    </a:lnTo>
                    <a:lnTo>
                      <a:pt x="292100" y="968375"/>
                    </a:lnTo>
                    <a:lnTo>
                      <a:pt x="327025" y="993775"/>
                    </a:lnTo>
                    <a:lnTo>
                      <a:pt x="355600" y="1012825"/>
                    </a:lnTo>
                    <a:lnTo>
                      <a:pt x="365125" y="993775"/>
                    </a:lnTo>
                    <a:lnTo>
                      <a:pt x="330200" y="939800"/>
                    </a:lnTo>
                    <a:lnTo>
                      <a:pt x="330200" y="939800"/>
                    </a:lnTo>
                    <a:cubicBezTo>
                      <a:pt x="329879" y="936758"/>
                      <a:pt x="321508" y="926572"/>
                      <a:pt x="328275" y="921546"/>
                    </a:cubicBezTo>
                    <a:lnTo>
                      <a:pt x="407650" y="883446"/>
                    </a:lnTo>
                    <a:cubicBezTo>
                      <a:pt x="414000" y="878684"/>
                      <a:pt x="305329" y="858837"/>
                      <a:pt x="276225" y="835025"/>
                    </a:cubicBezTo>
                    <a:cubicBezTo>
                      <a:pt x="247121" y="811213"/>
                      <a:pt x="242342" y="784359"/>
                      <a:pt x="233025" y="740571"/>
                    </a:cubicBezTo>
                    <a:cubicBezTo>
                      <a:pt x="223708" y="696783"/>
                      <a:pt x="241171" y="654449"/>
                      <a:pt x="236200" y="562771"/>
                    </a:cubicBezTo>
                    <a:cubicBezTo>
                      <a:pt x="231229" y="471093"/>
                      <a:pt x="198967" y="272522"/>
                      <a:pt x="203200" y="190501"/>
                    </a:cubicBezTo>
                    <a:cubicBezTo>
                      <a:pt x="207433" y="108480"/>
                      <a:pt x="324892" y="78980"/>
                      <a:pt x="337800" y="54771"/>
                    </a:cubicBezTo>
                    <a:cubicBezTo>
                      <a:pt x="350708" y="30562"/>
                      <a:pt x="293558" y="44849"/>
                      <a:pt x="280650" y="45246"/>
                    </a:cubicBezTo>
                    <a:cubicBezTo>
                      <a:pt x="267742" y="45643"/>
                      <a:pt x="206584" y="90621"/>
                      <a:pt x="184151" y="73026"/>
                    </a:cubicBezTo>
                    <a:cubicBezTo>
                      <a:pt x="164043" y="41276"/>
                      <a:pt x="84667" y="25929"/>
                      <a:pt x="66675" y="0"/>
                    </a:cubicBezTo>
                  </a:path>
                </a:pathLst>
              </a:custGeom>
              <a:solidFill>
                <a:schemeClr val="tx2"/>
              </a:solidFill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5FB3FB7C-CAAC-8E4D-8F3A-C201FFA5CB3A}"/>
                </a:ext>
              </a:extLst>
            </p:cNvPr>
            <p:cNvSpPr txBox="1"/>
            <p:nvPr/>
          </p:nvSpPr>
          <p:spPr>
            <a:xfrm>
              <a:off x="7398604" y="4955023"/>
              <a:ext cx="162095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Media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08325478-1C7E-FD49-9B0D-50E96ADDB965}"/>
                </a:ext>
              </a:extLst>
            </p:cNvPr>
            <p:cNvSpPr txBox="1"/>
            <p:nvPr/>
          </p:nvSpPr>
          <p:spPr>
            <a:xfrm>
              <a:off x="8056757" y="3112786"/>
              <a:ext cx="2048593" cy="10365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b="1" dirty="0">
                  <a:solidFill>
                    <a:srgbClr val="FF0000"/>
                  </a:solidFill>
                </a:rPr>
                <a:t>GIFU</a:t>
              </a:r>
              <a:r>
                <a:rPr lang="en-US" b="1" dirty="0">
                  <a:solidFill>
                    <a:schemeClr val="accent1">
                      <a:lumMod val="75000"/>
                    </a:schemeClr>
                  </a:solidFill>
                </a:rPr>
                <a:t> </a:t>
              </a:r>
              <a:r>
                <a:rPr lang="en-US" b="1" dirty="0"/>
                <a:t>/ </a:t>
              </a:r>
              <a:r>
                <a:rPr lang="en-US" b="1" dirty="0" err="1">
                  <a:solidFill>
                    <a:schemeClr val="accent6">
                      <a:lumMod val="75000"/>
                    </a:schemeClr>
                  </a:solidFill>
                </a:rPr>
                <a:t>pGIFU</a:t>
              </a:r>
              <a:r>
                <a:rPr lang="en-US" b="1" dirty="0">
                  <a:solidFill>
                    <a:schemeClr val="accent6">
                      <a:lumMod val="75000"/>
                    </a:schemeClr>
                  </a:solidFill>
                </a:rPr>
                <a:t> </a:t>
              </a:r>
              <a:r>
                <a:rPr lang="en-US" b="1" dirty="0"/>
                <a:t>/ </a:t>
              </a:r>
            </a:p>
            <a:p>
              <a:pPr algn="ctr"/>
              <a:r>
                <a:rPr lang="en-US" b="1" dirty="0">
                  <a:solidFill>
                    <a:srgbClr val="FF0000"/>
                  </a:solidFill>
                </a:rPr>
                <a:t>GIFU-S</a:t>
              </a:r>
              <a:r>
                <a:rPr lang="en-US" b="1" dirty="0">
                  <a:solidFill>
                    <a:schemeClr val="accent1">
                      <a:lumMod val="75000"/>
                    </a:schemeClr>
                  </a:solidFill>
                </a:rPr>
                <a:t> </a:t>
              </a:r>
              <a:r>
                <a:rPr lang="en-US" b="1" dirty="0"/>
                <a:t>/ </a:t>
              </a:r>
              <a:r>
                <a:rPr lang="en-US" b="1" dirty="0" err="1">
                  <a:solidFill>
                    <a:schemeClr val="accent6">
                      <a:lumMod val="75000"/>
                    </a:schemeClr>
                  </a:solidFill>
                </a:rPr>
                <a:t>pGIFU</a:t>
              </a:r>
              <a:r>
                <a:rPr lang="en-US" b="1" dirty="0">
                  <a:solidFill>
                    <a:schemeClr val="accent6">
                      <a:lumMod val="75000"/>
                    </a:schemeClr>
                  </a:solidFill>
                </a:rPr>
                <a:t>-S</a:t>
              </a:r>
            </a:p>
            <a:p>
              <a:pPr algn="ctr"/>
              <a:endParaRPr lang="en-US" b="1" dirty="0"/>
            </a:p>
          </p:txBody>
        </p:sp>
      </p:grpSp>
      <p:sp>
        <p:nvSpPr>
          <p:cNvPr id="49" name="Rounded Rectangle 48">
            <a:extLst>
              <a:ext uri="{FF2B5EF4-FFF2-40B4-BE49-F238E27FC236}">
                <a16:creationId xmlns:a16="http://schemas.microsoft.com/office/drawing/2014/main" id="{C4F83B71-A4D3-4141-AE31-C328EFB14562}"/>
              </a:ext>
            </a:extLst>
          </p:cNvPr>
          <p:cNvSpPr/>
          <p:nvPr/>
        </p:nvSpPr>
        <p:spPr>
          <a:xfrm>
            <a:off x="5965566" y="343646"/>
            <a:ext cx="5970046" cy="5440897"/>
          </a:xfrm>
          <a:prstGeom prst="roundRect">
            <a:avLst/>
          </a:prstGeom>
          <a:noFill/>
          <a:ln w="28575"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0FEF1EF1-B578-6C46-9050-6CC8A228D647}"/>
              </a:ext>
            </a:extLst>
          </p:cNvPr>
          <p:cNvSpPr txBox="1"/>
          <p:nvPr/>
        </p:nvSpPr>
        <p:spPr>
          <a:xfrm>
            <a:off x="7334700" y="5808"/>
            <a:ext cx="33645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aco2/HT29-MTX +/- DC Cultures</a:t>
            </a:r>
          </a:p>
        </p:txBody>
      </p: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42E3713A-F1F4-4A4C-9821-F329A2CF64F5}"/>
              </a:ext>
            </a:extLst>
          </p:cNvPr>
          <p:cNvCxnSpPr>
            <a:cxnSpLocks/>
          </p:cNvCxnSpPr>
          <p:nvPr/>
        </p:nvCxnSpPr>
        <p:spPr>
          <a:xfrm>
            <a:off x="8849006" y="2450762"/>
            <a:ext cx="109728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1976BFAF-99BD-9745-B2EC-F34A361C8F26}"/>
              </a:ext>
            </a:extLst>
          </p:cNvPr>
          <p:cNvSpPr txBox="1"/>
          <p:nvPr/>
        </p:nvSpPr>
        <p:spPr>
          <a:xfrm>
            <a:off x="9847188" y="2343536"/>
            <a:ext cx="2171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ucus quantification</a:t>
            </a:r>
          </a:p>
        </p:txBody>
      </p:sp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id="{62B646AF-226D-0B4F-B459-EFCDE5797888}"/>
              </a:ext>
            </a:extLst>
          </p:cNvPr>
          <p:cNvCxnSpPr>
            <a:cxnSpLocks/>
          </p:cNvCxnSpPr>
          <p:nvPr/>
        </p:nvCxnSpPr>
        <p:spPr>
          <a:xfrm>
            <a:off x="8849006" y="2956196"/>
            <a:ext cx="109728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85B7A5CF-C695-0E46-9484-369B3DCD59BE}"/>
              </a:ext>
            </a:extLst>
          </p:cNvPr>
          <p:cNvSpPr txBox="1"/>
          <p:nvPr/>
        </p:nvSpPr>
        <p:spPr>
          <a:xfrm>
            <a:off x="9859714" y="2838033"/>
            <a:ext cx="2010166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NA quantification</a:t>
            </a:r>
          </a:p>
          <a:p>
            <a:r>
              <a:rPr lang="en-US" dirty="0"/>
              <a:t>TEER measurement</a:t>
            </a:r>
          </a:p>
          <a:p>
            <a:r>
              <a:rPr lang="en-US" dirty="0"/>
              <a:t>ZO-1 staining</a:t>
            </a:r>
          </a:p>
        </p:txBody>
      </p: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1A0280A2-B975-7A4F-B9C6-22D8B902A8D4}"/>
              </a:ext>
            </a:extLst>
          </p:cNvPr>
          <p:cNvCxnSpPr>
            <a:cxnSpLocks/>
          </p:cNvCxnSpPr>
          <p:nvPr/>
        </p:nvCxnSpPr>
        <p:spPr>
          <a:xfrm>
            <a:off x="8849006" y="2089393"/>
            <a:ext cx="109728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:a16="http://schemas.microsoft.com/office/drawing/2014/main" id="{0F47F24E-23D8-9F4F-8D23-60D5137D87F0}"/>
              </a:ext>
            </a:extLst>
          </p:cNvPr>
          <p:cNvSpPr txBox="1"/>
          <p:nvPr/>
        </p:nvSpPr>
        <p:spPr>
          <a:xfrm>
            <a:off x="9859714" y="1681595"/>
            <a:ext cx="217104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ecreted cytokine quantification</a:t>
            </a:r>
          </a:p>
        </p:txBody>
      </p:sp>
      <p:grpSp>
        <p:nvGrpSpPr>
          <p:cNvPr id="99" name="Group 98">
            <a:extLst>
              <a:ext uri="{FF2B5EF4-FFF2-40B4-BE49-F238E27FC236}">
                <a16:creationId xmlns:a16="http://schemas.microsoft.com/office/drawing/2014/main" id="{0332D5B7-77ED-EB49-BD25-559EB02A1441}"/>
              </a:ext>
            </a:extLst>
          </p:cNvPr>
          <p:cNvGrpSpPr/>
          <p:nvPr/>
        </p:nvGrpSpPr>
        <p:grpSpPr>
          <a:xfrm>
            <a:off x="200278" y="462477"/>
            <a:ext cx="5660955" cy="4865381"/>
            <a:chOff x="200278" y="462477"/>
            <a:chExt cx="5660955" cy="4865381"/>
          </a:xfrm>
        </p:grpSpPr>
        <p:pic>
          <p:nvPicPr>
            <p:cNvPr id="3" name="Picture 2" descr="Diagram&#10;&#10;Description automatically generated">
              <a:extLst>
                <a:ext uri="{FF2B5EF4-FFF2-40B4-BE49-F238E27FC236}">
                  <a16:creationId xmlns:a16="http://schemas.microsoft.com/office/drawing/2014/main" id="{1FD56DA6-3F75-4500-8BD4-2BD3B6846AD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771"/>
            <a:stretch/>
          </p:blipFill>
          <p:spPr>
            <a:xfrm>
              <a:off x="200278" y="510873"/>
              <a:ext cx="5592857" cy="4098938"/>
            </a:xfrm>
            <a:prstGeom prst="rect">
              <a:avLst/>
            </a:prstGeom>
          </p:spPr>
        </p:pic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B7A2E255-1AA8-CE4B-BD7E-75C45EF63D52}"/>
                </a:ext>
              </a:extLst>
            </p:cNvPr>
            <p:cNvSpPr txBox="1"/>
            <p:nvPr/>
          </p:nvSpPr>
          <p:spPr>
            <a:xfrm>
              <a:off x="2388798" y="3441083"/>
              <a:ext cx="951893" cy="553998"/>
            </a:xfrm>
            <a:prstGeom prst="rect">
              <a:avLst/>
            </a:prstGeom>
            <a:solidFill>
              <a:srgbClr val="DDD9C3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dirty="0"/>
                <a:t>Growth Vessel 1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1790AB0F-40C3-3C4C-A00C-31722D7C811A}"/>
                </a:ext>
              </a:extLst>
            </p:cNvPr>
            <p:cNvSpPr txBox="1"/>
            <p:nvPr/>
          </p:nvSpPr>
          <p:spPr>
            <a:xfrm>
              <a:off x="3619149" y="3441083"/>
              <a:ext cx="951893" cy="553998"/>
            </a:xfrm>
            <a:prstGeom prst="rect">
              <a:avLst/>
            </a:prstGeom>
            <a:solidFill>
              <a:srgbClr val="BCA1A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dirty="0"/>
                <a:t>Growth Vessel 2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990C3741-6012-C24C-9E01-EE8F72E559F3}"/>
                </a:ext>
              </a:extLst>
            </p:cNvPr>
            <p:cNvSpPr txBox="1"/>
            <p:nvPr/>
          </p:nvSpPr>
          <p:spPr>
            <a:xfrm>
              <a:off x="3193834" y="4332812"/>
              <a:ext cx="951893" cy="55399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dirty="0"/>
                <a:t>Custom vessel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40AC1957-AB6D-294F-B1BB-4B2AF50C0031}"/>
                </a:ext>
              </a:extLst>
            </p:cNvPr>
            <p:cNvSpPr txBox="1"/>
            <p:nvPr/>
          </p:nvSpPr>
          <p:spPr>
            <a:xfrm>
              <a:off x="1693380" y="4332812"/>
              <a:ext cx="951893" cy="55399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dirty="0"/>
                <a:t>Standard vessels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C7983A02-4F2F-F54A-ACE8-F58831B0BDB8}"/>
                </a:ext>
              </a:extLst>
            </p:cNvPr>
            <p:cNvSpPr txBox="1"/>
            <p:nvPr/>
          </p:nvSpPr>
          <p:spPr>
            <a:xfrm>
              <a:off x="430888" y="4339187"/>
              <a:ext cx="95189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dirty="0"/>
                <a:t>Stir bar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9F526D29-C1DF-AC4C-A892-9895056E2A52}"/>
                </a:ext>
              </a:extLst>
            </p:cNvPr>
            <p:cNvSpPr txBox="1"/>
            <p:nvPr/>
          </p:nvSpPr>
          <p:spPr>
            <a:xfrm>
              <a:off x="246440" y="1393230"/>
              <a:ext cx="951893" cy="55399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dirty="0"/>
                <a:t>Custom lids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9ACE99F0-A19A-F84E-9485-4C35F7CE5F63}"/>
                </a:ext>
              </a:extLst>
            </p:cNvPr>
            <p:cNvSpPr txBox="1"/>
            <p:nvPr/>
          </p:nvSpPr>
          <p:spPr>
            <a:xfrm>
              <a:off x="1881259" y="462477"/>
              <a:ext cx="50753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dirty="0"/>
                <a:t>Flow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AFAFE599-CB86-5345-BD14-3DA6FCBA5D2B}"/>
                </a:ext>
              </a:extLst>
            </p:cNvPr>
            <p:cNvSpPr txBox="1"/>
            <p:nvPr/>
          </p:nvSpPr>
          <p:spPr>
            <a:xfrm>
              <a:off x="3113393" y="466910"/>
              <a:ext cx="50753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dirty="0"/>
                <a:t>Flow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1D21D665-410B-1742-A464-D5C71CF0C46F}"/>
                </a:ext>
              </a:extLst>
            </p:cNvPr>
            <p:cNvSpPr txBox="1"/>
            <p:nvPr/>
          </p:nvSpPr>
          <p:spPr>
            <a:xfrm>
              <a:off x="1831961" y="1488045"/>
              <a:ext cx="606133" cy="276999"/>
            </a:xfrm>
            <a:prstGeom prst="rect">
              <a:avLst/>
            </a:prstGeom>
            <a:solidFill>
              <a:srgbClr val="BFBFBF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dirty="0"/>
                <a:t>Pump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B371A7B5-871B-214D-B1D2-368CE6FE8E3C}"/>
                </a:ext>
              </a:extLst>
            </p:cNvPr>
            <p:cNvSpPr txBox="1"/>
            <p:nvPr/>
          </p:nvSpPr>
          <p:spPr>
            <a:xfrm>
              <a:off x="4401171" y="1390761"/>
              <a:ext cx="904183" cy="55399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dirty="0"/>
                <a:t>Sampling port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0C887D04-94A4-CB42-9A40-47E688BC309E}"/>
                </a:ext>
              </a:extLst>
            </p:cNvPr>
            <p:cNvSpPr txBox="1"/>
            <p:nvPr/>
          </p:nvSpPr>
          <p:spPr>
            <a:xfrm>
              <a:off x="3113393" y="1529260"/>
              <a:ext cx="606133" cy="276999"/>
            </a:xfrm>
            <a:prstGeom prst="rect">
              <a:avLst/>
            </a:prstGeom>
            <a:solidFill>
              <a:srgbClr val="BFBFBF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dirty="0"/>
                <a:t>Pump</a:t>
              </a:r>
            </a:p>
          </p:txBody>
        </p:sp>
        <p:cxnSp>
          <p:nvCxnSpPr>
            <p:cNvPr id="7" name="Straight Arrow Connector 6">
              <a:extLst>
                <a:ext uri="{FF2B5EF4-FFF2-40B4-BE49-F238E27FC236}">
                  <a16:creationId xmlns:a16="http://schemas.microsoft.com/office/drawing/2014/main" id="{436F6ADB-20FF-9441-9B7B-1065D8D2F423}"/>
                </a:ext>
              </a:extLst>
            </p:cNvPr>
            <p:cNvCxnSpPr>
              <a:cxnSpLocks/>
            </p:cNvCxnSpPr>
            <p:nvPr/>
          </p:nvCxnSpPr>
          <p:spPr>
            <a:xfrm>
              <a:off x="672281" y="1944759"/>
              <a:ext cx="319004" cy="53287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3" name="Straight Arrow Connector 72">
              <a:extLst>
                <a:ext uri="{FF2B5EF4-FFF2-40B4-BE49-F238E27FC236}">
                  <a16:creationId xmlns:a16="http://schemas.microsoft.com/office/drawing/2014/main" id="{BFADA87C-92E6-4047-8F55-04EBDE47849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463832" y="1944759"/>
              <a:ext cx="214506" cy="46650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6" name="Straight Arrow Connector 75">
              <a:extLst>
                <a:ext uri="{FF2B5EF4-FFF2-40B4-BE49-F238E27FC236}">
                  <a16:creationId xmlns:a16="http://schemas.microsoft.com/office/drawing/2014/main" id="{BFD84E85-9439-9941-9E9D-7565A4D4996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25006" y="4054950"/>
              <a:ext cx="449272" cy="271376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8" name="Straight Arrow Connector 77">
              <a:extLst>
                <a:ext uri="{FF2B5EF4-FFF2-40B4-BE49-F238E27FC236}">
                  <a16:creationId xmlns:a16="http://schemas.microsoft.com/office/drawing/2014/main" id="{DD98C2FA-C416-0548-A68C-ABAA28C5F6D6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068941" y="4099409"/>
              <a:ext cx="127072" cy="207992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0" name="Straight Arrow Connector 79">
              <a:extLst>
                <a:ext uri="{FF2B5EF4-FFF2-40B4-BE49-F238E27FC236}">
                  <a16:creationId xmlns:a16="http://schemas.microsoft.com/office/drawing/2014/main" id="{D764D0F0-2EDA-764C-A960-20EA02B4FE5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188439" y="4099409"/>
              <a:ext cx="129981" cy="205192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4" name="Straight Arrow Connector 83">
              <a:extLst>
                <a:ext uri="{FF2B5EF4-FFF2-40B4-BE49-F238E27FC236}">
                  <a16:creationId xmlns:a16="http://schemas.microsoft.com/office/drawing/2014/main" id="{24DC929C-0928-AA4C-BE40-87297214DDB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620932" y="4135808"/>
              <a:ext cx="98594" cy="197004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6" name="Rectangle 85">
              <a:extLst>
                <a:ext uri="{FF2B5EF4-FFF2-40B4-BE49-F238E27FC236}">
                  <a16:creationId xmlns:a16="http://schemas.microsoft.com/office/drawing/2014/main" id="{A8505DCD-195C-0E4C-8421-F0D9CBF880E9}"/>
                </a:ext>
              </a:extLst>
            </p:cNvPr>
            <p:cNvSpPr/>
            <p:nvPr/>
          </p:nvSpPr>
          <p:spPr>
            <a:xfrm>
              <a:off x="4540773" y="4099410"/>
              <a:ext cx="549043" cy="36914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7" name="Rectangle 86">
              <a:extLst>
                <a:ext uri="{FF2B5EF4-FFF2-40B4-BE49-F238E27FC236}">
                  <a16:creationId xmlns:a16="http://schemas.microsoft.com/office/drawing/2014/main" id="{2E8C56F4-C7C6-FF41-8894-C78359CB8075}"/>
                </a:ext>
              </a:extLst>
            </p:cNvPr>
            <p:cNvSpPr/>
            <p:nvPr/>
          </p:nvSpPr>
          <p:spPr>
            <a:xfrm>
              <a:off x="4262576" y="4247038"/>
              <a:ext cx="549043" cy="36914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0B0D7EF3-38A1-0241-AE2E-E97D1D3741A7}"/>
                </a:ext>
              </a:extLst>
            </p:cNvPr>
            <p:cNvSpPr txBox="1"/>
            <p:nvPr/>
          </p:nvSpPr>
          <p:spPr>
            <a:xfrm>
              <a:off x="4762744" y="3593924"/>
              <a:ext cx="50753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dirty="0"/>
                <a:t>Flow</a:t>
              </a:r>
            </a:p>
          </p:txBody>
        </p:sp>
        <p:pic>
          <p:nvPicPr>
            <p:cNvPr id="90" name="Picture 89">
              <a:extLst>
                <a:ext uri="{FF2B5EF4-FFF2-40B4-BE49-F238E27FC236}">
                  <a16:creationId xmlns:a16="http://schemas.microsoft.com/office/drawing/2014/main" id="{99F7B8CC-EB0B-9147-9903-856C0CFDC54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996" t="20217" r="16353" b="17604"/>
            <a:stretch/>
          </p:blipFill>
          <p:spPr>
            <a:xfrm>
              <a:off x="5237468" y="4072813"/>
              <a:ext cx="429790" cy="369148"/>
            </a:xfrm>
            <a:prstGeom prst="rect">
              <a:avLst/>
            </a:prstGeom>
          </p:spPr>
        </p:pic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F738620F-0422-FD45-8383-23B430ACC639}"/>
                </a:ext>
              </a:extLst>
            </p:cNvPr>
            <p:cNvSpPr txBox="1"/>
            <p:nvPr/>
          </p:nvSpPr>
          <p:spPr>
            <a:xfrm>
              <a:off x="4713204" y="4093035"/>
              <a:ext cx="50753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dirty="0"/>
                <a:t>Filter</a:t>
              </a:r>
            </a:p>
          </p:txBody>
        </p:sp>
        <p:sp>
          <p:nvSpPr>
            <p:cNvPr id="92" name="Rectangle 91">
              <a:extLst>
                <a:ext uri="{FF2B5EF4-FFF2-40B4-BE49-F238E27FC236}">
                  <a16:creationId xmlns:a16="http://schemas.microsoft.com/office/drawing/2014/main" id="{8BC8F4B2-E12D-2447-A910-C62CD1F23A28}"/>
                </a:ext>
              </a:extLst>
            </p:cNvPr>
            <p:cNvSpPr/>
            <p:nvPr/>
          </p:nvSpPr>
          <p:spPr>
            <a:xfrm>
              <a:off x="5413968" y="4435885"/>
              <a:ext cx="73152" cy="274320"/>
            </a:xfrm>
            <a:prstGeom prst="rect">
              <a:avLst/>
            </a:prstGeom>
            <a:solidFill>
              <a:schemeClr val="accent4">
                <a:lumMod val="20000"/>
                <a:lumOff val="80000"/>
              </a:schemeClr>
            </a:solidFill>
            <a:ln>
              <a:solidFill>
                <a:schemeClr val="accent4">
                  <a:lumMod val="40000"/>
                  <a:lumOff val="6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83590A73-AB00-0F4D-9FB9-DD952C0654EB}"/>
                </a:ext>
              </a:extLst>
            </p:cNvPr>
            <p:cNvSpPr txBox="1"/>
            <p:nvPr/>
          </p:nvSpPr>
          <p:spPr>
            <a:xfrm>
              <a:off x="4039434" y="4958526"/>
              <a:ext cx="182179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solidFill>
                    <a:srgbClr val="FF0000"/>
                  </a:solidFill>
                </a:rPr>
                <a:t>GIFU-S</a:t>
              </a:r>
              <a:r>
                <a:rPr lang="en-US" b="1" dirty="0">
                  <a:solidFill>
                    <a:schemeClr val="accent1">
                      <a:lumMod val="75000"/>
                    </a:schemeClr>
                  </a:solidFill>
                </a:rPr>
                <a:t> </a:t>
              </a:r>
              <a:r>
                <a:rPr lang="en-US" b="1" dirty="0"/>
                <a:t>/ </a:t>
              </a:r>
              <a:r>
                <a:rPr lang="en-US" b="1" dirty="0" err="1">
                  <a:solidFill>
                    <a:schemeClr val="accent6">
                      <a:lumMod val="75000"/>
                    </a:schemeClr>
                  </a:solidFill>
                </a:rPr>
                <a:t>pGIFU</a:t>
              </a:r>
              <a:r>
                <a:rPr lang="en-US" b="1" dirty="0">
                  <a:solidFill>
                    <a:schemeClr val="accent6">
                      <a:lumMod val="75000"/>
                    </a:schemeClr>
                  </a:solidFill>
                </a:rPr>
                <a:t>-S</a:t>
              </a:r>
            </a:p>
          </p:txBody>
        </p:sp>
        <p:cxnSp>
          <p:nvCxnSpPr>
            <p:cNvPr id="94" name="Straight Arrow Connector 93">
              <a:extLst>
                <a:ext uri="{FF2B5EF4-FFF2-40B4-BE49-F238E27FC236}">
                  <a16:creationId xmlns:a16="http://schemas.microsoft.com/office/drawing/2014/main" id="{C25D33C0-55DB-4347-AB23-54507FEE1DBC}"/>
                </a:ext>
              </a:extLst>
            </p:cNvPr>
            <p:cNvCxnSpPr>
              <a:cxnSpLocks/>
            </p:cNvCxnSpPr>
            <p:nvPr/>
          </p:nvCxnSpPr>
          <p:spPr>
            <a:xfrm>
              <a:off x="5453698" y="4587239"/>
              <a:ext cx="0" cy="399437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B704B0A9-D8E5-D545-B10B-3BD1636BF6C9}"/>
                </a:ext>
              </a:extLst>
            </p:cNvPr>
            <p:cNvSpPr txBox="1"/>
            <p:nvPr/>
          </p:nvSpPr>
          <p:spPr>
            <a:xfrm>
              <a:off x="1253679" y="3414710"/>
              <a:ext cx="614290" cy="553998"/>
            </a:xfrm>
            <a:prstGeom prst="rect">
              <a:avLst/>
            </a:prstGeom>
            <a:solidFill>
              <a:srgbClr val="C6D9F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b="1" dirty="0">
                  <a:solidFill>
                    <a:srgbClr val="FF0000"/>
                  </a:solidFill>
                </a:rPr>
                <a:t>GIFU</a:t>
              </a:r>
              <a:r>
                <a:rPr lang="en-US" b="1" dirty="0">
                  <a:solidFill>
                    <a:schemeClr val="accent1">
                      <a:lumMod val="75000"/>
                    </a:schemeClr>
                  </a:solidFill>
                </a:rPr>
                <a:t> </a:t>
              </a:r>
              <a:r>
                <a:rPr lang="en-US" b="1" dirty="0"/>
                <a:t>/ </a:t>
              </a:r>
              <a:r>
                <a:rPr lang="en-US" b="1" dirty="0" err="1">
                  <a:solidFill>
                    <a:schemeClr val="accent6">
                      <a:lumMod val="75000"/>
                    </a:schemeClr>
                  </a:solidFill>
                </a:rPr>
                <a:t>pGIFU</a:t>
              </a:r>
              <a:endParaRPr lang="en-US" b="1" dirty="0">
                <a:solidFill>
                  <a:schemeClr val="accent6">
                    <a:lumMod val="75000"/>
                  </a:schemeClr>
                </a:solidFill>
              </a:endParaRPr>
            </a:p>
          </p:txBody>
        </p:sp>
      </p:grpSp>
      <p:sp>
        <p:nvSpPr>
          <p:cNvPr id="98" name="TextBox 97">
            <a:extLst>
              <a:ext uri="{FF2B5EF4-FFF2-40B4-BE49-F238E27FC236}">
                <a16:creationId xmlns:a16="http://schemas.microsoft.com/office/drawing/2014/main" id="{EA20D945-AAC6-DC4D-A170-51F834E07BED}"/>
              </a:ext>
            </a:extLst>
          </p:cNvPr>
          <p:cNvSpPr txBox="1"/>
          <p:nvPr/>
        </p:nvSpPr>
        <p:spPr>
          <a:xfrm>
            <a:off x="2505394" y="5739454"/>
            <a:ext cx="6872074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GIFU</a:t>
            </a:r>
            <a:r>
              <a:rPr lang="en-US" dirty="0"/>
              <a:t>: regular microbial media</a:t>
            </a:r>
            <a:endParaRPr lang="en-US" b="1" dirty="0">
              <a:solidFill>
                <a:srgbClr val="FF0000"/>
              </a:solidFill>
            </a:endParaRPr>
          </a:p>
          <a:p>
            <a:r>
              <a:rPr lang="en-US" b="1" dirty="0" err="1">
                <a:solidFill>
                  <a:schemeClr val="accent6">
                    <a:lumMod val="75000"/>
                  </a:schemeClr>
                </a:solidFill>
              </a:rPr>
              <a:t>pGIFU</a:t>
            </a:r>
            <a:r>
              <a:rPr lang="en-US" dirty="0"/>
              <a:t>: pro-inflammatory microbial media containing nitrate and TMAO</a:t>
            </a:r>
            <a:endParaRPr lang="en-US" b="1" dirty="0"/>
          </a:p>
          <a:p>
            <a:r>
              <a:rPr lang="en-US" b="1" dirty="0">
                <a:solidFill>
                  <a:srgbClr val="FF0000"/>
                </a:solidFill>
              </a:rPr>
              <a:t>GIFU-S</a:t>
            </a:r>
            <a:r>
              <a:rPr lang="en-US" dirty="0"/>
              <a:t>: spent microbial media</a:t>
            </a:r>
            <a:endParaRPr lang="en-US" b="1" dirty="0">
              <a:solidFill>
                <a:schemeClr val="accent1">
                  <a:lumMod val="75000"/>
                </a:schemeClr>
              </a:solidFill>
            </a:endParaRPr>
          </a:p>
          <a:p>
            <a:r>
              <a:rPr lang="en-US" b="1" dirty="0" err="1">
                <a:solidFill>
                  <a:schemeClr val="accent6">
                    <a:lumMod val="75000"/>
                  </a:schemeClr>
                </a:solidFill>
              </a:rPr>
              <a:t>pGIFU</a:t>
            </a:r>
            <a:r>
              <a:rPr lang="en-US" b="1" dirty="0">
                <a:solidFill>
                  <a:schemeClr val="accent6">
                    <a:lumMod val="75000"/>
                  </a:schemeClr>
                </a:solidFill>
              </a:rPr>
              <a:t>-S</a:t>
            </a:r>
            <a:r>
              <a:rPr lang="en-US" dirty="0"/>
              <a:t>: spent pro-inflammatory microbial media </a:t>
            </a:r>
            <a:endParaRPr lang="en-US" b="1" dirty="0">
              <a:solidFill>
                <a:schemeClr val="accent6">
                  <a:lumMod val="75000"/>
                </a:schemeClr>
              </a:solidFill>
            </a:endParaRPr>
          </a:p>
          <a:p>
            <a:pPr algn="ctr"/>
            <a:endParaRPr lang="en-US" b="1" dirty="0"/>
          </a:p>
        </p:txBody>
      </p:sp>
      <p:sp>
        <p:nvSpPr>
          <p:cNvPr id="2" name="Rounded Rectangle 1">
            <a:extLst>
              <a:ext uri="{FF2B5EF4-FFF2-40B4-BE49-F238E27FC236}">
                <a16:creationId xmlns:a16="http://schemas.microsoft.com/office/drawing/2014/main" id="{20D393CC-98F9-9D4C-9E3C-5904924DE996}"/>
              </a:ext>
            </a:extLst>
          </p:cNvPr>
          <p:cNvSpPr/>
          <p:nvPr/>
        </p:nvSpPr>
        <p:spPr>
          <a:xfrm>
            <a:off x="192925" y="344544"/>
            <a:ext cx="5644173" cy="5439999"/>
          </a:xfrm>
          <a:prstGeom prst="roundRect">
            <a:avLst/>
          </a:prstGeom>
          <a:noFill/>
          <a:ln w="285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18416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5</TotalTime>
  <Words>86</Words>
  <Application>Microsoft Macintosh PowerPoint</Application>
  <PresentationFormat>Widescreen</PresentationFormat>
  <Paragraphs>3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aelena</dc:creator>
  <cp:lastModifiedBy>Carrier, Rebecca</cp:lastModifiedBy>
  <cp:revision>9</cp:revision>
  <dcterms:created xsi:type="dcterms:W3CDTF">2021-05-07T15:47:45Z</dcterms:created>
  <dcterms:modified xsi:type="dcterms:W3CDTF">2021-06-27T12:44:08Z</dcterms:modified>
</cp:coreProperties>
</file>